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rts/chart19.xml" ContentType="application/vnd.openxmlformats-officedocument.drawingml.chart+xml"/>
  <Override PartName="/ppt/charts/chart28.xml" ContentType="application/vnd.openxmlformats-officedocument.drawingml.chart+xml"/>
  <Override PartName="/customXml/itemProps1.xml" ContentType="application/vnd.openxmlformats-officedocument.customXmlPropertie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charts/chart17.xml" ContentType="application/vnd.openxmlformats-officedocument.drawingml.chart+xml"/>
  <Override PartName="/ppt/charts/chart26.xml" ContentType="application/vnd.openxmlformats-officedocument.drawingml.chart+xml"/>
  <Default Extension="rels" ContentType="application/vnd.openxmlformats-package.relationships+xml"/>
  <Default Extension="xml" ContentType="application/xml"/>
  <Override PartName="/ppt/charts/chart13.xml" ContentType="application/vnd.openxmlformats-officedocument.drawingml.chart+xml"/>
  <Override PartName="/ppt/charts/chart15.xml" ContentType="application/vnd.openxmlformats-officedocument.drawingml.chart+xml"/>
  <Override PartName="/ppt/charts/chart24.xml" ContentType="application/vnd.openxmlformats-officedocument.drawingml.chart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22.xml" ContentType="application/vnd.openxmlformats-officedocument.drawingml.chart+xml"/>
  <Override PartName="/docProps/custom.xml" ContentType="application/vnd.openxmlformats-officedocument.custom-properties+xml"/>
  <Override PartName="/ppt/charts/chart7.xml" ContentType="application/vnd.openxmlformats-officedocument.drawingml.chart+xml"/>
  <Override PartName="/ppt/charts/chart20.xml" ContentType="application/vnd.openxmlformats-officedocument.drawingml.chart+xml"/>
  <Override PartName="/ppt/charts/chart3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ppt/charts/chart29.xml" ContentType="application/vnd.openxmlformats-officedocument.drawingml.char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charts/chart18.xml" ContentType="application/vnd.openxmlformats-officedocument.drawingml.chart+xml"/>
  <Override PartName="/ppt/charts/chart27.xml" ContentType="application/vnd.openxmlformats-officedocument.drawingml.char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charts/chart16.xml" ContentType="application/vnd.openxmlformats-officedocument.drawingml.chart+xml"/>
  <Override PartName="/ppt/charts/chart25.xml" ContentType="application/vnd.openxmlformats-officedocument.drawingml.chart+xml"/>
  <Default Extension="jpeg" ContentType="image/jpeg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hart14.xml" ContentType="application/vnd.openxmlformats-officedocument.drawingml.chart+xml"/>
  <Override PartName="/ppt/charts/chart23.xml" ContentType="application/vnd.openxmlformats-officedocument.drawingml.chart+xml"/>
  <Override PartName="/docProps/app.xml" ContentType="application/vnd.openxmlformats-officedocument.extended-properties+xml"/>
  <Override PartName="/ppt/charts/chart8.xml" ContentType="application/vnd.openxmlformats-officedocument.drawingml.chart+xml"/>
  <Override PartName="/ppt/charts/chart12.xml" ContentType="application/vnd.openxmlformats-officedocument.drawingml.chart+xml"/>
  <Override PartName="/ppt/charts/chart21.xml" ContentType="application/vnd.openxmlformats-officedocument.drawingml.chart+xml"/>
  <Override PartName="/ppt/charts/chart30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10.xml" ContentType="application/vnd.openxmlformats-officedocument.drawingml.chart+xml"/>
  <Override PartName="/ppt/charts/chart4.xml" ContentType="application/vnd.openxmlformats-officedocument.drawingml.char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714" y="1164"/>
      </p:cViewPr>
      <p:guideLst>
        <p:guide orient="horz" pos="172"/>
        <p:guide pos="1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slide" Target="slides/slide3.xml"/><Relationship Id="rId9" Type="http://schemas.openxmlformats.org/officeDocument/2006/relationships/customXml" Target="../customXml/item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N2%20A1_0.02_5%25_&#34411;&#27598;&#12498;&#12473;&#12488;&#12464;&#12521;&#12512;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25%20A2_0.02_5%25_&#34411;&#27598;&#12498;&#12473;&#12488;&#12464;&#12521;&#12512;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nmr-1(ak4)_A1_0.02_5%25_&#34411;&#27598;&#12498;&#12473;&#12488;&#12464;&#12521;&#12512;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glr-1(n2461)_A1_0.02_5%25_&#34411;&#27598;&#12498;&#12473;&#12488;&#12464;&#12521;&#12512;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49%20L4_0.02_5%25_&#34411;&#27598;&#12498;&#12473;&#12488;&#12464;&#12521;&#12512;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49%20A1_0.02_5%25_&#34411;&#27598;&#12498;&#12473;&#12488;&#12464;&#12521;&#12512;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49%20A2_0.02_5%25_&#34411;&#27598;&#12498;&#12473;&#12488;&#12464;&#12521;&#12512;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49%20A3_0.02_5%25_&#34411;&#27598;&#12498;&#12473;&#12488;&#12464;&#12521;&#12512;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49%20A5_0.02_5%25_&#34411;&#27598;&#12498;&#12473;&#12488;&#12464;&#12521;&#12512;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glr-1(n2461)_A3_0.02_5%25_&#34411;&#27598;&#12498;&#12473;&#12488;&#12464;&#12521;&#12512;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glr-1(n2461)_A5_0.02_5%25_&#34411;&#27598;&#12498;&#12473;&#12488;&#12464;&#12521;&#1251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N2%20L4_0.02_5%25_&#34411;&#27598;&#12498;&#12473;&#12488;&#12464;&#12521;&#12512;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nmr-1(ak4)_A3_0.02_5%25_&#34411;&#27598;&#12498;&#12473;&#12488;&#12464;&#12521;&#12512;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nmr-1(ak4)_A5_0.02_5%25_&#34411;&#27598;&#12498;&#12473;&#12488;&#12464;&#12521;&#12512;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cat-2(CB1112)_A5_0.02_5%25_&#34411;&#27598;&#12498;&#12473;&#12488;&#12464;&#12521;&#12512;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cat-2(CB1112)_A3_0.02_5%25_&#34411;&#27598;&#12498;&#12473;&#12488;&#12464;&#12521;&#12512;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cat-2(CB1112)_A1_0.02_5%25_&#34411;&#27598;&#12498;&#12473;&#12488;&#12464;&#12521;&#12512;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cat-1(CB1111)_A5_0.02_5%25_&#34411;&#27598;&#12498;&#12473;&#12488;&#12464;&#12521;&#12512;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cat-1(CB1111)_A3_0.02_5%25_&#34411;&#27598;&#12498;&#12473;&#12488;&#12464;&#12521;&#12512;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cat-1(CB1111)_A1_0.02_5%25_&#34411;&#27598;&#12498;&#12473;&#12488;&#12464;&#12521;&#12512;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tph-1(mg280)_A5_0.02_5%25_&#34411;&#27598;&#12498;&#12473;&#12488;&#12464;&#12521;&#12512;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tph-1(mg280)_A3_0.02_5%25_&#34411;&#27598;&#12498;&#12473;&#12488;&#12464;&#12521;&#12512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N2%20A2_0.02_5%25_&#34411;&#27598;&#12498;&#12473;&#12488;&#12464;&#12521;&#12512;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tph-1(mg280)_A1_0.02_5%25_&#34411;&#27598;&#12498;&#12473;&#12488;&#12464;&#12521;&#12512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N2%20A5_0.02_5%25_&#34411;&#27598;&#12498;&#12473;&#12488;&#12464;&#12521;&#12512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25%20A1_0.02_5%25_&#34411;&#27598;&#12498;&#12473;&#12488;&#12464;&#12521;&#12512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25%20A3_0.02_5%25_&#34411;&#27598;&#12498;&#12473;&#12488;&#12464;&#12521;&#12512;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25%20A5_0.02_5%25_&#34411;&#27598;&#12498;&#12473;&#12488;&#12464;&#12521;&#12512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N2%20A3_0.02_5%25_&#34411;&#27598;&#12498;&#12473;&#12488;&#12464;&#12521;&#12512;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05%25\&#34411;&#27598;&#12498;&#12473;&#12488;&#12464;&#12521;&#12512;5%25\unc-25%20L4_0.02_5%25_&#34411;&#27598;&#12498;&#12473;&#12488;&#12464;&#12521;&#125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</a:t>
            </a:r>
            <a:r>
              <a:rPr lang="en-US" altLang="ja-JP" sz="1400" b="0" baseline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A1_0.02_5%'!$B$104</c:f>
              <c:strCache>
                <c:ptCount val="1"/>
                <c:pt idx="0">
                  <c:v>N2_A1_40_30_01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B$105:$B$125</c:f>
              <c:numCache>
                <c:formatCode>General</c:formatCode>
                <c:ptCount val="21"/>
                <c:pt idx="1">
                  <c:v>6.6791744840525358E-2</c:v>
                </c:pt>
                <c:pt idx="2">
                  <c:v>9.9812382739212099E-2</c:v>
                </c:pt>
                <c:pt idx="3">
                  <c:v>0.10806754221388407</c:v>
                </c:pt>
                <c:pt idx="4">
                  <c:v>0.140337711069418</c:v>
                </c:pt>
                <c:pt idx="5">
                  <c:v>0.1163227016885551</c:v>
                </c:pt>
                <c:pt idx="6">
                  <c:v>7.3545966228893103E-2</c:v>
                </c:pt>
                <c:pt idx="7">
                  <c:v>6.9043151969981245E-2</c:v>
                </c:pt>
                <c:pt idx="8">
                  <c:v>4.7654784240150114E-2</c:v>
                </c:pt>
                <c:pt idx="9">
                  <c:v>4.3527204502814304E-2</c:v>
                </c:pt>
                <c:pt idx="10">
                  <c:v>3.6022514071294615E-2</c:v>
                </c:pt>
                <c:pt idx="11">
                  <c:v>2.7016885553470916E-2</c:v>
                </c:pt>
                <c:pt idx="12">
                  <c:v>1.6510318949343301E-2</c:v>
                </c:pt>
                <c:pt idx="13">
                  <c:v>1.9512195121951202E-2</c:v>
                </c:pt>
                <c:pt idx="14">
                  <c:v>1.35084427767355E-2</c:v>
                </c:pt>
                <c:pt idx="15">
                  <c:v>1.2757973733583505E-2</c:v>
                </c:pt>
                <c:pt idx="16">
                  <c:v>7.8799249530956926E-3</c:v>
                </c:pt>
                <c:pt idx="17">
                  <c:v>1.0881801125703605E-2</c:v>
                </c:pt>
                <c:pt idx="18">
                  <c:v>6.7542213883677342E-3</c:v>
                </c:pt>
                <c:pt idx="19">
                  <c:v>3.3771106941838597E-3</c:v>
                </c:pt>
                <c:pt idx="20">
                  <c:v>3.7523452157598499E-3</c:v>
                </c:pt>
              </c:numCache>
            </c:numRef>
          </c:val>
        </c:ser>
        <c:ser>
          <c:idx val="1"/>
          <c:order val="1"/>
          <c:tx>
            <c:strRef>
              <c:f>'N2 A1_0.02_5%'!$C$104</c:f>
              <c:strCache>
                <c:ptCount val="1"/>
                <c:pt idx="0">
                  <c:v>N2_A1_40_30_06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C$105:$C$125</c:f>
              <c:numCache>
                <c:formatCode>General</c:formatCode>
                <c:ptCount val="21"/>
                <c:pt idx="1">
                  <c:v>7.340206185567015E-2</c:v>
                </c:pt>
                <c:pt idx="2">
                  <c:v>0.13731958762886601</c:v>
                </c:pt>
                <c:pt idx="3">
                  <c:v>0.16659793814433019</c:v>
                </c:pt>
                <c:pt idx="4">
                  <c:v>0.12577319587628899</c:v>
                </c:pt>
                <c:pt idx="5">
                  <c:v>0.107216494845361</c:v>
                </c:pt>
                <c:pt idx="6">
                  <c:v>8.7010309278350503E-2</c:v>
                </c:pt>
                <c:pt idx="7">
                  <c:v>5.9381443298969105E-2</c:v>
                </c:pt>
                <c:pt idx="8">
                  <c:v>4.7835051546391838E-2</c:v>
                </c:pt>
                <c:pt idx="9">
                  <c:v>2.51546391752577E-2</c:v>
                </c:pt>
                <c:pt idx="10">
                  <c:v>2.6391752577319631E-2</c:v>
                </c:pt>
                <c:pt idx="11">
                  <c:v>1.6907216494845403E-2</c:v>
                </c:pt>
                <c:pt idx="12">
                  <c:v>1.4845360824742299E-2</c:v>
                </c:pt>
                <c:pt idx="13">
                  <c:v>9.0721649484536183E-3</c:v>
                </c:pt>
                <c:pt idx="14">
                  <c:v>6.1855670103092824E-3</c:v>
                </c:pt>
                <c:pt idx="15">
                  <c:v>3.7113402061855734E-3</c:v>
                </c:pt>
                <c:pt idx="16">
                  <c:v>2.8865979381443329E-3</c:v>
                </c:pt>
                <c:pt idx="17">
                  <c:v>2.4742268041237098E-3</c:v>
                </c:pt>
                <c:pt idx="18">
                  <c:v>2.4742268041237098E-3</c:v>
                </c:pt>
                <c:pt idx="19">
                  <c:v>2.0618556701030885E-3</c:v>
                </c:pt>
                <c:pt idx="20">
                  <c:v>0</c:v>
                </c:pt>
              </c:numCache>
            </c:numRef>
          </c:val>
        </c:ser>
        <c:ser>
          <c:idx val="2"/>
          <c:order val="2"/>
          <c:tx>
            <c:strRef>
              <c:f>'N2 A1_0.02_5%'!$D$104</c:f>
              <c:strCache>
                <c:ptCount val="1"/>
                <c:pt idx="0">
                  <c:v>N2_A1_40_30_07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D$105:$D$125</c:f>
              <c:numCache>
                <c:formatCode>General</c:formatCode>
                <c:ptCount val="21"/>
                <c:pt idx="1">
                  <c:v>7.7081615828524366E-2</c:v>
                </c:pt>
                <c:pt idx="2">
                  <c:v>0.10181368507831802</c:v>
                </c:pt>
                <c:pt idx="3">
                  <c:v>0.10717230008244004</c:v>
                </c:pt>
                <c:pt idx="4">
                  <c:v>0.11253091508656203</c:v>
                </c:pt>
                <c:pt idx="5">
                  <c:v>9.8516075845012555E-2</c:v>
                </c:pt>
                <c:pt idx="6">
                  <c:v>7.7081615828524366E-2</c:v>
                </c:pt>
                <c:pt idx="7">
                  <c:v>5.9356966199505451E-2</c:v>
                </c:pt>
                <c:pt idx="8">
                  <c:v>5.3173948887056892E-2</c:v>
                </c:pt>
                <c:pt idx="9">
                  <c:v>4.4929925803792327E-2</c:v>
                </c:pt>
                <c:pt idx="10">
                  <c:v>3.709810387469082E-2</c:v>
                </c:pt>
                <c:pt idx="11">
                  <c:v>3.1739488870568801E-2</c:v>
                </c:pt>
                <c:pt idx="12">
                  <c:v>2.6380873866446809E-2</c:v>
                </c:pt>
                <c:pt idx="13">
                  <c:v>2.1846661170651299E-2</c:v>
                </c:pt>
                <c:pt idx="14">
                  <c:v>1.4839241549876299E-2</c:v>
                </c:pt>
                <c:pt idx="15">
                  <c:v>1.4014839241549901E-2</c:v>
                </c:pt>
                <c:pt idx="16">
                  <c:v>1.112943116240731E-2</c:v>
                </c:pt>
                <c:pt idx="17">
                  <c:v>1.23660346248969E-2</c:v>
                </c:pt>
                <c:pt idx="18">
                  <c:v>8.6562242374278696E-3</c:v>
                </c:pt>
                <c:pt idx="19">
                  <c:v>1.0305028854080803E-2</c:v>
                </c:pt>
                <c:pt idx="20">
                  <c:v>5.7708161582852415E-3</c:v>
                </c:pt>
              </c:numCache>
            </c:numRef>
          </c:val>
        </c:ser>
        <c:ser>
          <c:idx val="3"/>
          <c:order val="3"/>
          <c:tx>
            <c:strRef>
              <c:f>'N2 A1_0.02_5%'!$E$104</c:f>
              <c:strCache>
                <c:ptCount val="1"/>
                <c:pt idx="0">
                  <c:v>N2_REX_A1_01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E$105:$E$125</c:f>
              <c:numCache>
                <c:formatCode>General</c:formatCode>
                <c:ptCount val="21"/>
                <c:pt idx="1">
                  <c:v>8.5181451612903136E-2</c:v>
                </c:pt>
                <c:pt idx="2">
                  <c:v>9.9798387096774244E-2</c:v>
                </c:pt>
                <c:pt idx="3">
                  <c:v>0.10559475806451608</c:v>
                </c:pt>
                <c:pt idx="4">
                  <c:v>0.140120967741935</c:v>
                </c:pt>
                <c:pt idx="5">
                  <c:v>0.11214717741935501</c:v>
                </c:pt>
                <c:pt idx="6">
                  <c:v>7.510080645161292E-2</c:v>
                </c:pt>
                <c:pt idx="7">
                  <c:v>5.771169354838715E-2</c:v>
                </c:pt>
                <c:pt idx="8">
                  <c:v>5.3427419354838752E-2</c:v>
                </c:pt>
                <c:pt idx="9">
                  <c:v>3.9566532258064502E-2</c:v>
                </c:pt>
                <c:pt idx="10">
                  <c:v>2.9737903225806526E-2</c:v>
                </c:pt>
                <c:pt idx="11">
                  <c:v>2.7217741935483909E-2</c:v>
                </c:pt>
                <c:pt idx="12">
                  <c:v>1.8397177419354812E-2</c:v>
                </c:pt>
                <c:pt idx="13">
                  <c:v>1.6633064516129007E-2</c:v>
                </c:pt>
                <c:pt idx="14">
                  <c:v>1.2348790322580599E-2</c:v>
                </c:pt>
                <c:pt idx="15">
                  <c:v>7.8125000000000035E-3</c:v>
                </c:pt>
                <c:pt idx="16">
                  <c:v>9.8286290322580662E-3</c:v>
                </c:pt>
                <c:pt idx="17">
                  <c:v>8.3165322580645313E-3</c:v>
                </c:pt>
                <c:pt idx="18">
                  <c:v>6.5524193548387117E-3</c:v>
                </c:pt>
                <c:pt idx="19">
                  <c:v>5.5443548387096794E-3</c:v>
                </c:pt>
                <c:pt idx="20">
                  <c:v>3.5282258064516128E-3</c:v>
                </c:pt>
              </c:numCache>
            </c:numRef>
          </c:val>
        </c:ser>
        <c:ser>
          <c:idx val="4"/>
          <c:order val="4"/>
          <c:tx>
            <c:strRef>
              <c:f>'N2 A1_0.02_5%'!$F$104</c:f>
              <c:strCache>
                <c:ptCount val="1"/>
                <c:pt idx="0">
                  <c:v>N2_REX_A1_03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F$105:$F$125</c:f>
              <c:numCache>
                <c:formatCode>General</c:formatCode>
                <c:ptCount val="21"/>
                <c:pt idx="1">
                  <c:v>7.8863726658720767E-2</c:v>
                </c:pt>
                <c:pt idx="2">
                  <c:v>0.11362733412793001</c:v>
                </c:pt>
                <c:pt idx="3">
                  <c:v>0.10945570123162508</c:v>
                </c:pt>
                <c:pt idx="4">
                  <c:v>0.12872467222884384</c:v>
                </c:pt>
                <c:pt idx="5">
                  <c:v>0.13170441001191899</c:v>
                </c:pt>
                <c:pt idx="6">
                  <c:v>8.1247516885180768E-2</c:v>
                </c:pt>
                <c:pt idx="7">
                  <c:v>6.8533969010727114E-2</c:v>
                </c:pt>
                <c:pt idx="8">
                  <c:v>5.4032578466428338E-2</c:v>
                </c:pt>
                <c:pt idx="9">
                  <c:v>3.8339292808899528E-2</c:v>
                </c:pt>
                <c:pt idx="10">
                  <c:v>3.1783869686134329E-2</c:v>
                </c:pt>
                <c:pt idx="11">
                  <c:v>2.6023043305522412E-2</c:v>
                </c:pt>
                <c:pt idx="12">
                  <c:v>1.8077075883988911E-2</c:v>
                </c:pt>
                <c:pt idx="13">
                  <c:v>1.45013905442988E-2</c:v>
                </c:pt>
                <c:pt idx="14">
                  <c:v>1.0131108462455306E-2</c:v>
                </c:pt>
                <c:pt idx="15">
                  <c:v>8.1446166070719174E-3</c:v>
                </c:pt>
                <c:pt idx="16">
                  <c:v>6.3567739372268643E-3</c:v>
                </c:pt>
                <c:pt idx="17">
                  <c:v>4.7675804529201402E-3</c:v>
                </c:pt>
                <c:pt idx="18">
                  <c:v>5.3635280095351628E-3</c:v>
                </c:pt>
                <c:pt idx="19">
                  <c:v>3.3770361541517716E-3</c:v>
                </c:pt>
                <c:pt idx="20">
                  <c:v>2.1851410409217333E-3</c:v>
                </c:pt>
              </c:numCache>
            </c:numRef>
          </c:val>
        </c:ser>
        <c:ser>
          <c:idx val="5"/>
          <c:order val="5"/>
          <c:tx>
            <c:strRef>
              <c:f>'N2 A1_0.02_5%'!$G$104</c:f>
              <c:strCache>
                <c:ptCount val="1"/>
                <c:pt idx="0">
                  <c:v>N2_REX_A1_05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G$105:$G$125</c:f>
              <c:numCache>
                <c:formatCode>General</c:formatCode>
                <c:ptCount val="21"/>
                <c:pt idx="1">
                  <c:v>8.6242299794661192E-2</c:v>
                </c:pt>
                <c:pt idx="2">
                  <c:v>0.10215605749486698</c:v>
                </c:pt>
                <c:pt idx="3">
                  <c:v>0.13603696098562601</c:v>
                </c:pt>
                <c:pt idx="4">
                  <c:v>0.145790554414784</c:v>
                </c:pt>
                <c:pt idx="5">
                  <c:v>0.10985626283367604</c:v>
                </c:pt>
                <c:pt idx="6">
                  <c:v>9.2402464065708387E-2</c:v>
                </c:pt>
                <c:pt idx="7">
                  <c:v>6.6735112936345042E-2</c:v>
                </c:pt>
                <c:pt idx="8">
                  <c:v>4.6201232032854193E-2</c:v>
                </c:pt>
                <c:pt idx="9">
                  <c:v>3.9527720739219716E-2</c:v>
                </c:pt>
                <c:pt idx="10">
                  <c:v>2.8234086242299797E-2</c:v>
                </c:pt>
                <c:pt idx="11">
                  <c:v>2.51540041067762E-2</c:v>
                </c:pt>
                <c:pt idx="12">
                  <c:v>1.5400410677618112E-2</c:v>
                </c:pt>
                <c:pt idx="13">
                  <c:v>1.1293634496919901E-2</c:v>
                </c:pt>
                <c:pt idx="14">
                  <c:v>8.7268993839835687E-3</c:v>
                </c:pt>
                <c:pt idx="15">
                  <c:v>6.6735112936345048E-3</c:v>
                </c:pt>
                <c:pt idx="16">
                  <c:v>3.593429158110882E-3</c:v>
                </c:pt>
                <c:pt idx="17">
                  <c:v>2.5667351129363427E-3</c:v>
                </c:pt>
                <c:pt idx="18">
                  <c:v>1.5400410677618114E-3</c:v>
                </c:pt>
                <c:pt idx="19">
                  <c:v>1.5400410677618114E-3</c:v>
                </c:pt>
                <c:pt idx="20">
                  <c:v>5.1334702258726945E-4</c:v>
                </c:pt>
              </c:numCache>
            </c:numRef>
          </c:val>
        </c:ser>
        <c:ser>
          <c:idx val="6"/>
          <c:order val="6"/>
          <c:tx>
            <c:strRef>
              <c:f>'N2 A1_0.02_5%'!$H$104</c:f>
              <c:strCache>
                <c:ptCount val="1"/>
                <c:pt idx="0">
                  <c:v>N2_REX_A1_07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H$105:$H$125</c:f>
              <c:numCache>
                <c:formatCode>General</c:formatCode>
                <c:ptCount val="21"/>
                <c:pt idx="1">
                  <c:v>8.7147441310589435E-2</c:v>
                </c:pt>
                <c:pt idx="2">
                  <c:v>0.10994764397905804</c:v>
                </c:pt>
                <c:pt idx="3">
                  <c:v>0.12514777909137001</c:v>
                </c:pt>
                <c:pt idx="4">
                  <c:v>0.133930079378483</c:v>
                </c:pt>
                <c:pt idx="5">
                  <c:v>0.11974328660699207</c:v>
                </c:pt>
                <c:pt idx="6">
                  <c:v>7.9040702584023029E-2</c:v>
                </c:pt>
                <c:pt idx="7">
                  <c:v>6.5360580982942146E-2</c:v>
                </c:pt>
                <c:pt idx="8">
                  <c:v>5.3031582502955595E-2</c:v>
                </c:pt>
                <c:pt idx="9">
                  <c:v>3.8338118561053937E-2</c:v>
                </c:pt>
                <c:pt idx="10">
                  <c:v>3.1413612565445025E-2</c:v>
                </c:pt>
                <c:pt idx="11">
                  <c:v>2.600912008106742E-2</c:v>
                </c:pt>
                <c:pt idx="12">
                  <c:v>1.5875696672859298E-2</c:v>
                </c:pt>
                <c:pt idx="13">
                  <c:v>1.2666779260260119E-2</c:v>
                </c:pt>
                <c:pt idx="14">
                  <c:v>9.288971457524069E-3</c:v>
                </c:pt>
                <c:pt idx="15">
                  <c:v>5.0667117041040457E-3</c:v>
                </c:pt>
                <c:pt idx="16">
                  <c:v>4.8978213139672403E-3</c:v>
                </c:pt>
                <c:pt idx="17">
                  <c:v>2.7022462421888212E-3</c:v>
                </c:pt>
                <c:pt idx="18">
                  <c:v>3.0400270224624241E-3</c:v>
                </c:pt>
                <c:pt idx="19">
                  <c:v>1.688903901368012E-3</c:v>
                </c:pt>
                <c:pt idx="20">
                  <c:v>1.5200135112312123E-3</c:v>
                </c:pt>
              </c:numCache>
            </c:numRef>
          </c:val>
        </c:ser>
        <c:ser>
          <c:idx val="7"/>
          <c:order val="7"/>
          <c:tx>
            <c:strRef>
              <c:f>'N2 A1_0.02_5%'!$I$104</c:f>
              <c:strCache>
                <c:ptCount val="1"/>
                <c:pt idx="0">
                  <c:v>N2_REX_A1_08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I$105:$I$125</c:f>
              <c:numCache>
                <c:formatCode>General</c:formatCode>
                <c:ptCount val="21"/>
                <c:pt idx="1">
                  <c:v>7.6731990063483344E-2</c:v>
                </c:pt>
                <c:pt idx="2">
                  <c:v>0.10681755451283501</c:v>
                </c:pt>
                <c:pt idx="3">
                  <c:v>0.131934860612752</c:v>
                </c:pt>
                <c:pt idx="4">
                  <c:v>0.14628760695556201</c:v>
                </c:pt>
                <c:pt idx="5">
                  <c:v>0.12061827215015204</c:v>
                </c:pt>
                <c:pt idx="6">
                  <c:v>7.6731990063483344E-2</c:v>
                </c:pt>
                <c:pt idx="7">
                  <c:v>6.8727573833839442E-2</c:v>
                </c:pt>
                <c:pt idx="8">
                  <c:v>4.8854540436102697E-2</c:v>
                </c:pt>
                <c:pt idx="9">
                  <c:v>4.0298095500966101E-2</c:v>
                </c:pt>
                <c:pt idx="10">
                  <c:v>3.1465636213083112E-2</c:v>
                </c:pt>
                <c:pt idx="11">
                  <c:v>2.4289263041678211E-2</c:v>
                </c:pt>
                <c:pt idx="12">
                  <c:v>1.4628760695556207E-2</c:v>
                </c:pt>
                <c:pt idx="13">
                  <c:v>1.40767319900635E-2</c:v>
                </c:pt>
                <c:pt idx="14">
                  <c:v>6.6243444659122323E-3</c:v>
                </c:pt>
                <c:pt idx="15">
                  <c:v>6.348330113165883E-3</c:v>
                </c:pt>
                <c:pt idx="16">
                  <c:v>3.5881865857024645E-3</c:v>
                </c:pt>
                <c:pt idx="17">
                  <c:v>3.3121722329561114E-3</c:v>
                </c:pt>
                <c:pt idx="18">
                  <c:v>2.4841291747170926E-3</c:v>
                </c:pt>
                <c:pt idx="19">
                  <c:v>2.7601435274634328E-3</c:v>
                </c:pt>
                <c:pt idx="20">
                  <c:v>2.4841291747170926E-3</c:v>
                </c:pt>
              </c:numCache>
            </c:numRef>
          </c:val>
        </c:ser>
        <c:ser>
          <c:idx val="8"/>
          <c:order val="8"/>
          <c:tx>
            <c:strRef>
              <c:f>'N2 A1_0.02_5%'!$J$104</c:f>
              <c:strCache>
                <c:ptCount val="1"/>
                <c:pt idx="0">
                  <c:v>N2_REX_A1_09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J$105:$J$125</c:f>
              <c:numCache>
                <c:formatCode>General</c:formatCode>
                <c:ptCount val="21"/>
                <c:pt idx="1">
                  <c:v>8.1441263573543907E-2</c:v>
                </c:pt>
                <c:pt idx="2">
                  <c:v>0.10562685093780808</c:v>
                </c:pt>
                <c:pt idx="3">
                  <c:v>0.11829549193813811</c:v>
                </c:pt>
                <c:pt idx="4">
                  <c:v>0.14577163540638399</c:v>
                </c:pt>
                <c:pt idx="5">
                  <c:v>0.125534715366897</c:v>
                </c:pt>
                <c:pt idx="6">
                  <c:v>6.8608094768015812E-2</c:v>
                </c:pt>
                <c:pt idx="7">
                  <c:v>6.1533399144455422E-2</c:v>
                </c:pt>
                <c:pt idx="8">
                  <c:v>5.6103981572885812E-2</c:v>
                </c:pt>
                <c:pt idx="9">
                  <c:v>4.5409674234945761E-2</c:v>
                </c:pt>
                <c:pt idx="10">
                  <c:v>3.2082922013820334E-2</c:v>
                </c:pt>
                <c:pt idx="11">
                  <c:v>2.3198420533070082E-2</c:v>
                </c:pt>
                <c:pt idx="12">
                  <c:v>1.8427114182296801E-2</c:v>
                </c:pt>
                <c:pt idx="13">
                  <c:v>1.3984863441921706E-2</c:v>
                </c:pt>
                <c:pt idx="14">
                  <c:v>1.0365251727542001E-2</c:v>
                </c:pt>
                <c:pt idx="15">
                  <c:v>8.5554458703521047E-3</c:v>
                </c:pt>
                <c:pt idx="16">
                  <c:v>6.4165844027640742E-3</c:v>
                </c:pt>
                <c:pt idx="17">
                  <c:v>5.7584731819677543E-3</c:v>
                </c:pt>
                <c:pt idx="18">
                  <c:v>2.6324448831852587E-3</c:v>
                </c:pt>
                <c:pt idx="19">
                  <c:v>2.7969726883843422E-3</c:v>
                </c:pt>
                <c:pt idx="20">
                  <c:v>2.3033892727871031E-3</c:v>
                </c:pt>
              </c:numCache>
            </c:numRef>
          </c:val>
        </c:ser>
        <c:ser>
          <c:idx val="9"/>
          <c:order val="9"/>
          <c:tx>
            <c:strRef>
              <c:f>'N2 A1_0.02_5%'!$K$104</c:f>
              <c:strCache>
                <c:ptCount val="1"/>
                <c:pt idx="0">
                  <c:v>N2_REX_A1_10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K$105:$K$125</c:f>
              <c:numCache>
                <c:formatCode>General</c:formatCode>
                <c:ptCount val="21"/>
                <c:pt idx="1">
                  <c:v>7.3290517567056998E-2</c:v>
                </c:pt>
                <c:pt idx="2">
                  <c:v>0.10162448054401207</c:v>
                </c:pt>
                <c:pt idx="3">
                  <c:v>0.11616924820551611</c:v>
                </c:pt>
                <c:pt idx="4">
                  <c:v>0.135058556856819</c:v>
                </c:pt>
                <c:pt idx="5">
                  <c:v>0.11220249338874203</c:v>
                </c:pt>
                <c:pt idx="6">
                  <c:v>7.6879486210804704E-2</c:v>
                </c:pt>
                <c:pt idx="7">
                  <c:v>6.4034756327918441E-2</c:v>
                </c:pt>
                <c:pt idx="8">
                  <c:v>5.2134491877597361E-2</c:v>
                </c:pt>
                <c:pt idx="9">
                  <c:v>4.2689837551945636E-2</c:v>
                </c:pt>
                <c:pt idx="10">
                  <c:v>3.6078579523989428E-2</c:v>
                </c:pt>
                <c:pt idx="11">
                  <c:v>2.4367208160181311E-2</c:v>
                </c:pt>
                <c:pt idx="12">
                  <c:v>1.870041556479031E-2</c:v>
                </c:pt>
                <c:pt idx="13">
                  <c:v>1.4922553834529706E-2</c:v>
                </c:pt>
                <c:pt idx="14">
                  <c:v>1.1144692104268999E-2</c:v>
                </c:pt>
                <c:pt idx="15">
                  <c:v>1.0389119758216806E-2</c:v>
                </c:pt>
                <c:pt idx="16">
                  <c:v>9.6335474121647165E-3</c:v>
                </c:pt>
                <c:pt idx="17">
                  <c:v>6.6112580279561834E-3</c:v>
                </c:pt>
                <c:pt idx="18">
                  <c:v>4.5334340763128105E-3</c:v>
                </c:pt>
                <c:pt idx="19">
                  <c:v>3.4000755572346129E-3</c:v>
                </c:pt>
                <c:pt idx="20">
                  <c:v>2.6445032111824742E-3</c:v>
                </c:pt>
              </c:numCache>
            </c:numRef>
          </c:val>
        </c:ser>
        <c:ser>
          <c:idx val="10"/>
          <c:order val="10"/>
          <c:tx>
            <c:strRef>
              <c:f>'N2 A1_0.02_5%'!$L$104</c:f>
              <c:strCache>
                <c:ptCount val="1"/>
                <c:pt idx="0">
                  <c:v>N2_REX_A1_11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L$105:$L$125</c:f>
              <c:numCache>
                <c:formatCode>General</c:formatCode>
                <c:ptCount val="21"/>
                <c:pt idx="1">
                  <c:v>7.6772354827217767E-2</c:v>
                </c:pt>
                <c:pt idx="2">
                  <c:v>0.10135375846099004</c:v>
                </c:pt>
                <c:pt idx="3">
                  <c:v>0.12166013537584602</c:v>
                </c:pt>
                <c:pt idx="4">
                  <c:v>0.133594584966156</c:v>
                </c:pt>
                <c:pt idx="5">
                  <c:v>0.12397577484859308</c:v>
                </c:pt>
                <c:pt idx="6">
                  <c:v>8.2828642679016753E-2</c:v>
                </c:pt>
                <c:pt idx="7">
                  <c:v>6.1809761311008238E-2</c:v>
                </c:pt>
                <c:pt idx="8">
                  <c:v>6.1809761311008238E-2</c:v>
                </c:pt>
                <c:pt idx="9">
                  <c:v>4.7381546134663326E-2</c:v>
                </c:pt>
                <c:pt idx="10">
                  <c:v>3.562522265764162E-2</c:v>
                </c:pt>
                <c:pt idx="11">
                  <c:v>2.6540790879943009E-2</c:v>
                </c:pt>
                <c:pt idx="12">
                  <c:v>2.3334520840755296E-2</c:v>
                </c:pt>
                <c:pt idx="13">
                  <c:v>1.3003206270039199E-2</c:v>
                </c:pt>
                <c:pt idx="14">
                  <c:v>9.9750623441396593E-3</c:v>
                </c:pt>
                <c:pt idx="15">
                  <c:v>8.3719273245457856E-3</c:v>
                </c:pt>
                <c:pt idx="16">
                  <c:v>5.1656572853580329E-3</c:v>
                </c:pt>
                <c:pt idx="17">
                  <c:v>3.9187744923405822E-3</c:v>
                </c:pt>
                <c:pt idx="18">
                  <c:v>4.0969006056287916E-3</c:v>
                </c:pt>
                <c:pt idx="19">
                  <c:v>3.2062700391877409E-3</c:v>
                </c:pt>
                <c:pt idx="20">
                  <c:v>2.4937655860349122E-3</c:v>
                </c:pt>
              </c:numCache>
            </c:numRef>
          </c:val>
        </c:ser>
        <c:ser>
          <c:idx val="11"/>
          <c:order val="11"/>
          <c:tx>
            <c:strRef>
              <c:f>'N2 A1_0.02_5%'!$M$104</c:f>
              <c:strCache>
                <c:ptCount val="1"/>
                <c:pt idx="0">
                  <c:v>N2_REX_A1_12</c:v>
                </c:pt>
              </c:strCache>
            </c:strRef>
          </c:tx>
          <c:marker>
            <c:symbol val="none"/>
          </c:marker>
          <c:cat>
            <c:numRef>
              <c:f>'N2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00000000000000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000000000000006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000000000000019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1_0.02_5%'!$M$105:$M$125</c:f>
              <c:numCache>
                <c:formatCode>General</c:formatCode>
                <c:ptCount val="21"/>
                <c:pt idx="1">
                  <c:v>7.8418117289166839E-2</c:v>
                </c:pt>
                <c:pt idx="2">
                  <c:v>0.10512083826263308</c:v>
                </c:pt>
                <c:pt idx="3">
                  <c:v>0.12320432651681607</c:v>
                </c:pt>
                <c:pt idx="4">
                  <c:v>0.13351360486733113</c:v>
                </c:pt>
                <c:pt idx="5">
                  <c:v>0.12151428088558408</c:v>
                </c:pt>
                <c:pt idx="6">
                  <c:v>7.7066080784181284E-2</c:v>
                </c:pt>
                <c:pt idx="7">
                  <c:v>7.4023998647963524E-2</c:v>
                </c:pt>
                <c:pt idx="8">
                  <c:v>5.357444651005578E-2</c:v>
                </c:pt>
                <c:pt idx="9">
                  <c:v>4.3772181848909936E-2</c:v>
                </c:pt>
                <c:pt idx="10">
                  <c:v>3.2786885245901599E-2</c:v>
                </c:pt>
                <c:pt idx="11">
                  <c:v>2.7378739225959126E-2</c:v>
                </c:pt>
                <c:pt idx="12">
                  <c:v>1.7238465438566813E-2</c:v>
                </c:pt>
                <c:pt idx="13">
                  <c:v>1.4872401554842001E-2</c:v>
                </c:pt>
                <c:pt idx="14">
                  <c:v>9.9712692242690682E-3</c:v>
                </c:pt>
                <c:pt idx="15">
                  <c:v>9.9712692242690682E-3</c:v>
                </c:pt>
                <c:pt idx="16">
                  <c:v>7.2671962142977905E-3</c:v>
                </c:pt>
                <c:pt idx="17">
                  <c:v>5.9151597093121547E-3</c:v>
                </c:pt>
                <c:pt idx="18">
                  <c:v>4.0561095149569014E-3</c:v>
                </c:pt>
                <c:pt idx="19">
                  <c:v>2.5350684468480596E-3</c:v>
                </c:pt>
                <c:pt idx="20">
                  <c:v>3.0420821362176801E-3</c:v>
                </c:pt>
              </c:numCache>
            </c:numRef>
          </c:val>
        </c:ser>
        <c:marker val="1"/>
        <c:axId val="146723200"/>
        <c:axId val="146724736"/>
      </c:lineChart>
      <c:catAx>
        <c:axId val="146723200"/>
        <c:scaling>
          <c:orientation val="minMax"/>
        </c:scaling>
        <c:axPos val="b"/>
        <c:numFmt formatCode="#,##0.0_);\(#,##0.0\)" sourceLinked="0"/>
        <c:tickLblPos val="nextTo"/>
        <c:crossAx val="146724736"/>
        <c:crosses val="autoZero"/>
        <c:auto val="1"/>
        <c:lblAlgn val="ctr"/>
        <c:lblOffset val="100"/>
        <c:tickLblSkip val="5"/>
        <c:tickMarkSkip val="5"/>
      </c:catAx>
      <c:valAx>
        <c:axId val="14672473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46723200"/>
        <c:crosses val="autoZero"/>
        <c:crossBetween val="between"/>
      </c:valAx>
    </c:plotArea>
    <c:plotVisOnly val="1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2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A2_0.02_5%'!$B$104</c:f>
              <c:strCache>
                <c:ptCount val="1"/>
                <c:pt idx="0">
                  <c:v>unc-25_A2_40_30_01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B$105:$B$125</c:f>
              <c:numCache>
                <c:formatCode>General</c:formatCode>
                <c:ptCount val="21"/>
                <c:pt idx="1">
                  <c:v>8.6956521739130446E-2</c:v>
                </c:pt>
                <c:pt idx="2">
                  <c:v>0.10111223458038403</c:v>
                </c:pt>
                <c:pt idx="3">
                  <c:v>0.12082912032355904</c:v>
                </c:pt>
                <c:pt idx="4">
                  <c:v>9.807886754297275E-2</c:v>
                </c:pt>
                <c:pt idx="5">
                  <c:v>8.6450960566228544E-2</c:v>
                </c:pt>
                <c:pt idx="6">
                  <c:v>6.6228513650151699E-2</c:v>
                </c:pt>
                <c:pt idx="7">
                  <c:v>5.3083923154701736E-2</c:v>
                </c:pt>
                <c:pt idx="8">
                  <c:v>5.3083923154701736E-2</c:v>
                </c:pt>
                <c:pt idx="9">
                  <c:v>4.1456016177957487E-2</c:v>
                </c:pt>
                <c:pt idx="10">
                  <c:v>3.1850353892821009E-2</c:v>
                </c:pt>
                <c:pt idx="11">
                  <c:v>3.1850353892821009E-2</c:v>
                </c:pt>
                <c:pt idx="12">
                  <c:v>2.7805864509605718E-2</c:v>
                </c:pt>
                <c:pt idx="13">
                  <c:v>2.5278058645096108E-2</c:v>
                </c:pt>
                <c:pt idx="14">
                  <c:v>2.3761375126390306E-2</c:v>
                </c:pt>
                <c:pt idx="15">
                  <c:v>1.8705763397371105E-2</c:v>
                </c:pt>
                <c:pt idx="16">
                  <c:v>1.01112234580384E-2</c:v>
                </c:pt>
                <c:pt idx="17">
                  <c:v>9.6056622851365039E-3</c:v>
                </c:pt>
                <c:pt idx="18">
                  <c:v>1.01112234580384E-2</c:v>
                </c:pt>
                <c:pt idx="19">
                  <c:v>3.5389282103134509E-3</c:v>
                </c:pt>
                <c:pt idx="20">
                  <c:v>3.5389282103134509E-3</c:v>
                </c:pt>
              </c:numCache>
            </c:numRef>
          </c:val>
        </c:ser>
        <c:ser>
          <c:idx val="1"/>
          <c:order val="1"/>
          <c:tx>
            <c:strRef>
              <c:f>'unc-25 A2_0.02_5%'!$C$104</c:f>
              <c:strCache>
                <c:ptCount val="1"/>
                <c:pt idx="0">
                  <c:v>unc-25_A2_40_30_02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C$105:$C$125</c:f>
              <c:numCache>
                <c:formatCode>General</c:formatCode>
                <c:ptCount val="21"/>
                <c:pt idx="1">
                  <c:v>7.6849183477425601E-2</c:v>
                </c:pt>
                <c:pt idx="2">
                  <c:v>8.5014409221901996E-2</c:v>
                </c:pt>
                <c:pt idx="3">
                  <c:v>9.9903938520653254E-2</c:v>
                </c:pt>
                <c:pt idx="4">
                  <c:v>9.2699327569644621E-2</c:v>
                </c:pt>
                <c:pt idx="5">
                  <c:v>6.9164265129683031E-2</c:v>
                </c:pt>
                <c:pt idx="6">
                  <c:v>5.0432276657060515E-2</c:v>
                </c:pt>
                <c:pt idx="7">
                  <c:v>4.9951969260326599E-2</c:v>
                </c:pt>
                <c:pt idx="8">
                  <c:v>4.2747358309318001E-2</c:v>
                </c:pt>
                <c:pt idx="9">
                  <c:v>4.3227665706051882E-2</c:v>
                </c:pt>
                <c:pt idx="10">
                  <c:v>3.6503362151777116E-2</c:v>
                </c:pt>
                <c:pt idx="11">
                  <c:v>3.7463976945245017E-2</c:v>
                </c:pt>
                <c:pt idx="12">
                  <c:v>3.7463976945245017E-2</c:v>
                </c:pt>
                <c:pt idx="13">
                  <c:v>3.5542747358309312E-2</c:v>
                </c:pt>
                <c:pt idx="14">
                  <c:v>3.314121037463981E-2</c:v>
                </c:pt>
                <c:pt idx="15">
                  <c:v>3.5542747358309312E-2</c:v>
                </c:pt>
                <c:pt idx="16">
                  <c:v>3.2180595581172013E-2</c:v>
                </c:pt>
                <c:pt idx="17">
                  <c:v>2.6897214217098907E-2</c:v>
                </c:pt>
                <c:pt idx="18">
                  <c:v>1.7291066282420799E-2</c:v>
                </c:pt>
                <c:pt idx="19">
                  <c:v>1.3448607108549499E-2</c:v>
                </c:pt>
                <c:pt idx="20">
                  <c:v>8.1652257444764561E-3</c:v>
                </c:pt>
              </c:numCache>
            </c:numRef>
          </c:val>
        </c:ser>
        <c:ser>
          <c:idx val="2"/>
          <c:order val="2"/>
          <c:tx>
            <c:strRef>
              <c:f>'unc-25 A2_0.02_5%'!$D$104</c:f>
              <c:strCache>
                <c:ptCount val="1"/>
                <c:pt idx="0">
                  <c:v>unc-25_A2_40_30_03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D$105:$D$125</c:f>
              <c:numCache>
                <c:formatCode>General</c:formatCode>
                <c:ptCount val="21"/>
                <c:pt idx="1">
                  <c:v>8.0000000000000029E-2</c:v>
                </c:pt>
                <c:pt idx="2">
                  <c:v>0.11125</c:v>
                </c:pt>
                <c:pt idx="3">
                  <c:v>8.6250000000000007E-2</c:v>
                </c:pt>
                <c:pt idx="4">
                  <c:v>0.11</c:v>
                </c:pt>
                <c:pt idx="5">
                  <c:v>7.3749999999999996E-2</c:v>
                </c:pt>
                <c:pt idx="6">
                  <c:v>5.8749999999999997E-2</c:v>
                </c:pt>
                <c:pt idx="7">
                  <c:v>6.3750000000000001E-2</c:v>
                </c:pt>
                <c:pt idx="8">
                  <c:v>0.05</c:v>
                </c:pt>
                <c:pt idx="9">
                  <c:v>3.3750000000000002E-2</c:v>
                </c:pt>
                <c:pt idx="10">
                  <c:v>3.875E-2</c:v>
                </c:pt>
                <c:pt idx="11">
                  <c:v>2.7500000000000007E-2</c:v>
                </c:pt>
                <c:pt idx="12">
                  <c:v>3.2500000000000001E-2</c:v>
                </c:pt>
                <c:pt idx="13">
                  <c:v>3.6250000000000011E-2</c:v>
                </c:pt>
                <c:pt idx="14">
                  <c:v>2.3749999999999997E-2</c:v>
                </c:pt>
                <c:pt idx="15">
                  <c:v>2.6250000000000002E-2</c:v>
                </c:pt>
                <c:pt idx="16">
                  <c:v>1.6250000000000001E-2</c:v>
                </c:pt>
                <c:pt idx="17">
                  <c:v>1.1250000000000001E-2</c:v>
                </c:pt>
                <c:pt idx="18">
                  <c:v>1.7500000000000005E-2</c:v>
                </c:pt>
                <c:pt idx="19">
                  <c:v>1.2500000000000001E-2</c:v>
                </c:pt>
                <c:pt idx="20">
                  <c:v>5.0000000000000018E-3</c:v>
                </c:pt>
              </c:numCache>
            </c:numRef>
          </c:val>
        </c:ser>
        <c:ser>
          <c:idx val="3"/>
          <c:order val="3"/>
          <c:tx>
            <c:strRef>
              <c:f>'unc-25 A2_0.02_5%'!$E$104</c:f>
              <c:strCache>
                <c:ptCount val="1"/>
                <c:pt idx="0">
                  <c:v>unc-25_REX_A2_03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E$105:$E$125</c:f>
              <c:numCache>
                <c:formatCode>General</c:formatCode>
                <c:ptCount val="21"/>
                <c:pt idx="1">
                  <c:v>7.3104936606420312E-2</c:v>
                </c:pt>
                <c:pt idx="2">
                  <c:v>8.8211491772322598E-2</c:v>
                </c:pt>
                <c:pt idx="3">
                  <c:v>9.4955489614243341E-2</c:v>
                </c:pt>
                <c:pt idx="4">
                  <c:v>0.10628540598867009</c:v>
                </c:pt>
                <c:pt idx="5">
                  <c:v>8.8211491772322598E-2</c:v>
                </c:pt>
                <c:pt idx="6">
                  <c:v>6.8788777987591032E-2</c:v>
                </c:pt>
                <c:pt idx="7">
                  <c:v>6.0695980577286215E-2</c:v>
                </c:pt>
                <c:pt idx="8">
                  <c:v>4.2352306447261914E-2</c:v>
                </c:pt>
                <c:pt idx="9">
                  <c:v>4.720798489344482E-2</c:v>
                </c:pt>
                <c:pt idx="10">
                  <c:v>3.8575667655786405E-2</c:v>
                </c:pt>
                <c:pt idx="11">
                  <c:v>3.9384947396816805E-2</c:v>
                </c:pt>
                <c:pt idx="12">
                  <c:v>3.7226868087402214E-2</c:v>
                </c:pt>
                <c:pt idx="13">
                  <c:v>2.6706231454005899E-2</c:v>
                </c:pt>
                <c:pt idx="14">
                  <c:v>2.5627191799298597E-2</c:v>
                </c:pt>
                <c:pt idx="15">
                  <c:v>1.9962233612085208E-2</c:v>
                </c:pt>
                <c:pt idx="16">
                  <c:v>2.0771513353115705E-2</c:v>
                </c:pt>
                <c:pt idx="17">
                  <c:v>1.2139196115457199E-2</c:v>
                </c:pt>
                <c:pt idx="18">
                  <c:v>9.7113568923658002E-3</c:v>
                </c:pt>
                <c:pt idx="19">
                  <c:v>8.6323172376584854E-3</c:v>
                </c:pt>
                <c:pt idx="20">
                  <c:v>4.0463987051524136E-3</c:v>
                </c:pt>
              </c:numCache>
            </c:numRef>
          </c:val>
        </c:ser>
        <c:ser>
          <c:idx val="4"/>
          <c:order val="4"/>
          <c:tx>
            <c:strRef>
              <c:f>'unc-25 A2_0.02_5%'!$F$104</c:f>
              <c:strCache>
                <c:ptCount val="1"/>
                <c:pt idx="0">
                  <c:v>unc-25_REX_A2_04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F$105:$F$125</c:f>
              <c:numCache>
                <c:formatCode>General</c:formatCode>
                <c:ptCount val="21"/>
                <c:pt idx="1">
                  <c:v>9.3740640910452241E-2</c:v>
                </c:pt>
                <c:pt idx="2">
                  <c:v>0.10092842168313899</c:v>
                </c:pt>
                <c:pt idx="3">
                  <c:v>0.10272536687631004</c:v>
                </c:pt>
                <c:pt idx="4">
                  <c:v>9.134471398622343E-2</c:v>
                </c:pt>
                <c:pt idx="5">
                  <c:v>7.6370170709793406E-2</c:v>
                </c:pt>
                <c:pt idx="6">
                  <c:v>5.9598682240191742E-2</c:v>
                </c:pt>
                <c:pt idx="7">
                  <c:v>4.7319556753519003E-2</c:v>
                </c:pt>
                <c:pt idx="8">
                  <c:v>3.5938903863432202E-2</c:v>
                </c:pt>
                <c:pt idx="9">
                  <c:v>3.7436358191075214E-2</c:v>
                </c:pt>
                <c:pt idx="10">
                  <c:v>4.1629230308475589E-2</c:v>
                </c:pt>
                <c:pt idx="11">
                  <c:v>3.2045522611560413E-2</c:v>
                </c:pt>
                <c:pt idx="12">
                  <c:v>3.2045522611560413E-2</c:v>
                </c:pt>
                <c:pt idx="13">
                  <c:v>2.6055705300988299E-2</c:v>
                </c:pt>
                <c:pt idx="14">
                  <c:v>2.2761305780173723E-2</c:v>
                </c:pt>
                <c:pt idx="15">
                  <c:v>2.1263851452530701E-2</c:v>
                </c:pt>
                <c:pt idx="16">
                  <c:v>1.1081162024558304E-2</c:v>
                </c:pt>
                <c:pt idx="17">
                  <c:v>1.5274034141958701E-2</c:v>
                </c:pt>
                <c:pt idx="18">
                  <c:v>1.07816711590297E-2</c:v>
                </c:pt>
                <c:pt idx="19">
                  <c:v>5.9898173105720322E-3</c:v>
                </c:pt>
                <c:pt idx="20">
                  <c:v>3.893381251871822E-3</c:v>
                </c:pt>
              </c:numCache>
            </c:numRef>
          </c:val>
        </c:ser>
        <c:ser>
          <c:idx val="5"/>
          <c:order val="5"/>
          <c:tx>
            <c:strRef>
              <c:f>'unc-25 A2_0.02_5%'!$G$104</c:f>
              <c:strCache>
                <c:ptCount val="1"/>
                <c:pt idx="0">
                  <c:v>unc-25_REX_A2_05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G$105:$G$125</c:f>
              <c:numCache>
                <c:formatCode>General</c:formatCode>
                <c:ptCount val="21"/>
                <c:pt idx="1">
                  <c:v>0.1</c:v>
                </c:pt>
                <c:pt idx="2">
                  <c:v>0.10375000000000002</c:v>
                </c:pt>
                <c:pt idx="3">
                  <c:v>0.11093749999999995</c:v>
                </c:pt>
                <c:pt idx="4">
                  <c:v>8.9375000000000024E-2</c:v>
                </c:pt>
                <c:pt idx="5">
                  <c:v>5.5312500000000021E-2</c:v>
                </c:pt>
                <c:pt idx="6">
                  <c:v>4.2500000000000003E-2</c:v>
                </c:pt>
                <c:pt idx="7">
                  <c:v>3.2812500000000001E-2</c:v>
                </c:pt>
                <c:pt idx="8">
                  <c:v>2.5937499999999999E-2</c:v>
                </c:pt>
                <c:pt idx="9">
                  <c:v>2.6250000000000002E-2</c:v>
                </c:pt>
                <c:pt idx="10">
                  <c:v>2.4687500000000001E-2</c:v>
                </c:pt>
                <c:pt idx="11">
                  <c:v>2.8749999999999998E-2</c:v>
                </c:pt>
                <c:pt idx="12">
                  <c:v>3.15625E-2</c:v>
                </c:pt>
                <c:pt idx="13">
                  <c:v>3.5312499999999997E-2</c:v>
                </c:pt>
                <c:pt idx="14">
                  <c:v>2.7187500000000007E-2</c:v>
                </c:pt>
                <c:pt idx="15">
                  <c:v>2.1562499999999988E-2</c:v>
                </c:pt>
                <c:pt idx="16">
                  <c:v>2.0625000000000001E-2</c:v>
                </c:pt>
                <c:pt idx="17">
                  <c:v>1.7812499999999998E-2</c:v>
                </c:pt>
                <c:pt idx="18">
                  <c:v>2.0000000000000007E-2</c:v>
                </c:pt>
                <c:pt idx="19">
                  <c:v>1.2500000000000001E-2</c:v>
                </c:pt>
                <c:pt idx="20">
                  <c:v>7.1875000000000003E-3</c:v>
                </c:pt>
              </c:numCache>
            </c:numRef>
          </c:val>
        </c:ser>
        <c:ser>
          <c:idx val="6"/>
          <c:order val="6"/>
          <c:tx>
            <c:strRef>
              <c:f>'unc-25 A2_0.02_5%'!$H$104</c:f>
              <c:strCache>
                <c:ptCount val="1"/>
                <c:pt idx="0">
                  <c:v>unc-25_REX_A2_06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H$105:$H$125</c:f>
              <c:numCache>
                <c:formatCode>General</c:formatCode>
                <c:ptCount val="21"/>
                <c:pt idx="1">
                  <c:v>8.3489096573208701E-2</c:v>
                </c:pt>
                <c:pt idx="2">
                  <c:v>8.5981308411215013E-2</c:v>
                </c:pt>
                <c:pt idx="3">
                  <c:v>9.8442367601246097E-2</c:v>
                </c:pt>
                <c:pt idx="4">
                  <c:v>9.0965732087227441E-2</c:v>
                </c:pt>
                <c:pt idx="5">
                  <c:v>8.0373831775700899E-2</c:v>
                </c:pt>
                <c:pt idx="6">
                  <c:v>4.4236760124610627E-2</c:v>
                </c:pt>
                <c:pt idx="7">
                  <c:v>4.0809968847352003E-2</c:v>
                </c:pt>
                <c:pt idx="8">
                  <c:v>3.0841121495327115E-2</c:v>
                </c:pt>
                <c:pt idx="9">
                  <c:v>3.4890965732087199E-2</c:v>
                </c:pt>
                <c:pt idx="10">
                  <c:v>3.7383177570093525E-2</c:v>
                </c:pt>
                <c:pt idx="11">
                  <c:v>2.8037383177570117E-2</c:v>
                </c:pt>
                <c:pt idx="12">
                  <c:v>3.707165109034271E-2</c:v>
                </c:pt>
                <c:pt idx="13">
                  <c:v>2.8660436137071685E-2</c:v>
                </c:pt>
                <c:pt idx="14">
                  <c:v>2.8660436137071685E-2</c:v>
                </c:pt>
                <c:pt idx="15">
                  <c:v>2.4299065420560709E-2</c:v>
                </c:pt>
                <c:pt idx="16">
                  <c:v>2.9595015576324019E-2</c:v>
                </c:pt>
                <c:pt idx="17">
                  <c:v>2.5856697819314611E-2</c:v>
                </c:pt>
                <c:pt idx="18">
                  <c:v>1.9003115264797511E-2</c:v>
                </c:pt>
                <c:pt idx="19">
                  <c:v>9.9688473520249243E-3</c:v>
                </c:pt>
                <c:pt idx="20">
                  <c:v>9.9688473520249243E-3</c:v>
                </c:pt>
              </c:numCache>
            </c:numRef>
          </c:val>
        </c:ser>
        <c:ser>
          <c:idx val="7"/>
          <c:order val="7"/>
          <c:tx>
            <c:strRef>
              <c:f>'unc-25 A2_0.02_5%'!$I$104</c:f>
              <c:strCache>
                <c:ptCount val="1"/>
                <c:pt idx="0">
                  <c:v>unc-25_REX_A2_08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I$105:$I$125</c:f>
              <c:numCache>
                <c:formatCode>General</c:formatCode>
                <c:ptCount val="21"/>
                <c:pt idx="1">
                  <c:v>9.7730600292825806E-2</c:v>
                </c:pt>
                <c:pt idx="2">
                  <c:v>0.11493411420205002</c:v>
                </c:pt>
                <c:pt idx="3">
                  <c:v>9.9560761346998539E-2</c:v>
                </c:pt>
                <c:pt idx="4">
                  <c:v>9.0775988286969339E-2</c:v>
                </c:pt>
                <c:pt idx="5">
                  <c:v>7.5402635431918025E-2</c:v>
                </c:pt>
                <c:pt idx="6">
                  <c:v>5.6368960468521211E-2</c:v>
                </c:pt>
                <c:pt idx="7">
                  <c:v>3.8067349926793614E-2</c:v>
                </c:pt>
                <c:pt idx="8">
                  <c:v>3.3674963396778897E-2</c:v>
                </c:pt>
                <c:pt idx="9">
                  <c:v>3.95314787701318E-2</c:v>
                </c:pt>
                <c:pt idx="10">
                  <c:v>2.85505124450952E-2</c:v>
                </c:pt>
                <c:pt idx="11">
                  <c:v>3.4040995607613513E-2</c:v>
                </c:pt>
                <c:pt idx="12">
                  <c:v>2.7086383601757007E-2</c:v>
                </c:pt>
                <c:pt idx="13">
                  <c:v>2.48901903367496E-2</c:v>
                </c:pt>
                <c:pt idx="14">
                  <c:v>2.85505124450952E-2</c:v>
                </c:pt>
                <c:pt idx="15">
                  <c:v>2.3792093704245992E-2</c:v>
                </c:pt>
                <c:pt idx="16">
                  <c:v>1.7935578330893105E-2</c:v>
                </c:pt>
                <c:pt idx="17">
                  <c:v>1.5007320644216707E-2</c:v>
                </c:pt>
                <c:pt idx="18">
                  <c:v>1.1346998535871199E-2</c:v>
                </c:pt>
                <c:pt idx="19">
                  <c:v>6.9546120058565225E-3</c:v>
                </c:pt>
                <c:pt idx="20">
                  <c:v>5.1244509516837483E-3</c:v>
                </c:pt>
              </c:numCache>
            </c:numRef>
          </c:val>
        </c:ser>
        <c:ser>
          <c:idx val="8"/>
          <c:order val="8"/>
          <c:tx>
            <c:strRef>
              <c:f>'unc-25 A2_0.02_5%'!$J$104</c:f>
              <c:strCache>
                <c:ptCount val="1"/>
                <c:pt idx="0">
                  <c:v>unc-25_REX_A2_09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J$105:$J$125</c:f>
              <c:numCache>
                <c:formatCode>General</c:formatCode>
                <c:ptCount val="21"/>
                <c:pt idx="1">
                  <c:v>9.4922737306843294E-2</c:v>
                </c:pt>
                <c:pt idx="2">
                  <c:v>0.10871964679911703</c:v>
                </c:pt>
                <c:pt idx="3">
                  <c:v>0.11920529801324503</c:v>
                </c:pt>
                <c:pt idx="4">
                  <c:v>9.2715231788079527E-2</c:v>
                </c:pt>
                <c:pt idx="5">
                  <c:v>7.339955849889622E-2</c:v>
                </c:pt>
                <c:pt idx="6">
                  <c:v>5.7671081677704183E-2</c:v>
                </c:pt>
                <c:pt idx="7">
                  <c:v>4.6909492273730702E-2</c:v>
                </c:pt>
                <c:pt idx="8">
                  <c:v>3.8907284768211897E-2</c:v>
                </c:pt>
                <c:pt idx="9">
                  <c:v>3.1456953642384114E-2</c:v>
                </c:pt>
                <c:pt idx="10">
                  <c:v>3.4768211920529805E-2</c:v>
                </c:pt>
                <c:pt idx="11">
                  <c:v>2.9801324503311313E-2</c:v>
                </c:pt>
                <c:pt idx="12">
                  <c:v>2.59381898454746E-2</c:v>
                </c:pt>
                <c:pt idx="13">
                  <c:v>2.4558498896247189E-2</c:v>
                </c:pt>
                <c:pt idx="14">
                  <c:v>2.01434878587196E-2</c:v>
                </c:pt>
                <c:pt idx="15">
                  <c:v>1.82119205298013E-2</c:v>
                </c:pt>
                <c:pt idx="16">
                  <c:v>1.3245033112582804E-2</c:v>
                </c:pt>
                <c:pt idx="17">
                  <c:v>1.0485651214128007E-2</c:v>
                </c:pt>
                <c:pt idx="18">
                  <c:v>8.8300220750551894E-3</c:v>
                </c:pt>
                <c:pt idx="19">
                  <c:v>4.6909492273730716E-3</c:v>
                </c:pt>
                <c:pt idx="20">
                  <c:v>3.0353200883002211E-3</c:v>
                </c:pt>
              </c:numCache>
            </c:numRef>
          </c:val>
        </c:ser>
        <c:ser>
          <c:idx val="9"/>
          <c:order val="9"/>
          <c:tx>
            <c:strRef>
              <c:f>'unc-25 A2_0.02_5%'!$K$104</c:f>
              <c:strCache>
                <c:ptCount val="1"/>
                <c:pt idx="0">
                  <c:v>unc-25_REX_A2_10</c:v>
                </c:pt>
              </c:strCache>
            </c:strRef>
          </c:tx>
          <c:marker>
            <c:symbol val="none"/>
          </c:marker>
          <c:cat>
            <c:numRef>
              <c:f>'unc-25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A2_0.02_5%'!$K$105:$K$125</c:f>
              <c:numCache>
                <c:formatCode>General</c:formatCode>
                <c:ptCount val="21"/>
                <c:pt idx="1">
                  <c:v>8.7626262626262663E-2</c:v>
                </c:pt>
                <c:pt idx="2">
                  <c:v>0.11691919191919201</c:v>
                </c:pt>
                <c:pt idx="3">
                  <c:v>0.11540404040404002</c:v>
                </c:pt>
                <c:pt idx="4">
                  <c:v>9.3939393939393975E-2</c:v>
                </c:pt>
                <c:pt idx="5">
                  <c:v>7.5757575757575801E-2</c:v>
                </c:pt>
                <c:pt idx="6">
                  <c:v>6.3888888888888898E-2</c:v>
                </c:pt>
                <c:pt idx="7">
                  <c:v>5.0252525252525319E-2</c:v>
                </c:pt>
                <c:pt idx="8">
                  <c:v>4.5454545454545497E-2</c:v>
                </c:pt>
                <c:pt idx="9">
                  <c:v>3.6616161616161602E-2</c:v>
                </c:pt>
                <c:pt idx="10">
                  <c:v>3.4595959595959604E-2</c:v>
                </c:pt>
                <c:pt idx="11">
                  <c:v>3.3333333333333298E-2</c:v>
                </c:pt>
                <c:pt idx="12">
                  <c:v>2.3989898989898999E-2</c:v>
                </c:pt>
                <c:pt idx="13">
                  <c:v>1.9949494949495009E-2</c:v>
                </c:pt>
                <c:pt idx="14">
                  <c:v>1.868686868686871E-2</c:v>
                </c:pt>
                <c:pt idx="15">
                  <c:v>1.3383838383838408E-2</c:v>
                </c:pt>
                <c:pt idx="16">
                  <c:v>1.3636363636363601E-2</c:v>
                </c:pt>
                <c:pt idx="17">
                  <c:v>8.0808080808080808E-3</c:v>
                </c:pt>
                <c:pt idx="18">
                  <c:v>1.1111111111111101E-2</c:v>
                </c:pt>
                <c:pt idx="19">
                  <c:v>5.0505050505050483E-3</c:v>
                </c:pt>
                <c:pt idx="20">
                  <c:v>3.0303030303030299E-3</c:v>
                </c:pt>
              </c:numCache>
            </c:numRef>
          </c:val>
        </c:ser>
        <c:marker val="1"/>
        <c:axId val="158259840"/>
        <c:axId val="158327168"/>
      </c:lineChart>
      <c:catAx>
        <c:axId val="158259840"/>
        <c:scaling>
          <c:orientation val="minMax"/>
        </c:scaling>
        <c:axPos val="b"/>
        <c:numFmt formatCode="0.0_ " sourceLinked="1"/>
        <c:tickLblPos val="nextTo"/>
        <c:crossAx val="158327168"/>
        <c:crosses val="autoZero"/>
        <c:auto val="1"/>
        <c:lblAlgn val="ctr"/>
        <c:lblOffset val="100"/>
        <c:tickLblSkip val="5"/>
        <c:tickMarkSkip val="5"/>
      </c:catAx>
      <c:valAx>
        <c:axId val="15832716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8259840"/>
        <c:crosses val="autoZero"/>
        <c:crossBetween val="between"/>
      </c:valAx>
    </c:plotArea>
    <c:plotVisOnly val="1"/>
  </c:chart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nm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mr-1(ak4)_A1_0.02_5%'!$B$104</c:f>
              <c:strCache>
                <c:ptCount val="1"/>
                <c:pt idx="0">
                  <c:v>nmr-1(ak4)_A1_01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B$105:$B$125</c:f>
              <c:numCache>
                <c:formatCode>General</c:formatCode>
                <c:ptCount val="21"/>
                <c:pt idx="1">
                  <c:v>5.9712773998488344E-2</c:v>
                </c:pt>
                <c:pt idx="2">
                  <c:v>0.10052910052910102</c:v>
                </c:pt>
                <c:pt idx="3">
                  <c:v>0.12169312169312205</c:v>
                </c:pt>
                <c:pt idx="4">
                  <c:v>0.13907785336356795</c:v>
                </c:pt>
                <c:pt idx="5">
                  <c:v>0.136054421768707</c:v>
                </c:pt>
                <c:pt idx="6">
                  <c:v>7.6341647770219206E-2</c:v>
                </c:pt>
                <c:pt idx="7">
                  <c:v>6.1980347694633398E-2</c:v>
                </c:pt>
                <c:pt idx="8">
                  <c:v>7.4074074074074098E-2</c:v>
                </c:pt>
                <c:pt idx="9">
                  <c:v>5.6689342403628079E-2</c:v>
                </c:pt>
                <c:pt idx="10">
                  <c:v>3.7037037037037014E-2</c:v>
                </c:pt>
                <c:pt idx="11">
                  <c:v>2.2675736961451209E-2</c:v>
                </c:pt>
                <c:pt idx="12">
                  <c:v>1.8140589569161016E-2</c:v>
                </c:pt>
                <c:pt idx="13">
                  <c:v>1.58730158730159E-2</c:v>
                </c:pt>
                <c:pt idx="14">
                  <c:v>9.8261526832955394E-3</c:v>
                </c:pt>
                <c:pt idx="15">
                  <c:v>5.2910052910052898E-3</c:v>
                </c:pt>
                <c:pt idx="16">
                  <c:v>6.0468631897203353E-3</c:v>
                </c:pt>
                <c:pt idx="17">
                  <c:v>1.5117157974300799E-3</c:v>
                </c:pt>
                <c:pt idx="18">
                  <c:v>7.5585789871504224E-4</c:v>
                </c:pt>
                <c:pt idx="19">
                  <c:v>3.023431594860172E-3</c:v>
                </c:pt>
                <c:pt idx="20">
                  <c:v>1.5117157974300799E-3</c:v>
                </c:pt>
              </c:numCache>
            </c:numRef>
          </c:val>
        </c:ser>
        <c:ser>
          <c:idx val="1"/>
          <c:order val="1"/>
          <c:tx>
            <c:strRef>
              <c:f>'nmr-1(ak4)_A1_0.02_5%'!$C$104</c:f>
              <c:strCache>
                <c:ptCount val="1"/>
                <c:pt idx="0">
                  <c:v>nmr-1(ak4)_A1_02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C$105:$C$125</c:f>
              <c:numCache>
                <c:formatCode>General</c:formatCode>
                <c:ptCount val="21"/>
                <c:pt idx="1">
                  <c:v>6.6666666666666693E-2</c:v>
                </c:pt>
                <c:pt idx="2">
                  <c:v>0.10406504065040703</c:v>
                </c:pt>
                <c:pt idx="3">
                  <c:v>0.11869918699187003</c:v>
                </c:pt>
                <c:pt idx="4">
                  <c:v>0.1447154471544721</c:v>
                </c:pt>
                <c:pt idx="5">
                  <c:v>0.12276422764227606</c:v>
                </c:pt>
                <c:pt idx="6">
                  <c:v>8.292682926829277E-2</c:v>
                </c:pt>
                <c:pt idx="7">
                  <c:v>6.910569105691064E-2</c:v>
                </c:pt>
                <c:pt idx="8">
                  <c:v>6.1788617886178919E-2</c:v>
                </c:pt>
                <c:pt idx="9">
                  <c:v>5.6097560975609813E-2</c:v>
                </c:pt>
                <c:pt idx="10">
                  <c:v>3.1707317073170725E-2</c:v>
                </c:pt>
                <c:pt idx="11">
                  <c:v>3.0894308943089407E-2</c:v>
                </c:pt>
                <c:pt idx="12">
                  <c:v>1.6260162601626001E-2</c:v>
                </c:pt>
                <c:pt idx="13">
                  <c:v>1.6260162601626001E-2</c:v>
                </c:pt>
                <c:pt idx="14">
                  <c:v>8.9430894308943146E-3</c:v>
                </c:pt>
                <c:pt idx="15">
                  <c:v>8.9430894308943146E-3</c:v>
                </c:pt>
                <c:pt idx="16">
                  <c:v>4.0650406504065002E-3</c:v>
                </c:pt>
                <c:pt idx="17">
                  <c:v>1.6260162601626005E-3</c:v>
                </c:pt>
                <c:pt idx="18">
                  <c:v>1.6260162601626005E-3</c:v>
                </c:pt>
                <c:pt idx="19">
                  <c:v>3.2520325203252002E-3</c:v>
                </c:pt>
                <c:pt idx="20">
                  <c:v>8.1300813008130103E-4</c:v>
                </c:pt>
              </c:numCache>
            </c:numRef>
          </c:val>
        </c:ser>
        <c:ser>
          <c:idx val="2"/>
          <c:order val="2"/>
          <c:tx>
            <c:strRef>
              <c:f>'nmr-1(ak4)_A1_0.02_5%'!$D$104</c:f>
              <c:strCache>
                <c:ptCount val="1"/>
                <c:pt idx="0">
                  <c:v>nmr-1(ak4)_A1_03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D$105:$D$125</c:f>
              <c:numCache>
                <c:formatCode>General</c:formatCode>
                <c:ptCount val="21"/>
                <c:pt idx="1">
                  <c:v>6.0478199718706001E-2</c:v>
                </c:pt>
                <c:pt idx="2">
                  <c:v>9.7749648382559798E-2</c:v>
                </c:pt>
                <c:pt idx="3">
                  <c:v>0.11954992967651203</c:v>
                </c:pt>
                <c:pt idx="4">
                  <c:v>0.15049226441631511</c:v>
                </c:pt>
                <c:pt idx="5">
                  <c:v>0.14486638537271407</c:v>
                </c:pt>
                <c:pt idx="6">
                  <c:v>7.5949367088607597E-2</c:v>
                </c:pt>
                <c:pt idx="7">
                  <c:v>6.4697609001406531E-2</c:v>
                </c:pt>
                <c:pt idx="8">
                  <c:v>5.3445850914205298E-2</c:v>
                </c:pt>
                <c:pt idx="9">
                  <c:v>4.8523206751054884E-2</c:v>
                </c:pt>
                <c:pt idx="10">
                  <c:v>3.7974683544303806E-2</c:v>
                </c:pt>
                <c:pt idx="11">
                  <c:v>1.9690576652602015E-2</c:v>
                </c:pt>
                <c:pt idx="12">
                  <c:v>2.2503516174402299E-2</c:v>
                </c:pt>
                <c:pt idx="13">
                  <c:v>1.5471167369901501E-2</c:v>
                </c:pt>
                <c:pt idx="14">
                  <c:v>1.4767932489451498E-2</c:v>
                </c:pt>
                <c:pt idx="15">
                  <c:v>5.6258790436005618E-3</c:v>
                </c:pt>
                <c:pt idx="16">
                  <c:v>2.1097046413502112E-3</c:v>
                </c:pt>
                <c:pt idx="17">
                  <c:v>2.81293952180028E-3</c:v>
                </c:pt>
                <c:pt idx="18">
                  <c:v>2.81293952180028E-3</c:v>
                </c:pt>
                <c:pt idx="19">
                  <c:v>2.1097046413502112E-3</c:v>
                </c:pt>
                <c:pt idx="20">
                  <c:v>1.40646976090014E-3</c:v>
                </c:pt>
              </c:numCache>
            </c:numRef>
          </c:val>
        </c:ser>
        <c:ser>
          <c:idx val="3"/>
          <c:order val="3"/>
          <c:tx>
            <c:strRef>
              <c:f>'nmr-1(ak4)_A1_0.02_5%'!$E$104</c:f>
              <c:strCache>
                <c:ptCount val="1"/>
                <c:pt idx="0">
                  <c:v>nmr-1(ak4)_A1_04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E$105:$E$125</c:f>
              <c:numCache>
                <c:formatCode>General</c:formatCode>
                <c:ptCount val="21"/>
                <c:pt idx="1">
                  <c:v>6.3847429519071311E-2</c:v>
                </c:pt>
                <c:pt idx="2">
                  <c:v>0.10033167495854105</c:v>
                </c:pt>
                <c:pt idx="3">
                  <c:v>0.12023217247097806</c:v>
                </c:pt>
                <c:pt idx="4">
                  <c:v>0.15671641791044807</c:v>
                </c:pt>
                <c:pt idx="5">
                  <c:v>0.13432835820895495</c:v>
                </c:pt>
                <c:pt idx="6">
                  <c:v>7.5456053067993412E-2</c:v>
                </c:pt>
                <c:pt idx="7">
                  <c:v>4.9751243781094495E-2</c:v>
                </c:pt>
                <c:pt idx="8">
                  <c:v>5.8872305140961902E-2</c:v>
                </c:pt>
                <c:pt idx="9">
                  <c:v>5.1409618573797687E-2</c:v>
                </c:pt>
                <c:pt idx="10">
                  <c:v>4.06301824212272E-2</c:v>
                </c:pt>
                <c:pt idx="11">
                  <c:v>2.2388059701492494E-2</c:v>
                </c:pt>
                <c:pt idx="12">
                  <c:v>1.9071310116086201E-2</c:v>
                </c:pt>
                <c:pt idx="13">
                  <c:v>1.3266998341625204E-2</c:v>
                </c:pt>
                <c:pt idx="14">
                  <c:v>9.9502487562189174E-3</c:v>
                </c:pt>
                <c:pt idx="15">
                  <c:v>1.0779436152570498E-2</c:v>
                </c:pt>
                <c:pt idx="16">
                  <c:v>5.8043117744610304E-3</c:v>
                </c:pt>
                <c:pt idx="17">
                  <c:v>4.9751243781094483E-3</c:v>
                </c:pt>
                <c:pt idx="18">
                  <c:v>4.9751243781094483E-3</c:v>
                </c:pt>
                <c:pt idx="19">
                  <c:v>4.1459369817578801E-3</c:v>
                </c:pt>
                <c:pt idx="20">
                  <c:v>0</c:v>
                </c:pt>
              </c:numCache>
            </c:numRef>
          </c:val>
        </c:ser>
        <c:ser>
          <c:idx val="4"/>
          <c:order val="4"/>
          <c:tx>
            <c:strRef>
              <c:f>'nmr-1(ak4)_A1_0.02_5%'!$F$104</c:f>
              <c:strCache>
                <c:ptCount val="1"/>
                <c:pt idx="0">
                  <c:v>nmr-1(ak4)_A1_05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F$105:$F$125</c:f>
              <c:numCache>
                <c:formatCode>General</c:formatCode>
                <c:ptCount val="21"/>
                <c:pt idx="1">
                  <c:v>6.65680473372781E-2</c:v>
                </c:pt>
                <c:pt idx="2">
                  <c:v>9.7633136094674597E-2</c:v>
                </c:pt>
                <c:pt idx="3">
                  <c:v>0.11168639053254401</c:v>
                </c:pt>
                <c:pt idx="4">
                  <c:v>0.13461538461538505</c:v>
                </c:pt>
                <c:pt idx="5">
                  <c:v>0.12869822485207105</c:v>
                </c:pt>
                <c:pt idx="6">
                  <c:v>8.1360946745562157E-2</c:v>
                </c:pt>
                <c:pt idx="7">
                  <c:v>7.2485207100591725E-2</c:v>
                </c:pt>
                <c:pt idx="8">
                  <c:v>6.2869822485207102E-2</c:v>
                </c:pt>
                <c:pt idx="9">
                  <c:v>4.1420118343195297E-2</c:v>
                </c:pt>
                <c:pt idx="10">
                  <c:v>4.4378698224852103E-2</c:v>
                </c:pt>
                <c:pt idx="11">
                  <c:v>2.73668639053254E-2</c:v>
                </c:pt>
                <c:pt idx="12">
                  <c:v>1.9970414201183409E-2</c:v>
                </c:pt>
                <c:pt idx="13">
                  <c:v>1.55325443786982E-2</c:v>
                </c:pt>
                <c:pt idx="14">
                  <c:v>1.03550295857988E-2</c:v>
                </c:pt>
                <c:pt idx="15">
                  <c:v>9.6153846153846281E-3</c:v>
                </c:pt>
                <c:pt idx="16">
                  <c:v>2.2189349112426019E-3</c:v>
                </c:pt>
                <c:pt idx="17">
                  <c:v>7.3964497041420149E-4</c:v>
                </c:pt>
                <c:pt idx="18">
                  <c:v>2.2189349112426019E-3</c:v>
                </c:pt>
                <c:pt idx="19">
                  <c:v>2.9585798816568008E-3</c:v>
                </c:pt>
                <c:pt idx="20">
                  <c:v>2.2189349112426019E-3</c:v>
                </c:pt>
              </c:numCache>
            </c:numRef>
          </c:val>
        </c:ser>
        <c:ser>
          <c:idx val="5"/>
          <c:order val="5"/>
          <c:tx>
            <c:strRef>
              <c:f>'nmr-1(ak4)_A1_0.02_5%'!$G$104</c:f>
              <c:strCache>
                <c:ptCount val="1"/>
                <c:pt idx="0">
                  <c:v>nmr-1(ak4)_A1_06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G$105:$G$125</c:f>
              <c:numCache>
                <c:formatCode>General</c:formatCode>
                <c:ptCount val="21"/>
                <c:pt idx="1">
                  <c:v>7.0859167404782986E-2</c:v>
                </c:pt>
                <c:pt idx="2">
                  <c:v>9.1231178033658128E-2</c:v>
                </c:pt>
                <c:pt idx="3">
                  <c:v>0.110717449069973</c:v>
                </c:pt>
                <c:pt idx="4">
                  <c:v>0.11868910540301203</c:v>
                </c:pt>
                <c:pt idx="5">
                  <c:v>0.11514614703277203</c:v>
                </c:pt>
                <c:pt idx="6">
                  <c:v>9.1231178033658128E-2</c:v>
                </c:pt>
                <c:pt idx="7">
                  <c:v>7.0859167404782986E-2</c:v>
                </c:pt>
                <c:pt idx="8">
                  <c:v>4.9601417183348116E-2</c:v>
                </c:pt>
                <c:pt idx="9">
                  <c:v>4.6058458813108903E-2</c:v>
                </c:pt>
                <c:pt idx="10">
                  <c:v>5.0487156775907878E-2</c:v>
                </c:pt>
                <c:pt idx="11">
                  <c:v>3.631532329495131E-2</c:v>
                </c:pt>
                <c:pt idx="12">
                  <c:v>2.3029229406554507E-2</c:v>
                </c:pt>
                <c:pt idx="13">
                  <c:v>1.1514614703277203E-2</c:v>
                </c:pt>
                <c:pt idx="14">
                  <c:v>2.0372010628875118E-2</c:v>
                </c:pt>
                <c:pt idx="15">
                  <c:v>5.3144375553587182E-3</c:v>
                </c:pt>
                <c:pt idx="16">
                  <c:v>9.7431355181576661E-3</c:v>
                </c:pt>
                <c:pt idx="17">
                  <c:v>1.240035429583701E-2</c:v>
                </c:pt>
                <c:pt idx="18">
                  <c:v>2.6572187776793617E-3</c:v>
                </c:pt>
                <c:pt idx="19">
                  <c:v>4.4286979627989418E-3</c:v>
                </c:pt>
                <c:pt idx="20">
                  <c:v>4.4286979627989418E-3</c:v>
                </c:pt>
              </c:numCache>
            </c:numRef>
          </c:val>
        </c:ser>
        <c:ser>
          <c:idx val="6"/>
          <c:order val="6"/>
          <c:tx>
            <c:strRef>
              <c:f>'nmr-1(ak4)_A1_0.02_5%'!$H$104</c:f>
              <c:strCache>
                <c:ptCount val="1"/>
                <c:pt idx="0">
                  <c:v>nmr-1(ak4)_A1_07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H$105:$H$125</c:f>
              <c:numCache>
                <c:formatCode>General</c:formatCode>
                <c:ptCount val="21"/>
                <c:pt idx="1">
                  <c:v>6.4414768263943434E-2</c:v>
                </c:pt>
                <c:pt idx="2">
                  <c:v>8.7981146897093507E-2</c:v>
                </c:pt>
                <c:pt idx="3">
                  <c:v>0.111547525530244</c:v>
                </c:pt>
                <c:pt idx="4">
                  <c:v>0.13589945011783211</c:v>
                </c:pt>
                <c:pt idx="5">
                  <c:v>0.12568735271013401</c:v>
                </c:pt>
                <c:pt idx="6">
                  <c:v>7.2270227808326842E-2</c:v>
                </c:pt>
                <c:pt idx="7">
                  <c:v>6.8342498036135124E-2</c:v>
                </c:pt>
                <c:pt idx="8">
                  <c:v>6.8342498036135124E-2</c:v>
                </c:pt>
                <c:pt idx="9">
                  <c:v>6.4414768263943434E-2</c:v>
                </c:pt>
                <c:pt idx="10">
                  <c:v>4.5561665357423418E-2</c:v>
                </c:pt>
                <c:pt idx="11">
                  <c:v>2.5923016496465008E-2</c:v>
                </c:pt>
                <c:pt idx="12">
                  <c:v>2.2780832678711713E-2</c:v>
                </c:pt>
                <c:pt idx="13">
                  <c:v>1.8853102906520001E-2</c:v>
                </c:pt>
                <c:pt idx="14">
                  <c:v>8.6410054988216804E-3</c:v>
                </c:pt>
                <c:pt idx="15">
                  <c:v>6.2843676355066836E-3</c:v>
                </c:pt>
                <c:pt idx="16">
                  <c:v>3.1421838177533418E-3</c:v>
                </c:pt>
                <c:pt idx="17">
                  <c:v>3.9277297721916722E-3</c:v>
                </c:pt>
                <c:pt idx="18">
                  <c:v>2.3566378633150002E-3</c:v>
                </c:pt>
                <c:pt idx="19">
                  <c:v>4.7132757266300116E-3</c:v>
                </c:pt>
                <c:pt idx="20">
                  <c:v>2.3566378633150002E-3</c:v>
                </c:pt>
              </c:numCache>
            </c:numRef>
          </c:val>
        </c:ser>
        <c:ser>
          <c:idx val="7"/>
          <c:order val="7"/>
          <c:tx>
            <c:strRef>
              <c:f>'nmr-1(ak4)_A1_0.02_5%'!$I$104</c:f>
              <c:strCache>
                <c:ptCount val="1"/>
                <c:pt idx="0">
                  <c:v>nmr-1(ak4)_A1_08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I$105:$I$125</c:f>
              <c:numCache>
                <c:formatCode>General</c:formatCode>
                <c:ptCount val="21"/>
                <c:pt idx="1">
                  <c:v>6.8219633943427643E-2</c:v>
                </c:pt>
                <c:pt idx="2">
                  <c:v>0.10981697171381004</c:v>
                </c:pt>
                <c:pt idx="3">
                  <c:v>0.11397670549084903</c:v>
                </c:pt>
                <c:pt idx="4">
                  <c:v>0.13394342762063199</c:v>
                </c:pt>
                <c:pt idx="5">
                  <c:v>0.11647254575707203</c:v>
                </c:pt>
                <c:pt idx="6">
                  <c:v>8.1530782029950094E-2</c:v>
                </c:pt>
                <c:pt idx="7">
                  <c:v>6.4891846921797003E-2</c:v>
                </c:pt>
                <c:pt idx="8">
                  <c:v>6.4059900166389405E-2</c:v>
                </c:pt>
                <c:pt idx="9">
                  <c:v>5.8236272878535819E-2</c:v>
                </c:pt>
                <c:pt idx="10">
                  <c:v>3.2445923460898515E-2</c:v>
                </c:pt>
                <c:pt idx="11">
                  <c:v>2.6622296173044908E-2</c:v>
                </c:pt>
                <c:pt idx="12">
                  <c:v>2.0798668885191302E-2</c:v>
                </c:pt>
                <c:pt idx="13">
                  <c:v>1.58069883527454E-2</c:v>
                </c:pt>
                <c:pt idx="14">
                  <c:v>8.3194675540765491E-3</c:v>
                </c:pt>
                <c:pt idx="15">
                  <c:v>4.9916805324459199E-3</c:v>
                </c:pt>
                <c:pt idx="16">
                  <c:v>4.9916805324459199E-3</c:v>
                </c:pt>
                <c:pt idx="17">
                  <c:v>3.3277870216306218E-3</c:v>
                </c:pt>
                <c:pt idx="18">
                  <c:v>1.6638935108153105E-3</c:v>
                </c:pt>
                <c:pt idx="19">
                  <c:v>1.6638935108153105E-3</c:v>
                </c:pt>
                <c:pt idx="20">
                  <c:v>8.319467554076548E-4</c:v>
                </c:pt>
              </c:numCache>
            </c:numRef>
          </c:val>
        </c:ser>
        <c:ser>
          <c:idx val="8"/>
          <c:order val="8"/>
          <c:tx>
            <c:strRef>
              <c:f>'nmr-1(ak4)_A1_0.02_5%'!$J$104</c:f>
              <c:strCache>
                <c:ptCount val="1"/>
                <c:pt idx="0">
                  <c:v>nmr-1(ak4)_A1_09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J$105:$J$125</c:f>
              <c:numCache>
                <c:formatCode>General</c:formatCode>
                <c:ptCount val="21"/>
                <c:pt idx="1">
                  <c:v>4.9242424242424226E-2</c:v>
                </c:pt>
                <c:pt idx="2">
                  <c:v>0.118181818181818</c:v>
                </c:pt>
                <c:pt idx="3">
                  <c:v>0.112878787878788</c:v>
                </c:pt>
                <c:pt idx="4">
                  <c:v>0.14090909090909107</c:v>
                </c:pt>
                <c:pt idx="5">
                  <c:v>0.12045454545454502</c:v>
                </c:pt>
                <c:pt idx="6">
                  <c:v>7.34848484848485E-2</c:v>
                </c:pt>
                <c:pt idx="7">
                  <c:v>6.5909090909090903E-2</c:v>
                </c:pt>
                <c:pt idx="8">
                  <c:v>6.8181818181818205E-2</c:v>
                </c:pt>
                <c:pt idx="9">
                  <c:v>4.6969696969697002E-2</c:v>
                </c:pt>
                <c:pt idx="10">
                  <c:v>4.3181818181818189E-2</c:v>
                </c:pt>
                <c:pt idx="11">
                  <c:v>3.1818181818181801E-2</c:v>
                </c:pt>
                <c:pt idx="12">
                  <c:v>2.12121212121212E-2</c:v>
                </c:pt>
                <c:pt idx="13">
                  <c:v>1.43939393939394E-2</c:v>
                </c:pt>
                <c:pt idx="14">
                  <c:v>9.0909090909090991E-3</c:v>
                </c:pt>
                <c:pt idx="15">
                  <c:v>1.6666666666666701E-2</c:v>
                </c:pt>
                <c:pt idx="16">
                  <c:v>3.7878787878787919E-3</c:v>
                </c:pt>
                <c:pt idx="17">
                  <c:v>6.8181818181818196E-3</c:v>
                </c:pt>
                <c:pt idx="18">
                  <c:v>3.7878787878787919E-3</c:v>
                </c:pt>
                <c:pt idx="19">
                  <c:v>7.5757575757575823E-4</c:v>
                </c:pt>
                <c:pt idx="20">
                  <c:v>3.0303030303030299E-3</c:v>
                </c:pt>
              </c:numCache>
            </c:numRef>
          </c:val>
        </c:ser>
        <c:ser>
          <c:idx val="9"/>
          <c:order val="9"/>
          <c:tx>
            <c:strRef>
              <c:f>'nmr-1(ak4)_A1_0.02_5%'!$K$104</c:f>
              <c:strCache>
                <c:ptCount val="1"/>
                <c:pt idx="0">
                  <c:v>nmr-1(ak4)_A1_10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K$105:$K$125</c:f>
              <c:numCache>
                <c:formatCode>General</c:formatCode>
                <c:ptCount val="21"/>
                <c:pt idx="1">
                  <c:v>5.1038062283736987E-2</c:v>
                </c:pt>
                <c:pt idx="2">
                  <c:v>0.106401384083045</c:v>
                </c:pt>
                <c:pt idx="3">
                  <c:v>0.11937716262975796</c:v>
                </c:pt>
                <c:pt idx="4">
                  <c:v>0.143598615916955</c:v>
                </c:pt>
                <c:pt idx="5">
                  <c:v>0.13235294117647106</c:v>
                </c:pt>
                <c:pt idx="6">
                  <c:v>7.871972318339103E-2</c:v>
                </c:pt>
                <c:pt idx="7">
                  <c:v>6.7474048442906595E-2</c:v>
                </c:pt>
                <c:pt idx="8">
                  <c:v>6.6608996539792395E-2</c:v>
                </c:pt>
                <c:pt idx="9">
                  <c:v>4.6712802768166098E-2</c:v>
                </c:pt>
                <c:pt idx="10">
                  <c:v>3.2006920415224918E-2</c:v>
                </c:pt>
                <c:pt idx="11">
                  <c:v>2.2491349480968922E-2</c:v>
                </c:pt>
                <c:pt idx="12">
                  <c:v>1.9896193771626301E-2</c:v>
                </c:pt>
                <c:pt idx="13">
                  <c:v>2.2491349480968922E-2</c:v>
                </c:pt>
                <c:pt idx="14">
                  <c:v>8.6505190311418744E-3</c:v>
                </c:pt>
                <c:pt idx="15">
                  <c:v>3.4602076124567518E-3</c:v>
                </c:pt>
                <c:pt idx="16">
                  <c:v>7.7854671280276838E-3</c:v>
                </c:pt>
                <c:pt idx="17">
                  <c:v>5.1903114186851217E-3</c:v>
                </c:pt>
                <c:pt idx="18">
                  <c:v>6.0553633217993123E-3</c:v>
                </c:pt>
                <c:pt idx="19">
                  <c:v>3.4602076124567518E-3</c:v>
                </c:pt>
                <c:pt idx="20">
                  <c:v>2.5951557093425608E-3</c:v>
                </c:pt>
              </c:numCache>
            </c:numRef>
          </c:val>
        </c:ser>
        <c:ser>
          <c:idx val="10"/>
          <c:order val="10"/>
          <c:tx>
            <c:strRef>
              <c:f>'nmr-1(ak4)_A1_0.02_5%'!$L$104</c:f>
              <c:strCache>
                <c:ptCount val="1"/>
                <c:pt idx="0">
                  <c:v>nmr-1(ak4)_A1_11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L$105:$L$125</c:f>
              <c:numCache>
                <c:formatCode>General</c:formatCode>
                <c:ptCount val="21"/>
                <c:pt idx="1">
                  <c:v>7.1832122679580293E-2</c:v>
                </c:pt>
                <c:pt idx="2">
                  <c:v>9.3623890234059773E-2</c:v>
                </c:pt>
                <c:pt idx="3">
                  <c:v>0.12429378531073405</c:v>
                </c:pt>
                <c:pt idx="4">
                  <c:v>0.13801452784503601</c:v>
                </c:pt>
                <c:pt idx="5">
                  <c:v>0.14850686037126706</c:v>
                </c:pt>
                <c:pt idx="6">
                  <c:v>6.860371267150929E-2</c:v>
                </c:pt>
                <c:pt idx="7">
                  <c:v>4.8426150121065395E-2</c:v>
                </c:pt>
                <c:pt idx="8">
                  <c:v>5.4075867635189699E-2</c:v>
                </c:pt>
                <c:pt idx="9">
                  <c:v>5.084745762711862E-2</c:v>
                </c:pt>
                <c:pt idx="10">
                  <c:v>3.8740920096852302E-2</c:v>
                </c:pt>
                <c:pt idx="11">
                  <c:v>3.0669895076674718E-2</c:v>
                </c:pt>
                <c:pt idx="12">
                  <c:v>2.5020177562550414E-2</c:v>
                </c:pt>
                <c:pt idx="13">
                  <c:v>1.21065375302663E-2</c:v>
                </c:pt>
                <c:pt idx="14">
                  <c:v>1.0492332526230795E-2</c:v>
                </c:pt>
                <c:pt idx="15">
                  <c:v>8.878127522195323E-3</c:v>
                </c:pt>
                <c:pt idx="16">
                  <c:v>4.8426150121065404E-3</c:v>
                </c:pt>
                <c:pt idx="17">
                  <c:v>7.2639225181598101E-3</c:v>
                </c:pt>
                <c:pt idx="18">
                  <c:v>5.6497175141242903E-3</c:v>
                </c:pt>
                <c:pt idx="19">
                  <c:v>4.8426150121065404E-3</c:v>
                </c:pt>
                <c:pt idx="20">
                  <c:v>2.421307506053271E-3</c:v>
                </c:pt>
              </c:numCache>
            </c:numRef>
          </c:val>
        </c:ser>
        <c:ser>
          <c:idx val="11"/>
          <c:order val="11"/>
          <c:tx>
            <c:strRef>
              <c:f>'nmr-1(ak4)_A1_0.02_5%'!$M$104</c:f>
              <c:strCache>
                <c:ptCount val="1"/>
                <c:pt idx="0">
                  <c:v>nmr-1(ak4)_A1_12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M$105:$M$125</c:f>
              <c:numCache>
                <c:formatCode>General</c:formatCode>
                <c:ptCount val="21"/>
                <c:pt idx="1">
                  <c:v>6.9421487603305826E-2</c:v>
                </c:pt>
                <c:pt idx="2">
                  <c:v>0.11074380165289301</c:v>
                </c:pt>
                <c:pt idx="3">
                  <c:v>0.13471074380165299</c:v>
                </c:pt>
                <c:pt idx="4">
                  <c:v>0.16363636363636405</c:v>
                </c:pt>
                <c:pt idx="5">
                  <c:v>0.15371900826446311</c:v>
                </c:pt>
                <c:pt idx="6">
                  <c:v>5.1239669421487589E-2</c:v>
                </c:pt>
                <c:pt idx="7">
                  <c:v>5.9504132231405014E-2</c:v>
                </c:pt>
                <c:pt idx="8">
                  <c:v>4.7933884297520719E-2</c:v>
                </c:pt>
                <c:pt idx="9">
                  <c:v>3.8842975206611612E-2</c:v>
                </c:pt>
                <c:pt idx="10">
                  <c:v>2.809917355371901E-2</c:v>
                </c:pt>
                <c:pt idx="11">
                  <c:v>1.9008264462809902E-2</c:v>
                </c:pt>
                <c:pt idx="12">
                  <c:v>1.7355371900826401E-2</c:v>
                </c:pt>
                <c:pt idx="13">
                  <c:v>1.6528925619834708E-2</c:v>
                </c:pt>
                <c:pt idx="14">
                  <c:v>1.3223140495867806E-2</c:v>
                </c:pt>
                <c:pt idx="15">
                  <c:v>6.6115702479338815E-3</c:v>
                </c:pt>
                <c:pt idx="16">
                  <c:v>6.6115702479338815E-3</c:v>
                </c:pt>
                <c:pt idx="17">
                  <c:v>4.9586776859504135E-3</c:v>
                </c:pt>
                <c:pt idx="18">
                  <c:v>8.2644628099173649E-4</c:v>
                </c:pt>
                <c:pt idx="19">
                  <c:v>2.4793388429752107E-3</c:v>
                </c:pt>
                <c:pt idx="2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nmr-1(ak4)_A1_0.02_5%'!$N$104</c:f>
              <c:strCache>
                <c:ptCount val="1"/>
                <c:pt idx="0">
                  <c:v>nmr-1(ak4)_A1_13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N$105:$N$125</c:f>
              <c:numCache>
                <c:formatCode>General</c:formatCode>
                <c:ptCount val="21"/>
                <c:pt idx="1">
                  <c:v>8.5543199315654433E-2</c:v>
                </c:pt>
                <c:pt idx="2">
                  <c:v>0.10179640718562906</c:v>
                </c:pt>
                <c:pt idx="3">
                  <c:v>0.13259195893926401</c:v>
                </c:pt>
                <c:pt idx="4">
                  <c:v>0.14713430282292611</c:v>
                </c:pt>
                <c:pt idx="5">
                  <c:v>0.118049615055603</c:v>
                </c:pt>
                <c:pt idx="6">
                  <c:v>7.1000855431993207E-2</c:v>
                </c:pt>
                <c:pt idx="7">
                  <c:v>6.3301967493584299E-2</c:v>
                </c:pt>
                <c:pt idx="8">
                  <c:v>5.3892215568862312E-2</c:v>
                </c:pt>
                <c:pt idx="9">
                  <c:v>4.4482463644140338E-2</c:v>
                </c:pt>
                <c:pt idx="10">
                  <c:v>3.1650983746792101E-2</c:v>
                </c:pt>
                <c:pt idx="11">
                  <c:v>2.7373823781009419E-2</c:v>
                </c:pt>
                <c:pt idx="12">
                  <c:v>1.3686911890504699E-2</c:v>
                </c:pt>
                <c:pt idx="13">
                  <c:v>1.1120615911035105E-2</c:v>
                </c:pt>
                <c:pt idx="14">
                  <c:v>1.1976047904191595E-2</c:v>
                </c:pt>
                <c:pt idx="15">
                  <c:v>5.1325919589392602E-3</c:v>
                </c:pt>
                <c:pt idx="16">
                  <c:v>4.277159965782722E-3</c:v>
                </c:pt>
                <c:pt idx="17">
                  <c:v>7.6988879384088998E-3</c:v>
                </c:pt>
                <c:pt idx="18">
                  <c:v>4.277159965782722E-3</c:v>
                </c:pt>
                <c:pt idx="19">
                  <c:v>2.5662959794696301E-3</c:v>
                </c:pt>
                <c:pt idx="20">
                  <c:v>8.5543199315654466E-4</c:v>
                </c:pt>
              </c:numCache>
            </c:numRef>
          </c:val>
        </c:ser>
        <c:ser>
          <c:idx val="13"/>
          <c:order val="13"/>
          <c:tx>
            <c:strRef>
              <c:f>'nmr-1(ak4)_A1_0.02_5%'!$O$104</c:f>
              <c:strCache>
                <c:ptCount val="1"/>
                <c:pt idx="0">
                  <c:v>nmr-1(ak4)_A1_14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O$105:$O$125</c:f>
              <c:numCache>
                <c:formatCode>General</c:formatCode>
                <c:ptCount val="21"/>
                <c:pt idx="1">
                  <c:v>7.9953650057937448E-2</c:v>
                </c:pt>
                <c:pt idx="2">
                  <c:v>0.12746234067207404</c:v>
                </c:pt>
                <c:pt idx="3">
                  <c:v>0.10428736964078797</c:v>
                </c:pt>
                <c:pt idx="4">
                  <c:v>0.12862108922363788</c:v>
                </c:pt>
                <c:pt idx="5">
                  <c:v>0.13441483198146012</c:v>
                </c:pt>
                <c:pt idx="6">
                  <c:v>6.0254924681344101E-2</c:v>
                </c:pt>
                <c:pt idx="7">
                  <c:v>4.0556199304750885E-2</c:v>
                </c:pt>
                <c:pt idx="8">
                  <c:v>5.9096176129779819E-2</c:v>
                </c:pt>
                <c:pt idx="9">
                  <c:v>4.5191193511008101E-2</c:v>
                </c:pt>
                <c:pt idx="10">
                  <c:v>3.9397450753186597E-2</c:v>
                </c:pt>
                <c:pt idx="11">
                  <c:v>2.3174971031286191E-2</c:v>
                </c:pt>
                <c:pt idx="12">
                  <c:v>2.0857473928157601E-2</c:v>
                </c:pt>
                <c:pt idx="13">
                  <c:v>1.1587485515643104E-2</c:v>
                </c:pt>
                <c:pt idx="14">
                  <c:v>2.201622247972192E-2</c:v>
                </c:pt>
                <c:pt idx="15">
                  <c:v>1.39049826187717E-2</c:v>
                </c:pt>
                <c:pt idx="16">
                  <c:v>5.7937427578215522E-3</c:v>
                </c:pt>
                <c:pt idx="17">
                  <c:v>8.1112398609501681E-3</c:v>
                </c:pt>
                <c:pt idx="18">
                  <c:v>5.7937427578215522E-3</c:v>
                </c:pt>
                <c:pt idx="19">
                  <c:v>2.3174971031286198E-3</c:v>
                </c:pt>
                <c:pt idx="20">
                  <c:v>6.9524913093858623E-3</c:v>
                </c:pt>
              </c:numCache>
            </c:numRef>
          </c:val>
        </c:ser>
        <c:ser>
          <c:idx val="14"/>
          <c:order val="14"/>
          <c:tx>
            <c:strRef>
              <c:f>'nmr-1(ak4)_A1_0.02_5%'!$P$104</c:f>
              <c:strCache>
                <c:ptCount val="1"/>
                <c:pt idx="0">
                  <c:v>nmr-1(ak4)_A1_15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P$105:$P$125</c:f>
              <c:numCache>
                <c:formatCode>General</c:formatCode>
                <c:ptCount val="21"/>
                <c:pt idx="1">
                  <c:v>5.9225512528473787E-2</c:v>
                </c:pt>
                <c:pt idx="2">
                  <c:v>9.5671981776765405E-2</c:v>
                </c:pt>
                <c:pt idx="3">
                  <c:v>0.11996962794229303</c:v>
                </c:pt>
                <c:pt idx="4">
                  <c:v>0.12680334092634801</c:v>
                </c:pt>
                <c:pt idx="5">
                  <c:v>0.14274867122247506</c:v>
                </c:pt>
                <c:pt idx="6">
                  <c:v>7.5170842824601403E-2</c:v>
                </c:pt>
                <c:pt idx="7">
                  <c:v>4.9354593773728229E-2</c:v>
                </c:pt>
                <c:pt idx="8">
                  <c:v>6.2262718299164799E-2</c:v>
                </c:pt>
                <c:pt idx="9">
                  <c:v>5.6188306757782795E-2</c:v>
                </c:pt>
                <c:pt idx="10">
                  <c:v>4.2520880789673483E-2</c:v>
                </c:pt>
                <c:pt idx="11">
                  <c:v>3.1131359149582399E-2</c:v>
                </c:pt>
                <c:pt idx="12">
                  <c:v>2.4297646165527705E-2</c:v>
                </c:pt>
                <c:pt idx="13">
                  <c:v>1.3667425968109305E-2</c:v>
                </c:pt>
                <c:pt idx="14">
                  <c:v>8.3523158694001551E-3</c:v>
                </c:pt>
                <c:pt idx="15">
                  <c:v>1.29081245254366E-2</c:v>
                </c:pt>
                <c:pt idx="16">
                  <c:v>5.3151100987091898E-3</c:v>
                </c:pt>
                <c:pt idx="17">
                  <c:v>8.3523158694001551E-3</c:v>
                </c:pt>
                <c:pt idx="18">
                  <c:v>6.0744115413819298E-3</c:v>
                </c:pt>
                <c:pt idx="19">
                  <c:v>4.555808656036448E-3</c:v>
                </c:pt>
                <c:pt idx="20">
                  <c:v>3.037205770690961E-3</c:v>
                </c:pt>
              </c:numCache>
            </c:numRef>
          </c:val>
        </c:ser>
        <c:ser>
          <c:idx val="15"/>
          <c:order val="15"/>
          <c:tx>
            <c:strRef>
              <c:f>'nmr-1(ak4)_A1_0.02_5%'!$Q$104</c:f>
              <c:strCache>
                <c:ptCount val="1"/>
                <c:pt idx="0">
                  <c:v>nmr-1(ak4)_A1_16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Q$105:$Q$125</c:f>
              <c:numCache>
                <c:formatCode>General</c:formatCode>
                <c:ptCount val="21"/>
                <c:pt idx="1">
                  <c:v>7.3929961089494206E-2</c:v>
                </c:pt>
                <c:pt idx="2">
                  <c:v>9.7276264591439704E-2</c:v>
                </c:pt>
                <c:pt idx="3">
                  <c:v>7.5875486381323021E-2</c:v>
                </c:pt>
                <c:pt idx="4">
                  <c:v>0.14007782101167293</c:v>
                </c:pt>
                <c:pt idx="5">
                  <c:v>0.12062256809338499</c:v>
                </c:pt>
                <c:pt idx="6">
                  <c:v>6.420233463035023E-2</c:v>
                </c:pt>
                <c:pt idx="7">
                  <c:v>6.8093385214007804E-2</c:v>
                </c:pt>
                <c:pt idx="8">
                  <c:v>6.6147859922178989E-2</c:v>
                </c:pt>
                <c:pt idx="9">
                  <c:v>6.420233463035023E-2</c:v>
                </c:pt>
                <c:pt idx="10">
                  <c:v>3.5019455252918302E-2</c:v>
                </c:pt>
                <c:pt idx="11">
                  <c:v>3.3073929961089502E-2</c:v>
                </c:pt>
                <c:pt idx="12">
                  <c:v>1.5564202334630401E-2</c:v>
                </c:pt>
                <c:pt idx="13">
                  <c:v>1.7509727626459103E-2</c:v>
                </c:pt>
                <c:pt idx="14">
                  <c:v>9.7276264591439707E-3</c:v>
                </c:pt>
                <c:pt idx="15">
                  <c:v>1.36186770428016E-2</c:v>
                </c:pt>
                <c:pt idx="16">
                  <c:v>1.36186770428016E-2</c:v>
                </c:pt>
                <c:pt idx="17">
                  <c:v>9.7276264591439707E-3</c:v>
                </c:pt>
                <c:pt idx="18">
                  <c:v>0</c:v>
                </c:pt>
                <c:pt idx="19">
                  <c:v>3.8910505836575902E-3</c:v>
                </c:pt>
                <c:pt idx="2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nmr-1(ak4)_A1_0.02_5%'!$R$104</c:f>
              <c:strCache>
                <c:ptCount val="1"/>
                <c:pt idx="0">
                  <c:v>nmr-1(ak4)_A1_17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R$105:$R$125</c:f>
              <c:numCache>
                <c:formatCode>General</c:formatCode>
                <c:ptCount val="21"/>
                <c:pt idx="1">
                  <c:v>6.4516129032258132E-2</c:v>
                </c:pt>
                <c:pt idx="2">
                  <c:v>8.6546026750590158E-2</c:v>
                </c:pt>
                <c:pt idx="3">
                  <c:v>0.11880409126671899</c:v>
                </c:pt>
                <c:pt idx="4">
                  <c:v>0.13532651455546801</c:v>
                </c:pt>
                <c:pt idx="5">
                  <c:v>0.12903225806451593</c:v>
                </c:pt>
                <c:pt idx="6">
                  <c:v>7.2383949645948131E-2</c:v>
                </c:pt>
                <c:pt idx="7">
                  <c:v>5.3501180173092085E-2</c:v>
                </c:pt>
                <c:pt idx="8">
                  <c:v>6.2942564909520132E-2</c:v>
                </c:pt>
                <c:pt idx="9">
                  <c:v>6.2155782848151118E-2</c:v>
                </c:pt>
                <c:pt idx="10">
                  <c:v>4.8780487804878127E-2</c:v>
                </c:pt>
                <c:pt idx="11">
                  <c:v>2.9897718332022E-2</c:v>
                </c:pt>
                <c:pt idx="12">
                  <c:v>1.3375295043273E-2</c:v>
                </c:pt>
                <c:pt idx="13">
                  <c:v>2.1243115656963022E-2</c:v>
                </c:pt>
                <c:pt idx="14">
                  <c:v>1.1014948859165999E-2</c:v>
                </c:pt>
                <c:pt idx="15">
                  <c:v>1.0228166797797001E-2</c:v>
                </c:pt>
                <c:pt idx="16">
                  <c:v>9.4413847364280146E-3</c:v>
                </c:pt>
                <c:pt idx="17">
                  <c:v>5.5074744295830116E-3</c:v>
                </c:pt>
                <c:pt idx="18">
                  <c:v>6.2942564909520132E-3</c:v>
                </c:pt>
                <c:pt idx="19">
                  <c:v>3.9339103068450013E-3</c:v>
                </c:pt>
                <c:pt idx="20">
                  <c:v>7.8678206136900122E-4</c:v>
                </c:pt>
              </c:numCache>
            </c:numRef>
          </c:val>
        </c:ser>
        <c:ser>
          <c:idx val="17"/>
          <c:order val="17"/>
          <c:tx>
            <c:strRef>
              <c:f>'nmr-1(ak4)_A1_0.02_5%'!$S$104</c:f>
              <c:strCache>
                <c:ptCount val="1"/>
                <c:pt idx="0">
                  <c:v>nmr-1(ak4)_A1_18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S$105:$S$125</c:f>
              <c:numCache>
                <c:formatCode>General</c:formatCode>
                <c:ptCount val="21"/>
                <c:pt idx="1">
                  <c:v>7.0539419087136929E-2</c:v>
                </c:pt>
                <c:pt idx="2">
                  <c:v>0.12116182572614104</c:v>
                </c:pt>
                <c:pt idx="3">
                  <c:v>0.12199170124481305</c:v>
                </c:pt>
                <c:pt idx="4">
                  <c:v>0.15269709543568499</c:v>
                </c:pt>
                <c:pt idx="5">
                  <c:v>0.13360995850622406</c:v>
                </c:pt>
                <c:pt idx="6">
                  <c:v>8.0497925311203339E-2</c:v>
                </c:pt>
                <c:pt idx="7">
                  <c:v>7.2199170124481321E-2</c:v>
                </c:pt>
                <c:pt idx="8">
                  <c:v>4.0663900414937816E-2</c:v>
                </c:pt>
                <c:pt idx="9">
                  <c:v>4.1493775933610019E-2</c:v>
                </c:pt>
                <c:pt idx="10">
                  <c:v>3.3195020746887988E-2</c:v>
                </c:pt>
                <c:pt idx="11">
                  <c:v>2.9875518672199217E-2</c:v>
                </c:pt>
                <c:pt idx="12">
                  <c:v>1.2448132780083001E-2</c:v>
                </c:pt>
                <c:pt idx="13">
                  <c:v>6.6390041493775915E-3</c:v>
                </c:pt>
                <c:pt idx="14">
                  <c:v>7.4688796680497903E-3</c:v>
                </c:pt>
                <c:pt idx="15">
                  <c:v>9.1286307053941879E-3</c:v>
                </c:pt>
                <c:pt idx="16">
                  <c:v>5.8091286307053918E-3</c:v>
                </c:pt>
                <c:pt idx="17">
                  <c:v>3.3195020746887992E-3</c:v>
                </c:pt>
                <c:pt idx="18">
                  <c:v>8.2987551867219904E-4</c:v>
                </c:pt>
                <c:pt idx="19">
                  <c:v>8.2987551867219904E-4</c:v>
                </c:pt>
                <c:pt idx="20">
                  <c:v>1.6597510373444E-3</c:v>
                </c:pt>
              </c:numCache>
            </c:numRef>
          </c:val>
        </c:ser>
        <c:ser>
          <c:idx val="18"/>
          <c:order val="18"/>
          <c:tx>
            <c:strRef>
              <c:f>'nmr-1(ak4)_A1_0.02_5%'!$T$104</c:f>
              <c:strCache>
                <c:ptCount val="1"/>
                <c:pt idx="0">
                  <c:v>nmr-1(ak4)_A1_20</c:v>
                </c:pt>
              </c:strCache>
            </c:strRef>
          </c:tx>
          <c:marker>
            <c:symbol val="none"/>
          </c:marker>
          <c:cat>
            <c:numRef>
              <c:f>'nmr-1(ak4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1_0.02_5%'!$T$105:$T$125</c:f>
              <c:numCache>
                <c:formatCode>General</c:formatCode>
                <c:ptCount val="21"/>
                <c:pt idx="1">
                  <c:v>7.1074380165289289E-2</c:v>
                </c:pt>
                <c:pt idx="2">
                  <c:v>7.3553719008264504E-2</c:v>
                </c:pt>
                <c:pt idx="3">
                  <c:v>0.11157024793388404</c:v>
                </c:pt>
                <c:pt idx="4">
                  <c:v>0.12231404958677702</c:v>
                </c:pt>
                <c:pt idx="5">
                  <c:v>0.123140495867769</c:v>
                </c:pt>
                <c:pt idx="6">
                  <c:v>7.5206611570247925E-2</c:v>
                </c:pt>
                <c:pt idx="7">
                  <c:v>5.9504132231405014E-2</c:v>
                </c:pt>
                <c:pt idx="8">
                  <c:v>6.8595041322314004E-2</c:v>
                </c:pt>
                <c:pt idx="9">
                  <c:v>6.0330578512396718E-2</c:v>
                </c:pt>
                <c:pt idx="10">
                  <c:v>4.7933884297520719E-2</c:v>
                </c:pt>
                <c:pt idx="11">
                  <c:v>3.1404958677686015E-2</c:v>
                </c:pt>
                <c:pt idx="12">
                  <c:v>3.1404958677686015E-2</c:v>
                </c:pt>
                <c:pt idx="13">
                  <c:v>2.2314049586776918E-2</c:v>
                </c:pt>
                <c:pt idx="14">
                  <c:v>1.40495867768595E-2</c:v>
                </c:pt>
                <c:pt idx="15">
                  <c:v>1.1570247933884299E-2</c:v>
                </c:pt>
                <c:pt idx="16">
                  <c:v>9.9173553719008305E-3</c:v>
                </c:pt>
                <c:pt idx="17">
                  <c:v>6.6115702479338815E-3</c:v>
                </c:pt>
                <c:pt idx="18">
                  <c:v>4.9586776859504135E-3</c:v>
                </c:pt>
                <c:pt idx="19">
                  <c:v>4.1322314049586821E-3</c:v>
                </c:pt>
                <c:pt idx="20">
                  <c:v>3.3057851239669408E-3</c:v>
                </c:pt>
              </c:numCache>
            </c:numRef>
          </c:val>
        </c:ser>
        <c:marker val="1"/>
        <c:axId val="158443008"/>
        <c:axId val="158444544"/>
      </c:lineChart>
      <c:catAx>
        <c:axId val="158443008"/>
        <c:scaling>
          <c:orientation val="minMax"/>
        </c:scaling>
        <c:axPos val="b"/>
        <c:numFmt formatCode="0.0_ " sourceLinked="1"/>
        <c:tickLblPos val="nextTo"/>
        <c:crossAx val="158444544"/>
        <c:crosses val="autoZero"/>
        <c:auto val="1"/>
        <c:lblAlgn val="ctr"/>
        <c:lblOffset val="100"/>
        <c:tickLblSkip val="5"/>
        <c:tickMarkSkip val="5"/>
      </c:catAx>
      <c:valAx>
        <c:axId val="15844454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8443008"/>
        <c:crosses val="autoZero"/>
        <c:crossBetween val="between"/>
      </c:valAx>
    </c:plotArea>
    <c:plotVisOnly val="1"/>
  </c:chart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gl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glr-1(n2461)_A1_0.02_5%'!$B$104</c:f>
              <c:strCache>
                <c:ptCount val="1"/>
                <c:pt idx="0">
                  <c:v>glr-1(n2461)_A1_01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B$105:$B$125</c:f>
              <c:numCache>
                <c:formatCode>General</c:formatCode>
                <c:ptCount val="21"/>
                <c:pt idx="1">
                  <c:v>6.8181818181818205E-2</c:v>
                </c:pt>
                <c:pt idx="2">
                  <c:v>8.2644628099173639E-2</c:v>
                </c:pt>
                <c:pt idx="3">
                  <c:v>0.11639118457300303</c:v>
                </c:pt>
                <c:pt idx="4">
                  <c:v>0.14462809917355393</c:v>
                </c:pt>
                <c:pt idx="5">
                  <c:v>0.167355371900826</c:v>
                </c:pt>
                <c:pt idx="6">
                  <c:v>8.0578512396694238E-2</c:v>
                </c:pt>
                <c:pt idx="7">
                  <c:v>4.2011019283746627E-2</c:v>
                </c:pt>
                <c:pt idx="8">
                  <c:v>4.2699724517906323E-2</c:v>
                </c:pt>
                <c:pt idx="9">
                  <c:v>5.1652892561983479E-2</c:v>
                </c:pt>
                <c:pt idx="10">
                  <c:v>3.9256198347107397E-2</c:v>
                </c:pt>
                <c:pt idx="11">
                  <c:v>3.5123966942148803E-2</c:v>
                </c:pt>
                <c:pt idx="12">
                  <c:v>1.9972451790633613E-2</c:v>
                </c:pt>
                <c:pt idx="13">
                  <c:v>1.2396694214876E-2</c:v>
                </c:pt>
                <c:pt idx="14">
                  <c:v>8.2644628099173643E-3</c:v>
                </c:pt>
                <c:pt idx="15">
                  <c:v>8.2644628099173643E-3</c:v>
                </c:pt>
                <c:pt idx="16">
                  <c:v>7.575757575757582E-3</c:v>
                </c:pt>
                <c:pt idx="17">
                  <c:v>5.5096418732782423E-3</c:v>
                </c:pt>
                <c:pt idx="18">
                  <c:v>2.0661157024793411E-3</c:v>
                </c:pt>
                <c:pt idx="19">
                  <c:v>1.3774104683195608E-3</c:v>
                </c:pt>
                <c:pt idx="20">
                  <c:v>1.3774104683195608E-3</c:v>
                </c:pt>
              </c:numCache>
            </c:numRef>
          </c:val>
        </c:ser>
        <c:ser>
          <c:idx val="1"/>
          <c:order val="1"/>
          <c:tx>
            <c:strRef>
              <c:f>'glr-1(n2461)_A1_0.02_5%'!$C$104</c:f>
              <c:strCache>
                <c:ptCount val="1"/>
                <c:pt idx="0">
                  <c:v>glr-1(n2461)_A1_02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C$105:$C$125</c:f>
              <c:numCache>
                <c:formatCode>General</c:formatCode>
                <c:ptCount val="21"/>
                <c:pt idx="1">
                  <c:v>5.9023066485753096E-2</c:v>
                </c:pt>
                <c:pt idx="2">
                  <c:v>9.7693351424694708E-2</c:v>
                </c:pt>
                <c:pt idx="3">
                  <c:v>0.10312075983717803</c:v>
                </c:pt>
                <c:pt idx="4">
                  <c:v>0.11601085481682498</c:v>
                </c:pt>
                <c:pt idx="5">
                  <c:v>0.15264586160108501</c:v>
                </c:pt>
                <c:pt idx="6">
                  <c:v>8.0054274084124827E-2</c:v>
                </c:pt>
                <c:pt idx="7">
                  <c:v>6.5128900949796523E-2</c:v>
                </c:pt>
                <c:pt idx="8">
                  <c:v>5.5630936227951219E-2</c:v>
                </c:pt>
                <c:pt idx="9">
                  <c:v>5.5630936227951219E-2</c:v>
                </c:pt>
                <c:pt idx="10">
                  <c:v>5.0203527815468114E-2</c:v>
                </c:pt>
                <c:pt idx="11">
                  <c:v>3.1207598371777515E-2</c:v>
                </c:pt>
                <c:pt idx="12">
                  <c:v>2.4423337856173719E-2</c:v>
                </c:pt>
                <c:pt idx="13">
                  <c:v>1.4925373134328401E-2</c:v>
                </c:pt>
                <c:pt idx="14">
                  <c:v>1.28900949796472E-2</c:v>
                </c:pt>
                <c:pt idx="15">
                  <c:v>1.1533242876526495E-2</c:v>
                </c:pt>
                <c:pt idx="16">
                  <c:v>7.4626865671641816E-3</c:v>
                </c:pt>
                <c:pt idx="17">
                  <c:v>4.7489823609226621E-3</c:v>
                </c:pt>
                <c:pt idx="18">
                  <c:v>4.0705563093622801E-3</c:v>
                </c:pt>
                <c:pt idx="19">
                  <c:v>5.4274084124830433E-3</c:v>
                </c:pt>
                <c:pt idx="20">
                  <c:v>1.3568521031207613E-3</c:v>
                </c:pt>
              </c:numCache>
            </c:numRef>
          </c:val>
        </c:ser>
        <c:ser>
          <c:idx val="2"/>
          <c:order val="2"/>
          <c:tx>
            <c:strRef>
              <c:f>'glr-1(n2461)_A1_0.02_5%'!$D$104</c:f>
              <c:strCache>
                <c:ptCount val="1"/>
                <c:pt idx="0">
                  <c:v>glr-1(n2461)_A1_03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D$105:$D$125</c:f>
              <c:numCache>
                <c:formatCode>General</c:formatCode>
                <c:ptCount val="21"/>
                <c:pt idx="1">
                  <c:v>6.8452380952381042E-2</c:v>
                </c:pt>
                <c:pt idx="2">
                  <c:v>0.107142857142857</c:v>
                </c:pt>
                <c:pt idx="3">
                  <c:v>0.121279761904762</c:v>
                </c:pt>
                <c:pt idx="4">
                  <c:v>0.13392857142857095</c:v>
                </c:pt>
                <c:pt idx="5">
                  <c:v>0.15029761904761901</c:v>
                </c:pt>
                <c:pt idx="6">
                  <c:v>7.8125E-2</c:v>
                </c:pt>
                <c:pt idx="7">
                  <c:v>4.98511904761905E-2</c:v>
                </c:pt>
                <c:pt idx="8">
                  <c:v>6.1011904761904795E-2</c:v>
                </c:pt>
                <c:pt idx="9">
                  <c:v>5.2827380952381035E-2</c:v>
                </c:pt>
                <c:pt idx="10">
                  <c:v>3.4226190476190514E-2</c:v>
                </c:pt>
                <c:pt idx="11">
                  <c:v>1.5625E-2</c:v>
                </c:pt>
                <c:pt idx="12">
                  <c:v>2.23214285714286E-2</c:v>
                </c:pt>
                <c:pt idx="13">
                  <c:v>1.3392857142857107E-2</c:v>
                </c:pt>
                <c:pt idx="14">
                  <c:v>8.1845238095238134E-3</c:v>
                </c:pt>
                <c:pt idx="15">
                  <c:v>6.6964285714285702E-3</c:v>
                </c:pt>
                <c:pt idx="16">
                  <c:v>5.2083333333333339E-3</c:v>
                </c:pt>
                <c:pt idx="17">
                  <c:v>2.9761904761904808E-3</c:v>
                </c:pt>
                <c:pt idx="18">
                  <c:v>1.4880952380952404E-3</c:v>
                </c:pt>
                <c:pt idx="19">
                  <c:v>7.4404761904761944E-4</c:v>
                </c:pt>
                <c:pt idx="20">
                  <c:v>1.4880952380952404E-3</c:v>
                </c:pt>
              </c:numCache>
            </c:numRef>
          </c:val>
        </c:ser>
        <c:ser>
          <c:idx val="3"/>
          <c:order val="3"/>
          <c:tx>
            <c:strRef>
              <c:f>'glr-1(n2461)_A1_0.02_5%'!$E$104</c:f>
              <c:strCache>
                <c:ptCount val="1"/>
                <c:pt idx="0">
                  <c:v>glr-1(n2461)_A1_04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E$105:$E$125</c:f>
              <c:numCache>
                <c:formatCode>General</c:formatCode>
                <c:ptCount val="21"/>
                <c:pt idx="1">
                  <c:v>6.174819566960707E-2</c:v>
                </c:pt>
                <c:pt idx="2">
                  <c:v>0.10184442662389701</c:v>
                </c:pt>
                <c:pt idx="3">
                  <c:v>0.14274258219727315</c:v>
                </c:pt>
                <c:pt idx="4">
                  <c:v>0.14113873295910201</c:v>
                </c:pt>
                <c:pt idx="5">
                  <c:v>0.14354450681635905</c:v>
                </c:pt>
                <c:pt idx="6">
                  <c:v>7.7786688051323258E-2</c:v>
                </c:pt>
                <c:pt idx="7">
                  <c:v>4.8115477145148432E-2</c:v>
                </c:pt>
                <c:pt idx="8">
                  <c:v>5.8540497193263812E-2</c:v>
                </c:pt>
                <c:pt idx="9">
                  <c:v>4.1700080192461901E-2</c:v>
                </c:pt>
                <c:pt idx="10">
                  <c:v>3.4482758620689717E-2</c:v>
                </c:pt>
                <c:pt idx="11">
                  <c:v>2.4859663191660001E-2</c:v>
                </c:pt>
                <c:pt idx="12">
                  <c:v>2.004811547714512E-2</c:v>
                </c:pt>
                <c:pt idx="13">
                  <c:v>1.2830793905372898E-2</c:v>
                </c:pt>
                <c:pt idx="14">
                  <c:v>1.68404170008019E-2</c:v>
                </c:pt>
                <c:pt idx="15">
                  <c:v>5.6134723336006432E-3</c:v>
                </c:pt>
                <c:pt idx="16">
                  <c:v>6.41539695268645E-3</c:v>
                </c:pt>
                <c:pt idx="17">
                  <c:v>2.4057738572574217E-3</c:v>
                </c:pt>
                <c:pt idx="18">
                  <c:v>2.4057738572574217E-3</c:v>
                </c:pt>
                <c:pt idx="19">
                  <c:v>1.6038492381716101E-3</c:v>
                </c:pt>
                <c:pt idx="20">
                  <c:v>2.4057738572574217E-3</c:v>
                </c:pt>
              </c:numCache>
            </c:numRef>
          </c:val>
        </c:ser>
        <c:ser>
          <c:idx val="4"/>
          <c:order val="4"/>
          <c:tx>
            <c:strRef>
              <c:f>'glr-1(n2461)_A1_0.02_5%'!$F$104</c:f>
              <c:strCache>
                <c:ptCount val="1"/>
                <c:pt idx="0">
                  <c:v>glr-1(n2461)_A1_05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F$105:$F$125</c:f>
              <c:numCache>
                <c:formatCode>General</c:formatCode>
                <c:ptCount val="21"/>
                <c:pt idx="1">
                  <c:v>6.641509433962263E-2</c:v>
                </c:pt>
                <c:pt idx="2">
                  <c:v>9.3584905660377471E-2</c:v>
                </c:pt>
                <c:pt idx="3">
                  <c:v>0.12377358490566005</c:v>
                </c:pt>
                <c:pt idx="4">
                  <c:v>0.14490566037735805</c:v>
                </c:pt>
                <c:pt idx="5">
                  <c:v>0.15245283018867906</c:v>
                </c:pt>
                <c:pt idx="6">
                  <c:v>9.5094339622641536E-2</c:v>
                </c:pt>
                <c:pt idx="7">
                  <c:v>4.6037735849056627E-2</c:v>
                </c:pt>
                <c:pt idx="8">
                  <c:v>4.6037735849056627E-2</c:v>
                </c:pt>
                <c:pt idx="9">
                  <c:v>4.45283018867925E-2</c:v>
                </c:pt>
                <c:pt idx="10">
                  <c:v>4.0000000000000015E-2</c:v>
                </c:pt>
                <c:pt idx="11">
                  <c:v>3.0188679245282988E-2</c:v>
                </c:pt>
                <c:pt idx="12">
                  <c:v>1.88679245283019E-2</c:v>
                </c:pt>
                <c:pt idx="13">
                  <c:v>1.5849056603773601E-2</c:v>
                </c:pt>
                <c:pt idx="14">
                  <c:v>8.3018867924528339E-3</c:v>
                </c:pt>
                <c:pt idx="15">
                  <c:v>6.0377358490566E-3</c:v>
                </c:pt>
                <c:pt idx="16">
                  <c:v>4.5283018867924496E-3</c:v>
                </c:pt>
                <c:pt idx="17">
                  <c:v>1.50943396226415E-3</c:v>
                </c:pt>
                <c:pt idx="18">
                  <c:v>2.2641509433962317E-3</c:v>
                </c:pt>
                <c:pt idx="19">
                  <c:v>2.2641509433962317E-3</c:v>
                </c:pt>
                <c:pt idx="20">
                  <c:v>1.50943396226415E-3</c:v>
                </c:pt>
              </c:numCache>
            </c:numRef>
          </c:val>
        </c:ser>
        <c:ser>
          <c:idx val="5"/>
          <c:order val="5"/>
          <c:tx>
            <c:strRef>
              <c:f>'glr-1(n2461)_A1_0.02_5%'!$G$104</c:f>
              <c:strCache>
                <c:ptCount val="1"/>
                <c:pt idx="0">
                  <c:v>glr-1(n2461)_A1_06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G$105:$G$125</c:f>
              <c:numCache>
                <c:formatCode>General</c:formatCode>
                <c:ptCount val="21"/>
                <c:pt idx="1">
                  <c:v>6.0929169840060887E-2</c:v>
                </c:pt>
                <c:pt idx="2">
                  <c:v>9.13937547600914E-2</c:v>
                </c:pt>
                <c:pt idx="3">
                  <c:v>0.12338156892612299</c:v>
                </c:pt>
                <c:pt idx="4">
                  <c:v>0.14394516374714411</c:v>
                </c:pt>
                <c:pt idx="5">
                  <c:v>0.14470677837014501</c:v>
                </c:pt>
                <c:pt idx="6">
                  <c:v>8.149276466108149E-2</c:v>
                </c:pt>
                <c:pt idx="7">
                  <c:v>5.0266565118050298E-2</c:v>
                </c:pt>
                <c:pt idx="8">
                  <c:v>5.3313023610053321E-2</c:v>
                </c:pt>
                <c:pt idx="9">
                  <c:v>5.25514089870526E-2</c:v>
                </c:pt>
                <c:pt idx="10">
                  <c:v>4.2650418888042621E-2</c:v>
                </c:pt>
                <c:pt idx="11">
                  <c:v>3.5795887281035804E-2</c:v>
                </c:pt>
                <c:pt idx="12">
                  <c:v>2.3610053313023599E-2</c:v>
                </c:pt>
                <c:pt idx="13">
                  <c:v>1.4470677837014501E-2</c:v>
                </c:pt>
                <c:pt idx="14">
                  <c:v>7.6161462300076213E-3</c:v>
                </c:pt>
                <c:pt idx="15">
                  <c:v>3.8080731150038098E-3</c:v>
                </c:pt>
                <c:pt idx="16">
                  <c:v>3.04645849200305E-3</c:v>
                </c:pt>
                <c:pt idx="17">
                  <c:v>6.8545316070068481E-3</c:v>
                </c:pt>
                <c:pt idx="18">
                  <c:v>3.04645849200305E-3</c:v>
                </c:pt>
                <c:pt idx="19">
                  <c:v>2.2848438690022911E-3</c:v>
                </c:pt>
                <c:pt idx="20">
                  <c:v>7.6161462300076217E-4</c:v>
                </c:pt>
              </c:numCache>
            </c:numRef>
          </c:val>
        </c:ser>
        <c:ser>
          <c:idx val="6"/>
          <c:order val="6"/>
          <c:tx>
            <c:strRef>
              <c:f>'glr-1(n2461)_A1_0.02_5%'!$H$104</c:f>
              <c:strCache>
                <c:ptCount val="1"/>
                <c:pt idx="0">
                  <c:v>glr-1(n2461)_A1_07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H$105:$H$125</c:f>
              <c:numCache>
                <c:formatCode>General</c:formatCode>
                <c:ptCount val="21"/>
                <c:pt idx="1">
                  <c:v>5.5393586005830921E-2</c:v>
                </c:pt>
                <c:pt idx="2">
                  <c:v>8.6005830903790145E-2</c:v>
                </c:pt>
                <c:pt idx="3">
                  <c:v>0.12026239067055403</c:v>
                </c:pt>
                <c:pt idx="4">
                  <c:v>0.13265306122449</c:v>
                </c:pt>
                <c:pt idx="5">
                  <c:v>0.15597667638484</c:v>
                </c:pt>
                <c:pt idx="6">
                  <c:v>0.10349854227405203</c:v>
                </c:pt>
                <c:pt idx="7">
                  <c:v>5.5393586005830921E-2</c:v>
                </c:pt>
                <c:pt idx="8">
                  <c:v>5.3206997084548124E-2</c:v>
                </c:pt>
                <c:pt idx="9">
                  <c:v>4.591836734693882E-2</c:v>
                </c:pt>
                <c:pt idx="10">
                  <c:v>4.3731778425656002E-2</c:v>
                </c:pt>
                <c:pt idx="11">
                  <c:v>3.2798833819242E-2</c:v>
                </c:pt>
                <c:pt idx="12">
                  <c:v>1.8950437317784306E-2</c:v>
                </c:pt>
                <c:pt idx="13">
                  <c:v>2.1137026239067092E-2</c:v>
                </c:pt>
                <c:pt idx="14">
                  <c:v>1.0932944606414001E-2</c:v>
                </c:pt>
                <c:pt idx="15">
                  <c:v>1.3119533527696795E-2</c:v>
                </c:pt>
                <c:pt idx="16">
                  <c:v>8.7463556851311974E-3</c:v>
                </c:pt>
                <c:pt idx="17">
                  <c:v>2.91545189504373E-3</c:v>
                </c:pt>
                <c:pt idx="18">
                  <c:v>2.1865889212828002E-3</c:v>
                </c:pt>
                <c:pt idx="19">
                  <c:v>1.45772594752187E-3</c:v>
                </c:pt>
                <c:pt idx="20">
                  <c:v>2.91545189504373E-3</c:v>
                </c:pt>
              </c:numCache>
            </c:numRef>
          </c:val>
        </c:ser>
        <c:ser>
          <c:idx val="7"/>
          <c:order val="7"/>
          <c:tx>
            <c:strRef>
              <c:f>'glr-1(n2461)_A1_0.02_5%'!$I$104</c:f>
              <c:strCache>
                <c:ptCount val="1"/>
                <c:pt idx="0">
                  <c:v>glr-1(n2461)_A1_08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I$105:$I$125</c:f>
              <c:numCache>
                <c:formatCode>General</c:formatCode>
                <c:ptCount val="21"/>
                <c:pt idx="1">
                  <c:v>5.8618283321702713E-2</c:v>
                </c:pt>
                <c:pt idx="2">
                  <c:v>8.2344731332868099E-2</c:v>
                </c:pt>
                <c:pt idx="3">
                  <c:v>0.11235170969992997</c:v>
                </c:pt>
                <c:pt idx="4">
                  <c:v>0.13677599441730606</c:v>
                </c:pt>
                <c:pt idx="5">
                  <c:v>0.166085136078158</c:v>
                </c:pt>
                <c:pt idx="6">
                  <c:v>6.629448709002092E-2</c:v>
                </c:pt>
                <c:pt idx="7">
                  <c:v>5.373342637822752E-2</c:v>
                </c:pt>
                <c:pt idx="8">
                  <c:v>5.0244242847173798E-2</c:v>
                </c:pt>
                <c:pt idx="9">
                  <c:v>4.8150732728541513E-2</c:v>
                </c:pt>
                <c:pt idx="10">
                  <c:v>5.0244242847173798E-2</c:v>
                </c:pt>
                <c:pt idx="11">
                  <c:v>4.6057222609909299E-2</c:v>
                </c:pt>
                <c:pt idx="12">
                  <c:v>2.6517794836008392E-2</c:v>
                </c:pt>
                <c:pt idx="13">
                  <c:v>2.0237264480111719E-2</c:v>
                </c:pt>
                <c:pt idx="14">
                  <c:v>1.2561060711793401E-2</c:v>
                </c:pt>
                <c:pt idx="15">
                  <c:v>1.1165387299371901E-2</c:v>
                </c:pt>
                <c:pt idx="16">
                  <c:v>4.8848569434752284E-3</c:v>
                </c:pt>
                <c:pt idx="17">
                  <c:v>4.8848569434752284E-3</c:v>
                </c:pt>
                <c:pt idx="18">
                  <c:v>1.39567341242149E-3</c:v>
                </c:pt>
                <c:pt idx="19">
                  <c:v>3.4891835310537312E-3</c:v>
                </c:pt>
                <c:pt idx="20">
                  <c:v>6.978367062107474E-4</c:v>
                </c:pt>
              </c:numCache>
            </c:numRef>
          </c:val>
        </c:ser>
        <c:ser>
          <c:idx val="8"/>
          <c:order val="8"/>
          <c:tx>
            <c:strRef>
              <c:f>'glr-1(n2461)_A1_0.02_5%'!$J$104</c:f>
              <c:strCache>
                <c:ptCount val="1"/>
                <c:pt idx="0">
                  <c:v>glr-1(n2461)_A1_09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J$105:$J$125</c:f>
              <c:numCache>
                <c:formatCode>General</c:formatCode>
                <c:ptCount val="21"/>
                <c:pt idx="1">
                  <c:v>6.2403697996918354E-2</c:v>
                </c:pt>
                <c:pt idx="2">
                  <c:v>0.10862865947611708</c:v>
                </c:pt>
                <c:pt idx="3">
                  <c:v>0.11864406779661005</c:v>
                </c:pt>
                <c:pt idx="4">
                  <c:v>0.14560862865947594</c:v>
                </c:pt>
                <c:pt idx="5">
                  <c:v>0.14869029275808901</c:v>
                </c:pt>
                <c:pt idx="6">
                  <c:v>7.9352850539291225E-2</c:v>
                </c:pt>
                <c:pt idx="7">
                  <c:v>4.6995377503852083E-2</c:v>
                </c:pt>
                <c:pt idx="8">
                  <c:v>5.8551617873651804E-2</c:v>
                </c:pt>
                <c:pt idx="9">
                  <c:v>5.0077041602465296E-2</c:v>
                </c:pt>
                <c:pt idx="10">
                  <c:v>4.3143297380585498E-2</c:v>
                </c:pt>
                <c:pt idx="11">
                  <c:v>2.311248073959939E-2</c:v>
                </c:pt>
                <c:pt idx="12">
                  <c:v>1.6178736517719599E-2</c:v>
                </c:pt>
                <c:pt idx="13">
                  <c:v>1.6178736517719599E-2</c:v>
                </c:pt>
                <c:pt idx="14">
                  <c:v>1.2326656394453003E-2</c:v>
                </c:pt>
                <c:pt idx="15">
                  <c:v>8.4745762711864476E-3</c:v>
                </c:pt>
                <c:pt idx="16">
                  <c:v>6.1633281972264999E-3</c:v>
                </c:pt>
                <c:pt idx="17">
                  <c:v>3.8520801232665592E-3</c:v>
                </c:pt>
                <c:pt idx="18">
                  <c:v>1.5408320493066308E-3</c:v>
                </c:pt>
                <c:pt idx="19">
                  <c:v>3.0816640986132508E-3</c:v>
                </c:pt>
                <c:pt idx="20">
                  <c:v>2.311248073959939E-3</c:v>
                </c:pt>
              </c:numCache>
            </c:numRef>
          </c:val>
        </c:ser>
        <c:ser>
          <c:idx val="9"/>
          <c:order val="9"/>
          <c:tx>
            <c:strRef>
              <c:f>'glr-1(n2461)_A1_0.02_5%'!$K$104</c:f>
              <c:strCache>
                <c:ptCount val="1"/>
                <c:pt idx="0">
                  <c:v>glr-1(n2461)_A1_10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K$105:$K$125</c:f>
              <c:numCache>
                <c:formatCode>General</c:formatCode>
                <c:ptCount val="21"/>
                <c:pt idx="1">
                  <c:v>6.3903281519861813E-2</c:v>
                </c:pt>
                <c:pt idx="2">
                  <c:v>9.8445595854922296E-2</c:v>
                </c:pt>
                <c:pt idx="3">
                  <c:v>0.12348877374784099</c:v>
                </c:pt>
                <c:pt idx="4">
                  <c:v>0.13644214162348905</c:v>
                </c:pt>
                <c:pt idx="5">
                  <c:v>0.13126079447323005</c:v>
                </c:pt>
                <c:pt idx="6">
                  <c:v>7.512953367875648E-2</c:v>
                </c:pt>
                <c:pt idx="7">
                  <c:v>6.2176165803108814E-2</c:v>
                </c:pt>
                <c:pt idx="8">
                  <c:v>6.1312607944732353E-2</c:v>
                </c:pt>
                <c:pt idx="9">
                  <c:v>3.9723661485319514E-2</c:v>
                </c:pt>
                <c:pt idx="10">
                  <c:v>3.7996545768566516E-2</c:v>
                </c:pt>
                <c:pt idx="11">
                  <c:v>2.1588946459412808E-2</c:v>
                </c:pt>
                <c:pt idx="12">
                  <c:v>2.5043177892918808E-2</c:v>
                </c:pt>
                <c:pt idx="13">
                  <c:v>1.20898100172712E-2</c:v>
                </c:pt>
                <c:pt idx="14">
                  <c:v>1.4680483592400701E-2</c:v>
                </c:pt>
                <c:pt idx="15">
                  <c:v>6.9084628670120921E-3</c:v>
                </c:pt>
                <c:pt idx="16">
                  <c:v>1.38169257340242E-2</c:v>
                </c:pt>
                <c:pt idx="17">
                  <c:v>4.3177892918825622E-3</c:v>
                </c:pt>
                <c:pt idx="18">
                  <c:v>6.9084628670120921E-3</c:v>
                </c:pt>
                <c:pt idx="19">
                  <c:v>4.3177892918825622E-3</c:v>
                </c:pt>
                <c:pt idx="20">
                  <c:v>2.5906735751295299E-3</c:v>
                </c:pt>
              </c:numCache>
            </c:numRef>
          </c:val>
        </c:ser>
        <c:ser>
          <c:idx val="10"/>
          <c:order val="10"/>
          <c:tx>
            <c:strRef>
              <c:f>'glr-1(n2461)_A1_0.02_5%'!$L$104</c:f>
              <c:strCache>
                <c:ptCount val="1"/>
                <c:pt idx="0">
                  <c:v>glr-1(n2461)_A1_11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L$105:$L$125</c:f>
              <c:numCache>
                <c:formatCode>General</c:formatCode>
                <c:ptCount val="21"/>
                <c:pt idx="1">
                  <c:v>6.795469686875423E-2</c:v>
                </c:pt>
                <c:pt idx="2">
                  <c:v>9.2604930046635628E-2</c:v>
                </c:pt>
                <c:pt idx="3">
                  <c:v>0.126582278481013</c:v>
                </c:pt>
                <c:pt idx="4">
                  <c:v>0.14790139906728811</c:v>
                </c:pt>
                <c:pt idx="5">
                  <c:v>0.15722851432378396</c:v>
                </c:pt>
                <c:pt idx="6">
                  <c:v>9.1938707528314484E-2</c:v>
                </c:pt>
                <c:pt idx="7">
                  <c:v>4.39706862091939E-2</c:v>
                </c:pt>
                <c:pt idx="8">
                  <c:v>4.9300466355762816E-2</c:v>
                </c:pt>
                <c:pt idx="9">
                  <c:v>4.7301798800799502E-2</c:v>
                </c:pt>
                <c:pt idx="10">
                  <c:v>2.7981345769487017E-2</c:v>
                </c:pt>
                <c:pt idx="11">
                  <c:v>2.7315123251165908E-2</c:v>
                </c:pt>
                <c:pt idx="12">
                  <c:v>2.5316455696202493E-2</c:v>
                </c:pt>
                <c:pt idx="13">
                  <c:v>1.5989340439706901E-2</c:v>
                </c:pt>
                <c:pt idx="14">
                  <c:v>1.7321785476349102E-2</c:v>
                </c:pt>
                <c:pt idx="15">
                  <c:v>4.6635576282478284E-3</c:v>
                </c:pt>
                <c:pt idx="16">
                  <c:v>6.6622251832111935E-3</c:v>
                </c:pt>
                <c:pt idx="17">
                  <c:v>1.3324450366422409E-3</c:v>
                </c:pt>
                <c:pt idx="18">
                  <c:v>2.664890073284481E-3</c:v>
                </c:pt>
                <c:pt idx="19">
                  <c:v>6.6622251832111948E-4</c:v>
                </c:pt>
                <c:pt idx="20">
                  <c:v>1.3324450366422409E-3</c:v>
                </c:pt>
              </c:numCache>
            </c:numRef>
          </c:val>
        </c:ser>
        <c:ser>
          <c:idx val="11"/>
          <c:order val="11"/>
          <c:tx>
            <c:strRef>
              <c:f>'glr-1(n2461)_A1_0.02_5%'!$M$104</c:f>
              <c:strCache>
                <c:ptCount val="1"/>
                <c:pt idx="0">
                  <c:v>glr-1(n2461)_A1_12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M$105:$M$125</c:f>
              <c:numCache>
                <c:formatCode>General</c:formatCode>
                <c:ptCount val="21"/>
                <c:pt idx="1">
                  <c:v>7.7003121748179013E-2</c:v>
                </c:pt>
                <c:pt idx="2">
                  <c:v>0.11758584807492202</c:v>
                </c:pt>
                <c:pt idx="3">
                  <c:v>0.11238293444328799</c:v>
                </c:pt>
                <c:pt idx="4">
                  <c:v>0.14255983350676407</c:v>
                </c:pt>
                <c:pt idx="5">
                  <c:v>0.106139438085328</c:v>
                </c:pt>
                <c:pt idx="6">
                  <c:v>6.6597294484911626E-2</c:v>
                </c:pt>
                <c:pt idx="7">
                  <c:v>6.7637877211238331E-2</c:v>
                </c:pt>
                <c:pt idx="8">
                  <c:v>5.4110301768990614E-2</c:v>
                </c:pt>
                <c:pt idx="9">
                  <c:v>5.9313215400624321E-2</c:v>
                </c:pt>
                <c:pt idx="10">
                  <c:v>2.8095733610822106E-2</c:v>
                </c:pt>
                <c:pt idx="11">
                  <c:v>2.7055150884495317E-2</c:v>
                </c:pt>
                <c:pt idx="12">
                  <c:v>1.5608740894901101E-2</c:v>
                </c:pt>
                <c:pt idx="13">
                  <c:v>1.3527575442247709E-2</c:v>
                </c:pt>
                <c:pt idx="14">
                  <c:v>9.365244536940702E-3</c:v>
                </c:pt>
                <c:pt idx="15">
                  <c:v>6.2434963579604619E-3</c:v>
                </c:pt>
                <c:pt idx="16">
                  <c:v>4.1623309053069697E-3</c:v>
                </c:pt>
                <c:pt idx="17">
                  <c:v>9.365244536940702E-3</c:v>
                </c:pt>
                <c:pt idx="18">
                  <c:v>3.121748178980231E-3</c:v>
                </c:pt>
                <c:pt idx="19">
                  <c:v>4.1623309053069697E-3</c:v>
                </c:pt>
                <c:pt idx="20">
                  <c:v>4.1623309053069697E-3</c:v>
                </c:pt>
              </c:numCache>
            </c:numRef>
          </c:val>
        </c:ser>
        <c:ser>
          <c:idx val="12"/>
          <c:order val="12"/>
          <c:tx>
            <c:strRef>
              <c:f>'glr-1(n2461)_A1_0.02_5%'!$N$104</c:f>
              <c:strCache>
                <c:ptCount val="1"/>
                <c:pt idx="0">
                  <c:v>glr-1(n2461)_A1_13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N$105:$N$125</c:f>
              <c:numCache>
                <c:formatCode>General</c:formatCode>
                <c:ptCount val="21"/>
                <c:pt idx="1">
                  <c:v>9.768451519536904E-2</c:v>
                </c:pt>
                <c:pt idx="2">
                  <c:v>0.11649782923299598</c:v>
                </c:pt>
                <c:pt idx="3">
                  <c:v>0.12156295224312604</c:v>
                </c:pt>
                <c:pt idx="4">
                  <c:v>0.15340086830680205</c:v>
                </c:pt>
                <c:pt idx="5">
                  <c:v>0.14254703328509408</c:v>
                </c:pt>
                <c:pt idx="6">
                  <c:v>7.7424023154848032E-2</c:v>
                </c:pt>
                <c:pt idx="7">
                  <c:v>4.6309696092619403E-2</c:v>
                </c:pt>
                <c:pt idx="8">
                  <c:v>5.2098408104196817E-2</c:v>
                </c:pt>
                <c:pt idx="9">
                  <c:v>3.8350217076700416E-2</c:v>
                </c:pt>
                <c:pt idx="10">
                  <c:v>1.9536903039073801E-2</c:v>
                </c:pt>
                <c:pt idx="11">
                  <c:v>2.7496382054992802E-2</c:v>
                </c:pt>
                <c:pt idx="12">
                  <c:v>1.3024602026049199E-2</c:v>
                </c:pt>
                <c:pt idx="13">
                  <c:v>1.0130246020260495E-2</c:v>
                </c:pt>
                <c:pt idx="14">
                  <c:v>6.5123010130246038E-3</c:v>
                </c:pt>
                <c:pt idx="15">
                  <c:v>7.9594790159189677E-3</c:v>
                </c:pt>
                <c:pt idx="16">
                  <c:v>2.1707670043415311E-3</c:v>
                </c:pt>
                <c:pt idx="17">
                  <c:v>2.1707670043415311E-3</c:v>
                </c:pt>
                <c:pt idx="18">
                  <c:v>1.44717800289436E-3</c:v>
                </c:pt>
                <c:pt idx="19">
                  <c:v>2.1707670043415311E-3</c:v>
                </c:pt>
                <c:pt idx="20">
                  <c:v>1.44717800289436E-3</c:v>
                </c:pt>
              </c:numCache>
            </c:numRef>
          </c:val>
        </c:ser>
        <c:ser>
          <c:idx val="13"/>
          <c:order val="13"/>
          <c:tx>
            <c:strRef>
              <c:f>'glr-1(n2461)_A1_0.02_5%'!$O$104</c:f>
              <c:strCache>
                <c:ptCount val="1"/>
                <c:pt idx="0">
                  <c:v>glr-1(n2461)_A1_14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O$105:$O$125</c:f>
              <c:numCache>
                <c:formatCode>General</c:formatCode>
                <c:ptCount val="21"/>
                <c:pt idx="1">
                  <c:v>6.0991957104557598E-2</c:v>
                </c:pt>
                <c:pt idx="2">
                  <c:v>9.9195710455764127E-2</c:v>
                </c:pt>
                <c:pt idx="3">
                  <c:v>0.12265415549597899</c:v>
                </c:pt>
                <c:pt idx="4">
                  <c:v>0.14611260053619307</c:v>
                </c:pt>
                <c:pt idx="5">
                  <c:v>0.14611260053619307</c:v>
                </c:pt>
                <c:pt idx="6">
                  <c:v>8.2439678284182305E-2</c:v>
                </c:pt>
                <c:pt idx="7">
                  <c:v>5.9651474530831118E-2</c:v>
                </c:pt>
                <c:pt idx="8">
                  <c:v>5.42895442359249E-2</c:v>
                </c:pt>
                <c:pt idx="9">
                  <c:v>4.825737265415548E-2</c:v>
                </c:pt>
                <c:pt idx="10">
                  <c:v>3.1501340482573734E-2</c:v>
                </c:pt>
                <c:pt idx="11">
                  <c:v>2.5469168900804313E-2</c:v>
                </c:pt>
                <c:pt idx="12">
                  <c:v>1.8096514745308306E-2</c:v>
                </c:pt>
                <c:pt idx="13">
                  <c:v>1.5415549597855205E-2</c:v>
                </c:pt>
                <c:pt idx="14">
                  <c:v>9.3833780160857954E-3</c:v>
                </c:pt>
                <c:pt idx="15">
                  <c:v>8.042895442359253E-3</c:v>
                </c:pt>
                <c:pt idx="16">
                  <c:v>6.0321715817694419E-3</c:v>
                </c:pt>
                <c:pt idx="17">
                  <c:v>6.0321715817694419E-3</c:v>
                </c:pt>
                <c:pt idx="18">
                  <c:v>4.0214477211796239E-3</c:v>
                </c:pt>
                <c:pt idx="19">
                  <c:v>2.0107238605898111E-3</c:v>
                </c:pt>
                <c:pt idx="20">
                  <c:v>1.3404825737265414E-3</c:v>
                </c:pt>
              </c:numCache>
            </c:numRef>
          </c:val>
        </c:ser>
        <c:ser>
          <c:idx val="14"/>
          <c:order val="14"/>
          <c:tx>
            <c:strRef>
              <c:f>'glr-1(n2461)_A1_0.02_5%'!$P$104</c:f>
              <c:strCache>
                <c:ptCount val="1"/>
                <c:pt idx="0">
                  <c:v>glr-1(n2461)_A1_15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P$105:$P$125</c:f>
              <c:numCache>
                <c:formatCode>General</c:formatCode>
                <c:ptCount val="21"/>
                <c:pt idx="1">
                  <c:v>6.8390325271059205E-2</c:v>
                </c:pt>
                <c:pt idx="2">
                  <c:v>0.10091743119266094</c:v>
                </c:pt>
                <c:pt idx="3">
                  <c:v>0.12427022518765606</c:v>
                </c:pt>
                <c:pt idx="4">
                  <c:v>0.15095913261050906</c:v>
                </c:pt>
                <c:pt idx="5">
                  <c:v>0.15512927439532906</c:v>
                </c:pt>
                <c:pt idx="6">
                  <c:v>6.4220183486238494E-2</c:v>
                </c:pt>
                <c:pt idx="7">
                  <c:v>5.2543786488740599E-2</c:v>
                </c:pt>
                <c:pt idx="8">
                  <c:v>5.9216013344453727E-2</c:v>
                </c:pt>
                <c:pt idx="9">
                  <c:v>4.7539616346955804E-2</c:v>
                </c:pt>
                <c:pt idx="10">
                  <c:v>4.3369474562135114E-2</c:v>
                </c:pt>
                <c:pt idx="11">
                  <c:v>3.0025020850708892E-2</c:v>
                </c:pt>
                <c:pt idx="12">
                  <c:v>1.0842368640533805E-2</c:v>
                </c:pt>
                <c:pt idx="13">
                  <c:v>1.4178482068390298E-2</c:v>
                </c:pt>
                <c:pt idx="14">
                  <c:v>5.0041701417848222E-3</c:v>
                </c:pt>
                <c:pt idx="15">
                  <c:v>3.3361134278565509E-3</c:v>
                </c:pt>
                <c:pt idx="16">
                  <c:v>4.1701417848206837E-3</c:v>
                </c:pt>
                <c:pt idx="17">
                  <c:v>4.1701417848206837E-3</c:v>
                </c:pt>
                <c:pt idx="18">
                  <c:v>2.5020850708924107E-3</c:v>
                </c:pt>
                <c:pt idx="19">
                  <c:v>0</c:v>
                </c:pt>
                <c:pt idx="20">
                  <c:v>8.340283569641374E-4</c:v>
                </c:pt>
              </c:numCache>
            </c:numRef>
          </c:val>
        </c:ser>
        <c:ser>
          <c:idx val="15"/>
          <c:order val="15"/>
          <c:tx>
            <c:strRef>
              <c:f>'glr-1(n2461)_A1_0.02_5%'!$Q$104</c:f>
              <c:strCache>
                <c:ptCount val="1"/>
                <c:pt idx="0">
                  <c:v>glr-1(n2461)_A1_16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Q$105:$Q$125</c:f>
              <c:numCache>
                <c:formatCode>General</c:formatCode>
                <c:ptCount val="21"/>
                <c:pt idx="1">
                  <c:v>5.9322033898305135E-2</c:v>
                </c:pt>
                <c:pt idx="2">
                  <c:v>8.0508474576271236E-2</c:v>
                </c:pt>
                <c:pt idx="3">
                  <c:v>0.10169491525423703</c:v>
                </c:pt>
                <c:pt idx="4">
                  <c:v>0.15677966101694901</c:v>
                </c:pt>
                <c:pt idx="5">
                  <c:v>0.12288135593220302</c:v>
                </c:pt>
                <c:pt idx="6">
                  <c:v>8.0508474576271236E-2</c:v>
                </c:pt>
                <c:pt idx="7">
                  <c:v>8.0508474576271236E-2</c:v>
                </c:pt>
                <c:pt idx="8">
                  <c:v>1.27118644067797E-2</c:v>
                </c:pt>
                <c:pt idx="9">
                  <c:v>6.3559322033898302E-2</c:v>
                </c:pt>
                <c:pt idx="10">
                  <c:v>3.8135593220338999E-2</c:v>
                </c:pt>
                <c:pt idx="11">
                  <c:v>2.9661016949152502E-2</c:v>
                </c:pt>
                <c:pt idx="12">
                  <c:v>2.542372881355931E-2</c:v>
                </c:pt>
                <c:pt idx="13">
                  <c:v>2.9661016949152502E-2</c:v>
                </c:pt>
                <c:pt idx="14">
                  <c:v>1.27118644067797E-2</c:v>
                </c:pt>
                <c:pt idx="15">
                  <c:v>8.4745762711864476E-3</c:v>
                </c:pt>
                <c:pt idx="16">
                  <c:v>8.4745762711864476E-3</c:v>
                </c:pt>
                <c:pt idx="17">
                  <c:v>8.4745762711864476E-3</c:v>
                </c:pt>
                <c:pt idx="18">
                  <c:v>4.2372881355932238E-3</c:v>
                </c:pt>
                <c:pt idx="19">
                  <c:v>1.27118644067797E-2</c:v>
                </c:pt>
                <c:pt idx="20">
                  <c:v>4.2372881355932238E-3</c:v>
                </c:pt>
              </c:numCache>
            </c:numRef>
          </c:val>
        </c:ser>
        <c:ser>
          <c:idx val="16"/>
          <c:order val="16"/>
          <c:tx>
            <c:strRef>
              <c:f>'glr-1(n2461)_A1_0.02_5%'!$R$104</c:f>
              <c:strCache>
                <c:ptCount val="1"/>
                <c:pt idx="0">
                  <c:v>glr-1(n2461)_A1_17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R$105:$R$125</c:f>
              <c:numCache>
                <c:formatCode>General</c:formatCode>
                <c:ptCount val="21"/>
                <c:pt idx="1">
                  <c:v>6.1936259771497297E-2</c:v>
                </c:pt>
                <c:pt idx="2">
                  <c:v>9.9819603126879153E-2</c:v>
                </c:pt>
                <c:pt idx="3">
                  <c:v>0.11545399879735396</c:v>
                </c:pt>
                <c:pt idx="4">
                  <c:v>0.14191220685508107</c:v>
                </c:pt>
                <c:pt idx="5">
                  <c:v>0.18761274804570099</c:v>
                </c:pt>
                <c:pt idx="6">
                  <c:v>7.9975947083583895E-2</c:v>
                </c:pt>
                <c:pt idx="7">
                  <c:v>5.1713770294648236E-2</c:v>
                </c:pt>
                <c:pt idx="8">
                  <c:v>4.2092603728202026E-2</c:v>
                </c:pt>
                <c:pt idx="9">
                  <c:v>4.6903187011425103E-2</c:v>
                </c:pt>
                <c:pt idx="10">
                  <c:v>4.0288634996993429E-2</c:v>
                </c:pt>
                <c:pt idx="11">
                  <c:v>3.2471437161755913E-2</c:v>
                </c:pt>
                <c:pt idx="12">
                  <c:v>1.6235718580877901E-2</c:v>
                </c:pt>
                <c:pt idx="13">
                  <c:v>1.2627781118460607E-2</c:v>
                </c:pt>
                <c:pt idx="14">
                  <c:v>6.0132291040288655E-3</c:v>
                </c:pt>
                <c:pt idx="15">
                  <c:v>6.0132291040288655E-3</c:v>
                </c:pt>
                <c:pt idx="16">
                  <c:v>5.4119061936259817E-3</c:v>
                </c:pt>
                <c:pt idx="17">
                  <c:v>3.0066145520144319E-3</c:v>
                </c:pt>
                <c:pt idx="18">
                  <c:v>3.0066145520144319E-3</c:v>
                </c:pt>
                <c:pt idx="19">
                  <c:v>0</c:v>
                </c:pt>
                <c:pt idx="20">
                  <c:v>6.013229104028867E-4</c:v>
                </c:pt>
              </c:numCache>
            </c:numRef>
          </c:val>
        </c:ser>
        <c:ser>
          <c:idx val="17"/>
          <c:order val="17"/>
          <c:tx>
            <c:strRef>
              <c:f>'glr-1(n2461)_A1_0.02_5%'!$S$104</c:f>
              <c:strCache>
                <c:ptCount val="1"/>
                <c:pt idx="0">
                  <c:v>glr-1(n2461)_A1_18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S$105:$S$125</c:f>
              <c:numCache>
                <c:formatCode>General</c:formatCode>
                <c:ptCount val="21"/>
                <c:pt idx="1">
                  <c:v>5.9540889526542302E-2</c:v>
                </c:pt>
                <c:pt idx="2">
                  <c:v>0.10473457675753209</c:v>
                </c:pt>
                <c:pt idx="3">
                  <c:v>0.13414634146341506</c:v>
                </c:pt>
                <c:pt idx="4">
                  <c:v>0.14921090387374505</c:v>
                </c:pt>
                <c:pt idx="5">
                  <c:v>0.14490674318507907</c:v>
                </c:pt>
                <c:pt idx="6">
                  <c:v>7.8909612625538014E-2</c:v>
                </c:pt>
                <c:pt idx="7">
                  <c:v>5.0215208034433315E-2</c:v>
                </c:pt>
                <c:pt idx="8">
                  <c:v>5.0215208034433315E-2</c:v>
                </c:pt>
                <c:pt idx="9">
                  <c:v>4.3758967001434716E-2</c:v>
                </c:pt>
                <c:pt idx="10">
                  <c:v>3.3715925394548103E-2</c:v>
                </c:pt>
                <c:pt idx="11">
                  <c:v>2.58249641319943E-2</c:v>
                </c:pt>
                <c:pt idx="12">
                  <c:v>1.21951219512195E-2</c:v>
                </c:pt>
                <c:pt idx="13">
                  <c:v>1.3629842180774695E-2</c:v>
                </c:pt>
                <c:pt idx="14">
                  <c:v>5.7388809182209498E-3</c:v>
                </c:pt>
                <c:pt idx="15">
                  <c:v>1.0043041606886701E-2</c:v>
                </c:pt>
                <c:pt idx="16">
                  <c:v>2.8694404591104701E-3</c:v>
                </c:pt>
                <c:pt idx="17">
                  <c:v>2.1520803443328602E-3</c:v>
                </c:pt>
                <c:pt idx="18">
                  <c:v>7.1736011477761836E-3</c:v>
                </c:pt>
                <c:pt idx="19">
                  <c:v>4.30416068866571E-3</c:v>
                </c:pt>
                <c:pt idx="20">
                  <c:v>1.4347202295552401E-3</c:v>
                </c:pt>
              </c:numCache>
            </c:numRef>
          </c:val>
        </c:ser>
        <c:ser>
          <c:idx val="18"/>
          <c:order val="18"/>
          <c:tx>
            <c:strRef>
              <c:f>'glr-1(n2461)_A1_0.02_5%'!$T$104</c:f>
              <c:strCache>
                <c:ptCount val="1"/>
                <c:pt idx="0">
                  <c:v>glr-1(n2461)_A1_19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T$105:$T$125</c:f>
              <c:numCache>
                <c:formatCode>General</c:formatCode>
                <c:ptCount val="21"/>
                <c:pt idx="1">
                  <c:v>7.5545171339563899E-2</c:v>
                </c:pt>
                <c:pt idx="2">
                  <c:v>0.10514018691588803</c:v>
                </c:pt>
                <c:pt idx="3">
                  <c:v>0.10825545171339603</c:v>
                </c:pt>
                <c:pt idx="4">
                  <c:v>0.13006230529595</c:v>
                </c:pt>
                <c:pt idx="5">
                  <c:v>0.13940809968847406</c:v>
                </c:pt>
                <c:pt idx="6">
                  <c:v>8.2554517133956451E-2</c:v>
                </c:pt>
                <c:pt idx="7">
                  <c:v>5.7632398753894101E-2</c:v>
                </c:pt>
                <c:pt idx="8">
                  <c:v>4.9065420560747718E-2</c:v>
                </c:pt>
                <c:pt idx="9">
                  <c:v>4.2834890965732113E-2</c:v>
                </c:pt>
                <c:pt idx="10">
                  <c:v>3.6604361370716515E-2</c:v>
                </c:pt>
                <c:pt idx="11">
                  <c:v>2.7258566978193108E-2</c:v>
                </c:pt>
                <c:pt idx="12">
                  <c:v>2.8816199376946999E-2</c:v>
                </c:pt>
                <c:pt idx="13">
                  <c:v>1.8691588785046703E-2</c:v>
                </c:pt>
                <c:pt idx="14">
                  <c:v>1.0124610591900299E-2</c:v>
                </c:pt>
                <c:pt idx="15">
                  <c:v>8.5669781931464201E-3</c:v>
                </c:pt>
                <c:pt idx="16">
                  <c:v>8.5669781931464201E-3</c:v>
                </c:pt>
                <c:pt idx="17">
                  <c:v>7.7881619937694739E-3</c:v>
                </c:pt>
                <c:pt idx="18">
                  <c:v>5.4517133956386351E-3</c:v>
                </c:pt>
                <c:pt idx="19">
                  <c:v>3.89408099688474E-3</c:v>
                </c:pt>
                <c:pt idx="2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glr-1(n2461)_A1_0.02_5%'!$U$104</c:f>
              <c:strCache>
                <c:ptCount val="1"/>
                <c:pt idx="0">
                  <c:v>glr-1(n2461)_A1_20</c:v>
                </c:pt>
              </c:strCache>
            </c:strRef>
          </c:tx>
          <c:marker>
            <c:symbol val="none"/>
          </c:marker>
          <c:cat>
            <c:numRef>
              <c:f>'glr-1(n246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1_0.02_5%'!$U$105:$U$125</c:f>
              <c:numCache>
                <c:formatCode>General</c:formatCode>
                <c:ptCount val="21"/>
                <c:pt idx="1">
                  <c:v>7.9166666666666732E-2</c:v>
                </c:pt>
                <c:pt idx="2">
                  <c:v>7.9166666666666732E-2</c:v>
                </c:pt>
                <c:pt idx="3">
                  <c:v>0.110416666666667</c:v>
                </c:pt>
                <c:pt idx="4">
                  <c:v>0.12986111111111101</c:v>
                </c:pt>
                <c:pt idx="5">
                  <c:v>0.15416666666666701</c:v>
                </c:pt>
                <c:pt idx="6">
                  <c:v>7.2222222222222229E-2</c:v>
                </c:pt>
                <c:pt idx="7">
                  <c:v>4.7916666666666718E-2</c:v>
                </c:pt>
                <c:pt idx="8">
                  <c:v>5.1388888888888901E-2</c:v>
                </c:pt>
                <c:pt idx="9">
                  <c:v>3.9583333333333297E-2</c:v>
                </c:pt>
                <c:pt idx="10">
                  <c:v>4.3055555555555569E-2</c:v>
                </c:pt>
                <c:pt idx="11">
                  <c:v>2.3611111111111114E-2</c:v>
                </c:pt>
                <c:pt idx="12">
                  <c:v>3.3333333333333298E-2</c:v>
                </c:pt>
                <c:pt idx="13">
                  <c:v>1.8055555555555606E-2</c:v>
                </c:pt>
                <c:pt idx="14">
                  <c:v>1.6666666666666701E-2</c:v>
                </c:pt>
                <c:pt idx="15">
                  <c:v>1.1805555555555609E-2</c:v>
                </c:pt>
                <c:pt idx="16">
                  <c:v>7.6388888888888904E-3</c:v>
                </c:pt>
                <c:pt idx="17">
                  <c:v>5.5555555555555601E-3</c:v>
                </c:pt>
                <c:pt idx="18">
                  <c:v>6.2500000000000021E-3</c:v>
                </c:pt>
                <c:pt idx="19">
                  <c:v>1.3888888888888909E-3</c:v>
                </c:pt>
                <c:pt idx="20">
                  <c:v>2.7777777777777827E-3</c:v>
                </c:pt>
              </c:numCache>
            </c:numRef>
          </c:val>
        </c:ser>
        <c:marker val="1"/>
        <c:axId val="158562560"/>
        <c:axId val="158572544"/>
      </c:lineChart>
      <c:catAx>
        <c:axId val="158562560"/>
        <c:scaling>
          <c:orientation val="minMax"/>
        </c:scaling>
        <c:axPos val="b"/>
        <c:numFmt formatCode="0.0_ " sourceLinked="1"/>
        <c:tickLblPos val="nextTo"/>
        <c:crossAx val="158572544"/>
        <c:crosses val="autoZero"/>
        <c:auto val="1"/>
        <c:lblAlgn val="ctr"/>
        <c:lblOffset val="100"/>
        <c:tickLblSkip val="5"/>
        <c:tickMarkSkip val="5"/>
      </c:catAx>
      <c:valAx>
        <c:axId val="15857254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8562560"/>
        <c:crosses val="autoZero"/>
        <c:crossBetween val="between"/>
      </c:valAx>
    </c:plotArea>
    <c:plotVisOnly val="1"/>
  </c:chart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L4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L4_0.02_5%'!$B$104</c:f>
              <c:strCache>
                <c:ptCount val="1"/>
                <c:pt idx="0">
                  <c:v>unc-49_L4_0601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B$105:$B$125</c:f>
              <c:numCache>
                <c:formatCode>General</c:formatCode>
                <c:ptCount val="21"/>
              </c:numCache>
            </c:numRef>
          </c:val>
        </c:ser>
        <c:ser>
          <c:idx val="1"/>
          <c:order val="1"/>
          <c:tx>
            <c:strRef>
              <c:f>'unc-49 L4_0.02_5%'!$C$104</c:f>
              <c:strCache>
                <c:ptCount val="1"/>
                <c:pt idx="0">
                  <c:v>unc-49_L4_0602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C$105:$C$125</c:f>
              <c:numCache>
                <c:formatCode>General</c:formatCode>
                <c:ptCount val="21"/>
                <c:pt idx="1">
                  <c:v>6.7349350137849595E-2</c:v>
                </c:pt>
                <c:pt idx="2">
                  <c:v>8.5072863332020535E-2</c:v>
                </c:pt>
                <c:pt idx="3">
                  <c:v>0.117762898779047</c:v>
                </c:pt>
                <c:pt idx="4">
                  <c:v>0.12209531311540002</c:v>
                </c:pt>
                <c:pt idx="5">
                  <c:v>0.11894446632532497</c:v>
                </c:pt>
                <c:pt idx="6">
                  <c:v>8.3891295785742476E-2</c:v>
                </c:pt>
                <c:pt idx="7">
                  <c:v>5.9472233162662515E-2</c:v>
                </c:pt>
                <c:pt idx="8">
                  <c:v>5.3170539582512784E-2</c:v>
                </c:pt>
                <c:pt idx="9">
                  <c:v>4.6868846002363095E-2</c:v>
                </c:pt>
                <c:pt idx="10">
                  <c:v>3.5447026388341914E-2</c:v>
                </c:pt>
                <c:pt idx="11">
                  <c:v>3.1902323749507702E-2</c:v>
                </c:pt>
                <c:pt idx="12">
                  <c:v>2.3237495076801899E-2</c:v>
                </c:pt>
                <c:pt idx="13">
                  <c:v>1.4572666404096095E-2</c:v>
                </c:pt>
                <c:pt idx="14">
                  <c:v>1.4178810555336699E-2</c:v>
                </c:pt>
                <c:pt idx="15">
                  <c:v>1.1421819614021307E-2</c:v>
                </c:pt>
                <c:pt idx="16">
                  <c:v>1.0634107916502603E-2</c:v>
                </c:pt>
                <c:pt idx="17">
                  <c:v>8.2709728239464438E-3</c:v>
                </c:pt>
                <c:pt idx="18">
                  <c:v>5.907837731390312E-3</c:v>
                </c:pt>
                <c:pt idx="19">
                  <c:v>3.5447026388341907E-3</c:v>
                </c:pt>
                <c:pt idx="20">
                  <c:v>6.3016935801496754E-3</c:v>
                </c:pt>
              </c:numCache>
            </c:numRef>
          </c:val>
        </c:ser>
        <c:ser>
          <c:idx val="2"/>
          <c:order val="2"/>
          <c:tx>
            <c:strRef>
              <c:f>'unc-49 L4_0.02_5%'!$D$104</c:f>
              <c:strCache>
                <c:ptCount val="1"/>
                <c:pt idx="0">
                  <c:v>unc-49_L4_06021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D$105:$D$125</c:f>
              <c:numCache>
                <c:formatCode>General</c:formatCode>
                <c:ptCount val="21"/>
                <c:pt idx="1">
                  <c:v>9.2996555683122831E-2</c:v>
                </c:pt>
                <c:pt idx="2">
                  <c:v>0.10619977037887506</c:v>
                </c:pt>
                <c:pt idx="3">
                  <c:v>0.11768082663605102</c:v>
                </c:pt>
                <c:pt idx="4">
                  <c:v>0.10964408725602805</c:v>
                </c:pt>
                <c:pt idx="5">
                  <c:v>0.10390355912744</c:v>
                </c:pt>
                <c:pt idx="6">
                  <c:v>8.3811710677382301E-2</c:v>
                </c:pt>
                <c:pt idx="7">
                  <c:v>7.0608495981630326E-2</c:v>
                </c:pt>
                <c:pt idx="8">
                  <c:v>5.5109070034443229E-2</c:v>
                </c:pt>
                <c:pt idx="9">
                  <c:v>4.1905855338691178E-2</c:v>
                </c:pt>
                <c:pt idx="10">
                  <c:v>2.9276693455797899E-2</c:v>
                </c:pt>
                <c:pt idx="11">
                  <c:v>1.4925373134328401E-2</c:v>
                </c:pt>
                <c:pt idx="12">
                  <c:v>1.4925373134328401E-2</c:v>
                </c:pt>
                <c:pt idx="13">
                  <c:v>1.3777267508610799E-2</c:v>
                </c:pt>
                <c:pt idx="14">
                  <c:v>9.7588978185993176E-3</c:v>
                </c:pt>
                <c:pt idx="15">
                  <c:v>6.3145809414466084E-3</c:v>
                </c:pt>
                <c:pt idx="16">
                  <c:v>8.0367393800229638E-3</c:v>
                </c:pt>
                <c:pt idx="17">
                  <c:v>8.6107921928817444E-3</c:v>
                </c:pt>
                <c:pt idx="18">
                  <c:v>4.5924225028702598E-3</c:v>
                </c:pt>
                <c:pt idx="19">
                  <c:v>3.4443168771527018E-3</c:v>
                </c:pt>
                <c:pt idx="20">
                  <c:v>2.2962112514351312E-3</c:v>
                </c:pt>
              </c:numCache>
            </c:numRef>
          </c:val>
        </c:ser>
        <c:ser>
          <c:idx val="3"/>
          <c:order val="3"/>
          <c:tx>
            <c:strRef>
              <c:f>'unc-49 L4_0.02_5%'!$E$104</c:f>
              <c:strCache>
                <c:ptCount val="1"/>
                <c:pt idx="0">
                  <c:v>unc-49_L4_06022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E$105:$E$125</c:f>
              <c:numCache>
                <c:formatCode>General</c:formatCode>
                <c:ptCount val="21"/>
                <c:pt idx="1">
                  <c:v>9.9699699699699759E-2</c:v>
                </c:pt>
                <c:pt idx="2">
                  <c:v>0.10030030030029999</c:v>
                </c:pt>
                <c:pt idx="3">
                  <c:v>0.11171171171171203</c:v>
                </c:pt>
                <c:pt idx="4">
                  <c:v>9.4894894894894985E-2</c:v>
                </c:pt>
                <c:pt idx="5">
                  <c:v>9.429429429429434E-2</c:v>
                </c:pt>
                <c:pt idx="6">
                  <c:v>6.1261261261261302E-2</c:v>
                </c:pt>
                <c:pt idx="7">
                  <c:v>5.8858858858858901E-2</c:v>
                </c:pt>
                <c:pt idx="8">
                  <c:v>5.1051051051051101E-2</c:v>
                </c:pt>
                <c:pt idx="9">
                  <c:v>3.9039039039038999E-2</c:v>
                </c:pt>
                <c:pt idx="10">
                  <c:v>2.8828828828828798E-2</c:v>
                </c:pt>
                <c:pt idx="11">
                  <c:v>3.6636636636636598E-2</c:v>
                </c:pt>
                <c:pt idx="12">
                  <c:v>3.1231231231231206E-2</c:v>
                </c:pt>
                <c:pt idx="13">
                  <c:v>1.8018018018018007E-2</c:v>
                </c:pt>
                <c:pt idx="14">
                  <c:v>1.32132132132132E-2</c:v>
                </c:pt>
                <c:pt idx="15">
                  <c:v>8.4084084084084139E-3</c:v>
                </c:pt>
                <c:pt idx="16">
                  <c:v>3.6036036036036002E-3</c:v>
                </c:pt>
                <c:pt idx="17">
                  <c:v>6.6066066066066114E-3</c:v>
                </c:pt>
                <c:pt idx="18">
                  <c:v>3.0030030030030012E-3</c:v>
                </c:pt>
                <c:pt idx="19">
                  <c:v>5.4054054054054118E-3</c:v>
                </c:pt>
                <c:pt idx="20">
                  <c:v>3.6036036036036002E-3</c:v>
                </c:pt>
              </c:numCache>
            </c:numRef>
          </c:val>
        </c:ser>
        <c:ser>
          <c:idx val="4"/>
          <c:order val="4"/>
          <c:tx>
            <c:strRef>
              <c:f>'unc-49 L4_0.02_5%'!$F$104</c:f>
              <c:strCache>
                <c:ptCount val="1"/>
                <c:pt idx="0">
                  <c:v>unc-49_L4_06023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F$105:$F$125</c:f>
              <c:numCache>
                <c:formatCode>General</c:formatCode>
                <c:ptCount val="21"/>
                <c:pt idx="1">
                  <c:v>0.10734463276836199</c:v>
                </c:pt>
                <c:pt idx="2">
                  <c:v>0.10056497175141209</c:v>
                </c:pt>
                <c:pt idx="3">
                  <c:v>0.10508474576271205</c:v>
                </c:pt>
                <c:pt idx="4">
                  <c:v>0.102824858757062</c:v>
                </c:pt>
                <c:pt idx="5">
                  <c:v>9.7175141242937899E-2</c:v>
                </c:pt>
                <c:pt idx="6">
                  <c:v>6.21468926553672E-2</c:v>
                </c:pt>
                <c:pt idx="7">
                  <c:v>5.084745762711862E-2</c:v>
                </c:pt>
                <c:pt idx="8">
                  <c:v>3.2768361581920917E-2</c:v>
                </c:pt>
                <c:pt idx="9">
                  <c:v>3.6158192090395502E-2</c:v>
                </c:pt>
                <c:pt idx="10">
                  <c:v>3.9548022598870115E-2</c:v>
                </c:pt>
                <c:pt idx="11">
                  <c:v>2.824858757062151E-2</c:v>
                </c:pt>
                <c:pt idx="12">
                  <c:v>1.6949152542372906E-2</c:v>
                </c:pt>
                <c:pt idx="13">
                  <c:v>7.9096045197740127E-3</c:v>
                </c:pt>
                <c:pt idx="14">
                  <c:v>4.5197740112994404E-3</c:v>
                </c:pt>
                <c:pt idx="15">
                  <c:v>9.0395480225988704E-3</c:v>
                </c:pt>
                <c:pt idx="16">
                  <c:v>6.7796610169491541E-3</c:v>
                </c:pt>
                <c:pt idx="17">
                  <c:v>1.1299435028248601E-3</c:v>
                </c:pt>
                <c:pt idx="18">
                  <c:v>2.2598870056497202E-3</c:v>
                </c:pt>
                <c:pt idx="19">
                  <c:v>1.1299435028248601E-3</c:v>
                </c:pt>
                <c:pt idx="20">
                  <c:v>0</c:v>
                </c:pt>
              </c:numCache>
            </c:numRef>
          </c:val>
        </c:ser>
        <c:ser>
          <c:idx val="5"/>
          <c:order val="5"/>
          <c:tx>
            <c:strRef>
              <c:f>'unc-49 L4_0.02_5%'!$G$104</c:f>
              <c:strCache>
                <c:ptCount val="1"/>
                <c:pt idx="0">
                  <c:v>unc-49_L4_06024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G$105:$G$125</c:f>
              <c:numCache>
                <c:formatCode>General</c:formatCode>
                <c:ptCount val="21"/>
                <c:pt idx="1">
                  <c:v>7.3520249221183803E-2</c:v>
                </c:pt>
                <c:pt idx="2">
                  <c:v>0.10467289719626198</c:v>
                </c:pt>
                <c:pt idx="3">
                  <c:v>0.10404984423676</c:v>
                </c:pt>
                <c:pt idx="4">
                  <c:v>0.10155763239875397</c:v>
                </c:pt>
                <c:pt idx="5">
                  <c:v>9.5950155763239953E-2</c:v>
                </c:pt>
                <c:pt idx="6">
                  <c:v>8.5981308411215013E-2</c:v>
                </c:pt>
                <c:pt idx="7">
                  <c:v>5.3582554517134014E-2</c:v>
                </c:pt>
                <c:pt idx="8">
                  <c:v>4.79750778816199E-2</c:v>
                </c:pt>
                <c:pt idx="9">
                  <c:v>3.9252336448598102E-2</c:v>
                </c:pt>
                <c:pt idx="10">
                  <c:v>3.6137071651090313E-2</c:v>
                </c:pt>
                <c:pt idx="11">
                  <c:v>2.9906542056074809E-2</c:v>
                </c:pt>
                <c:pt idx="12">
                  <c:v>2.1806853582554513E-2</c:v>
                </c:pt>
                <c:pt idx="13">
                  <c:v>1.9314641744548305E-2</c:v>
                </c:pt>
                <c:pt idx="14">
                  <c:v>1.61993769470405E-2</c:v>
                </c:pt>
                <c:pt idx="15">
                  <c:v>1.61993769470405E-2</c:v>
                </c:pt>
                <c:pt idx="16">
                  <c:v>9.9688473520249243E-3</c:v>
                </c:pt>
                <c:pt idx="17">
                  <c:v>6.2305295950155822E-3</c:v>
                </c:pt>
                <c:pt idx="18">
                  <c:v>6.2305295950155822E-3</c:v>
                </c:pt>
                <c:pt idx="19">
                  <c:v>6.8535825545171314E-3</c:v>
                </c:pt>
                <c:pt idx="20">
                  <c:v>3.1152647975077907E-3</c:v>
                </c:pt>
              </c:numCache>
            </c:numRef>
          </c:val>
        </c:ser>
        <c:ser>
          <c:idx val="6"/>
          <c:order val="6"/>
          <c:tx>
            <c:strRef>
              <c:f>'unc-49 L4_0.02_5%'!$H$104</c:f>
              <c:strCache>
                <c:ptCount val="1"/>
                <c:pt idx="0">
                  <c:v>unc-49_L4_06025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H$105:$H$125</c:f>
              <c:numCache>
                <c:formatCode>General</c:formatCode>
                <c:ptCount val="21"/>
                <c:pt idx="1">
                  <c:v>0.11602209944751403</c:v>
                </c:pt>
                <c:pt idx="2">
                  <c:v>0.10865561694291004</c:v>
                </c:pt>
                <c:pt idx="3">
                  <c:v>0.13198281154082306</c:v>
                </c:pt>
                <c:pt idx="4">
                  <c:v>9.0853284223450001E-2</c:v>
                </c:pt>
                <c:pt idx="5">
                  <c:v>6.3842848373235075E-2</c:v>
                </c:pt>
                <c:pt idx="6">
                  <c:v>6.1387354205033814E-2</c:v>
                </c:pt>
                <c:pt idx="7">
                  <c:v>5.7704112952731736E-2</c:v>
                </c:pt>
                <c:pt idx="8">
                  <c:v>4.7268262737876002E-2</c:v>
                </c:pt>
                <c:pt idx="9">
                  <c:v>3.0079803560466516E-2</c:v>
                </c:pt>
                <c:pt idx="10">
                  <c:v>2.8238182934315501E-2</c:v>
                </c:pt>
                <c:pt idx="11">
                  <c:v>2.3327194597912791E-2</c:v>
                </c:pt>
                <c:pt idx="12">
                  <c:v>2.0871700429711523E-2</c:v>
                </c:pt>
                <c:pt idx="13">
                  <c:v>6.7526089625537123E-3</c:v>
                </c:pt>
                <c:pt idx="14">
                  <c:v>1.2891344383057101E-2</c:v>
                </c:pt>
                <c:pt idx="15">
                  <c:v>3.6832412523020324E-3</c:v>
                </c:pt>
                <c:pt idx="16">
                  <c:v>4.9109883364026998E-3</c:v>
                </c:pt>
                <c:pt idx="17">
                  <c:v>4.297114794352362E-3</c:v>
                </c:pt>
                <c:pt idx="18">
                  <c:v>3.069367710251692E-3</c:v>
                </c:pt>
                <c:pt idx="19">
                  <c:v>4.9109883364026998E-3</c:v>
                </c:pt>
                <c:pt idx="20">
                  <c:v>1.2277470841006801E-3</c:v>
                </c:pt>
              </c:numCache>
            </c:numRef>
          </c:val>
        </c:ser>
        <c:ser>
          <c:idx val="7"/>
          <c:order val="7"/>
          <c:tx>
            <c:strRef>
              <c:f>'unc-49 L4_0.02_5%'!$I$104</c:f>
              <c:strCache>
                <c:ptCount val="1"/>
                <c:pt idx="0">
                  <c:v>unc-49_L4_06026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I$105:$I$125</c:f>
              <c:numCache>
                <c:formatCode>General</c:formatCode>
                <c:ptCount val="21"/>
                <c:pt idx="1">
                  <c:v>8.4597701149425331E-2</c:v>
                </c:pt>
                <c:pt idx="2">
                  <c:v>0.10160919540229903</c:v>
                </c:pt>
                <c:pt idx="3">
                  <c:v>0.11862068965517203</c:v>
                </c:pt>
                <c:pt idx="4">
                  <c:v>0.100229885057471</c:v>
                </c:pt>
                <c:pt idx="5">
                  <c:v>0.102068965517241</c:v>
                </c:pt>
                <c:pt idx="6">
                  <c:v>8.0000000000000029E-2</c:v>
                </c:pt>
                <c:pt idx="7">
                  <c:v>6.160919540229888E-2</c:v>
                </c:pt>
                <c:pt idx="8">
                  <c:v>4.5977011494252887E-2</c:v>
                </c:pt>
                <c:pt idx="9">
                  <c:v>4.2758620689655198E-2</c:v>
                </c:pt>
                <c:pt idx="10">
                  <c:v>2.7126436781609201E-2</c:v>
                </c:pt>
                <c:pt idx="11">
                  <c:v>2.8965517241379309E-2</c:v>
                </c:pt>
                <c:pt idx="12">
                  <c:v>2.5287356321839111E-2</c:v>
                </c:pt>
                <c:pt idx="13">
                  <c:v>1.7471264367816101E-2</c:v>
                </c:pt>
                <c:pt idx="14">
                  <c:v>1.2873563218390801E-2</c:v>
                </c:pt>
                <c:pt idx="15">
                  <c:v>1.1954022988505701E-2</c:v>
                </c:pt>
                <c:pt idx="16">
                  <c:v>1.2873563218390801E-2</c:v>
                </c:pt>
                <c:pt idx="17">
                  <c:v>8.7356321839080538E-3</c:v>
                </c:pt>
                <c:pt idx="18">
                  <c:v>6.4367816091954015E-3</c:v>
                </c:pt>
                <c:pt idx="19">
                  <c:v>1.8390804597701105E-3</c:v>
                </c:pt>
                <c:pt idx="20">
                  <c:v>5.9770114942528756E-3</c:v>
                </c:pt>
              </c:numCache>
            </c:numRef>
          </c:val>
        </c:ser>
        <c:ser>
          <c:idx val="8"/>
          <c:order val="8"/>
          <c:tx>
            <c:strRef>
              <c:f>'unc-49 L4_0.02_5%'!$J$104</c:f>
              <c:strCache>
                <c:ptCount val="1"/>
                <c:pt idx="0">
                  <c:v>unc-49_L4_0603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J$105:$J$125</c:f>
              <c:numCache>
                <c:formatCode>General</c:formatCode>
                <c:ptCount val="21"/>
                <c:pt idx="1">
                  <c:v>0.14031620553359705</c:v>
                </c:pt>
                <c:pt idx="2">
                  <c:v>0.13043478260869601</c:v>
                </c:pt>
                <c:pt idx="3">
                  <c:v>9.683794466403163E-2</c:v>
                </c:pt>
                <c:pt idx="4">
                  <c:v>5.5335968379446619E-2</c:v>
                </c:pt>
                <c:pt idx="5">
                  <c:v>4.150197628458497E-2</c:v>
                </c:pt>
                <c:pt idx="6">
                  <c:v>2.7667984189723313E-2</c:v>
                </c:pt>
                <c:pt idx="7">
                  <c:v>2.1739130434782601E-2</c:v>
                </c:pt>
                <c:pt idx="8">
                  <c:v>1.58102766798419E-2</c:v>
                </c:pt>
                <c:pt idx="9">
                  <c:v>1.7786561264822108E-2</c:v>
                </c:pt>
                <c:pt idx="10">
                  <c:v>5.9288537549407119E-3</c:v>
                </c:pt>
                <c:pt idx="11">
                  <c:v>0</c:v>
                </c:pt>
                <c:pt idx="12">
                  <c:v>7.9051383399209498E-3</c:v>
                </c:pt>
                <c:pt idx="13">
                  <c:v>3.9525691699604697E-3</c:v>
                </c:pt>
                <c:pt idx="14">
                  <c:v>9.8814229249011946E-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.9762845849802418E-3</c:v>
                </c:pt>
              </c:numCache>
            </c:numRef>
          </c:val>
        </c:ser>
        <c:ser>
          <c:idx val="9"/>
          <c:order val="9"/>
          <c:tx>
            <c:strRef>
              <c:f>'unc-49 L4_0.02_5%'!$K$104</c:f>
              <c:strCache>
                <c:ptCount val="1"/>
                <c:pt idx="0">
                  <c:v>unc-49_L4_0604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K$105:$K$125</c:f>
              <c:numCache>
                <c:formatCode>General</c:formatCode>
                <c:ptCount val="21"/>
                <c:pt idx="1">
                  <c:v>0.11389521640091105</c:v>
                </c:pt>
                <c:pt idx="2">
                  <c:v>0.13211845102505701</c:v>
                </c:pt>
                <c:pt idx="3">
                  <c:v>0.11161731207289295</c:v>
                </c:pt>
                <c:pt idx="4">
                  <c:v>0.10250569476082003</c:v>
                </c:pt>
                <c:pt idx="5">
                  <c:v>5.69476082004556E-2</c:v>
                </c:pt>
                <c:pt idx="6">
                  <c:v>4.1002277904328026E-2</c:v>
                </c:pt>
                <c:pt idx="7">
                  <c:v>4.3280182232346198E-2</c:v>
                </c:pt>
                <c:pt idx="8">
                  <c:v>2.0501138952164009E-2</c:v>
                </c:pt>
                <c:pt idx="9">
                  <c:v>2.73348519362187E-2</c:v>
                </c:pt>
                <c:pt idx="10">
                  <c:v>2.2779043280182206E-2</c:v>
                </c:pt>
                <c:pt idx="11">
                  <c:v>1.1389521640091107E-2</c:v>
                </c:pt>
                <c:pt idx="12">
                  <c:v>4.555808656036448E-3</c:v>
                </c:pt>
                <c:pt idx="13">
                  <c:v>1.5945330296127609E-2</c:v>
                </c:pt>
                <c:pt idx="14">
                  <c:v>1.3667425968109305E-2</c:v>
                </c:pt>
                <c:pt idx="15">
                  <c:v>2.277904328018221E-3</c:v>
                </c:pt>
                <c:pt idx="16">
                  <c:v>4.555808656036448E-3</c:v>
                </c:pt>
                <c:pt idx="17">
                  <c:v>4.555808656036448E-3</c:v>
                </c:pt>
                <c:pt idx="18">
                  <c:v>0</c:v>
                </c:pt>
                <c:pt idx="19">
                  <c:v>2.277904328018221E-3</c:v>
                </c:pt>
                <c:pt idx="2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unc-49 L4_0.02_5%'!$L$104</c:f>
              <c:strCache>
                <c:ptCount val="1"/>
                <c:pt idx="0">
                  <c:v>unc-49_L4_0605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L$105:$L$125</c:f>
              <c:numCache>
                <c:formatCode>General</c:formatCode>
                <c:ptCount val="21"/>
                <c:pt idx="1">
                  <c:v>0.14086956521739105</c:v>
                </c:pt>
                <c:pt idx="2">
                  <c:v>0.10608695652173904</c:v>
                </c:pt>
                <c:pt idx="3">
                  <c:v>0.111304347826087</c:v>
                </c:pt>
                <c:pt idx="4">
                  <c:v>9.5652173913043537E-2</c:v>
                </c:pt>
                <c:pt idx="5">
                  <c:v>8.52173913043478E-2</c:v>
                </c:pt>
                <c:pt idx="6">
                  <c:v>4.8695652173913001E-2</c:v>
                </c:pt>
                <c:pt idx="7">
                  <c:v>4.3478260869565202E-2</c:v>
                </c:pt>
                <c:pt idx="8">
                  <c:v>3.1304347826087014E-2</c:v>
                </c:pt>
                <c:pt idx="9">
                  <c:v>3.3043478260869612E-2</c:v>
                </c:pt>
                <c:pt idx="10">
                  <c:v>1.9130434782608705E-2</c:v>
                </c:pt>
                <c:pt idx="11">
                  <c:v>1.9130434782608705E-2</c:v>
                </c:pt>
                <c:pt idx="12">
                  <c:v>1.39130434782609E-2</c:v>
                </c:pt>
                <c:pt idx="13">
                  <c:v>3.4782608695652201E-3</c:v>
                </c:pt>
                <c:pt idx="14">
                  <c:v>1.7391304347826105E-3</c:v>
                </c:pt>
                <c:pt idx="15">
                  <c:v>3.4782608695652201E-3</c:v>
                </c:pt>
                <c:pt idx="16">
                  <c:v>1.7391304347826105E-3</c:v>
                </c:pt>
                <c:pt idx="17">
                  <c:v>1.7391304347826105E-3</c:v>
                </c:pt>
                <c:pt idx="18">
                  <c:v>0</c:v>
                </c:pt>
                <c:pt idx="19">
                  <c:v>1.7391304347826105E-3</c:v>
                </c:pt>
                <c:pt idx="2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unc-49 L4_0.02_5%'!$M$104</c:f>
              <c:strCache>
                <c:ptCount val="1"/>
                <c:pt idx="0">
                  <c:v>unc-49_L4_0606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M$105:$M$125</c:f>
              <c:numCache>
                <c:formatCode>General</c:formatCode>
                <c:ptCount val="21"/>
                <c:pt idx="1">
                  <c:v>0.12280701754385999</c:v>
                </c:pt>
                <c:pt idx="2">
                  <c:v>0.105263157894737</c:v>
                </c:pt>
                <c:pt idx="3">
                  <c:v>0.12280701754385999</c:v>
                </c:pt>
                <c:pt idx="4">
                  <c:v>6.140350877192978E-2</c:v>
                </c:pt>
                <c:pt idx="5">
                  <c:v>4.3859649122807001E-2</c:v>
                </c:pt>
                <c:pt idx="6">
                  <c:v>8.7719298245613996E-3</c:v>
                </c:pt>
                <c:pt idx="7">
                  <c:v>1.7543859649122813E-2</c:v>
                </c:pt>
                <c:pt idx="8">
                  <c:v>8.7719298245613996E-3</c:v>
                </c:pt>
                <c:pt idx="9">
                  <c:v>8.7719298245613996E-3</c:v>
                </c:pt>
                <c:pt idx="10">
                  <c:v>8.7719298245613996E-3</c:v>
                </c:pt>
                <c:pt idx="11">
                  <c:v>0</c:v>
                </c:pt>
                <c:pt idx="12">
                  <c:v>0</c:v>
                </c:pt>
                <c:pt idx="13">
                  <c:v>8.7719298245613996E-3</c:v>
                </c:pt>
                <c:pt idx="14">
                  <c:v>0</c:v>
                </c:pt>
                <c:pt idx="15">
                  <c:v>8.7719298245613996E-3</c:v>
                </c:pt>
                <c:pt idx="16">
                  <c:v>0</c:v>
                </c:pt>
                <c:pt idx="17">
                  <c:v>0</c:v>
                </c:pt>
                <c:pt idx="18">
                  <c:v>8.7719298245613996E-3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unc-49 L4_0.02_5%'!$N$104</c:f>
              <c:strCache>
                <c:ptCount val="1"/>
                <c:pt idx="0">
                  <c:v>unc-49_L4_0607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N$105:$N$125</c:f>
              <c:numCache>
                <c:formatCode>General</c:formatCode>
                <c:ptCount val="21"/>
                <c:pt idx="1">
                  <c:v>8.7312414733969959E-2</c:v>
                </c:pt>
                <c:pt idx="2">
                  <c:v>0.102319236016371</c:v>
                </c:pt>
                <c:pt idx="3">
                  <c:v>0.11869031377899003</c:v>
                </c:pt>
                <c:pt idx="4">
                  <c:v>9.4815825375170568E-2</c:v>
                </c:pt>
                <c:pt idx="5">
                  <c:v>0.10163710777626203</c:v>
                </c:pt>
                <c:pt idx="6">
                  <c:v>7.5716234652114661E-2</c:v>
                </c:pt>
                <c:pt idx="7">
                  <c:v>6.6166439290586632E-2</c:v>
                </c:pt>
                <c:pt idx="8">
                  <c:v>4.8431105047749001E-2</c:v>
                </c:pt>
                <c:pt idx="9">
                  <c:v>3.6152796725784399E-2</c:v>
                </c:pt>
                <c:pt idx="10">
                  <c:v>3.4106412005456999E-2</c:v>
                </c:pt>
                <c:pt idx="11">
                  <c:v>3.0695770804911315E-2</c:v>
                </c:pt>
                <c:pt idx="12">
                  <c:v>2.3874488403819911E-2</c:v>
                </c:pt>
                <c:pt idx="13">
                  <c:v>1.1596180081855404E-2</c:v>
                </c:pt>
                <c:pt idx="14">
                  <c:v>1.0914051841746203E-2</c:v>
                </c:pt>
                <c:pt idx="15">
                  <c:v>4.7748976807639818E-3</c:v>
                </c:pt>
                <c:pt idx="16">
                  <c:v>6.1391541609822622E-3</c:v>
                </c:pt>
                <c:pt idx="17">
                  <c:v>6.1391541609822622E-3</c:v>
                </c:pt>
                <c:pt idx="18">
                  <c:v>2.7285129604365617E-3</c:v>
                </c:pt>
                <c:pt idx="19">
                  <c:v>2.7285129604365617E-3</c:v>
                </c:pt>
                <c:pt idx="20">
                  <c:v>2.7285129604365617E-3</c:v>
                </c:pt>
              </c:numCache>
            </c:numRef>
          </c:val>
        </c:ser>
        <c:ser>
          <c:idx val="13"/>
          <c:order val="13"/>
          <c:tx>
            <c:strRef>
              <c:f>'unc-49 L4_0.02_5%'!$O$104</c:f>
              <c:strCache>
                <c:ptCount val="1"/>
                <c:pt idx="0">
                  <c:v>unc-49_L4_0608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O$105:$O$125</c:f>
              <c:numCache>
                <c:formatCode>General</c:formatCode>
                <c:ptCount val="21"/>
                <c:pt idx="1">
                  <c:v>7.8904109589041094E-2</c:v>
                </c:pt>
                <c:pt idx="2">
                  <c:v>0.10356164383561606</c:v>
                </c:pt>
                <c:pt idx="3">
                  <c:v>0.10958904109589</c:v>
                </c:pt>
                <c:pt idx="4">
                  <c:v>0.118356164383562</c:v>
                </c:pt>
                <c:pt idx="5">
                  <c:v>0.103013698630137</c:v>
                </c:pt>
                <c:pt idx="6">
                  <c:v>8.4383561643835578E-2</c:v>
                </c:pt>
                <c:pt idx="7">
                  <c:v>7.1780821917808227E-2</c:v>
                </c:pt>
                <c:pt idx="8">
                  <c:v>5.4246575342465797E-2</c:v>
                </c:pt>
                <c:pt idx="9">
                  <c:v>3.6712328767123312E-2</c:v>
                </c:pt>
                <c:pt idx="10">
                  <c:v>3.5616438356164404E-2</c:v>
                </c:pt>
                <c:pt idx="11">
                  <c:v>3.0684931506849318E-2</c:v>
                </c:pt>
                <c:pt idx="12">
                  <c:v>2.3561643835616399E-2</c:v>
                </c:pt>
                <c:pt idx="13">
                  <c:v>1.424657534246581E-2</c:v>
                </c:pt>
                <c:pt idx="14">
                  <c:v>1.0410958904109599E-2</c:v>
                </c:pt>
                <c:pt idx="15">
                  <c:v>1.6438356164383602E-2</c:v>
                </c:pt>
                <c:pt idx="16">
                  <c:v>1.3150684931506899E-2</c:v>
                </c:pt>
                <c:pt idx="17">
                  <c:v>7.6712328767123321E-3</c:v>
                </c:pt>
                <c:pt idx="18">
                  <c:v>3.2876712328767121E-3</c:v>
                </c:pt>
                <c:pt idx="19">
                  <c:v>4.3835616438356222E-3</c:v>
                </c:pt>
                <c:pt idx="20">
                  <c:v>1.6438356164383604E-3</c:v>
                </c:pt>
              </c:numCache>
            </c:numRef>
          </c:val>
        </c:ser>
        <c:ser>
          <c:idx val="14"/>
          <c:order val="14"/>
          <c:tx>
            <c:strRef>
              <c:f>'unc-49 L4_0.02_5%'!$P$104</c:f>
              <c:strCache>
                <c:ptCount val="1"/>
                <c:pt idx="0">
                  <c:v>unc-49_L4_0609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P$105:$P$125</c:f>
              <c:numCache>
                <c:formatCode>General</c:formatCode>
                <c:ptCount val="21"/>
                <c:pt idx="1">
                  <c:v>0.114213197969543</c:v>
                </c:pt>
                <c:pt idx="2">
                  <c:v>9.2216582064297795E-2</c:v>
                </c:pt>
                <c:pt idx="3">
                  <c:v>0.10236886632825698</c:v>
                </c:pt>
                <c:pt idx="4">
                  <c:v>0.109137055837563</c:v>
                </c:pt>
                <c:pt idx="5">
                  <c:v>7.6988155668358677E-2</c:v>
                </c:pt>
                <c:pt idx="6">
                  <c:v>6.7681895093062605E-2</c:v>
                </c:pt>
                <c:pt idx="7">
                  <c:v>5.076142131979703E-2</c:v>
                </c:pt>
                <c:pt idx="8">
                  <c:v>3.6379018612521213E-2</c:v>
                </c:pt>
                <c:pt idx="9">
                  <c:v>4.0609137055837616E-2</c:v>
                </c:pt>
                <c:pt idx="10">
                  <c:v>2.7918781725888294E-2</c:v>
                </c:pt>
                <c:pt idx="11">
                  <c:v>2.2842639593908601E-2</c:v>
                </c:pt>
                <c:pt idx="12">
                  <c:v>1.4382402707275801E-2</c:v>
                </c:pt>
                <c:pt idx="13">
                  <c:v>1.9458544839255507E-2</c:v>
                </c:pt>
                <c:pt idx="14">
                  <c:v>1.26903553299492E-2</c:v>
                </c:pt>
                <c:pt idx="15">
                  <c:v>4.2301184433164102E-3</c:v>
                </c:pt>
                <c:pt idx="16">
                  <c:v>6.7681895093062603E-3</c:v>
                </c:pt>
                <c:pt idx="17">
                  <c:v>5.0761421319797037E-3</c:v>
                </c:pt>
                <c:pt idx="18">
                  <c:v>6.7681895093062603E-3</c:v>
                </c:pt>
                <c:pt idx="19">
                  <c:v>3.3840947546531319E-3</c:v>
                </c:pt>
                <c:pt idx="20">
                  <c:v>3.3840947546531319E-3</c:v>
                </c:pt>
              </c:numCache>
            </c:numRef>
          </c:val>
        </c:ser>
        <c:ser>
          <c:idx val="15"/>
          <c:order val="15"/>
          <c:tx>
            <c:strRef>
              <c:f>'unc-49 L4_0.02_5%'!$Q$104</c:f>
              <c:strCache>
                <c:ptCount val="1"/>
                <c:pt idx="0">
                  <c:v>unc-49_L4_0611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Q$105:$Q$125</c:f>
              <c:numCache>
                <c:formatCode>General</c:formatCode>
                <c:ptCount val="21"/>
                <c:pt idx="1">
                  <c:v>8.4423305588585032E-2</c:v>
                </c:pt>
                <c:pt idx="2">
                  <c:v>0.10344827586206902</c:v>
                </c:pt>
                <c:pt idx="3">
                  <c:v>0.11593341260404297</c:v>
                </c:pt>
                <c:pt idx="4">
                  <c:v>0.10523186682520802</c:v>
                </c:pt>
                <c:pt idx="5">
                  <c:v>0.11474435196195006</c:v>
                </c:pt>
                <c:pt idx="6">
                  <c:v>6.6587395957193804E-2</c:v>
                </c:pt>
                <c:pt idx="7">
                  <c:v>6.4209274673008312E-2</c:v>
                </c:pt>
                <c:pt idx="8">
                  <c:v>5.64803804994055E-2</c:v>
                </c:pt>
                <c:pt idx="9">
                  <c:v>3.9833531510107011E-2</c:v>
                </c:pt>
                <c:pt idx="10">
                  <c:v>3.09155766944114E-2</c:v>
                </c:pt>
                <c:pt idx="11">
                  <c:v>3.09155766944114E-2</c:v>
                </c:pt>
                <c:pt idx="12">
                  <c:v>1.78359096313912E-2</c:v>
                </c:pt>
                <c:pt idx="13">
                  <c:v>1.5457788347205707E-2</c:v>
                </c:pt>
                <c:pt idx="14">
                  <c:v>1.0107015457788301E-2</c:v>
                </c:pt>
                <c:pt idx="15">
                  <c:v>7.1343638525564815E-3</c:v>
                </c:pt>
                <c:pt idx="16">
                  <c:v>1.0107015457788301E-2</c:v>
                </c:pt>
                <c:pt idx="17">
                  <c:v>5.945303210463734E-3</c:v>
                </c:pt>
                <c:pt idx="18">
                  <c:v>5.945303210463734E-3</c:v>
                </c:pt>
                <c:pt idx="19">
                  <c:v>2.3781212841854911E-3</c:v>
                </c:pt>
                <c:pt idx="20">
                  <c:v>2.97265160523187E-3</c:v>
                </c:pt>
              </c:numCache>
            </c:numRef>
          </c:val>
        </c:ser>
        <c:ser>
          <c:idx val="16"/>
          <c:order val="16"/>
          <c:tx>
            <c:strRef>
              <c:f>'unc-49 L4_0.02_5%'!$R$104</c:f>
              <c:strCache>
                <c:ptCount val="1"/>
                <c:pt idx="0">
                  <c:v>unc-49_L4_0612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R$105:$R$125</c:f>
              <c:numCache>
                <c:formatCode>General</c:formatCode>
                <c:ptCount val="21"/>
                <c:pt idx="1">
                  <c:v>8.5419734904270961E-2</c:v>
                </c:pt>
                <c:pt idx="2">
                  <c:v>0.111438389788905</c:v>
                </c:pt>
                <c:pt idx="3">
                  <c:v>0.120274914089347</c:v>
                </c:pt>
                <c:pt idx="4">
                  <c:v>0.10554737358861103</c:v>
                </c:pt>
                <c:pt idx="5">
                  <c:v>9.5238095238095247E-2</c:v>
                </c:pt>
                <c:pt idx="6">
                  <c:v>7.511045655375552E-2</c:v>
                </c:pt>
                <c:pt idx="7">
                  <c:v>5.1055473735886099E-2</c:v>
                </c:pt>
                <c:pt idx="8">
                  <c:v>5.1055473735886099E-2</c:v>
                </c:pt>
                <c:pt idx="9">
                  <c:v>3.8782523318605794E-2</c:v>
                </c:pt>
                <c:pt idx="10">
                  <c:v>3.5346097201767297E-2</c:v>
                </c:pt>
                <c:pt idx="11">
                  <c:v>2.9945999018164009E-2</c:v>
                </c:pt>
                <c:pt idx="12">
                  <c:v>1.6200294550809999E-2</c:v>
                </c:pt>
                <c:pt idx="13">
                  <c:v>1.5709376534118805E-2</c:v>
                </c:pt>
                <c:pt idx="14">
                  <c:v>1.6200294550809999E-2</c:v>
                </c:pt>
                <c:pt idx="15">
                  <c:v>1.0800196367206704E-2</c:v>
                </c:pt>
                <c:pt idx="16">
                  <c:v>8.345606283750617E-3</c:v>
                </c:pt>
                <c:pt idx="17">
                  <c:v>8.345606283750617E-3</c:v>
                </c:pt>
                <c:pt idx="18">
                  <c:v>1.9636720667648511E-3</c:v>
                </c:pt>
                <c:pt idx="19">
                  <c:v>1.4727540500736401E-3</c:v>
                </c:pt>
                <c:pt idx="20">
                  <c:v>2.9455081001472801E-3</c:v>
                </c:pt>
              </c:numCache>
            </c:numRef>
          </c:val>
        </c:ser>
        <c:ser>
          <c:idx val="17"/>
          <c:order val="17"/>
          <c:tx>
            <c:strRef>
              <c:f>'unc-49 L4_0.02_5%'!$S$104</c:f>
              <c:strCache>
                <c:ptCount val="1"/>
                <c:pt idx="0">
                  <c:v>unc-49_L4_0613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S$105:$S$125</c:f>
              <c:numCache>
                <c:formatCode>General</c:formatCode>
                <c:ptCount val="21"/>
                <c:pt idx="1">
                  <c:v>0.16867469879518093</c:v>
                </c:pt>
                <c:pt idx="2">
                  <c:v>0.120481927710843</c:v>
                </c:pt>
                <c:pt idx="3">
                  <c:v>6.6265060240963902E-2</c:v>
                </c:pt>
                <c:pt idx="4">
                  <c:v>6.6265060240963902E-2</c:v>
                </c:pt>
                <c:pt idx="5">
                  <c:v>6.6265060240963902E-2</c:v>
                </c:pt>
                <c:pt idx="6">
                  <c:v>3.6144578313252997E-2</c:v>
                </c:pt>
                <c:pt idx="7">
                  <c:v>1.2048192771084298E-2</c:v>
                </c:pt>
                <c:pt idx="8">
                  <c:v>3.6144578313252997E-2</c:v>
                </c:pt>
                <c:pt idx="9">
                  <c:v>0</c:v>
                </c:pt>
                <c:pt idx="10">
                  <c:v>1.2048192771084298E-2</c:v>
                </c:pt>
                <c:pt idx="11">
                  <c:v>0</c:v>
                </c:pt>
                <c:pt idx="12">
                  <c:v>6.0240963855421733E-3</c:v>
                </c:pt>
                <c:pt idx="13">
                  <c:v>0</c:v>
                </c:pt>
                <c:pt idx="14">
                  <c:v>1.2048192771084298E-2</c:v>
                </c:pt>
                <c:pt idx="15">
                  <c:v>0</c:v>
                </c:pt>
                <c:pt idx="16">
                  <c:v>6.0240963855421733E-3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unc-49 L4_0.02_5%'!$T$104</c:f>
              <c:strCache>
                <c:ptCount val="1"/>
                <c:pt idx="0">
                  <c:v>unc-49_L4_0614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T$105:$T$125</c:f>
              <c:numCache>
                <c:formatCode>General</c:formatCode>
                <c:ptCount val="21"/>
                <c:pt idx="1">
                  <c:v>7.8838174273858905E-2</c:v>
                </c:pt>
                <c:pt idx="2">
                  <c:v>0.10529045643153509</c:v>
                </c:pt>
                <c:pt idx="3">
                  <c:v>0.108921161825726</c:v>
                </c:pt>
                <c:pt idx="4">
                  <c:v>0.10580912863070498</c:v>
                </c:pt>
                <c:pt idx="5">
                  <c:v>9.699170124481328E-2</c:v>
                </c:pt>
                <c:pt idx="6">
                  <c:v>7.7282157676348634E-2</c:v>
                </c:pt>
                <c:pt idx="7">
                  <c:v>8.0912863070539437E-2</c:v>
                </c:pt>
                <c:pt idx="8">
                  <c:v>4.9792531120331954E-2</c:v>
                </c:pt>
                <c:pt idx="9">
                  <c:v>4.3049792531120297E-2</c:v>
                </c:pt>
                <c:pt idx="10">
                  <c:v>3.6825726141078798E-2</c:v>
                </c:pt>
                <c:pt idx="11">
                  <c:v>2.38589211618257E-2</c:v>
                </c:pt>
                <c:pt idx="12">
                  <c:v>1.9190871369294607E-2</c:v>
                </c:pt>
                <c:pt idx="13">
                  <c:v>1.7116182572614099E-2</c:v>
                </c:pt>
                <c:pt idx="14">
                  <c:v>1.3485477178423201E-2</c:v>
                </c:pt>
                <c:pt idx="15">
                  <c:v>1.2448132780083001E-2</c:v>
                </c:pt>
                <c:pt idx="16">
                  <c:v>6.2240663900414916E-3</c:v>
                </c:pt>
                <c:pt idx="17">
                  <c:v>5.186721991701242E-3</c:v>
                </c:pt>
                <c:pt idx="18">
                  <c:v>4.1493775933610019E-3</c:v>
                </c:pt>
                <c:pt idx="19">
                  <c:v>4.1493775933610019E-3</c:v>
                </c:pt>
                <c:pt idx="20">
                  <c:v>2.0746887966805001E-3</c:v>
                </c:pt>
              </c:numCache>
            </c:numRef>
          </c:val>
        </c:ser>
        <c:ser>
          <c:idx val="19"/>
          <c:order val="19"/>
          <c:tx>
            <c:strRef>
              <c:f>'unc-49 L4_0.02_5%'!$U$104</c:f>
              <c:strCache>
                <c:ptCount val="1"/>
                <c:pt idx="0">
                  <c:v>unc-49_L4_0615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U$105:$U$125</c:f>
              <c:numCache>
                <c:formatCode>General</c:formatCode>
                <c:ptCount val="21"/>
                <c:pt idx="1">
                  <c:v>8.8940448569218969E-2</c:v>
                </c:pt>
                <c:pt idx="2">
                  <c:v>0.10131477184841503</c:v>
                </c:pt>
                <c:pt idx="3">
                  <c:v>0.11291569992266</c:v>
                </c:pt>
                <c:pt idx="4">
                  <c:v>9.899458623356544E-2</c:v>
                </c:pt>
                <c:pt idx="5">
                  <c:v>8.5846867749420061E-2</c:v>
                </c:pt>
                <c:pt idx="6">
                  <c:v>8.2753286929620987E-2</c:v>
                </c:pt>
                <c:pt idx="7">
                  <c:v>5.4137664346481137E-2</c:v>
                </c:pt>
                <c:pt idx="8">
                  <c:v>5.2590873936581635E-2</c:v>
                </c:pt>
                <c:pt idx="9">
                  <c:v>4.6403712296983798E-2</c:v>
                </c:pt>
                <c:pt idx="10">
                  <c:v>4.33101314771848E-2</c:v>
                </c:pt>
                <c:pt idx="11">
                  <c:v>3.4029389017788098E-2</c:v>
                </c:pt>
                <c:pt idx="12">
                  <c:v>2.5522041763341101E-2</c:v>
                </c:pt>
                <c:pt idx="13">
                  <c:v>1.6241299303944301E-2</c:v>
                </c:pt>
                <c:pt idx="14">
                  <c:v>1.8561484918793506E-2</c:v>
                </c:pt>
                <c:pt idx="15">
                  <c:v>1.0054137664346499E-2</c:v>
                </c:pt>
                <c:pt idx="16">
                  <c:v>7.7339520494972913E-3</c:v>
                </c:pt>
                <c:pt idx="17">
                  <c:v>8.5073472544470244E-3</c:v>
                </c:pt>
                <c:pt idx="18">
                  <c:v>4.64037122969838E-3</c:v>
                </c:pt>
                <c:pt idx="19">
                  <c:v>1.54679040989946E-3</c:v>
                </c:pt>
                <c:pt idx="20">
                  <c:v>7.7339520494972924E-4</c:v>
                </c:pt>
              </c:numCache>
            </c:numRef>
          </c:val>
        </c:ser>
        <c:ser>
          <c:idx val="20"/>
          <c:order val="20"/>
          <c:tx>
            <c:strRef>
              <c:f>'unc-49 L4_0.02_5%'!$V$104</c:f>
              <c:strCache>
                <c:ptCount val="1"/>
                <c:pt idx="0">
                  <c:v>unc-49_L4_0616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V$105:$V$125</c:f>
              <c:numCache>
                <c:formatCode>General</c:formatCode>
                <c:ptCount val="21"/>
                <c:pt idx="1">
                  <c:v>0.13395638629283507</c:v>
                </c:pt>
                <c:pt idx="2">
                  <c:v>0.10280373831775701</c:v>
                </c:pt>
                <c:pt idx="3">
                  <c:v>0.121495327102804</c:v>
                </c:pt>
                <c:pt idx="4">
                  <c:v>7.7881619937694727E-2</c:v>
                </c:pt>
                <c:pt idx="5">
                  <c:v>6.5420560747663503E-2</c:v>
                </c:pt>
                <c:pt idx="6">
                  <c:v>4.3613707165108997E-2</c:v>
                </c:pt>
                <c:pt idx="7">
                  <c:v>2.4922118380062301E-2</c:v>
                </c:pt>
                <c:pt idx="8">
                  <c:v>4.0498442367601216E-2</c:v>
                </c:pt>
                <c:pt idx="9">
                  <c:v>3.4267912772585715E-2</c:v>
                </c:pt>
                <c:pt idx="10">
                  <c:v>3.4267912772585715E-2</c:v>
                </c:pt>
                <c:pt idx="11">
                  <c:v>2.1806853582554513E-2</c:v>
                </c:pt>
                <c:pt idx="12">
                  <c:v>1.2461059190031204E-2</c:v>
                </c:pt>
                <c:pt idx="13">
                  <c:v>9.3457943925233673E-3</c:v>
                </c:pt>
                <c:pt idx="14">
                  <c:v>1.2461059190031204E-2</c:v>
                </c:pt>
                <c:pt idx="15">
                  <c:v>6.2305295950155822E-3</c:v>
                </c:pt>
                <c:pt idx="16">
                  <c:v>9.3457943925233673E-3</c:v>
                </c:pt>
                <c:pt idx="17">
                  <c:v>6.2305295950155822E-3</c:v>
                </c:pt>
                <c:pt idx="18">
                  <c:v>3.1152647975077907E-3</c:v>
                </c:pt>
                <c:pt idx="19">
                  <c:v>3.1152647975077907E-3</c:v>
                </c:pt>
                <c:pt idx="20">
                  <c:v>0</c:v>
                </c:pt>
              </c:numCache>
            </c:numRef>
          </c:val>
        </c:ser>
        <c:ser>
          <c:idx val="21"/>
          <c:order val="21"/>
          <c:tx>
            <c:strRef>
              <c:f>'unc-49 L4_0.02_5%'!$W$104</c:f>
              <c:strCache>
                <c:ptCount val="1"/>
                <c:pt idx="0">
                  <c:v>unc-49_L4_0617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W$105:$W$125</c:f>
              <c:numCache>
                <c:formatCode>General</c:formatCode>
                <c:ptCount val="21"/>
                <c:pt idx="1">
                  <c:v>0.10376282782212103</c:v>
                </c:pt>
                <c:pt idx="2">
                  <c:v>8.6659064994298735E-2</c:v>
                </c:pt>
                <c:pt idx="3">
                  <c:v>0.10718358038768504</c:v>
                </c:pt>
                <c:pt idx="4">
                  <c:v>9.2360319270239508E-2</c:v>
                </c:pt>
                <c:pt idx="5">
                  <c:v>8.6659064994298735E-2</c:v>
                </c:pt>
                <c:pt idx="6">
                  <c:v>6.9555302166476596E-2</c:v>
                </c:pt>
                <c:pt idx="7">
                  <c:v>4.9030786773090099E-2</c:v>
                </c:pt>
                <c:pt idx="8">
                  <c:v>3.5347776510832402E-2</c:v>
                </c:pt>
                <c:pt idx="9">
                  <c:v>2.9646522234891694E-2</c:v>
                </c:pt>
                <c:pt idx="10">
                  <c:v>2.7366020524515401E-2</c:v>
                </c:pt>
                <c:pt idx="11">
                  <c:v>2.3945267958951001E-2</c:v>
                </c:pt>
                <c:pt idx="12">
                  <c:v>2.6225769669327312E-2</c:v>
                </c:pt>
                <c:pt idx="13">
                  <c:v>1.48232611174458E-2</c:v>
                </c:pt>
                <c:pt idx="14">
                  <c:v>1.0262257696693301E-2</c:v>
                </c:pt>
                <c:pt idx="15">
                  <c:v>7.9817559863169935E-3</c:v>
                </c:pt>
                <c:pt idx="16">
                  <c:v>6.841505131128852E-3</c:v>
                </c:pt>
                <c:pt idx="17">
                  <c:v>1.1402508551881404E-2</c:v>
                </c:pt>
                <c:pt idx="18">
                  <c:v>1.1402508551881406E-3</c:v>
                </c:pt>
                <c:pt idx="19">
                  <c:v>4.5610034207525735E-3</c:v>
                </c:pt>
                <c:pt idx="20">
                  <c:v>3.4207525655644208E-3</c:v>
                </c:pt>
              </c:numCache>
            </c:numRef>
          </c:val>
        </c:ser>
        <c:ser>
          <c:idx val="22"/>
          <c:order val="22"/>
          <c:tx>
            <c:strRef>
              <c:f>'unc-49 L4_0.02_5%'!$X$104</c:f>
              <c:strCache>
                <c:ptCount val="1"/>
                <c:pt idx="0">
                  <c:v>unc-49_L4_0618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X$105:$X$125</c:f>
              <c:numCache>
                <c:formatCode>General</c:formatCode>
                <c:ptCount val="21"/>
                <c:pt idx="1">
                  <c:v>0.10093299406276497</c:v>
                </c:pt>
                <c:pt idx="2">
                  <c:v>7.9728583545377429E-2</c:v>
                </c:pt>
                <c:pt idx="3">
                  <c:v>0.11111111111111099</c:v>
                </c:pt>
                <c:pt idx="4">
                  <c:v>0.11280746395250198</c:v>
                </c:pt>
                <c:pt idx="5">
                  <c:v>7.209499575911793E-2</c:v>
                </c:pt>
                <c:pt idx="6">
                  <c:v>5.8524173027989797E-2</c:v>
                </c:pt>
                <c:pt idx="7">
                  <c:v>5.5979643765903295E-2</c:v>
                </c:pt>
                <c:pt idx="8">
                  <c:v>4.1560644614079698E-2</c:v>
                </c:pt>
                <c:pt idx="9">
                  <c:v>4.3256997455470715E-2</c:v>
                </c:pt>
                <c:pt idx="10">
                  <c:v>3.3078880407124714E-2</c:v>
                </c:pt>
                <c:pt idx="11">
                  <c:v>2.7141645462256121E-2</c:v>
                </c:pt>
                <c:pt idx="12">
                  <c:v>2.3748939779474114E-2</c:v>
                </c:pt>
                <c:pt idx="13">
                  <c:v>1.3570822731128104E-2</c:v>
                </c:pt>
                <c:pt idx="14">
                  <c:v>2.2900763358778602E-2</c:v>
                </c:pt>
                <c:pt idx="15">
                  <c:v>1.0178117048346098E-2</c:v>
                </c:pt>
                <c:pt idx="16">
                  <c:v>5.0890585241730336E-3</c:v>
                </c:pt>
                <c:pt idx="17">
                  <c:v>5.9372349448685319E-3</c:v>
                </c:pt>
                <c:pt idx="18">
                  <c:v>6.7854113655640433E-3</c:v>
                </c:pt>
                <c:pt idx="19">
                  <c:v>3.3927056827820208E-3</c:v>
                </c:pt>
                <c:pt idx="20">
                  <c:v>1.6963528413910117E-3</c:v>
                </c:pt>
              </c:numCache>
            </c:numRef>
          </c:val>
        </c:ser>
        <c:ser>
          <c:idx val="23"/>
          <c:order val="23"/>
          <c:tx>
            <c:strRef>
              <c:f>'unc-49 L4_0.02_5%'!$Y$104</c:f>
              <c:strCache>
                <c:ptCount val="1"/>
                <c:pt idx="0">
                  <c:v>unc-49_L4_0619</c:v>
                </c:pt>
              </c:strCache>
            </c:strRef>
          </c:tx>
          <c:marker>
            <c:symbol val="none"/>
          </c:marker>
          <c:cat>
            <c:numRef>
              <c:f>'unc-49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L4_0.02_5%'!$Y$105:$Y$125</c:f>
              <c:numCache>
                <c:formatCode>General</c:formatCode>
                <c:ptCount val="21"/>
              </c:numCache>
            </c:numRef>
          </c:val>
        </c:ser>
        <c:marker val="1"/>
        <c:axId val="158720768"/>
        <c:axId val="158722304"/>
      </c:lineChart>
      <c:catAx>
        <c:axId val="158720768"/>
        <c:scaling>
          <c:orientation val="minMax"/>
        </c:scaling>
        <c:axPos val="b"/>
        <c:numFmt formatCode="0.0_ " sourceLinked="1"/>
        <c:tickLblPos val="nextTo"/>
        <c:crossAx val="158722304"/>
        <c:crosses val="autoZero"/>
        <c:auto val="1"/>
        <c:lblAlgn val="ctr"/>
        <c:lblOffset val="100"/>
        <c:tickLblSkip val="5"/>
        <c:tickMarkSkip val="5"/>
      </c:catAx>
      <c:valAx>
        <c:axId val="15872230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8720768"/>
        <c:crosses val="autoZero"/>
        <c:crossBetween val="between"/>
      </c:valAx>
    </c:plotArea>
    <c:plotVisOnly val="1"/>
  </c:chart>
  <c:externalData r:id="rId1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A1_0.02_5%'!$B$104</c:f>
              <c:strCache>
                <c:ptCount val="1"/>
                <c:pt idx="0">
                  <c:v>unc-49_REX_A1_01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B$105:$B$125</c:f>
              <c:numCache>
                <c:formatCode>General</c:formatCode>
                <c:ptCount val="21"/>
                <c:pt idx="1">
                  <c:v>0.11600221483942398</c:v>
                </c:pt>
                <c:pt idx="2">
                  <c:v>0.12347729789590298</c:v>
                </c:pt>
                <c:pt idx="3">
                  <c:v>0.139811738648948</c:v>
                </c:pt>
                <c:pt idx="4">
                  <c:v>0.10769656699889303</c:v>
                </c:pt>
                <c:pt idx="5">
                  <c:v>8.1672203765227006E-2</c:v>
                </c:pt>
                <c:pt idx="6">
                  <c:v>6.8660022148394201E-2</c:v>
                </c:pt>
                <c:pt idx="7">
                  <c:v>4.3743078626799589E-2</c:v>
                </c:pt>
                <c:pt idx="8">
                  <c:v>3.7375415282392015E-2</c:v>
                </c:pt>
                <c:pt idx="9">
                  <c:v>2.8516057585825007E-2</c:v>
                </c:pt>
                <c:pt idx="10">
                  <c:v>2.3809523809523808E-2</c:v>
                </c:pt>
                <c:pt idx="11">
                  <c:v>1.2458471760797304E-2</c:v>
                </c:pt>
                <c:pt idx="12">
                  <c:v>5.5370985603543721E-3</c:v>
                </c:pt>
                <c:pt idx="13">
                  <c:v>5.2602436323366643E-3</c:v>
                </c:pt>
                <c:pt idx="14">
                  <c:v>6.090808416389812E-3</c:v>
                </c:pt>
                <c:pt idx="15">
                  <c:v>2.2148394241417501E-3</c:v>
                </c:pt>
                <c:pt idx="16">
                  <c:v>1.6611295681063108E-3</c:v>
                </c:pt>
                <c:pt idx="17">
                  <c:v>8.3056478405315649E-4</c:v>
                </c:pt>
                <c:pt idx="18">
                  <c:v>1.10741971207087E-3</c:v>
                </c:pt>
                <c:pt idx="19">
                  <c:v>8.3056478405315649E-4</c:v>
                </c:pt>
                <c:pt idx="20">
                  <c:v>5.537098560354373E-4</c:v>
                </c:pt>
              </c:numCache>
            </c:numRef>
          </c:val>
        </c:ser>
        <c:ser>
          <c:idx val="1"/>
          <c:order val="1"/>
          <c:tx>
            <c:strRef>
              <c:f>'unc-49 A1_0.02_5%'!$C$104</c:f>
              <c:strCache>
                <c:ptCount val="1"/>
                <c:pt idx="0">
                  <c:v>unc-49_REX_A1_02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C$105:$C$125</c:f>
              <c:numCache>
                <c:formatCode>General</c:formatCode>
                <c:ptCount val="21"/>
                <c:pt idx="1">
                  <c:v>0.10119343610144202</c:v>
                </c:pt>
                <c:pt idx="2">
                  <c:v>0.11611138736946795</c:v>
                </c:pt>
                <c:pt idx="3">
                  <c:v>0.14172053704624599</c:v>
                </c:pt>
                <c:pt idx="4">
                  <c:v>0.11263053207359502</c:v>
                </c:pt>
                <c:pt idx="5">
                  <c:v>9.9701640974639572E-2</c:v>
                </c:pt>
                <c:pt idx="6">
                  <c:v>7.8816509199403334E-2</c:v>
                </c:pt>
                <c:pt idx="7">
                  <c:v>5.3953257086026912E-2</c:v>
                </c:pt>
                <c:pt idx="8">
                  <c:v>4.8731974142217818E-2</c:v>
                </c:pt>
                <c:pt idx="9">
                  <c:v>3.8538040775733515E-2</c:v>
                </c:pt>
                <c:pt idx="10">
                  <c:v>2.0636499254102398E-2</c:v>
                </c:pt>
                <c:pt idx="11">
                  <c:v>2.0139234211834899E-2</c:v>
                </c:pt>
                <c:pt idx="12">
                  <c:v>1.4420686225758301E-2</c:v>
                </c:pt>
                <c:pt idx="13">
                  <c:v>5.9671805072103396E-3</c:v>
                </c:pt>
                <c:pt idx="14">
                  <c:v>1.0442565887618107E-2</c:v>
                </c:pt>
                <c:pt idx="15">
                  <c:v>4.9726504226752918E-3</c:v>
                </c:pt>
                <c:pt idx="16">
                  <c:v>4.2267528592739899E-3</c:v>
                </c:pt>
                <c:pt idx="17">
                  <c:v>2.2376926902038792E-3</c:v>
                </c:pt>
                <c:pt idx="18">
                  <c:v>1.4917951268025905E-3</c:v>
                </c:pt>
                <c:pt idx="19">
                  <c:v>1.4917951268025905E-3</c:v>
                </c:pt>
                <c:pt idx="20">
                  <c:v>1.2431626056688201E-3</c:v>
                </c:pt>
              </c:numCache>
            </c:numRef>
          </c:val>
        </c:ser>
        <c:ser>
          <c:idx val="2"/>
          <c:order val="2"/>
          <c:tx>
            <c:strRef>
              <c:f>'unc-49 A1_0.02_5%'!$D$104</c:f>
              <c:strCache>
                <c:ptCount val="1"/>
                <c:pt idx="0">
                  <c:v>unc-49_REX_A1_03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D$105:$D$125</c:f>
              <c:numCache>
                <c:formatCode>General</c:formatCode>
                <c:ptCount val="21"/>
                <c:pt idx="1">
                  <c:v>8.7474702046323405E-2</c:v>
                </c:pt>
                <c:pt idx="2">
                  <c:v>0.12187991904654798</c:v>
                </c:pt>
                <c:pt idx="3">
                  <c:v>0.13649651450416006</c:v>
                </c:pt>
                <c:pt idx="4">
                  <c:v>0.11783224645828605</c:v>
                </c:pt>
                <c:pt idx="5">
                  <c:v>0.11873172925567806</c:v>
                </c:pt>
                <c:pt idx="6">
                  <c:v>8.2527546660670151E-2</c:v>
                </c:pt>
                <c:pt idx="7">
                  <c:v>6.2963795817404994E-2</c:v>
                </c:pt>
                <c:pt idx="8">
                  <c:v>4.8347200359793112E-2</c:v>
                </c:pt>
                <c:pt idx="9">
                  <c:v>3.8677760287834512E-2</c:v>
                </c:pt>
                <c:pt idx="10">
                  <c:v>2.4510906228918401E-2</c:v>
                </c:pt>
                <c:pt idx="11">
                  <c:v>1.9114009444569407E-2</c:v>
                </c:pt>
                <c:pt idx="12">
                  <c:v>1.3267371261524604E-2</c:v>
                </c:pt>
                <c:pt idx="13">
                  <c:v>7.6456037778277518E-3</c:v>
                </c:pt>
                <c:pt idx="14">
                  <c:v>5.621767483696874E-3</c:v>
                </c:pt>
                <c:pt idx="15">
                  <c:v>5.1720260850011239E-3</c:v>
                </c:pt>
                <c:pt idx="16">
                  <c:v>2.0238362941308709E-3</c:v>
                </c:pt>
                <c:pt idx="17">
                  <c:v>4.4974139869575016E-4</c:v>
                </c:pt>
                <c:pt idx="18">
                  <c:v>1.3492241960872499E-3</c:v>
                </c:pt>
                <c:pt idx="19">
                  <c:v>4.4974139869575016E-4</c:v>
                </c:pt>
                <c:pt idx="20">
                  <c:v>8.9948279739150033E-4</c:v>
                </c:pt>
              </c:numCache>
            </c:numRef>
          </c:val>
        </c:ser>
        <c:ser>
          <c:idx val="3"/>
          <c:order val="3"/>
          <c:tx>
            <c:strRef>
              <c:f>'unc-49 A1_0.02_5%'!$E$104</c:f>
              <c:strCache>
                <c:ptCount val="1"/>
                <c:pt idx="0">
                  <c:v>unc-49_REX_A1_04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E$105:$E$125</c:f>
              <c:numCache>
                <c:formatCode>General</c:formatCode>
                <c:ptCount val="21"/>
                <c:pt idx="1">
                  <c:v>0.12490594431903702</c:v>
                </c:pt>
                <c:pt idx="2">
                  <c:v>0.14647604715324805</c:v>
                </c:pt>
                <c:pt idx="3">
                  <c:v>0.14597441685477799</c:v>
                </c:pt>
                <c:pt idx="4">
                  <c:v>0.11261600200652103</c:v>
                </c:pt>
                <c:pt idx="5">
                  <c:v>8.3772259844494629E-2</c:v>
                </c:pt>
                <c:pt idx="6">
                  <c:v>6.3205417607223494E-2</c:v>
                </c:pt>
                <c:pt idx="7">
                  <c:v>4.5899172310007487E-2</c:v>
                </c:pt>
                <c:pt idx="8">
                  <c:v>3.3860045146726914E-2</c:v>
                </c:pt>
                <c:pt idx="9">
                  <c:v>2.4579884625031398E-2</c:v>
                </c:pt>
                <c:pt idx="10">
                  <c:v>1.4296463506395796E-2</c:v>
                </c:pt>
                <c:pt idx="11">
                  <c:v>1.05342362678706E-2</c:v>
                </c:pt>
                <c:pt idx="12">
                  <c:v>7.5244544770504077E-3</c:v>
                </c:pt>
                <c:pt idx="13">
                  <c:v>4.76548783546526E-3</c:v>
                </c:pt>
                <c:pt idx="14">
                  <c:v>2.7589666415851512E-3</c:v>
                </c:pt>
                <c:pt idx="15">
                  <c:v>1.2540757461750704E-3</c:v>
                </c:pt>
                <c:pt idx="16">
                  <c:v>1.0032605969400601E-3</c:v>
                </c:pt>
                <c:pt idx="17">
                  <c:v>2.5081514923501409E-4</c:v>
                </c:pt>
                <c:pt idx="18">
                  <c:v>1.2540757461750704E-3</c:v>
                </c:pt>
                <c:pt idx="19">
                  <c:v>2.5081514923501409E-4</c:v>
                </c:pt>
                <c:pt idx="20">
                  <c:v>2.5081514923501409E-4</c:v>
                </c:pt>
              </c:numCache>
            </c:numRef>
          </c:val>
        </c:ser>
        <c:ser>
          <c:idx val="4"/>
          <c:order val="4"/>
          <c:tx>
            <c:strRef>
              <c:f>'unc-49 A1_0.02_5%'!$F$104</c:f>
              <c:strCache>
                <c:ptCount val="1"/>
                <c:pt idx="0">
                  <c:v>unc-49_REX_A1_05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F$105:$F$125</c:f>
              <c:numCache>
                <c:formatCode>General</c:formatCode>
                <c:ptCount val="21"/>
                <c:pt idx="1">
                  <c:v>8.8030888030888058E-2</c:v>
                </c:pt>
                <c:pt idx="2">
                  <c:v>0.10939510939510905</c:v>
                </c:pt>
                <c:pt idx="3">
                  <c:v>0.12689832689832706</c:v>
                </c:pt>
                <c:pt idx="4">
                  <c:v>0.11145431145431101</c:v>
                </c:pt>
                <c:pt idx="5">
                  <c:v>9.7812097812097779E-2</c:v>
                </c:pt>
                <c:pt idx="6">
                  <c:v>7.6447876447876401E-2</c:v>
                </c:pt>
                <c:pt idx="7">
                  <c:v>5.6885456885456896E-2</c:v>
                </c:pt>
                <c:pt idx="8">
                  <c:v>4.6332046332046337E-2</c:v>
                </c:pt>
                <c:pt idx="9">
                  <c:v>4.1956241956242021E-2</c:v>
                </c:pt>
                <c:pt idx="10">
                  <c:v>2.9858429858429892E-2</c:v>
                </c:pt>
                <c:pt idx="11">
                  <c:v>2.5482625482625518E-2</c:v>
                </c:pt>
                <c:pt idx="12">
                  <c:v>2.0592020592020598E-2</c:v>
                </c:pt>
                <c:pt idx="13">
                  <c:v>1.0810810810810801E-2</c:v>
                </c:pt>
                <c:pt idx="14">
                  <c:v>9.7812097812097799E-3</c:v>
                </c:pt>
                <c:pt idx="15">
                  <c:v>7.2072072072072099E-3</c:v>
                </c:pt>
                <c:pt idx="16">
                  <c:v>7.9794079794079827E-3</c:v>
                </c:pt>
                <c:pt idx="17">
                  <c:v>3.088803088803091E-3</c:v>
                </c:pt>
                <c:pt idx="18">
                  <c:v>5.9202059202059197E-3</c:v>
                </c:pt>
                <c:pt idx="19">
                  <c:v>2.31660231660232E-3</c:v>
                </c:pt>
                <c:pt idx="20">
                  <c:v>1.8018018018018005E-3</c:v>
                </c:pt>
              </c:numCache>
            </c:numRef>
          </c:val>
        </c:ser>
        <c:ser>
          <c:idx val="5"/>
          <c:order val="5"/>
          <c:tx>
            <c:strRef>
              <c:f>'unc-49 A1_0.02_5%'!$G$104</c:f>
              <c:strCache>
                <c:ptCount val="1"/>
                <c:pt idx="0">
                  <c:v>unc-49_REX_A1_06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G$105:$G$125</c:f>
              <c:numCache>
                <c:formatCode>General</c:formatCode>
                <c:ptCount val="21"/>
                <c:pt idx="1">
                  <c:v>0.10117789187556597</c:v>
                </c:pt>
                <c:pt idx="2">
                  <c:v>0.13319238900634306</c:v>
                </c:pt>
                <c:pt idx="3">
                  <c:v>0.128360012080942</c:v>
                </c:pt>
                <c:pt idx="4">
                  <c:v>0.102385986106916</c:v>
                </c:pt>
                <c:pt idx="5">
                  <c:v>9.3023255813953501E-2</c:v>
                </c:pt>
                <c:pt idx="6">
                  <c:v>6.9163394744790122E-2</c:v>
                </c:pt>
                <c:pt idx="7">
                  <c:v>5.2552099063727015E-2</c:v>
                </c:pt>
                <c:pt idx="8">
                  <c:v>4.2283298097251613E-2</c:v>
                </c:pt>
                <c:pt idx="9">
                  <c:v>3.6242826940501398E-2</c:v>
                </c:pt>
                <c:pt idx="10">
                  <c:v>2.4463908184838401E-2</c:v>
                </c:pt>
                <c:pt idx="11">
                  <c:v>1.9027484143763207E-2</c:v>
                </c:pt>
                <c:pt idx="12">
                  <c:v>1.2080942313500499E-2</c:v>
                </c:pt>
                <c:pt idx="13">
                  <c:v>1.08728480821504E-2</c:v>
                </c:pt>
                <c:pt idx="14">
                  <c:v>7.2485653881002735E-3</c:v>
                </c:pt>
                <c:pt idx="15">
                  <c:v>5.4364240410752019E-3</c:v>
                </c:pt>
                <c:pt idx="16">
                  <c:v>2.4161884627000902E-3</c:v>
                </c:pt>
                <c:pt idx="17">
                  <c:v>3.3222591362126199E-3</c:v>
                </c:pt>
                <c:pt idx="18">
                  <c:v>6.0404711567502319E-4</c:v>
                </c:pt>
                <c:pt idx="19">
                  <c:v>3.0202355783751121E-4</c:v>
                </c:pt>
                <c:pt idx="20">
                  <c:v>6.0404711567502319E-4</c:v>
                </c:pt>
              </c:numCache>
            </c:numRef>
          </c:val>
        </c:ser>
        <c:ser>
          <c:idx val="6"/>
          <c:order val="6"/>
          <c:tx>
            <c:strRef>
              <c:f>'unc-49 A1_0.02_5%'!$H$104</c:f>
              <c:strCache>
                <c:ptCount val="1"/>
                <c:pt idx="0">
                  <c:v>unc-49_REX_A1_07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H$105:$H$125</c:f>
              <c:numCache>
                <c:formatCode>General</c:formatCode>
                <c:ptCount val="21"/>
                <c:pt idx="1">
                  <c:v>9.504253446758576E-2</c:v>
                </c:pt>
                <c:pt idx="2">
                  <c:v>0.106189498386624</c:v>
                </c:pt>
                <c:pt idx="3">
                  <c:v>0.11880316808448202</c:v>
                </c:pt>
                <c:pt idx="4">
                  <c:v>0.10853622763273703</c:v>
                </c:pt>
                <c:pt idx="5">
                  <c:v>9.0642417131123504E-2</c:v>
                </c:pt>
                <c:pt idx="6">
                  <c:v>6.4241713112349719E-2</c:v>
                </c:pt>
                <c:pt idx="7">
                  <c:v>5.9841595775887386E-2</c:v>
                </c:pt>
                <c:pt idx="8">
                  <c:v>5.2801408037547723E-2</c:v>
                </c:pt>
                <c:pt idx="9">
                  <c:v>3.7547667937811717E-2</c:v>
                </c:pt>
                <c:pt idx="10">
                  <c:v>2.9920797887943711E-2</c:v>
                </c:pt>
                <c:pt idx="11">
                  <c:v>2.3760633616896489E-2</c:v>
                </c:pt>
                <c:pt idx="12">
                  <c:v>1.3787034320915204E-2</c:v>
                </c:pt>
                <c:pt idx="13">
                  <c:v>2.1120563215019102E-2</c:v>
                </c:pt>
                <c:pt idx="14">
                  <c:v>8.8002346729246193E-3</c:v>
                </c:pt>
                <c:pt idx="15">
                  <c:v>8.8002346729246193E-3</c:v>
                </c:pt>
                <c:pt idx="16">
                  <c:v>7.3335288941038437E-3</c:v>
                </c:pt>
                <c:pt idx="17">
                  <c:v>4.4001173364623114E-3</c:v>
                </c:pt>
                <c:pt idx="18">
                  <c:v>7.6268700498680004E-3</c:v>
                </c:pt>
                <c:pt idx="19">
                  <c:v>5.8668231152830741E-3</c:v>
                </c:pt>
                <c:pt idx="20">
                  <c:v>2.05338809034908E-3</c:v>
                </c:pt>
              </c:numCache>
            </c:numRef>
          </c:val>
        </c:ser>
        <c:ser>
          <c:idx val="7"/>
          <c:order val="7"/>
          <c:tx>
            <c:strRef>
              <c:f>'unc-49 A1_0.02_5%'!$I$104</c:f>
              <c:strCache>
                <c:ptCount val="1"/>
                <c:pt idx="0">
                  <c:v>unc-49_REX_A1_08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I$105:$I$125</c:f>
              <c:numCache>
                <c:formatCode>General</c:formatCode>
                <c:ptCount val="21"/>
                <c:pt idx="1">
                  <c:v>9.0123456790123527E-2</c:v>
                </c:pt>
                <c:pt idx="2">
                  <c:v>0.12197530864197502</c:v>
                </c:pt>
                <c:pt idx="3">
                  <c:v>0.135061728395062</c:v>
                </c:pt>
                <c:pt idx="4">
                  <c:v>0.11185185185185198</c:v>
                </c:pt>
                <c:pt idx="5">
                  <c:v>0.110123456790123</c:v>
                </c:pt>
                <c:pt idx="6">
                  <c:v>7.3086419753086426E-2</c:v>
                </c:pt>
                <c:pt idx="7">
                  <c:v>6.222222222222222E-2</c:v>
                </c:pt>
                <c:pt idx="8">
                  <c:v>4.7654320987654299E-2</c:v>
                </c:pt>
                <c:pt idx="9">
                  <c:v>3.9753086419753114E-2</c:v>
                </c:pt>
                <c:pt idx="10">
                  <c:v>2.7407407407407415E-2</c:v>
                </c:pt>
                <c:pt idx="11">
                  <c:v>1.8765432098765408E-2</c:v>
                </c:pt>
                <c:pt idx="12">
                  <c:v>1.5061728395061709E-2</c:v>
                </c:pt>
                <c:pt idx="13">
                  <c:v>7.9012345679012313E-3</c:v>
                </c:pt>
                <c:pt idx="14">
                  <c:v>7.9012345679012313E-3</c:v>
                </c:pt>
                <c:pt idx="15">
                  <c:v>4.4444444444444418E-3</c:v>
                </c:pt>
                <c:pt idx="16">
                  <c:v>3.95061728395062E-3</c:v>
                </c:pt>
                <c:pt idx="17">
                  <c:v>2.469135802469141E-3</c:v>
                </c:pt>
                <c:pt idx="18">
                  <c:v>3.456790123456789E-3</c:v>
                </c:pt>
                <c:pt idx="19">
                  <c:v>1.2345679012345705E-3</c:v>
                </c:pt>
                <c:pt idx="20">
                  <c:v>7.4074074074074114E-4</c:v>
                </c:pt>
              </c:numCache>
            </c:numRef>
          </c:val>
        </c:ser>
        <c:ser>
          <c:idx val="8"/>
          <c:order val="8"/>
          <c:tx>
            <c:strRef>
              <c:f>'unc-49 A1_0.02_5%'!$J$104</c:f>
              <c:strCache>
                <c:ptCount val="1"/>
                <c:pt idx="0">
                  <c:v>unc-49_REX_A1_09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J$105:$J$125</c:f>
              <c:numCache>
                <c:formatCode>General</c:formatCode>
                <c:ptCount val="21"/>
                <c:pt idx="1">
                  <c:v>0.10527589545014503</c:v>
                </c:pt>
                <c:pt idx="2">
                  <c:v>0.13020329138431799</c:v>
                </c:pt>
                <c:pt idx="3">
                  <c:v>0.12778315585672806</c:v>
                </c:pt>
                <c:pt idx="4">
                  <c:v>0.10696999031945797</c:v>
                </c:pt>
                <c:pt idx="5">
                  <c:v>9.6805421103581826E-2</c:v>
                </c:pt>
                <c:pt idx="6">
                  <c:v>7.4540174249758021E-2</c:v>
                </c:pt>
                <c:pt idx="7">
                  <c:v>5.4695062923523725E-2</c:v>
                </c:pt>
                <c:pt idx="8">
                  <c:v>5.0822846079380396E-2</c:v>
                </c:pt>
                <c:pt idx="9">
                  <c:v>3.6544046466602115E-2</c:v>
                </c:pt>
                <c:pt idx="10">
                  <c:v>2.8557599225556597E-2</c:v>
                </c:pt>
                <c:pt idx="11">
                  <c:v>2.3717328170377507E-2</c:v>
                </c:pt>
                <c:pt idx="12">
                  <c:v>1.5004840271055201E-2</c:v>
                </c:pt>
                <c:pt idx="13">
                  <c:v>9.438528557599234E-3</c:v>
                </c:pt>
                <c:pt idx="14">
                  <c:v>4.8402710551790915E-3</c:v>
                </c:pt>
                <c:pt idx="15">
                  <c:v>3.630203291384321E-3</c:v>
                </c:pt>
                <c:pt idx="16">
                  <c:v>3.388189738625362E-3</c:v>
                </c:pt>
                <c:pt idx="17">
                  <c:v>3.630203291384321E-3</c:v>
                </c:pt>
                <c:pt idx="18">
                  <c:v>1.6940948693126808E-3</c:v>
                </c:pt>
                <c:pt idx="19">
                  <c:v>7.260406582768644E-4</c:v>
                </c:pt>
                <c:pt idx="20">
                  <c:v>4.8402710551790924E-4</c:v>
                </c:pt>
              </c:numCache>
            </c:numRef>
          </c:val>
        </c:ser>
        <c:ser>
          <c:idx val="9"/>
          <c:order val="9"/>
          <c:tx>
            <c:strRef>
              <c:f>'unc-49 A1_0.02_5%'!$K$104</c:f>
              <c:strCache>
                <c:ptCount val="1"/>
                <c:pt idx="0">
                  <c:v>unc-49_REX_A1_10</c:v>
                </c:pt>
              </c:strCache>
            </c:strRef>
          </c:tx>
          <c:marker>
            <c:symbol val="none"/>
          </c:marker>
          <c:cat>
            <c:numRef>
              <c:f>'unc-49 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1_0.02_5%'!$K$105:$K$125</c:f>
              <c:numCache>
                <c:formatCode>General</c:formatCode>
                <c:ptCount val="21"/>
                <c:pt idx="1">
                  <c:v>0.10626773278308005</c:v>
                </c:pt>
                <c:pt idx="2">
                  <c:v>0.11761671395408803</c:v>
                </c:pt>
                <c:pt idx="3">
                  <c:v>0.11890637090533904</c:v>
                </c:pt>
                <c:pt idx="4">
                  <c:v>0.103172556100077</c:v>
                </c:pt>
                <c:pt idx="5">
                  <c:v>8.1764250709311301E-2</c:v>
                </c:pt>
                <c:pt idx="6">
                  <c:v>5.9840082538044903E-2</c:v>
                </c:pt>
                <c:pt idx="7">
                  <c:v>4.9006964147536844E-2</c:v>
                </c:pt>
                <c:pt idx="8">
                  <c:v>3.9205571318029417E-2</c:v>
                </c:pt>
                <c:pt idx="9">
                  <c:v>3.5078669074026313E-2</c:v>
                </c:pt>
                <c:pt idx="10">
                  <c:v>2.7082795976270318E-2</c:v>
                </c:pt>
                <c:pt idx="11">
                  <c:v>1.8571060098013906E-2</c:v>
                </c:pt>
                <c:pt idx="12">
                  <c:v>1.8313128707763707E-2</c:v>
                </c:pt>
                <c:pt idx="13">
                  <c:v>1.0575187000257901E-2</c:v>
                </c:pt>
                <c:pt idx="14">
                  <c:v>6.448284756254842E-3</c:v>
                </c:pt>
                <c:pt idx="15">
                  <c:v>4.38483363425329E-3</c:v>
                </c:pt>
                <c:pt idx="16">
                  <c:v>4.6427650245034818E-3</c:v>
                </c:pt>
                <c:pt idx="17">
                  <c:v>1.5475883415011604E-3</c:v>
                </c:pt>
                <c:pt idx="18">
                  <c:v>1.0317255610007704E-3</c:v>
                </c:pt>
                <c:pt idx="19">
                  <c:v>5.1586278050038748E-4</c:v>
                </c:pt>
                <c:pt idx="20">
                  <c:v>2.5793139025019314E-4</c:v>
                </c:pt>
              </c:numCache>
            </c:numRef>
          </c:val>
        </c:ser>
        <c:marker val="1"/>
        <c:axId val="158576000"/>
        <c:axId val="158585984"/>
      </c:lineChart>
      <c:catAx>
        <c:axId val="158576000"/>
        <c:scaling>
          <c:orientation val="minMax"/>
        </c:scaling>
        <c:axPos val="b"/>
        <c:numFmt formatCode="0.0_ " sourceLinked="1"/>
        <c:tickLblPos val="nextTo"/>
        <c:crossAx val="158585984"/>
        <c:crosses val="autoZero"/>
        <c:auto val="1"/>
        <c:lblAlgn val="ctr"/>
        <c:lblOffset val="100"/>
        <c:tickLblSkip val="5"/>
        <c:tickMarkSkip val="5"/>
      </c:catAx>
      <c:valAx>
        <c:axId val="15858598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8576000"/>
        <c:crosses val="autoZero"/>
        <c:crossBetween val="between"/>
      </c:valAx>
    </c:plotArea>
    <c:plotVisOnly val="1"/>
  </c:chart>
  <c:externalData r:id="rId1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2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A2_0.02_5%'!$B$104</c:f>
              <c:strCache>
                <c:ptCount val="1"/>
                <c:pt idx="0">
                  <c:v>unc-49_REX_A2_01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B$105:$B$125</c:f>
              <c:numCache>
                <c:formatCode>General</c:formatCode>
                <c:ptCount val="21"/>
                <c:pt idx="1">
                  <c:v>8.953341740226993E-2</c:v>
                </c:pt>
                <c:pt idx="2">
                  <c:v>0.11696090794451403</c:v>
                </c:pt>
                <c:pt idx="3">
                  <c:v>0.115069356872636</c:v>
                </c:pt>
                <c:pt idx="4">
                  <c:v>9.899117276166465E-2</c:v>
                </c:pt>
                <c:pt idx="5">
                  <c:v>9.615384615384627E-2</c:v>
                </c:pt>
                <c:pt idx="6">
                  <c:v>6.9041614123581327E-2</c:v>
                </c:pt>
                <c:pt idx="7">
                  <c:v>5.7377049180327898E-2</c:v>
                </c:pt>
                <c:pt idx="8">
                  <c:v>5.2648171500630496E-2</c:v>
                </c:pt>
                <c:pt idx="9">
                  <c:v>3.7515762925599015E-2</c:v>
                </c:pt>
                <c:pt idx="10">
                  <c:v>3.2471626733921802E-2</c:v>
                </c:pt>
                <c:pt idx="11">
                  <c:v>2.4590163934426198E-2</c:v>
                </c:pt>
                <c:pt idx="12">
                  <c:v>1.8600252206809605E-2</c:v>
                </c:pt>
                <c:pt idx="13">
                  <c:v>1.3556116015132404E-2</c:v>
                </c:pt>
                <c:pt idx="14">
                  <c:v>1.1664564943253507E-2</c:v>
                </c:pt>
                <c:pt idx="15">
                  <c:v>5.3593947036569998E-3</c:v>
                </c:pt>
                <c:pt idx="16">
                  <c:v>1.0403530895334204E-2</c:v>
                </c:pt>
                <c:pt idx="17">
                  <c:v>7.2509457755359401E-3</c:v>
                </c:pt>
                <c:pt idx="18">
                  <c:v>4.0983606557377103E-3</c:v>
                </c:pt>
                <c:pt idx="19">
                  <c:v>1.5762925598991205E-3</c:v>
                </c:pt>
                <c:pt idx="20">
                  <c:v>3.7831021437578819E-3</c:v>
                </c:pt>
              </c:numCache>
            </c:numRef>
          </c:val>
        </c:ser>
        <c:ser>
          <c:idx val="1"/>
          <c:order val="1"/>
          <c:tx>
            <c:strRef>
              <c:f>'unc-49 A2_0.02_5%'!$C$104</c:f>
              <c:strCache>
                <c:ptCount val="1"/>
                <c:pt idx="0">
                  <c:v>unc-49_REX_A2_02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C$105:$C$125</c:f>
              <c:numCache>
                <c:formatCode>General</c:formatCode>
                <c:ptCount val="21"/>
                <c:pt idx="1">
                  <c:v>0.128226025536539</c:v>
                </c:pt>
                <c:pt idx="2">
                  <c:v>0.154577560445531</c:v>
                </c:pt>
                <c:pt idx="3">
                  <c:v>0.13909263787014406</c:v>
                </c:pt>
                <c:pt idx="4">
                  <c:v>0.100516164085846</c:v>
                </c:pt>
                <c:pt idx="5">
                  <c:v>7.0361314860092394E-2</c:v>
                </c:pt>
                <c:pt idx="6">
                  <c:v>4.8899755501222497E-2</c:v>
                </c:pt>
                <c:pt idx="7">
                  <c:v>3.3143167617495202E-2</c:v>
                </c:pt>
                <c:pt idx="8">
                  <c:v>2.63515349089921E-2</c:v>
                </c:pt>
                <c:pt idx="9">
                  <c:v>1.7386579733768011E-2</c:v>
                </c:pt>
                <c:pt idx="10">
                  <c:v>1.1138277641945101E-2</c:v>
                </c:pt>
                <c:pt idx="11">
                  <c:v>7.0632980168432533E-3</c:v>
                </c:pt>
                <c:pt idx="12">
                  <c:v>7.878293941863625E-3</c:v>
                </c:pt>
                <c:pt idx="13">
                  <c:v>5.7049714751426237E-3</c:v>
                </c:pt>
                <c:pt idx="14">
                  <c:v>3.5316490084216202E-3</c:v>
                </c:pt>
                <c:pt idx="15">
                  <c:v>2.1733224667210009E-3</c:v>
                </c:pt>
                <c:pt idx="16">
                  <c:v>8.149959250203754E-4</c:v>
                </c:pt>
                <c:pt idx="17">
                  <c:v>8.149959250203754E-4</c:v>
                </c:pt>
                <c:pt idx="18">
                  <c:v>8.149959250203754E-4</c:v>
                </c:pt>
                <c:pt idx="19">
                  <c:v>2.7166530834012501E-4</c:v>
                </c:pt>
                <c:pt idx="20">
                  <c:v>1.0866612333605E-3</c:v>
                </c:pt>
              </c:numCache>
            </c:numRef>
          </c:val>
        </c:ser>
        <c:ser>
          <c:idx val="2"/>
          <c:order val="2"/>
          <c:tx>
            <c:strRef>
              <c:f>'unc-49 A2_0.02_5%'!$D$104</c:f>
              <c:strCache>
                <c:ptCount val="1"/>
                <c:pt idx="0">
                  <c:v>unc-49_REX_A2_03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D$105:$D$125</c:f>
              <c:numCache>
                <c:formatCode>General</c:formatCode>
                <c:ptCount val="21"/>
                <c:pt idx="1">
                  <c:v>9.6665867114415951E-2</c:v>
                </c:pt>
                <c:pt idx="2">
                  <c:v>0.12473015111537503</c:v>
                </c:pt>
                <c:pt idx="3">
                  <c:v>0.14511873350923507</c:v>
                </c:pt>
                <c:pt idx="4">
                  <c:v>0.11489565843127804</c:v>
                </c:pt>
                <c:pt idx="5">
                  <c:v>9.4746941712640961E-2</c:v>
                </c:pt>
                <c:pt idx="6">
                  <c:v>6.8361717438234632E-2</c:v>
                </c:pt>
                <c:pt idx="7">
                  <c:v>5.5408970976253316E-2</c:v>
                </c:pt>
                <c:pt idx="8">
                  <c:v>4.4854881266490801E-2</c:v>
                </c:pt>
                <c:pt idx="9">
                  <c:v>4.149676181338452E-2</c:v>
                </c:pt>
                <c:pt idx="10">
                  <c:v>2.5905492923962607E-2</c:v>
                </c:pt>
                <c:pt idx="11">
                  <c:v>2.06284480690813E-2</c:v>
                </c:pt>
                <c:pt idx="12">
                  <c:v>1.0554089709762505E-2</c:v>
                </c:pt>
                <c:pt idx="13">
                  <c:v>1.19932837610938E-2</c:v>
                </c:pt>
                <c:pt idx="14">
                  <c:v>6.9561045814344018E-3</c:v>
                </c:pt>
                <c:pt idx="15">
                  <c:v>5.5169105301031401E-3</c:v>
                </c:pt>
                <c:pt idx="16">
                  <c:v>2.1587910769968817E-3</c:v>
                </c:pt>
                <c:pt idx="17">
                  <c:v>3.1182537778843816E-3</c:v>
                </c:pt>
                <c:pt idx="18">
                  <c:v>1.1993283761093799E-3</c:v>
                </c:pt>
                <c:pt idx="19">
                  <c:v>1.1993283761093799E-3</c:v>
                </c:pt>
                <c:pt idx="20">
                  <c:v>7.1959702566562695E-4</c:v>
                </c:pt>
              </c:numCache>
            </c:numRef>
          </c:val>
        </c:ser>
        <c:ser>
          <c:idx val="3"/>
          <c:order val="3"/>
          <c:tx>
            <c:strRef>
              <c:f>'unc-49 A2_0.02_5%'!$E$104</c:f>
              <c:strCache>
                <c:ptCount val="1"/>
                <c:pt idx="0">
                  <c:v>unc-49_REX_A2_04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E$105:$E$125</c:f>
              <c:numCache>
                <c:formatCode>General</c:formatCode>
                <c:ptCount val="21"/>
                <c:pt idx="1">
                  <c:v>8.4210526315789527E-2</c:v>
                </c:pt>
                <c:pt idx="2">
                  <c:v>0.12727272727272695</c:v>
                </c:pt>
                <c:pt idx="3">
                  <c:v>0.124401913875598</c:v>
                </c:pt>
                <c:pt idx="4">
                  <c:v>0.11961722488038302</c:v>
                </c:pt>
                <c:pt idx="5">
                  <c:v>0.124401913875598</c:v>
                </c:pt>
                <c:pt idx="6">
                  <c:v>8.6124401913875645E-2</c:v>
                </c:pt>
                <c:pt idx="7">
                  <c:v>6.7942583732057402E-2</c:v>
                </c:pt>
                <c:pt idx="8">
                  <c:v>4.1148325358851684E-2</c:v>
                </c:pt>
                <c:pt idx="9">
                  <c:v>4.8803827751196217E-2</c:v>
                </c:pt>
                <c:pt idx="10">
                  <c:v>3.73205741626794E-2</c:v>
                </c:pt>
                <c:pt idx="11">
                  <c:v>1.9138755980861205E-2</c:v>
                </c:pt>
                <c:pt idx="12">
                  <c:v>1.2440191387559803E-2</c:v>
                </c:pt>
                <c:pt idx="13">
                  <c:v>1.5311004784689001E-2</c:v>
                </c:pt>
                <c:pt idx="14">
                  <c:v>1.3397129186602904E-2</c:v>
                </c:pt>
                <c:pt idx="15">
                  <c:v>6.6985645933014416E-3</c:v>
                </c:pt>
                <c:pt idx="16">
                  <c:v>3.8277511961722511E-3</c:v>
                </c:pt>
                <c:pt idx="17">
                  <c:v>1.9138755980861206E-3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4"/>
          <c:order val="4"/>
          <c:tx>
            <c:strRef>
              <c:f>'unc-49 A2_0.02_5%'!$F$104</c:f>
              <c:strCache>
                <c:ptCount val="1"/>
                <c:pt idx="0">
                  <c:v>unc-49_REX_A2_05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F$105:$F$125</c:f>
              <c:numCache>
                <c:formatCode>General</c:formatCode>
                <c:ptCount val="21"/>
                <c:pt idx="1">
                  <c:v>8.8309503784693058E-2</c:v>
                </c:pt>
                <c:pt idx="2">
                  <c:v>0.11333052985702298</c:v>
                </c:pt>
                <c:pt idx="3">
                  <c:v>0.126156433978133</c:v>
                </c:pt>
                <c:pt idx="4">
                  <c:v>0.10807401177460105</c:v>
                </c:pt>
                <c:pt idx="5">
                  <c:v>0.10702270815811606</c:v>
                </c:pt>
                <c:pt idx="6">
                  <c:v>8.3473507148864604E-2</c:v>
                </c:pt>
                <c:pt idx="7">
                  <c:v>6.4970563498738421E-2</c:v>
                </c:pt>
                <c:pt idx="8">
                  <c:v>4.4785534062237231E-2</c:v>
                </c:pt>
                <c:pt idx="9">
                  <c:v>3.9949537426408714E-2</c:v>
                </c:pt>
                <c:pt idx="10">
                  <c:v>3.1959629941126999E-2</c:v>
                </c:pt>
                <c:pt idx="11">
                  <c:v>2.5441547518923534E-2</c:v>
                </c:pt>
                <c:pt idx="12">
                  <c:v>2.1236333052985706E-2</c:v>
                </c:pt>
                <c:pt idx="13">
                  <c:v>1.3456686291000801E-2</c:v>
                </c:pt>
                <c:pt idx="14">
                  <c:v>8.2001682085786395E-3</c:v>
                </c:pt>
                <c:pt idx="15">
                  <c:v>8.2001682085786395E-3</c:v>
                </c:pt>
                <c:pt idx="16">
                  <c:v>6.9386038687973134E-3</c:v>
                </c:pt>
                <c:pt idx="17">
                  <c:v>5.0462573591253199E-3</c:v>
                </c:pt>
                <c:pt idx="18">
                  <c:v>3.5744322960471015E-3</c:v>
                </c:pt>
                <c:pt idx="19">
                  <c:v>3.3641715727502123E-3</c:v>
                </c:pt>
                <c:pt idx="20">
                  <c:v>2.9436501261564311E-3</c:v>
                </c:pt>
              </c:numCache>
            </c:numRef>
          </c:val>
        </c:ser>
        <c:ser>
          <c:idx val="5"/>
          <c:order val="5"/>
          <c:tx>
            <c:strRef>
              <c:f>'unc-49 A2_0.02_5%'!$G$104</c:f>
              <c:strCache>
                <c:ptCount val="1"/>
                <c:pt idx="0">
                  <c:v>unc-49_REX_A2_06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G$105:$G$125</c:f>
              <c:numCache>
                <c:formatCode>General</c:formatCode>
                <c:ptCount val="21"/>
                <c:pt idx="1">
                  <c:v>0.11926605504587204</c:v>
                </c:pt>
                <c:pt idx="2">
                  <c:v>0.12300373768263703</c:v>
                </c:pt>
                <c:pt idx="3">
                  <c:v>0.12810057764186195</c:v>
                </c:pt>
                <c:pt idx="4">
                  <c:v>9.242269792728508E-2</c:v>
                </c:pt>
                <c:pt idx="5">
                  <c:v>8.0190282025144402E-2</c:v>
                </c:pt>
                <c:pt idx="6">
                  <c:v>5.5385660890248024E-2</c:v>
                </c:pt>
                <c:pt idx="7">
                  <c:v>4.9949031600407701E-2</c:v>
                </c:pt>
                <c:pt idx="8">
                  <c:v>4.5531770302412497E-2</c:v>
                </c:pt>
                <c:pt idx="9">
                  <c:v>3.6697247706422027E-2</c:v>
                </c:pt>
                <c:pt idx="10">
                  <c:v>2.2426095820591206E-2</c:v>
                </c:pt>
                <c:pt idx="11">
                  <c:v>1.5970098538905901E-2</c:v>
                </c:pt>
                <c:pt idx="12">
                  <c:v>1.0193679918450601E-2</c:v>
                </c:pt>
                <c:pt idx="13">
                  <c:v>9.5141012572205197E-3</c:v>
                </c:pt>
                <c:pt idx="14">
                  <c:v>5.7764186204553236E-3</c:v>
                </c:pt>
                <c:pt idx="15">
                  <c:v>4.7570506286102581E-3</c:v>
                </c:pt>
                <c:pt idx="16">
                  <c:v>2.7183146449201519E-3</c:v>
                </c:pt>
                <c:pt idx="17">
                  <c:v>1.0193679918450605E-3</c:v>
                </c:pt>
                <c:pt idx="18">
                  <c:v>1.3591573224600705E-3</c:v>
                </c:pt>
                <c:pt idx="19">
                  <c:v>1.3591573224600705E-3</c:v>
                </c:pt>
                <c:pt idx="20">
                  <c:v>1.6989466530750901E-3</c:v>
                </c:pt>
              </c:numCache>
            </c:numRef>
          </c:val>
        </c:ser>
        <c:ser>
          <c:idx val="6"/>
          <c:order val="6"/>
          <c:tx>
            <c:strRef>
              <c:f>'unc-49 A2_0.02_5%'!$H$104</c:f>
              <c:strCache>
                <c:ptCount val="1"/>
                <c:pt idx="0">
                  <c:v>unc-49_REX_A2_07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H$105:$H$125</c:f>
              <c:numCache>
                <c:formatCode>General</c:formatCode>
                <c:ptCount val="21"/>
                <c:pt idx="1">
                  <c:v>8.9573732718894031E-2</c:v>
                </c:pt>
                <c:pt idx="2">
                  <c:v>0.12355990783410098</c:v>
                </c:pt>
                <c:pt idx="3">
                  <c:v>0.13940092165898593</c:v>
                </c:pt>
                <c:pt idx="4">
                  <c:v>0.11261520737327205</c:v>
                </c:pt>
                <c:pt idx="5">
                  <c:v>0.10397465437788003</c:v>
                </c:pt>
                <c:pt idx="6">
                  <c:v>7.632488479262671E-2</c:v>
                </c:pt>
                <c:pt idx="7">
                  <c:v>6.1347926267281104E-2</c:v>
                </c:pt>
                <c:pt idx="8">
                  <c:v>4.8099078341013804E-2</c:v>
                </c:pt>
                <c:pt idx="9">
                  <c:v>4.1186635944700518E-2</c:v>
                </c:pt>
                <c:pt idx="10">
                  <c:v>3.1970046082949316E-2</c:v>
                </c:pt>
                <c:pt idx="11">
                  <c:v>2.1601382488479336E-2</c:v>
                </c:pt>
                <c:pt idx="12">
                  <c:v>1.6705069124424002E-2</c:v>
                </c:pt>
                <c:pt idx="13">
                  <c:v>1.5552995391705104E-2</c:v>
                </c:pt>
                <c:pt idx="14">
                  <c:v>1.0656682027649795E-2</c:v>
                </c:pt>
                <c:pt idx="15">
                  <c:v>7.2004608294930919E-3</c:v>
                </c:pt>
                <c:pt idx="16">
                  <c:v>3.4562211981566809E-3</c:v>
                </c:pt>
                <c:pt idx="17">
                  <c:v>2.5921658986175111E-3</c:v>
                </c:pt>
                <c:pt idx="18">
                  <c:v>2.0161290322580601E-3</c:v>
                </c:pt>
                <c:pt idx="19">
                  <c:v>1.7281105990783409E-3</c:v>
                </c:pt>
                <c:pt idx="20">
                  <c:v>8.6405529953917132E-4</c:v>
                </c:pt>
              </c:numCache>
            </c:numRef>
          </c:val>
        </c:ser>
        <c:ser>
          <c:idx val="7"/>
          <c:order val="7"/>
          <c:tx>
            <c:strRef>
              <c:f>'unc-49 A2_0.02_5%'!$I$104</c:f>
              <c:strCache>
                <c:ptCount val="1"/>
                <c:pt idx="0">
                  <c:v>unc-49_REX_A2_08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I$105:$I$125</c:f>
              <c:numCache>
                <c:formatCode>General</c:formatCode>
                <c:ptCount val="21"/>
                <c:pt idx="1">
                  <c:v>8.9548452562151243E-2</c:v>
                </c:pt>
                <c:pt idx="2">
                  <c:v>0.10933536276002002</c:v>
                </c:pt>
                <c:pt idx="3">
                  <c:v>0.13089802130897996</c:v>
                </c:pt>
                <c:pt idx="4">
                  <c:v>0.10755961440892903</c:v>
                </c:pt>
                <c:pt idx="5">
                  <c:v>8.4221207508878695E-2</c:v>
                </c:pt>
                <c:pt idx="6">
                  <c:v>7.1790969051243048E-2</c:v>
                </c:pt>
                <c:pt idx="7">
                  <c:v>5.3018772196854386E-2</c:v>
                </c:pt>
                <c:pt idx="8">
                  <c:v>4.3378995433790001E-2</c:v>
                </c:pt>
                <c:pt idx="9">
                  <c:v>3.2217148655504818E-2</c:v>
                </c:pt>
                <c:pt idx="10">
                  <c:v>2.5621511922881798E-2</c:v>
                </c:pt>
                <c:pt idx="11">
                  <c:v>1.9025875190258813E-2</c:v>
                </c:pt>
                <c:pt idx="12">
                  <c:v>1.6235413495687506E-2</c:v>
                </c:pt>
                <c:pt idx="13">
                  <c:v>1.3698630136986301E-2</c:v>
                </c:pt>
                <c:pt idx="14">
                  <c:v>1.3444951801116201E-2</c:v>
                </c:pt>
                <c:pt idx="15">
                  <c:v>9.3860984271943206E-3</c:v>
                </c:pt>
                <c:pt idx="16">
                  <c:v>5.3272450532724502E-3</c:v>
                </c:pt>
                <c:pt idx="17">
                  <c:v>5.0735667174023336E-3</c:v>
                </c:pt>
                <c:pt idx="18">
                  <c:v>3.5514967021816318E-3</c:v>
                </c:pt>
                <c:pt idx="19">
                  <c:v>2.5367833587011707E-3</c:v>
                </c:pt>
                <c:pt idx="20">
                  <c:v>2.0294266869609317E-3</c:v>
                </c:pt>
              </c:numCache>
            </c:numRef>
          </c:val>
        </c:ser>
        <c:ser>
          <c:idx val="8"/>
          <c:order val="8"/>
          <c:tx>
            <c:strRef>
              <c:f>'unc-49 A2_0.02_5%'!$J$104</c:f>
              <c:strCache>
                <c:ptCount val="1"/>
                <c:pt idx="0">
                  <c:v>unc-49_REX_A2_09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J$105:$J$125</c:f>
              <c:numCache>
                <c:formatCode>General</c:formatCode>
                <c:ptCount val="21"/>
                <c:pt idx="1">
                  <c:v>0.10438047559449297</c:v>
                </c:pt>
                <c:pt idx="2">
                  <c:v>0.129411764705882</c:v>
                </c:pt>
                <c:pt idx="3">
                  <c:v>0.13692115143929906</c:v>
                </c:pt>
                <c:pt idx="4">
                  <c:v>0.108886107634543</c:v>
                </c:pt>
                <c:pt idx="5">
                  <c:v>8.9862327909887449E-2</c:v>
                </c:pt>
                <c:pt idx="6">
                  <c:v>6.1576971214017513E-2</c:v>
                </c:pt>
                <c:pt idx="7">
                  <c:v>4.75594493116396E-2</c:v>
                </c:pt>
                <c:pt idx="8">
                  <c:v>4.0050062578222786E-2</c:v>
                </c:pt>
                <c:pt idx="9">
                  <c:v>3.1539424280350399E-2</c:v>
                </c:pt>
                <c:pt idx="10">
                  <c:v>2.2277847309136418E-2</c:v>
                </c:pt>
                <c:pt idx="11">
                  <c:v>1.4768460575719599E-2</c:v>
                </c:pt>
                <c:pt idx="12">
                  <c:v>1.1764705882352905E-2</c:v>
                </c:pt>
                <c:pt idx="13">
                  <c:v>1.0513141426783499E-2</c:v>
                </c:pt>
                <c:pt idx="14">
                  <c:v>9.0112640801001259E-3</c:v>
                </c:pt>
                <c:pt idx="15">
                  <c:v>7.759699624530666E-3</c:v>
                </c:pt>
                <c:pt idx="16">
                  <c:v>3.5043804755944918E-3</c:v>
                </c:pt>
                <c:pt idx="17">
                  <c:v>5.0062578222778518E-3</c:v>
                </c:pt>
                <c:pt idx="18">
                  <c:v>3.0037546933667099E-3</c:v>
                </c:pt>
                <c:pt idx="19">
                  <c:v>2.2528160200250302E-3</c:v>
                </c:pt>
                <c:pt idx="20">
                  <c:v>7.5093867334167749E-4</c:v>
                </c:pt>
              </c:numCache>
            </c:numRef>
          </c:val>
        </c:ser>
        <c:ser>
          <c:idx val="9"/>
          <c:order val="9"/>
          <c:tx>
            <c:strRef>
              <c:f>'unc-49 A2_0.02_5%'!$K$104</c:f>
              <c:strCache>
                <c:ptCount val="1"/>
                <c:pt idx="0">
                  <c:v>unc-49_REX_A2_10</c:v>
                </c:pt>
              </c:strCache>
            </c:strRef>
          </c:tx>
          <c:marker>
            <c:symbol val="none"/>
          </c:marker>
          <c:cat>
            <c:numRef>
              <c:f>'unc-49 A2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2_0.02_5%'!$K$105:$K$125</c:f>
              <c:numCache>
                <c:formatCode>General</c:formatCode>
                <c:ptCount val="21"/>
                <c:pt idx="1">
                  <c:v>9.9252384635215282E-2</c:v>
                </c:pt>
                <c:pt idx="2">
                  <c:v>0.12786800721835495</c:v>
                </c:pt>
                <c:pt idx="3">
                  <c:v>0.12064965197215803</c:v>
                </c:pt>
                <c:pt idx="4">
                  <c:v>0.11394689352925999</c:v>
                </c:pt>
                <c:pt idx="5">
                  <c:v>8.8940448569218969E-2</c:v>
                </c:pt>
                <c:pt idx="6">
                  <c:v>7.8628512503222489E-2</c:v>
                </c:pt>
                <c:pt idx="7">
                  <c:v>5.64578499613302E-2</c:v>
                </c:pt>
                <c:pt idx="8">
                  <c:v>5.2333075534931738E-2</c:v>
                </c:pt>
                <c:pt idx="9">
                  <c:v>3.6091776230987402E-2</c:v>
                </c:pt>
                <c:pt idx="10">
                  <c:v>2.62954369682908E-2</c:v>
                </c:pt>
                <c:pt idx="11">
                  <c:v>1.7014694508893993E-2</c:v>
                </c:pt>
                <c:pt idx="12">
                  <c:v>1.8561484918793506E-2</c:v>
                </c:pt>
                <c:pt idx="13">
                  <c:v>1.2889920082495499E-2</c:v>
                </c:pt>
                <c:pt idx="14">
                  <c:v>1.1858726475895798E-2</c:v>
                </c:pt>
                <c:pt idx="15">
                  <c:v>6.9605568445475618E-3</c:v>
                </c:pt>
                <c:pt idx="16">
                  <c:v>6.9605568445475618E-3</c:v>
                </c:pt>
                <c:pt idx="17">
                  <c:v>3.86697602474865E-3</c:v>
                </c:pt>
                <c:pt idx="18">
                  <c:v>3.60917762309874E-3</c:v>
                </c:pt>
                <c:pt idx="19">
                  <c:v>2.06238721319928E-3</c:v>
                </c:pt>
                <c:pt idx="20">
                  <c:v>2.83578241814901E-3</c:v>
                </c:pt>
              </c:numCache>
            </c:numRef>
          </c:val>
        </c:ser>
        <c:marker val="1"/>
        <c:axId val="158905856"/>
        <c:axId val="158907392"/>
      </c:lineChart>
      <c:catAx>
        <c:axId val="158905856"/>
        <c:scaling>
          <c:orientation val="minMax"/>
        </c:scaling>
        <c:axPos val="b"/>
        <c:numFmt formatCode="#,##0.0_);\(#,##0.0\)" sourceLinked="0"/>
        <c:tickLblPos val="nextTo"/>
        <c:crossAx val="158907392"/>
        <c:crosses val="autoZero"/>
        <c:auto val="1"/>
        <c:lblAlgn val="ctr"/>
        <c:lblOffset val="100"/>
        <c:tickLblSkip val="5"/>
        <c:tickMarkSkip val="5"/>
      </c:catAx>
      <c:valAx>
        <c:axId val="15890739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8905856"/>
        <c:crosses val="autoZero"/>
        <c:crossBetween val="between"/>
      </c:valAx>
    </c:plotArea>
    <c:plotVisOnly val="1"/>
  </c:chart>
  <c:externalData r:id="rId1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A3_0.02_5%'!$B$104</c:f>
              <c:strCache>
                <c:ptCount val="1"/>
                <c:pt idx="0">
                  <c:v>unc-49_REX_A3_01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B$105:$B$125</c:f>
              <c:numCache>
                <c:formatCode>General</c:formatCode>
                <c:ptCount val="21"/>
                <c:pt idx="1">
                  <c:v>9.54930834448907E-2</c:v>
                </c:pt>
                <c:pt idx="2">
                  <c:v>0.14904060687193207</c:v>
                </c:pt>
                <c:pt idx="3">
                  <c:v>0.145470771976796</c:v>
                </c:pt>
                <c:pt idx="4">
                  <c:v>0.12271307452030303</c:v>
                </c:pt>
                <c:pt idx="5">
                  <c:v>9.6831771530566713E-2</c:v>
                </c:pt>
                <c:pt idx="6">
                  <c:v>5.622489959839358E-2</c:v>
                </c:pt>
                <c:pt idx="7">
                  <c:v>4.9531459170013413E-2</c:v>
                </c:pt>
                <c:pt idx="8">
                  <c:v>3.4805890227577012E-2</c:v>
                </c:pt>
                <c:pt idx="9">
                  <c:v>2.9451137884872816E-2</c:v>
                </c:pt>
                <c:pt idx="10">
                  <c:v>2.1865238732708601E-2</c:v>
                </c:pt>
                <c:pt idx="11">
                  <c:v>1.6956715751896501E-2</c:v>
                </c:pt>
                <c:pt idx="12">
                  <c:v>1.3386880856760404E-2</c:v>
                </c:pt>
                <c:pt idx="13">
                  <c:v>1.0263275323516305E-2</c:v>
                </c:pt>
                <c:pt idx="14">
                  <c:v>8.4783578759482486E-3</c:v>
                </c:pt>
                <c:pt idx="15">
                  <c:v>4.9085229808121435E-3</c:v>
                </c:pt>
                <c:pt idx="16">
                  <c:v>4.0160642570281095E-3</c:v>
                </c:pt>
                <c:pt idx="17">
                  <c:v>3.1236055332440902E-3</c:v>
                </c:pt>
                <c:pt idx="18">
                  <c:v>8.9245872378402604E-4</c:v>
                </c:pt>
                <c:pt idx="19">
                  <c:v>8.9245872378402604E-4</c:v>
                </c:pt>
                <c:pt idx="20">
                  <c:v>0</c:v>
                </c:pt>
              </c:numCache>
            </c:numRef>
          </c:val>
        </c:ser>
        <c:ser>
          <c:idx val="1"/>
          <c:order val="1"/>
          <c:tx>
            <c:strRef>
              <c:f>'unc-49 A3_0.02_5%'!$C$104</c:f>
              <c:strCache>
                <c:ptCount val="1"/>
                <c:pt idx="0">
                  <c:v>unc-49_REX_A3_02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C$105:$C$125</c:f>
              <c:numCache>
                <c:formatCode>General</c:formatCode>
                <c:ptCount val="21"/>
                <c:pt idx="1">
                  <c:v>0.11076130509444797</c:v>
                </c:pt>
                <c:pt idx="2">
                  <c:v>0.14167143674871197</c:v>
                </c:pt>
                <c:pt idx="3">
                  <c:v>0.15254722381225011</c:v>
                </c:pt>
                <c:pt idx="4">
                  <c:v>0.11419576416714403</c:v>
                </c:pt>
                <c:pt idx="5">
                  <c:v>8.4716657126502629E-2</c:v>
                </c:pt>
                <c:pt idx="6">
                  <c:v>5.8672009158557498E-2</c:v>
                </c:pt>
                <c:pt idx="7">
                  <c:v>5.6382369776760179E-2</c:v>
                </c:pt>
                <c:pt idx="8">
                  <c:v>3.3199771036061795E-2</c:v>
                </c:pt>
                <c:pt idx="9">
                  <c:v>2.6903262736119118E-2</c:v>
                </c:pt>
                <c:pt idx="10">
                  <c:v>1.7744705208929606E-2</c:v>
                </c:pt>
                <c:pt idx="11">
                  <c:v>1.0589582140812804E-2</c:v>
                </c:pt>
                <c:pt idx="12">
                  <c:v>1.2020606754436199E-2</c:v>
                </c:pt>
                <c:pt idx="13">
                  <c:v>7.4413279908414438E-3</c:v>
                </c:pt>
                <c:pt idx="14">
                  <c:v>7.1551230681167702E-3</c:v>
                </c:pt>
                <c:pt idx="15">
                  <c:v>4.0068689181453915E-3</c:v>
                </c:pt>
                <c:pt idx="16">
                  <c:v>1.4310246136233498E-3</c:v>
                </c:pt>
                <c:pt idx="17">
                  <c:v>5.7240984544934222E-4</c:v>
                </c:pt>
                <c:pt idx="18">
                  <c:v>1.4310246136233498E-3</c:v>
                </c:pt>
                <c:pt idx="19">
                  <c:v>8.5861476817401295E-4</c:v>
                </c:pt>
                <c:pt idx="20">
                  <c:v>2.8620492272467106E-4</c:v>
                </c:pt>
              </c:numCache>
            </c:numRef>
          </c:val>
        </c:ser>
        <c:ser>
          <c:idx val="2"/>
          <c:order val="2"/>
          <c:tx>
            <c:strRef>
              <c:f>'unc-49 A3_0.02_5%'!$D$104</c:f>
              <c:strCache>
                <c:ptCount val="1"/>
                <c:pt idx="0">
                  <c:v>unc-49_REX_A3_03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D$105:$D$125</c:f>
              <c:numCache>
                <c:formatCode>General</c:formatCode>
                <c:ptCount val="21"/>
                <c:pt idx="1">
                  <c:v>0.110148514851485</c:v>
                </c:pt>
                <c:pt idx="2">
                  <c:v>0.12871287128712899</c:v>
                </c:pt>
                <c:pt idx="3">
                  <c:v>0.12995049504950501</c:v>
                </c:pt>
                <c:pt idx="4">
                  <c:v>0.103960396039604</c:v>
                </c:pt>
                <c:pt idx="5">
                  <c:v>8.6221122112211224E-2</c:v>
                </c:pt>
                <c:pt idx="6">
                  <c:v>6.8069306930693102E-2</c:v>
                </c:pt>
                <c:pt idx="7">
                  <c:v>5.4455445544554483E-2</c:v>
                </c:pt>
                <c:pt idx="8">
                  <c:v>4.41419141914191E-2</c:v>
                </c:pt>
                <c:pt idx="9">
                  <c:v>3.176567656765681E-2</c:v>
                </c:pt>
                <c:pt idx="10">
                  <c:v>2.2689768976897715E-2</c:v>
                </c:pt>
                <c:pt idx="11">
                  <c:v>1.73267326732673E-2</c:v>
                </c:pt>
                <c:pt idx="12">
                  <c:v>1.8151815181518201E-2</c:v>
                </c:pt>
                <c:pt idx="13">
                  <c:v>1.2376237623762399E-2</c:v>
                </c:pt>
                <c:pt idx="14">
                  <c:v>6.1881188118811901E-3</c:v>
                </c:pt>
                <c:pt idx="15">
                  <c:v>6.1881188118811901E-3</c:v>
                </c:pt>
                <c:pt idx="16">
                  <c:v>4.1254125412541302E-3</c:v>
                </c:pt>
                <c:pt idx="17">
                  <c:v>2.47524752475248E-3</c:v>
                </c:pt>
                <c:pt idx="18">
                  <c:v>2.0627062706270616E-3</c:v>
                </c:pt>
                <c:pt idx="19">
                  <c:v>1.23762376237624E-3</c:v>
                </c:pt>
                <c:pt idx="20">
                  <c:v>0</c:v>
                </c:pt>
              </c:numCache>
            </c:numRef>
          </c:val>
        </c:ser>
        <c:ser>
          <c:idx val="3"/>
          <c:order val="3"/>
          <c:tx>
            <c:strRef>
              <c:f>'unc-49 A3_0.02_5%'!$E$104</c:f>
              <c:strCache>
                <c:ptCount val="1"/>
                <c:pt idx="0">
                  <c:v>unc-49_REX_A3_04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E$105:$E$125</c:f>
              <c:numCache>
                <c:formatCode>General</c:formatCode>
                <c:ptCount val="21"/>
                <c:pt idx="1">
                  <c:v>8.7154570300637738E-2</c:v>
                </c:pt>
                <c:pt idx="2">
                  <c:v>0.12632857576677795</c:v>
                </c:pt>
                <c:pt idx="3">
                  <c:v>0.12845429699362301</c:v>
                </c:pt>
                <c:pt idx="4">
                  <c:v>0.12238080777406597</c:v>
                </c:pt>
                <c:pt idx="5">
                  <c:v>9.0191314910416029E-2</c:v>
                </c:pt>
                <c:pt idx="6">
                  <c:v>7.8651685393258397E-2</c:v>
                </c:pt>
                <c:pt idx="7">
                  <c:v>5.7090798663832404E-2</c:v>
                </c:pt>
                <c:pt idx="8">
                  <c:v>4.6765866990586102E-2</c:v>
                </c:pt>
                <c:pt idx="9">
                  <c:v>3.1278469480716713E-2</c:v>
                </c:pt>
                <c:pt idx="10">
                  <c:v>3.09747950197388E-2</c:v>
                </c:pt>
                <c:pt idx="11">
                  <c:v>2.4293956878226514E-2</c:v>
                </c:pt>
                <c:pt idx="12">
                  <c:v>1.5791071970847302E-2</c:v>
                </c:pt>
                <c:pt idx="13">
                  <c:v>1.60947464318251E-2</c:v>
                </c:pt>
                <c:pt idx="14">
                  <c:v>1.2450652900091093E-2</c:v>
                </c:pt>
                <c:pt idx="15">
                  <c:v>6.3771636805344733E-3</c:v>
                </c:pt>
                <c:pt idx="16">
                  <c:v>3.6440935317339817E-3</c:v>
                </c:pt>
                <c:pt idx="17">
                  <c:v>2.1257212268448208E-3</c:v>
                </c:pt>
                <c:pt idx="18">
                  <c:v>3.9477679927118117E-3</c:v>
                </c:pt>
                <c:pt idx="19">
                  <c:v>2.4293956878226517E-3</c:v>
                </c:pt>
                <c:pt idx="20">
                  <c:v>2.1257212268448208E-3</c:v>
                </c:pt>
              </c:numCache>
            </c:numRef>
          </c:val>
        </c:ser>
        <c:ser>
          <c:idx val="4"/>
          <c:order val="4"/>
          <c:tx>
            <c:strRef>
              <c:f>'unc-49 A3_0.02_5%'!$F$104</c:f>
              <c:strCache>
                <c:ptCount val="1"/>
                <c:pt idx="0">
                  <c:v>unc-49_REX_A3_05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F$105:$F$125</c:f>
              <c:numCache>
                <c:formatCode>General</c:formatCode>
                <c:ptCount val="21"/>
                <c:pt idx="1">
                  <c:v>9.028177113283499E-2</c:v>
                </c:pt>
                <c:pt idx="2">
                  <c:v>0.13110983323749306</c:v>
                </c:pt>
                <c:pt idx="3">
                  <c:v>0.14318573893042005</c:v>
                </c:pt>
                <c:pt idx="4">
                  <c:v>0.10897067280046002</c:v>
                </c:pt>
                <c:pt idx="5">
                  <c:v>9.9194939620471531E-2</c:v>
                </c:pt>
                <c:pt idx="6">
                  <c:v>7.2167912593444503E-2</c:v>
                </c:pt>
                <c:pt idx="7">
                  <c:v>5.29039677975848E-2</c:v>
                </c:pt>
                <c:pt idx="8">
                  <c:v>4.6290971822886731E-2</c:v>
                </c:pt>
                <c:pt idx="9">
                  <c:v>4.2265669925244422E-2</c:v>
                </c:pt>
                <c:pt idx="10">
                  <c:v>2.64519838987924E-2</c:v>
                </c:pt>
                <c:pt idx="11">
                  <c:v>2.0989074180563515E-2</c:v>
                </c:pt>
                <c:pt idx="12">
                  <c:v>1.5526164462334704E-2</c:v>
                </c:pt>
                <c:pt idx="13">
                  <c:v>1.1213341000575E-2</c:v>
                </c:pt>
                <c:pt idx="14">
                  <c:v>1.2938470385278901E-2</c:v>
                </c:pt>
                <c:pt idx="15">
                  <c:v>6.0379528464634784E-3</c:v>
                </c:pt>
                <c:pt idx="16">
                  <c:v>3.162737205290402E-3</c:v>
                </c:pt>
                <c:pt idx="17">
                  <c:v>4.3128234617596318E-3</c:v>
                </c:pt>
                <c:pt idx="18">
                  <c:v>1.4376078205865408E-3</c:v>
                </c:pt>
                <c:pt idx="19">
                  <c:v>2.875215641173089E-3</c:v>
                </c:pt>
                <c:pt idx="20">
                  <c:v>3.162737205290402E-3</c:v>
                </c:pt>
              </c:numCache>
            </c:numRef>
          </c:val>
        </c:ser>
        <c:ser>
          <c:idx val="5"/>
          <c:order val="5"/>
          <c:tx>
            <c:strRef>
              <c:f>'unc-49 A3_0.02_5%'!$G$104</c:f>
              <c:strCache>
                <c:ptCount val="1"/>
                <c:pt idx="0">
                  <c:v>unc-49_REX_A3_06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G$105:$G$125</c:f>
              <c:numCache>
                <c:formatCode>General</c:formatCode>
                <c:ptCount val="21"/>
                <c:pt idx="1">
                  <c:v>9.1662351113412754E-2</c:v>
                </c:pt>
                <c:pt idx="2">
                  <c:v>0.12351113412739501</c:v>
                </c:pt>
                <c:pt idx="3">
                  <c:v>0.13775245986535506</c:v>
                </c:pt>
                <c:pt idx="4">
                  <c:v>0.11885033661315397</c:v>
                </c:pt>
                <c:pt idx="5">
                  <c:v>9.839461418953914E-2</c:v>
                </c:pt>
                <c:pt idx="6">
                  <c:v>7.8715691351631353E-2</c:v>
                </c:pt>
                <c:pt idx="7">
                  <c:v>6.4474365613671702E-2</c:v>
                </c:pt>
                <c:pt idx="8">
                  <c:v>4.0134645261522495E-2</c:v>
                </c:pt>
                <c:pt idx="9">
                  <c:v>3.5991714137752498E-2</c:v>
                </c:pt>
                <c:pt idx="10">
                  <c:v>2.8482651475919208E-2</c:v>
                </c:pt>
                <c:pt idx="11">
                  <c:v>2.2009321595028514E-2</c:v>
                </c:pt>
                <c:pt idx="12">
                  <c:v>1.7089590885551498E-2</c:v>
                </c:pt>
                <c:pt idx="13">
                  <c:v>9.5805282237182796E-3</c:v>
                </c:pt>
                <c:pt idx="14">
                  <c:v>1.00983946141895E-2</c:v>
                </c:pt>
                <c:pt idx="15">
                  <c:v>8.285862247540134E-3</c:v>
                </c:pt>
                <c:pt idx="16">
                  <c:v>4.9197307094769622E-3</c:v>
                </c:pt>
                <c:pt idx="17">
                  <c:v>4.6607975142413313E-3</c:v>
                </c:pt>
                <c:pt idx="18">
                  <c:v>1.5535991714137804E-3</c:v>
                </c:pt>
                <c:pt idx="19">
                  <c:v>2.3303987571206609E-3</c:v>
                </c:pt>
                <c:pt idx="20">
                  <c:v>2.3303987571206609E-3</c:v>
                </c:pt>
              </c:numCache>
            </c:numRef>
          </c:val>
        </c:ser>
        <c:ser>
          <c:idx val="6"/>
          <c:order val="6"/>
          <c:tx>
            <c:strRef>
              <c:f>'unc-49 A3_0.02_5%'!$H$104</c:f>
              <c:strCache>
                <c:ptCount val="1"/>
                <c:pt idx="0">
                  <c:v>unc-49_REX_A3_07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H$105:$H$125</c:f>
              <c:numCache>
                <c:formatCode>General</c:formatCode>
                <c:ptCount val="21"/>
                <c:pt idx="1">
                  <c:v>9.8927294398093071E-2</c:v>
                </c:pt>
                <c:pt idx="2">
                  <c:v>0.12097735399284895</c:v>
                </c:pt>
                <c:pt idx="3">
                  <c:v>0.1287246722288439</c:v>
                </c:pt>
                <c:pt idx="4">
                  <c:v>9.833134684147804E-2</c:v>
                </c:pt>
                <c:pt idx="5">
                  <c:v>8.5816448152562674E-2</c:v>
                </c:pt>
                <c:pt idx="6">
                  <c:v>6.0786650774731825E-2</c:v>
                </c:pt>
                <c:pt idx="7">
                  <c:v>5.3039332538736619E-2</c:v>
                </c:pt>
                <c:pt idx="8">
                  <c:v>3.9928486293206188E-2</c:v>
                </c:pt>
                <c:pt idx="9">
                  <c:v>3.7544696066746097E-2</c:v>
                </c:pt>
                <c:pt idx="10">
                  <c:v>2.9201430274135898E-2</c:v>
                </c:pt>
                <c:pt idx="11">
                  <c:v>1.6686531585220508E-2</c:v>
                </c:pt>
                <c:pt idx="12">
                  <c:v>1.5494636471990494E-2</c:v>
                </c:pt>
                <c:pt idx="13">
                  <c:v>7.7473182359952316E-3</c:v>
                </c:pt>
                <c:pt idx="14">
                  <c:v>8.9392133492252751E-3</c:v>
                </c:pt>
                <c:pt idx="15">
                  <c:v>8.9392133492252751E-3</c:v>
                </c:pt>
                <c:pt idx="16">
                  <c:v>4.1716328963051323E-3</c:v>
                </c:pt>
                <c:pt idx="17">
                  <c:v>4.7675804529201402E-3</c:v>
                </c:pt>
                <c:pt idx="18">
                  <c:v>1.19189511323004E-3</c:v>
                </c:pt>
                <c:pt idx="19">
                  <c:v>3.5756853396901101E-3</c:v>
                </c:pt>
                <c:pt idx="20">
                  <c:v>1.7878426698450505E-3</c:v>
                </c:pt>
              </c:numCache>
            </c:numRef>
          </c:val>
        </c:ser>
        <c:ser>
          <c:idx val="7"/>
          <c:order val="7"/>
          <c:tx>
            <c:strRef>
              <c:f>'unc-49 A3_0.02_5%'!$I$104</c:f>
              <c:strCache>
                <c:ptCount val="1"/>
                <c:pt idx="0">
                  <c:v>unc-49_REX_A3_08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I$105:$I$125</c:f>
              <c:numCache>
                <c:formatCode>General</c:formatCode>
                <c:ptCount val="21"/>
                <c:pt idx="1">
                  <c:v>9.7731239092495606E-2</c:v>
                </c:pt>
                <c:pt idx="2">
                  <c:v>0.12739965095986</c:v>
                </c:pt>
                <c:pt idx="3">
                  <c:v>0.13821989528795806</c:v>
                </c:pt>
                <c:pt idx="4">
                  <c:v>0.1012216404886561</c:v>
                </c:pt>
                <c:pt idx="5">
                  <c:v>9.3542757417102995E-2</c:v>
                </c:pt>
                <c:pt idx="6">
                  <c:v>9.5986038394415441E-2</c:v>
                </c:pt>
                <c:pt idx="7">
                  <c:v>7.0855148342059276E-2</c:v>
                </c:pt>
                <c:pt idx="8">
                  <c:v>4.8865619546247817E-2</c:v>
                </c:pt>
                <c:pt idx="9">
                  <c:v>3.7347294938918002E-2</c:v>
                </c:pt>
                <c:pt idx="10">
                  <c:v>3.1064572425829013E-2</c:v>
                </c:pt>
                <c:pt idx="11">
                  <c:v>1.60558464223386E-2</c:v>
                </c:pt>
                <c:pt idx="12">
                  <c:v>1.2914485165794101E-2</c:v>
                </c:pt>
                <c:pt idx="13">
                  <c:v>7.6788830715532322E-3</c:v>
                </c:pt>
                <c:pt idx="14">
                  <c:v>5.9336823734729522E-3</c:v>
                </c:pt>
                <c:pt idx="15">
                  <c:v>6.2827225130890132E-3</c:v>
                </c:pt>
                <c:pt idx="16">
                  <c:v>2.7923211169284512E-3</c:v>
                </c:pt>
                <c:pt idx="17">
                  <c:v>2.0942408376963409E-3</c:v>
                </c:pt>
                <c:pt idx="18">
                  <c:v>1.3961605584642204E-3</c:v>
                </c:pt>
                <c:pt idx="19">
                  <c:v>1.04712041884817E-3</c:v>
                </c:pt>
                <c:pt idx="20">
                  <c:v>3.4904013961605614E-4</c:v>
                </c:pt>
              </c:numCache>
            </c:numRef>
          </c:val>
        </c:ser>
        <c:ser>
          <c:idx val="8"/>
          <c:order val="8"/>
          <c:tx>
            <c:strRef>
              <c:f>'unc-49 A3_0.02_5%'!$J$104</c:f>
              <c:strCache>
                <c:ptCount val="1"/>
                <c:pt idx="0">
                  <c:v>unc-49_REX_A3_09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J$105:$J$125</c:f>
              <c:numCache>
                <c:formatCode>General</c:formatCode>
                <c:ptCount val="21"/>
                <c:pt idx="1">
                  <c:v>9.7218397135775278E-2</c:v>
                </c:pt>
                <c:pt idx="2">
                  <c:v>0.14210961167722405</c:v>
                </c:pt>
                <c:pt idx="3">
                  <c:v>0.138804736987056</c:v>
                </c:pt>
                <c:pt idx="4">
                  <c:v>0.114844395483338</c:v>
                </c:pt>
                <c:pt idx="5">
                  <c:v>9.8320022032497983E-2</c:v>
                </c:pt>
                <c:pt idx="6">
                  <c:v>7.1054805838611998E-2</c:v>
                </c:pt>
                <c:pt idx="7">
                  <c:v>5.0399339025062002E-2</c:v>
                </c:pt>
                <c:pt idx="8">
                  <c:v>4.5992839438171326E-2</c:v>
                </c:pt>
                <c:pt idx="9">
                  <c:v>3.3599559350041282E-2</c:v>
                </c:pt>
                <c:pt idx="10">
                  <c:v>2.4511153952079309E-2</c:v>
                </c:pt>
                <c:pt idx="11">
                  <c:v>1.9003029468466014E-2</c:v>
                </c:pt>
                <c:pt idx="12">
                  <c:v>1.34949049848527E-2</c:v>
                </c:pt>
                <c:pt idx="13">
                  <c:v>8.2621867254199961E-3</c:v>
                </c:pt>
                <c:pt idx="14">
                  <c:v>7.4359680528779922E-3</c:v>
                </c:pt>
                <c:pt idx="15">
                  <c:v>3.5802809143486601E-3</c:v>
                </c:pt>
                <c:pt idx="16">
                  <c:v>3.5802809143486601E-3</c:v>
                </c:pt>
                <c:pt idx="17">
                  <c:v>2.2032497934453311E-3</c:v>
                </c:pt>
                <c:pt idx="18">
                  <c:v>3.3048746901680002E-3</c:v>
                </c:pt>
                <c:pt idx="19">
                  <c:v>1.9278435692646708E-3</c:v>
                </c:pt>
                <c:pt idx="20">
                  <c:v>1.3770311209033309E-3</c:v>
                </c:pt>
              </c:numCache>
            </c:numRef>
          </c:val>
        </c:ser>
        <c:ser>
          <c:idx val="9"/>
          <c:order val="9"/>
          <c:tx>
            <c:strRef>
              <c:f>'unc-49 A3_0.02_5%'!$K$104</c:f>
              <c:strCache>
                <c:ptCount val="1"/>
                <c:pt idx="0">
                  <c:v>unc-49_REX_A3_10</c:v>
                </c:pt>
              </c:strCache>
            </c:strRef>
          </c:tx>
          <c:marker>
            <c:symbol val="none"/>
          </c:marker>
          <c:cat>
            <c:numRef>
              <c:f>'unc-49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3_0.02_5%'!$K$105:$K$125</c:f>
              <c:numCache>
                <c:formatCode>General</c:formatCode>
                <c:ptCount val="21"/>
                <c:pt idx="1">
                  <c:v>0.10738653218629503</c:v>
                </c:pt>
                <c:pt idx="2">
                  <c:v>0.14506081281518801</c:v>
                </c:pt>
                <c:pt idx="3">
                  <c:v>0.13438148917235204</c:v>
                </c:pt>
                <c:pt idx="4">
                  <c:v>0.11124295461287501</c:v>
                </c:pt>
                <c:pt idx="5">
                  <c:v>8.8994363690299713E-2</c:v>
                </c:pt>
                <c:pt idx="6">
                  <c:v>5.7846336398694714E-2</c:v>
                </c:pt>
                <c:pt idx="7">
                  <c:v>5.4286561851082826E-2</c:v>
                </c:pt>
                <c:pt idx="8">
                  <c:v>4.24206466923761E-2</c:v>
                </c:pt>
                <c:pt idx="9">
                  <c:v>3.5894393355087498E-2</c:v>
                </c:pt>
                <c:pt idx="10">
                  <c:v>2.8478196380895899E-2</c:v>
                </c:pt>
                <c:pt idx="11">
                  <c:v>1.6612281222189301E-2</c:v>
                </c:pt>
                <c:pt idx="12">
                  <c:v>1.3052506674577304E-2</c:v>
                </c:pt>
                <c:pt idx="13">
                  <c:v>8.0094927321269771E-3</c:v>
                </c:pt>
                <c:pt idx="14">
                  <c:v>5.9329575793533101E-3</c:v>
                </c:pt>
                <c:pt idx="15">
                  <c:v>5.0430139424503121E-3</c:v>
                </c:pt>
                <c:pt idx="16">
                  <c:v>5.3396618214179821E-3</c:v>
                </c:pt>
                <c:pt idx="17">
                  <c:v>8.8994363690299727E-4</c:v>
                </c:pt>
                <c:pt idx="18">
                  <c:v>3.8564224265796487E-3</c:v>
                </c:pt>
                <c:pt idx="19">
                  <c:v>1.4832393948383301E-3</c:v>
                </c:pt>
                <c:pt idx="20">
                  <c:v>1.1865915158706601E-3</c:v>
                </c:pt>
              </c:numCache>
            </c:numRef>
          </c:val>
        </c:ser>
        <c:marker val="1"/>
        <c:axId val="158983680"/>
        <c:axId val="158985216"/>
      </c:lineChart>
      <c:catAx>
        <c:axId val="158983680"/>
        <c:scaling>
          <c:orientation val="minMax"/>
        </c:scaling>
        <c:axPos val="b"/>
        <c:numFmt formatCode="0.0_ " sourceLinked="1"/>
        <c:tickLblPos val="nextTo"/>
        <c:crossAx val="158985216"/>
        <c:crosses val="autoZero"/>
        <c:auto val="1"/>
        <c:lblAlgn val="ctr"/>
        <c:lblOffset val="100"/>
        <c:tickLblSkip val="5"/>
        <c:tickMarkSkip val="5"/>
      </c:catAx>
      <c:valAx>
        <c:axId val="15898521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8983680"/>
        <c:crosses val="autoZero"/>
        <c:crossBetween val="between"/>
      </c:valAx>
    </c:plotArea>
    <c:plotVisOnly val="1"/>
  </c:chart>
  <c:externalData r:id="rId1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A5_0.02_5%'!$B$104</c:f>
              <c:strCache>
                <c:ptCount val="1"/>
                <c:pt idx="0">
                  <c:v>unc-49_A5_40_30_03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B$105:$B$125</c:f>
              <c:numCache>
                <c:formatCode>General</c:formatCode>
                <c:ptCount val="21"/>
                <c:pt idx="1">
                  <c:v>0.110406091370558</c:v>
                </c:pt>
                <c:pt idx="2">
                  <c:v>0.13959390862944199</c:v>
                </c:pt>
                <c:pt idx="3">
                  <c:v>0.121827411167513</c:v>
                </c:pt>
                <c:pt idx="4">
                  <c:v>7.8045685279187801E-2</c:v>
                </c:pt>
                <c:pt idx="5">
                  <c:v>5.2664974619289304E-2</c:v>
                </c:pt>
                <c:pt idx="6">
                  <c:v>3.9974619289340117E-2</c:v>
                </c:pt>
                <c:pt idx="7">
                  <c:v>2.9187817258883208E-2</c:v>
                </c:pt>
                <c:pt idx="8">
                  <c:v>2.1573604060913715E-2</c:v>
                </c:pt>
                <c:pt idx="9">
                  <c:v>1.5862944162436502E-2</c:v>
                </c:pt>
                <c:pt idx="10">
                  <c:v>1.2055837563451795E-2</c:v>
                </c:pt>
                <c:pt idx="11">
                  <c:v>8.2487309644670107E-3</c:v>
                </c:pt>
                <c:pt idx="12">
                  <c:v>3.8071065989847717E-3</c:v>
                </c:pt>
                <c:pt idx="13">
                  <c:v>3.8071065989847717E-3</c:v>
                </c:pt>
                <c:pt idx="14">
                  <c:v>1.9035532994923904E-3</c:v>
                </c:pt>
                <c:pt idx="15">
                  <c:v>3.8071065989847717E-3</c:v>
                </c:pt>
                <c:pt idx="16">
                  <c:v>0</c:v>
                </c:pt>
                <c:pt idx="17">
                  <c:v>0</c:v>
                </c:pt>
                <c:pt idx="18">
                  <c:v>2.538071065989851E-3</c:v>
                </c:pt>
                <c:pt idx="19">
                  <c:v>1.2690355329949201E-3</c:v>
                </c:pt>
                <c:pt idx="20">
                  <c:v>6.3451776649746231E-4</c:v>
                </c:pt>
              </c:numCache>
            </c:numRef>
          </c:val>
        </c:ser>
        <c:ser>
          <c:idx val="1"/>
          <c:order val="1"/>
          <c:tx>
            <c:strRef>
              <c:f>'unc-49 A5_0.02_5%'!$C$104</c:f>
              <c:strCache>
                <c:ptCount val="1"/>
                <c:pt idx="0">
                  <c:v>unc-49_A5_40_30_04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C$105:$C$125</c:f>
              <c:numCache>
                <c:formatCode>General</c:formatCode>
                <c:ptCount val="21"/>
                <c:pt idx="1">
                  <c:v>0.12253937007874002</c:v>
                </c:pt>
                <c:pt idx="2">
                  <c:v>0.14468503937007901</c:v>
                </c:pt>
                <c:pt idx="3">
                  <c:v>0.15600393700787407</c:v>
                </c:pt>
                <c:pt idx="4">
                  <c:v>0.11023622047244105</c:v>
                </c:pt>
                <c:pt idx="5">
                  <c:v>8.3661417322834705E-2</c:v>
                </c:pt>
                <c:pt idx="6">
                  <c:v>5.7578740157480303E-2</c:v>
                </c:pt>
                <c:pt idx="7">
                  <c:v>4.1830708661417283E-2</c:v>
                </c:pt>
                <c:pt idx="8">
                  <c:v>2.5098425196850398E-2</c:v>
                </c:pt>
                <c:pt idx="9">
                  <c:v>2.3622047244094498E-2</c:v>
                </c:pt>
                <c:pt idx="10">
                  <c:v>1.6732283464566903E-2</c:v>
                </c:pt>
                <c:pt idx="11">
                  <c:v>1.6240157480315008E-2</c:v>
                </c:pt>
                <c:pt idx="12">
                  <c:v>2.9527559055118092E-3</c:v>
                </c:pt>
                <c:pt idx="13">
                  <c:v>1.968503937007871E-3</c:v>
                </c:pt>
                <c:pt idx="14">
                  <c:v>2.9527559055118092E-3</c:v>
                </c:pt>
                <c:pt idx="15">
                  <c:v>9.8425196850393764E-4</c:v>
                </c:pt>
                <c:pt idx="16">
                  <c:v>2.9527559055118092E-3</c:v>
                </c:pt>
                <c:pt idx="17">
                  <c:v>9.8425196850393764E-4</c:v>
                </c:pt>
                <c:pt idx="18">
                  <c:v>0</c:v>
                </c:pt>
                <c:pt idx="19">
                  <c:v>4.9212598425196936E-4</c:v>
                </c:pt>
                <c:pt idx="20">
                  <c:v>0</c:v>
                </c:pt>
              </c:numCache>
            </c:numRef>
          </c:val>
        </c:ser>
        <c:ser>
          <c:idx val="2"/>
          <c:order val="2"/>
          <c:tx>
            <c:strRef>
              <c:f>'unc-49 A5_0.02_5%'!$D$104</c:f>
              <c:strCache>
                <c:ptCount val="1"/>
                <c:pt idx="0">
                  <c:v>unc-49_REX_A5_01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D$105:$D$125</c:f>
              <c:numCache>
                <c:formatCode>General</c:formatCode>
                <c:ptCount val="21"/>
                <c:pt idx="1">
                  <c:v>0.10357934748178703</c:v>
                </c:pt>
                <c:pt idx="2">
                  <c:v>0.12575229648400399</c:v>
                </c:pt>
                <c:pt idx="3">
                  <c:v>0.12670256572695596</c:v>
                </c:pt>
                <c:pt idx="4">
                  <c:v>0.10231232182451698</c:v>
                </c:pt>
                <c:pt idx="5">
                  <c:v>9.5343680709534362E-2</c:v>
                </c:pt>
                <c:pt idx="6">
                  <c:v>7.507127019322142E-2</c:v>
                </c:pt>
                <c:pt idx="7">
                  <c:v>5.8283180234399698E-2</c:v>
                </c:pt>
                <c:pt idx="8">
                  <c:v>4.7513462147608529E-2</c:v>
                </c:pt>
                <c:pt idx="9">
                  <c:v>3.7694013303769411E-2</c:v>
                </c:pt>
                <c:pt idx="10">
                  <c:v>2.4390243902439001E-2</c:v>
                </c:pt>
                <c:pt idx="11">
                  <c:v>1.8371872030408607E-2</c:v>
                </c:pt>
                <c:pt idx="12">
                  <c:v>1.4887551472917307E-2</c:v>
                </c:pt>
                <c:pt idx="13">
                  <c:v>1.2987012987013E-2</c:v>
                </c:pt>
                <c:pt idx="14">
                  <c:v>8.8691796008869266E-3</c:v>
                </c:pt>
                <c:pt idx="15">
                  <c:v>2.8508077288565111E-3</c:v>
                </c:pt>
                <c:pt idx="16">
                  <c:v>5.3848590433956314E-3</c:v>
                </c:pt>
                <c:pt idx="17">
                  <c:v>2.2172949002217312E-3</c:v>
                </c:pt>
                <c:pt idx="18">
                  <c:v>1.5837820715869509E-3</c:v>
                </c:pt>
                <c:pt idx="19">
                  <c:v>1.2670256572695595E-3</c:v>
                </c:pt>
                <c:pt idx="20">
                  <c:v>9.5026924295217076E-4</c:v>
                </c:pt>
              </c:numCache>
            </c:numRef>
          </c:val>
        </c:ser>
        <c:ser>
          <c:idx val="3"/>
          <c:order val="3"/>
          <c:tx>
            <c:strRef>
              <c:f>'unc-49 A5_0.02_5%'!$E$104</c:f>
              <c:strCache>
                <c:ptCount val="1"/>
                <c:pt idx="0">
                  <c:v>unc-49_REX_A5_02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E$105:$E$125</c:f>
              <c:numCache>
                <c:formatCode>General</c:formatCode>
                <c:ptCount val="21"/>
                <c:pt idx="1">
                  <c:v>8.7628865979381465E-2</c:v>
                </c:pt>
                <c:pt idx="2">
                  <c:v>0.128163074039363</c:v>
                </c:pt>
                <c:pt idx="3">
                  <c:v>0.13776944704779812</c:v>
                </c:pt>
                <c:pt idx="4">
                  <c:v>0.11621368322399303</c:v>
                </c:pt>
                <c:pt idx="5">
                  <c:v>0.10988753514526697</c:v>
                </c:pt>
                <c:pt idx="6">
                  <c:v>8.2942830365510783E-2</c:v>
                </c:pt>
                <c:pt idx="7">
                  <c:v>6.3495782567947495E-2</c:v>
                </c:pt>
                <c:pt idx="8">
                  <c:v>4.8734770384254895E-2</c:v>
                </c:pt>
                <c:pt idx="9">
                  <c:v>3.5613870665417116E-2</c:v>
                </c:pt>
                <c:pt idx="10">
                  <c:v>2.811621368322401E-2</c:v>
                </c:pt>
                <c:pt idx="11">
                  <c:v>1.8041237113402105E-2</c:v>
                </c:pt>
                <c:pt idx="12">
                  <c:v>1.8041237113402105E-2</c:v>
                </c:pt>
                <c:pt idx="13">
                  <c:v>1.3589503280224903E-2</c:v>
                </c:pt>
                <c:pt idx="14">
                  <c:v>8.9034676663542738E-3</c:v>
                </c:pt>
                <c:pt idx="15">
                  <c:v>5.1546391752577301E-3</c:v>
                </c:pt>
                <c:pt idx="16">
                  <c:v>2.5773195876288711E-3</c:v>
                </c:pt>
                <c:pt idx="17">
                  <c:v>2.811621368322401E-3</c:v>
                </c:pt>
                <c:pt idx="18">
                  <c:v>1.4058106841612001E-3</c:v>
                </c:pt>
                <c:pt idx="19">
                  <c:v>1.1715089034676704E-3</c:v>
                </c:pt>
                <c:pt idx="20">
                  <c:v>1.8744142455482705E-3</c:v>
                </c:pt>
              </c:numCache>
            </c:numRef>
          </c:val>
        </c:ser>
        <c:ser>
          <c:idx val="4"/>
          <c:order val="4"/>
          <c:tx>
            <c:strRef>
              <c:f>'unc-49 A5_0.02_5%'!$F$104</c:f>
              <c:strCache>
                <c:ptCount val="1"/>
                <c:pt idx="0">
                  <c:v>unc-49_REX_A5_03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F$105:$F$125</c:f>
              <c:numCache>
                <c:formatCode>General</c:formatCode>
                <c:ptCount val="21"/>
                <c:pt idx="1">
                  <c:v>0.115229885057471</c:v>
                </c:pt>
                <c:pt idx="2">
                  <c:v>0.13563218390804593</c:v>
                </c:pt>
                <c:pt idx="3">
                  <c:v>0.13505747126436801</c:v>
                </c:pt>
                <c:pt idx="4">
                  <c:v>0.10862068965517205</c:v>
                </c:pt>
                <c:pt idx="5">
                  <c:v>8.7356321839080528E-2</c:v>
                </c:pt>
                <c:pt idx="6">
                  <c:v>6.8390804597701194E-2</c:v>
                </c:pt>
                <c:pt idx="7">
                  <c:v>5.4597701149425353E-2</c:v>
                </c:pt>
                <c:pt idx="8">
                  <c:v>4.3965517241379301E-2</c:v>
                </c:pt>
                <c:pt idx="9">
                  <c:v>3.3908045977011497E-2</c:v>
                </c:pt>
                <c:pt idx="10">
                  <c:v>1.9827586206896609E-2</c:v>
                </c:pt>
                <c:pt idx="11">
                  <c:v>1.6666666666666701E-2</c:v>
                </c:pt>
                <c:pt idx="12">
                  <c:v>9.4827586206896672E-3</c:v>
                </c:pt>
                <c:pt idx="13">
                  <c:v>7.4712643678160927E-3</c:v>
                </c:pt>
                <c:pt idx="14">
                  <c:v>7.1839080459770114E-3</c:v>
                </c:pt>
                <c:pt idx="15">
                  <c:v>4.0229885057471299E-3</c:v>
                </c:pt>
                <c:pt idx="16">
                  <c:v>2.5862068965517202E-3</c:v>
                </c:pt>
                <c:pt idx="17">
                  <c:v>2.8735632183908015E-3</c:v>
                </c:pt>
                <c:pt idx="18">
                  <c:v>8.6206896551724148E-4</c:v>
                </c:pt>
                <c:pt idx="19">
                  <c:v>1.1494252873563199E-3</c:v>
                </c:pt>
                <c:pt idx="20">
                  <c:v>1.4367816091954001E-3</c:v>
                </c:pt>
              </c:numCache>
            </c:numRef>
          </c:val>
        </c:ser>
        <c:ser>
          <c:idx val="5"/>
          <c:order val="5"/>
          <c:tx>
            <c:strRef>
              <c:f>'unc-49 A5_0.02_5%'!$G$104</c:f>
              <c:strCache>
                <c:ptCount val="1"/>
                <c:pt idx="0">
                  <c:v>unc-49_REX_A5_04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G$105:$G$125</c:f>
              <c:numCache>
                <c:formatCode>General</c:formatCode>
                <c:ptCount val="21"/>
                <c:pt idx="1">
                  <c:v>9.3375394321766655E-2</c:v>
                </c:pt>
                <c:pt idx="2">
                  <c:v>0.15552050473186099</c:v>
                </c:pt>
                <c:pt idx="3">
                  <c:v>0.13470031545741307</c:v>
                </c:pt>
                <c:pt idx="4">
                  <c:v>0.11198738170346997</c:v>
                </c:pt>
                <c:pt idx="5">
                  <c:v>9.7791798107255523E-2</c:v>
                </c:pt>
                <c:pt idx="6">
                  <c:v>6.214511041009458E-2</c:v>
                </c:pt>
                <c:pt idx="7">
                  <c:v>5.1104100946372202E-2</c:v>
                </c:pt>
                <c:pt idx="8">
                  <c:v>3.9432176656151417E-2</c:v>
                </c:pt>
                <c:pt idx="9">
                  <c:v>2.996845425867509E-2</c:v>
                </c:pt>
                <c:pt idx="10">
                  <c:v>2.2712933753943208E-2</c:v>
                </c:pt>
                <c:pt idx="11">
                  <c:v>1.7034700315457403E-2</c:v>
                </c:pt>
                <c:pt idx="12">
                  <c:v>1.1671924290220804E-2</c:v>
                </c:pt>
                <c:pt idx="13">
                  <c:v>4.4164037854889631E-3</c:v>
                </c:pt>
                <c:pt idx="14">
                  <c:v>7.5709779179810718E-3</c:v>
                </c:pt>
                <c:pt idx="15">
                  <c:v>2.5236593059936902E-3</c:v>
                </c:pt>
                <c:pt idx="16">
                  <c:v>2.8391167192429009E-3</c:v>
                </c:pt>
                <c:pt idx="17">
                  <c:v>2.8391167192429009E-3</c:v>
                </c:pt>
                <c:pt idx="18">
                  <c:v>1.2618296529968499E-3</c:v>
                </c:pt>
                <c:pt idx="19">
                  <c:v>6.3091482649842341E-4</c:v>
                </c:pt>
                <c:pt idx="20">
                  <c:v>0</c:v>
                </c:pt>
              </c:numCache>
            </c:numRef>
          </c:val>
        </c:ser>
        <c:ser>
          <c:idx val="6"/>
          <c:order val="6"/>
          <c:tx>
            <c:strRef>
              <c:f>'unc-49 A5_0.02_5%'!$H$104</c:f>
              <c:strCache>
                <c:ptCount val="1"/>
                <c:pt idx="0">
                  <c:v>unc-49_REX_A5_05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H$105:$H$125</c:f>
              <c:numCache>
                <c:formatCode>General</c:formatCode>
                <c:ptCount val="21"/>
                <c:pt idx="1">
                  <c:v>9.8646723646723708E-2</c:v>
                </c:pt>
                <c:pt idx="2">
                  <c:v>0.12037037037037</c:v>
                </c:pt>
                <c:pt idx="3">
                  <c:v>0.12072649572649605</c:v>
                </c:pt>
                <c:pt idx="4">
                  <c:v>0.10470085470085502</c:v>
                </c:pt>
                <c:pt idx="5">
                  <c:v>8.11965811965812E-2</c:v>
                </c:pt>
                <c:pt idx="6">
                  <c:v>6.3390313390313424E-2</c:v>
                </c:pt>
                <c:pt idx="7">
                  <c:v>5.7336182336182318E-2</c:v>
                </c:pt>
                <c:pt idx="8">
                  <c:v>4.8076923076923114E-2</c:v>
                </c:pt>
                <c:pt idx="9">
                  <c:v>4.4159544159544199E-2</c:v>
                </c:pt>
                <c:pt idx="10">
                  <c:v>2.6353276353276407E-2</c:v>
                </c:pt>
                <c:pt idx="11">
                  <c:v>1.8874643874643892E-2</c:v>
                </c:pt>
                <c:pt idx="12">
                  <c:v>1.6025641025641E-2</c:v>
                </c:pt>
                <c:pt idx="13">
                  <c:v>1.0683760683760705E-2</c:v>
                </c:pt>
                <c:pt idx="14">
                  <c:v>6.7663817663817715E-3</c:v>
                </c:pt>
                <c:pt idx="15">
                  <c:v>9.9715099715099766E-3</c:v>
                </c:pt>
                <c:pt idx="16">
                  <c:v>5.3418803418803402E-3</c:v>
                </c:pt>
                <c:pt idx="17">
                  <c:v>4.2735042735042713E-3</c:v>
                </c:pt>
                <c:pt idx="18">
                  <c:v>2.8490028490028509E-3</c:v>
                </c:pt>
                <c:pt idx="19">
                  <c:v>1.7806267806267804E-3</c:v>
                </c:pt>
                <c:pt idx="20">
                  <c:v>1.4245014245014205E-3</c:v>
                </c:pt>
              </c:numCache>
            </c:numRef>
          </c:val>
        </c:ser>
        <c:ser>
          <c:idx val="7"/>
          <c:order val="7"/>
          <c:tx>
            <c:strRef>
              <c:f>'unc-49 A5_0.02_5%'!$I$104</c:f>
              <c:strCache>
                <c:ptCount val="1"/>
                <c:pt idx="0">
                  <c:v>unc-49_REX_A5_06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I$105:$I$125</c:f>
              <c:numCache>
                <c:formatCode>General</c:formatCode>
                <c:ptCount val="21"/>
                <c:pt idx="1">
                  <c:v>0.13924870466321199</c:v>
                </c:pt>
                <c:pt idx="2">
                  <c:v>0.14702072538860095</c:v>
                </c:pt>
                <c:pt idx="3">
                  <c:v>0.10297927461139902</c:v>
                </c:pt>
                <c:pt idx="4">
                  <c:v>9.5207253886010396E-2</c:v>
                </c:pt>
                <c:pt idx="5">
                  <c:v>5.4404145077720185E-2</c:v>
                </c:pt>
                <c:pt idx="6">
                  <c:v>3.5621761658031097E-2</c:v>
                </c:pt>
                <c:pt idx="7">
                  <c:v>3.1088082901554407E-2</c:v>
                </c:pt>
                <c:pt idx="8">
                  <c:v>2.9792746113989601E-2</c:v>
                </c:pt>
                <c:pt idx="9">
                  <c:v>3.7564766839378198E-2</c:v>
                </c:pt>
                <c:pt idx="10">
                  <c:v>2.2668393782383413E-2</c:v>
                </c:pt>
                <c:pt idx="11">
                  <c:v>1.6191709844559601E-2</c:v>
                </c:pt>
                <c:pt idx="12">
                  <c:v>1.3601036269430109E-2</c:v>
                </c:pt>
                <c:pt idx="13">
                  <c:v>1.1658031088082901E-2</c:v>
                </c:pt>
                <c:pt idx="14">
                  <c:v>5.1813471502590736E-3</c:v>
                </c:pt>
                <c:pt idx="15">
                  <c:v>5.1813471502590736E-3</c:v>
                </c:pt>
                <c:pt idx="16">
                  <c:v>1.9430051813471509E-3</c:v>
                </c:pt>
                <c:pt idx="17">
                  <c:v>1.2953367875647699E-3</c:v>
                </c:pt>
                <c:pt idx="18">
                  <c:v>1.9430051813471509E-3</c:v>
                </c:pt>
                <c:pt idx="19">
                  <c:v>1.9430051813471509E-3</c:v>
                </c:pt>
                <c:pt idx="20">
                  <c:v>6.4766839378238355E-4</c:v>
                </c:pt>
              </c:numCache>
            </c:numRef>
          </c:val>
        </c:ser>
        <c:ser>
          <c:idx val="8"/>
          <c:order val="8"/>
          <c:tx>
            <c:strRef>
              <c:f>'unc-49 A5_0.02_5%'!$J$104</c:f>
              <c:strCache>
                <c:ptCount val="1"/>
                <c:pt idx="0">
                  <c:v>unc-49_REX_A5_09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J$105:$J$125</c:f>
              <c:numCache>
                <c:formatCode>General</c:formatCode>
                <c:ptCount val="21"/>
                <c:pt idx="1">
                  <c:v>9.631391200951249E-2</c:v>
                </c:pt>
                <c:pt idx="2">
                  <c:v>0.14783987316686506</c:v>
                </c:pt>
                <c:pt idx="3">
                  <c:v>0.13040031708283806</c:v>
                </c:pt>
                <c:pt idx="4">
                  <c:v>0.11058263971462498</c:v>
                </c:pt>
                <c:pt idx="5">
                  <c:v>9.7106619104240996E-2</c:v>
                </c:pt>
                <c:pt idx="6">
                  <c:v>7.6496234641300023E-2</c:v>
                </c:pt>
                <c:pt idx="7">
                  <c:v>5.8660325009908802E-2</c:v>
                </c:pt>
                <c:pt idx="8">
                  <c:v>4.9147839873166899E-2</c:v>
                </c:pt>
                <c:pt idx="9">
                  <c:v>3.6068172810146702E-2</c:v>
                </c:pt>
                <c:pt idx="10">
                  <c:v>2.1403091557669413E-2</c:v>
                </c:pt>
                <c:pt idx="11">
                  <c:v>1.9817677368212411E-2</c:v>
                </c:pt>
                <c:pt idx="12">
                  <c:v>1.0701545778834701E-2</c:v>
                </c:pt>
                <c:pt idx="13">
                  <c:v>1.3476020610384503E-2</c:v>
                </c:pt>
                <c:pt idx="14">
                  <c:v>5.1525961157352397E-3</c:v>
                </c:pt>
                <c:pt idx="15">
                  <c:v>5.945303210463734E-3</c:v>
                </c:pt>
                <c:pt idx="16">
                  <c:v>4.3598890210067402E-3</c:v>
                </c:pt>
                <c:pt idx="17">
                  <c:v>4.3598890210067402E-3</c:v>
                </c:pt>
                <c:pt idx="18">
                  <c:v>1.1890606420927501E-3</c:v>
                </c:pt>
                <c:pt idx="19">
                  <c:v>1.1890606420927501E-3</c:v>
                </c:pt>
                <c:pt idx="2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49 A5_0.02_5%'!$K$104</c:f>
              <c:strCache>
                <c:ptCount val="1"/>
                <c:pt idx="0">
                  <c:v>unc-49_REX_A5_10</c:v>
                </c:pt>
              </c:strCache>
            </c:strRef>
          </c:tx>
          <c:marker>
            <c:symbol val="none"/>
          </c:marker>
          <c:cat>
            <c:numRef>
              <c:f>'unc-49 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49 A5_0.02_5%'!$K$105:$K$125</c:f>
              <c:numCache>
                <c:formatCode>General</c:formatCode>
                <c:ptCount val="21"/>
                <c:pt idx="1">
                  <c:v>9.4436652641421204E-2</c:v>
                </c:pt>
                <c:pt idx="2">
                  <c:v>0.15942028985507212</c:v>
                </c:pt>
                <c:pt idx="3">
                  <c:v>0.135577372604021</c:v>
                </c:pt>
                <c:pt idx="4">
                  <c:v>0.109864422627396</c:v>
                </c:pt>
                <c:pt idx="5">
                  <c:v>8.6956521739130446E-2</c:v>
                </c:pt>
                <c:pt idx="6">
                  <c:v>6.7788686302010334E-2</c:v>
                </c:pt>
                <c:pt idx="7">
                  <c:v>4.8620850864890083E-2</c:v>
                </c:pt>
                <c:pt idx="8">
                  <c:v>3.9738195418419817E-2</c:v>
                </c:pt>
                <c:pt idx="9">
                  <c:v>3.1790556334735882E-2</c:v>
                </c:pt>
                <c:pt idx="10">
                  <c:v>2.2907900888265519E-2</c:v>
                </c:pt>
                <c:pt idx="11">
                  <c:v>1.7297802711547499E-2</c:v>
                </c:pt>
                <c:pt idx="12">
                  <c:v>1.1687704534829401E-2</c:v>
                </c:pt>
                <c:pt idx="13">
                  <c:v>7.4801309022907913E-3</c:v>
                </c:pt>
                <c:pt idx="14">
                  <c:v>6.0776063581112717E-3</c:v>
                </c:pt>
                <c:pt idx="15">
                  <c:v>5.1425899953249218E-3</c:v>
                </c:pt>
                <c:pt idx="16">
                  <c:v>4.2075736325385719E-3</c:v>
                </c:pt>
                <c:pt idx="17">
                  <c:v>3.7400654511454017E-3</c:v>
                </c:pt>
                <c:pt idx="18">
                  <c:v>1.4025245441795201E-3</c:v>
                </c:pt>
                <c:pt idx="19">
                  <c:v>9.3501636278634967E-4</c:v>
                </c:pt>
                <c:pt idx="20">
                  <c:v>9.3501636278634967E-4</c:v>
                </c:pt>
              </c:numCache>
            </c:numRef>
          </c:val>
        </c:ser>
        <c:marker val="1"/>
        <c:axId val="159196672"/>
        <c:axId val="159198208"/>
      </c:lineChart>
      <c:catAx>
        <c:axId val="159196672"/>
        <c:scaling>
          <c:orientation val="minMax"/>
        </c:scaling>
        <c:axPos val="b"/>
        <c:numFmt formatCode="0.0_ " sourceLinked="1"/>
        <c:tickLblPos val="nextTo"/>
        <c:crossAx val="159198208"/>
        <c:crosses val="autoZero"/>
        <c:auto val="1"/>
        <c:lblAlgn val="ctr"/>
        <c:lblOffset val="100"/>
        <c:tickLblSkip val="5"/>
        <c:tickMarkSkip val="5"/>
      </c:catAx>
      <c:valAx>
        <c:axId val="15919820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9196672"/>
        <c:crosses val="autoZero"/>
        <c:crossBetween val="between"/>
      </c:valAx>
    </c:plotArea>
    <c:plotVisOnly val="1"/>
  </c:chart>
  <c:externalData r:id="rId1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gl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glr-1(n2461)_A3_0.02_5%'!$B$104</c:f>
              <c:strCache>
                <c:ptCount val="1"/>
                <c:pt idx="0">
                  <c:v>glr-1(n2461)_A3_01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B$105:$B$125</c:f>
              <c:numCache>
                <c:formatCode>General</c:formatCode>
                <c:ptCount val="21"/>
                <c:pt idx="1">
                  <c:v>9.2075471698113198E-2</c:v>
                </c:pt>
                <c:pt idx="2">
                  <c:v>0.113207547169811</c:v>
                </c:pt>
                <c:pt idx="3">
                  <c:v>0.14566037735849099</c:v>
                </c:pt>
                <c:pt idx="4">
                  <c:v>0.195471698113208</c:v>
                </c:pt>
                <c:pt idx="5">
                  <c:v>0.12075471698113205</c:v>
                </c:pt>
                <c:pt idx="6">
                  <c:v>6.4905660377358496E-2</c:v>
                </c:pt>
                <c:pt idx="7">
                  <c:v>5.0566037735849119E-2</c:v>
                </c:pt>
                <c:pt idx="8">
                  <c:v>3.6981132075471719E-2</c:v>
                </c:pt>
                <c:pt idx="9">
                  <c:v>2.9433962264150917E-2</c:v>
                </c:pt>
                <c:pt idx="10">
                  <c:v>2.1132075471698115E-2</c:v>
                </c:pt>
                <c:pt idx="11">
                  <c:v>1.73584905660377E-2</c:v>
                </c:pt>
                <c:pt idx="12">
                  <c:v>1.3584905660377405E-2</c:v>
                </c:pt>
                <c:pt idx="13">
                  <c:v>5.2830188679245304E-3</c:v>
                </c:pt>
                <c:pt idx="14">
                  <c:v>8.3018867924528339E-3</c:v>
                </c:pt>
                <c:pt idx="15">
                  <c:v>3.0188679245283E-3</c:v>
                </c:pt>
                <c:pt idx="16">
                  <c:v>2.2641509433962317E-3</c:v>
                </c:pt>
                <c:pt idx="17">
                  <c:v>0</c:v>
                </c:pt>
                <c:pt idx="18">
                  <c:v>1.50943396226415E-3</c:v>
                </c:pt>
                <c:pt idx="19">
                  <c:v>7.5471698113207522E-4</c:v>
                </c:pt>
                <c:pt idx="20">
                  <c:v>7.5471698113207522E-4</c:v>
                </c:pt>
              </c:numCache>
            </c:numRef>
          </c:val>
        </c:ser>
        <c:ser>
          <c:idx val="1"/>
          <c:order val="1"/>
          <c:tx>
            <c:strRef>
              <c:f>'glr-1(n2461)_A3_0.02_5%'!$C$104</c:f>
              <c:strCache>
                <c:ptCount val="1"/>
                <c:pt idx="0">
                  <c:v>glr-1(n2461)_A3_02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C$105:$C$125</c:f>
              <c:numCache>
                <c:formatCode>General</c:formatCode>
                <c:ptCount val="21"/>
                <c:pt idx="1">
                  <c:v>8.0750407830342597E-2</c:v>
                </c:pt>
                <c:pt idx="2">
                  <c:v>0.11256117455138705</c:v>
                </c:pt>
                <c:pt idx="3">
                  <c:v>0.15089722675367001</c:v>
                </c:pt>
                <c:pt idx="4">
                  <c:v>0.15742251223490997</c:v>
                </c:pt>
                <c:pt idx="5">
                  <c:v>0.14437194127243105</c:v>
                </c:pt>
                <c:pt idx="6">
                  <c:v>6.9331158238172902E-2</c:v>
                </c:pt>
                <c:pt idx="7">
                  <c:v>5.7911908646003318E-2</c:v>
                </c:pt>
                <c:pt idx="8">
                  <c:v>4.2414355628058703E-2</c:v>
                </c:pt>
                <c:pt idx="9">
                  <c:v>2.5285481239804199E-2</c:v>
                </c:pt>
                <c:pt idx="10">
                  <c:v>2.77324632952692E-2</c:v>
                </c:pt>
                <c:pt idx="11">
                  <c:v>1.5497553017944501E-2</c:v>
                </c:pt>
                <c:pt idx="12">
                  <c:v>7.3409461663947817E-3</c:v>
                </c:pt>
                <c:pt idx="13">
                  <c:v>4.8939641109298502E-3</c:v>
                </c:pt>
                <c:pt idx="14">
                  <c:v>7.3409461663947817E-3</c:v>
                </c:pt>
                <c:pt idx="15">
                  <c:v>7.3409461663947817E-3</c:v>
                </c:pt>
                <c:pt idx="16">
                  <c:v>2.4469820554649311E-3</c:v>
                </c:pt>
                <c:pt idx="17">
                  <c:v>8.1566068515497709E-4</c:v>
                </c:pt>
                <c:pt idx="18">
                  <c:v>3.262642740619901E-3</c:v>
                </c:pt>
                <c:pt idx="19">
                  <c:v>1.6313213703099498E-3</c:v>
                </c:pt>
                <c:pt idx="20">
                  <c:v>1.6313213703099498E-3</c:v>
                </c:pt>
              </c:numCache>
            </c:numRef>
          </c:val>
        </c:ser>
        <c:ser>
          <c:idx val="2"/>
          <c:order val="2"/>
          <c:tx>
            <c:strRef>
              <c:f>'glr-1(n2461)_A3_0.02_5%'!$D$104</c:f>
              <c:strCache>
                <c:ptCount val="1"/>
                <c:pt idx="0">
                  <c:v>glr-1(n2461)_A3_03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D$105:$D$125</c:f>
              <c:numCache>
                <c:formatCode>General</c:formatCode>
                <c:ptCount val="21"/>
                <c:pt idx="1">
                  <c:v>6.9421487603305826E-2</c:v>
                </c:pt>
                <c:pt idx="2">
                  <c:v>9.5867768595041356E-2</c:v>
                </c:pt>
                <c:pt idx="3">
                  <c:v>0.11404958677686</c:v>
                </c:pt>
                <c:pt idx="4">
                  <c:v>0.12396694214876003</c:v>
                </c:pt>
                <c:pt idx="5">
                  <c:v>0.1504132231404961</c:v>
                </c:pt>
                <c:pt idx="6">
                  <c:v>9.9173553719008281E-2</c:v>
                </c:pt>
                <c:pt idx="7">
                  <c:v>4.4628099173553697E-2</c:v>
                </c:pt>
                <c:pt idx="8">
                  <c:v>4.7933884297520719E-2</c:v>
                </c:pt>
                <c:pt idx="9">
                  <c:v>4.6280991735537222E-2</c:v>
                </c:pt>
                <c:pt idx="10">
                  <c:v>3.3057851239669402E-2</c:v>
                </c:pt>
                <c:pt idx="11">
                  <c:v>1.9834710743801706E-2</c:v>
                </c:pt>
                <c:pt idx="12">
                  <c:v>3.1404958677686015E-2</c:v>
                </c:pt>
                <c:pt idx="13">
                  <c:v>1.6528925619834708E-2</c:v>
                </c:pt>
                <c:pt idx="14">
                  <c:v>9.9173553719008305E-3</c:v>
                </c:pt>
                <c:pt idx="15">
                  <c:v>6.6115702479338815E-3</c:v>
                </c:pt>
                <c:pt idx="16">
                  <c:v>4.9586776859504135E-3</c:v>
                </c:pt>
                <c:pt idx="17">
                  <c:v>8.2644628099173643E-3</c:v>
                </c:pt>
                <c:pt idx="18">
                  <c:v>4.9586776859504135E-3</c:v>
                </c:pt>
                <c:pt idx="19">
                  <c:v>0</c:v>
                </c:pt>
                <c:pt idx="20">
                  <c:v>1.6528925619834713E-3</c:v>
                </c:pt>
              </c:numCache>
            </c:numRef>
          </c:val>
        </c:ser>
        <c:ser>
          <c:idx val="3"/>
          <c:order val="3"/>
          <c:tx>
            <c:strRef>
              <c:f>'glr-1(n2461)_A3_0.02_5%'!$E$104</c:f>
              <c:strCache>
                <c:ptCount val="1"/>
                <c:pt idx="0">
                  <c:v>glr-1(n2461)_A3_04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E$105:$E$125</c:f>
              <c:numCache>
                <c:formatCode>General</c:formatCode>
                <c:ptCount val="21"/>
                <c:pt idx="1">
                  <c:v>8.5889570552147201E-2</c:v>
                </c:pt>
                <c:pt idx="2">
                  <c:v>0.10276073619631899</c:v>
                </c:pt>
                <c:pt idx="3">
                  <c:v>0.11579754601227005</c:v>
                </c:pt>
                <c:pt idx="4">
                  <c:v>0.14110429447852799</c:v>
                </c:pt>
                <c:pt idx="5">
                  <c:v>0.17484662576687099</c:v>
                </c:pt>
                <c:pt idx="6">
                  <c:v>5.6748466257668703E-2</c:v>
                </c:pt>
                <c:pt idx="7">
                  <c:v>4.6779141104294479E-2</c:v>
                </c:pt>
                <c:pt idx="8">
                  <c:v>4.1411042944785301E-2</c:v>
                </c:pt>
                <c:pt idx="9">
                  <c:v>4.2177914110429413E-2</c:v>
                </c:pt>
                <c:pt idx="10">
                  <c:v>3.680981595092022E-2</c:v>
                </c:pt>
                <c:pt idx="11">
                  <c:v>2.9141104294478502E-2</c:v>
                </c:pt>
                <c:pt idx="12">
                  <c:v>2.4539877300613518E-2</c:v>
                </c:pt>
                <c:pt idx="13">
                  <c:v>9.2024539877300637E-3</c:v>
                </c:pt>
                <c:pt idx="14">
                  <c:v>6.9018404907975539E-3</c:v>
                </c:pt>
                <c:pt idx="15">
                  <c:v>8.4355828220858981E-3</c:v>
                </c:pt>
                <c:pt idx="16">
                  <c:v>8.4355828220858981E-3</c:v>
                </c:pt>
                <c:pt idx="17">
                  <c:v>3.8343558282208602E-3</c:v>
                </c:pt>
                <c:pt idx="18">
                  <c:v>2.3006134969325207E-3</c:v>
                </c:pt>
                <c:pt idx="19">
                  <c:v>2.3006134969325207E-3</c:v>
                </c:pt>
                <c:pt idx="20">
                  <c:v>7.6687116564417201E-4</c:v>
                </c:pt>
              </c:numCache>
            </c:numRef>
          </c:val>
        </c:ser>
        <c:ser>
          <c:idx val="4"/>
          <c:order val="4"/>
          <c:tx>
            <c:strRef>
              <c:f>'glr-1(n2461)_A3_0.02_5%'!$F$104</c:f>
              <c:strCache>
                <c:ptCount val="1"/>
                <c:pt idx="0">
                  <c:v>glr-1(n2461)_A3_05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F$105:$F$125</c:f>
              <c:numCache>
                <c:formatCode>General</c:formatCode>
                <c:ptCount val="21"/>
                <c:pt idx="1">
                  <c:v>6.9696969696969702E-2</c:v>
                </c:pt>
                <c:pt idx="2">
                  <c:v>0.100757575757576</c:v>
                </c:pt>
                <c:pt idx="3">
                  <c:v>0.112878787878788</c:v>
                </c:pt>
                <c:pt idx="4">
                  <c:v>0.145454545454545</c:v>
                </c:pt>
                <c:pt idx="5">
                  <c:v>0.16136363636363593</c:v>
                </c:pt>
                <c:pt idx="6">
                  <c:v>6.74242424242424E-2</c:v>
                </c:pt>
                <c:pt idx="7">
                  <c:v>4.9242424242424226E-2</c:v>
                </c:pt>
                <c:pt idx="8">
                  <c:v>0.05</c:v>
                </c:pt>
                <c:pt idx="9">
                  <c:v>3.6363636363636397E-2</c:v>
                </c:pt>
                <c:pt idx="10">
                  <c:v>3.4848484848484886E-2</c:v>
                </c:pt>
                <c:pt idx="11">
                  <c:v>3.1818181818181801E-2</c:v>
                </c:pt>
                <c:pt idx="12">
                  <c:v>2.3484848484848515E-2</c:v>
                </c:pt>
                <c:pt idx="13">
                  <c:v>1.2878787878787899E-2</c:v>
                </c:pt>
                <c:pt idx="14">
                  <c:v>8.3333333333333297E-3</c:v>
                </c:pt>
                <c:pt idx="15">
                  <c:v>1.2121212121212099E-2</c:v>
                </c:pt>
                <c:pt idx="16">
                  <c:v>4.5454545454545504E-3</c:v>
                </c:pt>
                <c:pt idx="17">
                  <c:v>3.0303030303030299E-3</c:v>
                </c:pt>
                <c:pt idx="18">
                  <c:v>3.7878787878787919E-3</c:v>
                </c:pt>
                <c:pt idx="19">
                  <c:v>6.8181818181818196E-3</c:v>
                </c:pt>
                <c:pt idx="20">
                  <c:v>1.5151515151515208E-3</c:v>
                </c:pt>
              </c:numCache>
            </c:numRef>
          </c:val>
        </c:ser>
        <c:ser>
          <c:idx val="5"/>
          <c:order val="5"/>
          <c:tx>
            <c:strRef>
              <c:f>'glr-1(n2461)_A3_0.02_5%'!$G$104</c:f>
              <c:strCache>
                <c:ptCount val="1"/>
                <c:pt idx="0">
                  <c:v>glr-1(n2461)_A3_06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G$105:$G$125</c:f>
              <c:numCache>
                <c:formatCode>General</c:formatCode>
                <c:ptCount val="21"/>
                <c:pt idx="1">
                  <c:v>8.7827426810477727E-2</c:v>
                </c:pt>
                <c:pt idx="2">
                  <c:v>0.105546995377504</c:v>
                </c:pt>
                <c:pt idx="3">
                  <c:v>0.11710323574730402</c:v>
                </c:pt>
                <c:pt idx="4">
                  <c:v>0.19876733436055499</c:v>
                </c:pt>
                <c:pt idx="5">
                  <c:v>0.14483821263482299</c:v>
                </c:pt>
                <c:pt idx="6">
                  <c:v>5.8551617873651804E-2</c:v>
                </c:pt>
                <c:pt idx="7">
                  <c:v>4.0832049306625623E-2</c:v>
                </c:pt>
                <c:pt idx="8">
                  <c:v>3.6209553158705714E-2</c:v>
                </c:pt>
                <c:pt idx="9">
                  <c:v>4.0832049306625623E-2</c:v>
                </c:pt>
                <c:pt idx="10">
                  <c:v>2.542372881355931E-2</c:v>
                </c:pt>
                <c:pt idx="11">
                  <c:v>2.6194144838212592E-2</c:v>
                </c:pt>
                <c:pt idx="12">
                  <c:v>1.3867488443759604E-2</c:v>
                </c:pt>
                <c:pt idx="13">
                  <c:v>1.1556240369799698E-2</c:v>
                </c:pt>
                <c:pt idx="14">
                  <c:v>1.1556240369799698E-2</c:v>
                </c:pt>
                <c:pt idx="15">
                  <c:v>5.3929121725731916E-3</c:v>
                </c:pt>
                <c:pt idx="16">
                  <c:v>3.0816640986132508E-3</c:v>
                </c:pt>
                <c:pt idx="17">
                  <c:v>3.0816640986132508E-3</c:v>
                </c:pt>
                <c:pt idx="18">
                  <c:v>1.5408320493066308E-3</c:v>
                </c:pt>
                <c:pt idx="19">
                  <c:v>2.311248073959939E-3</c:v>
                </c:pt>
                <c:pt idx="20">
                  <c:v>7.7041602465331325E-4</c:v>
                </c:pt>
              </c:numCache>
            </c:numRef>
          </c:val>
        </c:ser>
        <c:ser>
          <c:idx val="6"/>
          <c:order val="6"/>
          <c:tx>
            <c:strRef>
              <c:f>'glr-1(n2461)_A3_0.02_5%'!$H$104</c:f>
              <c:strCache>
                <c:ptCount val="1"/>
                <c:pt idx="0">
                  <c:v>glr-1(n2461)_A3_07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H$105:$H$125</c:f>
              <c:numCache>
                <c:formatCode>General</c:formatCode>
                <c:ptCount val="21"/>
                <c:pt idx="1">
                  <c:v>8.660785886126704E-2</c:v>
                </c:pt>
                <c:pt idx="2">
                  <c:v>0.10665597433841204</c:v>
                </c:pt>
                <c:pt idx="3">
                  <c:v>0.14434643143544515</c:v>
                </c:pt>
                <c:pt idx="4">
                  <c:v>0.19727345629510801</c:v>
                </c:pt>
                <c:pt idx="5">
                  <c:v>0.13712910986367297</c:v>
                </c:pt>
                <c:pt idx="6">
                  <c:v>5.7738572574177985E-2</c:v>
                </c:pt>
                <c:pt idx="7">
                  <c:v>4.5709703287890896E-2</c:v>
                </c:pt>
                <c:pt idx="8">
                  <c:v>4.0096230954290345E-2</c:v>
                </c:pt>
                <c:pt idx="9">
                  <c:v>3.7690457097032899E-2</c:v>
                </c:pt>
                <c:pt idx="10">
                  <c:v>2.9671210906174819E-2</c:v>
                </c:pt>
                <c:pt idx="11">
                  <c:v>2.004811547714512E-2</c:v>
                </c:pt>
                <c:pt idx="12">
                  <c:v>1.4434643143544494E-2</c:v>
                </c:pt>
                <c:pt idx="13">
                  <c:v>6.41539695268645E-3</c:v>
                </c:pt>
                <c:pt idx="14">
                  <c:v>3.2076984763432202E-3</c:v>
                </c:pt>
                <c:pt idx="15">
                  <c:v>4.8115477145148433E-3</c:v>
                </c:pt>
                <c:pt idx="16">
                  <c:v>4.8115477145148433E-3</c:v>
                </c:pt>
                <c:pt idx="17">
                  <c:v>8.0192461908580647E-4</c:v>
                </c:pt>
                <c:pt idx="18">
                  <c:v>1.6038492381716101E-3</c:v>
                </c:pt>
                <c:pt idx="19">
                  <c:v>0</c:v>
                </c:pt>
                <c:pt idx="20">
                  <c:v>1.6038492381716101E-3</c:v>
                </c:pt>
              </c:numCache>
            </c:numRef>
          </c:val>
        </c:ser>
        <c:ser>
          <c:idx val="7"/>
          <c:order val="7"/>
          <c:tx>
            <c:strRef>
              <c:f>'glr-1(n2461)_A3_0.02_5%'!$I$104</c:f>
              <c:strCache>
                <c:ptCount val="1"/>
                <c:pt idx="0">
                  <c:v>glr-1(n2461)_A3_08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I$105:$I$125</c:f>
              <c:numCache>
                <c:formatCode>General</c:formatCode>
                <c:ptCount val="21"/>
                <c:pt idx="1">
                  <c:v>8.8930936613055803E-2</c:v>
                </c:pt>
                <c:pt idx="2">
                  <c:v>0.10974456007568606</c:v>
                </c:pt>
                <c:pt idx="3">
                  <c:v>0.13623462630085095</c:v>
                </c:pt>
                <c:pt idx="4">
                  <c:v>0.13718070009460695</c:v>
                </c:pt>
                <c:pt idx="5">
                  <c:v>0.165562913907285</c:v>
                </c:pt>
                <c:pt idx="6">
                  <c:v>5.2034058656575198E-2</c:v>
                </c:pt>
                <c:pt idx="7">
                  <c:v>3.7842951750236498E-2</c:v>
                </c:pt>
                <c:pt idx="8">
                  <c:v>3.1220435193945101E-2</c:v>
                </c:pt>
                <c:pt idx="9">
                  <c:v>3.5950804162724698E-2</c:v>
                </c:pt>
                <c:pt idx="10">
                  <c:v>3.3112582781456998E-2</c:v>
                </c:pt>
                <c:pt idx="11">
                  <c:v>2.3651844843897797E-2</c:v>
                </c:pt>
                <c:pt idx="12">
                  <c:v>1.8921475875118311E-2</c:v>
                </c:pt>
                <c:pt idx="13">
                  <c:v>1.4191106906338699E-2</c:v>
                </c:pt>
                <c:pt idx="14">
                  <c:v>1.0406811731315007E-2</c:v>
                </c:pt>
                <c:pt idx="15">
                  <c:v>4.7303689687795622E-3</c:v>
                </c:pt>
                <c:pt idx="16">
                  <c:v>5.6764427625354821E-3</c:v>
                </c:pt>
                <c:pt idx="17">
                  <c:v>6.6225165562913864E-3</c:v>
                </c:pt>
                <c:pt idx="18">
                  <c:v>3.784295175023651E-3</c:v>
                </c:pt>
                <c:pt idx="19">
                  <c:v>5.6764427625354821E-3</c:v>
                </c:pt>
                <c:pt idx="20">
                  <c:v>9.4607379375591383E-4</c:v>
                </c:pt>
              </c:numCache>
            </c:numRef>
          </c:val>
        </c:ser>
        <c:ser>
          <c:idx val="8"/>
          <c:order val="8"/>
          <c:tx>
            <c:strRef>
              <c:f>'glr-1(n2461)_A3_0.02_5%'!$J$104</c:f>
              <c:strCache>
                <c:ptCount val="1"/>
                <c:pt idx="0">
                  <c:v>glr-1(n2461)_A3_09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J$105:$J$125</c:f>
              <c:numCache>
                <c:formatCode>General</c:formatCode>
                <c:ptCount val="21"/>
                <c:pt idx="1">
                  <c:v>8.0762250453720513E-2</c:v>
                </c:pt>
                <c:pt idx="2">
                  <c:v>0.11070780399273998</c:v>
                </c:pt>
                <c:pt idx="3">
                  <c:v>0.12885662431941888</c:v>
                </c:pt>
                <c:pt idx="4">
                  <c:v>0.16969147005444599</c:v>
                </c:pt>
                <c:pt idx="5">
                  <c:v>0.12976406533575294</c:v>
                </c:pt>
                <c:pt idx="6">
                  <c:v>6.261343012704175E-2</c:v>
                </c:pt>
                <c:pt idx="7">
                  <c:v>4.5372050816696929E-2</c:v>
                </c:pt>
                <c:pt idx="8">
                  <c:v>3.1760435571687798E-2</c:v>
                </c:pt>
                <c:pt idx="9">
                  <c:v>3.9019963702359314E-2</c:v>
                </c:pt>
                <c:pt idx="10">
                  <c:v>3.1760435571687798E-2</c:v>
                </c:pt>
                <c:pt idx="11">
                  <c:v>1.7241379310344803E-2</c:v>
                </c:pt>
                <c:pt idx="12">
                  <c:v>1.8148820326678809E-2</c:v>
                </c:pt>
                <c:pt idx="13">
                  <c:v>1.2704174228675109E-2</c:v>
                </c:pt>
                <c:pt idx="14">
                  <c:v>7.259528130671513E-3</c:v>
                </c:pt>
                <c:pt idx="15">
                  <c:v>8.1669691470054439E-3</c:v>
                </c:pt>
                <c:pt idx="16">
                  <c:v>4.5372050816696935E-3</c:v>
                </c:pt>
                <c:pt idx="17">
                  <c:v>7.259528130671513E-3</c:v>
                </c:pt>
                <c:pt idx="18">
                  <c:v>1.8148820326678809E-3</c:v>
                </c:pt>
                <c:pt idx="19">
                  <c:v>9.0744101633393837E-4</c:v>
                </c:pt>
                <c:pt idx="20">
                  <c:v>2.7223230490018117E-3</c:v>
                </c:pt>
              </c:numCache>
            </c:numRef>
          </c:val>
        </c:ser>
        <c:ser>
          <c:idx val="9"/>
          <c:order val="9"/>
          <c:tx>
            <c:strRef>
              <c:f>'glr-1(n2461)_A3_0.02_5%'!$K$104</c:f>
              <c:strCache>
                <c:ptCount val="1"/>
                <c:pt idx="0">
                  <c:v>glr-1(n2461)_A3_10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K$105:$K$125</c:f>
              <c:numCache>
                <c:formatCode>General</c:formatCode>
                <c:ptCount val="21"/>
                <c:pt idx="1">
                  <c:v>9.5607235142118926E-2</c:v>
                </c:pt>
                <c:pt idx="2">
                  <c:v>0.10766580534022405</c:v>
                </c:pt>
                <c:pt idx="3">
                  <c:v>0.12489233419465999</c:v>
                </c:pt>
                <c:pt idx="4">
                  <c:v>0.15934539190353106</c:v>
                </c:pt>
                <c:pt idx="5">
                  <c:v>0.16106804478897499</c:v>
                </c:pt>
                <c:pt idx="6">
                  <c:v>6.5460809646856202E-2</c:v>
                </c:pt>
                <c:pt idx="7">
                  <c:v>4.0482342807924197E-2</c:v>
                </c:pt>
                <c:pt idx="8">
                  <c:v>3.2730404823428101E-2</c:v>
                </c:pt>
                <c:pt idx="9">
                  <c:v>2.8423772609819119E-2</c:v>
                </c:pt>
                <c:pt idx="10">
                  <c:v>2.9285099052540908E-2</c:v>
                </c:pt>
                <c:pt idx="11">
                  <c:v>1.6365202411714002E-2</c:v>
                </c:pt>
                <c:pt idx="12">
                  <c:v>1.5503875968992208E-2</c:v>
                </c:pt>
                <c:pt idx="13">
                  <c:v>1.1197243755383298E-2</c:v>
                </c:pt>
                <c:pt idx="14">
                  <c:v>1.2058570198105105E-2</c:v>
                </c:pt>
                <c:pt idx="15">
                  <c:v>3.4453057708871719E-3</c:v>
                </c:pt>
                <c:pt idx="16">
                  <c:v>6.0292850990525419E-3</c:v>
                </c:pt>
                <c:pt idx="17">
                  <c:v>2.5839793281653726E-3</c:v>
                </c:pt>
                <c:pt idx="18">
                  <c:v>4.3066322136089599E-3</c:v>
                </c:pt>
                <c:pt idx="19">
                  <c:v>8.6132644272179221E-4</c:v>
                </c:pt>
                <c:pt idx="20">
                  <c:v>1.7226528854435805E-3</c:v>
                </c:pt>
              </c:numCache>
            </c:numRef>
          </c:val>
        </c:ser>
        <c:ser>
          <c:idx val="10"/>
          <c:order val="10"/>
          <c:tx>
            <c:strRef>
              <c:f>'glr-1(n2461)_A3_0.02_5%'!$L$104</c:f>
              <c:strCache>
                <c:ptCount val="1"/>
                <c:pt idx="0">
                  <c:v>glr-1(n2461)_A3_11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L$105:$L$125</c:f>
              <c:numCache>
                <c:formatCode>General</c:formatCode>
                <c:ptCount val="21"/>
                <c:pt idx="1">
                  <c:v>7.8414096916299594E-2</c:v>
                </c:pt>
                <c:pt idx="2">
                  <c:v>9.8678414096916328E-2</c:v>
                </c:pt>
                <c:pt idx="3">
                  <c:v>0.11365638766519801</c:v>
                </c:pt>
                <c:pt idx="4">
                  <c:v>0.126872246696035</c:v>
                </c:pt>
                <c:pt idx="5">
                  <c:v>0.13215859030836993</c:v>
                </c:pt>
                <c:pt idx="6">
                  <c:v>7.0484581497797419E-2</c:v>
                </c:pt>
                <c:pt idx="7">
                  <c:v>5.8149779735682777E-2</c:v>
                </c:pt>
                <c:pt idx="8">
                  <c:v>3.8766519823788488E-2</c:v>
                </c:pt>
                <c:pt idx="9">
                  <c:v>3.7885462555066113E-2</c:v>
                </c:pt>
                <c:pt idx="10">
                  <c:v>3.7004405286343613E-2</c:v>
                </c:pt>
                <c:pt idx="11">
                  <c:v>3.1718061674008799E-2</c:v>
                </c:pt>
                <c:pt idx="12">
                  <c:v>2.2026431718061693E-2</c:v>
                </c:pt>
                <c:pt idx="13">
                  <c:v>1.3215859030837008E-2</c:v>
                </c:pt>
                <c:pt idx="14">
                  <c:v>1.7621145374449299E-2</c:v>
                </c:pt>
                <c:pt idx="15">
                  <c:v>1.4096916299559498E-2</c:v>
                </c:pt>
                <c:pt idx="16">
                  <c:v>8.8105726872246739E-3</c:v>
                </c:pt>
                <c:pt idx="17">
                  <c:v>9.6916299559471446E-3</c:v>
                </c:pt>
                <c:pt idx="18">
                  <c:v>7.0484581497797421E-3</c:v>
                </c:pt>
                <c:pt idx="19">
                  <c:v>8.8105726872246739E-3</c:v>
                </c:pt>
                <c:pt idx="20">
                  <c:v>2.6431718061674029E-3</c:v>
                </c:pt>
              </c:numCache>
            </c:numRef>
          </c:val>
        </c:ser>
        <c:ser>
          <c:idx val="11"/>
          <c:order val="11"/>
          <c:tx>
            <c:strRef>
              <c:f>'glr-1(n2461)_A3_0.02_5%'!$M$104</c:f>
              <c:strCache>
                <c:ptCount val="1"/>
                <c:pt idx="0">
                  <c:v>glr-1(n2461)_A3_12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M$105:$M$125</c:f>
              <c:numCache>
                <c:formatCode>General</c:formatCode>
                <c:ptCount val="21"/>
                <c:pt idx="1">
                  <c:v>7.0844686648501423E-2</c:v>
                </c:pt>
                <c:pt idx="2">
                  <c:v>0.10717529518619404</c:v>
                </c:pt>
                <c:pt idx="3">
                  <c:v>0.11171662125340605</c:v>
                </c:pt>
                <c:pt idx="4">
                  <c:v>0.143505903723887</c:v>
                </c:pt>
                <c:pt idx="5">
                  <c:v>0.14259763851044507</c:v>
                </c:pt>
                <c:pt idx="6">
                  <c:v>6.6303360581289703E-2</c:v>
                </c:pt>
                <c:pt idx="7">
                  <c:v>5.4495912806539523E-2</c:v>
                </c:pt>
                <c:pt idx="8">
                  <c:v>4.8138056312443216E-2</c:v>
                </c:pt>
                <c:pt idx="9">
                  <c:v>3.2697547683923744E-2</c:v>
                </c:pt>
                <c:pt idx="10">
                  <c:v>3.7238873751135312E-2</c:v>
                </c:pt>
                <c:pt idx="11">
                  <c:v>2.9972752043596701E-2</c:v>
                </c:pt>
                <c:pt idx="12">
                  <c:v>2.179836512261581E-2</c:v>
                </c:pt>
                <c:pt idx="13">
                  <c:v>1.5440508628519509E-2</c:v>
                </c:pt>
                <c:pt idx="14">
                  <c:v>1.18074477747502E-2</c:v>
                </c:pt>
                <c:pt idx="15">
                  <c:v>9.9909173478655838E-3</c:v>
                </c:pt>
                <c:pt idx="16">
                  <c:v>6.3578564940962815E-3</c:v>
                </c:pt>
                <c:pt idx="17">
                  <c:v>2.7247956403269819E-3</c:v>
                </c:pt>
                <c:pt idx="18">
                  <c:v>4.5413260672116321E-3</c:v>
                </c:pt>
                <c:pt idx="19">
                  <c:v>2.7247956403269819E-3</c:v>
                </c:pt>
                <c:pt idx="20">
                  <c:v>1.8165304268846505E-3</c:v>
                </c:pt>
              </c:numCache>
            </c:numRef>
          </c:val>
        </c:ser>
        <c:ser>
          <c:idx val="12"/>
          <c:order val="12"/>
          <c:tx>
            <c:strRef>
              <c:f>'glr-1(n2461)_A3_0.02_5%'!$N$104</c:f>
              <c:strCache>
                <c:ptCount val="1"/>
                <c:pt idx="0">
                  <c:v>glr-1(n2461)_A3_13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N$105:$N$125</c:f>
              <c:numCache>
                <c:formatCode>General</c:formatCode>
                <c:ptCount val="21"/>
                <c:pt idx="1">
                  <c:v>8.8450292397660876E-2</c:v>
                </c:pt>
                <c:pt idx="2">
                  <c:v>0.105263157894737</c:v>
                </c:pt>
                <c:pt idx="3">
                  <c:v>0.13230994152046807</c:v>
                </c:pt>
                <c:pt idx="4">
                  <c:v>0.16154970760233905</c:v>
                </c:pt>
                <c:pt idx="5">
                  <c:v>0.17909356725146205</c:v>
                </c:pt>
                <c:pt idx="6">
                  <c:v>7.2368421052631651E-2</c:v>
                </c:pt>
                <c:pt idx="7">
                  <c:v>5.1900584795321621E-2</c:v>
                </c:pt>
                <c:pt idx="8">
                  <c:v>4.0204678362573083E-2</c:v>
                </c:pt>
                <c:pt idx="9">
                  <c:v>3.5087719298245605E-2</c:v>
                </c:pt>
                <c:pt idx="10">
                  <c:v>2.7046783625731007E-2</c:v>
                </c:pt>
                <c:pt idx="11">
                  <c:v>1.2426900584795298E-2</c:v>
                </c:pt>
                <c:pt idx="12">
                  <c:v>1.2426900584795298E-2</c:v>
                </c:pt>
                <c:pt idx="13">
                  <c:v>7.3099415204678419E-3</c:v>
                </c:pt>
                <c:pt idx="14">
                  <c:v>5.8479532163742704E-3</c:v>
                </c:pt>
                <c:pt idx="15">
                  <c:v>3.6549707602339218E-3</c:v>
                </c:pt>
                <c:pt idx="16">
                  <c:v>4.3859649122806998E-3</c:v>
                </c:pt>
                <c:pt idx="17">
                  <c:v>0</c:v>
                </c:pt>
                <c:pt idx="18">
                  <c:v>2.1929824561403499E-3</c:v>
                </c:pt>
                <c:pt idx="19">
                  <c:v>7.3099415204678424E-4</c:v>
                </c:pt>
                <c:pt idx="2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glr-1(n2461)_A3_0.02_5%'!$O$104</c:f>
              <c:strCache>
                <c:ptCount val="1"/>
                <c:pt idx="0">
                  <c:v>glr-1(n2461)_A3_14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O$105:$O$125</c:f>
              <c:numCache>
                <c:formatCode>General</c:formatCode>
                <c:ptCount val="21"/>
                <c:pt idx="1">
                  <c:v>6.4829821717990302E-2</c:v>
                </c:pt>
                <c:pt idx="2">
                  <c:v>0.12155591572123205</c:v>
                </c:pt>
                <c:pt idx="3">
                  <c:v>0.12317666126418206</c:v>
                </c:pt>
                <c:pt idx="4">
                  <c:v>9.4003241491085895E-2</c:v>
                </c:pt>
                <c:pt idx="5">
                  <c:v>7.4554294975688828E-2</c:v>
                </c:pt>
                <c:pt idx="6">
                  <c:v>5.5105348460291678E-2</c:v>
                </c:pt>
                <c:pt idx="7">
                  <c:v>5.3484602917342021E-2</c:v>
                </c:pt>
                <c:pt idx="8">
                  <c:v>4.2139384116693719E-2</c:v>
                </c:pt>
                <c:pt idx="9">
                  <c:v>3.8897893030794203E-2</c:v>
                </c:pt>
                <c:pt idx="10">
                  <c:v>3.5656401944894701E-2</c:v>
                </c:pt>
                <c:pt idx="11">
                  <c:v>3.07941653160454E-2</c:v>
                </c:pt>
                <c:pt idx="12">
                  <c:v>1.7828200972447299E-2</c:v>
                </c:pt>
                <c:pt idx="13">
                  <c:v>1.9448946515397102E-2</c:v>
                </c:pt>
                <c:pt idx="14">
                  <c:v>2.4311183144246393E-2</c:v>
                </c:pt>
                <c:pt idx="15">
                  <c:v>2.4311183144246393E-2</c:v>
                </c:pt>
                <c:pt idx="16">
                  <c:v>2.1069692058346801E-2</c:v>
                </c:pt>
                <c:pt idx="17">
                  <c:v>1.7828200972447299E-2</c:v>
                </c:pt>
                <c:pt idx="18">
                  <c:v>8.1037277147487808E-3</c:v>
                </c:pt>
                <c:pt idx="19">
                  <c:v>1.2965964343598101E-2</c:v>
                </c:pt>
                <c:pt idx="20">
                  <c:v>2.2690437601296607E-2</c:v>
                </c:pt>
              </c:numCache>
            </c:numRef>
          </c:val>
        </c:ser>
        <c:ser>
          <c:idx val="14"/>
          <c:order val="14"/>
          <c:tx>
            <c:strRef>
              <c:f>'glr-1(n2461)_A3_0.02_5%'!$P$104</c:f>
              <c:strCache>
                <c:ptCount val="1"/>
                <c:pt idx="0">
                  <c:v>glr-1(n2461)_A3_15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P$105:$P$125</c:f>
              <c:numCache>
                <c:formatCode>General</c:formatCode>
                <c:ptCount val="21"/>
                <c:pt idx="1">
                  <c:v>7.9169869331283629E-2</c:v>
                </c:pt>
                <c:pt idx="2">
                  <c:v>0.10069177555726404</c:v>
                </c:pt>
                <c:pt idx="3">
                  <c:v>0.12067640276710204</c:v>
                </c:pt>
                <c:pt idx="4">
                  <c:v>0.12836279784780899</c:v>
                </c:pt>
                <c:pt idx="5">
                  <c:v>0.16525749423520406</c:v>
                </c:pt>
                <c:pt idx="6">
                  <c:v>9.3774019984627255E-2</c:v>
                </c:pt>
                <c:pt idx="7">
                  <c:v>5.5342044581091501E-2</c:v>
                </c:pt>
                <c:pt idx="8">
                  <c:v>4.5349730976172203E-2</c:v>
                </c:pt>
                <c:pt idx="9">
                  <c:v>2.9208301306687199E-2</c:v>
                </c:pt>
                <c:pt idx="10">
                  <c:v>2.6902382782475018E-2</c:v>
                </c:pt>
                <c:pt idx="11">
                  <c:v>3.1514219830899297E-2</c:v>
                </c:pt>
                <c:pt idx="12">
                  <c:v>2.84396617986164E-2</c:v>
                </c:pt>
                <c:pt idx="13">
                  <c:v>1.6910069177555703E-2</c:v>
                </c:pt>
                <c:pt idx="14">
                  <c:v>1.3835511145272905E-2</c:v>
                </c:pt>
                <c:pt idx="15">
                  <c:v>4.6118370484242895E-3</c:v>
                </c:pt>
                <c:pt idx="16">
                  <c:v>4.6118370484242895E-3</c:v>
                </c:pt>
                <c:pt idx="17">
                  <c:v>4.6118370484242895E-3</c:v>
                </c:pt>
                <c:pt idx="18">
                  <c:v>4.6118370484242895E-3</c:v>
                </c:pt>
                <c:pt idx="19">
                  <c:v>3.0745580322828602E-3</c:v>
                </c:pt>
                <c:pt idx="20">
                  <c:v>1.5372790161414301E-3</c:v>
                </c:pt>
              </c:numCache>
            </c:numRef>
          </c:val>
        </c:ser>
        <c:ser>
          <c:idx val="15"/>
          <c:order val="15"/>
          <c:tx>
            <c:strRef>
              <c:f>'glr-1(n2461)_A3_0.02_5%'!$Q$104</c:f>
              <c:strCache>
                <c:ptCount val="1"/>
                <c:pt idx="0">
                  <c:v>glr-1(n2461)_A3_16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Q$105:$Q$125</c:f>
              <c:numCache>
                <c:formatCode>General</c:formatCode>
                <c:ptCount val="21"/>
                <c:pt idx="1">
                  <c:v>7.8228086710650305E-2</c:v>
                </c:pt>
                <c:pt idx="2">
                  <c:v>0.13289349670122508</c:v>
                </c:pt>
                <c:pt idx="3">
                  <c:v>0.15928369462771005</c:v>
                </c:pt>
                <c:pt idx="4">
                  <c:v>0.153628652214892</c:v>
                </c:pt>
                <c:pt idx="5">
                  <c:v>0.12441093308199802</c:v>
                </c:pt>
                <c:pt idx="6">
                  <c:v>7.0688030160226234E-2</c:v>
                </c:pt>
                <c:pt idx="7">
                  <c:v>5.2780395852968919E-2</c:v>
                </c:pt>
                <c:pt idx="8">
                  <c:v>3.3930254476908603E-2</c:v>
                </c:pt>
                <c:pt idx="9">
                  <c:v>3.0160226201696491E-2</c:v>
                </c:pt>
                <c:pt idx="10">
                  <c:v>1.9792648444863305E-2</c:v>
                </c:pt>
                <c:pt idx="11">
                  <c:v>1.7907634307257309E-2</c:v>
                </c:pt>
                <c:pt idx="12">
                  <c:v>9.4250706880301596E-3</c:v>
                </c:pt>
                <c:pt idx="13">
                  <c:v>1.1310084825636203E-2</c:v>
                </c:pt>
                <c:pt idx="14">
                  <c:v>1.0367577756833205E-2</c:v>
                </c:pt>
                <c:pt idx="15">
                  <c:v>9.4250706880301596E-3</c:v>
                </c:pt>
                <c:pt idx="16">
                  <c:v>2.8275212064090521E-3</c:v>
                </c:pt>
                <c:pt idx="17">
                  <c:v>4.7125353440150798E-3</c:v>
                </c:pt>
                <c:pt idx="18">
                  <c:v>2.8275212064090521E-3</c:v>
                </c:pt>
                <c:pt idx="19">
                  <c:v>3.7700282752120618E-3</c:v>
                </c:pt>
                <c:pt idx="20">
                  <c:v>9.4250706880301632E-4</c:v>
                </c:pt>
              </c:numCache>
            </c:numRef>
          </c:val>
        </c:ser>
        <c:ser>
          <c:idx val="16"/>
          <c:order val="16"/>
          <c:tx>
            <c:strRef>
              <c:f>'glr-1(n2461)_A3_0.02_5%'!$R$104</c:f>
              <c:strCache>
                <c:ptCount val="1"/>
                <c:pt idx="0">
                  <c:v>glr-1(n2461)_A3_17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R$105:$R$125</c:f>
              <c:numCache>
                <c:formatCode>General</c:formatCode>
                <c:ptCount val="21"/>
                <c:pt idx="1">
                  <c:v>8.5668534827862297E-2</c:v>
                </c:pt>
                <c:pt idx="2">
                  <c:v>0.10168134507606102</c:v>
                </c:pt>
                <c:pt idx="3">
                  <c:v>0.12489991993594902</c:v>
                </c:pt>
                <c:pt idx="4">
                  <c:v>0.14011208967173699</c:v>
                </c:pt>
                <c:pt idx="5">
                  <c:v>0.13690952762209799</c:v>
                </c:pt>
                <c:pt idx="6">
                  <c:v>7.606084867894318E-2</c:v>
                </c:pt>
                <c:pt idx="7">
                  <c:v>4.8038430744595718E-2</c:v>
                </c:pt>
                <c:pt idx="8">
                  <c:v>4.0832666132906342E-2</c:v>
                </c:pt>
                <c:pt idx="9">
                  <c:v>3.2826261008806999E-2</c:v>
                </c:pt>
                <c:pt idx="10">
                  <c:v>3.9231385108086513E-2</c:v>
                </c:pt>
                <c:pt idx="11">
                  <c:v>2.0016012810248202E-2</c:v>
                </c:pt>
                <c:pt idx="12">
                  <c:v>1.6813450760608507E-2</c:v>
                </c:pt>
                <c:pt idx="13">
                  <c:v>1.4411529223378704E-2</c:v>
                </c:pt>
                <c:pt idx="14">
                  <c:v>1.04083266613291E-2</c:v>
                </c:pt>
                <c:pt idx="15">
                  <c:v>5.6044835868694987E-3</c:v>
                </c:pt>
                <c:pt idx="16">
                  <c:v>5.6044835868694987E-3</c:v>
                </c:pt>
                <c:pt idx="17">
                  <c:v>4.003202562049642E-3</c:v>
                </c:pt>
                <c:pt idx="18">
                  <c:v>4.8038430744595734E-3</c:v>
                </c:pt>
                <c:pt idx="19">
                  <c:v>2.4019215372297802E-3</c:v>
                </c:pt>
                <c:pt idx="20">
                  <c:v>3.2025620496397111E-3</c:v>
                </c:pt>
              </c:numCache>
            </c:numRef>
          </c:val>
        </c:ser>
        <c:ser>
          <c:idx val="17"/>
          <c:order val="17"/>
          <c:tx>
            <c:strRef>
              <c:f>'glr-1(n2461)_A3_0.02_5%'!$S$104</c:f>
              <c:strCache>
                <c:ptCount val="1"/>
                <c:pt idx="0">
                  <c:v>glr-1(n2461)_A3_18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S$105:$S$125</c:f>
              <c:numCache>
                <c:formatCode>General</c:formatCode>
                <c:ptCount val="21"/>
                <c:pt idx="1">
                  <c:v>8.9863407620417002E-2</c:v>
                </c:pt>
                <c:pt idx="2">
                  <c:v>8.483105679367367E-2</c:v>
                </c:pt>
                <c:pt idx="3">
                  <c:v>0.10927390366642703</c:v>
                </c:pt>
                <c:pt idx="4">
                  <c:v>0.110711718188354</c:v>
                </c:pt>
                <c:pt idx="5">
                  <c:v>0.17181883537023707</c:v>
                </c:pt>
                <c:pt idx="6">
                  <c:v>4.9604601006470211E-2</c:v>
                </c:pt>
                <c:pt idx="7">
                  <c:v>4.0258806613946797E-2</c:v>
                </c:pt>
                <c:pt idx="8">
                  <c:v>3.8820992092020098E-2</c:v>
                </c:pt>
                <c:pt idx="9">
                  <c:v>4.5291157440690184E-2</c:v>
                </c:pt>
                <c:pt idx="10">
                  <c:v>3.7383177570093525E-2</c:v>
                </c:pt>
                <c:pt idx="11">
                  <c:v>3.3788641265276802E-2</c:v>
                </c:pt>
                <c:pt idx="12">
                  <c:v>3.5945363048166812E-2</c:v>
                </c:pt>
                <c:pt idx="13">
                  <c:v>2.4442846872753412E-2</c:v>
                </c:pt>
                <c:pt idx="14">
                  <c:v>1.2940330697340005E-2</c:v>
                </c:pt>
                <c:pt idx="15">
                  <c:v>1.2940330697340005E-2</c:v>
                </c:pt>
                <c:pt idx="16">
                  <c:v>7.1890726096333641E-3</c:v>
                </c:pt>
                <c:pt idx="17">
                  <c:v>4.3134435657800115E-3</c:v>
                </c:pt>
                <c:pt idx="18">
                  <c:v>5.7512580877066939E-3</c:v>
                </c:pt>
                <c:pt idx="19">
                  <c:v>4.3134435657800115E-3</c:v>
                </c:pt>
                <c:pt idx="20">
                  <c:v>4.3134435657800115E-3</c:v>
                </c:pt>
              </c:numCache>
            </c:numRef>
          </c:val>
        </c:ser>
        <c:ser>
          <c:idx val="18"/>
          <c:order val="18"/>
          <c:tx>
            <c:strRef>
              <c:f>'glr-1(n2461)_A3_0.02_5%'!$T$104</c:f>
              <c:strCache>
                <c:ptCount val="1"/>
                <c:pt idx="0">
                  <c:v>glr-1(n2461)_A3_19</c:v>
                </c:pt>
              </c:strCache>
            </c:strRef>
          </c:tx>
          <c:marker>
            <c:symbol val="none"/>
          </c:marker>
          <c:cat>
            <c:numRef>
              <c:f>'glr-1(n246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3_0.02_5%'!$T$105:$T$125</c:f>
              <c:numCache>
                <c:formatCode>General</c:formatCode>
                <c:ptCount val="21"/>
                <c:pt idx="1">
                  <c:v>7.3489010989011033E-2</c:v>
                </c:pt>
                <c:pt idx="2">
                  <c:v>0.10027472527472503</c:v>
                </c:pt>
                <c:pt idx="3">
                  <c:v>0.12293956043956</c:v>
                </c:pt>
                <c:pt idx="4">
                  <c:v>0.12706043956044011</c:v>
                </c:pt>
                <c:pt idx="5">
                  <c:v>0.175824175824176</c:v>
                </c:pt>
                <c:pt idx="6">
                  <c:v>7.6236263736263701E-2</c:v>
                </c:pt>
                <c:pt idx="7">
                  <c:v>3.7774725274725321E-2</c:v>
                </c:pt>
                <c:pt idx="8">
                  <c:v>3.8461538461538498E-2</c:v>
                </c:pt>
                <c:pt idx="9">
                  <c:v>4.3269230769230796E-2</c:v>
                </c:pt>
                <c:pt idx="10">
                  <c:v>3.5027472527472521E-2</c:v>
                </c:pt>
                <c:pt idx="11">
                  <c:v>3.708791208791213E-2</c:v>
                </c:pt>
                <c:pt idx="12">
                  <c:v>2.2664835164835202E-2</c:v>
                </c:pt>
                <c:pt idx="13">
                  <c:v>1.4423076923076898E-2</c:v>
                </c:pt>
                <c:pt idx="14">
                  <c:v>8.2417582417582402E-3</c:v>
                </c:pt>
                <c:pt idx="15">
                  <c:v>1.0989010989011E-2</c:v>
                </c:pt>
                <c:pt idx="16">
                  <c:v>4.8076923076923114E-3</c:v>
                </c:pt>
                <c:pt idx="17">
                  <c:v>5.4945054945054897E-3</c:v>
                </c:pt>
                <c:pt idx="18">
                  <c:v>3.4340659340659301E-3</c:v>
                </c:pt>
                <c:pt idx="19">
                  <c:v>1.37362637362637E-3</c:v>
                </c:pt>
                <c:pt idx="20">
                  <c:v>3.4340659340659301E-3</c:v>
                </c:pt>
              </c:numCache>
            </c:numRef>
          </c:val>
        </c:ser>
        <c:marker val="1"/>
        <c:axId val="159412224"/>
        <c:axId val="159413760"/>
      </c:lineChart>
      <c:catAx>
        <c:axId val="159412224"/>
        <c:scaling>
          <c:orientation val="minMax"/>
        </c:scaling>
        <c:axPos val="b"/>
        <c:numFmt formatCode="0.0_ " sourceLinked="1"/>
        <c:tickLblPos val="nextTo"/>
        <c:crossAx val="159413760"/>
        <c:crosses val="autoZero"/>
        <c:auto val="1"/>
        <c:lblAlgn val="ctr"/>
        <c:lblOffset val="100"/>
        <c:tickLblSkip val="5"/>
        <c:tickMarkSkip val="5"/>
      </c:catAx>
      <c:valAx>
        <c:axId val="15941376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9412224"/>
        <c:crosses val="autoZero"/>
        <c:crossBetween val="between"/>
      </c:valAx>
    </c:plotArea>
    <c:plotVisOnly val="1"/>
  </c:chart>
  <c:externalData r:id="rId1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gl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glr-1(n2461)_A5_0.02_5%'!$B$104</c:f>
              <c:strCache>
                <c:ptCount val="1"/>
                <c:pt idx="0">
                  <c:v>glr-1(n2461)_A5_01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B$105:$B$125</c:f>
              <c:numCache>
                <c:formatCode>General</c:formatCode>
                <c:ptCount val="21"/>
                <c:pt idx="1">
                  <c:v>0.10439560439560402</c:v>
                </c:pt>
                <c:pt idx="2">
                  <c:v>8.2417582417582402E-2</c:v>
                </c:pt>
                <c:pt idx="3">
                  <c:v>8.7912087912087877E-2</c:v>
                </c:pt>
                <c:pt idx="4">
                  <c:v>8.2417582417582402E-2</c:v>
                </c:pt>
                <c:pt idx="5">
                  <c:v>0.13736263736263701</c:v>
                </c:pt>
                <c:pt idx="6">
                  <c:v>5.4945054945054896E-2</c:v>
                </c:pt>
                <c:pt idx="7">
                  <c:v>3.8461538461538498E-2</c:v>
                </c:pt>
                <c:pt idx="8">
                  <c:v>1.0989010989011E-2</c:v>
                </c:pt>
                <c:pt idx="9">
                  <c:v>2.1978021978022001E-2</c:v>
                </c:pt>
                <c:pt idx="10">
                  <c:v>2.1978021978022001E-2</c:v>
                </c:pt>
                <c:pt idx="11">
                  <c:v>1.0989010989011E-2</c:v>
                </c:pt>
                <c:pt idx="12">
                  <c:v>2.1978021978022001E-2</c:v>
                </c:pt>
                <c:pt idx="13">
                  <c:v>2.1978021978022001E-2</c:v>
                </c:pt>
                <c:pt idx="14">
                  <c:v>2.1978021978022001E-2</c:v>
                </c:pt>
                <c:pt idx="15">
                  <c:v>2.1978021978022001E-2</c:v>
                </c:pt>
                <c:pt idx="16">
                  <c:v>1.6483516483516501E-2</c:v>
                </c:pt>
                <c:pt idx="17">
                  <c:v>3.8461538461538498E-2</c:v>
                </c:pt>
                <c:pt idx="18">
                  <c:v>5.4945054945054897E-3</c:v>
                </c:pt>
                <c:pt idx="19">
                  <c:v>5.4945054945054897E-3</c:v>
                </c:pt>
                <c:pt idx="20">
                  <c:v>2.1978021978022001E-2</c:v>
                </c:pt>
              </c:numCache>
            </c:numRef>
          </c:val>
        </c:ser>
        <c:ser>
          <c:idx val="1"/>
          <c:order val="1"/>
          <c:tx>
            <c:strRef>
              <c:f>'glr-1(n2461)_A5_0.02_5%'!$C$104</c:f>
              <c:strCache>
                <c:ptCount val="1"/>
                <c:pt idx="0">
                  <c:v>glr-1(n2461)_A5_02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C$105:$C$125</c:f>
              <c:numCache>
                <c:formatCode>General</c:formatCode>
                <c:ptCount val="21"/>
                <c:pt idx="1">
                  <c:v>6.9767441860465129E-2</c:v>
                </c:pt>
                <c:pt idx="2">
                  <c:v>7.7519379844961225E-2</c:v>
                </c:pt>
                <c:pt idx="3">
                  <c:v>0.116279069767442</c:v>
                </c:pt>
                <c:pt idx="4">
                  <c:v>0.10077519379845003</c:v>
                </c:pt>
                <c:pt idx="5">
                  <c:v>7.3643410852713226E-2</c:v>
                </c:pt>
                <c:pt idx="6">
                  <c:v>5.0387596899224819E-2</c:v>
                </c:pt>
                <c:pt idx="7">
                  <c:v>4.6511627906976737E-2</c:v>
                </c:pt>
                <c:pt idx="8">
                  <c:v>3.8759689922480599E-2</c:v>
                </c:pt>
                <c:pt idx="9">
                  <c:v>3.4883720930232599E-2</c:v>
                </c:pt>
                <c:pt idx="10">
                  <c:v>3.8759689922480599E-2</c:v>
                </c:pt>
                <c:pt idx="11">
                  <c:v>4.6511627906976737E-2</c:v>
                </c:pt>
                <c:pt idx="12">
                  <c:v>3.682170542635662E-2</c:v>
                </c:pt>
                <c:pt idx="13">
                  <c:v>3.1007751937984492E-2</c:v>
                </c:pt>
                <c:pt idx="14">
                  <c:v>2.906976744186051E-2</c:v>
                </c:pt>
                <c:pt idx="15">
                  <c:v>2.5193798449612406E-2</c:v>
                </c:pt>
                <c:pt idx="16">
                  <c:v>1.3565891472868205E-2</c:v>
                </c:pt>
                <c:pt idx="17">
                  <c:v>3.8759689922480598E-3</c:v>
                </c:pt>
                <c:pt idx="18">
                  <c:v>9.6899224806201497E-3</c:v>
                </c:pt>
                <c:pt idx="19">
                  <c:v>1.1627906976744195E-2</c:v>
                </c:pt>
                <c:pt idx="20">
                  <c:v>1.7441860465116307E-2</c:v>
                </c:pt>
              </c:numCache>
            </c:numRef>
          </c:val>
        </c:ser>
        <c:ser>
          <c:idx val="2"/>
          <c:order val="2"/>
          <c:tx>
            <c:strRef>
              <c:f>'glr-1(n2461)_A5_0.02_5%'!$D$104</c:f>
              <c:strCache>
                <c:ptCount val="1"/>
                <c:pt idx="0">
                  <c:v>glr-1(n2461)_A5_03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D$105:$D$125</c:f>
              <c:numCache>
                <c:formatCode>General</c:formatCode>
                <c:ptCount val="21"/>
                <c:pt idx="1">
                  <c:v>6.88E-2</c:v>
                </c:pt>
                <c:pt idx="2">
                  <c:v>6.4000000000000029E-2</c:v>
                </c:pt>
                <c:pt idx="3">
                  <c:v>8.9600000000000068E-2</c:v>
                </c:pt>
                <c:pt idx="4">
                  <c:v>0.12160000000000003</c:v>
                </c:pt>
                <c:pt idx="5">
                  <c:v>9.4400000000000026E-2</c:v>
                </c:pt>
                <c:pt idx="6">
                  <c:v>3.8399999999999997E-2</c:v>
                </c:pt>
                <c:pt idx="7">
                  <c:v>4.480000000000002E-2</c:v>
                </c:pt>
                <c:pt idx="8">
                  <c:v>2.4E-2</c:v>
                </c:pt>
                <c:pt idx="9">
                  <c:v>2.240000000000001E-2</c:v>
                </c:pt>
                <c:pt idx="10">
                  <c:v>2.5600000000000008E-2</c:v>
                </c:pt>
                <c:pt idx="11">
                  <c:v>3.0400000000000007E-2</c:v>
                </c:pt>
                <c:pt idx="12">
                  <c:v>2.8799999999999999E-2</c:v>
                </c:pt>
                <c:pt idx="13">
                  <c:v>4.0000000000000015E-2</c:v>
                </c:pt>
                <c:pt idx="14">
                  <c:v>2.0799999999999999E-2</c:v>
                </c:pt>
                <c:pt idx="15">
                  <c:v>4.480000000000002E-2</c:v>
                </c:pt>
                <c:pt idx="16">
                  <c:v>2.240000000000001E-2</c:v>
                </c:pt>
                <c:pt idx="17">
                  <c:v>2.4E-2</c:v>
                </c:pt>
                <c:pt idx="18">
                  <c:v>2.240000000000001E-2</c:v>
                </c:pt>
                <c:pt idx="19">
                  <c:v>1.6000000000000007E-2</c:v>
                </c:pt>
                <c:pt idx="20">
                  <c:v>1.2800000000000004E-2</c:v>
                </c:pt>
              </c:numCache>
            </c:numRef>
          </c:val>
        </c:ser>
        <c:ser>
          <c:idx val="3"/>
          <c:order val="3"/>
          <c:tx>
            <c:strRef>
              <c:f>'glr-1(n2461)_A5_0.02_5%'!$E$104</c:f>
              <c:strCache>
                <c:ptCount val="1"/>
                <c:pt idx="0">
                  <c:v>glr-1(n2461)_A5_04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E$105:$E$125</c:f>
              <c:numCache>
                <c:formatCode>General</c:formatCode>
                <c:ptCount val="21"/>
                <c:pt idx="1">
                  <c:v>7.4850299401197626E-2</c:v>
                </c:pt>
                <c:pt idx="2">
                  <c:v>8.5329341317365331E-2</c:v>
                </c:pt>
                <c:pt idx="3">
                  <c:v>0.11976047904191606</c:v>
                </c:pt>
                <c:pt idx="4">
                  <c:v>0.11826347305389204</c:v>
                </c:pt>
                <c:pt idx="5">
                  <c:v>8.5329341317365331E-2</c:v>
                </c:pt>
                <c:pt idx="6">
                  <c:v>5.3892215568862312E-2</c:v>
                </c:pt>
                <c:pt idx="7">
                  <c:v>3.8922155688622805E-2</c:v>
                </c:pt>
                <c:pt idx="8">
                  <c:v>2.3952095808383197E-2</c:v>
                </c:pt>
                <c:pt idx="9">
                  <c:v>4.4910179640718625E-2</c:v>
                </c:pt>
                <c:pt idx="10">
                  <c:v>2.0958083832335286E-2</c:v>
                </c:pt>
                <c:pt idx="11">
                  <c:v>2.0958083832335286E-2</c:v>
                </c:pt>
                <c:pt idx="12">
                  <c:v>2.3952095808383197E-2</c:v>
                </c:pt>
                <c:pt idx="13">
                  <c:v>3.1437125748503013E-2</c:v>
                </c:pt>
                <c:pt idx="14">
                  <c:v>2.5449101796407202E-2</c:v>
                </c:pt>
                <c:pt idx="15">
                  <c:v>2.5449101796407202E-2</c:v>
                </c:pt>
                <c:pt idx="16">
                  <c:v>1.7964071856287407E-2</c:v>
                </c:pt>
                <c:pt idx="17">
                  <c:v>2.0958083832335286E-2</c:v>
                </c:pt>
                <c:pt idx="18">
                  <c:v>2.2455089820359306E-2</c:v>
                </c:pt>
                <c:pt idx="19">
                  <c:v>1.6467065868263506E-2</c:v>
                </c:pt>
                <c:pt idx="20">
                  <c:v>1.3473053892215604E-2</c:v>
                </c:pt>
              </c:numCache>
            </c:numRef>
          </c:val>
        </c:ser>
        <c:ser>
          <c:idx val="4"/>
          <c:order val="4"/>
          <c:tx>
            <c:strRef>
              <c:f>'glr-1(n2461)_A5_0.02_5%'!$F$104</c:f>
              <c:strCache>
                <c:ptCount val="1"/>
                <c:pt idx="0">
                  <c:v>glr-1(n2461)_A5_05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F$105:$F$125</c:f>
              <c:numCache>
                <c:formatCode>General</c:formatCode>
                <c:ptCount val="21"/>
                <c:pt idx="1">
                  <c:v>0.18881118881118911</c:v>
                </c:pt>
                <c:pt idx="2">
                  <c:v>0.15384615384615408</c:v>
                </c:pt>
                <c:pt idx="3">
                  <c:v>0.125874125874126</c:v>
                </c:pt>
                <c:pt idx="4">
                  <c:v>8.3916083916083961E-2</c:v>
                </c:pt>
                <c:pt idx="5">
                  <c:v>4.8951048951049E-2</c:v>
                </c:pt>
                <c:pt idx="6">
                  <c:v>4.1958041958042015E-2</c:v>
                </c:pt>
                <c:pt idx="7">
                  <c:v>1.3986013986014E-2</c:v>
                </c:pt>
                <c:pt idx="8">
                  <c:v>1.3986013986014E-2</c:v>
                </c:pt>
                <c:pt idx="9">
                  <c:v>2.0979020979021008E-2</c:v>
                </c:pt>
                <c:pt idx="10">
                  <c:v>0</c:v>
                </c:pt>
                <c:pt idx="11">
                  <c:v>2.0979020979021008E-2</c:v>
                </c:pt>
                <c:pt idx="12">
                  <c:v>6.9930069930069921E-3</c:v>
                </c:pt>
                <c:pt idx="13">
                  <c:v>0</c:v>
                </c:pt>
                <c:pt idx="14">
                  <c:v>0</c:v>
                </c:pt>
                <c:pt idx="15">
                  <c:v>6.9930069930069921E-3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6.9930069930069921E-3</c:v>
                </c:pt>
              </c:numCache>
            </c:numRef>
          </c:val>
        </c:ser>
        <c:ser>
          <c:idx val="5"/>
          <c:order val="5"/>
          <c:tx>
            <c:strRef>
              <c:f>'glr-1(n2461)_A5_0.02_5%'!$G$104</c:f>
              <c:strCache>
                <c:ptCount val="1"/>
                <c:pt idx="0">
                  <c:v>glr-1(n2461)_A5_06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G$105:$G$125</c:f>
              <c:numCache>
                <c:formatCode>General</c:formatCode>
                <c:ptCount val="21"/>
                <c:pt idx="1">
                  <c:v>0.10954063604240299</c:v>
                </c:pt>
                <c:pt idx="2">
                  <c:v>6.7137809187279199E-2</c:v>
                </c:pt>
                <c:pt idx="3">
                  <c:v>7.4204946996466403E-2</c:v>
                </c:pt>
                <c:pt idx="4">
                  <c:v>4.2402826855123747E-2</c:v>
                </c:pt>
                <c:pt idx="5">
                  <c:v>3.1802120141342802E-2</c:v>
                </c:pt>
                <c:pt idx="6">
                  <c:v>3.5335689045936397E-2</c:v>
                </c:pt>
                <c:pt idx="7">
                  <c:v>3.53356890459364E-3</c:v>
                </c:pt>
                <c:pt idx="8">
                  <c:v>4.9469964664311021E-2</c:v>
                </c:pt>
                <c:pt idx="9">
                  <c:v>2.1201413427561818E-2</c:v>
                </c:pt>
                <c:pt idx="10">
                  <c:v>3.5335689045936397E-2</c:v>
                </c:pt>
                <c:pt idx="11">
                  <c:v>2.1201413427561818E-2</c:v>
                </c:pt>
                <c:pt idx="12">
                  <c:v>3.1802120141342802E-2</c:v>
                </c:pt>
                <c:pt idx="13">
                  <c:v>4.5936395759717315E-2</c:v>
                </c:pt>
                <c:pt idx="14">
                  <c:v>4.5936395759717315E-2</c:v>
                </c:pt>
                <c:pt idx="15">
                  <c:v>2.8268551236749082E-2</c:v>
                </c:pt>
                <c:pt idx="16">
                  <c:v>4.2402826855123747E-2</c:v>
                </c:pt>
                <c:pt idx="17">
                  <c:v>1.7667844522968202E-2</c:v>
                </c:pt>
                <c:pt idx="18">
                  <c:v>2.8268551236749082E-2</c:v>
                </c:pt>
                <c:pt idx="19">
                  <c:v>2.8268551236749082E-2</c:v>
                </c:pt>
                <c:pt idx="20">
                  <c:v>1.41342756183746E-2</c:v>
                </c:pt>
              </c:numCache>
            </c:numRef>
          </c:val>
        </c:ser>
        <c:ser>
          <c:idx val="6"/>
          <c:order val="6"/>
          <c:tx>
            <c:strRef>
              <c:f>'glr-1(n2461)_A5_0.02_5%'!$H$104</c:f>
              <c:strCache>
                <c:ptCount val="1"/>
                <c:pt idx="0">
                  <c:v>glr-1(n2461)_A5_07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H$105:$H$125</c:f>
              <c:numCache>
                <c:formatCode>General</c:formatCode>
                <c:ptCount val="21"/>
                <c:pt idx="1">
                  <c:v>0.12795275590551194</c:v>
                </c:pt>
                <c:pt idx="2">
                  <c:v>0.12401574803149604</c:v>
                </c:pt>
                <c:pt idx="3">
                  <c:v>0.1358267716535429</c:v>
                </c:pt>
                <c:pt idx="4">
                  <c:v>0.10433070866141703</c:v>
                </c:pt>
                <c:pt idx="5">
                  <c:v>7.283464566929132E-2</c:v>
                </c:pt>
                <c:pt idx="6">
                  <c:v>4.3307086614173221E-2</c:v>
                </c:pt>
                <c:pt idx="7">
                  <c:v>5.7086614173228342E-2</c:v>
                </c:pt>
                <c:pt idx="8">
                  <c:v>3.3464566929133903E-2</c:v>
                </c:pt>
                <c:pt idx="9">
                  <c:v>2.16535433070866E-2</c:v>
                </c:pt>
                <c:pt idx="10">
                  <c:v>7.8740157480314977E-3</c:v>
                </c:pt>
                <c:pt idx="11">
                  <c:v>1.968503937007871E-3</c:v>
                </c:pt>
                <c:pt idx="12">
                  <c:v>7.8740157480314977E-3</c:v>
                </c:pt>
                <c:pt idx="13">
                  <c:v>3.9370078740157497E-3</c:v>
                </c:pt>
                <c:pt idx="14">
                  <c:v>1.3779527559055104E-2</c:v>
                </c:pt>
                <c:pt idx="15">
                  <c:v>1.968503937007871E-3</c:v>
                </c:pt>
                <c:pt idx="16">
                  <c:v>7.8740157480314977E-3</c:v>
                </c:pt>
                <c:pt idx="17">
                  <c:v>7.8740157480314977E-3</c:v>
                </c:pt>
                <c:pt idx="18">
                  <c:v>2.16535433070866E-2</c:v>
                </c:pt>
                <c:pt idx="19">
                  <c:v>1.9685039370078709E-2</c:v>
                </c:pt>
                <c:pt idx="20">
                  <c:v>1.7716535433070901E-2</c:v>
                </c:pt>
              </c:numCache>
            </c:numRef>
          </c:val>
        </c:ser>
        <c:ser>
          <c:idx val="7"/>
          <c:order val="7"/>
          <c:tx>
            <c:strRef>
              <c:f>'glr-1(n2461)_A5_0.02_5%'!$I$104</c:f>
              <c:strCache>
                <c:ptCount val="1"/>
                <c:pt idx="0">
                  <c:v>glr-1(n2461)_A5_08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I$105:$I$125</c:f>
              <c:numCache>
                <c:formatCode>General</c:formatCode>
                <c:ptCount val="21"/>
                <c:pt idx="1">
                  <c:v>5.583756345177672E-2</c:v>
                </c:pt>
                <c:pt idx="2">
                  <c:v>3.5532994923857898E-2</c:v>
                </c:pt>
                <c:pt idx="3">
                  <c:v>3.5532994923857898E-2</c:v>
                </c:pt>
                <c:pt idx="4">
                  <c:v>7.1065989847715727E-2</c:v>
                </c:pt>
                <c:pt idx="5">
                  <c:v>4.0609137055837616E-2</c:v>
                </c:pt>
                <c:pt idx="6">
                  <c:v>3.0456852791878201E-2</c:v>
                </c:pt>
                <c:pt idx="7">
                  <c:v>4.5685279187817299E-2</c:v>
                </c:pt>
                <c:pt idx="8">
                  <c:v>2.0304568527918801E-2</c:v>
                </c:pt>
                <c:pt idx="9">
                  <c:v>1.01522842639594E-2</c:v>
                </c:pt>
                <c:pt idx="10">
                  <c:v>4.0609137055837616E-2</c:v>
                </c:pt>
                <c:pt idx="11">
                  <c:v>3.0456852791878201E-2</c:v>
                </c:pt>
                <c:pt idx="12">
                  <c:v>3.0456852791878201E-2</c:v>
                </c:pt>
                <c:pt idx="13">
                  <c:v>3.5532994923857898E-2</c:v>
                </c:pt>
                <c:pt idx="14">
                  <c:v>3.0456852791878201E-2</c:v>
                </c:pt>
                <c:pt idx="15">
                  <c:v>5.583756345177672E-2</c:v>
                </c:pt>
                <c:pt idx="16">
                  <c:v>2.5380710659898501E-2</c:v>
                </c:pt>
                <c:pt idx="17">
                  <c:v>6.0913705583756313E-2</c:v>
                </c:pt>
                <c:pt idx="18">
                  <c:v>4.5685279187817299E-2</c:v>
                </c:pt>
                <c:pt idx="19">
                  <c:v>4.5685279187817299E-2</c:v>
                </c:pt>
                <c:pt idx="20">
                  <c:v>3.0456852791878201E-2</c:v>
                </c:pt>
              </c:numCache>
            </c:numRef>
          </c:val>
        </c:ser>
        <c:ser>
          <c:idx val="8"/>
          <c:order val="8"/>
          <c:tx>
            <c:strRef>
              <c:f>'glr-1(n2461)_A5_0.02_5%'!$J$104</c:f>
              <c:strCache>
                <c:ptCount val="1"/>
                <c:pt idx="0">
                  <c:v>glr-1(n2461)_A5_09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J$105:$J$125</c:f>
              <c:numCache>
                <c:formatCode>General</c:formatCode>
                <c:ptCount val="21"/>
                <c:pt idx="1">
                  <c:v>9.1476091476091495E-2</c:v>
                </c:pt>
                <c:pt idx="2">
                  <c:v>0.10187110187110203</c:v>
                </c:pt>
                <c:pt idx="3">
                  <c:v>0.10395010395010403</c:v>
                </c:pt>
                <c:pt idx="4">
                  <c:v>8.1081081081081099E-2</c:v>
                </c:pt>
                <c:pt idx="5">
                  <c:v>6.652806652806649E-2</c:v>
                </c:pt>
                <c:pt idx="6">
                  <c:v>5.8212058212058201E-2</c:v>
                </c:pt>
                <c:pt idx="7">
                  <c:v>2.4948024948024894E-2</c:v>
                </c:pt>
                <c:pt idx="8">
                  <c:v>2.4948024948024894E-2</c:v>
                </c:pt>
                <c:pt idx="9">
                  <c:v>3.9501039501039517E-2</c:v>
                </c:pt>
                <c:pt idx="10">
                  <c:v>1.8711018711018709E-2</c:v>
                </c:pt>
                <c:pt idx="11">
                  <c:v>2.4948024948024894E-2</c:v>
                </c:pt>
                <c:pt idx="12">
                  <c:v>1.0395010395010401E-2</c:v>
                </c:pt>
                <c:pt idx="13">
                  <c:v>2.7027027027027015E-2</c:v>
                </c:pt>
                <c:pt idx="14">
                  <c:v>2.0790020790020798E-2</c:v>
                </c:pt>
                <c:pt idx="15">
                  <c:v>2.2869022869022912E-2</c:v>
                </c:pt>
                <c:pt idx="16">
                  <c:v>3.3264033264033301E-2</c:v>
                </c:pt>
                <c:pt idx="17">
                  <c:v>2.2869022869022912E-2</c:v>
                </c:pt>
                <c:pt idx="18">
                  <c:v>2.2869022869022912E-2</c:v>
                </c:pt>
                <c:pt idx="19">
                  <c:v>3.1185031185031201E-2</c:v>
                </c:pt>
                <c:pt idx="20">
                  <c:v>1.2474012474012499E-2</c:v>
                </c:pt>
              </c:numCache>
            </c:numRef>
          </c:val>
        </c:ser>
        <c:ser>
          <c:idx val="9"/>
          <c:order val="9"/>
          <c:tx>
            <c:strRef>
              <c:f>'glr-1(n2461)_A5_0.02_5%'!$K$104</c:f>
              <c:strCache>
                <c:ptCount val="1"/>
                <c:pt idx="0">
                  <c:v>glr-1(n2461)_A5_10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K$105:$K$125</c:f>
              <c:numCache>
                <c:formatCode>General</c:formatCode>
                <c:ptCount val="21"/>
                <c:pt idx="1">
                  <c:v>7.6411960132890394E-2</c:v>
                </c:pt>
                <c:pt idx="2">
                  <c:v>0.11129568106312306</c:v>
                </c:pt>
                <c:pt idx="3">
                  <c:v>9.6345514950166106E-2</c:v>
                </c:pt>
                <c:pt idx="4">
                  <c:v>8.3056478405315645E-2</c:v>
                </c:pt>
                <c:pt idx="5">
                  <c:v>7.3089700996677706E-2</c:v>
                </c:pt>
                <c:pt idx="6">
                  <c:v>3.9867109634551499E-2</c:v>
                </c:pt>
                <c:pt idx="7">
                  <c:v>3.6544850498338902E-2</c:v>
                </c:pt>
                <c:pt idx="8">
                  <c:v>4.485049833887042E-2</c:v>
                </c:pt>
                <c:pt idx="9">
                  <c:v>3.8205980066445211E-2</c:v>
                </c:pt>
                <c:pt idx="10">
                  <c:v>3.1561461794019897E-2</c:v>
                </c:pt>
                <c:pt idx="11">
                  <c:v>2.4916943521594705E-2</c:v>
                </c:pt>
                <c:pt idx="12">
                  <c:v>2.8239202657807317E-2</c:v>
                </c:pt>
                <c:pt idx="13">
                  <c:v>3.4883720930232599E-2</c:v>
                </c:pt>
                <c:pt idx="14">
                  <c:v>2.4916943521594705E-2</c:v>
                </c:pt>
                <c:pt idx="15">
                  <c:v>1.9933554817275708E-2</c:v>
                </c:pt>
                <c:pt idx="16">
                  <c:v>1.6611295681063103E-2</c:v>
                </c:pt>
                <c:pt idx="17">
                  <c:v>1.8272425249169413E-2</c:v>
                </c:pt>
                <c:pt idx="18">
                  <c:v>1.4950166112956799E-2</c:v>
                </c:pt>
                <c:pt idx="19">
                  <c:v>1.9933554817275708E-2</c:v>
                </c:pt>
                <c:pt idx="20">
                  <c:v>8.3056478405315638E-3</c:v>
                </c:pt>
              </c:numCache>
            </c:numRef>
          </c:val>
        </c:ser>
        <c:ser>
          <c:idx val="10"/>
          <c:order val="10"/>
          <c:tx>
            <c:strRef>
              <c:f>'glr-1(n2461)_A5_0.02_5%'!$L$104</c:f>
              <c:strCache>
                <c:ptCount val="1"/>
                <c:pt idx="0">
                  <c:v>glr-1(n2461)_A5_11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L$105:$L$125</c:f>
              <c:numCache>
                <c:formatCode>General</c:formatCode>
                <c:ptCount val="21"/>
                <c:pt idx="1">
                  <c:v>0.105263157894737</c:v>
                </c:pt>
                <c:pt idx="2">
                  <c:v>0.10889292196007304</c:v>
                </c:pt>
                <c:pt idx="3">
                  <c:v>0.10889292196007304</c:v>
                </c:pt>
                <c:pt idx="4">
                  <c:v>0.105263157894737</c:v>
                </c:pt>
                <c:pt idx="5">
                  <c:v>9.0744101633393803E-2</c:v>
                </c:pt>
                <c:pt idx="6">
                  <c:v>5.2631578947368404E-2</c:v>
                </c:pt>
                <c:pt idx="7">
                  <c:v>2.3593466424682397E-2</c:v>
                </c:pt>
                <c:pt idx="8">
                  <c:v>2.9038112522686017E-2</c:v>
                </c:pt>
                <c:pt idx="9">
                  <c:v>2.9038112522686017E-2</c:v>
                </c:pt>
                <c:pt idx="10">
                  <c:v>3.2667876588021831E-2</c:v>
                </c:pt>
                <c:pt idx="11">
                  <c:v>2.9038112522686017E-2</c:v>
                </c:pt>
                <c:pt idx="12">
                  <c:v>2.1778584392014494E-2</c:v>
                </c:pt>
                <c:pt idx="13">
                  <c:v>1.9963702359346601E-2</c:v>
                </c:pt>
                <c:pt idx="14">
                  <c:v>1.6333938294010909E-2</c:v>
                </c:pt>
                <c:pt idx="15">
                  <c:v>1.9963702359346601E-2</c:v>
                </c:pt>
                <c:pt idx="16">
                  <c:v>1.9963702359346601E-2</c:v>
                </c:pt>
                <c:pt idx="17">
                  <c:v>1.6333938294010909E-2</c:v>
                </c:pt>
                <c:pt idx="18">
                  <c:v>1.4519056261342998E-2</c:v>
                </c:pt>
                <c:pt idx="19">
                  <c:v>1.2704174228675109E-2</c:v>
                </c:pt>
                <c:pt idx="20">
                  <c:v>7.259528130671513E-3</c:v>
                </c:pt>
              </c:numCache>
            </c:numRef>
          </c:val>
        </c:ser>
        <c:ser>
          <c:idx val="11"/>
          <c:order val="11"/>
          <c:tx>
            <c:strRef>
              <c:f>'glr-1(n2461)_A5_0.02_5%'!$M$104</c:f>
              <c:strCache>
                <c:ptCount val="1"/>
                <c:pt idx="0">
                  <c:v>glr-1(n2461)_A5_12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M$105:$M$125</c:f>
              <c:numCache>
                <c:formatCode>General</c:formatCode>
                <c:ptCount val="21"/>
                <c:pt idx="1">
                  <c:v>0.14216867469879493</c:v>
                </c:pt>
                <c:pt idx="2">
                  <c:v>0.156626506024096</c:v>
                </c:pt>
                <c:pt idx="3">
                  <c:v>8.67469879518072E-2</c:v>
                </c:pt>
                <c:pt idx="4">
                  <c:v>4.8192771084337421E-2</c:v>
                </c:pt>
                <c:pt idx="5">
                  <c:v>3.6144578313252997E-2</c:v>
                </c:pt>
                <c:pt idx="6">
                  <c:v>6.0240963855421721E-2</c:v>
                </c:pt>
                <c:pt idx="7">
                  <c:v>3.6144578313252997E-2</c:v>
                </c:pt>
                <c:pt idx="8">
                  <c:v>3.1325301204819314E-2</c:v>
                </c:pt>
                <c:pt idx="9">
                  <c:v>3.1325301204819314E-2</c:v>
                </c:pt>
                <c:pt idx="10">
                  <c:v>4.8192771084337423E-3</c:v>
                </c:pt>
                <c:pt idx="11">
                  <c:v>2.89156626506024E-2</c:v>
                </c:pt>
                <c:pt idx="12">
                  <c:v>1.2048192771084298E-2</c:v>
                </c:pt>
                <c:pt idx="13">
                  <c:v>9.6385542168674742E-3</c:v>
                </c:pt>
                <c:pt idx="14">
                  <c:v>2.1686746987951807E-2</c:v>
                </c:pt>
                <c:pt idx="15">
                  <c:v>2.4096385542168699E-3</c:v>
                </c:pt>
                <c:pt idx="16">
                  <c:v>4.8192771084337423E-3</c:v>
                </c:pt>
                <c:pt idx="17">
                  <c:v>4.8192771084337423E-3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glr-1(n2461)_A5_0.02_5%'!$N$104</c:f>
              <c:strCache>
                <c:ptCount val="1"/>
                <c:pt idx="0">
                  <c:v>glr-1(n2461)_A5_13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N$105:$N$125</c:f>
              <c:numCache>
                <c:formatCode>General</c:formatCode>
                <c:ptCount val="21"/>
                <c:pt idx="1">
                  <c:v>0.12286689419795201</c:v>
                </c:pt>
                <c:pt idx="2">
                  <c:v>8.5324232081911283E-2</c:v>
                </c:pt>
                <c:pt idx="3">
                  <c:v>8.1911262798634796E-2</c:v>
                </c:pt>
                <c:pt idx="4">
                  <c:v>3.7542662116041001E-2</c:v>
                </c:pt>
                <c:pt idx="5">
                  <c:v>2.3890784982935197E-2</c:v>
                </c:pt>
                <c:pt idx="6">
                  <c:v>1.3651877133105804E-2</c:v>
                </c:pt>
                <c:pt idx="7">
                  <c:v>2.3890784982935197E-2</c:v>
                </c:pt>
                <c:pt idx="8">
                  <c:v>1.3651877133105804E-2</c:v>
                </c:pt>
                <c:pt idx="9">
                  <c:v>1.7064846416382305E-2</c:v>
                </c:pt>
                <c:pt idx="10">
                  <c:v>1.7064846416382305E-2</c:v>
                </c:pt>
                <c:pt idx="11">
                  <c:v>4.0955631399317419E-2</c:v>
                </c:pt>
                <c:pt idx="12">
                  <c:v>1.7064846416382305E-2</c:v>
                </c:pt>
                <c:pt idx="13">
                  <c:v>4.436860068259392E-2</c:v>
                </c:pt>
                <c:pt idx="14">
                  <c:v>2.7303754266211601E-2</c:v>
                </c:pt>
                <c:pt idx="15">
                  <c:v>3.7542662116041001E-2</c:v>
                </c:pt>
                <c:pt idx="16">
                  <c:v>2.3890784982935197E-2</c:v>
                </c:pt>
                <c:pt idx="17">
                  <c:v>3.4129692832764499E-2</c:v>
                </c:pt>
                <c:pt idx="18">
                  <c:v>1.3651877133105804E-2</c:v>
                </c:pt>
                <c:pt idx="19">
                  <c:v>1.3651877133105804E-2</c:v>
                </c:pt>
                <c:pt idx="20">
                  <c:v>2.3890784982935197E-2</c:v>
                </c:pt>
              </c:numCache>
            </c:numRef>
          </c:val>
        </c:ser>
        <c:ser>
          <c:idx val="13"/>
          <c:order val="13"/>
          <c:tx>
            <c:strRef>
              <c:f>'glr-1(n2461)_A5_0.02_5%'!$O$104</c:f>
              <c:strCache>
                <c:ptCount val="1"/>
                <c:pt idx="0">
                  <c:v>glr-1(n2461)_A5_14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O$105:$O$125</c:f>
              <c:numCache>
                <c:formatCode>General</c:formatCode>
                <c:ptCount val="21"/>
                <c:pt idx="1">
                  <c:v>0.10150891632373098</c:v>
                </c:pt>
                <c:pt idx="2">
                  <c:v>8.9163237311385479E-2</c:v>
                </c:pt>
                <c:pt idx="3">
                  <c:v>0.120713305898491</c:v>
                </c:pt>
                <c:pt idx="4">
                  <c:v>0.12757201646090494</c:v>
                </c:pt>
                <c:pt idx="5">
                  <c:v>9.7393689986282603E-2</c:v>
                </c:pt>
                <c:pt idx="6">
                  <c:v>4.38957475994513E-2</c:v>
                </c:pt>
                <c:pt idx="7">
                  <c:v>4.6639231824417017E-2</c:v>
                </c:pt>
                <c:pt idx="8">
                  <c:v>3.7037037037037014E-2</c:v>
                </c:pt>
                <c:pt idx="9">
                  <c:v>1.9204389574759905E-2</c:v>
                </c:pt>
                <c:pt idx="10">
                  <c:v>1.6460905349794205E-2</c:v>
                </c:pt>
                <c:pt idx="11">
                  <c:v>2.3319615912208502E-2</c:v>
                </c:pt>
                <c:pt idx="12">
                  <c:v>2.6063100137174208E-2</c:v>
                </c:pt>
                <c:pt idx="13">
                  <c:v>1.9204389574759905E-2</c:v>
                </c:pt>
                <c:pt idx="14">
                  <c:v>1.6460905349794205E-2</c:v>
                </c:pt>
                <c:pt idx="15">
                  <c:v>2.3319615912208502E-2</c:v>
                </c:pt>
                <c:pt idx="16">
                  <c:v>1.0973936899862801E-2</c:v>
                </c:pt>
                <c:pt idx="17">
                  <c:v>2.0576131687242802E-2</c:v>
                </c:pt>
                <c:pt idx="18">
                  <c:v>1.0973936899862801E-2</c:v>
                </c:pt>
                <c:pt idx="19">
                  <c:v>1.37174211248285E-2</c:v>
                </c:pt>
                <c:pt idx="20">
                  <c:v>8.23045267489712E-3</c:v>
                </c:pt>
              </c:numCache>
            </c:numRef>
          </c:val>
        </c:ser>
        <c:ser>
          <c:idx val="14"/>
          <c:order val="14"/>
          <c:tx>
            <c:strRef>
              <c:f>'glr-1(n2461)_A5_0.02_5%'!$P$104</c:f>
              <c:strCache>
                <c:ptCount val="1"/>
                <c:pt idx="0">
                  <c:v>glr-1(n2461)_A5_15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P$105:$P$125</c:f>
              <c:numCache>
                <c:formatCode>General</c:formatCode>
                <c:ptCount val="21"/>
                <c:pt idx="1">
                  <c:v>8.7830687830687773E-2</c:v>
                </c:pt>
                <c:pt idx="2">
                  <c:v>8.6772486772486834E-2</c:v>
                </c:pt>
                <c:pt idx="3">
                  <c:v>0.11428571428571403</c:v>
                </c:pt>
                <c:pt idx="4">
                  <c:v>0.13650793650793611</c:v>
                </c:pt>
                <c:pt idx="5">
                  <c:v>0.12804232804232807</c:v>
                </c:pt>
                <c:pt idx="6">
                  <c:v>6.8783068783068793E-2</c:v>
                </c:pt>
                <c:pt idx="7">
                  <c:v>5.1851851851851899E-2</c:v>
                </c:pt>
                <c:pt idx="8">
                  <c:v>5.1851851851851899E-2</c:v>
                </c:pt>
                <c:pt idx="9">
                  <c:v>5.29100529100529E-2</c:v>
                </c:pt>
                <c:pt idx="10">
                  <c:v>3.1746031746031703E-2</c:v>
                </c:pt>
                <c:pt idx="11">
                  <c:v>2.3280423280423308E-2</c:v>
                </c:pt>
                <c:pt idx="12">
                  <c:v>2.7513227513227521E-2</c:v>
                </c:pt>
                <c:pt idx="13">
                  <c:v>1.37566137566138E-2</c:v>
                </c:pt>
                <c:pt idx="14">
                  <c:v>9.5238095238095229E-3</c:v>
                </c:pt>
                <c:pt idx="15">
                  <c:v>8.4656084656084731E-3</c:v>
                </c:pt>
                <c:pt idx="16">
                  <c:v>4.2328042328042314E-3</c:v>
                </c:pt>
                <c:pt idx="17">
                  <c:v>6.3492063492063518E-3</c:v>
                </c:pt>
                <c:pt idx="18">
                  <c:v>8.4656084656084731E-3</c:v>
                </c:pt>
                <c:pt idx="19">
                  <c:v>3.1746031746031698E-3</c:v>
                </c:pt>
                <c:pt idx="20">
                  <c:v>3.1746031746031698E-3</c:v>
                </c:pt>
              </c:numCache>
            </c:numRef>
          </c:val>
        </c:ser>
        <c:ser>
          <c:idx val="15"/>
          <c:order val="15"/>
          <c:tx>
            <c:strRef>
              <c:f>'glr-1(n2461)_A5_0.02_5%'!$Q$104</c:f>
              <c:strCache>
                <c:ptCount val="1"/>
                <c:pt idx="0">
                  <c:v>glr-1(n2461)_A5_16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Q$105:$Q$125</c:f>
              <c:numCache>
                <c:formatCode>General</c:formatCode>
                <c:ptCount val="21"/>
                <c:pt idx="1">
                  <c:v>8.8435374149659976E-2</c:v>
                </c:pt>
                <c:pt idx="2">
                  <c:v>7.346938775510202E-2</c:v>
                </c:pt>
                <c:pt idx="3">
                  <c:v>0.102040816326531</c:v>
                </c:pt>
                <c:pt idx="4">
                  <c:v>0.11156462585034002</c:v>
                </c:pt>
                <c:pt idx="5">
                  <c:v>8.4353741496598605E-2</c:v>
                </c:pt>
                <c:pt idx="6">
                  <c:v>4.0816326530612221E-2</c:v>
                </c:pt>
                <c:pt idx="7">
                  <c:v>3.673469387755101E-2</c:v>
                </c:pt>
                <c:pt idx="8">
                  <c:v>2.8571428571428602E-2</c:v>
                </c:pt>
                <c:pt idx="9">
                  <c:v>3.9455782312925215E-2</c:v>
                </c:pt>
                <c:pt idx="10">
                  <c:v>4.0816326530612221E-2</c:v>
                </c:pt>
                <c:pt idx="11">
                  <c:v>2.4489795918367314E-2</c:v>
                </c:pt>
                <c:pt idx="12">
                  <c:v>3.2653061224489806E-2</c:v>
                </c:pt>
                <c:pt idx="13">
                  <c:v>2.8571428571428602E-2</c:v>
                </c:pt>
                <c:pt idx="14">
                  <c:v>2.9931972789115621E-2</c:v>
                </c:pt>
                <c:pt idx="15">
                  <c:v>2.585034013605441E-2</c:v>
                </c:pt>
                <c:pt idx="16">
                  <c:v>2.176870748299321E-2</c:v>
                </c:pt>
                <c:pt idx="17">
                  <c:v>2.3129251700680281E-2</c:v>
                </c:pt>
                <c:pt idx="18">
                  <c:v>1.0884353741496601E-2</c:v>
                </c:pt>
                <c:pt idx="19">
                  <c:v>9.5238095238095229E-3</c:v>
                </c:pt>
                <c:pt idx="20">
                  <c:v>1.0884353741496601E-2</c:v>
                </c:pt>
              </c:numCache>
            </c:numRef>
          </c:val>
        </c:ser>
        <c:ser>
          <c:idx val="16"/>
          <c:order val="16"/>
          <c:tx>
            <c:strRef>
              <c:f>'glr-1(n2461)_A5_0.02_5%'!$R$104</c:f>
              <c:strCache>
                <c:ptCount val="1"/>
                <c:pt idx="0">
                  <c:v>glr-1(n2461)_A5_17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R$105:$R$125</c:f>
              <c:numCache>
                <c:formatCode>General</c:formatCode>
                <c:ptCount val="21"/>
                <c:pt idx="1">
                  <c:v>9.4693028095733642E-2</c:v>
                </c:pt>
                <c:pt idx="2">
                  <c:v>0.105098855359001</c:v>
                </c:pt>
                <c:pt idx="3">
                  <c:v>0.12591050988553601</c:v>
                </c:pt>
                <c:pt idx="4">
                  <c:v>0.14047866805411</c:v>
                </c:pt>
                <c:pt idx="5">
                  <c:v>0.105098855359001</c:v>
                </c:pt>
                <c:pt idx="6">
                  <c:v>5.5150884495317402E-2</c:v>
                </c:pt>
                <c:pt idx="7">
                  <c:v>6.3475546305931302E-2</c:v>
                </c:pt>
                <c:pt idx="8">
                  <c:v>4.9947970863683716E-2</c:v>
                </c:pt>
                <c:pt idx="9">
                  <c:v>5.5150884495317402E-2</c:v>
                </c:pt>
                <c:pt idx="10">
                  <c:v>3.1217481789802298E-2</c:v>
                </c:pt>
                <c:pt idx="11">
                  <c:v>2.7055150884495317E-2</c:v>
                </c:pt>
                <c:pt idx="12">
                  <c:v>1.7689906347554601E-2</c:v>
                </c:pt>
                <c:pt idx="13">
                  <c:v>1.6649323621227903E-2</c:v>
                </c:pt>
                <c:pt idx="14">
                  <c:v>8.3246618106139446E-3</c:v>
                </c:pt>
                <c:pt idx="15">
                  <c:v>7.2840790842872037E-3</c:v>
                </c:pt>
                <c:pt idx="16">
                  <c:v>5.2029136316337115E-3</c:v>
                </c:pt>
                <c:pt idx="17">
                  <c:v>1.0405827263267413E-3</c:v>
                </c:pt>
                <c:pt idx="18">
                  <c:v>4.1623309053069697E-3</c:v>
                </c:pt>
                <c:pt idx="19">
                  <c:v>1.0405827263267413E-3</c:v>
                </c:pt>
                <c:pt idx="20">
                  <c:v>3.121748178980231E-3</c:v>
                </c:pt>
              </c:numCache>
            </c:numRef>
          </c:val>
        </c:ser>
        <c:ser>
          <c:idx val="17"/>
          <c:order val="17"/>
          <c:tx>
            <c:strRef>
              <c:f>'glr-1(n2461)_A5_0.02_5%'!$S$104</c:f>
              <c:strCache>
                <c:ptCount val="1"/>
                <c:pt idx="0">
                  <c:v>glr-1(n2461)_A5_18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S$105:$S$125</c:f>
              <c:numCache>
                <c:formatCode>General</c:formatCode>
                <c:ptCount val="21"/>
                <c:pt idx="1">
                  <c:v>7.7750206782464804E-2</c:v>
                </c:pt>
                <c:pt idx="2">
                  <c:v>0.12324234904880105</c:v>
                </c:pt>
                <c:pt idx="3">
                  <c:v>0.13234077750206799</c:v>
                </c:pt>
                <c:pt idx="4">
                  <c:v>0.16625310173697305</c:v>
                </c:pt>
                <c:pt idx="5">
                  <c:v>0.15880893300248111</c:v>
                </c:pt>
                <c:pt idx="6">
                  <c:v>6.2034739454094323E-2</c:v>
                </c:pt>
                <c:pt idx="7">
                  <c:v>4.1356492969396225E-2</c:v>
                </c:pt>
                <c:pt idx="8">
                  <c:v>4.4665012406947903E-2</c:v>
                </c:pt>
                <c:pt idx="9">
                  <c:v>3.2258064516129011E-2</c:v>
                </c:pt>
                <c:pt idx="10">
                  <c:v>3.3912324234904888E-2</c:v>
                </c:pt>
                <c:pt idx="11">
                  <c:v>1.81968569065343E-2</c:v>
                </c:pt>
                <c:pt idx="12">
                  <c:v>1.9023986765922207E-2</c:v>
                </c:pt>
                <c:pt idx="13">
                  <c:v>7.4441687344913255E-3</c:v>
                </c:pt>
                <c:pt idx="14">
                  <c:v>9.0984284532671603E-3</c:v>
                </c:pt>
                <c:pt idx="15">
                  <c:v>4.1356492969396239E-3</c:v>
                </c:pt>
                <c:pt idx="16">
                  <c:v>4.1356492969396239E-3</c:v>
                </c:pt>
                <c:pt idx="17">
                  <c:v>3.3085194375517008E-3</c:v>
                </c:pt>
                <c:pt idx="18">
                  <c:v>2.4813895781637717E-3</c:v>
                </c:pt>
                <c:pt idx="19">
                  <c:v>2.4813895781637717E-3</c:v>
                </c:pt>
                <c:pt idx="20">
                  <c:v>8.2712985938792445E-4</c:v>
                </c:pt>
              </c:numCache>
            </c:numRef>
          </c:val>
        </c:ser>
        <c:ser>
          <c:idx val="18"/>
          <c:order val="18"/>
          <c:tx>
            <c:strRef>
              <c:f>'glr-1(n2461)_A5_0.02_5%'!$T$104</c:f>
              <c:strCache>
                <c:ptCount val="1"/>
                <c:pt idx="0">
                  <c:v>glr-1(n2461)_A5_19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T$105:$T$125</c:f>
              <c:numCache>
                <c:formatCode>General</c:formatCode>
                <c:ptCount val="21"/>
                <c:pt idx="1">
                  <c:v>0.10133843212237095</c:v>
                </c:pt>
                <c:pt idx="2">
                  <c:v>0.14531548757170215</c:v>
                </c:pt>
                <c:pt idx="3">
                  <c:v>0.13575525812619507</c:v>
                </c:pt>
                <c:pt idx="4">
                  <c:v>0.11281070745697905</c:v>
                </c:pt>
                <c:pt idx="5">
                  <c:v>6.8833652007648224E-2</c:v>
                </c:pt>
                <c:pt idx="6">
                  <c:v>4.3977055449330796E-2</c:v>
                </c:pt>
                <c:pt idx="7">
                  <c:v>4.9713193116634836E-2</c:v>
                </c:pt>
                <c:pt idx="8">
                  <c:v>3.8240917782026818E-2</c:v>
                </c:pt>
                <c:pt idx="9">
                  <c:v>2.2944550669216107E-2</c:v>
                </c:pt>
                <c:pt idx="10">
                  <c:v>1.9120458891013409E-2</c:v>
                </c:pt>
                <c:pt idx="11">
                  <c:v>2.6768642447418702E-2</c:v>
                </c:pt>
                <c:pt idx="12">
                  <c:v>1.52963671128107E-2</c:v>
                </c:pt>
                <c:pt idx="13">
                  <c:v>1.52963671128107E-2</c:v>
                </c:pt>
                <c:pt idx="14">
                  <c:v>1.9120458891013409E-2</c:v>
                </c:pt>
                <c:pt idx="15">
                  <c:v>1.52963671128107E-2</c:v>
                </c:pt>
                <c:pt idx="16">
                  <c:v>9.560229445506694E-3</c:v>
                </c:pt>
                <c:pt idx="17">
                  <c:v>1.3384321223709405E-2</c:v>
                </c:pt>
                <c:pt idx="18">
                  <c:v>0</c:v>
                </c:pt>
                <c:pt idx="19">
                  <c:v>9.560229445506694E-3</c:v>
                </c:pt>
                <c:pt idx="2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glr-1(n2461)_A5_0.02_5%'!$U$104</c:f>
              <c:strCache>
                <c:ptCount val="1"/>
                <c:pt idx="0">
                  <c:v>glr-1(n2461)_A5_20</c:v>
                </c:pt>
              </c:strCache>
            </c:strRef>
          </c:tx>
          <c:marker>
            <c:symbol val="none"/>
          </c:marker>
          <c:cat>
            <c:numRef>
              <c:f>'glr-1(n246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glr-1(n2461)_A5_0.02_5%'!$U$105:$U$125</c:f>
              <c:numCache>
                <c:formatCode>General</c:formatCode>
                <c:ptCount val="21"/>
                <c:pt idx="1">
                  <c:v>8.0952380952381026E-2</c:v>
                </c:pt>
                <c:pt idx="2">
                  <c:v>9.6825396825396842E-2</c:v>
                </c:pt>
                <c:pt idx="3">
                  <c:v>9.8412698412698396E-2</c:v>
                </c:pt>
                <c:pt idx="4">
                  <c:v>0.12539682539682501</c:v>
                </c:pt>
                <c:pt idx="5">
                  <c:v>7.6190476190476197E-2</c:v>
                </c:pt>
                <c:pt idx="6">
                  <c:v>4.6031746031746014E-2</c:v>
                </c:pt>
                <c:pt idx="7">
                  <c:v>4.1269841269841297E-2</c:v>
                </c:pt>
                <c:pt idx="8">
                  <c:v>4.2857142857142913E-2</c:v>
                </c:pt>
                <c:pt idx="9">
                  <c:v>3.3333333333333298E-2</c:v>
                </c:pt>
                <c:pt idx="10">
                  <c:v>1.58730158730159E-2</c:v>
                </c:pt>
                <c:pt idx="11">
                  <c:v>3.6507936507936517E-2</c:v>
                </c:pt>
                <c:pt idx="12">
                  <c:v>2.8571428571428602E-2</c:v>
                </c:pt>
                <c:pt idx="13">
                  <c:v>4.1269841269841297E-2</c:v>
                </c:pt>
                <c:pt idx="14">
                  <c:v>2.5396825396825397E-2</c:v>
                </c:pt>
                <c:pt idx="15">
                  <c:v>1.4285714285714301E-2</c:v>
                </c:pt>
                <c:pt idx="16">
                  <c:v>1.58730158730159E-2</c:v>
                </c:pt>
                <c:pt idx="17">
                  <c:v>7.9365079365079413E-3</c:v>
                </c:pt>
                <c:pt idx="18">
                  <c:v>7.9365079365079413E-3</c:v>
                </c:pt>
                <c:pt idx="19">
                  <c:v>1.7460317460317506E-2</c:v>
                </c:pt>
                <c:pt idx="20">
                  <c:v>2.0634920634920607E-2</c:v>
                </c:pt>
              </c:numCache>
            </c:numRef>
          </c:val>
        </c:ser>
        <c:marker val="1"/>
        <c:axId val="159568640"/>
        <c:axId val="159570176"/>
      </c:lineChart>
      <c:catAx>
        <c:axId val="159568640"/>
        <c:scaling>
          <c:orientation val="minMax"/>
        </c:scaling>
        <c:axPos val="b"/>
        <c:numFmt formatCode="0.0_ " sourceLinked="1"/>
        <c:tickLblPos val="nextTo"/>
        <c:crossAx val="159570176"/>
        <c:crosses val="autoZero"/>
        <c:auto val="1"/>
        <c:lblAlgn val="ctr"/>
        <c:lblOffset val="100"/>
        <c:tickLblSkip val="5"/>
        <c:tickMarkSkip val="5"/>
      </c:catAx>
      <c:valAx>
        <c:axId val="15957017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9568640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 L4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L4_0.02_5%'!$B$104</c:f>
              <c:strCache>
                <c:ptCount val="1"/>
                <c:pt idx="0">
                  <c:v>N2_L4_0601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B$105:$B$125</c:f>
              <c:numCache>
                <c:formatCode>General</c:formatCode>
                <c:ptCount val="21"/>
                <c:pt idx="1">
                  <c:v>0.141666666666667</c:v>
                </c:pt>
                <c:pt idx="2">
                  <c:v>0.1</c:v>
                </c:pt>
                <c:pt idx="3">
                  <c:v>0.108333333333333</c:v>
                </c:pt>
                <c:pt idx="4">
                  <c:v>5.8333333333333348E-2</c:v>
                </c:pt>
                <c:pt idx="5">
                  <c:v>5.8333333333333348E-2</c:v>
                </c:pt>
                <c:pt idx="6">
                  <c:v>3.3333333333333298E-2</c:v>
                </c:pt>
                <c:pt idx="7">
                  <c:v>0.05</c:v>
                </c:pt>
                <c:pt idx="8">
                  <c:v>1.6666666666666701E-2</c:v>
                </c:pt>
                <c:pt idx="9">
                  <c:v>3.3333333333333298E-2</c:v>
                </c:pt>
                <c:pt idx="10">
                  <c:v>0.05</c:v>
                </c:pt>
                <c:pt idx="11">
                  <c:v>2.5000000000000001E-2</c:v>
                </c:pt>
                <c:pt idx="12">
                  <c:v>1.6666666666666701E-2</c:v>
                </c:pt>
                <c:pt idx="13">
                  <c:v>8.3333333333333297E-3</c:v>
                </c:pt>
                <c:pt idx="14">
                  <c:v>0</c:v>
                </c:pt>
                <c:pt idx="15">
                  <c:v>8.3333333333333297E-3</c:v>
                </c:pt>
                <c:pt idx="16">
                  <c:v>0</c:v>
                </c:pt>
                <c:pt idx="17">
                  <c:v>8.3333333333333297E-3</c:v>
                </c:pt>
                <c:pt idx="18">
                  <c:v>8.3333333333333297E-3</c:v>
                </c:pt>
                <c:pt idx="19">
                  <c:v>0</c:v>
                </c:pt>
                <c:pt idx="20">
                  <c:v>1.6666666666666701E-2</c:v>
                </c:pt>
              </c:numCache>
            </c:numRef>
          </c:val>
        </c:ser>
        <c:ser>
          <c:idx val="1"/>
          <c:order val="1"/>
          <c:tx>
            <c:strRef>
              <c:f>'N2 L4_0.02_5%'!$C$104</c:f>
              <c:strCache>
                <c:ptCount val="1"/>
                <c:pt idx="0">
                  <c:v>N2_L4_0602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C$105:$C$125</c:f>
              <c:numCache>
                <c:formatCode>General</c:formatCode>
                <c:ptCount val="21"/>
                <c:pt idx="1">
                  <c:v>6.833878589603784E-2</c:v>
                </c:pt>
                <c:pt idx="2">
                  <c:v>9.5601599418393357E-2</c:v>
                </c:pt>
                <c:pt idx="3">
                  <c:v>0.113413304252999</c:v>
                </c:pt>
                <c:pt idx="4">
                  <c:v>0.124318429661941</c:v>
                </c:pt>
                <c:pt idx="5">
                  <c:v>0.10069065794256604</c:v>
                </c:pt>
                <c:pt idx="6">
                  <c:v>8.7968011632133733E-2</c:v>
                </c:pt>
                <c:pt idx="7">
                  <c:v>7.3427844420210803E-2</c:v>
                </c:pt>
                <c:pt idx="8">
                  <c:v>6.397673573246089E-2</c:v>
                </c:pt>
                <c:pt idx="9">
                  <c:v>4.7982551799345727E-2</c:v>
                </c:pt>
                <c:pt idx="10">
                  <c:v>3.4896401308615099E-2</c:v>
                </c:pt>
                <c:pt idx="11">
                  <c:v>3.2715376226826624E-2</c:v>
                </c:pt>
                <c:pt idx="12">
                  <c:v>2.3264267539076712E-2</c:v>
                </c:pt>
                <c:pt idx="13">
                  <c:v>1.4176663031624891E-2</c:v>
                </c:pt>
                <c:pt idx="14">
                  <c:v>1.38131588513268E-2</c:v>
                </c:pt>
                <c:pt idx="15">
                  <c:v>9.8146128680479897E-3</c:v>
                </c:pt>
                <c:pt idx="16">
                  <c:v>7.2700836059614755E-3</c:v>
                </c:pt>
                <c:pt idx="17">
                  <c:v>6.9065794256634077E-3</c:v>
                </c:pt>
                <c:pt idx="18">
                  <c:v>5.4525627044711067E-3</c:v>
                </c:pt>
                <c:pt idx="19">
                  <c:v>3.99854598327881E-3</c:v>
                </c:pt>
                <c:pt idx="20">
                  <c:v>1.4540167211922912E-3</c:v>
                </c:pt>
              </c:numCache>
            </c:numRef>
          </c:val>
        </c:ser>
        <c:ser>
          <c:idx val="2"/>
          <c:order val="2"/>
          <c:tx>
            <c:strRef>
              <c:f>'N2 L4_0.02_5%'!$D$104</c:f>
              <c:strCache>
                <c:ptCount val="1"/>
                <c:pt idx="0">
                  <c:v>N2_L4_0603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D$105:$D$125</c:f>
              <c:numCache>
                <c:formatCode>General</c:formatCode>
                <c:ptCount val="21"/>
                <c:pt idx="1">
                  <c:v>9.8389982110912447E-2</c:v>
                </c:pt>
                <c:pt idx="2">
                  <c:v>9.8389982110912447E-2</c:v>
                </c:pt>
                <c:pt idx="3">
                  <c:v>0.11091234347048302</c:v>
                </c:pt>
                <c:pt idx="4">
                  <c:v>0.10375670840787105</c:v>
                </c:pt>
                <c:pt idx="5">
                  <c:v>6.6189624329159202E-2</c:v>
                </c:pt>
                <c:pt idx="6">
                  <c:v>6.2611806797853289E-2</c:v>
                </c:pt>
                <c:pt idx="7">
                  <c:v>4.4722719141323856E-2</c:v>
                </c:pt>
                <c:pt idx="8">
                  <c:v>4.2933810375670796E-2</c:v>
                </c:pt>
                <c:pt idx="9">
                  <c:v>3.3989266547406097E-2</c:v>
                </c:pt>
                <c:pt idx="10">
                  <c:v>3.0411449016100212E-2</c:v>
                </c:pt>
                <c:pt idx="11">
                  <c:v>2.5044722719141314E-2</c:v>
                </c:pt>
                <c:pt idx="12">
                  <c:v>1.6100178890876612E-2</c:v>
                </c:pt>
                <c:pt idx="13">
                  <c:v>1.4311270125223598E-2</c:v>
                </c:pt>
                <c:pt idx="14">
                  <c:v>1.6100178890876612E-2</c:v>
                </c:pt>
                <c:pt idx="15">
                  <c:v>1.4311270125223598E-2</c:v>
                </c:pt>
                <c:pt idx="16">
                  <c:v>1.7889087656529506E-3</c:v>
                </c:pt>
                <c:pt idx="17">
                  <c:v>5.3667262969588504E-3</c:v>
                </c:pt>
                <c:pt idx="18">
                  <c:v>1.7889087656529506E-3</c:v>
                </c:pt>
                <c:pt idx="19">
                  <c:v>1.7889087656529506E-3</c:v>
                </c:pt>
                <c:pt idx="20">
                  <c:v>1.7889087656529506E-3</c:v>
                </c:pt>
              </c:numCache>
            </c:numRef>
          </c:val>
        </c:ser>
        <c:ser>
          <c:idx val="3"/>
          <c:order val="3"/>
          <c:tx>
            <c:strRef>
              <c:f>'N2 L4_0.02_5%'!$E$104</c:f>
              <c:strCache>
                <c:ptCount val="1"/>
                <c:pt idx="0">
                  <c:v>N2_L4_0604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E$105:$E$125</c:f>
              <c:numCache>
                <c:formatCode>General</c:formatCode>
                <c:ptCount val="21"/>
                <c:pt idx="1">
                  <c:v>5.7142857142857099E-2</c:v>
                </c:pt>
                <c:pt idx="2">
                  <c:v>9.2063492063492194E-2</c:v>
                </c:pt>
                <c:pt idx="3">
                  <c:v>0.11519274376417209</c:v>
                </c:pt>
                <c:pt idx="4">
                  <c:v>0.118367346938776</c:v>
                </c:pt>
                <c:pt idx="5">
                  <c:v>0.13922902494331091</c:v>
                </c:pt>
                <c:pt idx="6">
                  <c:v>7.301587301587302E-2</c:v>
                </c:pt>
                <c:pt idx="7">
                  <c:v>6.21315192743764E-2</c:v>
                </c:pt>
                <c:pt idx="8">
                  <c:v>7.2562358276644007E-2</c:v>
                </c:pt>
                <c:pt idx="9">
                  <c:v>5.9410430839002382E-2</c:v>
                </c:pt>
                <c:pt idx="10">
                  <c:v>4.4897959183673522E-2</c:v>
                </c:pt>
                <c:pt idx="11">
                  <c:v>3.6281179138322024E-2</c:v>
                </c:pt>
                <c:pt idx="12">
                  <c:v>1.8140589569161022E-2</c:v>
                </c:pt>
                <c:pt idx="13">
                  <c:v>2.0861678004535113E-2</c:v>
                </c:pt>
                <c:pt idx="14">
                  <c:v>8.1632653061224497E-3</c:v>
                </c:pt>
                <c:pt idx="15">
                  <c:v>1.1337868480725601E-2</c:v>
                </c:pt>
                <c:pt idx="16">
                  <c:v>9.0702947845805008E-3</c:v>
                </c:pt>
                <c:pt idx="17">
                  <c:v>4.0816326530612231E-3</c:v>
                </c:pt>
                <c:pt idx="18">
                  <c:v>5.4421768707482972E-3</c:v>
                </c:pt>
                <c:pt idx="19">
                  <c:v>3.1746031746031698E-3</c:v>
                </c:pt>
                <c:pt idx="20">
                  <c:v>3.1746031746031698E-3</c:v>
                </c:pt>
              </c:numCache>
            </c:numRef>
          </c:val>
        </c:ser>
        <c:ser>
          <c:idx val="4"/>
          <c:order val="4"/>
          <c:tx>
            <c:strRef>
              <c:f>'N2 L4_0.02_5%'!$F$104</c:f>
              <c:strCache>
                <c:ptCount val="1"/>
                <c:pt idx="0">
                  <c:v>N2_L4_0605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F$105:$F$125</c:f>
              <c:numCache>
                <c:formatCode>General</c:formatCode>
                <c:ptCount val="21"/>
                <c:pt idx="1">
                  <c:v>6.2040816326530614E-2</c:v>
                </c:pt>
                <c:pt idx="2">
                  <c:v>0.10530612244898009</c:v>
                </c:pt>
                <c:pt idx="3">
                  <c:v>0.115918367346939</c:v>
                </c:pt>
                <c:pt idx="4">
                  <c:v>0.12952380952380993</c:v>
                </c:pt>
                <c:pt idx="5">
                  <c:v>0.12163265306122412</c:v>
                </c:pt>
                <c:pt idx="6">
                  <c:v>8.1904761904761883E-2</c:v>
                </c:pt>
                <c:pt idx="7">
                  <c:v>6.6122448979591797E-2</c:v>
                </c:pt>
                <c:pt idx="8">
                  <c:v>5.9591836734693912E-2</c:v>
                </c:pt>
                <c:pt idx="9">
                  <c:v>5.6598639455782328E-2</c:v>
                </c:pt>
                <c:pt idx="10">
                  <c:v>4.7346938775510224E-2</c:v>
                </c:pt>
                <c:pt idx="11">
                  <c:v>2.9931972789115635E-2</c:v>
                </c:pt>
                <c:pt idx="12">
                  <c:v>2.4761904761904801E-2</c:v>
                </c:pt>
                <c:pt idx="13">
                  <c:v>1.7959183673469402E-2</c:v>
                </c:pt>
                <c:pt idx="14">
                  <c:v>9.7959183673469452E-3</c:v>
                </c:pt>
                <c:pt idx="15">
                  <c:v>9.2517006802721059E-3</c:v>
                </c:pt>
                <c:pt idx="16">
                  <c:v>5.4421768707482972E-3</c:v>
                </c:pt>
                <c:pt idx="17">
                  <c:v>3.2653061224489814E-3</c:v>
                </c:pt>
                <c:pt idx="18">
                  <c:v>5.1700680272108827E-3</c:v>
                </c:pt>
                <c:pt idx="19">
                  <c:v>3.8095238095238113E-3</c:v>
                </c:pt>
                <c:pt idx="20">
                  <c:v>2.9931972789115639E-3</c:v>
                </c:pt>
              </c:numCache>
            </c:numRef>
          </c:val>
        </c:ser>
        <c:ser>
          <c:idx val="5"/>
          <c:order val="5"/>
          <c:tx>
            <c:strRef>
              <c:f>'N2 L4_0.02_5%'!$G$104</c:f>
              <c:strCache>
                <c:ptCount val="1"/>
                <c:pt idx="0">
                  <c:v>N2_L4_0606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G$105:$G$125</c:f>
              <c:numCache>
                <c:formatCode>General</c:formatCode>
                <c:ptCount val="21"/>
                <c:pt idx="1">
                  <c:v>6.3204646395626896E-2</c:v>
                </c:pt>
                <c:pt idx="2">
                  <c:v>9.8394260334813896E-2</c:v>
                </c:pt>
                <c:pt idx="3">
                  <c:v>0.10796036897847602</c:v>
                </c:pt>
                <c:pt idx="4">
                  <c:v>0.116843184147591</c:v>
                </c:pt>
                <c:pt idx="5">
                  <c:v>0.13221728732490609</c:v>
                </c:pt>
                <c:pt idx="6">
                  <c:v>7.1062521352921168E-2</c:v>
                </c:pt>
                <c:pt idx="7">
                  <c:v>6.7646053980184501E-2</c:v>
                </c:pt>
                <c:pt idx="8">
                  <c:v>6.1154765971984965E-2</c:v>
                </c:pt>
                <c:pt idx="9">
                  <c:v>5.5346771438332831E-2</c:v>
                </c:pt>
                <c:pt idx="10">
                  <c:v>3.7922787837376203E-2</c:v>
                </c:pt>
                <c:pt idx="11">
                  <c:v>3.3481380252818604E-2</c:v>
                </c:pt>
                <c:pt idx="12">
                  <c:v>2.3915271609156099E-2</c:v>
                </c:pt>
                <c:pt idx="13">
                  <c:v>2.3915271609156099E-2</c:v>
                </c:pt>
                <c:pt idx="14">
                  <c:v>1.6740690126409302E-2</c:v>
                </c:pt>
                <c:pt idx="15">
                  <c:v>1.0249402118209799E-2</c:v>
                </c:pt>
                <c:pt idx="16">
                  <c:v>6.1496412709258633E-3</c:v>
                </c:pt>
                <c:pt idx="17">
                  <c:v>7.8578749572941597E-3</c:v>
                </c:pt>
                <c:pt idx="18">
                  <c:v>3.7581141100102517E-3</c:v>
                </c:pt>
                <c:pt idx="19">
                  <c:v>2.7331738981892727E-3</c:v>
                </c:pt>
                <c:pt idx="20">
                  <c:v>3.7581141100102517E-3</c:v>
                </c:pt>
              </c:numCache>
            </c:numRef>
          </c:val>
        </c:ser>
        <c:ser>
          <c:idx val="6"/>
          <c:order val="6"/>
          <c:tx>
            <c:strRef>
              <c:f>'N2 L4_0.02_5%'!$H$104</c:f>
              <c:strCache>
                <c:ptCount val="1"/>
                <c:pt idx="0">
                  <c:v>N2_L4_0607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H$105:$H$125</c:f>
              <c:numCache>
                <c:formatCode>General</c:formatCode>
                <c:ptCount val="21"/>
              </c:numCache>
            </c:numRef>
          </c:val>
        </c:ser>
        <c:ser>
          <c:idx val="7"/>
          <c:order val="7"/>
          <c:tx>
            <c:strRef>
              <c:f>'N2 L4_0.02_5%'!$I$104</c:f>
              <c:strCache>
                <c:ptCount val="1"/>
                <c:pt idx="0">
                  <c:v>N2_L4_0608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I$105:$I$125</c:f>
              <c:numCache>
                <c:formatCode>General</c:formatCode>
                <c:ptCount val="21"/>
                <c:pt idx="1">
                  <c:v>8.6666666666666781E-2</c:v>
                </c:pt>
                <c:pt idx="2">
                  <c:v>0.10416666666666705</c:v>
                </c:pt>
                <c:pt idx="3">
                  <c:v>0.10666666666666708</c:v>
                </c:pt>
                <c:pt idx="4">
                  <c:v>0.11666666666666704</c:v>
                </c:pt>
                <c:pt idx="5">
                  <c:v>0.11666666666666704</c:v>
                </c:pt>
                <c:pt idx="6">
                  <c:v>8.4166666666666765E-2</c:v>
                </c:pt>
                <c:pt idx="7">
                  <c:v>6.3333333333333366E-2</c:v>
                </c:pt>
                <c:pt idx="8">
                  <c:v>4.5833333333333351E-2</c:v>
                </c:pt>
                <c:pt idx="9">
                  <c:v>3.6666666666666702E-2</c:v>
                </c:pt>
                <c:pt idx="10">
                  <c:v>3.1666666666666697E-2</c:v>
                </c:pt>
                <c:pt idx="11">
                  <c:v>2.416666666666669E-2</c:v>
                </c:pt>
                <c:pt idx="12">
                  <c:v>2.5000000000000001E-2</c:v>
                </c:pt>
                <c:pt idx="13">
                  <c:v>1.0833333333333301E-2</c:v>
                </c:pt>
                <c:pt idx="14">
                  <c:v>1.1666666666666707E-2</c:v>
                </c:pt>
                <c:pt idx="15">
                  <c:v>1.0833333333333301E-2</c:v>
                </c:pt>
                <c:pt idx="16">
                  <c:v>9.1666666666666806E-3</c:v>
                </c:pt>
                <c:pt idx="17">
                  <c:v>5.8333333333333362E-3</c:v>
                </c:pt>
                <c:pt idx="18">
                  <c:v>5.0000000000000027E-3</c:v>
                </c:pt>
                <c:pt idx="19">
                  <c:v>5.8333333333333362E-3</c:v>
                </c:pt>
                <c:pt idx="20">
                  <c:v>3.3333333333333314E-3</c:v>
                </c:pt>
              </c:numCache>
            </c:numRef>
          </c:val>
        </c:ser>
        <c:ser>
          <c:idx val="8"/>
          <c:order val="8"/>
          <c:tx>
            <c:strRef>
              <c:f>'N2 L4_0.02_5%'!$J$104</c:f>
              <c:strCache>
                <c:ptCount val="1"/>
                <c:pt idx="0">
                  <c:v>N2_L4_0609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J$105:$J$125</c:f>
              <c:numCache>
                <c:formatCode>General</c:formatCode>
                <c:ptCount val="21"/>
                <c:pt idx="1">
                  <c:v>5.9055118110236199E-2</c:v>
                </c:pt>
                <c:pt idx="2">
                  <c:v>6.1304836895388112E-2</c:v>
                </c:pt>
                <c:pt idx="3">
                  <c:v>7.1428571428571411E-2</c:v>
                </c:pt>
                <c:pt idx="4">
                  <c:v>8.6051743532058508E-2</c:v>
                </c:pt>
                <c:pt idx="5">
                  <c:v>0.11642294713160908</c:v>
                </c:pt>
                <c:pt idx="6">
                  <c:v>0.10686164229471302</c:v>
                </c:pt>
                <c:pt idx="7">
                  <c:v>6.4679415073115906E-2</c:v>
                </c:pt>
                <c:pt idx="8">
                  <c:v>5.2868391451068655E-2</c:v>
                </c:pt>
                <c:pt idx="9">
                  <c:v>4.1057367829021432E-2</c:v>
                </c:pt>
                <c:pt idx="10">
                  <c:v>3.7120359955005601E-2</c:v>
                </c:pt>
                <c:pt idx="11">
                  <c:v>4.6681664791901001E-2</c:v>
                </c:pt>
                <c:pt idx="12">
                  <c:v>4.1057367829021432E-2</c:v>
                </c:pt>
                <c:pt idx="13">
                  <c:v>3.5995500562429734E-2</c:v>
                </c:pt>
                <c:pt idx="14">
                  <c:v>3.2620922384701899E-2</c:v>
                </c:pt>
                <c:pt idx="15">
                  <c:v>2.5309336332958399E-2</c:v>
                </c:pt>
                <c:pt idx="16">
                  <c:v>1.4060742407199098E-2</c:v>
                </c:pt>
                <c:pt idx="17">
                  <c:v>9.5613048368953964E-3</c:v>
                </c:pt>
                <c:pt idx="18">
                  <c:v>1.0123734533183401E-2</c:v>
                </c:pt>
                <c:pt idx="19">
                  <c:v>5.6242969628796423E-3</c:v>
                </c:pt>
                <c:pt idx="20">
                  <c:v>5.6242969628796423E-3</c:v>
                </c:pt>
              </c:numCache>
            </c:numRef>
          </c:val>
        </c:ser>
        <c:ser>
          <c:idx val="9"/>
          <c:order val="9"/>
          <c:tx>
            <c:strRef>
              <c:f>'N2 L4_0.02_5%'!$K$104</c:f>
              <c:strCache>
                <c:ptCount val="1"/>
                <c:pt idx="0">
                  <c:v>N2_L4_0611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K$105:$K$125</c:f>
              <c:numCache>
                <c:formatCode>General</c:formatCode>
                <c:ptCount val="21"/>
                <c:pt idx="1">
                  <c:v>7.2524407252440748E-2</c:v>
                </c:pt>
                <c:pt idx="2">
                  <c:v>9.4839609483960946E-2</c:v>
                </c:pt>
                <c:pt idx="3">
                  <c:v>0.13249651324965092</c:v>
                </c:pt>
                <c:pt idx="4">
                  <c:v>0.111576011157601</c:v>
                </c:pt>
                <c:pt idx="5">
                  <c:v>0.10460251046025108</c:v>
                </c:pt>
                <c:pt idx="6">
                  <c:v>9.065550906555099E-2</c:v>
                </c:pt>
                <c:pt idx="7">
                  <c:v>6.6945606694560705E-2</c:v>
                </c:pt>
                <c:pt idx="8">
                  <c:v>4.6025104602510469E-2</c:v>
                </c:pt>
                <c:pt idx="9">
                  <c:v>4.4630404463040424E-2</c:v>
                </c:pt>
                <c:pt idx="10">
                  <c:v>2.5104602510460317E-2</c:v>
                </c:pt>
                <c:pt idx="11">
                  <c:v>1.5341701534170206E-2</c:v>
                </c:pt>
                <c:pt idx="12">
                  <c:v>1.9525801952580212E-2</c:v>
                </c:pt>
                <c:pt idx="13">
                  <c:v>1.6736401673640201E-2</c:v>
                </c:pt>
                <c:pt idx="14">
                  <c:v>1.2552301255230106E-2</c:v>
                </c:pt>
                <c:pt idx="15">
                  <c:v>9.7629009762901005E-3</c:v>
                </c:pt>
                <c:pt idx="16">
                  <c:v>8.3682008368200864E-3</c:v>
                </c:pt>
                <c:pt idx="17">
                  <c:v>1.1157601115760106E-2</c:v>
                </c:pt>
                <c:pt idx="18">
                  <c:v>2.7894002789400339E-3</c:v>
                </c:pt>
                <c:pt idx="19">
                  <c:v>1.3947001394700113E-3</c:v>
                </c:pt>
                <c:pt idx="20">
                  <c:v>2.7894002789400339E-3</c:v>
                </c:pt>
              </c:numCache>
            </c:numRef>
          </c:val>
        </c:ser>
        <c:ser>
          <c:idx val="10"/>
          <c:order val="10"/>
          <c:tx>
            <c:strRef>
              <c:f>'N2 L4_0.02_5%'!$L$104</c:f>
              <c:strCache>
                <c:ptCount val="1"/>
                <c:pt idx="0">
                  <c:v>N2_L4_0612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L$105:$L$125</c:f>
              <c:numCache>
                <c:formatCode>General</c:formatCode>
                <c:ptCount val="21"/>
                <c:pt idx="1">
                  <c:v>8.1876724931002801E-2</c:v>
                </c:pt>
                <c:pt idx="2">
                  <c:v>0.11407543698252104</c:v>
                </c:pt>
                <c:pt idx="3">
                  <c:v>0.11683532658693704</c:v>
                </c:pt>
                <c:pt idx="4">
                  <c:v>0.12327506899724004</c:v>
                </c:pt>
                <c:pt idx="5">
                  <c:v>0.11315547378104907</c:v>
                </c:pt>
                <c:pt idx="6">
                  <c:v>6.347746090156392E-2</c:v>
                </c:pt>
                <c:pt idx="7">
                  <c:v>5.7037718491260402E-2</c:v>
                </c:pt>
                <c:pt idx="8">
                  <c:v>5.1517939282428732E-2</c:v>
                </c:pt>
                <c:pt idx="9">
                  <c:v>5.1517939282428732E-2</c:v>
                </c:pt>
                <c:pt idx="10">
                  <c:v>3.31186752529899E-2</c:v>
                </c:pt>
                <c:pt idx="11">
                  <c:v>2.7598896044158189E-2</c:v>
                </c:pt>
                <c:pt idx="12">
                  <c:v>2.1159153633854601E-2</c:v>
                </c:pt>
                <c:pt idx="13">
                  <c:v>1.195952161913522E-2</c:v>
                </c:pt>
                <c:pt idx="14">
                  <c:v>1.28794848206072E-2</c:v>
                </c:pt>
                <c:pt idx="15">
                  <c:v>1.195952161913522E-2</c:v>
                </c:pt>
                <c:pt idx="16">
                  <c:v>5.5197792088316541E-3</c:v>
                </c:pt>
                <c:pt idx="17">
                  <c:v>6.4397424103035993E-3</c:v>
                </c:pt>
                <c:pt idx="18">
                  <c:v>3.6798528058877601E-3</c:v>
                </c:pt>
                <c:pt idx="19">
                  <c:v>3.6798528058877601E-3</c:v>
                </c:pt>
                <c:pt idx="20">
                  <c:v>1.8399264029438801E-3</c:v>
                </c:pt>
              </c:numCache>
            </c:numRef>
          </c:val>
        </c:ser>
        <c:ser>
          <c:idx val="11"/>
          <c:order val="11"/>
          <c:tx>
            <c:strRef>
              <c:f>'N2 L4_0.02_5%'!$M$104</c:f>
              <c:strCache>
                <c:ptCount val="1"/>
                <c:pt idx="0">
                  <c:v>N2_L4_0613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M$105:$M$125</c:f>
              <c:numCache>
                <c:formatCode>General</c:formatCode>
                <c:ptCount val="21"/>
                <c:pt idx="1">
                  <c:v>6.8085106382978697E-2</c:v>
                </c:pt>
                <c:pt idx="2">
                  <c:v>8.0851063829787226E-2</c:v>
                </c:pt>
                <c:pt idx="3">
                  <c:v>0.13475177304964492</c:v>
                </c:pt>
                <c:pt idx="4">
                  <c:v>0.12765957446808485</c:v>
                </c:pt>
                <c:pt idx="5">
                  <c:v>0.15319148936170213</c:v>
                </c:pt>
                <c:pt idx="6">
                  <c:v>8.2269503546099298E-2</c:v>
                </c:pt>
                <c:pt idx="7">
                  <c:v>5.8156028368794299E-2</c:v>
                </c:pt>
                <c:pt idx="8">
                  <c:v>4.5390070921985839E-2</c:v>
                </c:pt>
                <c:pt idx="9">
                  <c:v>5.3900709219858185E-2</c:v>
                </c:pt>
                <c:pt idx="10">
                  <c:v>4.8226950354609895E-2</c:v>
                </c:pt>
                <c:pt idx="11">
                  <c:v>2.5531914893617006E-2</c:v>
                </c:pt>
                <c:pt idx="12">
                  <c:v>1.2765957446808501E-2</c:v>
                </c:pt>
                <c:pt idx="13">
                  <c:v>2.6950354609929124E-2</c:v>
                </c:pt>
                <c:pt idx="14">
                  <c:v>9.9290780141844028E-3</c:v>
                </c:pt>
                <c:pt idx="15">
                  <c:v>1.2765957446808501E-2</c:v>
                </c:pt>
                <c:pt idx="16">
                  <c:v>1.2765957446808501E-2</c:v>
                </c:pt>
                <c:pt idx="17">
                  <c:v>5.6737588652482325E-3</c:v>
                </c:pt>
                <c:pt idx="18">
                  <c:v>1.4184397163120599E-3</c:v>
                </c:pt>
                <c:pt idx="19">
                  <c:v>1.4184397163120599E-3</c:v>
                </c:pt>
                <c:pt idx="20">
                  <c:v>7.0921985815602826E-3</c:v>
                </c:pt>
              </c:numCache>
            </c:numRef>
          </c:val>
        </c:ser>
        <c:ser>
          <c:idx val="12"/>
          <c:order val="12"/>
          <c:tx>
            <c:strRef>
              <c:f>'N2 L4_0.02_5%'!$N$104</c:f>
              <c:strCache>
                <c:ptCount val="1"/>
                <c:pt idx="0">
                  <c:v>N2_L4_0614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N$105:$N$125</c:f>
              <c:numCache>
                <c:formatCode>General</c:formatCode>
                <c:ptCount val="21"/>
                <c:pt idx="1">
                  <c:v>7.1248650593738694E-2</c:v>
                </c:pt>
                <c:pt idx="2">
                  <c:v>7.8085642317380397E-2</c:v>
                </c:pt>
                <c:pt idx="3">
                  <c:v>0.10831234256927004</c:v>
                </c:pt>
                <c:pt idx="4">
                  <c:v>0.11586901763224196</c:v>
                </c:pt>
                <c:pt idx="5">
                  <c:v>0.12954300107952499</c:v>
                </c:pt>
                <c:pt idx="6">
                  <c:v>7.9165167326376421E-2</c:v>
                </c:pt>
                <c:pt idx="7">
                  <c:v>5.2896725440806057E-2</c:v>
                </c:pt>
                <c:pt idx="8">
                  <c:v>6.0453400503778329E-2</c:v>
                </c:pt>
                <c:pt idx="9">
                  <c:v>5.0377833753148651E-2</c:v>
                </c:pt>
                <c:pt idx="10">
                  <c:v>4.49802087081684E-2</c:v>
                </c:pt>
                <c:pt idx="11">
                  <c:v>3.1666066930550595E-2</c:v>
                </c:pt>
                <c:pt idx="12">
                  <c:v>3.1306225260885202E-2</c:v>
                </c:pt>
                <c:pt idx="13">
                  <c:v>1.7632241813602002E-2</c:v>
                </c:pt>
                <c:pt idx="14">
                  <c:v>2.0870816840590115E-2</c:v>
                </c:pt>
                <c:pt idx="15">
                  <c:v>1.3314141777617807E-2</c:v>
                </c:pt>
                <c:pt idx="16">
                  <c:v>1.0435408420295099E-2</c:v>
                </c:pt>
                <c:pt idx="17">
                  <c:v>5.3976250449802102E-3</c:v>
                </c:pt>
                <c:pt idx="18">
                  <c:v>6.1173083843109027E-3</c:v>
                </c:pt>
                <c:pt idx="19">
                  <c:v>4.3181000359841732E-3</c:v>
                </c:pt>
                <c:pt idx="20">
                  <c:v>4.6779417056495125E-3</c:v>
                </c:pt>
              </c:numCache>
            </c:numRef>
          </c:val>
        </c:ser>
        <c:ser>
          <c:idx val="13"/>
          <c:order val="13"/>
          <c:tx>
            <c:strRef>
              <c:f>'N2 L4_0.02_5%'!$O$104</c:f>
              <c:strCache>
                <c:ptCount val="1"/>
                <c:pt idx="0">
                  <c:v>N2_L4_0615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O$105:$O$125</c:f>
              <c:numCache>
                <c:formatCode>General</c:formatCode>
                <c:ptCount val="21"/>
                <c:pt idx="1">
                  <c:v>6.6377675426713634E-2</c:v>
                </c:pt>
                <c:pt idx="2">
                  <c:v>9.807640205906272E-2</c:v>
                </c:pt>
                <c:pt idx="3">
                  <c:v>0.11514494716878899</c:v>
                </c:pt>
                <c:pt idx="4">
                  <c:v>0.128691411541588</c:v>
                </c:pt>
                <c:pt idx="5">
                  <c:v>0.12679490652939612</c:v>
                </c:pt>
                <c:pt idx="6">
                  <c:v>8.3988079111351893E-2</c:v>
                </c:pt>
                <c:pt idx="7">
                  <c:v>7.7756705499864506E-2</c:v>
                </c:pt>
                <c:pt idx="8">
                  <c:v>6.0417231102682246E-2</c:v>
                </c:pt>
                <c:pt idx="9">
                  <c:v>5.4456786778650804E-2</c:v>
                </c:pt>
                <c:pt idx="10">
                  <c:v>3.3324302357084799E-2</c:v>
                </c:pt>
                <c:pt idx="11">
                  <c:v>3.2782443782172918E-2</c:v>
                </c:pt>
                <c:pt idx="12">
                  <c:v>1.9777837984286107E-2</c:v>
                </c:pt>
                <c:pt idx="13">
                  <c:v>1.7339474397182312E-2</c:v>
                </c:pt>
                <c:pt idx="14">
                  <c:v>9.2115957735031204E-3</c:v>
                </c:pt>
                <c:pt idx="15">
                  <c:v>8.669737198591175E-3</c:v>
                </c:pt>
                <c:pt idx="16">
                  <c:v>6.7732321863993566E-3</c:v>
                </c:pt>
                <c:pt idx="17">
                  <c:v>3.7930100243836412E-3</c:v>
                </c:pt>
                <c:pt idx="18">
                  <c:v>2.9802221620157114E-3</c:v>
                </c:pt>
                <c:pt idx="19">
                  <c:v>1.6255757247358416E-3</c:v>
                </c:pt>
                <c:pt idx="20">
                  <c:v>2.1674342996477933E-3</c:v>
                </c:pt>
              </c:numCache>
            </c:numRef>
          </c:val>
        </c:ser>
        <c:ser>
          <c:idx val="14"/>
          <c:order val="14"/>
          <c:tx>
            <c:strRef>
              <c:f>'N2 L4_0.02_5%'!$P$104</c:f>
              <c:strCache>
                <c:ptCount val="1"/>
                <c:pt idx="0">
                  <c:v>N2_L4_0616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P$105:$P$125</c:f>
              <c:numCache>
                <c:formatCode>General</c:formatCode>
                <c:ptCount val="21"/>
                <c:pt idx="1">
                  <c:v>7.7825159914712214E-2</c:v>
                </c:pt>
                <c:pt idx="2">
                  <c:v>7.5692963752665335E-2</c:v>
                </c:pt>
                <c:pt idx="3">
                  <c:v>8.6353944562899868E-2</c:v>
                </c:pt>
                <c:pt idx="4">
                  <c:v>0.11194029850746295</c:v>
                </c:pt>
                <c:pt idx="5">
                  <c:v>0.11407249466951</c:v>
                </c:pt>
                <c:pt idx="6">
                  <c:v>7.1428571428571411E-2</c:v>
                </c:pt>
                <c:pt idx="7">
                  <c:v>5.22388059701493E-2</c:v>
                </c:pt>
                <c:pt idx="8">
                  <c:v>5.5437100213219598E-2</c:v>
                </c:pt>
                <c:pt idx="9">
                  <c:v>4.9040511727078913E-2</c:v>
                </c:pt>
                <c:pt idx="10">
                  <c:v>4.0511727078891328E-2</c:v>
                </c:pt>
                <c:pt idx="11">
                  <c:v>2.5586353944562885E-2</c:v>
                </c:pt>
                <c:pt idx="12">
                  <c:v>1.7057569296375311E-2</c:v>
                </c:pt>
                <c:pt idx="13">
                  <c:v>1.8123667377398699E-2</c:v>
                </c:pt>
                <c:pt idx="14">
                  <c:v>2.0255863539445602E-2</c:v>
                </c:pt>
                <c:pt idx="15">
                  <c:v>2.2388059701492487E-2</c:v>
                </c:pt>
                <c:pt idx="16">
                  <c:v>1.2793176972281398E-2</c:v>
                </c:pt>
                <c:pt idx="17">
                  <c:v>8.5287846481876366E-3</c:v>
                </c:pt>
                <c:pt idx="18">
                  <c:v>9.5948827292110898E-3</c:v>
                </c:pt>
                <c:pt idx="19">
                  <c:v>8.5287846481876366E-3</c:v>
                </c:pt>
                <c:pt idx="20">
                  <c:v>5.3304904051172742E-3</c:v>
                </c:pt>
              </c:numCache>
            </c:numRef>
          </c:val>
        </c:ser>
        <c:ser>
          <c:idx val="15"/>
          <c:order val="15"/>
          <c:tx>
            <c:strRef>
              <c:f>'N2 L4_0.02_5%'!$Q$104</c:f>
              <c:strCache>
                <c:ptCount val="1"/>
                <c:pt idx="0">
                  <c:v>N2_L4_0617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Q$105:$Q$125</c:f>
              <c:numCache>
                <c:formatCode>General</c:formatCode>
                <c:ptCount val="21"/>
                <c:pt idx="1">
                  <c:v>0.16216216216216209</c:v>
                </c:pt>
                <c:pt idx="2">
                  <c:v>5.4054054054054113E-2</c:v>
                </c:pt>
                <c:pt idx="3">
                  <c:v>5.4054054054054113E-2</c:v>
                </c:pt>
                <c:pt idx="4">
                  <c:v>0</c:v>
                </c:pt>
                <c:pt idx="5">
                  <c:v>5.4054054054054113E-2</c:v>
                </c:pt>
                <c:pt idx="6">
                  <c:v>2.7027027027027022E-2</c:v>
                </c:pt>
                <c:pt idx="7">
                  <c:v>2.7027027027027022E-2</c:v>
                </c:pt>
                <c:pt idx="8">
                  <c:v>5.4054054054054113E-2</c:v>
                </c:pt>
                <c:pt idx="9">
                  <c:v>0</c:v>
                </c:pt>
                <c:pt idx="10">
                  <c:v>0</c:v>
                </c:pt>
                <c:pt idx="11">
                  <c:v>2.7027027027027022E-2</c:v>
                </c:pt>
                <c:pt idx="12">
                  <c:v>0</c:v>
                </c:pt>
                <c:pt idx="13">
                  <c:v>0</c:v>
                </c:pt>
                <c:pt idx="14">
                  <c:v>2.7027027027027022E-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N2 L4_0.02_5%'!$R$104</c:f>
              <c:strCache>
                <c:ptCount val="1"/>
                <c:pt idx="0">
                  <c:v>N2_L4_0618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R$105:$R$125</c:f>
              <c:numCache>
                <c:formatCode>General</c:formatCode>
                <c:ptCount val="21"/>
                <c:pt idx="1">
                  <c:v>6.2451412282974877E-2</c:v>
                </c:pt>
                <c:pt idx="2">
                  <c:v>9.6138896087069256E-2</c:v>
                </c:pt>
                <c:pt idx="3">
                  <c:v>0.11609225187872504</c:v>
                </c:pt>
                <c:pt idx="4">
                  <c:v>0.120497538222337</c:v>
                </c:pt>
                <c:pt idx="5">
                  <c:v>0.122829748639544</c:v>
                </c:pt>
                <c:pt idx="6">
                  <c:v>7.8776885203420632E-2</c:v>
                </c:pt>
                <c:pt idx="7">
                  <c:v>7.1780253951801043E-2</c:v>
                </c:pt>
                <c:pt idx="8">
                  <c:v>6.478362270018144E-2</c:v>
                </c:pt>
                <c:pt idx="9">
                  <c:v>5.9082663902565447E-2</c:v>
                </c:pt>
                <c:pt idx="10">
                  <c:v>4.6644208344130571E-2</c:v>
                </c:pt>
                <c:pt idx="11">
                  <c:v>3.7315366675304523E-2</c:v>
                </c:pt>
                <c:pt idx="12">
                  <c:v>2.254470069966312E-2</c:v>
                </c:pt>
                <c:pt idx="13">
                  <c:v>1.9175952319253703E-2</c:v>
                </c:pt>
                <c:pt idx="14">
                  <c:v>1.0365379632029006E-2</c:v>
                </c:pt>
                <c:pt idx="15">
                  <c:v>9.8471106504275704E-3</c:v>
                </c:pt>
                <c:pt idx="16">
                  <c:v>5.4418243068152404E-3</c:v>
                </c:pt>
                <c:pt idx="17">
                  <c:v>4.405286343612343E-3</c:v>
                </c:pt>
                <c:pt idx="18">
                  <c:v>3.627882871210162E-3</c:v>
                </c:pt>
                <c:pt idx="19">
                  <c:v>3.8870173620108826E-3</c:v>
                </c:pt>
                <c:pt idx="20">
                  <c:v>1.5548069448043512E-3</c:v>
                </c:pt>
              </c:numCache>
            </c:numRef>
          </c:val>
        </c:ser>
        <c:ser>
          <c:idx val="17"/>
          <c:order val="17"/>
          <c:tx>
            <c:strRef>
              <c:f>'N2 L4_0.02_5%'!$S$104</c:f>
              <c:strCache>
                <c:ptCount val="1"/>
                <c:pt idx="0">
                  <c:v>N2_L4_0619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S$105:$S$125</c:f>
              <c:numCache>
                <c:formatCode>General</c:formatCode>
                <c:ptCount val="21"/>
                <c:pt idx="1">
                  <c:v>7.7844311377245512E-2</c:v>
                </c:pt>
                <c:pt idx="2">
                  <c:v>5.6886227544910246E-2</c:v>
                </c:pt>
                <c:pt idx="3">
                  <c:v>8.9820359281437195E-2</c:v>
                </c:pt>
                <c:pt idx="4">
                  <c:v>8.0838323353293495E-2</c:v>
                </c:pt>
                <c:pt idx="5">
                  <c:v>7.185628742514974E-2</c:v>
                </c:pt>
                <c:pt idx="6">
                  <c:v>9.8802395209580868E-2</c:v>
                </c:pt>
                <c:pt idx="7">
                  <c:v>7.185628742514974E-2</c:v>
                </c:pt>
                <c:pt idx="8">
                  <c:v>2.6946107784431121E-2</c:v>
                </c:pt>
                <c:pt idx="9">
                  <c:v>3.2934131736526921E-2</c:v>
                </c:pt>
                <c:pt idx="10">
                  <c:v>4.1916167664670698E-2</c:v>
                </c:pt>
                <c:pt idx="11">
                  <c:v>1.7964071856287411E-2</c:v>
                </c:pt>
                <c:pt idx="12">
                  <c:v>3.2934131736526921E-2</c:v>
                </c:pt>
                <c:pt idx="13">
                  <c:v>2.0958083832335276E-2</c:v>
                </c:pt>
                <c:pt idx="14">
                  <c:v>2.3952095808383197E-2</c:v>
                </c:pt>
                <c:pt idx="15">
                  <c:v>1.49700598802395E-2</c:v>
                </c:pt>
                <c:pt idx="16">
                  <c:v>3.5928143712574814E-2</c:v>
                </c:pt>
                <c:pt idx="17">
                  <c:v>1.49700598802395E-2</c:v>
                </c:pt>
                <c:pt idx="18">
                  <c:v>1.1976047904191593E-2</c:v>
                </c:pt>
                <c:pt idx="19">
                  <c:v>5.9880239520958131E-3</c:v>
                </c:pt>
                <c:pt idx="20">
                  <c:v>2.0958083832335276E-2</c:v>
                </c:pt>
              </c:numCache>
            </c:numRef>
          </c:val>
        </c:ser>
        <c:ser>
          <c:idx val="18"/>
          <c:order val="18"/>
          <c:tx>
            <c:strRef>
              <c:f>'N2 L4_0.02_5%'!$T$104</c:f>
              <c:strCache>
                <c:ptCount val="1"/>
                <c:pt idx="0">
                  <c:v>N2_L4_0621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T$105:$T$125</c:f>
              <c:numCache>
                <c:formatCode>General</c:formatCode>
                <c:ptCount val="21"/>
                <c:pt idx="1">
                  <c:v>0.128205128205128</c:v>
                </c:pt>
                <c:pt idx="2">
                  <c:v>0.10256410256410305</c:v>
                </c:pt>
                <c:pt idx="3">
                  <c:v>7.6923076923076913E-2</c:v>
                </c:pt>
                <c:pt idx="4">
                  <c:v>0.15384615384615413</c:v>
                </c:pt>
                <c:pt idx="5">
                  <c:v>7.6923076923076913E-2</c:v>
                </c:pt>
                <c:pt idx="6">
                  <c:v>5.1282051282051301E-2</c:v>
                </c:pt>
                <c:pt idx="7">
                  <c:v>0.10256410256410305</c:v>
                </c:pt>
                <c:pt idx="8">
                  <c:v>2.5641025641025616E-2</c:v>
                </c:pt>
                <c:pt idx="9">
                  <c:v>2.5641025641025616E-2</c:v>
                </c:pt>
                <c:pt idx="10">
                  <c:v>2.5641025641025616E-2</c:v>
                </c:pt>
                <c:pt idx="11">
                  <c:v>2.5641025641025616E-2</c:v>
                </c:pt>
                <c:pt idx="12">
                  <c:v>0</c:v>
                </c:pt>
                <c:pt idx="13">
                  <c:v>0</c:v>
                </c:pt>
                <c:pt idx="14">
                  <c:v>2.5641025641025616E-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N2 L4_0.02_5%'!$U$104</c:f>
              <c:strCache>
                <c:ptCount val="1"/>
                <c:pt idx="0">
                  <c:v>N2_L4_0622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U$105:$U$125</c:f>
              <c:numCache>
                <c:formatCode>General</c:formatCode>
                <c:ptCount val="21"/>
                <c:pt idx="1">
                  <c:v>8.9316987740805584E-2</c:v>
                </c:pt>
                <c:pt idx="2">
                  <c:v>0.108581436077058</c:v>
                </c:pt>
                <c:pt idx="3">
                  <c:v>0.11908931698774096</c:v>
                </c:pt>
                <c:pt idx="4">
                  <c:v>0.13091068301225908</c:v>
                </c:pt>
                <c:pt idx="5">
                  <c:v>0.10070052539404598</c:v>
                </c:pt>
                <c:pt idx="6">
                  <c:v>8.143607705779328E-2</c:v>
                </c:pt>
                <c:pt idx="7">
                  <c:v>6.3047285464098102E-2</c:v>
                </c:pt>
                <c:pt idx="8">
                  <c:v>5.1225919439579673E-2</c:v>
                </c:pt>
                <c:pt idx="9">
                  <c:v>3.633975481611211E-2</c:v>
                </c:pt>
                <c:pt idx="10">
                  <c:v>3.8528896672504399E-2</c:v>
                </c:pt>
                <c:pt idx="11">
                  <c:v>2.0577933450087602E-2</c:v>
                </c:pt>
                <c:pt idx="12">
                  <c:v>1.8826619964973701E-2</c:v>
                </c:pt>
                <c:pt idx="13">
                  <c:v>1.5761821366024512E-2</c:v>
                </c:pt>
                <c:pt idx="14">
                  <c:v>1.0945709281961513E-2</c:v>
                </c:pt>
                <c:pt idx="15">
                  <c:v>8.7565674255691874E-3</c:v>
                </c:pt>
                <c:pt idx="16">
                  <c:v>9.1943957968476462E-3</c:v>
                </c:pt>
                <c:pt idx="17">
                  <c:v>6.129597197898423E-3</c:v>
                </c:pt>
                <c:pt idx="18">
                  <c:v>2.1891418563922934E-3</c:v>
                </c:pt>
                <c:pt idx="19">
                  <c:v>2.1891418563922934E-3</c:v>
                </c:pt>
                <c:pt idx="20">
                  <c:v>3.5026269702276716E-3</c:v>
                </c:pt>
              </c:numCache>
            </c:numRef>
          </c:val>
        </c:ser>
        <c:ser>
          <c:idx val="20"/>
          <c:order val="20"/>
          <c:tx>
            <c:strRef>
              <c:f>'N2 L4_0.02_5%'!$V$104</c:f>
              <c:strCache>
                <c:ptCount val="1"/>
                <c:pt idx="0">
                  <c:v>N2_L4_0623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V$105:$V$125</c:f>
              <c:numCache>
                <c:formatCode>General</c:formatCode>
                <c:ptCount val="21"/>
                <c:pt idx="1">
                  <c:v>8.4054388133498317E-2</c:v>
                </c:pt>
                <c:pt idx="2">
                  <c:v>0.10341985990935296</c:v>
                </c:pt>
                <c:pt idx="3">
                  <c:v>0.12772970745776699</c:v>
                </c:pt>
                <c:pt idx="4">
                  <c:v>0.14009064688916409</c:v>
                </c:pt>
                <c:pt idx="5">
                  <c:v>0.11742892459826898</c:v>
                </c:pt>
                <c:pt idx="6">
                  <c:v>8.1582200247218739E-2</c:v>
                </c:pt>
                <c:pt idx="7">
                  <c:v>6.1392665842604041E-2</c:v>
                </c:pt>
                <c:pt idx="8">
                  <c:v>5.0267820354346932E-2</c:v>
                </c:pt>
                <c:pt idx="9">
                  <c:v>3.25504738360115E-2</c:v>
                </c:pt>
                <c:pt idx="10">
                  <c:v>2.6782035434693013E-2</c:v>
                </c:pt>
                <c:pt idx="11">
                  <c:v>2.3897816234033802E-2</c:v>
                </c:pt>
                <c:pt idx="12">
                  <c:v>1.524515863205601E-2</c:v>
                </c:pt>
                <c:pt idx="13">
                  <c:v>1.2772970745776701E-2</c:v>
                </c:pt>
                <c:pt idx="14">
                  <c:v>1.2772970745776701E-2</c:v>
                </c:pt>
                <c:pt idx="15">
                  <c:v>9.0646889163576508E-3</c:v>
                </c:pt>
                <c:pt idx="16">
                  <c:v>7.0045323444581824E-3</c:v>
                </c:pt>
                <c:pt idx="17">
                  <c:v>6.1804697156983956E-3</c:v>
                </c:pt>
                <c:pt idx="18">
                  <c:v>4.1203131437989298E-3</c:v>
                </c:pt>
                <c:pt idx="19">
                  <c:v>2.8842192006592513E-3</c:v>
                </c:pt>
                <c:pt idx="20">
                  <c:v>1.64812525751957E-3</c:v>
                </c:pt>
              </c:numCache>
            </c:numRef>
          </c:val>
        </c:ser>
        <c:ser>
          <c:idx val="21"/>
          <c:order val="21"/>
          <c:tx>
            <c:strRef>
              <c:f>'N2 L4_0.02_5%'!$W$104</c:f>
              <c:strCache>
                <c:ptCount val="1"/>
                <c:pt idx="0">
                  <c:v>N2_L4_0624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W$105:$W$125</c:f>
              <c:numCache>
                <c:formatCode>General</c:formatCode>
                <c:ptCount val="21"/>
                <c:pt idx="1">
                  <c:v>7.8535891968727803E-2</c:v>
                </c:pt>
                <c:pt idx="2">
                  <c:v>0.10589907604833004</c:v>
                </c:pt>
                <c:pt idx="3">
                  <c:v>0.11869225302061112</c:v>
                </c:pt>
                <c:pt idx="4">
                  <c:v>0.1382373845060412</c:v>
                </c:pt>
                <c:pt idx="5">
                  <c:v>0.10341151385927498</c:v>
                </c:pt>
                <c:pt idx="6">
                  <c:v>7.7469793887704336E-2</c:v>
                </c:pt>
                <c:pt idx="7">
                  <c:v>5.3304904051172726E-2</c:v>
                </c:pt>
                <c:pt idx="8">
                  <c:v>4.1222459132906904E-2</c:v>
                </c:pt>
                <c:pt idx="9">
                  <c:v>3.8379530916844401E-2</c:v>
                </c:pt>
                <c:pt idx="10">
                  <c:v>3.162757640369581E-2</c:v>
                </c:pt>
                <c:pt idx="11">
                  <c:v>2.7718550106609799E-2</c:v>
                </c:pt>
                <c:pt idx="12">
                  <c:v>2.2388059701492487E-2</c:v>
                </c:pt>
                <c:pt idx="13">
                  <c:v>1.670220326936742E-2</c:v>
                </c:pt>
                <c:pt idx="14">
                  <c:v>1.172707889125801E-2</c:v>
                </c:pt>
                <c:pt idx="15">
                  <c:v>1.3503909026297101E-2</c:v>
                </c:pt>
                <c:pt idx="16">
                  <c:v>7.10732054015636E-3</c:v>
                </c:pt>
                <c:pt idx="17">
                  <c:v>9.9502487562189209E-3</c:v>
                </c:pt>
                <c:pt idx="18">
                  <c:v>6.0412224591329155E-3</c:v>
                </c:pt>
                <c:pt idx="19">
                  <c:v>2.8429282160625413E-3</c:v>
                </c:pt>
                <c:pt idx="20">
                  <c:v>3.55366027007818E-3</c:v>
                </c:pt>
              </c:numCache>
            </c:numRef>
          </c:val>
        </c:ser>
        <c:ser>
          <c:idx val="22"/>
          <c:order val="22"/>
          <c:tx>
            <c:strRef>
              <c:f>'N2 L4_0.02_5%'!$X$104</c:f>
              <c:strCache>
                <c:ptCount val="1"/>
                <c:pt idx="0">
                  <c:v>N2_L4_0625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X$105:$X$125</c:f>
              <c:numCache>
                <c:formatCode>General</c:formatCode>
                <c:ptCount val="21"/>
                <c:pt idx="1">
                  <c:v>7.7386934673366839E-2</c:v>
                </c:pt>
                <c:pt idx="2">
                  <c:v>0.10016750418760502</c:v>
                </c:pt>
                <c:pt idx="3">
                  <c:v>0.10954773869346696</c:v>
                </c:pt>
                <c:pt idx="4">
                  <c:v>0.12562814070351785</c:v>
                </c:pt>
                <c:pt idx="5">
                  <c:v>0.12294807370184302</c:v>
                </c:pt>
                <c:pt idx="6">
                  <c:v>8.0067001675041896E-2</c:v>
                </c:pt>
                <c:pt idx="7">
                  <c:v>6.1976549413735302E-2</c:v>
                </c:pt>
                <c:pt idx="8">
                  <c:v>6.1306532663316628E-2</c:v>
                </c:pt>
                <c:pt idx="9">
                  <c:v>3.68509212730318E-2</c:v>
                </c:pt>
                <c:pt idx="10">
                  <c:v>3.517587939698491E-2</c:v>
                </c:pt>
                <c:pt idx="11">
                  <c:v>2.9815745393634806E-2</c:v>
                </c:pt>
                <c:pt idx="12">
                  <c:v>2.5460636515912911E-2</c:v>
                </c:pt>
                <c:pt idx="13">
                  <c:v>1.7085427135678403E-2</c:v>
                </c:pt>
                <c:pt idx="14">
                  <c:v>1.4740368509212703E-2</c:v>
                </c:pt>
                <c:pt idx="15">
                  <c:v>1.10552763819095E-2</c:v>
                </c:pt>
                <c:pt idx="16">
                  <c:v>7.3701842546063604E-3</c:v>
                </c:pt>
                <c:pt idx="17">
                  <c:v>5.0251256281406975E-3</c:v>
                </c:pt>
                <c:pt idx="18">
                  <c:v>5.6951423785594601E-3</c:v>
                </c:pt>
                <c:pt idx="19">
                  <c:v>5.3601340033500797E-3</c:v>
                </c:pt>
                <c:pt idx="20">
                  <c:v>4.0201005025125598E-3</c:v>
                </c:pt>
              </c:numCache>
            </c:numRef>
          </c:val>
        </c:ser>
        <c:ser>
          <c:idx val="23"/>
          <c:order val="23"/>
          <c:tx>
            <c:strRef>
              <c:f>'N2 L4_0.02_5%'!$Y$104</c:f>
              <c:strCache>
                <c:ptCount val="1"/>
                <c:pt idx="0">
                  <c:v>N2_L4_0626</c:v>
                </c:pt>
              </c:strCache>
            </c:strRef>
          </c:tx>
          <c:marker>
            <c:symbol val="none"/>
          </c:marker>
          <c:cat>
            <c:numRef>
              <c:f>'N2 L4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L4_0.02_5%'!$Y$105:$Y$125</c:f>
              <c:numCache>
                <c:formatCode>General</c:formatCode>
                <c:ptCount val="21"/>
                <c:pt idx="1">
                  <c:v>3.8461538461538498E-2</c:v>
                </c:pt>
                <c:pt idx="2">
                  <c:v>7.6923076923076913E-2</c:v>
                </c:pt>
                <c:pt idx="3">
                  <c:v>0.15384615384615413</c:v>
                </c:pt>
                <c:pt idx="4">
                  <c:v>0.19230769230769201</c:v>
                </c:pt>
                <c:pt idx="5">
                  <c:v>7.6923076923076913E-2</c:v>
                </c:pt>
                <c:pt idx="6">
                  <c:v>3.8461538461538498E-2</c:v>
                </c:pt>
                <c:pt idx="7">
                  <c:v>3.8461538461538498E-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marker val="1"/>
        <c:axId val="157095040"/>
        <c:axId val="157096576"/>
      </c:lineChart>
      <c:catAx>
        <c:axId val="157095040"/>
        <c:scaling>
          <c:orientation val="minMax"/>
        </c:scaling>
        <c:axPos val="b"/>
        <c:numFmt formatCode="#,##0.0_);\(#,##0.0\)" sourceLinked="0"/>
        <c:tickLblPos val="nextTo"/>
        <c:crossAx val="157096576"/>
        <c:crosses val="autoZero"/>
        <c:auto val="1"/>
        <c:lblAlgn val="ctr"/>
        <c:lblOffset val="100"/>
        <c:tickLblSkip val="5"/>
        <c:tickMarkSkip val="5"/>
      </c:catAx>
      <c:valAx>
        <c:axId val="15709657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7095040"/>
        <c:crosses val="autoZero"/>
        <c:crossBetween val="between"/>
      </c:valAx>
    </c:plotArea>
    <c:plotVisOnly val="1"/>
  </c:chart>
  <c:externalData r:id="rId1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nm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mr-1(ak4)_A3_0.02_5%'!$B$104</c:f>
              <c:strCache>
                <c:ptCount val="1"/>
                <c:pt idx="0">
                  <c:v>nmr-1(ak4)_A3_01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B$105:$B$125</c:f>
              <c:numCache>
                <c:formatCode>General</c:formatCode>
                <c:ptCount val="21"/>
                <c:pt idx="1">
                  <c:v>6.7669172932330809E-2</c:v>
                </c:pt>
                <c:pt idx="2">
                  <c:v>0.119548872180451</c:v>
                </c:pt>
                <c:pt idx="3">
                  <c:v>0.12481203007518803</c:v>
                </c:pt>
                <c:pt idx="4">
                  <c:v>0.14360902255639107</c:v>
                </c:pt>
                <c:pt idx="5">
                  <c:v>0.15789473684210512</c:v>
                </c:pt>
                <c:pt idx="6">
                  <c:v>5.4887218045112825E-2</c:v>
                </c:pt>
                <c:pt idx="7">
                  <c:v>4.5112781954887243E-2</c:v>
                </c:pt>
                <c:pt idx="8">
                  <c:v>5.4135338345864703E-2</c:v>
                </c:pt>
                <c:pt idx="9">
                  <c:v>4.5112781954887243E-2</c:v>
                </c:pt>
                <c:pt idx="10">
                  <c:v>3.0075187969924817E-2</c:v>
                </c:pt>
                <c:pt idx="11">
                  <c:v>3.0075187969924817E-2</c:v>
                </c:pt>
                <c:pt idx="12">
                  <c:v>2.40601503759399E-2</c:v>
                </c:pt>
                <c:pt idx="13">
                  <c:v>1.12781954887218E-2</c:v>
                </c:pt>
                <c:pt idx="14">
                  <c:v>1.2030075187969901E-2</c:v>
                </c:pt>
                <c:pt idx="15">
                  <c:v>1.05263157894737E-2</c:v>
                </c:pt>
                <c:pt idx="16">
                  <c:v>6.7669172932330818E-3</c:v>
                </c:pt>
                <c:pt idx="17">
                  <c:v>3.7593984962406009E-3</c:v>
                </c:pt>
                <c:pt idx="18">
                  <c:v>3.7593984962406009E-3</c:v>
                </c:pt>
                <c:pt idx="19">
                  <c:v>2.255639097744361E-3</c:v>
                </c:pt>
                <c:pt idx="20">
                  <c:v>3.7593984962406009E-3</c:v>
                </c:pt>
              </c:numCache>
            </c:numRef>
          </c:val>
        </c:ser>
        <c:ser>
          <c:idx val="1"/>
          <c:order val="1"/>
          <c:tx>
            <c:strRef>
              <c:f>'nmr-1(ak4)_A3_0.02_5%'!$C$104</c:f>
              <c:strCache>
                <c:ptCount val="1"/>
                <c:pt idx="0">
                  <c:v>nmr-1(ak4)_A3_02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C$105:$C$125</c:f>
              <c:numCache>
                <c:formatCode>General</c:formatCode>
                <c:ptCount val="21"/>
                <c:pt idx="1">
                  <c:v>6.4122137404580198E-2</c:v>
                </c:pt>
                <c:pt idx="2">
                  <c:v>0.11068702290076297</c:v>
                </c:pt>
                <c:pt idx="3">
                  <c:v>0.126717557251908</c:v>
                </c:pt>
                <c:pt idx="4">
                  <c:v>0.14274809160305299</c:v>
                </c:pt>
                <c:pt idx="5">
                  <c:v>0.158778625954198</c:v>
                </c:pt>
                <c:pt idx="6">
                  <c:v>5.9541984732824411E-2</c:v>
                </c:pt>
                <c:pt idx="7">
                  <c:v>4.9618320610687001E-2</c:v>
                </c:pt>
                <c:pt idx="8">
                  <c:v>4.7328244274809202E-2</c:v>
                </c:pt>
                <c:pt idx="9">
                  <c:v>3.9694656488549612E-2</c:v>
                </c:pt>
                <c:pt idx="10">
                  <c:v>4.5038167938931332E-2</c:v>
                </c:pt>
                <c:pt idx="11">
                  <c:v>2.2900763358778602E-2</c:v>
                </c:pt>
                <c:pt idx="12">
                  <c:v>1.45038167938931E-2</c:v>
                </c:pt>
                <c:pt idx="13">
                  <c:v>1.1450381679389304E-2</c:v>
                </c:pt>
                <c:pt idx="14">
                  <c:v>4.5801526717557297E-3</c:v>
                </c:pt>
                <c:pt idx="15">
                  <c:v>1.0687022900763401E-2</c:v>
                </c:pt>
                <c:pt idx="16">
                  <c:v>6.8702290076335937E-3</c:v>
                </c:pt>
                <c:pt idx="17">
                  <c:v>6.1068702290076318E-3</c:v>
                </c:pt>
                <c:pt idx="18">
                  <c:v>3.81679389312977E-3</c:v>
                </c:pt>
                <c:pt idx="19">
                  <c:v>5.3435114503816803E-3</c:v>
                </c:pt>
                <c:pt idx="20">
                  <c:v>3.81679389312977E-3</c:v>
                </c:pt>
              </c:numCache>
            </c:numRef>
          </c:val>
        </c:ser>
        <c:ser>
          <c:idx val="2"/>
          <c:order val="2"/>
          <c:tx>
            <c:strRef>
              <c:f>'nmr-1(ak4)_A3_0.02_5%'!$D$104</c:f>
              <c:strCache>
                <c:ptCount val="1"/>
                <c:pt idx="0">
                  <c:v>nmr-1(ak4)_A3_03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D$105:$D$125</c:f>
              <c:numCache>
                <c:formatCode>General</c:formatCode>
                <c:ptCount val="21"/>
                <c:pt idx="1">
                  <c:v>5.8309037900874619E-2</c:v>
                </c:pt>
                <c:pt idx="2">
                  <c:v>8.1632653061224497E-2</c:v>
                </c:pt>
                <c:pt idx="3">
                  <c:v>8.4548104956268202E-2</c:v>
                </c:pt>
                <c:pt idx="4">
                  <c:v>0.14139941690962099</c:v>
                </c:pt>
                <c:pt idx="5">
                  <c:v>0.116618075801749</c:v>
                </c:pt>
                <c:pt idx="6">
                  <c:v>5.9766763848396555E-2</c:v>
                </c:pt>
                <c:pt idx="7">
                  <c:v>2.6239067055393618E-2</c:v>
                </c:pt>
                <c:pt idx="8">
                  <c:v>4.0816326530612221E-2</c:v>
                </c:pt>
                <c:pt idx="9">
                  <c:v>5.1020408163265286E-2</c:v>
                </c:pt>
                <c:pt idx="10">
                  <c:v>3.9358600583090403E-2</c:v>
                </c:pt>
                <c:pt idx="11">
                  <c:v>3.9358600583090403E-2</c:v>
                </c:pt>
                <c:pt idx="12">
                  <c:v>2.1865889212828001E-2</c:v>
                </c:pt>
                <c:pt idx="13">
                  <c:v>2.6239067055393618E-2</c:v>
                </c:pt>
                <c:pt idx="14">
                  <c:v>2.6239067055393618E-2</c:v>
                </c:pt>
                <c:pt idx="15">
                  <c:v>3.0612244897959207E-2</c:v>
                </c:pt>
                <c:pt idx="16">
                  <c:v>2.3323615160349899E-2</c:v>
                </c:pt>
                <c:pt idx="17">
                  <c:v>1.3119533527696795E-2</c:v>
                </c:pt>
                <c:pt idx="18">
                  <c:v>5.8309037900874635E-3</c:v>
                </c:pt>
                <c:pt idx="19">
                  <c:v>5.8309037900874635E-3</c:v>
                </c:pt>
                <c:pt idx="20">
                  <c:v>7.2886297376093352E-3</c:v>
                </c:pt>
              </c:numCache>
            </c:numRef>
          </c:val>
        </c:ser>
        <c:ser>
          <c:idx val="3"/>
          <c:order val="3"/>
          <c:tx>
            <c:strRef>
              <c:f>'nmr-1(ak4)_A3_0.02_5%'!$E$104</c:f>
              <c:strCache>
                <c:ptCount val="1"/>
                <c:pt idx="0">
                  <c:v>nmr-1(ak4)_A3_04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E$105:$E$125</c:f>
              <c:numCache>
                <c:formatCode>General</c:formatCode>
                <c:ptCount val="21"/>
                <c:pt idx="1">
                  <c:v>8.8000000000000037E-2</c:v>
                </c:pt>
                <c:pt idx="2">
                  <c:v>9.6000000000000002E-2</c:v>
                </c:pt>
                <c:pt idx="3">
                  <c:v>8.8000000000000037E-2</c:v>
                </c:pt>
                <c:pt idx="4">
                  <c:v>4.8000000000000001E-2</c:v>
                </c:pt>
                <c:pt idx="5">
                  <c:v>8.4000000000000047E-2</c:v>
                </c:pt>
                <c:pt idx="6">
                  <c:v>3.2000000000000015E-2</c:v>
                </c:pt>
                <c:pt idx="7">
                  <c:v>4.0000000000000015E-2</c:v>
                </c:pt>
                <c:pt idx="8">
                  <c:v>6.8000000000000019E-2</c:v>
                </c:pt>
                <c:pt idx="9">
                  <c:v>1.6000000000000007E-2</c:v>
                </c:pt>
                <c:pt idx="10">
                  <c:v>2.4E-2</c:v>
                </c:pt>
                <c:pt idx="11">
                  <c:v>3.2000000000000015E-2</c:v>
                </c:pt>
                <c:pt idx="12">
                  <c:v>2.0000000000000007E-2</c:v>
                </c:pt>
                <c:pt idx="13">
                  <c:v>4.3999999999999997E-2</c:v>
                </c:pt>
                <c:pt idx="14">
                  <c:v>2.8000000000000001E-2</c:v>
                </c:pt>
                <c:pt idx="15">
                  <c:v>2.8000000000000001E-2</c:v>
                </c:pt>
                <c:pt idx="16">
                  <c:v>2.8000000000000001E-2</c:v>
                </c:pt>
                <c:pt idx="17">
                  <c:v>2.0000000000000007E-2</c:v>
                </c:pt>
                <c:pt idx="18">
                  <c:v>1.2E-2</c:v>
                </c:pt>
                <c:pt idx="19">
                  <c:v>1.2E-2</c:v>
                </c:pt>
                <c:pt idx="20">
                  <c:v>1.6000000000000007E-2</c:v>
                </c:pt>
              </c:numCache>
            </c:numRef>
          </c:val>
        </c:ser>
        <c:ser>
          <c:idx val="4"/>
          <c:order val="4"/>
          <c:tx>
            <c:strRef>
              <c:f>'nmr-1(ak4)_A3_0.02_5%'!$F$104</c:f>
              <c:strCache>
                <c:ptCount val="1"/>
                <c:pt idx="0">
                  <c:v>nmr-1(ak4)_A3_05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F$105:$F$125</c:f>
              <c:numCache>
                <c:formatCode>General</c:formatCode>
                <c:ptCount val="21"/>
                <c:pt idx="1">
                  <c:v>5.7553956834532426E-2</c:v>
                </c:pt>
                <c:pt idx="2">
                  <c:v>7.8108941418293901E-2</c:v>
                </c:pt>
                <c:pt idx="3">
                  <c:v>0.11408016443987698</c:v>
                </c:pt>
                <c:pt idx="4">
                  <c:v>0.117163412127441</c:v>
                </c:pt>
                <c:pt idx="5">
                  <c:v>0.14388489208633107</c:v>
                </c:pt>
                <c:pt idx="6">
                  <c:v>6.1664953751284696E-2</c:v>
                </c:pt>
                <c:pt idx="7">
                  <c:v>6.2692702980472803E-2</c:v>
                </c:pt>
                <c:pt idx="8">
                  <c:v>5.9609455292908495E-2</c:v>
                </c:pt>
                <c:pt idx="9">
                  <c:v>3.2887975334018514E-2</c:v>
                </c:pt>
                <c:pt idx="10">
                  <c:v>3.2887975334018514E-2</c:v>
                </c:pt>
                <c:pt idx="11">
                  <c:v>2.980472764645431E-2</c:v>
                </c:pt>
                <c:pt idx="12">
                  <c:v>2.05549845837616E-2</c:v>
                </c:pt>
                <c:pt idx="13">
                  <c:v>1.6443987667009306E-2</c:v>
                </c:pt>
                <c:pt idx="14">
                  <c:v>2.05549845837616E-2</c:v>
                </c:pt>
                <c:pt idx="15">
                  <c:v>1.02774922918808E-2</c:v>
                </c:pt>
                <c:pt idx="16">
                  <c:v>1.2332990750256895E-2</c:v>
                </c:pt>
                <c:pt idx="17">
                  <c:v>1.02774922918808E-2</c:v>
                </c:pt>
                <c:pt idx="18">
                  <c:v>1.02774922918808E-2</c:v>
                </c:pt>
                <c:pt idx="19">
                  <c:v>5.1387461459403922E-3</c:v>
                </c:pt>
                <c:pt idx="20">
                  <c:v>9.2497430626926995E-3</c:v>
                </c:pt>
              </c:numCache>
            </c:numRef>
          </c:val>
        </c:ser>
        <c:ser>
          <c:idx val="5"/>
          <c:order val="5"/>
          <c:tx>
            <c:strRef>
              <c:f>'nmr-1(ak4)_A3_0.02_5%'!$G$104</c:f>
              <c:strCache>
                <c:ptCount val="1"/>
                <c:pt idx="0">
                  <c:v>nmr-1(ak4)_A3_06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G$105:$G$125</c:f>
              <c:numCache>
                <c:formatCode>General</c:formatCode>
                <c:ptCount val="21"/>
                <c:pt idx="1">
                  <c:v>7.5630252100840303E-2</c:v>
                </c:pt>
                <c:pt idx="2">
                  <c:v>0.102040816326531</c:v>
                </c:pt>
                <c:pt idx="3">
                  <c:v>0.11404561824729903</c:v>
                </c:pt>
                <c:pt idx="4">
                  <c:v>0.14165666266506594</c:v>
                </c:pt>
                <c:pt idx="5">
                  <c:v>0.11644657863145302</c:v>
                </c:pt>
                <c:pt idx="6">
                  <c:v>5.5222088835534221E-2</c:v>
                </c:pt>
                <c:pt idx="7">
                  <c:v>5.2821128451380601E-2</c:v>
                </c:pt>
                <c:pt idx="8">
                  <c:v>3.9615846338535404E-2</c:v>
                </c:pt>
                <c:pt idx="9">
                  <c:v>3.8415366146458602E-2</c:v>
                </c:pt>
                <c:pt idx="10">
                  <c:v>3.2412965186074422E-2</c:v>
                </c:pt>
                <c:pt idx="11">
                  <c:v>2.8811524609843899E-2</c:v>
                </c:pt>
                <c:pt idx="12">
                  <c:v>2.5210084033613397E-2</c:v>
                </c:pt>
                <c:pt idx="13">
                  <c:v>1.32052821128451E-2</c:v>
                </c:pt>
                <c:pt idx="14">
                  <c:v>1.5606242496998799E-2</c:v>
                </c:pt>
                <c:pt idx="15">
                  <c:v>1.2004801920768301E-2</c:v>
                </c:pt>
                <c:pt idx="16">
                  <c:v>1.2004801920768301E-2</c:v>
                </c:pt>
                <c:pt idx="17">
                  <c:v>1.2004801920768301E-2</c:v>
                </c:pt>
                <c:pt idx="18">
                  <c:v>3.6014405762304917E-3</c:v>
                </c:pt>
                <c:pt idx="19">
                  <c:v>6.0024009603841504E-3</c:v>
                </c:pt>
                <c:pt idx="20">
                  <c:v>6.0024009603841504E-3</c:v>
                </c:pt>
              </c:numCache>
            </c:numRef>
          </c:val>
        </c:ser>
        <c:ser>
          <c:idx val="6"/>
          <c:order val="6"/>
          <c:tx>
            <c:strRef>
              <c:f>'nmr-1(ak4)_A3_0.02_5%'!$H$104</c:f>
              <c:strCache>
                <c:ptCount val="1"/>
                <c:pt idx="0">
                  <c:v>nmr-1(ak4)_A3_07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H$105:$H$125</c:f>
              <c:numCache>
                <c:formatCode>General</c:formatCode>
                <c:ptCount val="21"/>
                <c:pt idx="1">
                  <c:v>7.3217726396917093E-2</c:v>
                </c:pt>
                <c:pt idx="2">
                  <c:v>8.4778420038535598E-2</c:v>
                </c:pt>
                <c:pt idx="3">
                  <c:v>0.10211946050096297</c:v>
                </c:pt>
                <c:pt idx="4">
                  <c:v>0.135838150289017</c:v>
                </c:pt>
                <c:pt idx="5">
                  <c:v>0.11849710982659002</c:v>
                </c:pt>
                <c:pt idx="6">
                  <c:v>5.6840077071290886E-2</c:v>
                </c:pt>
                <c:pt idx="7">
                  <c:v>4.81695568400771E-2</c:v>
                </c:pt>
                <c:pt idx="8">
                  <c:v>5.2986512524084803E-2</c:v>
                </c:pt>
                <c:pt idx="9">
                  <c:v>4.81695568400771E-2</c:v>
                </c:pt>
                <c:pt idx="10">
                  <c:v>3.6608863198458602E-2</c:v>
                </c:pt>
                <c:pt idx="11">
                  <c:v>3.5645472061657017E-2</c:v>
                </c:pt>
                <c:pt idx="12">
                  <c:v>3.6608863198458602E-2</c:v>
                </c:pt>
                <c:pt idx="13">
                  <c:v>1.7341040462427702E-2</c:v>
                </c:pt>
                <c:pt idx="14">
                  <c:v>2.6011560693641602E-2</c:v>
                </c:pt>
                <c:pt idx="15">
                  <c:v>1.3487475915221604E-2</c:v>
                </c:pt>
                <c:pt idx="16">
                  <c:v>1.252408477842E-2</c:v>
                </c:pt>
                <c:pt idx="17">
                  <c:v>1.0597302504817E-2</c:v>
                </c:pt>
                <c:pt idx="18">
                  <c:v>8.6705202312138702E-3</c:v>
                </c:pt>
                <c:pt idx="19">
                  <c:v>6.7437379576107915E-3</c:v>
                </c:pt>
                <c:pt idx="20">
                  <c:v>1.9267822736030809E-3</c:v>
                </c:pt>
              </c:numCache>
            </c:numRef>
          </c:val>
        </c:ser>
        <c:ser>
          <c:idx val="7"/>
          <c:order val="7"/>
          <c:tx>
            <c:strRef>
              <c:f>'nmr-1(ak4)_A3_0.02_5%'!$I$104</c:f>
              <c:strCache>
                <c:ptCount val="1"/>
                <c:pt idx="0">
                  <c:v>nmr-1(ak4)_A3_08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I$105:$I$125</c:f>
              <c:numCache>
                <c:formatCode>General</c:formatCode>
                <c:ptCount val="21"/>
                <c:pt idx="1">
                  <c:v>7.2864321608040225E-2</c:v>
                </c:pt>
                <c:pt idx="2">
                  <c:v>9.4221105527638238E-2</c:v>
                </c:pt>
                <c:pt idx="3">
                  <c:v>0.11055276381909497</c:v>
                </c:pt>
                <c:pt idx="4">
                  <c:v>0.12688442211055295</c:v>
                </c:pt>
                <c:pt idx="5">
                  <c:v>0.12437185929648202</c:v>
                </c:pt>
                <c:pt idx="6">
                  <c:v>6.5326633165829234E-2</c:v>
                </c:pt>
                <c:pt idx="7">
                  <c:v>5.2763819095477414E-2</c:v>
                </c:pt>
                <c:pt idx="8">
                  <c:v>4.8994974874371919E-2</c:v>
                </c:pt>
                <c:pt idx="9">
                  <c:v>4.7738693467336737E-2</c:v>
                </c:pt>
                <c:pt idx="10">
                  <c:v>3.2663316582914631E-2</c:v>
                </c:pt>
                <c:pt idx="11">
                  <c:v>3.517587939698491E-2</c:v>
                </c:pt>
                <c:pt idx="12">
                  <c:v>3.517587939698491E-2</c:v>
                </c:pt>
                <c:pt idx="13">
                  <c:v>2.5125628140703501E-2</c:v>
                </c:pt>
                <c:pt idx="14">
                  <c:v>1.2562814070351799E-2</c:v>
                </c:pt>
                <c:pt idx="15">
                  <c:v>2.1356783919597989E-2</c:v>
                </c:pt>
                <c:pt idx="16">
                  <c:v>8.7939698492462345E-3</c:v>
                </c:pt>
                <c:pt idx="17">
                  <c:v>5.0251256281406984E-3</c:v>
                </c:pt>
                <c:pt idx="18">
                  <c:v>5.0251256281406984E-3</c:v>
                </c:pt>
                <c:pt idx="19">
                  <c:v>2.5125628140703501E-3</c:v>
                </c:pt>
                <c:pt idx="20">
                  <c:v>1.25628140703518E-3</c:v>
                </c:pt>
              </c:numCache>
            </c:numRef>
          </c:val>
        </c:ser>
        <c:ser>
          <c:idx val="8"/>
          <c:order val="8"/>
          <c:tx>
            <c:strRef>
              <c:f>'nmr-1(ak4)_A3_0.02_5%'!$J$104</c:f>
              <c:strCache>
                <c:ptCount val="1"/>
                <c:pt idx="0">
                  <c:v>nmr-1(ak4)_A3_09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J$105:$J$125</c:f>
              <c:numCache>
                <c:formatCode>General</c:formatCode>
                <c:ptCount val="21"/>
                <c:pt idx="1">
                  <c:v>5.9061488673139199E-2</c:v>
                </c:pt>
                <c:pt idx="2">
                  <c:v>7.9288025889967598E-2</c:v>
                </c:pt>
                <c:pt idx="3">
                  <c:v>0.14077669902912601</c:v>
                </c:pt>
                <c:pt idx="4">
                  <c:v>0.11812297734627804</c:v>
                </c:pt>
                <c:pt idx="5">
                  <c:v>0.14644012944983806</c:v>
                </c:pt>
                <c:pt idx="6">
                  <c:v>5.5825242718446598E-2</c:v>
                </c:pt>
                <c:pt idx="7">
                  <c:v>5.0970873786407779E-2</c:v>
                </c:pt>
                <c:pt idx="8">
                  <c:v>5.7443365695792878E-2</c:v>
                </c:pt>
                <c:pt idx="9">
                  <c:v>5.0161812297734601E-2</c:v>
                </c:pt>
                <c:pt idx="10">
                  <c:v>3.4789644012945001E-2</c:v>
                </c:pt>
                <c:pt idx="11">
                  <c:v>2.9126213592233E-2</c:v>
                </c:pt>
                <c:pt idx="12">
                  <c:v>2.7508090614886706E-2</c:v>
                </c:pt>
                <c:pt idx="13">
                  <c:v>3.2362459546925598E-2</c:v>
                </c:pt>
                <c:pt idx="14">
                  <c:v>1.9417475728155307E-2</c:v>
                </c:pt>
                <c:pt idx="15">
                  <c:v>1.2135922330097099E-2</c:v>
                </c:pt>
                <c:pt idx="16">
                  <c:v>8.0906148867313944E-3</c:v>
                </c:pt>
                <c:pt idx="17">
                  <c:v>1.05177993527508E-2</c:v>
                </c:pt>
                <c:pt idx="18">
                  <c:v>4.8543689320388319E-3</c:v>
                </c:pt>
                <c:pt idx="19">
                  <c:v>3.2362459546925598E-3</c:v>
                </c:pt>
                <c:pt idx="20">
                  <c:v>2.4271844660194216E-3</c:v>
                </c:pt>
              </c:numCache>
            </c:numRef>
          </c:val>
        </c:ser>
        <c:ser>
          <c:idx val="9"/>
          <c:order val="9"/>
          <c:tx>
            <c:strRef>
              <c:f>'nmr-1(ak4)_A3_0.02_5%'!$K$104</c:f>
              <c:strCache>
                <c:ptCount val="1"/>
                <c:pt idx="0">
                  <c:v>nmr-1(ak4)_A3_10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K$105:$K$125</c:f>
              <c:numCache>
                <c:formatCode>General</c:formatCode>
                <c:ptCount val="21"/>
                <c:pt idx="1">
                  <c:v>6.2608695652173904E-2</c:v>
                </c:pt>
                <c:pt idx="2">
                  <c:v>9.130434782608704E-2</c:v>
                </c:pt>
                <c:pt idx="3">
                  <c:v>0.12173913043478303</c:v>
                </c:pt>
                <c:pt idx="4">
                  <c:v>0.14695652173913001</c:v>
                </c:pt>
                <c:pt idx="5">
                  <c:v>0.12608695652173901</c:v>
                </c:pt>
                <c:pt idx="6">
                  <c:v>5.6521739130434803E-2</c:v>
                </c:pt>
                <c:pt idx="7">
                  <c:v>5.0434782608695702E-2</c:v>
                </c:pt>
                <c:pt idx="8">
                  <c:v>4.0000000000000015E-2</c:v>
                </c:pt>
                <c:pt idx="9">
                  <c:v>4.26086956521739E-2</c:v>
                </c:pt>
                <c:pt idx="10">
                  <c:v>3.0434782608695705E-2</c:v>
                </c:pt>
                <c:pt idx="11">
                  <c:v>2.0869565217391292E-2</c:v>
                </c:pt>
                <c:pt idx="12">
                  <c:v>2.6086956521739115E-2</c:v>
                </c:pt>
                <c:pt idx="13">
                  <c:v>2.7826086956521699E-2</c:v>
                </c:pt>
                <c:pt idx="14">
                  <c:v>1.2173913043478299E-2</c:v>
                </c:pt>
                <c:pt idx="15">
                  <c:v>2.1739130434782601E-2</c:v>
                </c:pt>
                <c:pt idx="16">
                  <c:v>1.304347826086961E-2</c:v>
                </c:pt>
                <c:pt idx="17">
                  <c:v>1.2173913043478299E-2</c:v>
                </c:pt>
                <c:pt idx="18">
                  <c:v>1.2173913043478299E-2</c:v>
                </c:pt>
                <c:pt idx="19">
                  <c:v>3.4782608695652201E-3</c:v>
                </c:pt>
                <c:pt idx="20">
                  <c:v>5.2173913043478334E-3</c:v>
                </c:pt>
              </c:numCache>
            </c:numRef>
          </c:val>
        </c:ser>
        <c:ser>
          <c:idx val="10"/>
          <c:order val="10"/>
          <c:tx>
            <c:strRef>
              <c:f>'nmr-1(ak4)_A3_0.02_5%'!$L$104</c:f>
              <c:strCache>
                <c:ptCount val="1"/>
                <c:pt idx="0">
                  <c:v>nmr-1(ak4)_A3_11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L$105:$L$125</c:f>
              <c:numCache>
                <c:formatCode>General</c:formatCode>
                <c:ptCount val="21"/>
                <c:pt idx="1">
                  <c:v>6.8410462776660005E-2</c:v>
                </c:pt>
                <c:pt idx="2">
                  <c:v>9.8591549295774655E-2</c:v>
                </c:pt>
                <c:pt idx="3">
                  <c:v>0.12206572769953103</c:v>
                </c:pt>
                <c:pt idx="4">
                  <c:v>0.141515761234071</c:v>
                </c:pt>
                <c:pt idx="5">
                  <c:v>0.16498993963782707</c:v>
                </c:pt>
                <c:pt idx="6">
                  <c:v>5.7008718980550002E-2</c:v>
                </c:pt>
                <c:pt idx="7">
                  <c:v>4.5606975184439999E-2</c:v>
                </c:pt>
                <c:pt idx="8">
                  <c:v>4.8960429242119415E-2</c:v>
                </c:pt>
                <c:pt idx="9">
                  <c:v>3.6887994634473523E-2</c:v>
                </c:pt>
                <c:pt idx="10">
                  <c:v>3.5546613011401697E-2</c:v>
                </c:pt>
                <c:pt idx="11">
                  <c:v>2.9510395707578806E-2</c:v>
                </c:pt>
                <c:pt idx="12">
                  <c:v>2.2132796780684111E-2</c:v>
                </c:pt>
                <c:pt idx="13">
                  <c:v>1.8108651911468803E-2</c:v>
                </c:pt>
                <c:pt idx="14">
                  <c:v>1.0060362173038198E-2</c:v>
                </c:pt>
                <c:pt idx="15">
                  <c:v>7.3775989268947016E-3</c:v>
                </c:pt>
                <c:pt idx="16">
                  <c:v>8.0482897384305772E-3</c:v>
                </c:pt>
                <c:pt idx="17">
                  <c:v>4.024144869215286E-3</c:v>
                </c:pt>
                <c:pt idx="18">
                  <c:v>1.3413816230717608E-3</c:v>
                </c:pt>
                <c:pt idx="19">
                  <c:v>2.6827632461435312E-3</c:v>
                </c:pt>
                <c:pt idx="20">
                  <c:v>2.0120724346076482E-3</c:v>
                </c:pt>
              </c:numCache>
            </c:numRef>
          </c:val>
        </c:ser>
        <c:ser>
          <c:idx val="11"/>
          <c:order val="11"/>
          <c:tx>
            <c:strRef>
              <c:f>'nmr-1(ak4)_A3_0.02_5%'!$M$104</c:f>
              <c:strCache>
                <c:ptCount val="1"/>
                <c:pt idx="0">
                  <c:v>nmr-1(ak4)_A3_12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M$105:$M$125</c:f>
              <c:numCache>
                <c:formatCode>General</c:formatCode>
                <c:ptCount val="21"/>
                <c:pt idx="1">
                  <c:v>5.3415061295972004E-2</c:v>
                </c:pt>
                <c:pt idx="2">
                  <c:v>0.10683012259194399</c:v>
                </c:pt>
                <c:pt idx="3">
                  <c:v>0.11733800350262701</c:v>
                </c:pt>
                <c:pt idx="4">
                  <c:v>0.15761821366024506</c:v>
                </c:pt>
                <c:pt idx="5">
                  <c:v>0.11821366024518404</c:v>
                </c:pt>
                <c:pt idx="6">
                  <c:v>6.6549912434325703E-2</c:v>
                </c:pt>
                <c:pt idx="7">
                  <c:v>3.7653239929947513E-2</c:v>
                </c:pt>
                <c:pt idx="8">
                  <c:v>5.7793345008756623E-2</c:v>
                </c:pt>
                <c:pt idx="9">
                  <c:v>2.7145359019264414E-2</c:v>
                </c:pt>
                <c:pt idx="10">
                  <c:v>3.1523642732049002E-2</c:v>
                </c:pt>
                <c:pt idx="11">
                  <c:v>3.41506129597198E-2</c:v>
                </c:pt>
                <c:pt idx="12">
                  <c:v>2.5394045534150599E-2</c:v>
                </c:pt>
                <c:pt idx="13">
                  <c:v>2.4518388791593692E-2</c:v>
                </c:pt>
                <c:pt idx="14">
                  <c:v>1.4886164623467606E-2</c:v>
                </c:pt>
                <c:pt idx="15">
                  <c:v>1.1383537653239904E-2</c:v>
                </c:pt>
                <c:pt idx="16">
                  <c:v>6.1295971978984221E-3</c:v>
                </c:pt>
                <c:pt idx="17">
                  <c:v>7.0052539404553433E-3</c:v>
                </c:pt>
                <c:pt idx="18">
                  <c:v>4.3782837127845937E-3</c:v>
                </c:pt>
                <c:pt idx="19">
                  <c:v>2.6269702276707518E-3</c:v>
                </c:pt>
                <c:pt idx="20">
                  <c:v>8.7565674255691845E-4</c:v>
                </c:pt>
              </c:numCache>
            </c:numRef>
          </c:val>
        </c:ser>
        <c:ser>
          <c:idx val="12"/>
          <c:order val="12"/>
          <c:tx>
            <c:strRef>
              <c:f>'nmr-1(ak4)_A3_0.02_5%'!$N$104</c:f>
              <c:strCache>
                <c:ptCount val="1"/>
                <c:pt idx="0">
                  <c:v>nmr-1(ak4)_A3_13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N$105:$N$125</c:f>
              <c:numCache>
                <c:formatCode>General</c:formatCode>
                <c:ptCount val="21"/>
                <c:pt idx="1">
                  <c:v>8.7843833185448097E-2</c:v>
                </c:pt>
                <c:pt idx="2">
                  <c:v>9.5829636202306986E-2</c:v>
                </c:pt>
                <c:pt idx="3">
                  <c:v>0.102040816326531</c:v>
                </c:pt>
                <c:pt idx="4">
                  <c:v>0.14995563442768406</c:v>
                </c:pt>
                <c:pt idx="5">
                  <c:v>0.12599822537710706</c:v>
                </c:pt>
                <c:pt idx="6">
                  <c:v>5.7675244010647712E-2</c:v>
                </c:pt>
                <c:pt idx="7">
                  <c:v>5.5013309671694786E-2</c:v>
                </c:pt>
                <c:pt idx="8">
                  <c:v>4.9689440993788803E-2</c:v>
                </c:pt>
                <c:pt idx="9">
                  <c:v>3.5492457852706299E-2</c:v>
                </c:pt>
                <c:pt idx="10">
                  <c:v>3.5492457852706299E-2</c:v>
                </c:pt>
                <c:pt idx="11">
                  <c:v>2.9281277728482713E-2</c:v>
                </c:pt>
                <c:pt idx="12">
                  <c:v>2.3957409050576799E-2</c:v>
                </c:pt>
                <c:pt idx="13">
                  <c:v>1.5084294587400199E-2</c:v>
                </c:pt>
                <c:pt idx="14">
                  <c:v>1.5084294587400199E-2</c:v>
                </c:pt>
                <c:pt idx="15">
                  <c:v>1.06477373558119E-2</c:v>
                </c:pt>
                <c:pt idx="16">
                  <c:v>1.3309671694764907E-2</c:v>
                </c:pt>
                <c:pt idx="17">
                  <c:v>7.9858030168589236E-3</c:v>
                </c:pt>
                <c:pt idx="18">
                  <c:v>7.098491570541262E-3</c:v>
                </c:pt>
                <c:pt idx="19">
                  <c:v>5.3238686779059395E-3</c:v>
                </c:pt>
                <c:pt idx="20">
                  <c:v>8.8731144631765796E-4</c:v>
                </c:pt>
              </c:numCache>
            </c:numRef>
          </c:val>
        </c:ser>
        <c:ser>
          <c:idx val="13"/>
          <c:order val="13"/>
          <c:tx>
            <c:strRef>
              <c:f>'nmr-1(ak4)_A3_0.02_5%'!$O$104</c:f>
              <c:strCache>
                <c:ptCount val="1"/>
                <c:pt idx="0">
                  <c:v>nmr-1(ak4)_A3_14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O$105:$O$125</c:f>
              <c:numCache>
                <c:formatCode>General</c:formatCode>
                <c:ptCount val="21"/>
                <c:pt idx="1">
                  <c:v>9.5563139931740607E-2</c:v>
                </c:pt>
                <c:pt idx="2">
                  <c:v>8.5324232081911283E-2</c:v>
                </c:pt>
                <c:pt idx="3">
                  <c:v>9.0443686006825827E-2</c:v>
                </c:pt>
                <c:pt idx="4">
                  <c:v>0.116040955631399</c:v>
                </c:pt>
                <c:pt idx="5">
                  <c:v>7.8498293515358433E-2</c:v>
                </c:pt>
                <c:pt idx="6">
                  <c:v>7.8498293515358433E-2</c:v>
                </c:pt>
                <c:pt idx="7">
                  <c:v>5.2901023890785014E-2</c:v>
                </c:pt>
                <c:pt idx="8">
                  <c:v>3.4129692832764499E-2</c:v>
                </c:pt>
                <c:pt idx="9">
                  <c:v>4.2662116040955621E-2</c:v>
                </c:pt>
                <c:pt idx="10">
                  <c:v>2.9010238907849806E-2</c:v>
                </c:pt>
                <c:pt idx="11">
                  <c:v>3.0716723549488085E-2</c:v>
                </c:pt>
                <c:pt idx="12">
                  <c:v>3.0716723549488085E-2</c:v>
                </c:pt>
                <c:pt idx="13">
                  <c:v>3.2423208191126311E-2</c:v>
                </c:pt>
                <c:pt idx="14">
                  <c:v>2.2184300341296901E-2</c:v>
                </c:pt>
                <c:pt idx="15">
                  <c:v>1.7064846416382305E-2</c:v>
                </c:pt>
                <c:pt idx="16">
                  <c:v>5.1194539249146834E-3</c:v>
                </c:pt>
                <c:pt idx="17">
                  <c:v>6.8259385665528976E-3</c:v>
                </c:pt>
                <c:pt idx="18">
                  <c:v>3.412969283276451E-3</c:v>
                </c:pt>
                <c:pt idx="19">
                  <c:v>1.87713310580205E-2</c:v>
                </c:pt>
                <c:pt idx="20">
                  <c:v>6.8259385665528976E-3</c:v>
                </c:pt>
              </c:numCache>
            </c:numRef>
          </c:val>
        </c:ser>
        <c:ser>
          <c:idx val="14"/>
          <c:order val="14"/>
          <c:tx>
            <c:strRef>
              <c:f>'nmr-1(ak4)_A3_0.02_5%'!$P$104</c:f>
              <c:strCache>
                <c:ptCount val="1"/>
                <c:pt idx="0">
                  <c:v>nmr-1(ak4)_A3_15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P$105:$P$125</c:f>
              <c:numCache>
                <c:formatCode>General</c:formatCode>
                <c:ptCount val="21"/>
                <c:pt idx="1">
                  <c:v>5.450733752620552E-2</c:v>
                </c:pt>
                <c:pt idx="2">
                  <c:v>9.8532494758909975E-2</c:v>
                </c:pt>
                <c:pt idx="3">
                  <c:v>0.10901467505241105</c:v>
                </c:pt>
                <c:pt idx="4">
                  <c:v>0.13207547169811296</c:v>
                </c:pt>
                <c:pt idx="5">
                  <c:v>9.2243186582809195E-2</c:v>
                </c:pt>
                <c:pt idx="6">
                  <c:v>6.0796645702306119E-2</c:v>
                </c:pt>
                <c:pt idx="7">
                  <c:v>4.40251572327044E-2</c:v>
                </c:pt>
                <c:pt idx="8">
                  <c:v>5.8700209643605915E-2</c:v>
                </c:pt>
                <c:pt idx="9">
                  <c:v>4.612159329140457E-2</c:v>
                </c:pt>
                <c:pt idx="10">
                  <c:v>4.612159329140457E-2</c:v>
                </c:pt>
                <c:pt idx="11">
                  <c:v>2.515723270440251E-2</c:v>
                </c:pt>
                <c:pt idx="12">
                  <c:v>2.515723270440251E-2</c:v>
                </c:pt>
                <c:pt idx="13">
                  <c:v>2.0964360587002108E-2</c:v>
                </c:pt>
                <c:pt idx="14">
                  <c:v>2.0964360587002108E-2</c:v>
                </c:pt>
                <c:pt idx="15">
                  <c:v>2.3060796645702285E-2</c:v>
                </c:pt>
                <c:pt idx="16">
                  <c:v>1.6771488469601706E-2</c:v>
                </c:pt>
                <c:pt idx="17">
                  <c:v>1.6771488469601706E-2</c:v>
                </c:pt>
                <c:pt idx="18">
                  <c:v>6.2893081761006336E-3</c:v>
                </c:pt>
                <c:pt idx="19">
                  <c:v>6.2893081761006336E-3</c:v>
                </c:pt>
                <c:pt idx="20">
                  <c:v>4.1928721174004204E-3</c:v>
                </c:pt>
              </c:numCache>
            </c:numRef>
          </c:val>
        </c:ser>
        <c:ser>
          <c:idx val="15"/>
          <c:order val="15"/>
          <c:tx>
            <c:strRef>
              <c:f>'nmr-1(ak4)_A3_0.02_5%'!$Q$104</c:f>
              <c:strCache>
                <c:ptCount val="1"/>
                <c:pt idx="0">
                  <c:v>nmr-1(ak4)_A3_16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Q$105:$Q$125</c:f>
              <c:numCache>
                <c:formatCode>General</c:formatCode>
                <c:ptCount val="21"/>
                <c:pt idx="1">
                  <c:v>6.3025210084033598E-2</c:v>
                </c:pt>
                <c:pt idx="2">
                  <c:v>0.1</c:v>
                </c:pt>
                <c:pt idx="3">
                  <c:v>0.14117647058823499</c:v>
                </c:pt>
                <c:pt idx="4">
                  <c:v>0.16134453781512606</c:v>
                </c:pt>
                <c:pt idx="5">
                  <c:v>0.15042016806722708</c:v>
                </c:pt>
                <c:pt idx="6">
                  <c:v>5.7142857142857099E-2</c:v>
                </c:pt>
                <c:pt idx="7">
                  <c:v>5.6302521008403432E-2</c:v>
                </c:pt>
                <c:pt idx="8">
                  <c:v>5.4621848739495778E-2</c:v>
                </c:pt>
                <c:pt idx="9">
                  <c:v>3.1092436974789899E-2</c:v>
                </c:pt>
                <c:pt idx="10">
                  <c:v>3.445378151260501E-2</c:v>
                </c:pt>
                <c:pt idx="11">
                  <c:v>3.5294117647058802E-2</c:v>
                </c:pt>
                <c:pt idx="12">
                  <c:v>1.5126050420168104E-2</c:v>
                </c:pt>
                <c:pt idx="13">
                  <c:v>1.0924369747899204E-2</c:v>
                </c:pt>
                <c:pt idx="14">
                  <c:v>1.3445378151260505E-2</c:v>
                </c:pt>
                <c:pt idx="15">
                  <c:v>1.1764705882352905E-2</c:v>
                </c:pt>
                <c:pt idx="16">
                  <c:v>6.7226890756302516E-3</c:v>
                </c:pt>
                <c:pt idx="17">
                  <c:v>8.403361344537821E-4</c:v>
                </c:pt>
                <c:pt idx="18">
                  <c:v>3.361344537815131E-3</c:v>
                </c:pt>
                <c:pt idx="19">
                  <c:v>3.361344537815131E-3</c:v>
                </c:pt>
                <c:pt idx="20">
                  <c:v>8.403361344537821E-4</c:v>
                </c:pt>
              </c:numCache>
            </c:numRef>
          </c:val>
        </c:ser>
        <c:ser>
          <c:idx val="16"/>
          <c:order val="16"/>
          <c:tx>
            <c:strRef>
              <c:f>'nmr-1(ak4)_A3_0.02_5%'!$R$104</c:f>
              <c:strCache>
                <c:ptCount val="1"/>
                <c:pt idx="0">
                  <c:v>nmr-1(ak4)_A3_17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R$105:$R$125</c:f>
              <c:numCache>
                <c:formatCode>General</c:formatCode>
                <c:ptCount val="21"/>
                <c:pt idx="1">
                  <c:v>6.8897637795275621E-2</c:v>
                </c:pt>
                <c:pt idx="2">
                  <c:v>7.283464566929132E-2</c:v>
                </c:pt>
                <c:pt idx="3">
                  <c:v>8.2677165354330728E-2</c:v>
                </c:pt>
                <c:pt idx="4">
                  <c:v>9.350393700787403E-2</c:v>
                </c:pt>
                <c:pt idx="5">
                  <c:v>0.12007874015748003</c:v>
                </c:pt>
                <c:pt idx="6">
                  <c:v>5.0196850393700802E-2</c:v>
                </c:pt>
                <c:pt idx="7">
                  <c:v>5.9055118110236199E-2</c:v>
                </c:pt>
                <c:pt idx="8">
                  <c:v>6.2992125984252009E-2</c:v>
                </c:pt>
                <c:pt idx="9">
                  <c:v>4.8228346456692869E-2</c:v>
                </c:pt>
                <c:pt idx="10">
                  <c:v>3.6417322834645716E-2</c:v>
                </c:pt>
                <c:pt idx="11">
                  <c:v>3.7401574803149616E-2</c:v>
                </c:pt>
                <c:pt idx="12">
                  <c:v>4.7244094488188997E-2</c:v>
                </c:pt>
                <c:pt idx="13">
                  <c:v>3.7401574803149616E-2</c:v>
                </c:pt>
                <c:pt idx="14">
                  <c:v>3.3464566929133903E-2</c:v>
                </c:pt>
                <c:pt idx="15">
                  <c:v>1.9685039370078709E-2</c:v>
                </c:pt>
                <c:pt idx="16">
                  <c:v>1.27952755905512E-2</c:v>
                </c:pt>
                <c:pt idx="17">
                  <c:v>1.5748031496063006E-2</c:v>
                </c:pt>
                <c:pt idx="18">
                  <c:v>5.905511811023622E-3</c:v>
                </c:pt>
                <c:pt idx="19">
                  <c:v>3.9370078740157497E-3</c:v>
                </c:pt>
                <c:pt idx="20">
                  <c:v>5.905511811023622E-3</c:v>
                </c:pt>
              </c:numCache>
            </c:numRef>
          </c:val>
        </c:ser>
        <c:ser>
          <c:idx val="17"/>
          <c:order val="17"/>
          <c:tx>
            <c:strRef>
              <c:f>'nmr-1(ak4)_A3_0.02_5%'!$S$104</c:f>
              <c:strCache>
                <c:ptCount val="1"/>
                <c:pt idx="0">
                  <c:v>nmr-1(ak4)_A3_18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S$105:$S$125</c:f>
              <c:numCache>
                <c:formatCode>General</c:formatCode>
                <c:ptCount val="21"/>
                <c:pt idx="1">
                  <c:v>5.0490883590462797E-2</c:v>
                </c:pt>
                <c:pt idx="2">
                  <c:v>7.9242636746143139E-2</c:v>
                </c:pt>
                <c:pt idx="3">
                  <c:v>0.12131837307152903</c:v>
                </c:pt>
                <c:pt idx="4">
                  <c:v>0.14375876577840099</c:v>
                </c:pt>
                <c:pt idx="5">
                  <c:v>0.16058906030855488</c:v>
                </c:pt>
                <c:pt idx="6">
                  <c:v>6.241234221598882E-2</c:v>
                </c:pt>
                <c:pt idx="7">
                  <c:v>4.6283309957924304E-2</c:v>
                </c:pt>
                <c:pt idx="8">
                  <c:v>5.3997194950911646E-2</c:v>
                </c:pt>
                <c:pt idx="9">
                  <c:v>5.2594670406732116E-2</c:v>
                </c:pt>
                <c:pt idx="10">
                  <c:v>4.2776998597475503E-2</c:v>
                </c:pt>
                <c:pt idx="11">
                  <c:v>2.6647966339410911E-2</c:v>
                </c:pt>
                <c:pt idx="12">
                  <c:v>2.1739130434782601E-2</c:v>
                </c:pt>
                <c:pt idx="13">
                  <c:v>2.2440392706872418E-2</c:v>
                </c:pt>
                <c:pt idx="14">
                  <c:v>1.6129032258064505E-2</c:v>
                </c:pt>
                <c:pt idx="15">
                  <c:v>1.1921458625525906E-2</c:v>
                </c:pt>
                <c:pt idx="16">
                  <c:v>6.3113604488078522E-3</c:v>
                </c:pt>
                <c:pt idx="17">
                  <c:v>4.9088359046283317E-3</c:v>
                </c:pt>
                <c:pt idx="18">
                  <c:v>3.5063113604488112E-3</c:v>
                </c:pt>
                <c:pt idx="19">
                  <c:v>1.4025245441795201E-3</c:v>
                </c:pt>
                <c:pt idx="20">
                  <c:v>3.5063113604488112E-3</c:v>
                </c:pt>
              </c:numCache>
            </c:numRef>
          </c:val>
        </c:ser>
        <c:ser>
          <c:idx val="18"/>
          <c:order val="18"/>
          <c:tx>
            <c:strRef>
              <c:f>'nmr-1(ak4)_A3_0.02_5%'!$T$104</c:f>
              <c:strCache>
                <c:ptCount val="1"/>
                <c:pt idx="0">
                  <c:v>nmr-1(ak4)_A3_19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T$105:$T$125</c:f>
              <c:numCache>
                <c:formatCode>General</c:formatCode>
                <c:ptCount val="21"/>
                <c:pt idx="1">
                  <c:v>4.5939294503691629E-2</c:v>
                </c:pt>
                <c:pt idx="2">
                  <c:v>0.10910582444626706</c:v>
                </c:pt>
                <c:pt idx="3">
                  <c:v>0.12469237079573403</c:v>
                </c:pt>
                <c:pt idx="4">
                  <c:v>0.15832649712879407</c:v>
                </c:pt>
                <c:pt idx="5">
                  <c:v>0.13617719442165693</c:v>
                </c:pt>
                <c:pt idx="6">
                  <c:v>4.8400328137817902E-2</c:v>
                </c:pt>
                <c:pt idx="7">
                  <c:v>6.3166529942575933E-2</c:v>
                </c:pt>
                <c:pt idx="8">
                  <c:v>5.7424118129614399E-2</c:v>
                </c:pt>
                <c:pt idx="9">
                  <c:v>4.1837571780147714E-2</c:v>
                </c:pt>
                <c:pt idx="10">
                  <c:v>3.19934372436423E-2</c:v>
                </c:pt>
                <c:pt idx="11">
                  <c:v>3.6095159967186201E-2</c:v>
                </c:pt>
                <c:pt idx="12">
                  <c:v>2.2149302707137008E-2</c:v>
                </c:pt>
                <c:pt idx="13">
                  <c:v>1.2305168170631698E-2</c:v>
                </c:pt>
                <c:pt idx="14">
                  <c:v>8.2034454470877854E-3</c:v>
                </c:pt>
                <c:pt idx="15">
                  <c:v>7.3831009023789997E-3</c:v>
                </c:pt>
                <c:pt idx="16">
                  <c:v>9.0237899917965641E-3</c:v>
                </c:pt>
                <c:pt idx="17">
                  <c:v>7.3831009023789997E-3</c:v>
                </c:pt>
                <c:pt idx="18">
                  <c:v>4.1017227235438936E-3</c:v>
                </c:pt>
                <c:pt idx="19">
                  <c:v>2.4610336341263309E-3</c:v>
                </c:pt>
                <c:pt idx="20">
                  <c:v>2.4610336341263309E-3</c:v>
                </c:pt>
              </c:numCache>
            </c:numRef>
          </c:val>
        </c:ser>
        <c:ser>
          <c:idx val="19"/>
          <c:order val="19"/>
          <c:tx>
            <c:strRef>
              <c:f>'nmr-1(ak4)_A3_0.02_5%'!$U$104</c:f>
              <c:strCache>
                <c:ptCount val="1"/>
                <c:pt idx="0">
                  <c:v>nmr-1(ak4)_A3_20</c:v>
                </c:pt>
              </c:strCache>
            </c:strRef>
          </c:tx>
          <c:marker>
            <c:symbol val="none"/>
          </c:marker>
          <c:cat>
            <c:numRef>
              <c:f>'nmr-1(ak4)_A3_0.02_5%'!$A$105:$A$125</c:f>
              <c:numCache>
                <c:formatCode>0.0_);\(0.0\)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3_0.02_5%'!$U$105:$U$125</c:f>
              <c:numCache>
                <c:formatCode>General</c:formatCode>
                <c:ptCount val="21"/>
                <c:pt idx="1">
                  <c:v>8.6046511627906982E-2</c:v>
                </c:pt>
                <c:pt idx="2">
                  <c:v>0.101162790697674</c:v>
                </c:pt>
                <c:pt idx="3">
                  <c:v>0.102325581395349</c:v>
                </c:pt>
                <c:pt idx="4">
                  <c:v>0.1</c:v>
                </c:pt>
                <c:pt idx="5">
                  <c:v>0.124418604651163</c:v>
                </c:pt>
                <c:pt idx="6">
                  <c:v>6.86046511627907E-2</c:v>
                </c:pt>
                <c:pt idx="7">
                  <c:v>4.3023255813953498E-2</c:v>
                </c:pt>
                <c:pt idx="8">
                  <c:v>3.9534883720930197E-2</c:v>
                </c:pt>
                <c:pt idx="9">
                  <c:v>3.1395348837209312E-2</c:v>
                </c:pt>
                <c:pt idx="10">
                  <c:v>2.906976744186051E-2</c:v>
                </c:pt>
                <c:pt idx="11">
                  <c:v>3.0232558139534901E-2</c:v>
                </c:pt>
                <c:pt idx="12">
                  <c:v>2.4418604651162797E-2</c:v>
                </c:pt>
                <c:pt idx="13">
                  <c:v>2.5581395348837199E-2</c:v>
                </c:pt>
                <c:pt idx="14">
                  <c:v>2.5581395348837199E-2</c:v>
                </c:pt>
                <c:pt idx="15">
                  <c:v>1.6279069767441898E-2</c:v>
                </c:pt>
                <c:pt idx="16">
                  <c:v>1.7441860465116307E-2</c:v>
                </c:pt>
                <c:pt idx="17">
                  <c:v>1.5116279069767405E-2</c:v>
                </c:pt>
                <c:pt idx="18">
                  <c:v>8.1395348837209371E-3</c:v>
                </c:pt>
                <c:pt idx="19">
                  <c:v>6.9767441860465133E-3</c:v>
                </c:pt>
                <c:pt idx="20">
                  <c:v>3.4883720930232601E-3</c:v>
                </c:pt>
              </c:numCache>
            </c:numRef>
          </c:val>
        </c:ser>
        <c:marker val="1"/>
        <c:axId val="159699712"/>
        <c:axId val="159701248"/>
      </c:lineChart>
      <c:catAx>
        <c:axId val="159699712"/>
        <c:scaling>
          <c:orientation val="minMax"/>
        </c:scaling>
        <c:axPos val="b"/>
        <c:numFmt formatCode="0.0_);\(0.0\)" sourceLinked="1"/>
        <c:tickLblPos val="nextTo"/>
        <c:crossAx val="159701248"/>
        <c:crosses val="autoZero"/>
        <c:auto val="1"/>
        <c:lblAlgn val="ctr"/>
        <c:lblOffset val="100"/>
        <c:tickLblSkip val="5"/>
        <c:tickMarkSkip val="5"/>
      </c:catAx>
      <c:valAx>
        <c:axId val="15970124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9699712"/>
        <c:crosses val="autoZero"/>
        <c:crossBetween val="between"/>
      </c:valAx>
    </c:plotArea>
    <c:plotVisOnly val="1"/>
  </c:chart>
  <c:externalData r:id="rId1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nm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mr-1(ak4)_A5_0.02_5%'!$B$104</c:f>
              <c:strCache>
                <c:ptCount val="1"/>
                <c:pt idx="0">
                  <c:v>nmr-1(ak4)_A5_01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B$105:$B$125</c:f>
              <c:numCache>
                <c:formatCode>General</c:formatCode>
                <c:ptCount val="21"/>
                <c:pt idx="1">
                  <c:v>5.3691275167785178E-2</c:v>
                </c:pt>
                <c:pt idx="2">
                  <c:v>8.4563758389261848E-2</c:v>
                </c:pt>
                <c:pt idx="3">
                  <c:v>0.13154362416107401</c:v>
                </c:pt>
                <c:pt idx="4">
                  <c:v>0.12885906040268497</c:v>
                </c:pt>
                <c:pt idx="5">
                  <c:v>0.102013422818792</c:v>
                </c:pt>
                <c:pt idx="6">
                  <c:v>5.9060402684563813E-2</c:v>
                </c:pt>
                <c:pt idx="7">
                  <c:v>4.2953020134228227E-2</c:v>
                </c:pt>
                <c:pt idx="8">
                  <c:v>4.4295302013422799E-2</c:v>
                </c:pt>
                <c:pt idx="9">
                  <c:v>3.6241610738255013E-2</c:v>
                </c:pt>
                <c:pt idx="10">
                  <c:v>3.7583892617449731E-2</c:v>
                </c:pt>
                <c:pt idx="11">
                  <c:v>3.2214765100671117E-2</c:v>
                </c:pt>
                <c:pt idx="12">
                  <c:v>3.6241610738255013E-2</c:v>
                </c:pt>
                <c:pt idx="13">
                  <c:v>2.28187919463087E-2</c:v>
                </c:pt>
                <c:pt idx="14">
                  <c:v>1.3422818791946301E-2</c:v>
                </c:pt>
                <c:pt idx="15">
                  <c:v>1.61073825503356E-2</c:v>
                </c:pt>
                <c:pt idx="16">
                  <c:v>1.3422818791946301E-2</c:v>
                </c:pt>
                <c:pt idx="17">
                  <c:v>1.47651006711409E-2</c:v>
                </c:pt>
                <c:pt idx="18">
                  <c:v>1.20805369127517E-2</c:v>
                </c:pt>
                <c:pt idx="19">
                  <c:v>1.3422818791946301E-2</c:v>
                </c:pt>
                <c:pt idx="20">
                  <c:v>5.3691275167785197E-3</c:v>
                </c:pt>
              </c:numCache>
            </c:numRef>
          </c:val>
        </c:ser>
        <c:ser>
          <c:idx val="1"/>
          <c:order val="1"/>
          <c:tx>
            <c:strRef>
              <c:f>'nmr-1(ak4)_A5_0.02_5%'!$C$104</c:f>
              <c:strCache>
                <c:ptCount val="1"/>
                <c:pt idx="0">
                  <c:v>nmr-1(ak4)_A5_02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C$105:$C$125</c:f>
              <c:numCache>
                <c:formatCode>General</c:formatCode>
                <c:ptCount val="21"/>
                <c:pt idx="1">
                  <c:v>6.7357512953367921E-2</c:v>
                </c:pt>
                <c:pt idx="2">
                  <c:v>0.113989637305699</c:v>
                </c:pt>
                <c:pt idx="3">
                  <c:v>8.0310880829015482E-2</c:v>
                </c:pt>
                <c:pt idx="4">
                  <c:v>5.6994818652849701E-2</c:v>
                </c:pt>
                <c:pt idx="5">
                  <c:v>6.2176165803108814E-2</c:v>
                </c:pt>
                <c:pt idx="6">
                  <c:v>7.512953367875648E-2</c:v>
                </c:pt>
                <c:pt idx="7">
                  <c:v>3.3678756476683898E-2</c:v>
                </c:pt>
                <c:pt idx="8">
                  <c:v>4.1450777202072499E-2</c:v>
                </c:pt>
                <c:pt idx="9">
                  <c:v>4.9222797927461127E-2</c:v>
                </c:pt>
                <c:pt idx="10">
                  <c:v>3.3678756476683898E-2</c:v>
                </c:pt>
                <c:pt idx="11">
                  <c:v>3.8860103626943011E-2</c:v>
                </c:pt>
                <c:pt idx="12">
                  <c:v>4.6632124352331626E-2</c:v>
                </c:pt>
                <c:pt idx="13">
                  <c:v>4.9222797927461127E-2</c:v>
                </c:pt>
                <c:pt idx="14">
                  <c:v>4.1450777202072499E-2</c:v>
                </c:pt>
                <c:pt idx="15">
                  <c:v>2.0725388601036301E-2</c:v>
                </c:pt>
                <c:pt idx="16">
                  <c:v>3.6269430051813517E-2</c:v>
                </c:pt>
                <c:pt idx="17">
                  <c:v>2.0725388601036301E-2</c:v>
                </c:pt>
                <c:pt idx="18">
                  <c:v>1.2953367875647699E-2</c:v>
                </c:pt>
                <c:pt idx="19">
                  <c:v>1.5544041450777204E-2</c:v>
                </c:pt>
                <c:pt idx="20">
                  <c:v>1.5544041450777204E-2</c:v>
                </c:pt>
              </c:numCache>
            </c:numRef>
          </c:val>
        </c:ser>
        <c:ser>
          <c:idx val="2"/>
          <c:order val="2"/>
          <c:tx>
            <c:strRef>
              <c:f>'nmr-1(ak4)_A5_0.02_5%'!$D$104</c:f>
              <c:strCache>
                <c:ptCount val="1"/>
                <c:pt idx="0">
                  <c:v>nmr-1(ak4)_A5_03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D$105:$D$125</c:f>
              <c:numCache>
                <c:formatCode>General</c:formatCode>
                <c:ptCount val="21"/>
                <c:pt idx="1">
                  <c:v>6.7919075144508734E-2</c:v>
                </c:pt>
                <c:pt idx="2">
                  <c:v>0.10549132947976902</c:v>
                </c:pt>
                <c:pt idx="3">
                  <c:v>8.9595375722543377E-2</c:v>
                </c:pt>
                <c:pt idx="4">
                  <c:v>0.11849710982659002</c:v>
                </c:pt>
                <c:pt idx="5">
                  <c:v>9.9710982658959529E-2</c:v>
                </c:pt>
                <c:pt idx="6">
                  <c:v>4.6242774566473979E-2</c:v>
                </c:pt>
                <c:pt idx="7">
                  <c:v>4.6242774566473979E-2</c:v>
                </c:pt>
                <c:pt idx="8">
                  <c:v>4.19075144508671E-2</c:v>
                </c:pt>
                <c:pt idx="9">
                  <c:v>4.3352601156069419E-2</c:v>
                </c:pt>
                <c:pt idx="10">
                  <c:v>4.4797687861271751E-2</c:v>
                </c:pt>
                <c:pt idx="11">
                  <c:v>3.4682080924855502E-2</c:v>
                </c:pt>
                <c:pt idx="12">
                  <c:v>2.7456647398843913E-2</c:v>
                </c:pt>
                <c:pt idx="13">
                  <c:v>2.1676300578034716E-2</c:v>
                </c:pt>
                <c:pt idx="14">
                  <c:v>2.7456647398843913E-2</c:v>
                </c:pt>
                <c:pt idx="15">
                  <c:v>1.8786127167630107E-2</c:v>
                </c:pt>
                <c:pt idx="16">
                  <c:v>2.1676300578034716E-2</c:v>
                </c:pt>
                <c:pt idx="17">
                  <c:v>1.8786127167630107E-2</c:v>
                </c:pt>
                <c:pt idx="18">
                  <c:v>5.7803468208092517E-3</c:v>
                </c:pt>
                <c:pt idx="19">
                  <c:v>1.1560693641618505E-2</c:v>
                </c:pt>
                <c:pt idx="20">
                  <c:v>5.7803468208092517E-3</c:v>
                </c:pt>
              </c:numCache>
            </c:numRef>
          </c:val>
        </c:ser>
        <c:ser>
          <c:idx val="3"/>
          <c:order val="3"/>
          <c:tx>
            <c:strRef>
              <c:f>'nmr-1(ak4)_A5_0.02_5%'!$E$104</c:f>
              <c:strCache>
                <c:ptCount val="1"/>
                <c:pt idx="0">
                  <c:v>nmr-1(ak4)_A5_04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E$105:$E$125</c:f>
              <c:numCache>
                <c:formatCode>General</c:formatCode>
                <c:ptCount val="21"/>
                <c:pt idx="1">
                  <c:v>6.7456700091157701E-2</c:v>
                </c:pt>
                <c:pt idx="2">
                  <c:v>8.3865086599817756E-2</c:v>
                </c:pt>
                <c:pt idx="3">
                  <c:v>0.12215132178669105</c:v>
                </c:pt>
                <c:pt idx="4">
                  <c:v>0.16499544211485906</c:v>
                </c:pt>
                <c:pt idx="5">
                  <c:v>0.13400182315405695</c:v>
                </c:pt>
                <c:pt idx="6">
                  <c:v>4.9225159525979868E-2</c:v>
                </c:pt>
                <c:pt idx="7">
                  <c:v>6.0164083865086621E-2</c:v>
                </c:pt>
                <c:pt idx="8">
                  <c:v>5.2871467639015512E-2</c:v>
                </c:pt>
                <c:pt idx="9">
                  <c:v>4.3755697356426648E-2</c:v>
                </c:pt>
                <c:pt idx="10">
                  <c:v>3.9197812215132202E-2</c:v>
                </c:pt>
                <c:pt idx="11">
                  <c:v>2.8258887876025506E-2</c:v>
                </c:pt>
                <c:pt idx="12">
                  <c:v>1.9143117593436603E-2</c:v>
                </c:pt>
                <c:pt idx="13">
                  <c:v>1.5496809480401101E-2</c:v>
                </c:pt>
                <c:pt idx="14">
                  <c:v>9.1157702825888798E-3</c:v>
                </c:pt>
                <c:pt idx="15">
                  <c:v>1.00273473108478E-2</c:v>
                </c:pt>
                <c:pt idx="16">
                  <c:v>7.2926162260711002E-3</c:v>
                </c:pt>
                <c:pt idx="17">
                  <c:v>6.3810391978122239E-3</c:v>
                </c:pt>
                <c:pt idx="18">
                  <c:v>6.3810391978122239E-3</c:v>
                </c:pt>
                <c:pt idx="19">
                  <c:v>9.1157702825888796E-4</c:v>
                </c:pt>
                <c:pt idx="20">
                  <c:v>2.7347310847766616E-3</c:v>
                </c:pt>
              </c:numCache>
            </c:numRef>
          </c:val>
        </c:ser>
        <c:ser>
          <c:idx val="4"/>
          <c:order val="4"/>
          <c:tx>
            <c:strRef>
              <c:f>'nmr-1(ak4)_A5_0.02_5%'!$F$104</c:f>
              <c:strCache>
                <c:ptCount val="1"/>
                <c:pt idx="0">
                  <c:v>nmr-1(ak4)_A5_05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F$105:$F$125</c:f>
              <c:numCache>
                <c:formatCode>General</c:formatCode>
                <c:ptCount val="21"/>
                <c:pt idx="1">
                  <c:v>0.11111111111111099</c:v>
                </c:pt>
                <c:pt idx="2">
                  <c:v>5.555555555555558E-2</c:v>
                </c:pt>
                <c:pt idx="3">
                  <c:v>6.9444444444444434E-2</c:v>
                </c:pt>
                <c:pt idx="4">
                  <c:v>6.9444444444444434E-2</c:v>
                </c:pt>
                <c:pt idx="5">
                  <c:v>6.9444444444444434E-2</c:v>
                </c:pt>
                <c:pt idx="6">
                  <c:v>5.555555555555558E-2</c:v>
                </c:pt>
                <c:pt idx="7">
                  <c:v>4.1666666666666699E-2</c:v>
                </c:pt>
                <c:pt idx="8">
                  <c:v>2.7777777777777821E-2</c:v>
                </c:pt>
                <c:pt idx="9">
                  <c:v>6.9444444444444434E-2</c:v>
                </c:pt>
                <c:pt idx="10">
                  <c:v>0.11111111111111099</c:v>
                </c:pt>
                <c:pt idx="11">
                  <c:v>8.3333333333333329E-2</c:v>
                </c:pt>
                <c:pt idx="12">
                  <c:v>6.9444444444444434E-2</c:v>
                </c:pt>
                <c:pt idx="13">
                  <c:v>1.3888888888888907E-2</c:v>
                </c:pt>
                <c:pt idx="14">
                  <c:v>0</c:v>
                </c:pt>
                <c:pt idx="15">
                  <c:v>2.7777777777777821E-2</c:v>
                </c:pt>
                <c:pt idx="16">
                  <c:v>0</c:v>
                </c:pt>
                <c:pt idx="17">
                  <c:v>1.3888888888888907E-2</c:v>
                </c:pt>
                <c:pt idx="18">
                  <c:v>0</c:v>
                </c:pt>
                <c:pt idx="19">
                  <c:v>0</c:v>
                </c:pt>
                <c:pt idx="20">
                  <c:v>1.3888888888888907E-2</c:v>
                </c:pt>
              </c:numCache>
            </c:numRef>
          </c:val>
        </c:ser>
        <c:ser>
          <c:idx val="5"/>
          <c:order val="5"/>
          <c:tx>
            <c:strRef>
              <c:f>'nmr-1(ak4)_A5_0.02_5%'!$G$104</c:f>
              <c:strCache>
                <c:ptCount val="1"/>
                <c:pt idx="0">
                  <c:v>nmr-1(ak4)_A5_06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G$105:$G$125</c:f>
              <c:numCache>
                <c:formatCode>General</c:formatCode>
                <c:ptCount val="21"/>
                <c:pt idx="1">
                  <c:v>5.9050064184852404E-2</c:v>
                </c:pt>
                <c:pt idx="2">
                  <c:v>9.7560975609756156E-2</c:v>
                </c:pt>
                <c:pt idx="3">
                  <c:v>0.10397946084724</c:v>
                </c:pt>
                <c:pt idx="4">
                  <c:v>0.13222079589216906</c:v>
                </c:pt>
                <c:pt idx="5">
                  <c:v>0.102695763799743</c:v>
                </c:pt>
                <c:pt idx="6">
                  <c:v>5.648267008985882E-2</c:v>
                </c:pt>
                <c:pt idx="7">
                  <c:v>5.9050064184852404E-2</c:v>
                </c:pt>
                <c:pt idx="8">
                  <c:v>3.3376123234916594E-2</c:v>
                </c:pt>
                <c:pt idx="9">
                  <c:v>3.5943517329910121E-2</c:v>
                </c:pt>
                <c:pt idx="10">
                  <c:v>3.2092426187419802E-2</c:v>
                </c:pt>
                <c:pt idx="11">
                  <c:v>2.3106546854942189E-2</c:v>
                </c:pt>
                <c:pt idx="12">
                  <c:v>2.4390243902439001E-2</c:v>
                </c:pt>
                <c:pt idx="13">
                  <c:v>2.0539152759948699E-2</c:v>
                </c:pt>
                <c:pt idx="14">
                  <c:v>1.6688061617458311E-2</c:v>
                </c:pt>
                <c:pt idx="15">
                  <c:v>2.4390243902439001E-2</c:v>
                </c:pt>
                <c:pt idx="16">
                  <c:v>6.4184852374839499E-3</c:v>
                </c:pt>
                <c:pt idx="17">
                  <c:v>1.2836970474967901E-2</c:v>
                </c:pt>
                <c:pt idx="18">
                  <c:v>1.5404364569961504E-2</c:v>
                </c:pt>
                <c:pt idx="19">
                  <c:v>1.2836970474967901E-2</c:v>
                </c:pt>
                <c:pt idx="20">
                  <c:v>1.15532734274711E-2</c:v>
                </c:pt>
              </c:numCache>
            </c:numRef>
          </c:val>
        </c:ser>
        <c:ser>
          <c:idx val="6"/>
          <c:order val="6"/>
          <c:tx>
            <c:strRef>
              <c:f>'nmr-1(ak4)_A5_0.02_5%'!$H$104</c:f>
              <c:strCache>
                <c:ptCount val="1"/>
                <c:pt idx="0">
                  <c:v>nmr-1(ak4)_A5_07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H$105:$H$125</c:f>
              <c:numCache>
                <c:formatCode>General</c:formatCode>
                <c:ptCount val="21"/>
                <c:pt idx="1">
                  <c:v>5.0709939148073029E-2</c:v>
                </c:pt>
                <c:pt idx="2">
                  <c:v>7.5050709939148127E-2</c:v>
                </c:pt>
                <c:pt idx="3">
                  <c:v>5.8823529411764698E-2</c:v>
                </c:pt>
                <c:pt idx="4">
                  <c:v>4.8681541582150073E-2</c:v>
                </c:pt>
                <c:pt idx="5">
                  <c:v>4.6653144016227201E-2</c:v>
                </c:pt>
                <c:pt idx="6">
                  <c:v>2.4340770791075099E-2</c:v>
                </c:pt>
                <c:pt idx="7">
                  <c:v>3.4482758620689717E-2</c:v>
                </c:pt>
                <c:pt idx="8">
                  <c:v>2.2312373225152105E-2</c:v>
                </c:pt>
                <c:pt idx="9">
                  <c:v>3.0425963488843816E-2</c:v>
                </c:pt>
                <c:pt idx="10">
                  <c:v>3.651115618661261E-2</c:v>
                </c:pt>
                <c:pt idx="11">
                  <c:v>4.2596348884381317E-2</c:v>
                </c:pt>
                <c:pt idx="12">
                  <c:v>6.0851926977687598E-2</c:v>
                </c:pt>
                <c:pt idx="13">
                  <c:v>7.3022312373225221E-2</c:v>
                </c:pt>
                <c:pt idx="14">
                  <c:v>7.7079107505071007E-2</c:v>
                </c:pt>
                <c:pt idx="15">
                  <c:v>7.0993914807302244E-2</c:v>
                </c:pt>
                <c:pt idx="16">
                  <c:v>5.2738336713995915E-2</c:v>
                </c:pt>
                <c:pt idx="17">
                  <c:v>3.8539553752535503E-2</c:v>
                </c:pt>
                <c:pt idx="18">
                  <c:v>2.4340770791075099E-2</c:v>
                </c:pt>
                <c:pt idx="19">
                  <c:v>1.4198782961460396E-2</c:v>
                </c:pt>
                <c:pt idx="20">
                  <c:v>1.0141987829614599E-2</c:v>
                </c:pt>
              </c:numCache>
            </c:numRef>
          </c:val>
        </c:ser>
        <c:ser>
          <c:idx val="7"/>
          <c:order val="7"/>
          <c:tx>
            <c:strRef>
              <c:f>'nmr-1(ak4)_A5_0.02_5%'!$I$104</c:f>
              <c:strCache>
                <c:ptCount val="1"/>
                <c:pt idx="0">
                  <c:v>nmr-1(ak4)_A5_08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I$105:$I$125</c:f>
              <c:numCache>
                <c:formatCode>General</c:formatCode>
                <c:ptCount val="21"/>
                <c:pt idx="1">
                  <c:v>7.2273324572930397E-2</c:v>
                </c:pt>
                <c:pt idx="2">
                  <c:v>7.0959264126149821E-2</c:v>
                </c:pt>
                <c:pt idx="3">
                  <c:v>8.6727989487516421E-2</c:v>
                </c:pt>
                <c:pt idx="4">
                  <c:v>0.12483574244415209</c:v>
                </c:pt>
                <c:pt idx="5">
                  <c:v>8.6727989487516421E-2</c:v>
                </c:pt>
                <c:pt idx="6">
                  <c:v>6.9645203679369175E-2</c:v>
                </c:pt>
                <c:pt idx="7">
                  <c:v>3.8107752956636001E-2</c:v>
                </c:pt>
                <c:pt idx="8">
                  <c:v>4.5992115637319302E-2</c:v>
                </c:pt>
                <c:pt idx="9">
                  <c:v>4.4678055190538787E-2</c:v>
                </c:pt>
                <c:pt idx="10">
                  <c:v>3.4165571616294299E-2</c:v>
                </c:pt>
                <c:pt idx="11">
                  <c:v>3.5479632063074931E-2</c:v>
                </c:pt>
                <c:pt idx="12">
                  <c:v>2.890932982917211E-2</c:v>
                </c:pt>
                <c:pt idx="13">
                  <c:v>3.2851511169513813E-2</c:v>
                </c:pt>
                <c:pt idx="14">
                  <c:v>2.3653088042049901E-2</c:v>
                </c:pt>
                <c:pt idx="15">
                  <c:v>2.7595269382391607E-2</c:v>
                </c:pt>
                <c:pt idx="16">
                  <c:v>2.2339027595269418E-2</c:v>
                </c:pt>
                <c:pt idx="17">
                  <c:v>1.5768725361366608E-2</c:v>
                </c:pt>
                <c:pt idx="18">
                  <c:v>1.4454664914586099E-2</c:v>
                </c:pt>
                <c:pt idx="19">
                  <c:v>7.8843626806833142E-3</c:v>
                </c:pt>
                <c:pt idx="20">
                  <c:v>5.2562417871222138E-3</c:v>
                </c:pt>
              </c:numCache>
            </c:numRef>
          </c:val>
        </c:ser>
        <c:ser>
          <c:idx val="8"/>
          <c:order val="8"/>
          <c:tx>
            <c:strRef>
              <c:f>'nmr-1(ak4)_A5_0.02_5%'!$J$104</c:f>
              <c:strCache>
                <c:ptCount val="1"/>
                <c:pt idx="0">
                  <c:v>nmr-1(ak4)_A5_09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J$105:$J$125</c:f>
              <c:numCache>
                <c:formatCode>General</c:formatCode>
                <c:ptCount val="21"/>
                <c:pt idx="1">
                  <c:v>5.7142857142857099E-2</c:v>
                </c:pt>
                <c:pt idx="2">
                  <c:v>9.6428571428571405E-2</c:v>
                </c:pt>
                <c:pt idx="3">
                  <c:v>7.8571428571428598E-2</c:v>
                </c:pt>
                <c:pt idx="4">
                  <c:v>0.11785714285714298</c:v>
                </c:pt>
                <c:pt idx="5">
                  <c:v>6.4285714285714293E-2</c:v>
                </c:pt>
                <c:pt idx="6">
                  <c:v>5.1785714285714303E-2</c:v>
                </c:pt>
                <c:pt idx="7">
                  <c:v>3.9285714285714313E-2</c:v>
                </c:pt>
                <c:pt idx="8">
                  <c:v>3.7500000000000006E-2</c:v>
                </c:pt>
                <c:pt idx="9">
                  <c:v>3.7500000000000006E-2</c:v>
                </c:pt>
                <c:pt idx="10">
                  <c:v>4.8214285714285703E-2</c:v>
                </c:pt>
                <c:pt idx="11">
                  <c:v>3.2142857142857098E-2</c:v>
                </c:pt>
                <c:pt idx="12">
                  <c:v>4.8214285714285703E-2</c:v>
                </c:pt>
                <c:pt idx="13">
                  <c:v>3.7500000000000006E-2</c:v>
                </c:pt>
                <c:pt idx="14">
                  <c:v>4.1071428571428578E-2</c:v>
                </c:pt>
                <c:pt idx="15">
                  <c:v>3.0357142857142898E-2</c:v>
                </c:pt>
                <c:pt idx="16">
                  <c:v>2.8571428571428602E-2</c:v>
                </c:pt>
                <c:pt idx="17">
                  <c:v>2.5000000000000001E-2</c:v>
                </c:pt>
                <c:pt idx="18">
                  <c:v>2.1428571428571408E-2</c:v>
                </c:pt>
                <c:pt idx="19">
                  <c:v>8.9285714285714229E-3</c:v>
                </c:pt>
                <c:pt idx="20">
                  <c:v>8.9285714285714229E-3</c:v>
                </c:pt>
              </c:numCache>
            </c:numRef>
          </c:val>
        </c:ser>
        <c:ser>
          <c:idx val="9"/>
          <c:order val="9"/>
          <c:tx>
            <c:strRef>
              <c:f>'nmr-1(ak4)_A5_0.02_5%'!$K$104</c:f>
              <c:strCache>
                <c:ptCount val="1"/>
                <c:pt idx="0">
                  <c:v>nmr-1(ak4)_A5_10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K$105:$K$125</c:f>
              <c:numCache>
                <c:formatCode>General</c:formatCode>
                <c:ptCount val="21"/>
                <c:pt idx="1">
                  <c:v>8.2717872968980796E-2</c:v>
                </c:pt>
                <c:pt idx="2">
                  <c:v>0.10192023633678003</c:v>
                </c:pt>
                <c:pt idx="3">
                  <c:v>0.11669128508124109</c:v>
                </c:pt>
                <c:pt idx="4">
                  <c:v>0.10192023633678003</c:v>
                </c:pt>
                <c:pt idx="5">
                  <c:v>0.10487444608567204</c:v>
                </c:pt>
                <c:pt idx="6">
                  <c:v>6.2038404726735635E-2</c:v>
                </c:pt>
                <c:pt idx="7">
                  <c:v>4.7267355982274696E-2</c:v>
                </c:pt>
                <c:pt idx="8">
                  <c:v>3.2496307237813923E-2</c:v>
                </c:pt>
                <c:pt idx="9">
                  <c:v>3.5450516986706114E-2</c:v>
                </c:pt>
                <c:pt idx="10">
                  <c:v>2.806499261447561E-2</c:v>
                </c:pt>
                <c:pt idx="11">
                  <c:v>2.9542097488921719E-2</c:v>
                </c:pt>
                <c:pt idx="12">
                  <c:v>2.0679468242245199E-2</c:v>
                </c:pt>
                <c:pt idx="13">
                  <c:v>1.4771048744460901E-2</c:v>
                </c:pt>
                <c:pt idx="14">
                  <c:v>2.5110782865583492E-2</c:v>
                </c:pt>
                <c:pt idx="15">
                  <c:v>1.3293943870014794E-2</c:v>
                </c:pt>
                <c:pt idx="16">
                  <c:v>2.2156573116691301E-2</c:v>
                </c:pt>
                <c:pt idx="17">
                  <c:v>1.4771048744460901E-2</c:v>
                </c:pt>
                <c:pt idx="18">
                  <c:v>1.3293943870014794E-2</c:v>
                </c:pt>
                <c:pt idx="19">
                  <c:v>7.3855243722304297E-3</c:v>
                </c:pt>
                <c:pt idx="20">
                  <c:v>1.1816838995568707E-2</c:v>
                </c:pt>
              </c:numCache>
            </c:numRef>
          </c:val>
        </c:ser>
        <c:ser>
          <c:idx val="10"/>
          <c:order val="10"/>
          <c:tx>
            <c:strRef>
              <c:f>'nmr-1(ak4)_A5_0.02_5%'!$M$105</c:f>
              <c:strCache>
                <c:ptCount val="1"/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L$105:$L$125</c:f>
              <c:numCache>
                <c:formatCode>General</c:formatCode>
                <c:ptCount val="21"/>
                <c:pt idx="1">
                  <c:v>7.9787234042553251E-2</c:v>
                </c:pt>
                <c:pt idx="2">
                  <c:v>9.4680851063829841E-2</c:v>
                </c:pt>
                <c:pt idx="3">
                  <c:v>0.108510638297872</c:v>
                </c:pt>
                <c:pt idx="4">
                  <c:v>0.14361702127659601</c:v>
                </c:pt>
                <c:pt idx="5">
                  <c:v>0.13404255319148906</c:v>
                </c:pt>
                <c:pt idx="6">
                  <c:v>4.5744680851063826E-2</c:v>
                </c:pt>
                <c:pt idx="7">
                  <c:v>5.6382978723404302E-2</c:v>
                </c:pt>
                <c:pt idx="8">
                  <c:v>3.4042553191489397E-2</c:v>
                </c:pt>
                <c:pt idx="9">
                  <c:v>3.0851063829787202E-2</c:v>
                </c:pt>
                <c:pt idx="10">
                  <c:v>3.1914893617021316E-2</c:v>
                </c:pt>
                <c:pt idx="11">
                  <c:v>2.2340425531914902E-2</c:v>
                </c:pt>
                <c:pt idx="12">
                  <c:v>2.7659574468085115E-2</c:v>
                </c:pt>
                <c:pt idx="13">
                  <c:v>1.7021276595744698E-2</c:v>
                </c:pt>
                <c:pt idx="14">
                  <c:v>1.3829787234042604E-2</c:v>
                </c:pt>
                <c:pt idx="15">
                  <c:v>9.5744680851063795E-3</c:v>
                </c:pt>
                <c:pt idx="16">
                  <c:v>1.1702127659574506E-2</c:v>
                </c:pt>
                <c:pt idx="17">
                  <c:v>7.4468085106383025E-3</c:v>
                </c:pt>
                <c:pt idx="18">
                  <c:v>1.0638297872340394E-2</c:v>
                </c:pt>
                <c:pt idx="19">
                  <c:v>5.31914893617021E-3</c:v>
                </c:pt>
                <c:pt idx="20">
                  <c:v>6.3829787234042637E-3</c:v>
                </c:pt>
              </c:numCache>
            </c:numRef>
          </c:val>
        </c:ser>
        <c:ser>
          <c:idx val="11"/>
          <c:order val="11"/>
          <c:tx>
            <c:strRef>
              <c:f>'nmr-1(ak4)_A5_0.02_5%'!$M$104</c:f>
              <c:strCache>
                <c:ptCount val="1"/>
                <c:pt idx="0">
                  <c:v>nmr-1(ak4)_A5_12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M$105:$M$125</c:f>
              <c:numCache>
                <c:formatCode>General</c:formatCode>
                <c:ptCount val="21"/>
                <c:pt idx="1">
                  <c:v>7.0318887980376124E-2</c:v>
                </c:pt>
                <c:pt idx="2">
                  <c:v>7.2771872444807803E-2</c:v>
                </c:pt>
                <c:pt idx="3">
                  <c:v>0.11529026982829105</c:v>
                </c:pt>
                <c:pt idx="4">
                  <c:v>0.13409648405560107</c:v>
                </c:pt>
                <c:pt idx="5">
                  <c:v>0.13409648405560107</c:v>
                </c:pt>
                <c:pt idx="6">
                  <c:v>4.4971381847915021E-2</c:v>
                </c:pt>
                <c:pt idx="7">
                  <c:v>5.5600981193785814E-2</c:v>
                </c:pt>
                <c:pt idx="8">
                  <c:v>5.3965658217497985E-2</c:v>
                </c:pt>
                <c:pt idx="9">
                  <c:v>4.4153720359771123E-2</c:v>
                </c:pt>
                <c:pt idx="10">
                  <c:v>3.5159443990188083E-2</c:v>
                </c:pt>
                <c:pt idx="11">
                  <c:v>3.7612428454619817E-2</c:v>
                </c:pt>
                <c:pt idx="12">
                  <c:v>3.5977105478332015E-2</c:v>
                </c:pt>
                <c:pt idx="13">
                  <c:v>2.6982829108748992E-2</c:v>
                </c:pt>
                <c:pt idx="14">
                  <c:v>1.3900245298446405E-2</c:v>
                </c:pt>
                <c:pt idx="15">
                  <c:v>8.1766148814390854E-3</c:v>
                </c:pt>
                <c:pt idx="16">
                  <c:v>1.7988552739166008E-2</c:v>
                </c:pt>
                <c:pt idx="17">
                  <c:v>5.7236304170073622E-3</c:v>
                </c:pt>
                <c:pt idx="18">
                  <c:v>4.0883074407195418E-3</c:v>
                </c:pt>
                <c:pt idx="19">
                  <c:v>1.6353229762878208E-3</c:v>
                </c:pt>
                <c:pt idx="20">
                  <c:v>2.4529844644317301E-3</c:v>
                </c:pt>
              </c:numCache>
            </c:numRef>
          </c:val>
        </c:ser>
        <c:ser>
          <c:idx val="12"/>
          <c:order val="12"/>
          <c:tx>
            <c:strRef>
              <c:f>'nmr-1(ak4)_A5_0.02_5%'!$N$104</c:f>
              <c:strCache>
                <c:ptCount val="1"/>
                <c:pt idx="0">
                  <c:v>nmr-1(ak4)_A5_13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N$105:$N$125</c:f>
              <c:numCache>
                <c:formatCode>General</c:formatCode>
                <c:ptCount val="21"/>
                <c:pt idx="1">
                  <c:v>4.8665620094191502E-2</c:v>
                </c:pt>
                <c:pt idx="2">
                  <c:v>8.0062794348508576E-2</c:v>
                </c:pt>
                <c:pt idx="3">
                  <c:v>9.8901098901098952E-2</c:v>
                </c:pt>
                <c:pt idx="4">
                  <c:v>9.2621664050235503E-2</c:v>
                </c:pt>
                <c:pt idx="5">
                  <c:v>8.1632653061224497E-2</c:v>
                </c:pt>
                <c:pt idx="6">
                  <c:v>5.1805337519623199E-2</c:v>
                </c:pt>
                <c:pt idx="7">
                  <c:v>3.7676609105180517E-2</c:v>
                </c:pt>
                <c:pt idx="8">
                  <c:v>4.2386185243328121E-2</c:v>
                </c:pt>
                <c:pt idx="9">
                  <c:v>2.5117739403453711E-2</c:v>
                </c:pt>
                <c:pt idx="10">
                  <c:v>2.1978021978022001E-2</c:v>
                </c:pt>
                <c:pt idx="11">
                  <c:v>3.61067503924647E-2</c:v>
                </c:pt>
                <c:pt idx="12">
                  <c:v>3.61067503924647E-2</c:v>
                </c:pt>
                <c:pt idx="13">
                  <c:v>2.9827315541601309E-2</c:v>
                </c:pt>
                <c:pt idx="14">
                  <c:v>4.8665620094191502E-2</c:v>
                </c:pt>
                <c:pt idx="15">
                  <c:v>3.1397174254317102E-2</c:v>
                </c:pt>
                <c:pt idx="16">
                  <c:v>3.61067503924647E-2</c:v>
                </c:pt>
                <c:pt idx="17">
                  <c:v>2.5117739403453711E-2</c:v>
                </c:pt>
                <c:pt idx="18">
                  <c:v>2.1978021978022001E-2</c:v>
                </c:pt>
                <c:pt idx="19">
                  <c:v>1.25588697017268E-2</c:v>
                </c:pt>
                <c:pt idx="20">
                  <c:v>1.0989010989011E-2</c:v>
                </c:pt>
              </c:numCache>
            </c:numRef>
          </c:val>
        </c:ser>
        <c:ser>
          <c:idx val="13"/>
          <c:order val="13"/>
          <c:tx>
            <c:strRef>
              <c:f>'nmr-1(ak4)_A5_0.02_5%'!$O$104</c:f>
              <c:strCache>
                <c:ptCount val="1"/>
                <c:pt idx="0">
                  <c:v>nmr-1(ak4)_A5_14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O$105:$O$125</c:f>
              <c:numCache>
                <c:formatCode>General</c:formatCode>
                <c:ptCount val="21"/>
                <c:pt idx="1">
                  <c:v>7.1830985915493029E-2</c:v>
                </c:pt>
                <c:pt idx="2">
                  <c:v>8.1690140845070452E-2</c:v>
                </c:pt>
                <c:pt idx="3">
                  <c:v>6.4788732394366194E-2</c:v>
                </c:pt>
                <c:pt idx="4">
                  <c:v>6.6197183098591503E-2</c:v>
                </c:pt>
                <c:pt idx="5">
                  <c:v>9.154929577464796E-2</c:v>
                </c:pt>
                <c:pt idx="6">
                  <c:v>5.7746478873239422E-2</c:v>
                </c:pt>
                <c:pt idx="7">
                  <c:v>5.7746478873239422E-2</c:v>
                </c:pt>
                <c:pt idx="8">
                  <c:v>3.9436619718309911E-2</c:v>
                </c:pt>
                <c:pt idx="9">
                  <c:v>3.2394366197183097E-2</c:v>
                </c:pt>
                <c:pt idx="10">
                  <c:v>3.6619718309859217E-2</c:v>
                </c:pt>
                <c:pt idx="11">
                  <c:v>4.3661971830985913E-2</c:v>
                </c:pt>
                <c:pt idx="12">
                  <c:v>4.0845070422535198E-2</c:v>
                </c:pt>
                <c:pt idx="13">
                  <c:v>3.6619718309859217E-2</c:v>
                </c:pt>
                <c:pt idx="14">
                  <c:v>3.2394366197183097E-2</c:v>
                </c:pt>
                <c:pt idx="15">
                  <c:v>4.0845070422535198E-2</c:v>
                </c:pt>
                <c:pt idx="16">
                  <c:v>3.8028169014084498E-2</c:v>
                </c:pt>
                <c:pt idx="17">
                  <c:v>3.5211267605633818E-2</c:v>
                </c:pt>
                <c:pt idx="18">
                  <c:v>1.4084507042253504E-2</c:v>
                </c:pt>
                <c:pt idx="19">
                  <c:v>2.2535211267605614E-2</c:v>
                </c:pt>
                <c:pt idx="20">
                  <c:v>1.1267605633802807E-2</c:v>
                </c:pt>
              </c:numCache>
            </c:numRef>
          </c:val>
        </c:ser>
        <c:ser>
          <c:idx val="14"/>
          <c:order val="14"/>
          <c:tx>
            <c:strRef>
              <c:f>'nmr-1(ak4)_A5_0.02_5%'!$P$104</c:f>
              <c:strCache>
                <c:ptCount val="1"/>
                <c:pt idx="0">
                  <c:v>nmr-1(ak4)_A5_15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P$105:$P$125</c:f>
              <c:numCache>
                <c:formatCode>General</c:formatCode>
                <c:ptCount val="21"/>
                <c:pt idx="1">
                  <c:v>6.9892473118279647E-2</c:v>
                </c:pt>
                <c:pt idx="2">
                  <c:v>9.1397849462365593E-2</c:v>
                </c:pt>
                <c:pt idx="3">
                  <c:v>0.10322580645161308</c:v>
                </c:pt>
                <c:pt idx="4">
                  <c:v>0.12150537634408599</c:v>
                </c:pt>
                <c:pt idx="5">
                  <c:v>0.11827956989247297</c:v>
                </c:pt>
                <c:pt idx="6">
                  <c:v>5.2688172043010802E-2</c:v>
                </c:pt>
                <c:pt idx="7">
                  <c:v>5.591397849462372E-2</c:v>
                </c:pt>
                <c:pt idx="8">
                  <c:v>5.0537634408602226E-2</c:v>
                </c:pt>
                <c:pt idx="9">
                  <c:v>4.1935483870967703E-2</c:v>
                </c:pt>
                <c:pt idx="10">
                  <c:v>4.6236559139784895E-2</c:v>
                </c:pt>
                <c:pt idx="11">
                  <c:v>3.2258064516129011E-2</c:v>
                </c:pt>
                <c:pt idx="12">
                  <c:v>4.3010752688171984E-2</c:v>
                </c:pt>
                <c:pt idx="13">
                  <c:v>2.3655913978494609E-2</c:v>
                </c:pt>
                <c:pt idx="14">
                  <c:v>2.2580645161290311E-2</c:v>
                </c:pt>
                <c:pt idx="15">
                  <c:v>1.2903225806451601E-2</c:v>
                </c:pt>
                <c:pt idx="16">
                  <c:v>1.1827956989247301E-2</c:v>
                </c:pt>
                <c:pt idx="17">
                  <c:v>1.1827956989247301E-2</c:v>
                </c:pt>
                <c:pt idx="18">
                  <c:v>4.3010752688171982E-3</c:v>
                </c:pt>
                <c:pt idx="19">
                  <c:v>4.3010752688171982E-3</c:v>
                </c:pt>
                <c:pt idx="20">
                  <c:v>6.4516129032258134E-3</c:v>
                </c:pt>
              </c:numCache>
            </c:numRef>
          </c:val>
        </c:ser>
        <c:ser>
          <c:idx val="15"/>
          <c:order val="15"/>
          <c:tx>
            <c:strRef>
              <c:f>'nmr-1(ak4)_A5_0.02_5%'!$Q$104</c:f>
              <c:strCache>
                <c:ptCount val="1"/>
                <c:pt idx="0">
                  <c:v>nmr-1(ak4)_A5_16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Q$105:$Q$125</c:f>
              <c:numCache>
                <c:formatCode>General</c:formatCode>
                <c:ptCount val="21"/>
                <c:pt idx="1">
                  <c:v>9.954058192955588E-2</c:v>
                </c:pt>
                <c:pt idx="2">
                  <c:v>9.4946401225114899E-2</c:v>
                </c:pt>
                <c:pt idx="3">
                  <c:v>0.11485451761102597</c:v>
                </c:pt>
                <c:pt idx="4">
                  <c:v>8.4226646248085832E-2</c:v>
                </c:pt>
                <c:pt idx="5">
                  <c:v>9.4946401225114899E-2</c:v>
                </c:pt>
                <c:pt idx="6">
                  <c:v>5.5130168453292487E-2</c:v>
                </c:pt>
                <c:pt idx="7">
                  <c:v>5.0535987748851513E-2</c:v>
                </c:pt>
                <c:pt idx="8">
                  <c:v>4.441041347626342E-2</c:v>
                </c:pt>
                <c:pt idx="9">
                  <c:v>4.59418070444104E-2</c:v>
                </c:pt>
                <c:pt idx="10">
                  <c:v>3.0627871362940307E-2</c:v>
                </c:pt>
                <c:pt idx="11">
                  <c:v>2.7565084226646198E-2</c:v>
                </c:pt>
                <c:pt idx="12">
                  <c:v>2.1439509954058199E-2</c:v>
                </c:pt>
                <c:pt idx="13">
                  <c:v>2.6033690658499215E-2</c:v>
                </c:pt>
                <c:pt idx="14">
                  <c:v>1.6845329249617218E-2</c:v>
                </c:pt>
                <c:pt idx="15">
                  <c:v>3.3690658499234298E-2</c:v>
                </c:pt>
                <c:pt idx="16">
                  <c:v>1.6845329249617218E-2</c:v>
                </c:pt>
                <c:pt idx="17">
                  <c:v>1.0719754977029098E-2</c:v>
                </c:pt>
                <c:pt idx="18">
                  <c:v>1.53139356814701E-2</c:v>
                </c:pt>
                <c:pt idx="19">
                  <c:v>4.59418070444104E-3</c:v>
                </c:pt>
                <c:pt idx="20">
                  <c:v>1.0719754977029098E-2</c:v>
                </c:pt>
              </c:numCache>
            </c:numRef>
          </c:val>
        </c:ser>
        <c:ser>
          <c:idx val="16"/>
          <c:order val="16"/>
          <c:tx>
            <c:strRef>
              <c:f>'nmr-1(ak4)_A5_0.02_5%'!$R$104</c:f>
              <c:strCache>
                <c:ptCount val="1"/>
                <c:pt idx="0">
                  <c:v>nmr-1(ak4)_A5_17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R$105:$R$125</c:f>
              <c:numCache>
                <c:formatCode>General</c:formatCode>
                <c:ptCount val="21"/>
                <c:pt idx="1">
                  <c:v>7.1428571428571411E-2</c:v>
                </c:pt>
                <c:pt idx="2">
                  <c:v>9.3097913322632467E-2</c:v>
                </c:pt>
                <c:pt idx="3">
                  <c:v>9.9518459069020959E-2</c:v>
                </c:pt>
                <c:pt idx="4">
                  <c:v>0.13804173354735211</c:v>
                </c:pt>
                <c:pt idx="5">
                  <c:v>0.158908507223114</c:v>
                </c:pt>
                <c:pt idx="6">
                  <c:v>5.6982343499197396E-2</c:v>
                </c:pt>
                <c:pt idx="7">
                  <c:v>3.9325842696629212E-2</c:v>
                </c:pt>
                <c:pt idx="8">
                  <c:v>5.2969502407704698E-2</c:v>
                </c:pt>
                <c:pt idx="9">
                  <c:v>5.1364365971107495E-2</c:v>
                </c:pt>
                <c:pt idx="10">
                  <c:v>3.77207062600321E-2</c:v>
                </c:pt>
                <c:pt idx="11">
                  <c:v>3.77207062600321E-2</c:v>
                </c:pt>
                <c:pt idx="12">
                  <c:v>4.0930979133226332E-2</c:v>
                </c:pt>
                <c:pt idx="13">
                  <c:v>1.3643659711075408E-2</c:v>
                </c:pt>
                <c:pt idx="14">
                  <c:v>7.2231139646870002E-3</c:v>
                </c:pt>
                <c:pt idx="15">
                  <c:v>1.1235955056179799E-2</c:v>
                </c:pt>
                <c:pt idx="16">
                  <c:v>8.0256821829855531E-3</c:v>
                </c:pt>
                <c:pt idx="17">
                  <c:v>9.630818619582664E-3</c:v>
                </c:pt>
                <c:pt idx="18">
                  <c:v>4.0128410914927817E-3</c:v>
                </c:pt>
                <c:pt idx="19">
                  <c:v>6.4205457463884395E-3</c:v>
                </c:pt>
                <c:pt idx="20">
                  <c:v>2.4077046548956712E-3</c:v>
                </c:pt>
              </c:numCache>
            </c:numRef>
          </c:val>
        </c:ser>
        <c:ser>
          <c:idx val="17"/>
          <c:order val="17"/>
          <c:tx>
            <c:strRef>
              <c:f>'nmr-1(ak4)_A5_0.02_5%'!$S$104</c:f>
              <c:strCache>
                <c:ptCount val="1"/>
                <c:pt idx="0">
                  <c:v>nmr-1(ak4)_A5_18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S$105:$S$125</c:f>
              <c:numCache>
                <c:formatCode>General</c:formatCode>
                <c:ptCount val="21"/>
                <c:pt idx="1">
                  <c:v>6.4343163538873996E-2</c:v>
                </c:pt>
                <c:pt idx="2">
                  <c:v>5.0938337801608627E-2</c:v>
                </c:pt>
                <c:pt idx="3">
                  <c:v>5.0938337801608627E-2</c:v>
                </c:pt>
                <c:pt idx="4">
                  <c:v>4.2895442359249317E-2</c:v>
                </c:pt>
                <c:pt idx="5">
                  <c:v>3.4852546916890097E-2</c:v>
                </c:pt>
                <c:pt idx="6">
                  <c:v>2.6809651474530807E-2</c:v>
                </c:pt>
                <c:pt idx="7">
                  <c:v>2.949061662198391E-2</c:v>
                </c:pt>
                <c:pt idx="8">
                  <c:v>3.2171581769436998E-2</c:v>
                </c:pt>
                <c:pt idx="9">
                  <c:v>4.825737265415548E-2</c:v>
                </c:pt>
                <c:pt idx="10">
                  <c:v>4.5576407506702402E-2</c:v>
                </c:pt>
                <c:pt idx="11">
                  <c:v>7.2386058981233334E-2</c:v>
                </c:pt>
                <c:pt idx="12">
                  <c:v>5.8981233243967812E-2</c:v>
                </c:pt>
                <c:pt idx="13">
                  <c:v>5.0938337801608627E-2</c:v>
                </c:pt>
                <c:pt idx="14">
                  <c:v>6.7024128686327095E-2</c:v>
                </c:pt>
                <c:pt idx="15">
                  <c:v>2.1447721179624717E-2</c:v>
                </c:pt>
                <c:pt idx="16">
                  <c:v>2.1447721179624717E-2</c:v>
                </c:pt>
                <c:pt idx="17">
                  <c:v>2.6809651474530807E-2</c:v>
                </c:pt>
                <c:pt idx="18">
                  <c:v>2.1447721179624717E-2</c:v>
                </c:pt>
                <c:pt idx="19">
                  <c:v>2.4128686327077688E-2</c:v>
                </c:pt>
                <c:pt idx="20">
                  <c:v>1.6085790884718506E-2</c:v>
                </c:pt>
              </c:numCache>
            </c:numRef>
          </c:val>
        </c:ser>
        <c:ser>
          <c:idx val="18"/>
          <c:order val="18"/>
          <c:tx>
            <c:strRef>
              <c:f>'nmr-1(ak4)_A5_0.02_5%'!$T$104</c:f>
              <c:strCache>
                <c:ptCount val="1"/>
                <c:pt idx="0">
                  <c:v>nmr-1(ak4)_A5_19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T$105:$T$125</c:f>
              <c:numCache>
                <c:formatCode>General</c:formatCode>
                <c:ptCount val="21"/>
                <c:pt idx="1">
                  <c:v>8.6799276672694395E-2</c:v>
                </c:pt>
                <c:pt idx="2">
                  <c:v>0.11573236889692598</c:v>
                </c:pt>
                <c:pt idx="3">
                  <c:v>9.4032549728752357E-2</c:v>
                </c:pt>
                <c:pt idx="4">
                  <c:v>9.7649186256781179E-2</c:v>
                </c:pt>
                <c:pt idx="5">
                  <c:v>9.0415913200723272E-2</c:v>
                </c:pt>
                <c:pt idx="6">
                  <c:v>7.7757685352622133E-2</c:v>
                </c:pt>
                <c:pt idx="7">
                  <c:v>5.0632911392405118E-2</c:v>
                </c:pt>
                <c:pt idx="8">
                  <c:v>4.1591320072332703E-2</c:v>
                </c:pt>
                <c:pt idx="9">
                  <c:v>3.9783001808318313E-2</c:v>
                </c:pt>
                <c:pt idx="10">
                  <c:v>3.2549728752260414E-2</c:v>
                </c:pt>
                <c:pt idx="11">
                  <c:v>5.0632911392405118E-2</c:v>
                </c:pt>
                <c:pt idx="12">
                  <c:v>5.0632911392405118E-2</c:v>
                </c:pt>
                <c:pt idx="13">
                  <c:v>1.0849909584086799E-2</c:v>
                </c:pt>
                <c:pt idx="14">
                  <c:v>1.8083182640144701E-2</c:v>
                </c:pt>
                <c:pt idx="15">
                  <c:v>1.9891500904159101E-2</c:v>
                </c:pt>
                <c:pt idx="16">
                  <c:v>7.2332730560578738E-3</c:v>
                </c:pt>
                <c:pt idx="17">
                  <c:v>7.2332730560578738E-3</c:v>
                </c:pt>
                <c:pt idx="18">
                  <c:v>1.8083182640144704E-3</c:v>
                </c:pt>
                <c:pt idx="19">
                  <c:v>1.8083182640144701E-2</c:v>
                </c:pt>
                <c:pt idx="20">
                  <c:v>3.6166365280289312E-3</c:v>
                </c:pt>
              </c:numCache>
            </c:numRef>
          </c:val>
        </c:ser>
        <c:ser>
          <c:idx val="19"/>
          <c:order val="19"/>
          <c:tx>
            <c:strRef>
              <c:f>'nmr-1(ak4)_A5_0.02_5%'!$U$104</c:f>
              <c:strCache>
                <c:ptCount val="1"/>
                <c:pt idx="0">
                  <c:v>nmr-1(ak4)_A5_20</c:v>
                </c:pt>
              </c:strCache>
            </c:strRef>
          </c:tx>
          <c:marker>
            <c:symbol val="none"/>
          </c:marker>
          <c:cat>
            <c:numRef>
              <c:f>'nmr-1(ak4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mr-1(ak4)_A5_0.02_5%'!$U$105:$U$125</c:f>
              <c:numCache>
                <c:formatCode>General</c:formatCode>
                <c:ptCount val="21"/>
                <c:pt idx="1">
                  <c:v>8.3941605839416095E-2</c:v>
                </c:pt>
                <c:pt idx="2">
                  <c:v>5.8394160583941611E-2</c:v>
                </c:pt>
                <c:pt idx="3">
                  <c:v>7.2992700729927029E-2</c:v>
                </c:pt>
                <c:pt idx="4">
                  <c:v>8.5766423357664254E-2</c:v>
                </c:pt>
                <c:pt idx="5">
                  <c:v>8.9416058394160641E-2</c:v>
                </c:pt>
                <c:pt idx="6">
                  <c:v>5.1094890510948912E-2</c:v>
                </c:pt>
                <c:pt idx="7">
                  <c:v>4.0145985401459867E-2</c:v>
                </c:pt>
                <c:pt idx="8">
                  <c:v>1.8248175182481806E-2</c:v>
                </c:pt>
                <c:pt idx="9">
                  <c:v>2.1897810218978117E-2</c:v>
                </c:pt>
                <c:pt idx="10">
                  <c:v>5.1094890510948912E-2</c:v>
                </c:pt>
                <c:pt idx="11">
                  <c:v>3.4671532846715321E-2</c:v>
                </c:pt>
                <c:pt idx="12">
                  <c:v>4.0145985401459867E-2</c:v>
                </c:pt>
                <c:pt idx="13">
                  <c:v>4.1970802919707978E-2</c:v>
                </c:pt>
                <c:pt idx="14">
                  <c:v>2.7372262773722615E-2</c:v>
                </c:pt>
                <c:pt idx="15">
                  <c:v>3.4671532846715321E-2</c:v>
                </c:pt>
                <c:pt idx="16">
                  <c:v>3.2846715328467217E-2</c:v>
                </c:pt>
                <c:pt idx="17">
                  <c:v>2.37226277372263E-2</c:v>
                </c:pt>
                <c:pt idx="18">
                  <c:v>1.4598540145985401E-2</c:v>
                </c:pt>
                <c:pt idx="19">
                  <c:v>2.5547445255474512E-2</c:v>
                </c:pt>
                <c:pt idx="20">
                  <c:v>1.0948905109489104E-2</c:v>
                </c:pt>
              </c:numCache>
            </c:numRef>
          </c:val>
        </c:ser>
        <c:marker val="1"/>
        <c:axId val="159863552"/>
        <c:axId val="159865088"/>
      </c:lineChart>
      <c:catAx>
        <c:axId val="159863552"/>
        <c:scaling>
          <c:orientation val="minMax"/>
        </c:scaling>
        <c:axPos val="b"/>
        <c:numFmt formatCode="0.0_ " sourceLinked="1"/>
        <c:tickLblPos val="nextTo"/>
        <c:crossAx val="159865088"/>
        <c:crosses val="autoZero"/>
        <c:auto val="1"/>
        <c:lblAlgn val="ctr"/>
        <c:lblOffset val="100"/>
        <c:tickLblSkip val="5"/>
        <c:tickMarkSkip val="5"/>
      </c:catAx>
      <c:valAx>
        <c:axId val="15986508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9863552"/>
        <c:crosses val="autoZero"/>
        <c:crossBetween val="between"/>
      </c:valAx>
    </c:plotArea>
    <c:plotVisOnly val="1"/>
  </c:chart>
  <c:externalData r:id="rId1"/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2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2(CB1112)_A5_0.02_5%'!$B$104</c:f>
              <c:strCache>
                <c:ptCount val="1"/>
                <c:pt idx="0">
                  <c:v>cat-2(CB1112)_A5_01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B$105:$B$125</c:f>
              <c:numCache>
                <c:formatCode>General</c:formatCode>
                <c:ptCount val="21"/>
                <c:pt idx="1">
                  <c:v>6.9965870307167194E-2</c:v>
                </c:pt>
                <c:pt idx="2">
                  <c:v>8.7883959044368562E-2</c:v>
                </c:pt>
                <c:pt idx="3">
                  <c:v>0.10068259385665503</c:v>
                </c:pt>
                <c:pt idx="4">
                  <c:v>0.14505119453924906</c:v>
                </c:pt>
                <c:pt idx="5">
                  <c:v>0.12883959044368595</c:v>
                </c:pt>
                <c:pt idx="6">
                  <c:v>5.2901023890785014E-2</c:v>
                </c:pt>
                <c:pt idx="7">
                  <c:v>4.0102389078498314E-2</c:v>
                </c:pt>
                <c:pt idx="8">
                  <c:v>4.436860068259392E-2</c:v>
                </c:pt>
                <c:pt idx="9">
                  <c:v>4.3515358361774663E-2</c:v>
                </c:pt>
                <c:pt idx="10">
                  <c:v>4.0955631399317419E-2</c:v>
                </c:pt>
                <c:pt idx="11">
                  <c:v>3.8395904436860098E-2</c:v>
                </c:pt>
                <c:pt idx="12">
                  <c:v>3.2423208191126311E-2</c:v>
                </c:pt>
                <c:pt idx="13">
                  <c:v>2.3890784982935197E-2</c:v>
                </c:pt>
                <c:pt idx="14">
                  <c:v>9.3856655290102484E-3</c:v>
                </c:pt>
                <c:pt idx="15">
                  <c:v>1.7064846416382305E-2</c:v>
                </c:pt>
                <c:pt idx="16">
                  <c:v>8.5324232081911335E-3</c:v>
                </c:pt>
                <c:pt idx="17">
                  <c:v>9.3856655290102484E-3</c:v>
                </c:pt>
                <c:pt idx="18">
                  <c:v>6.8259385665528976E-3</c:v>
                </c:pt>
                <c:pt idx="19">
                  <c:v>4.2662116040955624E-3</c:v>
                </c:pt>
                <c:pt idx="20">
                  <c:v>5.9726962457337923E-3</c:v>
                </c:pt>
              </c:numCache>
            </c:numRef>
          </c:val>
        </c:ser>
        <c:ser>
          <c:idx val="1"/>
          <c:order val="1"/>
          <c:tx>
            <c:strRef>
              <c:f>'cat-2(CB1112)_A5_0.02_5%'!$C$104</c:f>
              <c:strCache>
                <c:ptCount val="1"/>
                <c:pt idx="0">
                  <c:v>cat-2(CB1112)_A5_02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C$105:$C$125</c:f>
              <c:numCache>
                <c:formatCode>General</c:formatCode>
                <c:ptCount val="21"/>
                <c:pt idx="1">
                  <c:v>8.6038961038960998E-2</c:v>
                </c:pt>
                <c:pt idx="2">
                  <c:v>8.1168831168831224E-2</c:v>
                </c:pt>
                <c:pt idx="3">
                  <c:v>7.1428571428571411E-2</c:v>
                </c:pt>
                <c:pt idx="4">
                  <c:v>0.10064935064935097</c:v>
                </c:pt>
                <c:pt idx="5">
                  <c:v>8.7662337662337692E-2</c:v>
                </c:pt>
                <c:pt idx="6">
                  <c:v>5.1948051948052E-2</c:v>
                </c:pt>
                <c:pt idx="7">
                  <c:v>3.0844155844155802E-2</c:v>
                </c:pt>
                <c:pt idx="8">
                  <c:v>3.8961038961039002E-2</c:v>
                </c:pt>
                <c:pt idx="9">
                  <c:v>1.9480519480519508E-2</c:v>
                </c:pt>
                <c:pt idx="10">
                  <c:v>3.7337662337662302E-2</c:v>
                </c:pt>
                <c:pt idx="11">
                  <c:v>3.2467532467532499E-2</c:v>
                </c:pt>
                <c:pt idx="12">
                  <c:v>1.9480519480519508E-2</c:v>
                </c:pt>
                <c:pt idx="13">
                  <c:v>2.5974025974026007E-2</c:v>
                </c:pt>
                <c:pt idx="14">
                  <c:v>2.922077922077921E-2</c:v>
                </c:pt>
                <c:pt idx="15">
                  <c:v>3.4090909090909102E-2</c:v>
                </c:pt>
                <c:pt idx="16">
                  <c:v>1.9480519480519508E-2</c:v>
                </c:pt>
                <c:pt idx="17">
                  <c:v>3.4090909090909102E-2</c:v>
                </c:pt>
                <c:pt idx="18">
                  <c:v>1.6233766233766201E-2</c:v>
                </c:pt>
                <c:pt idx="19">
                  <c:v>1.1363636363636404E-2</c:v>
                </c:pt>
                <c:pt idx="20">
                  <c:v>9.74025974025974E-3</c:v>
                </c:pt>
              </c:numCache>
            </c:numRef>
          </c:val>
        </c:ser>
        <c:ser>
          <c:idx val="2"/>
          <c:order val="2"/>
          <c:tx>
            <c:strRef>
              <c:f>'cat-2(CB1112)_A5_0.02_5%'!$D$104</c:f>
              <c:strCache>
                <c:ptCount val="1"/>
                <c:pt idx="0">
                  <c:v>cat-2(CB1112)_A5_03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D$105:$D$125</c:f>
              <c:numCache>
                <c:formatCode>General</c:formatCode>
                <c:ptCount val="21"/>
                <c:pt idx="1">
                  <c:v>7.1350164654226111E-2</c:v>
                </c:pt>
                <c:pt idx="2">
                  <c:v>0.10428100987925402</c:v>
                </c:pt>
                <c:pt idx="3">
                  <c:v>0.10976948408342503</c:v>
                </c:pt>
                <c:pt idx="4">
                  <c:v>0.106476399560922</c:v>
                </c:pt>
                <c:pt idx="5">
                  <c:v>0.14709110867178901</c:v>
                </c:pt>
                <c:pt idx="6">
                  <c:v>4.0614709110867203E-2</c:v>
                </c:pt>
                <c:pt idx="7">
                  <c:v>3.0735455543358901E-2</c:v>
                </c:pt>
                <c:pt idx="8">
                  <c:v>5.7080131723380903E-2</c:v>
                </c:pt>
                <c:pt idx="9">
                  <c:v>5.1591657519209702E-2</c:v>
                </c:pt>
                <c:pt idx="10">
                  <c:v>2.6344676180022002E-2</c:v>
                </c:pt>
                <c:pt idx="11">
                  <c:v>2.0856201975850707E-2</c:v>
                </c:pt>
                <c:pt idx="12">
                  <c:v>2.414928649835351E-2</c:v>
                </c:pt>
                <c:pt idx="13">
                  <c:v>2.414928649835351E-2</c:v>
                </c:pt>
                <c:pt idx="14">
                  <c:v>2.85400658616905E-2</c:v>
                </c:pt>
                <c:pt idx="15">
                  <c:v>1.7563117453348001E-2</c:v>
                </c:pt>
                <c:pt idx="16">
                  <c:v>2.1953896816685001E-2</c:v>
                </c:pt>
                <c:pt idx="17">
                  <c:v>1.3172338090011001E-2</c:v>
                </c:pt>
                <c:pt idx="18">
                  <c:v>1.0976948408342499E-2</c:v>
                </c:pt>
                <c:pt idx="19">
                  <c:v>8.781558726673978E-3</c:v>
                </c:pt>
                <c:pt idx="20">
                  <c:v>3.293084522502742E-3</c:v>
                </c:pt>
              </c:numCache>
            </c:numRef>
          </c:val>
        </c:ser>
        <c:ser>
          <c:idx val="3"/>
          <c:order val="3"/>
          <c:tx>
            <c:strRef>
              <c:f>'cat-2(CB1112)_A5_0.02_5%'!$E$104</c:f>
              <c:strCache>
                <c:ptCount val="1"/>
                <c:pt idx="0">
                  <c:v>cat-2(CB1112)_A5_04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E$105:$E$125</c:f>
              <c:numCache>
                <c:formatCode>General</c:formatCode>
                <c:ptCount val="21"/>
                <c:pt idx="1">
                  <c:v>9.555854643337823E-2</c:v>
                </c:pt>
                <c:pt idx="2">
                  <c:v>8.4791386271870842E-2</c:v>
                </c:pt>
                <c:pt idx="3">
                  <c:v>0.10767160161507403</c:v>
                </c:pt>
                <c:pt idx="4">
                  <c:v>0.12516823687752404</c:v>
                </c:pt>
                <c:pt idx="5">
                  <c:v>9.8250336473755029E-2</c:v>
                </c:pt>
                <c:pt idx="6">
                  <c:v>5.7873485868102321E-2</c:v>
                </c:pt>
                <c:pt idx="7">
                  <c:v>5.1144010767160172E-2</c:v>
                </c:pt>
                <c:pt idx="8">
                  <c:v>4.7106325706594884E-2</c:v>
                </c:pt>
                <c:pt idx="9">
                  <c:v>3.4993270524899131E-2</c:v>
                </c:pt>
                <c:pt idx="10">
                  <c:v>2.2880215343203218E-2</c:v>
                </c:pt>
                <c:pt idx="11">
                  <c:v>2.1534320323014809E-2</c:v>
                </c:pt>
                <c:pt idx="12">
                  <c:v>3.0955585464333801E-2</c:v>
                </c:pt>
                <c:pt idx="13">
                  <c:v>2.2880215343203218E-2</c:v>
                </c:pt>
                <c:pt idx="14">
                  <c:v>2.0188425302826392E-2</c:v>
                </c:pt>
                <c:pt idx="15">
                  <c:v>1.0767160161507404E-2</c:v>
                </c:pt>
                <c:pt idx="16">
                  <c:v>1.34589502018843E-2</c:v>
                </c:pt>
                <c:pt idx="17">
                  <c:v>1.4804845222072701E-2</c:v>
                </c:pt>
                <c:pt idx="18">
                  <c:v>1.34589502018843E-2</c:v>
                </c:pt>
                <c:pt idx="19">
                  <c:v>1.4804845222072701E-2</c:v>
                </c:pt>
                <c:pt idx="20">
                  <c:v>6.7294751009421335E-3</c:v>
                </c:pt>
              </c:numCache>
            </c:numRef>
          </c:val>
        </c:ser>
        <c:ser>
          <c:idx val="4"/>
          <c:order val="4"/>
          <c:tx>
            <c:strRef>
              <c:f>'cat-2(CB1112)_A5_0.02_5%'!$F$104</c:f>
              <c:strCache>
                <c:ptCount val="1"/>
                <c:pt idx="0">
                  <c:v>cat-2(CB1112)_A5_05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F$105:$F$125</c:f>
              <c:numCache>
                <c:formatCode>General</c:formatCode>
                <c:ptCount val="21"/>
                <c:pt idx="1">
                  <c:v>9.5461658841940494E-2</c:v>
                </c:pt>
                <c:pt idx="2">
                  <c:v>7.0422535211267595E-2</c:v>
                </c:pt>
                <c:pt idx="3">
                  <c:v>7.3552425665101714E-2</c:v>
                </c:pt>
                <c:pt idx="4">
                  <c:v>0.100156494522692</c:v>
                </c:pt>
                <c:pt idx="5">
                  <c:v>0.11111111111111099</c:v>
                </c:pt>
                <c:pt idx="6">
                  <c:v>3.2863849765258211E-2</c:v>
                </c:pt>
                <c:pt idx="7">
                  <c:v>3.2863849765258211E-2</c:v>
                </c:pt>
                <c:pt idx="8">
                  <c:v>4.3818466353677622E-2</c:v>
                </c:pt>
                <c:pt idx="9">
                  <c:v>3.599374021909231E-2</c:v>
                </c:pt>
                <c:pt idx="10">
                  <c:v>4.69483568075117E-2</c:v>
                </c:pt>
                <c:pt idx="11">
                  <c:v>2.3474178403755909E-2</c:v>
                </c:pt>
                <c:pt idx="12">
                  <c:v>3.4428794992175285E-2</c:v>
                </c:pt>
                <c:pt idx="13">
                  <c:v>3.7558685446009404E-2</c:v>
                </c:pt>
                <c:pt idx="14">
                  <c:v>3.2863849765258211E-2</c:v>
                </c:pt>
                <c:pt idx="15">
                  <c:v>2.1909233176838801E-2</c:v>
                </c:pt>
                <c:pt idx="16">
                  <c:v>2.5039123630672899E-2</c:v>
                </c:pt>
                <c:pt idx="17">
                  <c:v>2.6604068857590008E-2</c:v>
                </c:pt>
                <c:pt idx="18">
                  <c:v>9.3896713615023528E-3</c:v>
                </c:pt>
                <c:pt idx="19">
                  <c:v>2.1909233176838801E-2</c:v>
                </c:pt>
                <c:pt idx="20">
                  <c:v>1.2519561815336503E-2</c:v>
                </c:pt>
              </c:numCache>
            </c:numRef>
          </c:val>
        </c:ser>
        <c:ser>
          <c:idx val="5"/>
          <c:order val="5"/>
          <c:tx>
            <c:strRef>
              <c:f>'cat-2(CB1112)_A5_0.02_5%'!$G$104</c:f>
              <c:strCache>
                <c:ptCount val="1"/>
                <c:pt idx="0">
                  <c:v>cat-2(CB1112)_A5_06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G$105:$G$125</c:f>
              <c:numCache>
                <c:formatCode>General</c:formatCode>
                <c:ptCount val="21"/>
                <c:pt idx="1">
                  <c:v>8.2949308755760398E-2</c:v>
                </c:pt>
                <c:pt idx="2">
                  <c:v>8.6405529953917107E-2</c:v>
                </c:pt>
                <c:pt idx="3">
                  <c:v>9.2165898617511524E-2</c:v>
                </c:pt>
                <c:pt idx="4">
                  <c:v>0.11290322580645203</c:v>
                </c:pt>
                <c:pt idx="5">
                  <c:v>0.12903225806451593</c:v>
                </c:pt>
                <c:pt idx="6">
                  <c:v>6.566820276497698E-2</c:v>
                </c:pt>
                <c:pt idx="7">
                  <c:v>4.4930875576036901E-2</c:v>
                </c:pt>
                <c:pt idx="8">
                  <c:v>5.6451612903225819E-2</c:v>
                </c:pt>
                <c:pt idx="9">
                  <c:v>3.2258064516129011E-2</c:v>
                </c:pt>
                <c:pt idx="10">
                  <c:v>4.4930875576036901E-2</c:v>
                </c:pt>
                <c:pt idx="11">
                  <c:v>2.6497695852534607E-2</c:v>
                </c:pt>
                <c:pt idx="12">
                  <c:v>3.5714285714285698E-2</c:v>
                </c:pt>
                <c:pt idx="13">
                  <c:v>3.1105990783410118E-2</c:v>
                </c:pt>
                <c:pt idx="14">
                  <c:v>1.6129032258064505E-2</c:v>
                </c:pt>
                <c:pt idx="15">
                  <c:v>1.3824884792626705E-2</c:v>
                </c:pt>
                <c:pt idx="16">
                  <c:v>1.1520737327188904E-2</c:v>
                </c:pt>
                <c:pt idx="17">
                  <c:v>5.7603686635944737E-3</c:v>
                </c:pt>
                <c:pt idx="18">
                  <c:v>1.3824884792626705E-2</c:v>
                </c:pt>
                <c:pt idx="19">
                  <c:v>6.9124423963133654E-3</c:v>
                </c:pt>
                <c:pt idx="20">
                  <c:v>9.2165898617511503E-3</c:v>
                </c:pt>
              </c:numCache>
            </c:numRef>
          </c:val>
        </c:ser>
        <c:ser>
          <c:idx val="6"/>
          <c:order val="6"/>
          <c:tx>
            <c:strRef>
              <c:f>'cat-2(CB1112)_A5_0.02_5%'!$H$104</c:f>
              <c:strCache>
                <c:ptCount val="1"/>
                <c:pt idx="0">
                  <c:v>cat-2(CB1112)_A5_07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H$105:$H$125</c:f>
              <c:numCache>
                <c:formatCode>General</c:formatCode>
                <c:ptCount val="21"/>
                <c:pt idx="1">
                  <c:v>9.900990099009907E-2</c:v>
                </c:pt>
                <c:pt idx="2">
                  <c:v>8.5808580858085806E-2</c:v>
                </c:pt>
                <c:pt idx="3">
                  <c:v>0.10891089108910898</c:v>
                </c:pt>
                <c:pt idx="4">
                  <c:v>7.2607260726072598E-2</c:v>
                </c:pt>
                <c:pt idx="5">
                  <c:v>8.5808580858085806E-2</c:v>
                </c:pt>
                <c:pt idx="6">
                  <c:v>4.95049504950495E-2</c:v>
                </c:pt>
                <c:pt idx="7">
                  <c:v>3.6303630363036299E-2</c:v>
                </c:pt>
                <c:pt idx="8">
                  <c:v>3.3003300330033E-2</c:v>
                </c:pt>
                <c:pt idx="9">
                  <c:v>3.9603960396039611E-2</c:v>
                </c:pt>
                <c:pt idx="10">
                  <c:v>4.2904290429042917E-2</c:v>
                </c:pt>
                <c:pt idx="11">
                  <c:v>3.3003300330033E-2</c:v>
                </c:pt>
                <c:pt idx="12">
                  <c:v>2.9702970297029712E-2</c:v>
                </c:pt>
                <c:pt idx="13">
                  <c:v>3.9603960396039611E-2</c:v>
                </c:pt>
                <c:pt idx="14">
                  <c:v>3.3003300330033E-2</c:v>
                </c:pt>
                <c:pt idx="15">
                  <c:v>4.2904290429042917E-2</c:v>
                </c:pt>
                <c:pt idx="16">
                  <c:v>9.9009900990099063E-3</c:v>
                </c:pt>
                <c:pt idx="17">
                  <c:v>2.640264026402641E-2</c:v>
                </c:pt>
                <c:pt idx="18">
                  <c:v>1.6501650165016507E-2</c:v>
                </c:pt>
                <c:pt idx="19">
                  <c:v>9.9009900990099063E-3</c:v>
                </c:pt>
                <c:pt idx="20">
                  <c:v>9.9009900990099063E-3</c:v>
                </c:pt>
              </c:numCache>
            </c:numRef>
          </c:val>
        </c:ser>
        <c:ser>
          <c:idx val="7"/>
          <c:order val="7"/>
          <c:tx>
            <c:strRef>
              <c:f>'cat-2(CB1112)_A5_0.02_5%'!$I$104</c:f>
              <c:strCache>
                <c:ptCount val="1"/>
                <c:pt idx="0">
                  <c:v>cat-2(CB1112)_A5_08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I$105:$I$125</c:f>
              <c:numCache>
                <c:formatCode>General</c:formatCode>
                <c:ptCount val="21"/>
                <c:pt idx="1">
                  <c:v>7.6458752515090489E-2</c:v>
                </c:pt>
                <c:pt idx="2">
                  <c:v>6.4386317907444757E-2</c:v>
                </c:pt>
                <c:pt idx="3">
                  <c:v>6.8410462776660005E-2</c:v>
                </c:pt>
                <c:pt idx="4">
                  <c:v>5.0301810865191199E-2</c:v>
                </c:pt>
                <c:pt idx="5">
                  <c:v>0.10060362173038204</c:v>
                </c:pt>
                <c:pt idx="6">
                  <c:v>5.8350100603621703E-2</c:v>
                </c:pt>
                <c:pt idx="7">
                  <c:v>2.6156941649899401E-2</c:v>
                </c:pt>
                <c:pt idx="8">
                  <c:v>3.8229376257545314E-2</c:v>
                </c:pt>
                <c:pt idx="9">
                  <c:v>3.8229376257545314E-2</c:v>
                </c:pt>
                <c:pt idx="10">
                  <c:v>2.2132796780684111E-2</c:v>
                </c:pt>
                <c:pt idx="11">
                  <c:v>4.4265593561368201E-2</c:v>
                </c:pt>
                <c:pt idx="12">
                  <c:v>4.2253521126760597E-2</c:v>
                </c:pt>
                <c:pt idx="13">
                  <c:v>4.8289738430583484E-2</c:v>
                </c:pt>
                <c:pt idx="14">
                  <c:v>4.6277665995975895E-2</c:v>
                </c:pt>
                <c:pt idx="15">
                  <c:v>3.0181086519114705E-2</c:v>
                </c:pt>
                <c:pt idx="16">
                  <c:v>2.8169014084506998E-2</c:v>
                </c:pt>
                <c:pt idx="17">
                  <c:v>2.4144869215291694E-2</c:v>
                </c:pt>
                <c:pt idx="18">
                  <c:v>3.2193158953722302E-2</c:v>
                </c:pt>
                <c:pt idx="19">
                  <c:v>2.2132796780684111E-2</c:v>
                </c:pt>
                <c:pt idx="20">
                  <c:v>1.4084507042253504E-2</c:v>
                </c:pt>
              </c:numCache>
            </c:numRef>
          </c:val>
        </c:ser>
        <c:ser>
          <c:idx val="8"/>
          <c:order val="8"/>
          <c:tx>
            <c:strRef>
              <c:f>'cat-2(CB1112)_A5_0.02_5%'!$J$104</c:f>
              <c:strCache>
                <c:ptCount val="1"/>
                <c:pt idx="0">
                  <c:v>cat-2(CB1112)_A5_09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J$105:$J$125</c:f>
              <c:numCache>
                <c:formatCode>General</c:formatCode>
                <c:ptCount val="21"/>
                <c:pt idx="1">
                  <c:v>7.0899470899470934E-2</c:v>
                </c:pt>
                <c:pt idx="2">
                  <c:v>9.1005291005291006E-2</c:v>
                </c:pt>
                <c:pt idx="3">
                  <c:v>0.10158730158730198</c:v>
                </c:pt>
                <c:pt idx="4">
                  <c:v>8.8888888888888934E-2</c:v>
                </c:pt>
                <c:pt idx="5">
                  <c:v>0.13015873015873</c:v>
                </c:pt>
                <c:pt idx="6">
                  <c:v>6.6666666666666693E-2</c:v>
                </c:pt>
                <c:pt idx="7">
                  <c:v>4.1269841269841297E-2</c:v>
                </c:pt>
                <c:pt idx="8">
                  <c:v>4.7619047619047616E-2</c:v>
                </c:pt>
                <c:pt idx="9">
                  <c:v>3.5978835978836006E-2</c:v>
                </c:pt>
                <c:pt idx="10">
                  <c:v>2.4338624338624288E-2</c:v>
                </c:pt>
                <c:pt idx="11">
                  <c:v>2.962962962962961E-2</c:v>
                </c:pt>
                <c:pt idx="12">
                  <c:v>2.7513227513227521E-2</c:v>
                </c:pt>
                <c:pt idx="13">
                  <c:v>2.962962962962961E-2</c:v>
                </c:pt>
                <c:pt idx="14">
                  <c:v>2.1164021164021198E-2</c:v>
                </c:pt>
                <c:pt idx="15">
                  <c:v>2.7513227513227521E-2</c:v>
                </c:pt>
                <c:pt idx="16">
                  <c:v>2.1164021164021198E-2</c:v>
                </c:pt>
                <c:pt idx="17">
                  <c:v>1.2698412698412704E-2</c:v>
                </c:pt>
                <c:pt idx="18">
                  <c:v>1.37566137566138E-2</c:v>
                </c:pt>
                <c:pt idx="19">
                  <c:v>6.3492063492063518E-3</c:v>
                </c:pt>
                <c:pt idx="20">
                  <c:v>2.1164021164021191E-3</c:v>
                </c:pt>
              </c:numCache>
            </c:numRef>
          </c:val>
        </c:ser>
        <c:ser>
          <c:idx val="9"/>
          <c:order val="9"/>
          <c:tx>
            <c:strRef>
              <c:f>'cat-2(CB1112)_A5_0.02_5%'!$K$104</c:f>
              <c:strCache>
                <c:ptCount val="1"/>
                <c:pt idx="0">
                  <c:v>cat-2(CB1112)_A5_10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K$105:$K$125</c:f>
              <c:numCache>
                <c:formatCode>General</c:formatCode>
                <c:ptCount val="21"/>
                <c:pt idx="1">
                  <c:v>6.2624254473161001E-2</c:v>
                </c:pt>
                <c:pt idx="2">
                  <c:v>9.244532803180916E-2</c:v>
                </c:pt>
                <c:pt idx="3">
                  <c:v>0.10039761431411498</c:v>
                </c:pt>
                <c:pt idx="4">
                  <c:v>0.11133200795228602</c:v>
                </c:pt>
                <c:pt idx="5">
                  <c:v>0.145129224652087</c:v>
                </c:pt>
                <c:pt idx="6">
                  <c:v>5.5666003976143123E-2</c:v>
                </c:pt>
                <c:pt idx="7">
                  <c:v>3.7773359840954313E-2</c:v>
                </c:pt>
                <c:pt idx="8">
                  <c:v>5.2683896620278302E-2</c:v>
                </c:pt>
                <c:pt idx="9">
                  <c:v>2.982107355864811E-2</c:v>
                </c:pt>
                <c:pt idx="10">
                  <c:v>4.4731610337972225E-2</c:v>
                </c:pt>
                <c:pt idx="11">
                  <c:v>3.2803180914512911E-2</c:v>
                </c:pt>
                <c:pt idx="12">
                  <c:v>2.2862823061630198E-2</c:v>
                </c:pt>
                <c:pt idx="13">
                  <c:v>3.8767395626242498E-2</c:v>
                </c:pt>
                <c:pt idx="14">
                  <c:v>2.1868787276341999E-2</c:v>
                </c:pt>
                <c:pt idx="15">
                  <c:v>1.1928429423459204E-2</c:v>
                </c:pt>
                <c:pt idx="16">
                  <c:v>1.2922465208747506E-2</c:v>
                </c:pt>
                <c:pt idx="17">
                  <c:v>1.0934393638170999E-2</c:v>
                </c:pt>
                <c:pt idx="18">
                  <c:v>7.9522862823061639E-3</c:v>
                </c:pt>
                <c:pt idx="19">
                  <c:v>7.9522862823061639E-3</c:v>
                </c:pt>
                <c:pt idx="20">
                  <c:v>8.9463220675944279E-3</c:v>
                </c:pt>
              </c:numCache>
            </c:numRef>
          </c:val>
        </c:ser>
        <c:ser>
          <c:idx val="10"/>
          <c:order val="10"/>
          <c:tx>
            <c:strRef>
              <c:f>'cat-2(CB1112)_A5_0.02_5%'!$L$104</c:f>
              <c:strCache>
                <c:ptCount val="1"/>
                <c:pt idx="0">
                  <c:v>cat-2(CB1112)_A5_11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L$105:$L$125</c:f>
              <c:numCache>
                <c:formatCode>General</c:formatCode>
                <c:ptCount val="21"/>
                <c:pt idx="1">
                  <c:v>7.3541167066346905E-2</c:v>
                </c:pt>
                <c:pt idx="2">
                  <c:v>0.11350919264588298</c:v>
                </c:pt>
                <c:pt idx="3">
                  <c:v>0.12230215827338105</c:v>
                </c:pt>
                <c:pt idx="4">
                  <c:v>0.16306954436450793</c:v>
                </c:pt>
                <c:pt idx="5">
                  <c:v>0.12869704236610699</c:v>
                </c:pt>
                <c:pt idx="6">
                  <c:v>5.6754596322941726E-2</c:v>
                </c:pt>
                <c:pt idx="7">
                  <c:v>5.9952038369304614E-2</c:v>
                </c:pt>
                <c:pt idx="8">
                  <c:v>6.1550759392485978E-2</c:v>
                </c:pt>
                <c:pt idx="9">
                  <c:v>3.7569944044764214E-2</c:v>
                </c:pt>
                <c:pt idx="10">
                  <c:v>2.8776978417266213E-2</c:v>
                </c:pt>
                <c:pt idx="11">
                  <c:v>1.7585931254996003E-2</c:v>
                </c:pt>
                <c:pt idx="12">
                  <c:v>2.3181454836131078E-2</c:v>
                </c:pt>
                <c:pt idx="13">
                  <c:v>1.11910471622702E-2</c:v>
                </c:pt>
                <c:pt idx="14">
                  <c:v>1.2789768185451598E-2</c:v>
                </c:pt>
                <c:pt idx="15">
                  <c:v>7.9936051159072742E-3</c:v>
                </c:pt>
                <c:pt idx="16">
                  <c:v>4.7961630695443642E-3</c:v>
                </c:pt>
                <c:pt idx="17">
                  <c:v>4.7961630695443642E-3</c:v>
                </c:pt>
                <c:pt idx="18">
                  <c:v>3.1974420463629118E-3</c:v>
                </c:pt>
                <c:pt idx="19">
                  <c:v>7.9936051159072751E-4</c:v>
                </c:pt>
                <c:pt idx="20">
                  <c:v>1.5987210231814505E-3</c:v>
                </c:pt>
              </c:numCache>
            </c:numRef>
          </c:val>
        </c:ser>
        <c:ser>
          <c:idx val="11"/>
          <c:order val="11"/>
          <c:tx>
            <c:strRef>
              <c:f>'cat-2(CB1112)_A5_0.02_5%'!$M$104</c:f>
              <c:strCache>
                <c:ptCount val="1"/>
                <c:pt idx="0">
                  <c:v>cat-2(CB1112)_A5_12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M$105:$M$125</c:f>
              <c:numCache>
                <c:formatCode>General</c:formatCode>
                <c:ptCount val="21"/>
                <c:pt idx="1">
                  <c:v>8.6956521739130446E-2</c:v>
                </c:pt>
                <c:pt idx="2">
                  <c:v>0.11594202898550703</c:v>
                </c:pt>
                <c:pt idx="3">
                  <c:v>0.10276679841897206</c:v>
                </c:pt>
                <c:pt idx="4">
                  <c:v>0.13702239789196308</c:v>
                </c:pt>
                <c:pt idx="5">
                  <c:v>0.10935441370224</c:v>
                </c:pt>
                <c:pt idx="6">
                  <c:v>8.1686429512516506E-2</c:v>
                </c:pt>
                <c:pt idx="7">
                  <c:v>4.2160737812911742E-2</c:v>
                </c:pt>
                <c:pt idx="8">
                  <c:v>3.5573122529644313E-2</c:v>
                </c:pt>
                <c:pt idx="9">
                  <c:v>4.0843214756258218E-2</c:v>
                </c:pt>
                <c:pt idx="10">
                  <c:v>2.6350461133069797E-2</c:v>
                </c:pt>
                <c:pt idx="11">
                  <c:v>3.4255599472990804E-2</c:v>
                </c:pt>
                <c:pt idx="12">
                  <c:v>2.5032938076416319E-2</c:v>
                </c:pt>
                <c:pt idx="13">
                  <c:v>1.9762845849802414E-2</c:v>
                </c:pt>
                <c:pt idx="14">
                  <c:v>1.9762845849802414E-2</c:v>
                </c:pt>
                <c:pt idx="15">
                  <c:v>1.3175230566534898E-2</c:v>
                </c:pt>
                <c:pt idx="16">
                  <c:v>7.9051383399209498E-3</c:v>
                </c:pt>
                <c:pt idx="17">
                  <c:v>9.2226613965744435E-3</c:v>
                </c:pt>
                <c:pt idx="18">
                  <c:v>1.0540184453227904E-2</c:v>
                </c:pt>
                <c:pt idx="19">
                  <c:v>1.31752305665349E-3</c:v>
                </c:pt>
                <c:pt idx="20">
                  <c:v>1.31752305665349E-3</c:v>
                </c:pt>
              </c:numCache>
            </c:numRef>
          </c:val>
        </c:ser>
        <c:ser>
          <c:idx val="12"/>
          <c:order val="12"/>
          <c:tx>
            <c:strRef>
              <c:f>'cat-2(CB1112)_A5_0.02_5%'!$N$104</c:f>
              <c:strCache>
                <c:ptCount val="1"/>
                <c:pt idx="0">
                  <c:v>cat-2(CB1112)_A5_13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N$105:$N$125</c:f>
              <c:numCache>
                <c:formatCode>General</c:formatCode>
                <c:ptCount val="21"/>
                <c:pt idx="1">
                  <c:v>6.4356435643564427E-2</c:v>
                </c:pt>
                <c:pt idx="2">
                  <c:v>0.10297029702970301</c:v>
                </c:pt>
                <c:pt idx="3">
                  <c:v>0.110891089108911</c:v>
                </c:pt>
                <c:pt idx="4">
                  <c:v>0.164356435643564</c:v>
                </c:pt>
                <c:pt idx="5">
                  <c:v>0.133663366336634</c:v>
                </c:pt>
                <c:pt idx="6">
                  <c:v>6.2376237623762418E-2</c:v>
                </c:pt>
                <c:pt idx="7">
                  <c:v>4.7524752475247484E-2</c:v>
                </c:pt>
                <c:pt idx="8">
                  <c:v>4.4554455445544615E-2</c:v>
                </c:pt>
                <c:pt idx="9">
                  <c:v>4.3564356435643617E-2</c:v>
                </c:pt>
                <c:pt idx="10">
                  <c:v>2.9702970297029712E-2</c:v>
                </c:pt>
                <c:pt idx="11">
                  <c:v>1.9801980198019809E-2</c:v>
                </c:pt>
                <c:pt idx="12">
                  <c:v>2.07920792079208E-2</c:v>
                </c:pt>
                <c:pt idx="13">
                  <c:v>1.7821782178217803E-2</c:v>
                </c:pt>
                <c:pt idx="14">
                  <c:v>9.9009900990099063E-3</c:v>
                </c:pt>
                <c:pt idx="15">
                  <c:v>1.3861386138613901E-2</c:v>
                </c:pt>
                <c:pt idx="16">
                  <c:v>4.9504950495049514E-3</c:v>
                </c:pt>
                <c:pt idx="17">
                  <c:v>5.9405940594059398E-3</c:v>
                </c:pt>
                <c:pt idx="18">
                  <c:v>2.9702970297029712E-3</c:v>
                </c:pt>
                <c:pt idx="19">
                  <c:v>4.9504950495049514E-3</c:v>
                </c:pt>
                <c:pt idx="20">
                  <c:v>9.9009900990099098E-4</c:v>
                </c:pt>
              </c:numCache>
            </c:numRef>
          </c:val>
        </c:ser>
        <c:ser>
          <c:idx val="13"/>
          <c:order val="13"/>
          <c:tx>
            <c:strRef>
              <c:f>'cat-2(CB1112)_A5_0.02_5%'!$O$104</c:f>
              <c:strCache>
                <c:ptCount val="1"/>
                <c:pt idx="0">
                  <c:v>cat-2(CB1112)_A5_14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O$105:$O$125</c:f>
              <c:numCache>
                <c:formatCode>General</c:formatCode>
                <c:ptCount val="21"/>
                <c:pt idx="1">
                  <c:v>7.4165636588380726E-2</c:v>
                </c:pt>
                <c:pt idx="2">
                  <c:v>9.8887515451174302E-2</c:v>
                </c:pt>
                <c:pt idx="3">
                  <c:v>6.6749072929542602E-2</c:v>
                </c:pt>
                <c:pt idx="4">
                  <c:v>0.111248454882571</c:v>
                </c:pt>
                <c:pt idx="5">
                  <c:v>0.11372064276885005</c:v>
                </c:pt>
                <c:pt idx="6">
                  <c:v>4.0791100123609404E-2</c:v>
                </c:pt>
                <c:pt idx="7">
                  <c:v>3.0902348578492014E-2</c:v>
                </c:pt>
                <c:pt idx="8">
                  <c:v>4.82076637824475E-2</c:v>
                </c:pt>
                <c:pt idx="9">
                  <c:v>4.4499381953028452E-2</c:v>
                </c:pt>
                <c:pt idx="10">
                  <c:v>3.9555006180469712E-2</c:v>
                </c:pt>
                <c:pt idx="11">
                  <c:v>3.4610630407911014E-2</c:v>
                </c:pt>
                <c:pt idx="12">
                  <c:v>4.0791100123609404E-2</c:v>
                </c:pt>
                <c:pt idx="13">
                  <c:v>3.0902348578492014E-2</c:v>
                </c:pt>
                <c:pt idx="14">
                  <c:v>3.5846724351050699E-2</c:v>
                </c:pt>
                <c:pt idx="15">
                  <c:v>1.8541409147095213E-2</c:v>
                </c:pt>
                <c:pt idx="16">
                  <c:v>2.101359703337451E-2</c:v>
                </c:pt>
                <c:pt idx="17">
                  <c:v>1.4833127317676104E-2</c:v>
                </c:pt>
                <c:pt idx="18">
                  <c:v>7.4165636588380737E-3</c:v>
                </c:pt>
                <c:pt idx="19">
                  <c:v>6.1804697156983938E-3</c:v>
                </c:pt>
                <c:pt idx="20">
                  <c:v>6.1804697156983938E-3</c:v>
                </c:pt>
              </c:numCache>
            </c:numRef>
          </c:val>
        </c:ser>
        <c:ser>
          <c:idx val="14"/>
          <c:order val="14"/>
          <c:tx>
            <c:strRef>
              <c:f>'cat-2(CB1112)_A5_0.02_5%'!$P$104</c:f>
              <c:strCache>
                <c:ptCount val="1"/>
                <c:pt idx="0">
                  <c:v>cat-2(CB1112)_A5_15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P$105:$P$125</c:f>
              <c:numCache>
                <c:formatCode>General</c:formatCode>
                <c:ptCount val="21"/>
                <c:pt idx="1">
                  <c:v>5.6390977443609019E-2</c:v>
                </c:pt>
                <c:pt idx="2">
                  <c:v>7.1428571428571411E-2</c:v>
                </c:pt>
                <c:pt idx="3">
                  <c:v>7.8947368421052572E-2</c:v>
                </c:pt>
                <c:pt idx="4">
                  <c:v>7.5187969924812026E-2</c:v>
                </c:pt>
                <c:pt idx="5">
                  <c:v>6.0150375939849621E-2</c:v>
                </c:pt>
                <c:pt idx="6">
                  <c:v>4.1353383458646635E-2</c:v>
                </c:pt>
                <c:pt idx="7">
                  <c:v>4.5112781954887243E-2</c:v>
                </c:pt>
                <c:pt idx="8">
                  <c:v>3.7593984962405999E-2</c:v>
                </c:pt>
                <c:pt idx="9">
                  <c:v>3.7593984962405999E-2</c:v>
                </c:pt>
                <c:pt idx="10">
                  <c:v>3.3834586466165405E-2</c:v>
                </c:pt>
                <c:pt idx="11">
                  <c:v>3.0075187969924817E-2</c:v>
                </c:pt>
                <c:pt idx="12">
                  <c:v>3.0075187969924817E-2</c:v>
                </c:pt>
                <c:pt idx="13">
                  <c:v>2.6315789473684202E-2</c:v>
                </c:pt>
                <c:pt idx="14">
                  <c:v>2.6315789473684202E-2</c:v>
                </c:pt>
                <c:pt idx="15">
                  <c:v>4.5112781954887243E-2</c:v>
                </c:pt>
                <c:pt idx="16">
                  <c:v>4.8872180451127803E-2</c:v>
                </c:pt>
                <c:pt idx="17">
                  <c:v>3.3834586466165405E-2</c:v>
                </c:pt>
                <c:pt idx="18">
                  <c:v>3.3834586466165405E-2</c:v>
                </c:pt>
                <c:pt idx="19">
                  <c:v>3.3834586466165405E-2</c:v>
                </c:pt>
                <c:pt idx="20">
                  <c:v>3.0075187969924817E-2</c:v>
                </c:pt>
              </c:numCache>
            </c:numRef>
          </c:val>
        </c:ser>
        <c:ser>
          <c:idx val="15"/>
          <c:order val="15"/>
          <c:tx>
            <c:strRef>
              <c:f>'cat-2(CB1112)_A5_0.02_5%'!$Q$104</c:f>
              <c:strCache>
                <c:ptCount val="1"/>
                <c:pt idx="0">
                  <c:v>cat-2(CB1112)_A5_16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Q$105:$Q$125</c:f>
              <c:numCache>
                <c:formatCode>General</c:formatCode>
                <c:ptCount val="21"/>
                <c:pt idx="1">
                  <c:v>7.3878627968337732E-2</c:v>
                </c:pt>
                <c:pt idx="2">
                  <c:v>6.332453825857523E-2</c:v>
                </c:pt>
                <c:pt idx="3">
                  <c:v>5.8047493403693903E-2</c:v>
                </c:pt>
                <c:pt idx="4">
                  <c:v>8.9709762532981532E-2</c:v>
                </c:pt>
                <c:pt idx="5">
                  <c:v>5.0131926121372003E-2</c:v>
                </c:pt>
                <c:pt idx="6">
                  <c:v>5.8047493403693903E-2</c:v>
                </c:pt>
                <c:pt idx="7">
                  <c:v>3.4300791556728202E-2</c:v>
                </c:pt>
                <c:pt idx="8">
                  <c:v>3.9577836411609522E-2</c:v>
                </c:pt>
                <c:pt idx="9">
                  <c:v>5.8047493403693903E-2</c:v>
                </c:pt>
                <c:pt idx="10">
                  <c:v>5.2770448548812701E-2</c:v>
                </c:pt>
                <c:pt idx="11">
                  <c:v>3.9577836411609522E-2</c:v>
                </c:pt>
                <c:pt idx="12">
                  <c:v>1.8469656992084402E-2</c:v>
                </c:pt>
                <c:pt idx="13">
                  <c:v>1.3192612137203198E-2</c:v>
                </c:pt>
                <c:pt idx="14">
                  <c:v>2.1108179419525117E-2</c:v>
                </c:pt>
                <c:pt idx="15">
                  <c:v>2.1108179419525117E-2</c:v>
                </c:pt>
                <c:pt idx="16">
                  <c:v>2.3746701846965694E-2</c:v>
                </c:pt>
                <c:pt idx="17">
                  <c:v>3.4300791556728202E-2</c:v>
                </c:pt>
                <c:pt idx="18">
                  <c:v>2.6385224274406299E-2</c:v>
                </c:pt>
                <c:pt idx="19">
                  <c:v>1.5831134564643801E-2</c:v>
                </c:pt>
                <c:pt idx="20">
                  <c:v>1.5831134564643801E-2</c:v>
                </c:pt>
              </c:numCache>
            </c:numRef>
          </c:val>
        </c:ser>
        <c:ser>
          <c:idx val="16"/>
          <c:order val="16"/>
          <c:tx>
            <c:strRef>
              <c:f>'cat-2(CB1112)_A5_0.02_5%'!$R$104</c:f>
              <c:strCache>
                <c:ptCount val="1"/>
                <c:pt idx="0">
                  <c:v>cat-2(CB1112)_A5_17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R$105:$R$125</c:f>
              <c:numCache>
                <c:formatCode>General</c:formatCode>
                <c:ptCount val="21"/>
                <c:pt idx="1">
                  <c:v>6.5685164212910499E-2</c:v>
                </c:pt>
                <c:pt idx="2">
                  <c:v>0.11098527746319403</c:v>
                </c:pt>
                <c:pt idx="3">
                  <c:v>0.12344280860702198</c:v>
                </c:pt>
                <c:pt idx="4">
                  <c:v>0.14496036240090607</c:v>
                </c:pt>
                <c:pt idx="5">
                  <c:v>0.12797281993204995</c:v>
                </c:pt>
                <c:pt idx="6">
                  <c:v>6.5685164212910499E-2</c:v>
                </c:pt>
                <c:pt idx="7">
                  <c:v>6.0022650056625132E-2</c:v>
                </c:pt>
                <c:pt idx="8">
                  <c:v>6.1155152887882175E-2</c:v>
                </c:pt>
                <c:pt idx="9">
                  <c:v>4.8697621744054412E-2</c:v>
                </c:pt>
                <c:pt idx="10">
                  <c:v>2.944507361268401E-2</c:v>
                </c:pt>
                <c:pt idx="11">
                  <c:v>2.3782559456398591E-2</c:v>
                </c:pt>
                <c:pt idx="12">
                  <c:v>1.9252548131370301E-2</c:v>
                </c:pt>
                <c:pt idx="13">
                  <c:v>1.1325028312570805E-2</c:v>
                </c:pt>
                <c:pt idx="14">
                  <c:v>1.1325028312570805E-2</c:v>
                </c:pt>
                <c:pt idx="15">
                  <c:v>9.0600226500566344E-3</c:v>
                </c:pt>
                <c:pt idx="16">
                  <c:v>4.530011325028312E-3</c:v>
                </c:pt>
                <c:pt idx="17">
                  <c:v>3.3975084937712301E-3</c:v>
                </c:pt>
                <c:pt idx="18">
                  <c:v>4.530011325028312E-3</c:v>
                </c:pt>
                <c:pt idx="19">
                  <c:v>3.3975084937712301E-3</c:v>
                </c:pt>
                <c:pt idx="20">
                  <c:v>3.3975084937712301E-3</c:v>
                </c:pt>
              </c:numCache>
            </c:numRef>
          </c:val>
        </c:ser>
        <c:ser>
          <c:idx val="17"/>
          <c:order val="17"/>
          <c:tx>
            <c:strRef>
              <c:f>'cat-2(CB1112)_A5_0.02_5%'!$S$104</c:f>
              <c:strCache>
                <c:ptCount val="1"/>
                <c:pt idx="0">
                  <c:v>cat-2(CB1112)_A5_18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S$105:$S$125</c:f>
              <c:numCache>
                <c:formatCode>General</c:formatCode>
                <c:ptCount val="21"/>
                <c:pt idx="1">
                  <c:v>6.6516347237880497E-2</c:v>
                </c:pt>
                <c:pt idx="2">
                  <c:v>0.10597519729425002</c:v>
                </c:pt>
                <c:pt idx="3">
                  <c:v>7.4408117249154498E-2</c:v>
                </c:pt>
                <c:pt idx="4">
                  <c:v>0.12739571589627999</c:v>
                </c:pt>
                <c:pt idx="5">
                  <c:v>0.13979706877113907</c:v>
                </c:pt>
                <c:pt idx="6">
                  <c:v>4.8478015783539989E-2</c:v>
                </c:pt>
                <c:pt idx="7">
                  <c:v>4.3968432919954899E-2</c:v>
                </c:pt>
                <c:pt idx="8">
                  <c:v>4.0586245772266084E-2</c:v>
                </c:pt>
                <c:pt idx="9">
                  <c:v>3.8331454340473498E-2</c:v>
                </c:pt>
                <c:pt idx="10">
                  <c:v>4.1713641488162312E-2</c:v>
                </c:pt>
                <c:pt idx="11">
                  <c:v>3.269447576099211E-2</c:v>
                </c:pt>
                <c:pt idx="12">
                  <c:v>2.5930101465614412E-2</c:v>
                </c:pt>
                <c:pt idx="13">
                  <c:v>3.8331454340473498E-2</c:v>
                </c:pt>
                <c:pt idx="14">
                  <c:v>2.4802705749718202E-2</c:v>
                </c:pt>
                <c:pt idx="15">
                  <c:v>1.4656144306651599E-2</c:v>
                </c:pt>
                <c:pt idx="16">
                  <c:v>1.4656144306651599E-2</c:v>
                </c:pt>
                <c:pt idx="17">
                  <c:v>1.0146561443066507E-2</c:v>
                </c:pt>
                <c:pt idx="18">
                  <c:v>4.5095828635851199E-3</c:v>
                </c:pt>
                <c:pt idx="19">
                  <c:v>1.3528748590755401E-2</c:v>
                </c:pt>
                <c:pt idx="20">
                  <c:v>2.2547914317925617E-3</c:v>
                </c:pt>
              </c:numCache>
            </c:numRef>
          </c:val>
        </c:ser>
        <c:ser>
          <c:idx val="18"/>
          <c:order val="18"/>
          <c:tx>
            <c:strRef>
              <c:f>'cat-2(CB1112)_A5_0.02_5%'!$T$104</c:f>
              <c:strCache>
                <c:ptCount val="1"/>
                <c:pt idx="0">
                  <c:v>cat-2(CB1112)_A5_19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T$105:$T$125</c:f>
              <c:numCache>
                <c:formatCode>General</c:formatCode>
                <c:ptCount val="21"/>
                <c:pt idx="1">
                  <c:v>7.7083333333333337E-2</c:v>
                </c:pt>
                <c:pt idx="2">
                  <c:v>0.101041666666667</c:v>
                </c:pt>
                <c:pt idx="3">
                  <c:v>0.108333333333333</c:v>
                </c:pt>
                <c:pt idx="4">
                  <c:v>0.101041666666667</c:v>
                </c:pt>
                <c:pt idx="5">
                  <c:v>0.16458333333333305</c:v>
                </c:pt>
                <c:pt idx="6">
                  <c:v>6.8750000000000019E-2</c:v>
                </c:pt>
                <c:pt idx="7">
                  <c:v>3.7500000000000006E-2</c:v>
                </c:pt>
                <c:pt idx="8">
                  <c:v>4.0624999999999988E-2</c:v>
                </c:pt>
                <c:pt idx="9">
                  <c:v>4.8958333333333319E-2</c:v>
                </c:pt>
                <c:pt idx="10">
                  <c:v>4.0624999999999988E-2</c:v>
                </c:pt>
                <c:pt idx="11">
                  <c:v>4.0624999999999988E-2</c:v>
                </c:pt>
                <c:pt idx="12">
                  <c:v>2.1875000000000006E-2</c:v>
                </c:pt>
                <c:pt idx="13">
                  <c:v>1.2500000000000001E-2</c:v>
                </c:pt>
                <c:pt idx="14">
                  <c:v>2.0833333333333311E-2</c:v>
                </c:pt>
                <c:pt idx="15">
                  <c:v>1.0416666666666699E-2</c:v>
                </c:pt>
                <c:pt idx="16">
                  <c:v>1.1458333333333301E-2</c:v>
                </c:pt>
                <c:pt idx="17">
                  <c:v>6.2500000000000021E-3</c:v>
                </c:pt>
                <c:pt idx="18">
                  <c:v>3.125000000000001E-3</c:v>
                </c:pt>
                <c:pt idx="19">
                  <c:v>4.1666666666666701E-3</c:v>
                </c:pt>
                <c:pt idx="20">
                  <c:v>2.0833333333333311E-3</c:v>
                </c:pt>
              </c:numCache>
            </c:numRef>
          </c:val>
        </c:ser>
        <c:ser>
          <c:idx val="19"/>
          <c:order val="19"/>
          <c:tx>
            <c:strRef>
              <c:f>'cat-2(CB1112)_A5_0.02_5%'!$U$104</c:f>
              <c:strCache>
                <c:ptCount val="1"/>
                <c:pt idx="0">
                  <c:v>cat-2(CB1112)_A5_20</c:v>
                </c:pt>
              </c:strCache>
            </c:strRef>
          </c:tx>
          <c:marker>
            <c:symbol val="none"/>
          </c:marker>
          <c:cat>
            <c:numRef>
              <c:f>'cat-2(CB1112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5_0.02_5%'!$U$105:$U$125</c:f>
              <c:numCache>
                <c:formatCode>General</c:formatCode>
                <c:ptCount val="21"/>
                <c:pt idx="1">
                  <c:v>5.7860262008733634E-2</c:v>
                </c:pt>
                <c:pt idx="2">
                  <c:v>7.9694323144104823E-2</c:v>
                </c:pt>
                <c:pt idx="3">
                  <c:v>9.7161572052401807E-2</c:v>
                </c:pt>
                <c:pt idx="4">
                  <c:v>0.13755458515283805</c:v>
                </c:pt>
                <c:pt idx="5">
                  <c:v>0.13537117903930093</c:v>
                </c:pt>
                <c:pt idx="6">
                  <c:v>5.2401746724890799E-2</c:v>
                </c:pt>
                <c:pt idx="7">
                  <c:v>5.7860262008733634E-2</c:v>
                </c:pt>
                <c:pt idx="8">
                  <c:v>3.9301310043668117E-2</c:v>
                </c:pt>
                <c:pt idx="9">
                  <c:v>4.9126637554585136E-2</c:v>
                </c:pt>
                <c:pt idx="10">
                  <c:v>3.0567685589519611E-2</c:v>
                </c:pt>
                <c:pt idx="11">
                  <c:v>3.16593886462882E-2</c:v>
                </c:pt>
                <c:pt idx="12">
                  <c:v>2.1834061135371202E-2</c:v>
                </c:pt>
                <c:pt idx="13">
                  <c:v>2.4017467248908301E-2</c:v>
                </c:pt>
                <c:pt idx="14">
                  <c:v>1.9650655021834103E-2</c:v>
                </c:pt>
                <c:pt idx="15">
                  <c:v>2.1834061135371202E-2</c:v>
                </c:pt>
                <c:pt idx="16">
                  <c:v>1.52838427947598E-2</c:v>
                </c:pt>
                <c:pt idx="17">
                  <c:v>1.4192139737991299E-2</c:v>
                </c:pt>
                <c:pt idx="18">
                  <c:v>9.8253275109170344E-3</c:v>
                </c:pt>
                <c:pt idx="19">
                  <c:v>7.6419213973799114E-3</c:v>
                </c:pt>
                <c:pt idx="20">
                  <c:v>1.0917030567685604E-3</c:v>
                </c:pt>
              </c:numCache>
            </c:numRef>
          </c:val>
        </c:ser>
        <c:marker val="1"/>
        <c:axId val="159970432"/>
        <c:axId val="159971968"/>
      </c:lineChart>
      <c:catAx>
        <c:axId val="159970432"/>
        <c:scaling>
          <c:orientation val="minMax"/>
        </c:scaling>
        <c:axPos val="b"/>
        <c:numFmt formatCode="0.0_ " sourceLinked="1"/>
        <c:tickLblPos val="nextTo"/>
        <c:crossAx val="159971968"/>
        <c:crosses val="autoZero"/>
        <c:auto val="1"/>
        <c:lblAlgn val="ctr"/>
        <c:lblOffset val="100"/>
        <c:tickLblSkip val="5"/>
        <c:tickMarkSkip val="5"/>
      </c:catAx>
      <c:valAx>
        <c:axId val="15997196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9970432"/>
        <c:crosses val="autoZero"/>
        <c:crossBetween val="between"/>
      </c:valAx>
    </c:plotArea>
    <c:plotVisOnly val="1"/>
  </c:chart>
  <c:externalData r:id="rId1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2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2(CB1112)_A3_0.02_5%'!$B$104</c:f>
              <c:strCache>
                <c:ptCount val="1"/>
                <c:pt idx="0">
                  <c:v>cat-2(CB1112)_A3_01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B$105:$B$125</c:f>
              <c:numCache>
                <c:formatCode>General</c:formatCode>
                <c:ptCount val="21"/>
                <c:pt idx="1">
                  <c:v>7.29483282674772E-2</c:v>
                </c:pt>
                <c:pt idx="2">
                  <c:v>0.10790273556231003</c:v>
                </c:pt>
                <c:pt idx="3">
                  <c:v>0.10942249240121606</c:v>
                </c:pt>
                <c:pt idx="4">
                  <c:v>0.13069908814589706</c:v>
                </c:pt>
                <c:pt idx="5">
                  <c:v>7.7507598784194498E-2</c:v>
                </c:pt>
                <c:pt idx="6">
                  <c:v>4.8632218844984802E-2</c:v>
                </c:pt>
                <c:pt idx="7">
                  <c:v>6.0790273556231032E-2</c:v>
                </c:pt>
                <c:pt idx="8">
                  <c:v>3.9513677811550213E-2</c:v>
                </c:pt>
                <c:pt idx="9">
                  <c:v>4.2553191489361715E-2</c:v>
                </c:pt>
                <c:pt idx="10">
                  <c:v>3.3434650455927001E-2</c:v>
                </c:pt>
                <c:pt idx="11">
                  <c:v>3.1914893617021316E-2</c:v>
                </c:pt>
                <c:pt idx="12">
                  <c:v>2.7355623100304E-2</c:v>
                </c:pt>
                <c:pt idx="13">
                  <c:v>3.0395136778115506E-2</c:v>
                </c:pt>
                <c:pt idx="14">
                  <c:v>1.3677811550152E-2</c:v>
                </c:pt>
                <c:pt idx="15">
                  <c:v>1.5197568389057801E-2</c:v>
                </c:pt>
                <c:pt idx="16">
                  <c:v>1.6717325227963507E-2</c:v>
                </c:pt>
                <c:pt idx="17">
                  <c:v>1.3677811550152E-2</c:v>
                </c:pt>
                <c:pt idx="18">
                  <c:v>1.0638297872340394E-2</c:v>
                </c:pt>
                <c:pt idx="19">
                  <c:v>1.0638297872340394E-2</c:v>
                </c:pt>
                <c:pt idx="20">
                  <c:v>3.0395136778115519E-3</c:v>
                </c:pt>
              </c:numCache>
            </c:numRef>
          </c:val>
        </c:ser>
        <c:ser>
          <c:idx val="1"/>
          <c:order val="1"/>
          <c:tx>
            <c:strRef>
              <c:f>'cat-2(CB1112)_A3_0.02_5%'!$C$104</c:f>
              <c:strCache>
                <c:ptCount val="1"/>
                <c:pt idx="0">
                  <c:v>cat-2(CB1112)_A3_02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C$105:$C$125</c:f>
              <c:numCache>
                <c:formatCode>General</c:formatCode>
                <c:ptCount val="21"/>
                <c:pt idx="1">
                  <c:v>8.2018927444794984E-2</c:v>
                </c:pt>
                <c:pt idx="2">
                  <c:v>0.11356466876971602</c:v>
                </c:pt>
                <c:pt idx="3">
                  <c:v>9.9369085173501598E-2</c:v>
                </c:pt>
                <c:pt idx="4">
                  <c:v>0.12460567823343806</c:v>
                </c:pt>
                <c:pt idx="5">
                  <c:v>7.7287066246056801E-2</c:v>
                </c:pt>
                <c:pt idx="6">
                  <c:v>6.6246056782334375E-2</c:v>
                </c:pt>
                <c:pt idx="7">
                  <c:v>4.2586750788643504E-2</c:v>
                </c:pt>
                <c:pt idx="8">
                  <c:v>4.2586750788643504E-2</c:v>
                </c:pt>
                <c:pt idx="9">
                  <c:v>3.4700315457413221E-2</c:v>
                </c:pt>
                <c:pt idx="10">
                  <c:v>4.1009463722397485E-2</c:v>
                </c:pt>
                <c:pt idx="11">
                  <c:v>3.9432176656151417E-2</c:v>
                </c:pt>
                <c:pt idx="12">
                  <c:v>3.627760252365933E-2</c:v>
                </c:pt>
                <c:pt idx="13">
                  <c:v>3.3123028391167188E-2</c:v>
                </c:pt>
                <c:pt idx="14">
                  <c:v>2.3659305993690899E-2</c:v>
                </c:pt>
                <c:pt idx="15">
                  <c:v>1.5772870662460612E-2</c:v>
                </c:pt>
                <c:pt idx="16">
                  <c:v>2.5236593059936901E-2</c:v>
                </c:pt>
                <c:pt idx="17">
                  <c:v>1.5772870662460613E-3</c:v>
                </c:pt>
                <c:pt idx="18">
                  <c:v>1.2618296529968496E-2</c:v>
                </c:pt>
                <c:pt idx="19">
                  <c:v>1.5772870662460613E-3</c:v>
                </c:pt>
                <c:pt idx="20">
                  <c:v>3.1545741324921117E-3</c:v>
                </c:pt>
              </c:numCache>
            </c:numRef>
          </c:val>
        </c:ser>
        <c:ser>
          <c:idx val="2"/>
          <c:order val="2"/>
          <c:tx>
            <c:strRef>
              <c:f>'cat-2(CB1112)_A3_0.02_5%'!$D$104</c:f>
              <c:strCache>
                <c:ptCount val="1"/>
                <c:pt idx="0">
                  <c:v>cat-2(CB1112)_A3_04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D$105:$D$125</c:f>
              <c:numCache>
                <c:formatCode>General</c:formatCode>
                <c:ptCount val="21"/>
                <c:pt idx="1">
                  <c:v>5.54913294797688E-2</c:v>
                </c:pt>
                <c:pt idx="2">
                  <c:v>9.2485549132948E-2</c:v>
                </c:pt>
                <c:pt idx="3">
                  <c:v>0.10867052023121408</c:v>
                </c:pt>
                <c:pt idx="4">
                  <c:v>0.13179190751445105</c:v>
                </c:pt>
                <c:pt idx="5">
                  <c:v>0.11907514450867106</c:v>
                </c:pt>
                <c:pt idx="6">
                  <c:v>4.046242774566472E-2</c:v>
                </c:pt>
                <c:pt idx="7">
                  <c:v>6.0115606936416238E-2</c:v>
                </c:pt>
                <c:pt idx="8">
                  <c:v>5.3179190751445095E-2</c:v>
                </c:pt>
                <c:pt idx="9">
                  <c:v>4.1618497109826624E-2</c:v>
                </c:pt>
                <c:pt idx="10">
                  <c:v>3.3526011560693597E-2</c:v>
                </c:pt>
                <c:pt idx="11">
                  <c:v>3.2369942196531803E-2</c:v>
                </c:pt>
                <c:pt idx="12">
                  <c:v>3.3526011560693597E-2</c:v>
                </c:pt>
                <c:pt idx="13">
                  <c:v>1.7341040462427702E-2</c:v>
                </c:pt>
                <c:pt idx="14">
                  <c:v>1.5028901734104001E-2</c:v>
                </c:pt>
                <c:pt idx="15">
                  <c:v>1.5028901734104001E-2</c:v>
                </c:pt>
                <c:pt idx="16">
                  <c:v>1.6184971098265909E-2</c:v>
                </c:pt>
                <c:pt idx="17">
                  <c:v>1.6184971098265909E-2</c:v>
                </c:pt>
                <c:pt idx="18">
                  <c:v>6.9364161849711069E-3</c:v>
                </c:pt>
                <c:pt idx="19">
                  <c:v>8.0924855491329578E-3</c:v>
                </c:pt>
                <c:pt idx="20">
                  <c:v>5.7803468208092517E-3</c:v>
                </c:pt>
              </c:numCache>
            </c:numRef>
          </c:val>
        </c:ser>
        <c:ser>
          <c:idx val="3"/>
          <c:order val="3"/>
          <c:tx>
            <c:strRef>
              <c:f>'cat-2(CB1112)_A3_0.02_5%'!$E$104</c:f>
              <c:strCache>
                <c:ptCount val="1"/>
                <c:pt idx="0">
                  <c:v>cat-2(CB1112)_A3_05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E$105:$E$125</c:f>
              <c:numCache>
                <c:formatCode>General</c:formatCode>
                <c:ptCount val="21"/>
                <c:pt idx="1">
                  <c:v>8.75331564986737E-2</c:v>
                </c:pt>
                <c:pt idx="2">
                  <c:v>8.75331564986737E-2</c:v>
                </c:pt>
                <c:pt idx="3">
                  <c:v>5.8355437665782502E-2</c:v>
                </c:pt>
                <c:pt idx="4">
                  <c:v>8.2228116710875279E-2</c:v>
                </c:pt>
                <c:pt idx="5">
                  <c:v>8.2228116710875279E-2</c:v>
                </c:pt>
                <c:pt idx="6">
                  <c:v>4.2440318302387287E-2</c:v>
                </c:pt>
                <c:pt idx="7">
                  <c:v>4.6419098143236116E-2</c:v>
                </c:pt>
                <c:pt idx="8">
                  <c:v>2.7851458885941607E-2</c:v>
                </c:pt>
                <c:pt idx="9">
                  <c:v>3.8461538461538498E-2</c:v>
                </c:pt>
                <c:pt idx="10">
                  <c:v>3.9787798408488097E-2</c:v>
                </c:pt>
                <c:pt idx="11">
                  <c:v>4.907161803713532E-2</c:v>
                </c:pt>
                <c:pt idx="12">
                  <c:v>4.3766578249336927E-2</c:v>
                </c:pt>
                <c:pt idx="13">
                  <c:v>4.2440318302387287E-2</c:v>
                </c:pt>
                <c:pt idx="14">
                  <c:v>3.9787798408488097E-2</c:v>
                </c:pt>
                <c:pt idx="15">
                  <c:v>4.1114058355437702E-2</c:v>
                </c:pt>
                <c:pt idx="16">
                  <c:v>2.7851458885941607E-2</c:v>
                </c:pt>
                <c:pt idx="17">
                  <c:v>3.3156498673740098E-2</c:v>
                </c:pt>
                <c:pt idx="18">
                  <c:v>1.7241379310344803E-2</c:v>
                </c:pt>
                <c:pt idx="19">
                  <c:v>3.9787798408488098E-3</c:v>
                </c:pt>
                <c:pt idx="20">
                  <c:v>3.9787798408488098E-3</c:v>
                </c:pt>
              </c:numCache>
            </c:numRef>
          </c:val>
        </c:ser>
        <c:ser>
          <c:idx val="4"/>
          <c:order val="4"/>
          <c:tx>
            <c:strRef>
              <c:f>'cat-2(CB1112)_A3_0.02_5%'!$F$104</c:f>
              <c:strCache>
                <c:ptCount val="1"/>
                <c:pt idx="0">
                  <c:v>cat-2(CB1112)_A3_06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F$105:$F$125</c:f>
              <c:numCache>
                <c:formatCode>General</c:formatCode>
                <c:ptCount val="21"/>
                <c:pt idx="1">
                  <c:v>6.8678459937564995E-2</c:v>
                </c:pt>
                <c:pt idx="2">
                  <c:v>9.7814776274713799E-2</c:v>
                </c:pt>
                <c:pt idx="3">
                  <c:v>0.104058272632674</c:v>
                </c:pt>
                <c:pt idx="4">
                  <c:v>0.10718002081165504</c:v>
                </c:pt>
                <c:pt idx="5">
                  <c:v>0.13215400624349594</c:v>
                </c:pt>
                <c:pt idx="6">
                  <c:v>5.3069719042663901E-2</c:v>
                </c:pt>
                <c:pt idx="7">
                  <c:v>4.4745057232049912E-2</c:v>
                </c:pt>
                <c:pt idx="8">
                  <c:v>3.8501560874089499E-2</c:v>
                </c:pt>
                <c:pt idx="9">
                  <c:v>4.0582726326743021E-2</c:v>
                </c:pt>
                <c:pt idx="10">
                  <c:v>3.2258064516129011E-2</c:v>
                </c:pt>
                <c:pt idx="11">
                  <c:v>4.6826222684703399E-2</c:v>
                </c:pt>
                <c:pt idx="12">
                  <c:v>3.4339229968782498E-2</c:v>
                </c:pt>
                <c:pt idx="13">
                  <c:v>2.1852237252861607E-2</c:v>
                </c:pt>
                <c:pt idx="14">
                  <c:v>2.6014568158168598E-2</c:v>
                </c:pt>
                <c:pt idx="15">
                  <c:v>1.45681581685744E-2</c:v>
                </c:pt>
                <c:pt idx="16">
                  <c:v>1.9771071800208109E-2</c:v>
                </c:pt>
                <c:pt idx="17">
                  <c:v>1.1446409989594201E-2</c:v>
                </c:pt>
                <c:pt idx="18">
                  <c:v>8.3246618106139446E-3</c:v>
                </c:pt>
                <c:pt idx="19">
                  <c:v>1.0405827263267413E-2</c:v>
                </c:pt>
                <c:pt idx="20">
                  <c:v>0</c:v>
                </c:pt>
              </c:numCache>
            </c:numRef>
          </c:val>
        </c:ser>
        <c:ser>
          <c:idx val="5"/>
          <c:order val="5"/>
          <c:tx>
            <c:strRef>
              <c:f>'cat-2(CB1112)_A3_0.02_5%'!$G$104</c:f>
              <c:strCache>
                <c:ptCount val="1"/>
                <c:pt idx="0">
                  <c:v>cat-2(CB1112)_A3_07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G$105:$G$125</c:f>
              <c:numCache>
                <c:formatCode>General</c:formatCode>
                <c:ptCount val="21"/>
                <c:pt idx="1">
                  <c:v>7.0496083550913843E-2</c:v>
                </c:pt>
                <c:pt idx="2">
                  <c:v>8.4856396866840753E-2</c:v>
                </c:pt>
                <c:pt idx="3">
                  <c:v>8.8772845953002666E-2</c:v>
                </c:pt>
                <c:pt idx="4">
                  <c:v>9.9216710182767606E-2</c:v>
                </c:pt>
                <c:pt idx="5">
                  <c:v>0.116187989556136</c:v>
                </c:pt>
                <c:pt idx="6">
                  <c:v>4.9608355091383796E-2</c:v>
                </c:pt>
                <c:pt idx="7">
                  <c:v>4.3080939947780721E-2</c:v>
                </c:pt>
                <c:pt idx="8">
                  <c:v>4.8302872062663198E-2</c:v>
                </c:pt>
                <c:pt idx="9">
                  <c:v>4.699738903394262E-2</c:v>
                </c:pt>
                <c:pt idx="10">
                  <c:v>4.4386422976501347E-2</c:v>
                </c:pt>
                <c:pt idx="11">
                  <c:v>4.9608355091383796E-2</c:v>
                </c:pt>
                <c:pt idx="12">
                  <c:v>4.8302872062663198E-2</c:v>
                </c:pt>
                <c:pt idx="13">
                  <c:v>2.7415143603133216E-2</c:v>
                </c:pt>
                <c:pt idx="14">
                  <c:v>1.8276762402088802E-2</c:v>
                </c:pt>
                <c:pt idx="15">
                  <c:v>2.2193211488250719E-2</c:v>
                </c:pt>
                <c:pt idx="16">
                  <c:v>2.3498694516971307E-2</c:v>
                </c:pt>
                <c:pt idx="17">
                  <c:v>1.0443864229765006E-2</c:v>
                </c:pt>
                <c:pt idx="18">
                  <c:v>1.5665796344647501E-2</c:v>
                </c:pt>
                <c:pt idx="19">
                  <c:v>5.2219321148825118E-3</c:v>
                </c:pt>
                <c:pt idx="20">
                  <c:v>2.6109660574412511E-3</c:v>
                </c:pt>
              </c:numCache>
            </c:numRef>
          </c:val>
        </c:ser>
        <c:ser>
          <c:idx val="6"/>
          <c:order val="6"/>
          <c:tx>
            <c:strRef>
              <c:f>'cat-2(CB1112)_A3_0.02_5%'!$H$104</c:f>
              <c:strCache>
                <c:ptCount val="1"/>
                <c:pt idx="0">
                  <c:v>cat-2(CB1112)_A3_08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H$105:$H$125</c:f>
              <c:numCache>
                <c:formatCode>General</c:formatCode>
                <c:ptCount val="21"/>
                <c:pt idx="1">
                  <c:v>8.1487341772151903E-2</c:v>
                </c:pt>
                <c:pt idx="2">
                  <c:v>0.108386075949367</c:v>
                </c:pt>
                <c:pt idx="3">
                  <c:v>0.102848101265823</c:v>
                </c:pt>
                <c:pt idx="4">
                  <c:v>0.151107594936709</c:v>
                </c:pt>
                <c:pt idx="5">
                  <c:v>0.17009493670886106</c:v>
                </c:pt>
                <c:pt idx="6">
                  <c:v>4.3512658227848118E-2</c:v>
                </c:pt>
                <c:pt idx="7">
                  <c:v>5.2215189873417701E-2</c:v>
                </c:pt>
                <c:pt idx="8">
                  <c:v>4.6677215189873382E-2</c:v>
                </c:pt>
                <c:pt idx="9">
                  <c:v>4.8259493670886097E-2</c:v>
                </c:pt>
                <c:pt idx="10">
                  <c:v>4.3512658227848118E-2</c:v>
                </c:pt>
                <c:pt idx="11">
                  <c:v>2.2151898734177201E-2</c:v>
                </c:pt>
                <c:pt idx="12">
                  <c:v>2.2943037974683517E-2</c:v>
                </c:pt>
                <c:pt idx="13">
                  <c:v>1.8196202531645594E-2</c:v>
                </c:pt>
                <c:pt idx="14">
                  <c:v>9.4936708860759531E-3</c:v>
                </c:pt>
                <c:pt idx="15">
                  <c:v>7.1202531645569618E-3</c:v>
                </c:pt>
                <c:pt idx="16">
                  <c:v>3.9556962025316519E-3</c:v>
                </c:pt>
                <c:pt idx="17">
                  <c:v>2.3734177215189909E-3</c:v>
                </c:pt>
                <c:pt idx="18">
                  <c:v>3.9556962025316519E-3</c:v>
                </c:pt>
                <c:pt idx="19">
                  <c:v>3.164556962025322E-3</c:v>
                </c:pt>
                <c:pt idx="20">
                  <c:v>1.5822784810126606E-3</c:v>
                </c:pt>
              </c:numCache>
            </c:numRef>
          </c:val>
        </c:ser>
        <c:ser>
          <c:idx val="7"/>
          <c:order val="7"/>
          <c:tx>
            <c:strRef>
              <c:f>'cat-2(CB1112)_A3_0.02_5%'!$I$104</c:f>
              <c:strCache>
                <c:ptCount val="1"/>
                <c:pt idx="0">
                  <c:v>cat-2(CB1112)_A3_09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I$105:$I$125</c:f>
              <c:numCache>
                <c:formatCode>General</c:formatCode>
                <c:ptCount val="21"/>
                <c:pt idx="1">
                  <c:v>7.3999999999999996E-2</c:v>
                </c:pt>
                <c:pt idx="2">
                  <c:v>9.5000000000000029E-2</c:v>
                </c:pt>
                <c:pt idx="3">
                  <c:v>0.115</c:v>
                </c:pt>
                <c:pt idx="4">
                  <c:v>0.14600000000000005</c:v>
                </c:pt>
                <c:pt idx="5">
                  <c:v>0.129</c:v>
                </c:pt>
                <c:pt idx="6">
                  <c:v>5.6000000000000001E-2</c:v>
                </c:pt>
                <c:pt idx="7">
                  <c:v>5.3000000000000012E-2</c:v>
                </c:pt>
                <c:pt idx="8">
                  <c:v>4.7000000000000014E-2</c:v>
                </c:pt>
                <c:pt idx="9">
                  <c:v>3.4000000000000002E-2</c:v>
                </c:pt>
                <c:pt idx="10">
                  <c:v>3.6999999999999998E-2</c:v>
                </c:pt>
                <c:pt idx="11">
                  <c:v>2.8000000000000001E-2</c:v>
                </c:pt>
                <c:pt idx="12">
                  <c:v>3.2000000000000015E-2</c:v>
                </c:pt>
                <c:pt idx="13">
                  <c:v>1.9000000000000006E-2</c:v>
                </c:pt>
                <c:pt idx="14">
                  <c:v>1.7000000000000001E-2</c:v>
                </c:pt>
                <c:pt idx="15">
                  <c:v>1.6000000000000007E-2</c:v>
                </c:pt>
                <c:pt idx="16">
                  <c:v>6.0000000000000019E-3</c:v>
                </c:pt>
                <c:pt idx="17">
                  <c:v>1.0000000000000004E-2</c:v>
                </c:pt>
                <c:pt idx="18">
                  <c:v>4.0000000000000018E-3</c:v>
                </c:pt>
                <c:pt idx="19">
                  <c:v>6.0000000000000019E-3</c:v>
                </c:pt>
                <c:pt idx="20">
                  <c:v>2.0000000000000009E-3</c:v>
                </c:pt>
              </c:numCache>
            </c:numRef>
          </c:val>
        </c:ser>
        <c:ser>
          <c:idx val="8"/>
          <c:order val="8"/>
          <c:tx>
            <c:strRef>
              <c:f>'cat-2(CB1112)_A3_0.02_5%'!$J$104</c:f>
              <c:strCache>
                <c:ptCount val="1"/>
                <c:pt idx="0">
                  <c:v>cat-2(CB1112)_A3_10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J$105:$J$125</c:f>
              <c:numCache>
                <c:formatCode>General</c:formatCode>
                <c:ptCount val="21"/>
                <c:pt idx="1">
                  <c:v>5.7692307692307716E-2</c:v>
                </c:pt>
                <c:pt idx="2">
                  <c:v>8.2307692307692359E-2</c:v>
                </c:pt>
                <c:pt idx="3">
                  <c:v>0.12307692307692306</c:v>
                </c:pt>
                <c:pt idx="4">
                  <c:v>0.15230769230769206</c:v>
                </c:pt>
                <c:pt idx="5">
                  <c:v>0.17230769230769205</c:v>
                </c:pt>
                <c:pt idx="6">
                  <c:v>6.0000000000000019E-2</c:v>
                </c:pt>
                <c:pt idx="7">
                  <c:v>4.2307692307692324E-2</c:v>
                </c:pt>
                <c:pt idx="8">
                  <c:v>4.9230769230769203E-2</c:v>
                </c:pt>
                <c:pt idx="9">
                  <c:v>0.05</c:v>
                </c:pt>
                <c:pt idx="10">
                  <c:v>3.6923076923076913E-2</c:v>
                </c:pt>
                <c:pt idx="11">
                  <c:v>3.461538461538461E-2</c:v>
                </c:pt>
                <c:pt idx="12">
                  <c:v>2.2307692307692299E-2</c:v>
                </c:pt>
                <c:pt idx="13">
                  <c:v>2.07692307692308E-2</c:v>
                </c:pt>
                <c:pt idx="14">
                  <c:v>1.0000000000000004E-2</c:v>
                </c:pt>
                <c:pt idx="15">
                  <c:v>1.0769230769230803E-2</c:v>
                </c:pt>
                <c:pt idx="16">
                  <c:v>7.6923076923076919E-3</c:v>
                </c:pt>
                <c:pt idx="17">
                  <c:v>5.3846153846153818E-3</c:v>
                </c:pt>
                <c:pt idx="18">
                  <c:v>4.6153846153846219E-3</c:v>
                </c:pt>
                <c:pt idx="19">
                  <c:v>3.0769230769230808E-3</c:v>
                </c:pt>
                <c:pt idx="20">
                  <c:v>1.5384615384615408E-3</c:v>
                </c:pt>
              </c:numCache>
            </c:numRef>
          </c:val>
        </c:ser>
        <c:ser>
          <c:idx val="9"/>
          <c:order val="9"/>
          <c:tx>
            <c:strRef>
              <c:f>'cat-2(CB1112)_A3_0.02_5%'!$K$104</c:f>
              <c:strCache>
                <c:ptCount val="1"/>
                <c:pt idx="0">
                  <c:v>cat-2(CB1112)_A3_11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K$105:$K$125</c:f>
              <c:numCache>
                <c:formatCode>General</c:formatCode>
                <c:ptCount val="21"/>
                <c:pt idx="1">
                  <c:v>7.2932330827067737E-2</c:v>
                </c:pt>
                <c:pt idx="2">
                  <c:v>9.5488721804511206E-2</c:v>
                </c:pt>
                <c:pt idx="3">
                  <c:v>0.12932330827067695</c:v>
                </c:pt>
                <c:pt idx="4">
                  <c:v>0.15488721804511299</c:v>
                </c:pt>
                <c:pt idx="5">
                  <c:v>0.18872180451127807</c:v>
                </c:pt>
                <c:pt idx="6">
                  <c:v>6.6917293233082722E-2</c:v>
                </c:pt>
                <c:pt idx="7">
                  <c:v>4.4360902255639129E-2</c:v>
                </c:pt>
                <c:pt idx="8">
                  <c:v>4.4360902255639129E-2</c:v>
                </c:pt>
                <c:pt idx="9">
                  <c:v>4.2105263157894701E-2</c:v>
                </c:pt>
                <c:pt idx="10">
                  <c:v>3.4586466165413499E-2</c:v>
                </c:pt>
                <c:pt idx="11">
                  <c:v>2.40601503759399E-2</c:v>
                </c:pt>
                <c:pt idx="12">
                  <c:v>1.9548872180451107E-2</c:v>
                </c:pt>
                <c:pt idx="13">
                  <c:v>1.7293233082706798E-2</c:v>
                </c:pt>
                <c:pt idx="14">
                  <c:v>4.5112781954887255E-3</c:v>
                </c:pt>
                <c:pt idx="15">
                  <c:v>3.0075187969924818E-3</c:v>
                </c:pt>
                <c:pt idx="16">
                  <c:v>4.5112781954887255E-3</c:v>
                </c:pt>
                <c:pt idx="17">
                  <c:v>7.5187969924812035E-4</c:v>
                </c:pt>
                <c:pt idx="18">
                  <c:v>2.255639097744361E-3</c:v>
                </c:pt>
                <c:pt idx="19">
                  <c:v>3.7593984962406009E-3</c:v>
                </c:pt>
                <c:pt idx="2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cat-2(CB1112)_A3_0.02_5%'!$L$104</c:f>
              <c:strCache>
                <c:ptCount val="1"/>
                <c:pt idx="0">
                  <c:v>cat-2(CB1112)_A3_12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L$105:$L$125</c:f>
              <c:numCache>
                <c:formatCode>General</c:formatCode>
                <c:ptCount val="21"/>
                <c:pt idx="1">
                  <c:v>7.2796934865900456E-2</c:v>
                </c:pt>
                <c:pt idx="2">
                  <c:v>9.118773946360148E-2</c:v>
                </c:pt>
                <c:pt idx="3">
                  <c:v>0.10804597701149403</c:v>
                </c:pt>
                <c:pt idx="4">
                  <c:v>0.12413793103448302</c:v>
                </c:pt>
                <c:pt idx="5">
                  <c:v>0.13793103448275906</c:v>
                </c:pt>
                <c:pt idx="6">
                  <c:v>5.4406130268199217E-2</c:v>
                </c:pt>
                <c:pt idx="7">
                  <c:v>4.0613026819923431E-2</c:v>
                </c:pt>
                <c:pt idx="8">
                  <c:v>4.5977011494252887E-2</c:v>
                </c:pt>
                <c:pt idx="9">
                  <c:v>5.5172413793103413E-2</c:v>
                </c:pt>
                <c:pt idx="10">
                  <c:v>4.0613026819923431E-2</c:v>
                </c:pt>
                <c:pt idx="11">
                  <c:v>3.5249042145593913E-2</c:v>
                </c:pt>
                <c:pt idx="12">
                  <c:v>2.6819923371647507E-2</c:v>
                </c:pt>
                <c:pt idx="13">
                  <c:v>1.4559386973180094E-2</c:v>
                </c:pt>
                <c:pt idx="14">
                  <c:v>6.1302681992337254E-3</c:v>
                </c:pt>
                <c:pt idx="15">
                  <c:v>1.3026819923371598E-2</c:v>
                </c:pt>
                <c:pt idx="16">
                  <c:v>1.1494252873563199E-2</c:v>
                </c:pt>
                <c:pt idx="17">
                  <c:v>3.8314176245210709E-3</c:v>
                </c:pt>
                <c:pt idx="18">
                  <c:v>1.3793103448275905E-2</c:v>
                </c:pt>
                <c:pt idx="19">
                  <c:v>6.8965517241379318E-3</c:v>
                </c:pt>
                <c:pt idx="20">
                  <c:v>6.8965517241379318E-3</c:v>
                </c:pt>
              </c:numCache>
            </c:numRef>
          </c:val>
        </c:ser>
        <c:ser>
          <c:idx val="11"/>
          <c:order val="11"/>
          <c:tx>
            <c:strRef>
              <c:f>'cat-2(CB1112)_A3_0.02_5%'!$M$104</c:f>
              <c:strCache>
                <c:ptCount val="1"/>
                <c:pt idx="0">
                  <c:v>cat-2(CB1112)_A3_13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M$105:$M$125</c:f>
              <c:numCache>
                <c:formatCode>General</c:formatCode>
                <c:ptCount val="21"/>
                <c:pt idx="1">
                  <c:v>0.10443864229765003</c:v>
                </c:pt>
                <c:pt idx="2">
                  <c:v>9.3994778067885171E-2</c:v>
                </c:pt>
                <c:pt idx="3">
                  <c:v>8.7467362924282074E-2</c:v>
                </c:pt>
                <c:pt idx="4">
                  <c:v>0.13185378590078295</c:v>
                </c:pt>
                <c:pt idx="5">
                  <c:v>9.5300261096605693E-2</c:v>
                </c:pt>
                <c:pt idx="6">
                  <c:v>5.4830287206266336E-2</c:v>
                </c:pt>
                <c:pt idx="7">
                  <c:v>3.9164490861618793E-2</c:v>
                </c:pt>
                <c:pt idx="8">
                  <c:v>3.9164490861618793E-2</c:v>
                </c:pt>
                <c:pt idx="9">
                  <c:v>4.699738903394262E-2</c:v>
                </c:pt>
                <c:pt idx="10">
                  <c:v>4.046997389033942E-2</c:v>
                </c:pt>
                <c:pt idx="11">
                  <c:v>3.6553524804177499E-2</c:v>
                </c:pt>
                <c:pt idx="12">
                  <c:v>3.3942558746736289E-2</c:v>
                </c:pt>
                <c:pt idx="13">
                  <c:v>3.6553524804177499E-2</c:v>
                </c:pt>
                <c:pt idx="14">
                  <c:v>2.8720626631853791E-2</c:v>
                </c:pt>
                <c:pt idx="15">
                  <c:v>1.6971279373368106E-2</c:v>
                </c:pt>
                <c:pt idx="16">
                  <c:v>1.1749347258485601E-2</c:v>
                </c:pt>
                <c:pt idx="17">
                  <c:v>7.8328981723237642E-3</c:v>
                </c:pt>
                <c:pt idx="18">
                  <c:v>0</c:v>
                </c:pt>
                <c:pt idx="19">
                  <c:v>0</c:v>
                </c:pt>
                <c:pt idx="20">
                  <c:v>7.8328981723237642E-3</c:v>
                </c:pt>
              </c:numCache>
            </c:numRef>
          </c:val>
        </c:ser>
        <c:ser>
          <c:idx val="12"/>
          <c:order val="12"/>
          <c:tx>
            <c:strRef>
              <c:f>'cat-2(CB1112)_A3_0.02_5%'!$N$104</c:f>
              <c:strCache>
                <c:ptCount val="1"/>
                <c:pt idx="0">
                  <c:v>cat-2(CB1112)_A3_14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N$105:$N$125</c:f>
              <c:numCache>
                <c:formatCode>General</c:formatCode>
                <c:ptCount val="21"/>
                <c:pt idx="1">
                  <c:v>7.5367647058823553E-2</c:v>
                </c:pt>
                <c:pt idx="2">
                  <c:v>0.10202205882352899</c:v>
                </c:pt>
                <c:pt idx="3">
                  <c:v>9.5588235294117599E-2</c:v>
                </c:pt>
                <c:pt idx="4">
                  <c:v>0.125</c:v>
                </c:pt>
                <c:pt idx="5">
                  <c:v>0.13694852941176505</c:v>
                </c:pt>
                <c:pt idx="6">
                  <c:v>4.8713235294117627E-2</c:v>
                </c:pt>
                <c:pt idx="7">
                  <c:v>5.2389705882352887E-2</c:v>
                </c:pt>
                <c:pt idx="8">
                  <c:v>5.2389705882352887E-2</c:v>
                </c:pt>
                <c:pt idx="9">
                  <c:v>5.1470588235294081E-2</c:v>
                </c:pt>
                <c:pt idx="10">
                  <c:v>2.4816176470588206E-2</c:v>
                </c:pt>
                <c:pt idx="11">
                  <c:v>3.0330882352941197E-2</c:v>
                </c:pt>
                <c:pt idx="12">
                  <c:v>2.9411764705882398E-2</c:v>
                </c:pt>
                <c:pt idx="13">
                  <c:v>2.3897058823529414E-2</c:v>
                </c:pt>
                <c:pt idx="14">
                  <c:v>1.5625E-2</c:v>
                </c:pt>
                <c:pt idx="15">
                  <c:v>5.5147058823529415E-3</c:v>
                </c:pt>
                <c:pt idx="16">
                  <c:v>8.2720588235294153E-3</c:v>
                </c:pt>
                <c:pt idx="17">
                  <c:v>1.0110294117647099E-2</c:v>
                </c:pt>
                <c:pt idx="18">
                  <c:v>1.4705882352941199E-2</c:v>
                </c:pt>
                <c:pt idx="19">
                  <c:v>9.1911764705882443E-3</c:v>
                </c:pt>
                <c:pt idx="20">
                  <c:v>2.7573529411764721E-3</c:v>
                </c:pt>
              </c:numCache>
            </c:numRef>
          </c:val>
        </c:ser>
        <c:ser>
          <c:idx val="13"/>
          <c:order val="13"/>
          <c:tx>
            <c:strRef>
              <c:f>'cat-2(CB1112)_A3_0.02_5%'!$O$104</c:f>
              <c:strCache>
                <c:ptCount val="1"/>
                <c:pt idx="0">
                  <c:v>cat-2(CB1112)_A3_15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O$105:$O$125</c:f>
              <c:numCache>
                <c:formatCode>General</c:formatCode>
                <c:ptCount val="21"/>
                <c:pt idx="1">
                  <c:v>9.2307692307692341E-2</c:v>
                </c:pt>
                <c:pt idx="2">
                  <c:v>9.7435897435897437E-2</c:v>
                </c:pt>
                <c:pt idx="3">
                  <c:v>8.5897435897435898E-2</c:v>
                </c:pt>
                <c:pt idx="4">
                  <c:v>9.3589743589743646E-2</c:v>
                </c:pt>
                <c:pt idx="5">
                  <c:v>0.12179487179487203</c:v>
                </c:pt>
                <c:pt idx="6">
                  <c:v>5.8974358974358973E-2</c:v>
                </c:pt>
                <c:pt idx="7">
                  <c:v>1.7948717948717906E-2</c:v>
                </c:pt>
                <c:pt idx="8">
                  <c:v>4.4871794871794914E-2</c:v>
                </c:pt>
                <c:pt idx="9">
                  <c:v>4.2307692307692324E-2</c:v>
                </c:pt>
                <c:pt idx="10">
                  <c:v>5.3846153846153801E-2</c:v>
                </c:pt>
                <c:pt idx="11">
                  <c:v>3.3333333333333298E-2</c:v>
                </c:pt>
                <c:pt idx="12">
                  <c:v>2.4358974358974401E-2</c:v>
                </c:pt>
                <c:pt idx="13">
                  <c:v>3.5897435897435902E-2</c:v>
                </c:pt>
                <c:pt idx="14">
                  <c:v>2.3076923076923109E-2</c:v>
                </c:pt>
                <c:pt idx="15">
                  <c:v>2.1794871794871801E-2</c:v>
                </c:pt>
                <c:pt idx="16">
                  <c:v>1.0256410256410303E-2</c:v>
                </c:pt>
                <c:pt idx="17">
                  <c:v>1.4102564102564101E-2</c:v>
                </c:pt>
                <c:pt idx="18">
                  <c:v>1.4102564102564101E-2</c:v>
                </c:pt>
                <c:pt idx="19">
                  <c:v>1.2820512820512801E-2</c:v>
                </c:pt>
                <c:pt idx="20">
                  <c:v>6.4102564102564118E-3</c:v>
                </c:pt>
              </c:numCache>
            </c:numRef>
          </c:val>
        </c:ser>
        <c:ser>
          <c:idx val="14"/>
          <c:order val="14"/>
          <c:tx>
            <c:strRef>
              <c:f>'cat-2(CB1112)_A3_0.02_5%'!$P$104</c:f>
              <c:strCache>
                <c:ptCount val="1"/>
                <c:pt idx="0">
                  <c:v>cat-2(CB1112)_A3_16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P$105:$P$125</c:f>
              <c:numCache>
                <c:formatCode>General</c:formatCode>
                <c:ptCount val="21"/>
                <c:pt idx="1">
                  <c:v>6.7238912732474995E-2</c:v>
                </c:pt>
                <c:pt idx="2">
                  <c:v>7.582260371959941E-2</c:v>
                </c:pt>
                <c:pt idx="3">
                  <c:v>0.13519313304721006</c:v>
                </c:pt>
                <c:pt idx="4">
                  <c:v>0.106580829756795</c:v>
                </c:pt>
                <c:pt idx="5">
                  <c:v>0.16309012875536499</c:v>
                </c:pt>
                <c:pt idx="6">
                  <c:v>8.4406294706723881E-2</c:v>
                </c:pt>
                <c:pt idx="7">
                  <c:v>3.7911301859799712E-2</c:v>
                </c:pt>
                <c:pt idx="8">
                  <c:v>5.2217453505007221E-2</c:v>
                </c:pt>
                <c:pt idx="9">
                  <c:v>5.6509298998569386E-2</c:v>
                </c:pt>
                <c:pt idx="10">
                  <c:v>4.2918454935622338E-2</c:v>
                </c:pt>
                <c:pt idx="11">
                  <c:v>3.5765379113018601E-2</c:v>
                </c:pt>
                <c:pt idx="12">
                  <c:v>2.7896995708154518E-2</c:v>
                </c:pt>
                <c:pt idx="13">
                  <c:v>1.9313304721029999E-2</c:v>
                </c:pt>
                <c:pt idx="14">
                  <c:v>1.7882689556509301E-2</c:v>
                </c:pt>
                <c:pt idx="15">
                  <c:v>1.6452074391988609E-2</c:v>
                </c:pt>
                <c:pt idx="16">
                  <c:v>5.007153075822602E-3</c:v>
                </c:pt>
                <c:pt idx="17">
                  <c:v>4.2918454935622343E-3</c:v>
                </c:pt>
                <c:pt idx="18">
                  <c:v>3.5765379113018602E-3</c:v>
                </c:pt>
                <c:pt idx="19">
                  <c:v>3.5765379113018602E-3</c:v>
                </c:pt>
                <c:pt idx="20">
                  <c:v>4.2918454935622343E-3</c:v>
                </c:pt>
              </c:numCache>
            </c:numRef>
          </c:val>
        </c:ser>
        <c:ser>
          <c:idx val="15"/>
          <c:order val="15"/>
          <c:tx>
            <c:strRef>
              <c:f>'cat-2(CB1112)_A3_0.02_5%'!$Q$104</c:f>
              <c:strCache>
                <c:ptCount val="1"/>
                <c:pt idx="0">
                  <c:v>cat-2(CB1112)_A3_17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Q$105:$Q$125</c:f>
              <c:numCache>
                <c:formatCode>General</c:formatCode>
                <c:ptCount val="21"/>
                <c:pt idx="1">
                  <c:v>6.332453825857523E-2</c:v>
                </c:pt>
                <c:pt idx="2">
                  <c:v>9.762532981530346E-2</c:v>
                </c:pt>
                <c:pt idx="3">
                  <c:v>0.10290237467018502</c:v>
                </c:pt>
                <c:pt idx="4">
                  <c:v>0.11697449428320103</c:v>
                </c:pt>
                <c:pt idx="5">
                  <c:v>0.16007036059806501</c:v>
                </c:pt>
                <c:pt idx="6">
                  <c:v>5.1890941072999096E-2</c:v>
                </c:pt>
                <c:pt idx="7">
                  <c:v>5.1890941072999096E-2</c:v>
                </c:pt>
                <c:pt idx="8">
                  <c:v>4.6613896218117901E-2</c:v>
                </c:pt>
                <c:pt idx="9">
                  <c:v>3.9577836411609522E-2</c:v>
                </c:pt>
                <c:pt idx="10">
                  <c:v>3.5180299032541794E-2</c:v>
                </c:pt>
                <c:pt idx="11">
                  <c:v>4.3975373790677168E-2</c:v>
                </c:pt>
                <c:pt idx="12">
                  <c:v>2.5505716798592801E-2</c:v>
                </c:pt>
                <c:pt idx="13">
                  <c:v>2.1108179419525117E-2</c:v>
                </c:pt>
                <c:pt idx="14">
                  <c:v>2.28671943711522E-2</c:v>
                </c:pt>
                <c:pt idx="15">
                  <c:v>1.2313104661389601E-2</c:v>
                </c:pt>
                <c:pt idx="16">
                  <c:v>1.0554089709762505E-2</c:v>
                </c:pt>
                <c:pt idx="17">
                  <c:v>1.2313104661389601E-2</c:v>
                </c:pt>
                <c:pt idx="18">
                  <c:v>7.0360598065083635E-3</c:v>
                </c:pt>
                <c:pt idx="19">
                  <c:v>5.2770448548812715E-3</c:v>
                </c:pt>
                <c:pt idx="20">
                  <c:v>1.7590149516270904E-3</c:v>
                </c:pt>
              </c:numCache>
            </c:numRef>
          </c:val>
        </c:ser>
        <c:ser>
          <c:idx val="16"/>
          <c:order val="16"/>
          <c:tx>
            <c:strRef>
              <c:f>'cat-2(CB1112)_A3_0.02_5%'!$R$104</c:f>
              <c:strCache>
                <c:ptCount val="1"/>
                <c:pt idx="0">
                  <c:v>cat-2(CB1112)_A3_18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R$105:$R$125</c:f>
              <c:numCache>
                <c:formatCode>General</c:formatCode>
                <c:ptCount val="21"/>
                <c:pt idx="1">
                  <c:v>6.5527065527065498E-2</c:v>
                </c:pt>
                <c:pt idx="2">
                  <c:v>8.8319088319088329E-2</c:v>
                </c:pt>
                <c:pt idx="3">
                  <c:v>0.10754985754985801</c:v>
                </c:pt>
                <c:pt idx="4">
                  <c:v>0.10897435897435903</c:v>
                </c:pt>
                <c:pt idx="5">
                  <c:v>0.16524216524216506</c:v>
                </c:pt>
                <c:pt idx="6">
                  <c:v>7.4786324786324826E-2</c:v>
                </c:pt>
                <c:pt idx="7">
                  <c:v>5.3418803418803402E-2</c:v>
                </c:pt>
                <c:pt idx="8">
                  <c:v>6.3390313390313424E-2</c:v>
                </c:pt>
                <c:pt idx="9">
                  <c:v>4.4159544159544199E-2</c:v>
                </c:pt>
                <c:pt idx="10">
                  <c:v>3.9886039886039899E-2</c:v>
                </c:pt>
                <c:pt idx="11">
                  <c:v>2.9202279202279208E-2</c:v>
                </c:pt>
                <c:pt idx="12">
                  <c:v>3.1339031339031286E-2</c:v>
                </c:pt>
                <c:pt idx="13">
                  <c:v>2.27920227920228E-2</c:v>
                </c:pt>
                <c:pt idx="14">
                  <c:v>1.4245014245014204E-2</c:v>
                </c:pt>
                <c:pt idx="15">
                  <c:v>1.5669515669515709E-2</c:v>
                </c:pt>
                <c:pt idx="16">
                  <c:v>4.9857549857549935E-3</c:v>
                </c:pt>
                <c:pt idx="17">
                  <c:v>3.5612535612535609E-3</c:v>
                </c:pt>
                <c:pt idx="18">
                  <c:v>3.5612535612535609E-3</c:v>
                </c:pt>
                <c:pt idx="19">
                  <c:v>4.2735042735042713E-3</c:v>
                </c:pt>
                <c:pt idx="2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cat-2(CB1112)_A3_0.02_5%'!$S$104</c:f>
              <c:strCache>
                <c:ptCount val="1"/>
                <c:pt idx="0">
                  <c:v>cat-2(CB1112)_A3_19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S$105:$S$125</c:f>
              <c:numCache>
                <c:formatCode>General</c:formatCode>
                <c:ptCount val="21"/>
                <c:pt idx="1">
                  <c:v>5.7638888888888899E-2</c:v>
                </c:pt>
                <c:pt idx="2">
                  <c:v>8.5416666666666724E-2</c:v>
                </c:pt>
                <c:pt idx="3">
                  <c:v>0.13055555555555595</c:v>
                </c:pt>
                <c:pt idx="4">
                  <c:v>0.10972222222222208</c:v>
                </c:pt>
                <c:pt idx="5">
                  <c:v>0.18888888888888899</c:v>
                </c:pt>
                <c:pt idx="6">
                  <c:v>7.4305555555555597E-2</c:v>
                </c:pt>
                <c:pt idx="7">
                  <c:v>2.9861111111111106E-2</c:v>
                </c:pt>
                <c:pt idx="8">
                  <c:v>3.8888888888888903E-2</c:v>
                </c:pt>
                <c:pt idx="9">
                  <c:v>4.7222222222222221E-2</c:v>
                </c:pt>
                <c:pt idx="10">
                  <c:v>0.05</c:v>
                </c:pt>
                <c:pt idx="11">
                  <c:v>3.19444444444444E-2</c:v>
                </c:pt>
                <c:pt idx="12">
                  <c:v>2.1527777777777809E-2</c:v>
                </c:pt>
                <c:pt idx="13">
                  <c:v>2.1527777777777809E-2</c:v>
                </c:pt>
                <c:pt idx="14">
                  <c:v>1.8749999999999999E-2</c:v>
                </c:pt>
                <c:pt idx="15">
                  <c:v>1.59722222222222E-2</c:v>
                </c:pt>
                <c:pt idx="16">
                  <c:v>5.5555555555555601E-3</c:v>
                </c:pt>
                <c:pt idx="17">
                  <c:v>6.2500000000000021E-3</c:v>
                </c:pt>
                <c:pt idx="18">
                  <c:v>7.6388888888888904E-3</c:v>
                </c:pt>
                <c:pt idx="19">
                  <c:v>2.0833333333333311E-3</c:v>
                </c:pt>
                <c:pt idx="20">
                  <c:v>2.0833333333333311E-3</c:v>
                </c:pt>
              </c:numCache>
            </c:numRef>
          </c:val>
        </c:ser>
        <c:ser>
          <c:idx val="18"/>
          <c:order val="18"/>
          <c:tx>
            <c:strRef>
              <c:f>'cat-2(CB1112)_A3_0.02_5%'!$T$104</c:f>
              <c:strCache>
                <c:ptCount val="1"/>
                <c:pt idx="0">
                  <c:v>cat-2(CB1112)_A3_20</c:v>
                </c:pt>
              </c:strCache>
            </c:strRef>
          </c:tx>
          <c:marker>
            <c:symbol val="none"/>
          </c:marker>
          <c:cat>
            <c:numRef>
              <c:f>'cat-2(CB1112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3_0.02_5%'!$T$105:$T$125</c:f>
              <c:numCache>
                <c:formatCode>General</c:formatCode>
                <c:ptCount val="21"/>
                <c:pt idx="1">
                  <c:v>5.3859964093357297E-2</c:v>
                </c:pt>
                <c:pt idx="2">
                  <c:v>7.899461400359073E-2</c:v>
                </c:pt>
                <c:pt idx="3">
                  <c:v>0.10323159784560103</c:v>
                </c:pt>
                <c:pt idx="4">
                  <c:v>0.10323159784560103</c:v>
                </c:pt>
                <c:pt idx="5">
                  <c:v>0.140933572710952</c:v>
                </c:pt>
                <c:pt idx="6">
                  <c:v>7.0017953321364498E-2</c:v>
                </c:pt>
                <c:pt idx="7">
                  <c:v>4.2190305206463198E-2</c:v>
                </c:pt>
                <c:pt idx="8">
                  <c:v>3.8599640933572703E-2</c:v>
                </c:pt>
                <c:pt idx="9">
                  <c:v>5.1166965888689402E-2</c:v>
                </c:pt>
                <c:pt idx="10">
                  <c:v>3.9497307001795316E-2</c:v>
                </c:pt>
                <c:pt idx="11">
                  <c:v>3.8599640933572703E-2</c:v>
                </c:pt>
                <c:pt idx="12">
                  <c:v>4.4883303411131122E-2</c:v>
                </c:pt>
                <c:pt idx="13">
                  <c:v>2.9622980251346489E-2</c:v>
                </c:pt>
                <c:pt idx="14">
                  <c:v>1.8850987432675003E-2</c:v>
                </c:pt>
                <c:pt idx="15">
                  <c:v>1.8850987432675003E-2</c:v>
                </c:pt>
                <c:pt idx="16">
                  <c:v>1.2567324955116701E-2</c:v>
                </c:pt>
                <c:pt idx="17">
                  <c:v>1.0771992818671498E-2</c:v>
                </c:pt>
                <c:pt idx="18">
                  <c:v>4.4883303411131122E-3</c:v>
                </c:pt>
                <c:pt idx="19">
                  <c:v>6.2836624775583537E-3</c:v>
                </c:pt>
                <c:pt idx="20">
                  <c:v>6.2836624775583537E-3</c:v>
                </c:pt>
              </c:numCache>
            </c:numRef>
          </c:val>
        </c:ser>
        <c:marker val="1"/>
        <c:axId val="160152960"/>
        <c:axId val="160175232"/>
      </c:lineChart>
      <c:catAx>
        <c:axId val="160152960"/>
        <c:scaling>
          <c:orientation val="minMax"/>
        </c:scaling>
        <c:axPos val="b"/>
        <c:numFmt formatCode="0.0_ " sourceLinked="1"/>
        <c:tickLblPos val="nextTo"/>
        <c:crossAx val="160175232"/>
        <c:crosses val="autoZero"/>
        <c:auto val="1"/>
        <c:lblAlgn val="ctr"/>
        <c:lblOffset val="100"/>
        <c:tickLblSkip val="5"/>
        <c:tickMarkSkip val="5"/>
      </c:catAx>
      <c:valAx>
        <c:axId val="16017523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0152960"/>
        <c:crosses val="autoZero"/>
        <c:crossBetween val="between"/>
      </c:valAx>
    </c:plotArea>
    <c:plotVisOnly val="1"/>
  </c:chart>
  <c:externalData r:id="rId1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2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2(CB1112)_A1_0.02_5%'!$B$104</c:f>
              <c:strCache>
                <c:ptCount val="1"/>
                <c:pt idx="0">
                  <c:v>cat-2(CB1112)_A1_01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B$105:$B$125</c:f>
              <c:numCache>
                <c:formatCode>General</c:formatCode>
                <c:ptCount val="21"/>
                <c:pt idx="1">
                  <c:v>6.4914992272024713E-2</c:v>
                </c:pt>
                <c:pt idx="2">
                  <c:v>8.1143740340030884E-2</c:v>
                </c:pt>
                <c:pt idx="3">
                  <c:v>9.1190108191653851E-2</c:v>
                </c:pt>
                <c:pt idx="4">
                  <c:v>0.112828438948995</c:v>
                </c:pt>
                <c:pt idx="5">
                  <c:v>0.13214837712519306</c:v>
                </c:pt>
                <c:pt idx="6">
                  <c:v>8.964451313755803E-2</c:v>
                </c:pt>
                <c:pt idx="7">
                  <c:v>5.3323029366306014E-2</c:v>
                </c:pt>
                <c:pt idx="8">
                  <c:v>5.486862442040194E-2</c:v>
                </c:pt>
                <c:pt idx="9">
                  <c:v>5.3323029366306014E-2</c:v>
                </c:pt>
                <c:pt idx="10">
                  <c:v>4.7913446676970603E-2</c:v>
                </c:pt>
                <c:pt idx="11">
                  <c:v>3.2457496136012398E-2</c:v>
                </c:pt>
                <c:pt idx="12">
                  <c:v>2.8593508500772802E-2</c:v>
                </c:pt>
                <c:pt idx="13">
                  <c:v>3.3230293663060316E-2</c:v>
                </c:pt>
                <c:pt idx="14">
                  <c:v>1.2364760432766601E-2</c:v>
                </c:pt>
                <c:pt idx="15">
                  <c:v>1.6228748068006203E-2</c:v>
                </c:pt>
                <c:pt idx="16">
                  <c:v>9.2735703245749642E-3</c:v>
                </c:pt>
                <c:pt idx="17">
                  <c:v>7.7279752704791302E-3</c:v>
                </c:pt>
                <c:pt idx="18">
                  <c:v>3.8639876352395712E-3</c:v>
                </c:pt>
                <c:pt idx="19">
                  <c:v>6.9551777434312236E-3</c:v>
                </c:pt>
                <c:pt idx="20">
                  <c:v>4.6367851622874804E-3</c:v>
                </c:pt>
              </c:numCache>
            </c:numRef>
          </c:val>
        </c:ser>
        <c:ser>
          <c:idx val="1"/>
          <c:order val="1"/>
          <c:tx>
            <c:strRef>
              <c:f>'cat-2(CB1112)_A1_0.02_5%'!$C$104</c:f>
              <c:strCache>
                <c:ptCount val="1"/>
                <c:pt idx="0">
                  <c:v>cat-2(CB1112)_A1_02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C$105:$C$125</c:f>
              <c:numCache>
                <c:formatCode>General</c:formatCode>
                <c:ptCount val="21"/>
                <c:pt idx="1">
                  <c:v>7.0772058823529424E-2</c:v>
                </c:pt>
                <c:pt idx="2">
                  <c:v>7.1691176470588203E-2</c:v>
                </c:pt>
                <c:pt idx="3">
                  <c:v>0.10569852941176502</c:v>
                </c:pt>
                <c:pt idx="4">
                  <c:v>0.12316176470588205</c:v>
                </c:pt>
                <c:pt idx="5">
                  <c:v>0.12132352941176502</c:v>
                </c:pt>
                <c:pt idx="6">
                  <c:v>8.7316176470588161E-2</c:v>
                </c:pt>
                <c:pt idx="7">
                  <c:v>5.7904411764705913E-2</c:v>
                </c:pt>
                <c:pt idx="8">
                  <c:v>4.8713235294117627E-2</c:v>
                </c:pt>
                <c:pt idx="9">
                  <c:v>4.8713235294117627E-2</c:v>
                </c:pt>
                <c:pt idx="10">
                  <c:v>5.1470588235294081E-2</c:v>
                </c:pt>
                <c:pt idx="11">
                  <c:v>3.3088235294117599E-2</c:v>
                </c:pt>
                <c:pt idx="12">
                  <c:v>2.2058823529411808E-2</c:v>
                </c:pt>
                <c:pt idx="13">
                  <c:v>2.4816176470588206E-2</c:v>
                </c:pt>
                <c:pt idx="14">
                  <c:v>1.8382352941176499E-2</c:v>
                </c:pt>
                <c:pt idx="15">
                  <c:v>1.2867647058823499E-2</c:v>
                </c:pt>
                <c:pt idx="16">
                  <c:v>1.5625E-2</c:v>
                </c:pt>
                <c:pt idx="17">
                  <c:v>7.3529411764705899E-3</c:v>
                </c:pt>
                <c:pt idx="18">
                  <c:v>5.5147058823529415E-3</c:v>
                </c:pt>
                <c:pt idx="19">
                  <c:v>9.1911764705882428E-4</c:v>
                </c:pt>
                <c:pt idx="20">
                  <c:v>5.5147058823529415E-3</c:v>
                </c:pt>
              </c:numCache>
            </c:numRef>
          </c:val>
        </c:ser>
        <c:ser>
          <c:idx val="2"/>
          <c:order val="2"/>
          <c:tx>
            <c:strRef>
              <c:f>'cat-2(CB1112)_A1_0.02_5%'!$D$104</c:f>
              <c:strCache>
                <c:ptCount val="1"/>
                <c:pt idx="0">
                  <c:v>cat-2(CB1112)_A1_03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D$105:$D$125</c:f>
              <c:numCache>
                <c:formatCode>General</c:formatCode>
                <c:ptCount val="21"/>
                <c:pt idx="1">
                  <c:v>6.5127782357790598E-2</c:v>
                </c:pt>
                <c:pt idx="2">
                  <c:v>8.408903544929934E-2</c:v>
                </c:pt>
                <c:pt idx="3">
                  <c:v>9.5630667765869759E-2</c:v>
                </c:pt>
                <c:pt idx="4">
                  <c:v>0.118713932399011</c:v>
                </c:pt>
                <c:pt idx="5">
                  <c:v>0.12448474855729603</c:v>
                </c:pt>
                <c:pt idx="6">
                  <c:v>9.5630667765869759E-2</c:v>
                </c:pt>
                <c:pt idx="7">
                  <c:v>4.5342126957955517E-2</c:v>
                </c:pt>
                <c:pt idx="8">
                  <c:v>4.5342126957955517E-2</c:v>
                </c:pt>
                <c:pt idx="9">
                  <c:v>5.7708161582852399E-2</c:v>
                </c:pt>
                <c:pt idx="10">
                  <c:v>5.6059356966199479E-2</c:v>
                </c:pt>
                <c:pt idx="11">
                  <c:v>2.7205276174773328E-2</c:v>
                </c:pt>
                <c:pt idx="12">
                  <c:v>2.6380873866446802E-2</c:v>
                </c:pt>
                <c:pt idx="13">
                  <c:v>2.3083264633140997E-2</c:v>
                </c:pt>
                <c:pt idx="14">
                  <c:v>2.1434460016488001E-2</c:v>
                </c:pt>
                <c:pt idx="15">
                  <c:v>2.1434460016488001E-2</c:v>
                </c:pt>
                <c:pt idx="16">
                  <c:v>1.4839241549876299E-2</c:v>
                </c:pt>
                <c:pt idx="17">
                  <c:v>6.5952184666117101E-3</c:v>
                </c:pt>
                <c:pt idx="18">
                  <c:v>3.2976092333058499E-3</c:v>
                </c:pt>
                <c:pt idx="19">
                  <c:v>2.4732069249793899E-3</c:v>
                </c:pt>
                <c:pt idx="20">
                  <c:v>6.5952184666117101E-3</c:v>
                </c:pt>
              </c:numCache>
            </c:numRef>
          </c:val>
        </c:ser>
        <c:ser>
          <c:idx val="3"/>
          <c:order val="3"/>
          <c:tx>
            <c:strRef>
              <c:f>'cat-2(CB1112)_A1_0.02_5%'!$E$104</c:f>
              <c:strCache>
                <c:ptCount val="1"/>
                <c:pt idx="0">
                  <c:v>cat-2(CB1112)_A1_04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E$105:$E$125</c:f>
              <c:numCache>
                <c:formatCode>General</c:formatCode>
                <c:ptCount val="21"/>
                <c:pt idx="1">
                  <c:v>6.062819576333088E-2</c:v>
                </c:pt>
                <c:pt idx="2">
                  <c:v>7.3776479181884597E-2</c:v>
                </c:pt>
                <c:pt idx="3">
                  <c:v>0.10007304601899203</c:v>
                </c:pt>
                <c:pt idx="4">
                  <c:v>0.11468224981738502</c:v>
                </c:pt>
                <c:pt idx="5">
                  <c:v>0.12636961285609899</c:v>
                </c:pt>
                <c:pt idx="6">
                  <c:v>9.2768444119795526E-2</c:v>
                </c:pt>
                <c:pt idx="7">
                  <c:v>6.2089116143170198E-2</c:v>
                </c:pt>
                <c:pt idx="8">
                  <c:v>4.6018991964937916E-2</c:v>
                </c:pt>
                <c:pt idx="9">
                  <c:v>5.4784514243973736E-2</c:v>
                </c:pt>
                <c:pt idx="10">
                  <c:v>4.2366691015339755E-2</c:v>
                </c:pt>
                <c:pt idx="11">
                  <c:v>4.8940832724616495E-2</c:v>
                </c:pt>
                <c:pt idx="12">
                  <c:v>2.7027027027027015E-2</c:v>
                </c:pt>
                <c:pt idx="13">
                  <c:v>2.4835646457268119E-2</c:v>
                </c:pt>
                <c:pt idx="14">
                  <c:v>1.5339663988312598E-2</c:v>
                </c:pt>
                <c:pt idx="15">
                  <c:v>1.8261504747991208E-2</c:v>
                </c:pt>
                <c:pt idx="16">
                  <c:v>1.6800584368151912E-2</c:v>
                </c:pt>
                <c:pt idx="17">
                  <c:v>1.3148283418553701E-2</c:v>
                </c:pt>
                <c:pt idx="18">
                  <c:v>5.1132213294375504E-3</c:v>
                </c:pt>
                <c:pt idx="19">
                  <c:v>4.3827611395179013E-3</c:v>
                </c:pt>
                <c:pt idx="20">
                  <c:v>1.4609203798393001E-3</c:v>
                </c:pt>
              </c:numCache>
            </c:numRef>
          </c:val>
        </c:ser>
        <c:ser>
          <c:idx val="4"/>
          <c:order val="4"/>
          <c:tx>
            <c:strRef>
              <c:f>'cat-2(CB1112)_A1_0.02_5%'!$F$104</c:f>
              <c:strCache>
                <c:ptCount val="1"/>
                <c:pt idx="0">
                  <c:v>cat-2(CB1112)_A1_05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F$105:$F$125</c:f>
              <c:numCache>
                <c:formatCode>General</c:formatCode>
                <c:ptCount val="21"/>
                <c:pt idx="1">
                  <c:v>6.7176870748299297E-2</c:v>
                </c:pt>
                <c:pt idx="2">
                  <c:v>6.6326530612244902E-2</c:v>
                </c:pt>
                <c:pt idx="3">
                  <c:v>8.5884353741496652E-2</c:v>
                </c:pt>
                <c:pt idx="4">
                  <c:v>0.108843537414966</c:v>
                </c:pt>
                <c:pt idx="5">
                  <c:v>0.14965986394557795</c:v>
                </c:pt>
                <c:pt idx="6">
                  <c:v>9.5238095238095247E-2</c:v>
                </c:pt>
                <c:pt idx="7">
                  <c:v>4.1666666666666699E-2</c:v>
                </c:pt>
                <c:pt idx="8">
                  <c:v>4.4217687074829919E-2</c:v>
                </c:pt>
                <c:pt idx="9">
                  <c:v>4.7619047619047616E-2</c:v>
                </c:pt>
                <c:pt idx="10">
                  <c:v>4.5068027210884404E-2</c:v>
                </c:pt>
                <c:pt idx="11">
                  <c:v>3.5714285714285698E-2</c:v>
                </c:pt>
                <c:pt idx="12">
                  <c:v>4.1666666666666699E-2</c:v>
                </c:pt>
                <c:pt idx="13">
                  <c:v>2.1258503401360505E-2</c:v>
                </c:pt>
                <c:pt idx="14">
                  <c:v>2.1258503401360505E-2</c:v>
                </c:pt>
                <c:pt idx="15">
                  <c:v>1.5306122448979604E-2</c:v>
                </c:pt>
                <c:pt idx="16">
                  <c:v>1.6156462585034E-2</c:v>
                </c:pt>
                <c:pt idx="17">
                  <c:v>1.1904761904761904E-2</c:v>
                </c:pt>
                <c:pt idx="18">
                  <c:v>9.3537414965986481E-3</c:v>
                </c:pt>
                <c:pt idx="19">
                  <c:v>4.2517006802721136E-3</c:v>
                </c:pt>
                <c:pt idx="20">
                  <c:v>4.2517006802721136E-3</c:v>
                </c:pt>
              </c:numCache>
            </c:numRef>
          </c:val>
        </c:ser>
        <c:ser>
          <c:idx val="5"/>
          <c:order val="5"/>
          <c:tx>
            <c:strRef>
              <c:f>'cat-2(CB1112)_A1_0.02_5%'!$G$104</c:f>
              <c:strCache>
                <c:ptCount val="1"/>
                <c:pt idx="0">
                  <c:v>cat-2(CB1112)_A1_06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G$105:$G$125</c:f>
              <c:numCache>
                <c:formatCode>General</c:formatCode>
                <c:ptCount val="21"/>
                <c:pt idx="1">
                  <c:v>6.1728395061728399E-2</c:v>
                </c:pt>
                <c:pt idx="2">
                  <c:v>6.8783068783068793E-2</c:v>
                </c:pt>
                <c:pt idx="3">
                  <c:v>7.9365079365079402E-2</c:v>
                </c:pt>
                <c:pt idx="4">
                  <c:v>8.6419753086419679E-2</c:v>
                </c:pt>
                <c:pt idx="5">
                  <c:v>0.11111111111111099</c:v>
                </c:pt>
                <c:pt idx="6">
                  <c:v>0.13051146384479706</c:v>
                </c:pt>
                <c:pt idx="7">
                  <c:v>6.3492063492063502E-2</c:v>
                </c:pt>
                <c:pt idx="8">
                  <c:v>5.29100529100529E-2</c:v>
                </c:pt>
                <c:pt idx="9">
                  <c:v>3.5273368606701931E-2</c:v>
                </c:pt>
                <c:pt idx="10">
                  <c:v>3.8800705467372111E-2</c:v>
                </c:pt>
                <c:pt idx="11">
                  <c:v>3.5273368606701931E-2</c:v>
                </c:pt>
                <c:pt idx="12">
                  <c:v>2.8218694885361599E-2</c:v>
                </c:pt>
                <c:pt idx="13">
                  <c:v>4.0564373897707215E-2</c:v>
                </c:pt>
                <c:pt idx="14">
                  <c:v>2.9982363315696599E-2</c:v>
                </c:pt>
                <c:pt idx="15">
                  <c:v>1.9400352733686108E-2</c:v>
                </c:pt>
                <c:pt idx="16">
                  <c:v>2.1164021164021198E-2</c:v>
                </c:pt>
                <c:pt idx="17">
                  <c:v>1.0582010582010601E-2</c:v>
                </c:pt>
                <c:pt idx="18">
                  <c:v>7.054673721340392E-3</c:v>
                </c:pt>
                <c:pt idx="19">
                  <c:v>1.41093474426808E-2</c:v>
                </c:pt>
                <c:pt idx="20">
                  <c:v>7.054673721340392E-3</c:v>
                </c:pt>
              </c:numCache>
            </c:numRef>
          </c:val>
        </c:ser>
        <c:ser>
          <c:idx val="6"/>
          <c:order val="6"/>
          <c:tx>
            <c:strRef>
              <c:f>'cat-2(CB1112)_A1_0.02_5%'!$H$104</c:f>
              <c:strCache>
                <c:ptCount val="1"/>
                <c:pt idx="0">
                  <c:v>cat-2(CB1112)_A1_07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H$105:$H$125</c:f>
              <c:numCache>
                <c:formatCode>General</c:formatCode>
                <c:ptCount val="21"/>
                <c:pt idx="1">
                  <c:v>6.6141732283464552E-2</c:v>
                </c:pt>
                <c:pt idx="2">
                  <c:v>7.4015748031496104E-2</c:v>
                </c:pt>
                <c:pt idx="3">
                  <c:v>7.3228346456692878E-2</c:v>
                </c:pt>
                <c:pt idx="4">
                  <c:v>0.11338582677165403</c:v>
                </c:pt>
                <c:pt idx="5">
                  <c:v>0.13543307086614206</c:v>
                </c:pt>
                <c:pt idx="6">
                  <c:v>8.7401574803149543E-2</c:v>
                </c:pt>
                <c:pt idx="7">
                  <c:v>6.2204724409448825E-2</c:v>
                </c:pt>
                <c:pt idx="8">
                  <c:v>4.6456692913385819E-2</c:v>
                </c:pt>
                <c:pt idx="9">
                  <c:v>4.8031496062992098E-2</c:v>
                </c:pt>
                <c:pt idx="10">
                  <c:v>4.8818897637795317E-2</c:v>
                </c:pt>
                <c:pt idx="11">
                  <c:v>4.4094488188976419E-2</c:v>
                </c:pt>
                <c:pt idx="12">
                  <c:v>3.4645669291338603E-2</c:v>
                </c:pt>
                <c:pt idx="13">
                  <c:v>2.2047244094488206E-2</c:v>
                </c:pt>
                <c:pt idx="14">
                  <c:v>2.6771653543307107E-2</c:v>
                </c:pt>
                <c:pt idx="15">
                  <c:v>1.8110236220472399E-2</c:v>
                </c:pt>
                <c:pt idx="16">
                  <c:v>2.1259842519685018E-2</c:v>
                </c:pt>
                <c:pt idx="17">
                  <c:v>5.5118110236220515E-3</c:v>
                </c:pt>
                <c:pt idx="18">
                  <c:v>9.4488188976378003E-3</c:v>
                </c:pt>
                <c:pt idx="19">
                  <c:v>7.8740157480314977E-3</c:v>
                </c:pt>
                <c:pt idx="20">
                  <c:v>3.149606299212601E-3</c:v>
                </c:pt>
              </c:numCache>
            </c:numRef>
          </c:val>
        </c:ser>
        <c:ser>
          <c:idx val="7"/>
          <c:order val="7"/>
          <c:tx>
            <c:strRef>
              <c:f>'cat-2(CB1112)_A1_0.02_5%'!$I$104</c:f>
              <c:strCache>
                <c:ptCount val="1"/>
                <c:pt idx="0">
                  <c:v>cat-2(CB1112)_A1_08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I$105:$I$125</c:f>
              <c:numCache>
                <c:formatCode>General</c:formatCode>
                <c:ptCount val="21"/>
                <c:pt idx="1">
                  <c:v>7.6583210603829194E-2</c:v>
                </c:pt>
                <c:pt idx="2">
                  <c:v>7.1428571428571411E-2</c:v>
                </c:pt>
                <c:pt idx="3">
                  <c:v>9.3519882179676064E-2</c:v>
                </c:pt>
                <c:pt idx="4">
                  <c:v>0.10162002945508106</c:v>
                </c:pt>
                <c:pt idx="5">
                  <c:v>0.13549337260677499</c:v>
                </c:pt>
                <c:pt idx="6">
                  <c:v>8.8365243004418295E-2</c:v>
                </c:pt>
                <c:pt idx="7">
                  <c:v>6.7010309278350499E-2</c:v>
                </c:pt>
                <c:pt idx="8">
                  <c:v>5.3019145802650977E-2</c:v>
                </c:pt>
                <c:pt idx="9">
                  <c:v>3.9027982326951399E-2</c:v>
                </c:pt>
                <c:pt idx="10">
                  <c:v>4.197349042709872E-2</c:v>
                </c:pt>
                <c:pt idx="11">
                  <c:v>3.4609720176730502E-2</c:v>
                </c:pt>
                <c:pt idx="12">
                  <c:v>3.2400589101620005E-2</c:v>
                </c:pt>
                <c:pt idx="13">
                  <c:v>3.3873343151693713E-2</c:v>
                </c:pt>
                <c:pt idx="14">
                  <c:v>2.2091310751104619E-2</c:v>
                </c:pt>
                <c:pt idx="15">
                  <c:v>1.6936671575846801E-2</c:v>
                </c:pt>
                <c:pt idx="16">
                  <c:v>9.5729013254786527E-3</c:v>
                </c:pt>
                <c:pt idx="17">
                  <c:v>9.5729013254786527E-3</c:v>
                </c:pt>
                <c:pt idx="18">
                  <c:v>8.8365243004418295E-3</c:v>
                </c:pt>
                <c:pt idx="19">
                  <c:v>5.1546391752577301E-3</c:v>
                </c:pt>
                <c:pt idx="20">
                  <c:v>5.1546391752577301E-3</c:v>
                </c:pt>
              </c:numCache>
            </c:numRef>
          </c:val>
        </c:ser>
        <c:ser>
          <c:idx val="8"/>
          <c:order val="8"/>
          <c:tx>
            <c:strRef>
              <c:f>'cat-2(CB1112)_A1_0.02_5%'!$J$104</c:f>
              <c:strCache>
                <c:ptCount val="1"/>
                <c:pt idx="0">
                  <c:v>cat-2(CB1112)_A1_09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J$105:$J$125</c:f>
              <c:numCache>
                <c:formatCode>General</c:formatCode>
                <c:ptCount val="21"/>
                <c:pt idx="1">
                  <c:v>5.1736357193479798E-2</c:v>
                </c:pt>
                <c:pt idx="2">
                  <c:v>7.5832742735648523E-2</c:v>
                </c:pt>
                <c:pt idx="3">
                  <c:v>0.10063784549964598</c:v>
                </c:pt>
                <c:pt idx="4">
                  <c:v>0.11622962437987203</c:v>
                </c:pt>
                <c:pt idx="5">
                  <c:v>0.148830616583983</c:v>
                </c:pt>
                <c:pt idx="6">
                  <c:v>0.10276399716513103</c:v>
                </c:pt>
                <c:pt idx="7">
                  <c:v>5.1736357193479798E-2</c:v>
                </c:pt>
                <c:pt idx="8">
                  <c:v>4.4649184975194885E-2</c:v>
                </c:pt>
                <c:pt idx="9">
                  <c:v>5.5279943302622286E-2</c:v>
                </c:pt>
                <c:pt idx="10">
                  <c:v>5.8823529411764698E-2</c:v>
                </c:pt>
                <c:pt idx="11">
                  <c:v>3.9688164422395512E-2</c:v>
                </c:pt>
                <c:pt idx="12">
                  <c:v>3.4727143869596001E-2</c:v>
                </c:pt>
                <c:pt idx="13">
                  <c:v>1.91353649893692E-2</c:v>
                </c:pt>
                <c:pt idx="14">
                  <c:v>1.1339475549255807E-2</c:v>
                </c:pt>
                <c:pt idx="15">
                  <c:v>1.2756909992912801E-2</c:v>
                </c:pt>
                <c:pt idx="16">
                  <c:v>1.1339475549255807E-2</c:v>
                </c:pt>
                <c:pt idx="17">
                  <c:v>8.5046066619418794E-3</c:v>
                </c:pt>
                <c:pt idx="18">
                  <c:v>3.5435861091424521E-3</c:v>
                </c:pt>
                <c:pt idx="19">
                  <c:v>2.8348688873139597E-3</c:v>
                </c:pt>
                <c:pt idx="20">
                  <c:v>3.5435861091424521E-3</c:v>
                </c:pt>
              </c:numCache>
            </c:numRef>
          </c:val>
        </c:ser>
        <c:ser>
          <c:idx val="9"/>
          <c:order val="9"/>
          <c:tx>
            <c:strRef>
              <c:f>'cat-2(CB1112)_A1_0.02_5%'!$K$104</c:f>
              <c:strCache>
                <c:ptCount val="1"/>
                <c:pt idx="0">
                  <c:v>cat-2(CB1112)_A1_10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K$105:$K$125</c:f>
              <c:numCache>
                <c:formatCode>General</c:formatCode>
                <c:ptCount val="21"/>
                <c:pt idx="1">
                  <c:v>5.5124223602484486E-2</c:v>
                </c:pt>
                <c:pt idx="2">
                  <c:v>7.2204968944099404E-2</c:v>
                </c:pt>
                <c:pt idx="3">
                  <c:v>8.9285714285714246E-2</c:v>
                </c:pt>
                <c:pt idx="4">
                  <c:v>9.0062111801242198E-2</c:v>
                </c:pt>
                <c:pt idx="5">
                  <c:v>0.106366459627329</c:v>
                </c:pt>
                <c:pt idx="6">
                  <c:v>9.8602484472049737E-2</c:v>
                </c:pt>
                <c:pt idx="7">
                  <c:v>6.2111801242236031E-2</c:v>
                </c:pt>
                <c:pt idx="8">
                  <c:v>3.7267080745341602E-2</c:v>
                </c:pt>
                <c:pt idx="9">
                  <c:v>4.7360248447205017E-2</c:v>
                </c:pt>
                <c:pt idx="10">
                  <c:v>5.2795031055900644E-2</c:v>
                </c:pt>
                <c:pt idx="11">
                  <c:v>4.7360248447205017E-2</c:v>
                </c:pt>
                <c:pt idx="12">
                  <c:v>4.8136645962732899E-2</c:v>
                </c:pt>
                <c:pt idx="13">
                  <c:v>3.9596273291925499E-2</c:v>
                </c:pt>
                <c:pt idx="14">
                  <c:v>2.5621118012422412E-2</c:v>
                </c:pt>
                <c:pt idx="15">
                  <c:v>1.7080745341614901E-2</c:v>
                </c:pt>
                <c:pt idx="16">
                  <c:v>1.5527950310559004E-2</c:v>
                </c:pt>
                <c:pt idx="17">
                  <c:v>9.3167701863354005E-3</c:v>
                </c:pt>
                <c:pt idx="18">
                  <c:v>9.3167701863354005E-3</c:v>
                </c:pt>
                <c:pt idx="19">
                  <c:v>6.2111801242236038E-3</c:v>
                </c:pt>
                <c:pt idx="20">
                  <c:v>7.7639751552795021E-3</c:v>
                </c:pt>
              </c:numCache>
            </c:numRef>
          </c:val>
        </c:ser>
        <c:ser>
          <c:idx val="10"/>
          <c:order val="10"/>
          <c:tx>
            <c:strRef>
              <c:f>'cat-2(CB1112)_A1_0.02_5%'!$L$104</c:f>
              <c:strCache>
                <c:ptCount val="1"/>
                <c:pt idx="0">
                  <c:v>cat-2(CB1112)_A1_11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L$105:$L$125</c:f>
              <c:numCache>
                <c:formatCode>General</c:formatCode>
                <c:ptCount val="21"/>
                <c:pt idx="1">
                  <c:v>6.25E-2</c:v>
                </c:pt>
                <c:pt idx="2">
                  <c:v>8.7797619047619027E-2</c:v>
                </c:pt>
                <c:pt idx="3">
                  <c:v>9.5238095238095247E-2</c:v>
                </c:pt>
                <c:pt idx="4">
                  <c:v>0.13616071428571394</c:v>
                </c:pt>
                <c:pt idx="5">
                  <c:v>0.13020833333333307</c:v>
                </c:pt>
                <c:pt idx="6">
                  <c:v>9.4494047619047644E-2</c:v>
                </c:pt>
                <c:pt idx="7">
                  <c:v>6.6964285714285698E-2</c:v>
                </c:pt>
                <c:pt idx="8">
                  <c:v>4.6874999999999986E-2</c:v>
                </c:pt>
                <c:pt idx="9">
                  <c:v>5.2083333333333336E-2</c:v>
                </c:pt>
                <c:pt idx="10">
                  <c:v>5.2827380952381035E-2</c:v>
                </c:pt>
                <c:pt idx="11">
                  <c:v>3.4226190476190514E-2</c:v>
                </c:pt>
                <c:pt idx="12">
                  <c:v>2.23214285714286E-2</c:v>
                </c:pt>
                <c:pt idx="13">
                  <c:v>2.3065476190476199E-2</c:v>
                </c:pt>
                <c:pt idx="14">
                  <c:v>1.26488095238095E-2</c:v>
                </c:pt>
                <c:pt idx="15">
                  <c:v>8.1845238095238134E-3</c:v>
                </c:pt>
                <c:pt idx="16">
                  <c:v>8.1845238095238134E-3</c:v>
                </c:pt>
                <c:pt idx="17">
                  <c:v>5.2083333333333339E-3</c:v>
                </c:pt>
                <c:pt idx="18">
                  <c:v>5.9523809523809503E-3</c:v>
                </c:pt>
                <c:pt idx="19">
                  <c:v>2.9761904761904808E-3</c:v>
                </c:pt>
                <c:pt idx="20">
                  <c:v>2.2321428571428601E-3</c:v>
                </c:pt>
              </c:numCache>
            </c:numRef>
          </c:val>
        </c:ser>
        <c:ser>
          <c:idx val="11"/>
          <c:order val="11"/>
          <c:tx>
            <c:strRef>
              <c:f>'cat-2(CB1112)_A1_0.02_5%'!$M$104</c:f>
              <c:strCache>
                <c:ptCount val="1"/>
                <c:pt idx="0">
                  <c:v>cat-2(CB1112)_A1_12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M$105:$M$125</c:f>
              <c:numCache>
                <c:formatCode>General</c:formatCode>
                <c:ptCount val="21"/>
                <c:pt idx="1">
                  <c:v>5.4826254826254819E-2</c:v>
                </c:pt>
                <c:pt idx="2">
                  <c:v>7.0270270270270302E-2</c:v>
                </c:pt>
                <c:pt idx="3">
                  <c:v>9.6525096525096596E-2</c:v>
                </c:pt>
                <c:pt idx="4">
                  <c:v>0.12586872586872597</c:v>
                </c:pt>
                <c:pt idx="5">
                  <c:v>0.13436293436293406</c:v>
                </c:pt>
                <c:pt idx="6">
                  <c:v>0.10965250965251003</c:v>
                </c:pt>
                <c:pt idx="7">
                  <c:v>7.567567567567568E-2</c:v>
                </c:pt>
                <c:pt idx="8">
                  <c:v>3.24324324324324E-2</c:v>
                </c:pt>
                <c:pt idx="9">
                  <c:v>5.7142857142857099E-2</c:v>
                </c:pt>
                <c:pt idx="10">
                  <c:v>3.0888030888030899E-2</c:v>
                </c:pt>
                <c:pt idx="11">
                  <c:v>4.94208494208494E-2</c:v>
                </c:pt>
                <c:pt idx="12">
                  <c:v>3.9382239382239399E-2</c:v>
                </c:pt>
                <c:pt idx="13">
                  <c:v>2.2393822393822399E-2</c:v>
                </c:pt>
                <c:pt idx="14">
                  <c:v>1.7760617760617808E-2</c:v>
                </c:pt>
                <c:pt idx="15">
                  <c:v>1.31274131274131E-2</c:v>
                </c:pt>
                <c:pt idx="16">
                  <c:v>1.3899613899613901E-2</c:v>
                </c:pt>
                <c:pt idx="17">
                  <c:v>4.6332046332046338E-3</c:v>
                </c:pt>
                <c:pt idx="18">
                  <c:v>3.8610038610038602E-3</c:v>
                </c:pt>
                <c:pt idx="19">
                  <c:v>3.8610038610038602E-3</c:v>
                </c:pt>
                <c:pt idx="20">
                  <c:v>7.722007722007722E-4</c:v>
                </c:pt>
              </c:numCache>
            </c:numRef>
          </c:val>
        </c:ser>
        <c:ser>
          <c:idx val="12"/>
          <c:order val="12"/>
          <c:tx>
            <c:strRef>
              <c:f>'cat-2(CB1112)_A1_0.02_5%'!$N$104</c:f>
              <c:strCache>
                <c:ptCount val="1"/>
                <c:pt idx="0">
                  <c:v>cat-2(CB1112)_A1_13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N$105:$N$125</c:f>
              <c:numCache>
                <c:formatCode>General</c:formatCode>
                <c:ptCount val="21"/>
                <c:pt idx="1">
                  <c:v>7.0000000000000021E-2</c:v>
                </c:pt>
                <c:pt idx="2">
                  <c:v>9.8000000000000032E-2</c:v>
                </c:pt>
                <c:pt idx="3">
                  <c:v>0.12066666666666705</c:v>
                </c:pt>
                <c:pt idx="4">
                  <c:v>0.10666666666666705</c:v>
                </c:pt>
                <c:pt idx="5">
                  <c:v>0.17533333333333306</c:v>
                </c:pt>
                <c:pt idx="6">
                  <c:v>0.10466666666666703</c:v>
                </c:pt>
                <c:pt idx="7">
                  <c:v>3.8666666666666703E-2</c:v>
                </c:pt>
                <c:pt idx="8">
                  <c:v>3.6666666666666702E-2</c:v>
                </c:pt>
                <c:pt idx="9">
                  <c:v>4.0666666666666712E-2</c:v>
                </c:pt>
                <c:pt idx="10">
                  <c:v>3.4000000000000002E-2</c:v>
                </c:pt>
                <c:pt idx="11">
                  <c:v>2.9333333333333309E-2</c:v>
                </c:pt>
                <c:pt idx="12">
                  <c:v>2.8000000000000001E-2</c:v>
                </c:pt>
                <c:pt idx="13">
                  <c:v>2.0666666666666701E-2</c:v>
                </c:pt>
                <c:pt idx="14">
                  <c:v>1.7999999999999999E-2</c:v>
                </c:pt>
                <c:pt idx="15">
                  <c:v>1.0000000000000004E-2</c:v>
                </c:pt>
                <c:pt idx="16">
                  <c:v>5.333333333333334E-3</c:v>
                </c:pt>
                <c:pt idx="17">
                  <c:v>8.6666666666666767E-3</c:v>
                </c:pt>
                <c:pt idx="18">
                  <c:v>3.3333333333333309E-3</c:v>
                </c:pt>
                <c:pt idx="19">
                  <c:v>2.6666666666666709E-3</c:v>
                </c:pt>
                <c:pt idx="20">
                  <c:v>6.6666666666666719E-4</c:v>
                </c:pt>
              </c:numCache>
            </c:numRef>
          </c:val>
        </c:ser>
        <c:ser>
          <c:idx val="13"/>
          <c:order val="13"/>
          <c:tx>
            <c:strRef>
              <c:f>'cat-2(CB1112)_A1_0.02_5%'!$O$104</c:f>
              <c:strCache>
                <c:ptCount val="1"/>
                <c:pt idx="0">
                  <c:v>cat-2(CB1112)_A1_14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O$105:$O$125</c:f>
              <c:numCache>
                <c:formatCode>General</c:formatCode>
                <c:ptCount val="21"/>
                <c:pt idx="1">
                  <c:v>7.3262839879154107E-2</c:v>
                </c:pt>
                <c:pt idx="2">
                  <c:v>8.9879154078549905E-2</c:v>
                </c:pt>
                <c:pt idx="3">
                  <c:v>0.11631419939576995</c:v>
                </c:pt>
                <c:pt idx="4">
                  <c:v>0.11782477341389704</c:v>
                </c:pt>
                <c:pt idx="5">
                  <c:v>0.15558912386706911</c:v>
                </c:pt>
                <c:pt idx="6">
                  <c:v>8.5347432024169223E-2</c:v>
                </c:pt>
                <c:pt idx="7">
                  <c:v>4.0785498489426017E-2</c:v>
                </c:pt>
                <c:pt idx="8">
                  <c:v>4.9093655589123916E-2</c:v>
                </c:pt>
                <c:pt idx="9">
                  <c:v>5.2114803625377584E-2</c:v>
                </c:pt>
                <c:pt idx="10">
                  <c:v>4.3051359516616296E-2</c:v>
                </c:pt>
                <c:pt idx="11">
                  <c:v>3.09667673716012E-2</c:v>
                </c:pt>
                <c:pt idx="12">
                  <c:v>3.5498489425981897E-2</c:v>
                </c:pt>
                <c:pt idx="13">
                  <c:v>2.1148036253776398E-2</c:v>
                </c:pt>
                <c:pt idx="14">
                  <c:v>1.0574018126888199E-2</c:v>
                </c:pt>
                <c:pt idx="15">
                  <c:v>1.5861027190332309E-2</c:v>
                </c:pt>
                <c:pt idx="16">
                  <c:v>3.7764350453172216E-3</c:v>
                </c:pt>
                <c:pt idx="17">
                  <c:v>3.7764350453172216E-3</c:v>
                </c:pt>
                <c:pt idx="18">
                  <c:v>3.7764350453172216E-3</c:v>
                </c:pt>
                <c:pt idx="19">
                  <c:v>0</c:v>
                </c:pt>
                <c:pt idx="20">
                  <c:v>2.2658610271903312E-3</c:v>
                </c:pt>
              </c:numCache>
            </c:numRef>
          </c:val>
        </c:ser>
        <c:ser>
          <c:idx val="14"/>
          <c:order val="14"/>
          <c:tx>
            <c:strRef>
              <c:f>'cat-2(CB1112)_A1_0.02_5%'!$P$104</c:f>
              <c:strCache>
                <c:ptCount val="1"/>
                <c:pt idx="0">
                  <c:v>cat-2(CB1112)_A1_15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P$105:$P$125</c:f>
              <c:numCache>
                <c:formatCode>General</c:formatCode>
                <c:ptCount val="21"/>
                <c:pt idx="1">
                  <c:v>6.3199473337722231E-2</c:v>
                </c:pt>
                <c:pt idx="2">
                  <c:v>0.106649111257406</c:v>
                </c:pt>
                <c:pt idx="3">
                  <c:v>0.12376563528637305</c:v>
                </c:pt>
                <c:pt idx="4">
                  <c:v>0.12179065174456906</c:v>
                </c:pt>
                <c:pt idx="5">
                  <c:v>0.14944042132982208</c:v>
                </c:pt>
                <c:pt idx="6">
                  <c:v>9.0849242922975582E-2</c:v>
                </c:pt>
                <c:pt idx="7">
                  <c:v>5.5957867017774887E-2</c:v>
                </c:pt>
                <c:pt idx="8">
                  <c:v>3.6866359447004601E-2</c:v>
                </c:pt>
                <c:pt idx="9">
                  <c:v>5.4641211323239014E-2</c:v>
                </c:pt>
                <c:pt idx="10">
                  <c:v>3.55497037524687E-2</c:v>
                </c:pt>
                <c:pt idx="11">
                  <c:v>3.094140882159321E-2</c:v>
                </c:pt>
                <c:pt idx="12">
                  <c:v>1.9749835418038215E-2</c:v>
                </c:pt>
                <c:pt idx="13">
                  <c:v>1.9749835418038215E-2</c:v>
                </c:pt>
                <c:pt idx="14">
                  <c:v>1.1849901250822904E-2</c:v>
                </c:pt>
                <c:pt idx="15">
                  <c:v>1.0533245556286996E-2</c:v>
                </c:pt>
                <c:pt idx="16">
                  <c:v>9.2165898617511503E-3</c:v>
                </c:pt>
                <c:pt idx="17">
                  <c:v>3.9499670836076412E-3</c:v>
                </c:pt>
                <c:pt idx="18">
                  <c:v>1.9749835418038219E-3</c:v>
                </c:pt>
                <c:pt idx="19">
                  <c:v>1.9749835418038219E-3</c:v>
                </c:pt>
                <c:pt idx="20">
                  <c:v>3.2916392363397007E-3</c:v>
                </c:pt>
              </c:numCache>
            </c:numRef>
          </c:val>
        </c:ser>
        <c:ser>
          <c:idx val="15"/>
          <c:order val="15"/>
          <c:tx>
            <c:strRef>
              <c:f>'cat-2(CB1112)_A1_0.02_5%'!$Q$104</c:f>
              <c:strCache>
                <c:ptCount val="1"/>
                <c:pt idx="0">
                  <c:v>cat-2(CB1112)_A1_16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Q$105:$Q$125</c:f>
              <c:numCache>
                <c:formatCode>General</c:formatCode>
                <c:ptCount val="21"/>
                <c:pt idx="1">
                  <c:v>6.3E-2</c:v>
                </c:pt>
                <c:pt idx="2">
                  <c:v>8.5000000000000006E-2</c:v>
                </c:pt>
                <c:pt idx="3">
                  <c:v>0.10500000000000002</c:v>
                </c:pt>
                <c:pt idx="4">
                  <c:v>0.12200000000000003</c:v>
                </c:pt>
                <c:pt idx="5">
                  <c:v>0.16500000000000001</c:v>
                </c:pt>
                <c:pt idx="6">
                  <c:v>0.12300000000000003</c:v>
                </c:pt>
                <c:pt idx="7">
                  <c:v>4.2000000000000016E-2</c:v>
                </c:pt>
                <c:pt idx="8">
                  <c:v>4.9000000000000016E-2</c:v>
                </c:pt>
                <c:pt idx="9">
                  <c:v>4.8000000000000001E-2</c:v>
                </c:pt>
                <c:pt idx="10">
                  <c:v>4.5999999999999999E-2</c:v>
                </c:pt>
                <c:pt idx="11">
                  <c:v>3.3000000000000002E-2</c:v>
                </c:pt>
                <c:pt idx="12">
                  <c:v>2.1999999999999999E-2</c:v>
                </c:pt>
                <c:pt idx="13">
                  <c:v>2.3E-2</c:v>
                </c:pt>
                <c:pt idx="14">
                  <c:v>9.0000000000000028E-3</c:v>
                </c:pt>
                <c:pt idx="15">
                  <c:v>8.0000000000000054E-3</c:v>
                </c:pt>
                <c:pt idx="16">
                  <c:v>1.0000000000000004E-2</c:v>
                </c:pt>
                <c:pt idx="17">
                  <c:v>5.0000000000000018E-3</c:v>
                </c:pt>
                <c:pt idx="18">
                  <c:v>4.0000000000000018E-3</c:v>
                </c:pt>
                <c:pt idx="19">
                  <c:v>5.0000000000000018E-3</c:v>
                </c:pt>
                <c:pt idx="20">
                  <c:v>2.0000000000000009E-3</c:v>
                </c:pt>
              </c:numCache>
            </c:numRef>
          </c:val>
        </c:ser>
        <c:ser>
          <c:idx val="16"/>
          <c:order val="16"/>
          <c:tx>
            <c:strRef>
              <c:f>'cat-2(CB1112)_A1_0.02_5%'!$R$104</c:f>
              <c:strCache>
                <c:ptCount val="1"/>
                <c:pt idx="0">
                  <c:v>cat-2(CB1112)_A1_17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R$105:$R$125</c:f>
              <c:numCache>
                <c:formatCode>General</c:formatCode>
                <c:ptCount val="21"/>
                <c:pt idx="1">
                  <c:v>8.4162203519510301E-2</c:v>
                </c:pt>
                <c:pt idx="2">
                  <c:v>9.7169089517980103E-2</c:v>
                </c:pt>
                <c:pt idx="3">
                  <c:v>0.127008416220352</c:v>
                </c:pt>
                <c:pt idx="4">
                  <c:v>0.15761285386380999</c:v>
                </c:pt>
                <c:pt idx="5">
                  <c:v>0.14154552410099505</c:v>
                </c:pt>
                <c:pt idx="6">
                  <c:v>6.27390971690895E-2</c:v>
                </c:pt>
                <c:pt idx="7">
                  <c:v>5.5853098699311404E-2</c:v>
                </c:pt>
                <c:pt idx="8">
                  <c:v>5.3557765876051995E-2</c:v>
                </c:pt>
                <c:pt idx="9">
                  <c:v>3.2899770466717722E-2</c:v>
                </c:pt>
                <c:pt idx="10">
                  <c:v>3.9020657995409297E-2</c:v>
                </c:pt>
                <c:pt idx="11">
                  <c:v>2.295332823259371E-2</c:v>
                </c:pt>
                <c:pt idx="12">
                  <c:v>1.6067329762815611E-2</c:v>
                </c:pt>
                <c:pt idx="13">
                  <c:v>1.4537107880642698E-2</c:v>
                </c:pt>
                <c:pt idx="14">
                  <c:v>3.8255547054322912E-3</c:v>
                </c:pt>
                <c:pt idx="15">
                  <c:v>9.9464422341239579E-3</c:v>
                </c:pt>
                <c:pt idx="16">
                  <c:v>6.8859984697781235E-3</c:v>
                </c:pt>
                <c:pt idx="17">
                  <c:v>6.1208875286916601E-3</c:v>
                </c:pt>
                <c:pt idx="18">
                  <c:v>3.8255547054322912E-3</c:v>
                </c:pt>
                <c:pt idx="19">
                  <c:v>1.53022188217292E-3</c:v>
                </c:pt>
                <c:pt idx="20">
                  <c:v>1.53022188217292E-3</c:v>
                </c:pt>
              </c:numCache>
            </c:numRef>
          </c:val>
        </c:ser>
        <c:ser>
          <c:idx val="17"/>
          <c:order val="17"/>
          <c:tx>
            <c:strRef>
              <c:f>'cat-2(CB1112)_A1_0.02_5%'!$S$104</c:f>
              <c:strCache>
                <c:ptCount val="1"/>
                <c:pt idx="0">
                  <c:v>cat-2(CB1112)_A1_18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S$105:$S$125</c:f>
              <c:numCache>
                <c:formatCode>General</c:formatCode>
                <c:ptCount val="21"/>
                <c:pt idx="1">
                  <c:v>7.3446327683615809E-2</c:v>
                </c:pt>
                <c:pt idx="2">
                  <c:v>7.2033898305084706E-2</c:v>
                </c:pt>
                <c:pt idx="3">
                  <c:v>9.8870056497175132E-2</c:v>
                </c:pt>
                <c:pt idx="4">
                  <c:v>0.10310734463276795</c:v>
                </c:pt>
                <c:pt idx="5">
                  <c:v>0.14759887005649708</c:v>
                </c:pt>
                <c:pt idx="6">
                  <c:v>0.10310734463276795</c:v>
                </c:pt>
                <c:pt idx="7">
                  <c:v>7.2033898305084706E-2</c:v>
                </c:pt>
                <c:pt idx="8">
                  <c:v>3.8841807909604523E-2</c:v>
                </c:pt>
                <c:pt idx="9">
                  <c:v>4.2372881355932236E-2</c:v>
                </c:pt>
                <c:pt idx="10">
                  <c:v>5.2966101694915321E-2</c:v>
                </c:pt>
                <c:pt idx="11">
                  <c:v>3.7429378531073428E-2</c:v>
                </c:pt>
                <c:pt idx="12">
                  <c:v>3.1073446327683614E-2</c:v>
                </c:pt>
                <c:pt idx="13">
                  <c:v>2.3305084745762684E-2</c:v>
                </c:pt>
                <c:pt idx="14">
                  <c:v>2.0480225988700609E-2</c:v>
                </c:pt>
                <c:pt idx="15">
                  <c:v>1.4830508474576299E-2</c:v>
                </c:pt>
                <c:pt idx="16">
                  <c:v>1.20056497175141E-2</c:v>
                </c:pt>
                <c:pt idx="17">
                  <c:v>7.0621468926553715E-3</c:v>
                </c:pt>
                <c:pt idx="18">
                  <c:v>2.118644067796611E-3</c:v>
                </c:pt>
                <c:pt idx="19">
                  <c:v>1.41242937853107E-3</c:v>
                </c:pt>
                <c:pt idx="20">
                  <c:v>1.41242937853107E-3</c:v>
                </c:pt>
              </c:numCache>
            </c:numRef>
          </c:val>
        </c:ser>
        <c:ser>
          <c:idx val="18"/>
          <c:order val="18"/>
          <c:tx>
            <c:strRef>
              <c:f>'cat-2(CB1112)_A1_0.02_5%'!$T$104</c:f>
              <c:strCache>
                <c:ptCount val="1"/>
                <c:pt idx="0">
                  <c:v>cat-2(CB1112)_A1_19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T$105:$T$125</c:f>
              <c:numCache>
                <c:formatCode>General</c:formatCode>
                <c:ptCount val="21"/>
                <c:pt idx="1">
                  <c:v>5.3879310344827597E-2</c:v>
                </c:pt>
                <c:pt idx="2">
                  <c:v>8.1896551724137928E-2</c:v>
                </c:pt>
                <c:pt idx="3">
                  <c:v>0.13290229885057506</c:v>
                </c:pt>
                <c:pt idx="4">
                  <c:v>0.11853448275862104</c:v>
                </c:pt>
                <c:pt idx="5">
                  <c:v>0.15301724137931011</c:v>
                </c:pt>
                <c:pt idx="6">
                  <c:v>0.10344827586206902</c:v>
                </c:pt>
                <c:pt idx="7">
                  <c:v>5.3160919540229903E-2</c:v>
                </c:pt>
                <c:pt idx="8">
                  <c:v>3.5919540229885097E-2</c:v>
                </c:pt>
                <c:pt idx="9">
                  <c:v>4.3821839080459779E-2</c:v>
                </c:pt>
                <c:pt idx="10">
                  <c:v>4.8850574712643716E-2</c:v>
                </c:pt>
                <c:pt idx="11">
                  <c:v>2.8017241379310314E-2</c:v>
                </c:pt>
                <c:pt idx="12">
                  <c:v>3.2327586206896589E-2</c:v>
                </c:pt>
                <c:pt idx="13">
                  <c:v>1.79597701149425E-2</c:v>
                </c:pt>
                <c:pt idx="14">
                  <c:v>1.86781609195402E-2</c:v>
                </c:pt>
                <c:pt idx="15">
                  <c:v>1.0775862068965504E-2</c:v>
                </c:pt>
                <c:pt idx="16">
                  <c:v>1.1494252873563199E-2</c:v>
                </c:pt>
                <c:pt idx="17">
                  <c:v>8.6206896551724154E-3</c:v>
                </c:pt>
                <c:pt idx="18">
                  <c:v>1.4367816091954001E-3</c:v>
                </c:pt>
                <c:pt idx="19">
                  <c:v>7.1839080459770125E-4</c:v>
                </c:pt>
                <c:pt idx="20">
                  <c:v>7.1839080459770125E-4</c:v>
                </c:pt>
              </c:numCache>
            </c:numRef>
          </c:val>
        </c:ser>
        <c:ser>
          <c:idx val="19"/>
          <c:order val="19"/>
          <c:tx>
            <c:strRef>
              <c:f>'cat-2(CB1112)_A1_0.02_5%'!$U$104</c:f>
              <c:strCache>
                <c:ptCount val="1"/>
                <c:pt idx="0">
                  <c:v>cat-2(CB1112)_A1_20</c:v>
                </c:pt>
              </c:strCache>
            </c:strRef>
          </c:tx>
          <c:marker>
            <c:symbol val="none"/>
          </c:marker>
          <c:cat>
            <c:numRef>
              <c:f>'cat-2(CB1112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2(CB1112)_A1_0.02_5%'!$U$105:$U$125</c:f>
              <c:numCache>
                <c:formatCode>General</c:formatCode>
                <c:ptCount val="21"/>
                <c:pt idx="1">
                  <c:v>4.8799380325329211E-2</c:v>
                </c:pt>
                <c:pt idx="2">
                  <c:v>9.0627420604182871E-2</c:v>
                </c:pt>
                <c:pt idx="3">
                  <c:v>8.8303640588690974E-2</c:v>
                </c:pt>
                <c:pt idx="4">
                  <c:v>0.10147172734314502</c:v>
                </c:pt>
                <c:pt idx="5">
                  <c:v>0.12625871417505793</c:v>
                </c:pt>
                <c:pt idx="6">
                  <c:v>0.11928737412858199</c:v>
                </c:pt>
                <c:pt idx="7">
                  <c:v>6.429124709527502E-2</c:v>
                </c:pt>
                <c:pt idx="8">
                  <c:v>3.7955073586367218E-2</c:v>
                </c:pt>
                <c:pt idx="9">
                  <c:v>5.0348567002323819E-2</c:v>
                </c:pt>
                <c:pt idx="10">
                  <c:v>6.7389620449264123E-2</c:v>
                </c:pt>
                <c:pt idx="11">
                  <c:v>3.2532920216886099E-2</c:v>
                </c:pt>
                <c:pt idx="12">
                  <c:v>2.8659953524399713E-2</c:v>
                </c:pt>
                <c:pt idx="13">
                  <c:v>3.0983733539891607E-2</c:v>
                </c:pt>
                <c:pt idx="14">
                  <c:v>2.0914020139426798E-2</c:v>
                </c:pt>
                <c:pt idx="15">
                  <c:v>2.4786986831913198E-2</c:v>
                </c:pt>
                <c:pt idx="16">
                  <c:v>1.3168086754453899E-2</c:v>
                </c:pt>
                <c:pt idx="17">
                  <c:v>3.8729666924864408E-3</c:v>
                </c:pt>
                <c:pt idx="18">
                  <c:v>1.5491866769945801E-3</c:v>
                </c:pt>
                <c:pt idx="19">
                  <c:v>2.3237800154918709E-3</c:v>
                </c:pt>
                <c:pt idx="20">
                  <c:v>3.0983733539891602E-3</c:v>
                </c:pt>
              </c:numCache>
            </c:numRef>
          </c:val>
        </c:ser>
        <c:marker val="1"/>
        <c:axId val="160305536"/>
        <c:axId val="160307072"/>
      </c:lineChart>
      <c:catAx>
        <c:axId val="160305536"/>
        <c:scaling>
          <c:orientation val="minMax"/>
        </c:scaling>
        <c:axPos val="b"/>
        <c:numFmt formatCode="0.0_ " sourceLinked="1"/>
        <c:tickLblPos val="nextTo"/>
        <c:crossAx val="160307072"/>
        <c:crosses val="autoZero"/>
        <c:auto val="1"/>
        <c:lblAlgn val="ctr"/>
        <c:lblOffset val="100"/>
        <c:tickLblSkip val="5"/>
        <c:tickMarkSkip val="5"/>
      </c:catAx>
      <c:valAx>
        <c:axId val="16030707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0305536"/>
        <c:crosses val="autoZero"/>
        <c:crossBetween val="between"/>
      </c:valAx>
    </c:plotArea>
    <c:plotVisOnly val="1"/>
  </c:chart>
  <c:externalData r:id="rId1"/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1</a:t>
            </a:r>
            <a:r>
              <a:rPr lang="en-US" altLang="ja-JP" sz="1400" b="0" baseline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1(CB1111)_A5_0.02_5%'!$B$104</c:f>
              <c:strCache>
                <c:ptCount val="1"/>
                <c:pt idx="0">
                  <c:v>cat-1(CB1111)_A5_01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B$105:$B$125</c:f>
              <c:numCache>
                <c:formatCode>General</c:formatCode>
                <c:ptCount val="21"/>
                <c:pt idx="1">
                  <c:v>0.125</c:v>
                </c:pt>
                <c:pt idx="2">
                  <c:v>0.10416666666666703</c:v>
                </c:pt>
                <c:pt idx="3">
                  <c:v>0.10416666666666703</c:v>
                </c:pt>
                <c:pt idx="4">
                  <c:v>8.3333333333333329E-2</c:v>
                </c:pt>
                <c:pt idx="5">
                  <c:v>2.0833333333333311E-2</c:v>
                </c:pt>
                <c:pt idx="6">
                  <c:v>6.25E-2</c:v>
                </c:pt>
                <c:pt idx="7">
                  <c:v>0</c:v>
                </c:pt>
                <c:pt idx="8">
                  <c:v>2.0833333333333311E-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.0833333333333311E-2</c:v>
                </c:pt>
                <c:pt idx="16">
                  <c:v>2.0833333333333311E-2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"/>
          <c:order val="1"/>
          <c:tx>
            <c:strRef>
              <c:f>'cat-1(CB1111)_A5_0.02_5%'!$C$104</c:f>
              <c:strCache>
                <c:ptCount val="1"/>
                <c:pt idx="0">
                  <c:v>cat-1(CB1111)_A5_02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C$105:$C$125</c:f>
              <c:numCache>
                <c:formatCode>General</c:formatCode>
                <c:ptCount val="21"/>
                <c:pt idx="1">
                  <c:v>0.10857142857142905</c:v>
                </c:pt>
                <c:pt idx="2">
                  <c:v>0.11428571428571403</c:v>
                </c:pt>
                <c:pt idx="3">
                  <c:v>9.1428571428571401E-2</c:v>
                </c:pt>
                <c:pt idx="4">
                  <c:v>9.1428571428571401E-2</c:v>
                </c:pt>
                <c:pt idx="5">
                  <c:v>5.14285714285714E-2</c:v>
                </c:pt>
                <c:pt idx="6">
                  <c:v>7.4285714285714302E-2</c:v>
                </c:pt>
                <c:pt idx="7">
                  <c:v>5.7142857142857099E-2</c:v>
                </c:pt>
                <c:pt idx="8">
                  <c:v>3.4285714285714322E-2</c:v>
                </c:pt>
                <c:pt idx="9">
                  <c:v>1.7142857142857109E-2</c:v>
                </c:pt>
                <c:pt idx="10">
                  <c:v>1.7142857142857109E-2</c:v>
                </c:pt>
                <c:pt idx="11">
                  <c:v>3.4285714285714322E-2</c:v>
                </c:pt>
                <c:pt idx="12">
                  <c:v>1.7142857142857109E-2</c:v>
                </c:pt>
                <c:pt idx="13">
                  <c:v>1.7142857142857109E-2</c:v>
                </c:pt>
                <c:pt idx="14">
                  <c:v>1.7142857142857109E-2</c:v>
                </c:pt>
                <c:pt idx="15">
                  <c:v>5.7142857142857099E-3</c:v>
                </c:pt>
                <c:pt idx="16">
                  <c:v>5.7142857142857099E-3</c:v>
                </c:pt>
                <c:pt idx="17">
                  <c:v>5.7142857142857099E-3</c:v>
                </c:pt>
                <c:pt idx="18">
                  <c:v>5.7142857142857099E-3</c:v>
                </c:pt>
                <c:pt idx="19">
                  <c:v>1.1428571428571404E-2</c:v>
                </c:pt>
                <c:pt idx="20">
                  <c:v>0</c:v>
                </c:pt>
              </c:numCache>
            </c:numRef>
          </c:val>
        </c:ser>
        <c:ser>
          <c:idx val="2"/>
          <c:order val="2"/>
          <c:tx>
            <c:strRef>
              <c:f>'cat-1(CB1111)_A5_0.02_5%'!$D$104</c:f>
              <c:strCache>
                <c:ptCount val="1"/>
                <c:pt idx="0">
                  <c:v>cat-1(CB1111)_A5_03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D$105:$D$125</c:f>
              <c:numCache>
                <c:formatCode>General</c:formatCode>
                <c:ptCount val="21"/>
                <c:pt idx="1">
                  <c:v>8.1560283687943283E-2</c:v>
                </c:pt>
                <c:pt idx="2">
                  <c:v>0.10283687943262403</c:v>
                </c:pt>
                <c:pt idx="3">
                  <c:v>0.10283687943262403</c:v>
                </c:pt>
                <c:pt idx="4">
                  <c:v>0.12174940898345203</c:v>
                </c:pt>
                <c:pt idx="5">
                  <c:v>0.124113475177305</c:v>
                </c:pt>
                <c:pt idx="6">
                  <c:v>8.2742316784870026E-2</c:v>
                </c:pt>
                <c:pt idx="7">
                  <c:v>4.2553191489361715E-2</c:v>
                </c:pt>
                <c:pt idx="8">
                  <c:v>4.3735224586288417E-2</c:v>
                </c:pt>
                <c:pt idx="9">
                  <c:v>5.0827423167848731E-2</c:v>
                </c:pt>
                <c:pt idx="10">
                  <c:v>2.4822695035460998E-2</c:v>
                </c:pt>
                <c:pt idx="11">
                  <c:v>2.7186761229314408E-2</c:v>
                </c:pt>
                <c:pt idx="12">
                  <c:v>2.7186761229314408E-2</c:v>
                </c:pt>
                <c:pt idx="13">
                  <c:v>1.77304964539007E-2</c:v>
                </c:pt>
                <c:pt idx="14">
                  <c:v>2.3640661938534285E-2</c:v>
                </c:pt>
                <c:pt idx="15">
                  <c:v>1.4184397163120598E-2</c:v>
                </c:pt>
                <c:pt idx="16">
                  <c:v>1.30023640661939E-2</c:v>
                </c:pt>
                <c:pt idx="17">
                  <c:v>7.0921985815602818E-3</c:v>
                </c:pt>
                <c:pt idx="18">
                  <c:v>1.182033096926711E-2</c:v>
                </c:pt>
                <c:pt idx="19">
                  <c:v>1.1820330969267109E-3</c:v>
                </c:pt>
                <c:pt idx="20">
                  <c:v>7.0921985815602818E-3</c:v>
                </c:pt>
              </c:numCache>
            </c:numRef>
          </c:val>
        </c:ser>
        <c:ser>
          <c:idx val="3"/>
          <c:order val="3"/>
          <c:tx>
            <c:strRef>
              <c:f>'cat-1(CB1111)_A5_0.02_5%'!$E$104</c:f>
              <c:strCache>
                <c:ptCount val="1"/>
                <c:pt idx="0">
                  <c:v>cat-1(CB1111)_A5_04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E$105:$E$125</c:f>
              <c:numCache>
                <c:formatCode>General</c:formatCode>
                <c:ptCount val="21"/>
                <c:pt idx="1">
                  <c:v>8.1920903954802352E-2</c:v>
                </c:pt>
                <c:pt idx="2">
                  <c:v>0.14265536723163794</c:v>
                </c:pt>
                <c:pt idx="3">
                  <c:v>0.13276836158192115</c:v>
                </c:pt>
                <c:pt idx="4">
                  <c:v>0.12853107344632805</c:v>
                </c:pt>
                <c:pt idx="5">
                  <c:v>0.11581920903954797</c:v>
                </c:pt>
                <c:pt idx="6">
                  <c:v>9.4632768361581951E-2</c:v>
                </c:pt>
                <c:pt idx="7">
                  <c:v>4.5197740112994399E-2</c:v>
                </c:pt>
                <c:pt idx="8">
                  <c:v>4.6610169491525397E-2</c:v>
                </c:pt>
                <c:pt idx="9">
                  <c:v>3.3898305084745811E-2</c:v>
                </c:pt>
                <c:pt idx="10">
                  <c:v>1.9774011299435009E-2</c:v>
                </c:pt>
                <c:pt idx="11">
                  <c:v>2.542372881355931E-2</c:v>
                </c:pt>
                <c:pt idx="12">
                  <c:v>1.6949152542372906E-2</c:v>
                </c:pt>
                <c:pt idx="13">
                  <c:v>1.27118644067797E-2</c:v>
                </c:pt>
                <c:pt idx="14">
                  <c:v>1.12994350282486E-2</c:v>
                </c:pt>
                <c:pt idx="15">
                  <c:v>2.8248587570621512E-3</c:v>
                </c:pt>
                <c:pt idx="16">
                  <c:v>4.2372881355932238E-3</c:v>
                </c:pt>
                <c:pt idx="17">
                  <c:v>0</c:v>
                </c:pt>
                <c:pt idx="18">
                  <c:v>1.41242937853107E-3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4"/>
          <c:order val="4"/>
          <c:tx>
            <c:strRef>
              <c:f>'cat-1(CB1111)_A5_0.02_5%'!$F$104</c:f>
              <c:strCache>
                <c:ptCount val="1"/>
                <c:pt idx="0">
                  <c:v>cat-1(CB1111)_A5_05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F$105:$F$125</c:f>
              <c:numCache>
                <c:formatCode>General</c:formatCode>
                <c:ptCount val="21"/>
                <c:pt idx="1">
                  <c:v>7.0520231213872811E-2</c:v>
                </c:pt>
                <c:pt idx="2">
                  <c:v>9.7109826589595397E-2</c:v>
                </c:pt>
                <c:pt idx="3">
                  <c:v>0.10173410404624306</c:v>
                </c:pt>
                <c:pt idx="4">
                  <c:v>0.10289017341040503</c:v>
                </c:pt>
                <c:pt idx="5">
                  <c:v>0.10867052023121408</c:v>
                </c:pt>
                <c:pt idx="6">
                  <c:v>8.2080924855491275E-2</c:v>
                </c:pt>
                <c:pt idx="7">
                  <c:v>7.6300578034682098E-2</c:v>
                </c:pt>
                <c:pt idx="8">
                  <c:v>5.3179190751445095E-2</c:v>
                </c:pt>
                <c:pt idx="9">
                  <c:v>4.9710982658959513E-2</c:v>
                </c:pt>
                <c:pt idx="10">
                  <c:v>5.2023121387283211E-2</c:v>
                </c:pt>
                <c:pt idx="11">
                  <c:v>2.0809248554913323E-2</c:v>
                </c:pt>
                <c:pt idx="12">
                  <c:v>2.0809248554913323E-2</c:v>
                </c:pt>
                <c:pt idx="13">
                  <c:v>2.5433526011560705E-2</c:v>
                </c:pt>
                <c:pt idx="14">
                  <c:v>1.3872832369942205E-2</c:v>
                </c:pt>
                <c:pt idx="15">
                  <c:v>1.0404624277456601E-2</c:v>
                </c:pt>
                <c:pt idx="16">
                  <c:v>8.0924855491329578E-3</c:v>
                </c:pt>
                <c:pt idx="17">
                  <c:v>9.2485549132948E-3</c:v>
                </c:pt>
                <c:pt idx="18">
                  <c:v>4.6242774566473983E-3</c:v>
                </c:pt>
                <c:pt idx="19">
                  <c:v>3.4682080924855509E-3</c:v>
                </c:pt>
                <c:pt idx="20">
                  <c:v>3.4682080924855509E-3</c:v>
                </c:pt>
              </c:numCache>
            </c:numRef>
          </c:val>
        </c:ser>
        <c:ser>
          <c:idx val="5"/>
          <c:order val="5"/>
          <c:tx>
            <c:strRef>
              <c:f>'cat-1(CB1111)_A5_0.02_5%'!$G$104</c:f>
              <c:strCache>
                <c:ptCount val="1"/>
                <c:pt idx="0">
                  <c:v>cat-1(CB1111)_A5_06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G$105:$G$125</c:f>
              <c:numCache>
                <c:formatCode>General</c:formatCode>
                <c:ptCount val="21"/>
                <c:pt idx="1">
                  <c:v>0.10648148148148104</c:v>
                </c:pt>
                <c:pt idx="2">
                  <c:v>0.13541666666666699</c:v>
                </c:pt>
                <c:pt idx="3">
                  <c:v>0.16898148148148115</c:v>
                </c:pt>
                <c:pt idx="4">
                  <c:v>0.13888888888888901</c:v>
                </c:pt>
                <c:pt idx="5">
                  <c:v>0.116898148148148</c:v>
                </c:pt>
                <c:pt idx="6">
                  <c:v>7.7546296296296321E-2</c:v>
                </c:pt>
                <c:pt idx="7">
                  <c:v>5.4398148148148119E-2</c:v>
                </c:pt>
                <c:pt idx="8">
                  <c:v>3.125E-2</c:v>
                </c:pt>
                <c:pt idx="9">
                  <c:v>2.6620370370370409E-2</c:v>
                </c:pt>
                <c:pt idx="10">
                  <c:v>2.0833333333333311E-2</c:v>
                </c:pt>
                <c:pt idx="11">
                  <c:v>1.0416666666666699E-2</c:v>
                </c:pt>
                <c:pt idx="12">
                  <c:v>8.1018518518518497E-3</c:v>
                </c:pt>
                <c:pt idx="13">
                  <c:v>4.629629629629632E-3</c:v>
                </c:pt>
                <c:pt idx="14">
                  <c:v>5.7870370370370402E-3</c:v>
                </c:pt>
                <c:pt idx="15">
                  <c:v>2.314814814814809E-3</c:v>
                </c:pt>
                <c:pt idx="16">
                  <c:v>2.314814814814809E-3</c:v>
                </c:pt>
                <c:pt idx="17">
                  <c:v>0</c:v>
                </c:pt>
                <c:pt idx="18">
                  <c:v>3.4722222222222207E-3</c:v>
                </c:pt>
                <c:pt idx="19">
                  <c:v>0</c:v>
                </c:pt>
                <c:pt idx="20">
                  <c:v>2.314814814814809E-3</c:v>
                </c:pt>
              </c:numCache>
            </c:numRef>
          </c:val>
        </c:ser>
        <c:ser>
          <c:idx val="6"/>
          <c:order val="6"/>
          <c:tx>
            <c:strRef>
              <c:f>'cat-1(CB1111)_A5_0.02_5%'!$H$104</c:f>
              <c:strCache>
                <c:ptCount val="1"/>
                <c:pt idx="0">
                  <c:v>cat-1(CB1111)_A5_07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H$105:$H$125</c:f>
              <c:numCache>
                <c:formatCode>General</c:formatCode>
                <c:ptCount val="21"/>
                <c:pt idx="1">
                  <c:v>0.15151515151515207</c:v>
                </c:pt>
                <c:pt idx="2">
                  <c:v>0.10606060606060604</c:v>
                </c:pt>
                <c:pt idx="3">
                  <c:v>0.12121212121212104</c:v>
                </c:pt>
                <c:pt idx="4">
                  <c:v>6.0606060606060601E-2</c:v>
                </c:pt>
                <c:pt idx="5">
                  <c:v>4.5454545454545497E-2</c:v>
                </c:pt>
                <c:pt idx="6">
                  <c:v>7.5757575757575801E-2</c:v>
                </c:pt>
                <c:pt idx="7">
                  <c:v>3.03030303030303E-2</c:v>
                </c:pt>
                <c:pt idx="8">
                  <c:v>3.03030303030303E-2</c:v>
                </c:pt>
                <c:pt idx="9">
                  <c:v>1.5151515151515204E-2</c:v>
                </c:pt>
                <c:pt idx="10">
                  <c:v>1.5151515151515204E-2</c:v>
                </c:pt>
                <c:pt idx="11">
                  <c:v>0</c:v>
                </c:pt>
                <c:pt idx="12">
                  <c:v>1.5151515151515204E-2</c:v>
                </c:pt>
                <c:pt idx="13">
                  <c:v>0</c:v>
                </c:pt>
                <c:pt idx="14">
                  <c:v>1.5151515151515204E-2</c:v>
                </c:pt>
                <c:pt idx="15">
                  <c:v>0</c:v>
                </c:pt>
                <c:pt idx="16">
                  <c:v>1.5151515151515204E-2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7"/>
          <c:order val="7"/>
          <c:tx>
            <c:strRef>
              <c:f>'cat-1(CB1111)_A5_0.02_5%'!$I$104</c:f>
              <c:strCache>
                <c:ptCount val="1"/>
                <c:pt idx="0">
                  <c:v>cat-1(CB1111)_A5_08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I$105:$I$125</c:f>
              <c:numCache>
                <c:formatCode>General</c:formatCode>
                <c:ptCount val="21"/>
                <c:pt idx="1">
                  <c:v>0.11634349030470896</c:v>
                </c:pt>
                <c:pt idx="2">
                  <c:v>0.11080332409972295</c:v>
                </c:pt>
                <c:pt idx="3">
                  <c:v>0.12465373961218799</c:v>
                </c:pt>
                <c:pt idx="4">
                  <c:v>0.11911357340720204</c:v>
                </c:pt>
                <c:pt idx="5">
                  <c:v>6.9252077562326902E-2</c:v>
                </c:pt>
                <c:pt idx="6">
                  <c:v>4.9861495844875335E-2</c:v>
                </c:pt>
                <c:pt idx="7">
                  <c:v>4.1551246537396086E-2</c:v>
                </c:pt>
                <c:pt idx="8">
                  <c:v>3.6011080332410003E-2</c:v>
                </c:pt>
                <c:pt idx="9">
                  <c:v>1.3850415512465405E-2</c:v>
                </c:pt>
                <c:pt idx="10">
                  <c:v>2.2160664819944598E-2</c:v>
                </c:pt>
                <c:pt idx="11">
                  <c:v>2.2160664819944598E-2</c:v>
                </c:pt>
                <c:pt idx="12">
                  <c:v>1.3850415512465405E-2</c:v>
                </c:pt>
                <c:pt idx="13">
                  <c:v>2.7700831024930699E-2</c:v>
                </c:pt>
                <c:pt idx="14">
                  <c:v>2.7700831024930709E-3</c:v>
                </c:pt>
                <c:pt idx="15">
                  <c:v>8.3102493074792266E-3</c:v>
                </c:pt>
                <c:pt idx="16">
                  <c:v>1.1080332409972301E-2</c:v>
                </c:pt>
                <c:pt idx="17">
                  <c:v>5.5401662049861522E-3</c:v>
                </c:pt>
                <c:pt idx="18">
                  <c:v>0</c:v>
                </c:pt>
                <c:pt idx="19">
                  <c:v>5.5401662049861522E-3</c:v>
                </c:pt>
                <c:pt idx="20">
                  <c:v>2.7700831024930709E-3</c:v>
                </c:pt>
              </c:numCache>
            </c:numRef>
          </c:val>
        </c:ser>
        <c:ser>
          <c:idx val="8"/>
          <c:order val="8"/>
          <c:tx>
            <c:strRef>
              <c:f>'cat-1(CB1111)_A5_0.02_5%'!$J$104</c:f>
              <c:strCache>
                <c:ptCount val="1"/>
                <c:pt idx="0">
                  <c:v>cat-1(CB1111)_A5_10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J$105:$J$125</c:f>
              <c:numCache>
                <c:formatCode>General</c:formatCode>
                <c:ptCount val="21"/>
                <c:pt idx="1">
                  <c:v>6.5476190476190493E-2</c:v>
                </c:pt>
                <c:pt idx="2">
                  <c:v>8.7797619047619027E-2</c:v>
                </c:pt>
                <c:pt idx="3">
                  <c:v>8.3333333333333329E-2</c:v>
                </c:pt>
                <c:pt idx="4">
                  <c:v>0.11011904761904796</c:v>
                </c:pt>
                <c:pt idx="5">
                  <c:v>0.11607142857142905</c:v>
                </c:pt>
                <c:pt idx="6">
                  <c:v>7.7380952380952397E-2</c:v>
                </c:pt>
                <c:pt idx="7">
                  <c:v>6.1011904761904795E-2</c:v>
                </c:pt>
                <c:pt idx="8">
                  <c:v>4.9107142857142912E-2</c:v>
                </c:pt>
                <c:pt idx="9">
                  <c:v>4.4642857142857095E-2</c:v>
                </c:pt>
                <c:pt idx="10">
                  <c:v>3.2738095238095198E-2</c:v>
                </c:pt>
                <c:pt idx="11">
                  <c:v>3.5714285714285698E-2</c:v>
                </c:pt>
                <c:pt idx="12">
                  <c:v>3.5714285714285698E-2</c:v>
                </c:pt>
                <c:pt idx="13">
                  <c:v>2.8273809523809521E-2</c:v>
                </c:pt>
                <c:pt idx="14">
                  <c:v>2.0833333333333311E-2</c:v>
                </c:pt>
                <c:pt idx="15">
                  <c:v>1.9345238095238106E-2</c:v>
                </c:pt>
                <c:pt idx="16">
                  <c:v>1.1904761904761904E-2</c:v>
                </c:pt>
                <c:pt idx="17">
                  <c:v>1.3392857142857107E-2</c:v>
                </c:pt>
                <c:pt idx="18">
                  <c:v>7.4404761904761935E-3</c:v>
                </c:pt>
                <c:pt idx="19">
                  <c:v>1.3392857142857107E-2</c:v>
                </c:pt>
                <c:pt idx="20">
                  <c:v>8.9285714285714229E-3</c:v>
                </c:pt>
              </c:numCache>
            </c:numRef>
          </c:val>
        </c:ser>
        <c:ser>
          <c:idx val="9"/>
          <c:order val="9"/>
          <c:tx>
            <c:strRef>
              <c:f>'cat-1(CB1111)_A5_0.02_5%'!$K$104</c:f>
              <c:strCache>
                <c:ptCount val="1"/>
                <c:pt idx="0">
                  <c:v>cat-1(CB1111)_A5_11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K$105:$K$125</c:f>
              <c:numCache>
                <c:formatCode>General</c:formatCode>
                <c:ptCount val="21"/>
                <c:pt idx="1">
                  <c:v>6.5662002152852506E-2</c:v>
                </c:pt>
                <c:pt idx="2">
                  <c:v>0.10010764262648003</c:v>
                </c:pt>
                <c:pt idx="3">
                  <c:v>9.1496232508073205E-2</c:v>
                </c:pt>
                <c:pt idx="4">
                  <c:v>0.12163616792249703</c:v>
                </c:pt>
                <c:pt idx="5">
                  <c:v>0.12378902045209904</c:v>
                </c:pt>
                <c:pt idx="6">
                  <c:v>7.8579117330462897E-2</c:v>
                </c:pt>
                <c:pt idx="7">
                  <c:v>6.135629709364912E-2</c:v>
                </c:pt>
                <c:pt idx="8">
                  <c:v>6.0279870828848198E-2</c:v>
                </c:pt>
                <c:pt idx="9">
                  <c:v>4.0904198062432701E-2</c:v>
                </c:pt>
                <c:pt idx="10">
                  <c:v>3.2292787944025805E-2</c:v>
                </c:pt>
                <c:pt idx="11">
                  <c:v>3.0139935414424123E-2</c:v>
                </c:pt>
                <c:pt idx="12">
                  <c:v>3.1216361679225018E-2</c:v>
                </c:pt>
                <c:pt idx="13">
                  <c:v>2.5834230355220717E-2</c:v>
                </c:pt>
                <c:pt idx="14">
                  <c:v>1.29171151776103E-2</c:v>
                </c:pt>
                <c:pt idx="15">
                  <c:v>1.29171151776103E-2</c:v>
                </c:pt>
                <c:pt idx="16">
                  <c:v>9.6878363832077537E-3</c:v>
                </c:pt>
                <c:pt idx="17">
                  <c:v>3.229278794402581E-3</c:v>
                </c:pt>
                <c:pt idx="18">
                  <c:v>9.6878363832077537E-3</c:v>
                </c:pt>
                <c:pt idx="19">
                  <c:v>7.5349838536060299E-3</c:v>
                </c:pt>
                <c:pt idx="20">
                  <c:v>2.1528525296017191E-3</c:v>
                </c:pt>
              </c:numCache>
            </c:numRef>
          </c:val>
        </c:ser>
        <c:ser>
          <c:idx val="10"/>
          <c:order val="10"/>
          <c:tx>
            <c:strRef>
              <c:f>'cat-1(CB1111)_A5_0.02_5%'!$L$104</c:f>
              <c:strCache>
                <c:ptCount val="1"/>
                <c:pt idx="0">
                  <c:v>cat-1(CB1111)_A5_12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L$105:$L$125</c:f>
              <c:numCache>
                <c:formatCode>General</c:formatCode>
                <c:ptCount val="21"/>
                <c:pt idx="1">
                  <c:v>8.3143507972665107E-2</c:v>
                </c:pt>
                <c:pt idx="2">
                  <c:v>9.9088838268792737E-2</c:v>
                </c:pt>
                <c:pt idx="3">
                  <c:v>0.11617312072892909</c:v>
                </c:pt>
                <c:pt idx="4">
                  <c:v>9.7949886104783584E-2</c:v>
                </c:pt>
                <c:pt idx="5">
                  <c:v>0.12756264236902101</c:v>
                </c:pt>
                <c:pt idx="6">
                  <c:v>6.6059225512528505E-2</c:v>
                </c:pt>
                <c:pt idx="7">
                  <c:v>4.3280182232346198E-2</c:v>
                </c:pt>
                <c:pt idx="8">
                  <c:v>3.7585421412300715E-2</c:v>
                </c:pt>
                <c:pt idx="9">
                  <c:v>3.5307517084282515E-2</c:v>
                </c:pt>
                <c:pt idx="10">
                  <c:v>3.4168564920273301E-2</c:v>
                </c:pt>
                <c:pt idx="11">
                  <c:v>3.1890660592255114E-2</c:v>
                </c:pt>
                <c:pt idx="12">
                  <c:v>2.8473804100227807E-2</c:v>
                </c:pt>
                <c:pt idx="13">
                  <c:v>2.6195899772209607E-2</c:v>
                </c:pt>
                <c:pt idx="14">
                  <c:v>2.2779043280182206E-2</c:v>
                </c:pt>
                <c:pt idx="15">
                  <c:v>7.9726651480637838E-3</c:v>
                </c:pt>
                <c:pt idx="16">
                  <c:v>1.1389521640091107E-2</c:v>
                </c:pt>
                <c:pt idx="17">
                  <c:v>3.4168564920273301E-3</c:v>
                </c:pt>
                <c:pt idx="18">
                  <c:v>1.1389521640091107E-2</c:v>
                </c:pt>
                <c:pt idx="19">
                  <c:v>3.4168564920273301E-3</c:v>
                </c:pt>
                <c:pt idx="20">
                  <c:v>7.9726651480637838E-3</c:v>
                </c:pt>
              </c:numCache>
            </c:numRef>
          </c:val>
        </c:ser>
        <c:ser>
          <c:idx val="11"/>
          <c:order val="11"/>
          <c:tx>
            <c:strRef>
              <c:f>'cat-1(CB1111)_A5_0.02_5%'!$M$104</c:f>
              <c:strCache>
                <c:ptCount val="1"/>
                <c:pt idx="0">
                  <c:v>cat-1(CB1111)_A5_13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M$105:$M$125</c:f>
              <c:numCache>
                <c:formatCode>General</c:formatCode>
                <c:ptCount val="21"/>
                <c:pt idx="1">
                  <c:v>0.13580246913580199</c:v>
                </c:pt>
                <c:pt idx="2">
                  <c:v>0.14814814814814806</c:v>
                </c:pt>
                <c:pt idx="3">
                  <c:v>9.8765432098765468E-2</c:v>
                </c:pt>
                <c:pt idx="4">
                  <c:v>9.8765432098765468E-2</c:v>
                </c:pt>
                <c:pt idx="5">
                  <c:v>8.2304526748971207E-2</c:v>
                </c:pt>
                <c:pt idx="6">
                  <c:v>4.9382716049382734E-2</c:v>
                </c:pt>
                <c:pt idx="7">
                  <c:v>1.6460905349794205E-2</c:v>
                </c:pt>
                <c:pt idx="8">
                  <c:v>2.8806584362139891E-2</c:v>
                </c:pt>
                <c:pt idx="9">
                  <c:v>2.4691358024691409E-2</c:v>
                </c:pt>
                <c:pt idx="10">
                  <c:v>2.8806584362139891E-2</c:v>
                </c:pt>
                <c:pt idx="11">
                  <c:v>2.0576131687242802E-2</c:v>
                </c:pt>
                <c:pt idx="12">
                  <c:v>8.23045267489712E-3</c:v>
                </c:pt>
                <c:pt idx="13">
                  <c:v>4.11522633744856E-3</c:v>
                </c:pt>
                <c:pt idx="14">
                  <c:v>1.6460905349794205E-2</c:v>
                </c:pt>
                <c:pt idx="15">
                  <c:v>8.23045267489712E-3</c:v>
                </c:pt>
                <c:pt idx="16">
                  <c:v>2.0576131687242802E-2</c:v>
                </c:pt>
                <c:pt idx="17">
                  <c:v>2.0576131687242802E-2</c:v>
                </c:pt>
                <c:pt idx="18">
                  <c:v>1.2345679012345704E-2</c:v>
                </c:pt>
                <c:pt idx="19">
                  <c:v>4.11522633744856E-3</c:v>
                </c:pt>
                <c:pt idx="20">
                  <c:v>4.11522633744856E-3</c:v>
                </c:pt>
              </c:numCache>
            </c:numRef>
          </c:val>
        </c:ser>
        <c:ser>
          <c:idx val="12"/>
          <c:order val="12"/>
          <c:tx>
            <c:strRef>
              <c:f>'cat-1(CB1111)_A5_0.02_5%'!$N$104</c:f>
              <c:strCache>
                <c:ptCount val="1"/>
                <c:pt idx="0">
                  <c:v>cat-1(CB1111)_A5_14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N$105:$N$125</c:f>
              <c:numCache>
                <c:formatCode>General</c:formatCode>
                <c:ptCount val="21"/>
                <c:pt idx="1">
                  <c:v>8.8507265521796677E-2</c:v>
                </c:pt>
                <c:pt idx="2">
                  <c:v>0.12285336856010598</c:v>
                </c:pt>
                <c:pt idx="3">
                  <c:v>0.116248348745046</c:v>
                </c:pt>
                <c:pt idx="4">
                  <c:v>0.12681638044914106</c:v>
                </c:pt>
                <c:pt idx="5">
                  <c:v>0.104359313077939</c:v>
                </c:pt>
                <c:pt idx="6">
                  <c:v>7.5297225891677713E-2</c:v>
                </c:pt>
                <c:pt idx="7">
                  <c:v>6.472919418758262E-2</c:v>
                </c:pt>
                <c:pt idx="8">
                  <c:v>4.491413474240423E-2</c:v>
                </c:pt>
                <c:pt idx="9">
                  <c:v>3.9630118890356711E-2</c:v>
                </c:pt>
                <c:pt idx="10">
                  <c:v>3.698811096433291E-2</c:v>
                </c:pt>
                <c:pt idx="11">
                  <c:v>2.5099075297225906E-2</c:v>
                </c:pt>
                <c:pt idx="12">
                  <c:v>2.5099075297225906E-2</c:v>
                </c:pt>
                <c:pt idx="13">
                  <c:v>1.3210039630118905E-2</c:v>
                </c:pt>
                <c:pt idx="14">
                  <c:v>6.6050198150594498E-3</c:v>
                </c:pt>
                <c:pt idx="15">
                  <c:v>1.0568031704095104E-2</c:v>
                </c:pt>
                <c:pt idx="16">
                  <c:v>5.2840158520475579E-3</c:v>
                </c:pt>
                <c:pt idx="17">
                  <c:v>2.6420079260237798E-3</c:v>
                </c:pt>
                <c:pt idx="18">
                  <c:v>5.2840158520475579E-3</c:v>
                </c:pt>
                <c:pt idx="19">
                  <c:v>5.2840158520475579E-3</c:v>
                </c:pt>
                <c:pt idx="20">
                  <c:v>2.6420079260237798E-3</c:v>
                </c:pt>
              </c:numCache>
            </c:numRef>
          </c:val>
        </c:ser>
        <c:ser>
          <c:idx val="13"/>
          <c:order val="13"/>
          <c:tx>
            <c:strRef>
              <c:f>'cat-1(CB1111)_A5_0.02_5%'!$O$104</c:f>
              <c:strCache>
                <c:ptCount val="1"/>
                <c:pt idx="0">
                  <c:v>cat-1(CB1111)_A5_15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O$105:$O$125</c:f>
              <c:numCache>
                <c:formatCode>General</c:formatCode>
                <c:ptCount val="21"/>
                <c:pt idx="1">
                  <c:v>7.823129251700682E-2</c:v>
                </c:pt>
                <c:pt idx="2">
                  <c:v>8.3333333333333329E-2</c:v>
                </c:pt>
                <c:pt idx="3">
                  <c:v>7.9931972789115693E-2</c:v>
                </c:pt>
                <c:pt idx="4">
                  <c:v>8.6734693877551006E-2</c:v>
                </c:pt>
                <c:pt idx="5">
                  <c:v>0.17176870748299311</c:v>
                </c:pt>
                <c:pt idx="6">
                  <c:v>5.6122448979591802E-2</c:v>
                </c:pt>
                <c:pt idx="7">
                  <c:v>4.2517006802721136E-2</c:v>
                </c:pt>
                <c:pt idx="8">
                  <c:v>3.2312925170068001E-2</c:v>
                </c:pt>
                <c:pt idx="9">
                  <c:v>3.5714285714285698E-2</c:v>
                </c:pt>
                <c:pt idx="10">
                  <c:v>3.4013605442176915E-2</c:v>
                </c:pt>
                <c:pt idx="11">
                  <c:v>4.591836734693882E-2</c:v>
                </c:pt>
                <c:pt idx="12">
                  <c:v>3.0612244897959207E-2</c:v>
                </c:pt>
                <c:pt idx="13">
                  <c:v>2.0408163265306107E-2</c:v>
                </c:pt>
                <c:pt idx="14">
                  <c:v>1.7006802721088402E-2</c:v>
                </c:pt>
                <c:pt idx="15">
                  <c:v>1.8707482993197303E-2</c:v>
                </c:pt>
                <c:pt idx="16">
                  <c:v>1.8707482993197303E-2</c:v>
                </c:pt>
                <c:pt idx="17">
                  <c:v>1.5306122448979604E-2</c:v>
                </c:pt>
                <c:pt idx="18">
                  <c:v>5.1020408163265285E-3</c:v>
                </c:pt>
                <c:pt idx="19">
                  <c:v>8.5034013605442254E-3</c:v>
                </c:pt>
                <c:pt idx="20">
                  <c:v>1.8707482993197303E-2</c:v>
                </c:pt>
              </c:numCache>
            </c:numRef>
          </c:val>
        </c:ser>
        <c:ser>
          <c:idx val="14"/>
          <c:order val="14"/>
          <c:tx>
            <c:strRef>
              <c:f>'cat-1(CB1111)_A5_0.02_5%'!$P$104</c:f>
              <c:strCache>
                <c:ptCount val="1"/>
                <c:pt idx="0">
                  <c:v>cat-1(CB1111)_A5_16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P$105:$P$125</c:f>
              <c:numCache>
                <c:formatCode>General</c:formatCode>
                <c:ptCount val="21"/>
                <c:pt idx="1">
                  <c:v>8.98876404494382E-2</c:v>
                </c:pt>
                <c:pt idx="2">
                  <c:v>0.10486891385767801</c:v>
                </c:pt>
                <c:pt idx="3">
                  <c:v>0.116104868913858</c:v>
                </c:pt>
                <c:pt idx="4">
                  <c:v>5.6179775280898875E-2</c:v>
                </c:pt>
                <c:pt idx="5">
                  <c:v>5.9925093632958802E-2</c:v>
                </c:pt>
                <c:pt idx="6">
                  <c:v>5.6179775280898875E-2</c:v>
                </c:pt>
                <c:pt idx="7">
                  <c:v>4.11985018726592E-2</c:v>
                </c:pt>
                <c:pt idx="8">
                  <c:v>4.49438202247191E-2</c:v>
                </c:pt>
                <c:pt idx="9">
                  <c:v>3.7453183520599322E-2</c:v>
                </c:pt>
                <c:pt idx="10">
                  <c:v>2.6217228464419519E-2</c:v>
                </c:pt>
                <c:pt idx="11">
                  <c:v>1.8726591760299605E-2</c:v>
                </c:pt>
                <c:pt idx="12">
                  <c:v>1.1235955056179799E-2</c:v>
                </c:pt>
                <c:pt idx="13">
                  <c:v>1.4981273408239701E-2</c:v>
                </c:pt>
                <c:pt idx="14">
                  <c:v>1.8726591760299605E-2</c:v>
                </c:pt>
                <c:pt idx="15">
                  <c:v>7.4906367041198537E-3</c:v>
                </c:pt>
                <c:pt idx="16">
                  <c:v>1.4981273408239701E-2</c:v>
                </c:pt>
                <c:pt idx="17">
                  <c:v>7.4906367041198537E-3</c:v>
                </c:pt>
                <c:pt idx="18">
                  <c:v>7.4906367041198537E-3</c:v>
                </c:pt>
                <c:pt idx="19">
                  <c:v>1.1235955056179799E-2</c:v>
                </c:pt>
                <c:pt idx="20">
                  <c:v>1.1235955056179799E-2</c:v>
                </c:pt>
              </c:numCache>
            </c:numRef>
          </c:val>
        </c:ser>
        <c:ser>
          <c:idx val="15"/>
          <c:order val="15"/>
          <c:tx>
            <c:strRef>
              <c:f>'cat-1(CB1111)_A5_0.02_5%'!$Q$104</c:f>
              <c:strCache>
                <c:ptCount val="1"/>
                <c:pt idx="0">
                  <c:v>cat-1(CB1111)_A5_17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Q$105:$Q$125</c:f>
              <c:numCache>
                <c:formatCode>General</c:formatCode>
                <c:ptCount val="21"/>
                <c:pt idx="1">
                  <c:v>0.101522842639594</c:v>
                </c:pt>
                <c:pt idx="2">
                  <c:v>0.11928934010152302</c:v>
                </c:pt>
                <c:pt idx="3">
                  <c:v>8.3756345177665129E-2</c:v>
                </c:pt>
                <c:pt idx="4">
                  <c:v>9.3908629441624397E-2</c:v>
                </c:pt>
                <c:pt idx="5">
                  <c:v>6.8527918781725899E-2</c:v>
                </c:pt>
                <c:pt idx="6">
                  <c:v>8.6294416243654831E-2</c:v>
                </c:pt>
                <c:pt idx="7">
                  <c:v>4.0609137055837616E-2</c:v>
                </c:pt>
                <c:pt idx="8">
                  <c:v>3.2994923857868001E-2</c:v>
                </c:pt>
                <c:pt idx="9">
                  <c:v>4.0609137055837616E-2</c:v>
                </c:pt>
                <c:pt idx="10">
                  <c:v>3.0456852791878201E-2</c:v>
                </c:pt>
                <c:pt idx="11">
                  <c:v>2.2842639593908601E-2</c:v>
                </c:pt>
                <c:pt idx="12">
                  <c:v>1.7766497461928901E-2</c:v>
                </c:pt>
                <c:pt idx="13">
                  <c:v>1.01522842639594E-2</c:v>
                </c:pt>
                <c:pt idx="14">
                  <c:v>3.0456852791878201E-2</c:v>
                </c:pt>
                <c:pt idx="15">
                  <c:v>2.538071065989851E-3</c:v>
                </c:pt>
                <c:pt idx="16">
                  <c:v>1.26903553299492E-2</c:v>
                </c:pt>
                <c:pt idx="17">
                  <c:v>7.6142131979695417E-3</c:v>
                </c:pt>
                <c:pt idx="18">
                  <c:v>5.0761421319797037E-3</c:v>
                </c:pt>
                <c:pt idx="19">
                  <c:v>1.01522842639594E-2</c:v>
                </c:pt>
                <c:pt idx="2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cat-1(CB1111)_A5_0.02_5%'!$R$104</c:f>
              <c:strCache>
                <c:ptCount val="1"/>
                <c:pt idx="0">
                  <c:v>cat-1(CB1111)_A5_18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R$105:$R$125</c:f>
              <c:numCache>
                <c:formatCode>General</c:formatCode>
                <c:ptCount val="21"/>
                <c:pt idx="1">
                  <c:v>6.3354037267080721E-2</c:v>
                </c:pt>
                <c:pt idx="2">
                  <c:v>9.9378881987577605E-2</c:v>
                </c:pt>
                <c:pt idx="3">
                  <c:v>0.12795031055900599</c:v>
                </c:pt>
                <c:pt idx="4">
                  <c:v>0.12049689440993799</c:v>
                </c:pt>
                <c:pt idx="5">
                  <c:v>0.12049689440993799</c:v>
                </c:pt>
                <c:pt idx="6">
                  <c:v>6.9565217391304321E-2</c:v>
                </c:pt>
                <c:pt idx="7">
                  <c:v>6.2111801242236031E-2</c:v>
                </c:pt>
                <c:pt idx="8">
                  <c:v>5.9627329192546631E-2</c:v>
                </c:pt>
                <c:pt idx="9">
                  <c:v>2.8571428571428602E-2</c:v>
                </c:pt>
                <c:pt idx="10">
                  <c:v>3.4782608695652202E-2</c:v>
                </c:pt>
                <c:pt idx="11">
                  <c:v>3.2298136645962698E-2</c:v>
                </c:pt>
                <c:pt idx="12">
                  <c:v>1.1180124223602509E-2</c:v>
                </c:pt>
                <c:pt idx="13">
                  <c:v>1.6149068322981401E-2</c:v>
                </c:pt>
                <c:pt idx="14">
                  <c:v>7.453416149068322E-3</c:v>
                </c:pt>
                <c:pt idx="15">
                  <c:v>1.7391304347826101E-2</c:v>
                </c:pt>
                <c:pt idx="16">
                  <c:v>1.6149068322981401E-2</c:v>
                </c:pt>
                <c:pt idx="17">
                  <c:v>1.1180124223602509E-2</c:v>
                </c:pt>
                <c:pt idx="18">
                  <c:v>1.1180124223602509E-2</c:v>
                </c:pt>
                <c:pt idx="19">
                  <c:v>8.6956521739130453E-3</c:v>
                </c:pt>
                <c:pt idx="20">
                  <c:v>6.2111801242236038E-3</c:v>
                </c:pt>
              </c:numCache>
            </c:numRef>
          </c:val>
        </c:ser>
        <c:ser>
          <c:idx val="17"/>
          <c:order val="17"/>
          <c:tx>
            <c:strRef>
              <c:f>'cat-1(CB1111)_A5_0.02_5%'!$S$104</c:f>
              <c:strCache>
                <c:ptCount val="1"/>
                <c:pt idx="0">
                  <c:v>cat-1(CB1111)_A5_19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S$105:$S$125</c:f>
              <c:numCache>
                <c:formatCode>General</c:formatCode>
                <c:ptCount val="21"/>
                <c:pt idx="1">
                  <c:v>7.0805043646944704E-2</c:v>
                </c:pt>
                <c:pt idx="2">
                  <c:v>0.11542192046556703</c:v>
                </c:pt>
                <c:pt idx="3">
                  <c:v>8.4384093113482175E-2</c:v>
                </c:pt>
                <c:pt idx="4">
                  <c:v>9.8933074684772096E-2</c:v>
                </c:pt>
                <c:pt idx="5">
                  <c:v>0.13385063045586801</c:v>
                </c:pt>
                <c:pt idx="6">
                  <c:v>6.7895247332686731E-2</c:v>
                </c:pt>
                <c:pt idx="7">
                  <c:v>5.33462657613967E-2</c:v>
                </c:pt>
                <c:pt idx="8">
                  <c:v>4.3646944713869963E-2</c:v>
                </c:pt>
                <c:pt idx="9">
                  <c:v>3.5887487875848702E-2</c:v>
                </c:pt>
                <c:pt idx="10">
                  <c:v>4.8496605237633432E-2</c:v>
                </c:pt>
                <c:pt idx="11">
                  <c:v>2.6188166828322007E-2</c:v>
                </c:pt>
                <c:pt idx="12">
                  <c:v>2.7158098933074699E-2</c:v>
                </c:pt>
                <c:pt idx="13">
                  <c:v>2.5218234723569315E-2</c:v>
                </c:pt>
                <c:pt idx="14">
                  <c:v>2.6188166828322007E-2</c:v>
                </c:pt>
                <c:pt idx="15">
                  <c:v>1.5518913676042698E-2</c:v>
                </c:pt>
                <c:pt idx="16">
                  <c:v>1.6488845780795305E-2</c:v>
                </c:pt>
                <c:pt idx="17">
                  <c:v>1.0669253152279299E-2</c:v>
                </c:pt>
                <c:pt idx="18">
                  <c:v>1.2609117361784701E-2</c:v>
                </c:pt>
                <c:pt idx="19">
                  <c:v>7.7594568380213421E-3</c:v>
                </c:pt>
                <c:pt idx="20">
                  <c:v>6.789524733268674E-3</c:v>
                </c:pt>
              </c:numCache>
            </c:numRef>
          </c:val>
        </c:ser>
        <c:ser>
          <c:idx val="18"/>
          <c:order val="18"/>
          <c:tx>
            <c:strRef>
              <c:f>'cat-1(CB1111)_A5_0.02_5%'!$T$104</c:f>
              <c:strCache>
                <c:ptCount val="1"/>
                <c:pt idx="0">
                  <c:v>cat-1(CB1111)_A5_20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T$105:$T$125</c:f>
              <c:numCache>
                <c:formatCode>General</c:formatCode>
                <c:ptCount val="21"/>
                <c:pt idx="1">
                  <c:v>0.16969696969697001</c:v>
                </c:pt>
                <c:pt idx="2">
                  <c:v>0.13333333333333305</c:v>
                </c:pt>
                <c:pt idx="3">
                  <c:v>0.103030303030303</c:v>
                </c:pt>
                <c:pt idx="4">
                  <c:v>7.272727272727271E-2</c:v>
                </c:pt>
                <c:pt idx="5">
                  <c:v>3.6363636363636397E-2</c:v>
                </c:pt>
                <c:pt idx="6">
                  <c:v>3.03030303030303E-2</c:v>
                </c:pt>
                <c:pt idx="7">
                  <c:v>4.8484848484848485E-2</c:v>
                </c:pt>
                <c:pt idx="8">
                  <c:v>3.6363636363636397E-2</c:v>
                </c:pt>
                <c:pt idx="9">
                  <c:v>1.8181818181818205E-2</c:v>
                </c:pt>
                <c:pt idx="10">
                  <c:v>2.4242424242424197E-2</c:v>
                </c:pt>
                <c:pt idx="11">
                  <c:v>1.2121212121212099E-2</c:v>
                </c:pt>
                <c:pt idx="12">
                  <c:v>3.03030303030303E-2</c:v>
                </c:pt>
                <c:pt idx="13">
                  <c:v>1.8181818181818205E-2</c:v>
                </c:pt>
                <c:pt idx="14">
                  <c:v>0</c:v>
                </c:pt>
                <c:pt idx="15">
                  <c:v>6.0606060606060597E-3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cat-1(CB1111)_A5_0.02_5%'!$U$104</c:f>
              <c:strCache>
                <c:ptCount val="1"/>
                <c:pt idx="0">
                  <c:v>cat-1(CB1111)_A5_21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U$105:$U$125</c:f>
              <c:numCache>
                <c:formatCode>General</c:formatCode>
                <c:ptCount val="21"/>
                <c:pt idx="1">
                  <c:v>0.155555555555556</c:v>
                </c:pt>
                <c:pt idx="2">
                  <c:v>9.8765432098765468E-2</c:v>
                </c:pt>
                <c:pt idx="3">
                  <c:v>9.3827160493827264E-2</c:v>
                </c:pt>
                <c:pt idx="4">
                  <c:v>6.4197530864197522E-2</c:v>
                </c:pt>
                <c:pt idx="5">
                  <c:v>3.95061728395062E-2</c:v>
                </c:pt>
                <c:pt idx="6">
                  <c:v>3.95061728395062E-2</c:v>
                </c:pt>
                <c:pt idx="7">
                  <c:v>1.2345679012345704E-2</c:v>
                </c:pt>
                <c:pt idx="8">
                  <c:v>3.2098765432098803E-2</c:v>
                </c:pt>
                <c:pt idx="9">
                  <c:v>2.962962962962961E-2</c:v>
                </c:pt>
                <c:pt idx="10">
                  <c:v>2.2222222222222202E-2</c:v>
                </c:pt>
                <c:pt idx="11">
                  <c:v>2.2222222222222202E-2</c:v>
                </c:pt>
                <c:pt idx="12">
                  <c:v>7.4074074074074103E-3</c:v>
                </c:pt>
                <c:pt idx="13">
                  <c:v>1.7283950617283907E-2</c:v>
                </c:pt>
                <c:pt idx="14">
                  <c:v>2.469135802469141E-3</c:v>
                </c:pt>
                <c:pt idx="15">
                  <c:v>1.2345679012345704E-2</c:v>
                </c:pt>
                <c:pt idx="16">
                  <c:v>2.469135802469141E-3</c:v>
                </c:pt>
                <c:pt idx="17">
                  <c:v>2.469135802469141E-3</c:v>
                </c:pt>
                <c:pt idx="18">
                  <c:v>7.4074074074074103E-3</c:v>
                </c:pt>
                <c:pt idx="19">
                  <c:v>2.469135802469141E-3</c:v>
                </c:pt>
                <c:pt idx="20">
                  <c:v>4.9382716049382741E-3</c:v>
                </c:pt>
              </c:numCache>
            </c:numRef>
          </c:val>
        </c:ser>
        <c:ser>
          <c:idx val="20"/>
          <c:order val="20"/>
          <c:tx>
            <c:strRef>
              <c:f>'cat-1(CB1111)_A5_0.02_5%'!$V$104</c:f>
              <c:strCache>
                <c:ptCount val="1"/>
                <c:pt idx="0">
                  <c:v>cat-1(CB1111)_A5_22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V$105:$V$125</c:f>
              <c:numCache>
                <c:formatCode>General</c:formatCode>
                <c:ptCount val="21"/>
                <c:pt idx="1">
                  <c:v>7.6732673267326731E-2</c:v>
                </c:pt>
                <c:pt idx="2">
                  <c:v>8.910891089108916E-2</c:v>
                </c:pt>
                <c:pt idx="3">
                  <c:v>9.900990099009907E-2</c:v>
                </c:pt>
                <c:pt idx="4">
                  <c:v>9.4059405940594171E-2</c:v>
                </c:pt>
                <c:pt idx="5">
                  <c:v>5.4455445544554483E-2</c:v>
                </c:pt>
                <c:pt idx="6">
                  <c:v>3.4653465346534698E-2</c:v>
                </c:pt>
                <c:pt idx="7">
                  <c:v>3.2178217821782214E-2</c:v>
                </c:pt>
                <c:pt idx="8">
                  <c:v>4.7029702970296995E-2</c:v>
                </c:pt>
                <c:pt idx="9">
                  <c:v>4.2079207920792103E-2</c:v>
                </c:pt>
                <c:pt idx="10">
                  <c:v>4.95049504950495E-2</c:v>
                </c:pt>
                <c:pt idx="11">
                  <c:v>3.7128712871287099E-2</c:v>
                </c:pt>
                <c:pt idx="12">
                  <c:v>3.2178217821782214E-2</c:v>
                </c:pt>
                <c:pt idx="13">
                  <c:v>3.4653465346534698E-2</c:v>
                </c:pt>
                <c:pt idx="14">
                  <c:v>2.2277227722772325E-2</c:v>
                </c:pt>
                <c:pt idx="15">
                  <c:v>3.2178217821782214E-2</c:v>
                </c:pt>
                <c:pt idx="16">
                  <c:v>2.7227722772277214E-2</c:v>
                </c:pt>
                <c:pt idx="17">
                  <c:v>1.73267326732673E-2</c:v>
                </c:pt>
                <c:pt idx="18">
                  <c:v>1.4851485148514901E-2</c:v>
                </c:pt>
                <c:pt idx="19">
                  <c:v>1.73267326732673E-2</c:v>
                </c:pt>
                <c:pt idx="20">
                  <c:v>7.4257425742574315E-3</c:v>
                </c:pt>
              </c:numCache>
            </c:numRef>
          </c:val>
        </c:ser>
        <c:ser>
          <c:idx val="21"/>
          <c:order val="21"/>
          <c:tx>
            <c:strRef>
              <c:f>'cat-1(CB1111)_A5_0.02_5%'!$W$104</c:f>
              <c:strCache>
                <c:ptCount val="1"/>
                <c:pt idx="0">
                  <c:v>cat-1(CB1111)_A5_23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W$105:$W$125</c:f>
              <c:numCache>
                <c:formatCode>General</c:formatCode>
                <c:ptCount val="21"/>
                <c:pt idx="1">
                  <c:v>9.6852300242130707E-2</c:v>
                </c:pt>
                <c:pt idx="2">
                  <c:v>0.10169491525423703</c:v>
                </c:pt>
                <c:pt idx="3">
                  <c:v>0.10895883777239697</c:v>
                </c:pt>
                <c:pt idx="4">
                  <c:v>7.0217917675544819E-2</c:v>
                </c:pt>
                <c:pt idx="5">
                  <c:v>6.2953995157385034E-2</c:v>
                </c:pt>
                <c:pt idx="6">
                  <c:v>3.6319612590799015E-2</c:v>
                </c:pt>
                <c:pt idx="7">
                  <c:v>5.32687651331719E-2</c:v>
                </c:pt>
                <c:pt idx="8">
                  <c:v>5.32687651331719E-2</c:v>
                </c:pt>
                <c:pt idx="9">
                  <c:v>4.8426150121065395E-2</c:v>
                </c:pt>
                <c:pt idx="10">
                  <c:v>2.9055690072639202E-2</c:v>
                </c:pt>
                <c:pt idx="11">
                  <c:v>3.6319612590799015E-2</c:v>
                </c:pt>
                <c:pt idx="12">
                  <c:v>2.6634382566586012E-2</c:v>
                </c:pt>
                <c:pt idx="13">
                  <c:v>4.1162227602905624E-2</c:v>
                </c:pt>
                <c:pt idx="14">
                  <c:v>1.4527845036319601E-2</c:v>
                </c:pt>
                <c:pt idx="15">
                  <c:v>2.1791767554479417E-2</c:v>
                </c:pt>
                <c:pt idx="16">
                  <c:v>2.1791767554479417E-2</c:v>
                </c:pt>
                <c:pt idx="17">
                  <c:v>7.2639225181598101E-3</c:v>
                </c:pt>
                <c:pt idx="18">
                  <c:v>9.6852300242130842E-3</c:v>
                </c:pt>
                <c:pt idx="19">
                  <c:v>9.6852300242130842E-3</c:v>
                </c:pt>
                <c:pt idx="20">
                  <c:v>2.421307506053271E-3</c:v>
                </c:pt>
              </c:numCache>
            </c:numRef>
          </c:val>
        </c:ser>
        <c:ser>
          <c:idx val="22"/>
          <c:order val="22"/>
          <c:tx>
            <c:strRef>
              <c:f>'cat-1(CB1111)_A5_0.02_5%'!$X$104</c:f>
              <c:strCache>
                <c:ptCount val="1"/>
                <c:pt idx="0">
                  <c:v>cat-1(CB1111)_A5_24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X$105:$X$125</c:f>
              <c:numCache>
                <c:formatCode>General</c:formatCode>
                <c:ptCount val="21"/>
                <c:pt idx="1">
                  <c:v>7.8838174273858905E-2</c:v>
                </c:pt>
                <c:pt idx="2">
                  <c:v>5.3941908713692879E-2</c:v>
                </c:pt>
                <c:pt idx="3">
                  <c:v>6.8464730290456424E-2</c:v>
                </c:pt>
                <c:pt idx="4">
                  <c:v>9.5435684647302899E-2</c:v>
                </c:pt>
                <c:pt idx="5">
                  <c:v>5.3941908713692879E-2</c:v>
                </c:pt>
                <c:pt idx="6">
                  <c:v>5.8091286307053902E-2</c:v>
                </c:pt>
                <c:pt idx="7">
                  <c:v>3.9419087136929515E-2</c:v>
                </c:pt>
                <c:pt idx="8">
                  <c:v>3.9419087136929515E-2</c:v>
                </c:pt>
                <c:pt idx="9">
                  <c:v>4.3568464730290503E-2</c:v>
                </c:pt>
                <c:pt idx="10">
                  <c:v>3.734439834024901E-2</c:v>
                </c:pt>
                <c:pt idx="11">
                  <c:v>4.7717842323651401E-2</c:v>
                </c:pt>
                <c:pt idx="12">
                  <c:v>3.3195020746887988E-2</c:v>
                </c:pt>
                <c:pt idx="13">
                  <c:v>2.2821576763485511E-2</c:v>
                </c:pt>
                <c:pt idx="14">
                  <c:v>3.3195020746887988E-2</c:v>
                </c:pt>
                <c:pt idx="15">
                  <c:v>2.0746887966805006E-2</c:v>
                </c:pt>
                <c:pt idx="16">
                  <c:v>2.0746887966805006E-2</c:v>
                </c:pt>
                <c:pt idx="17">
                  <c:v>3.9419087136929515E-2</c:v>
                </c:pt>
                <c:pt idx="18">
                  <c:v>2.2821576763485511E-2</c:v>
                </c:pt>
                <c:pt idx="19">
                  <c:v>2.0746887966805006E-2</c:v>
                </c:pt>
                <c:pt idx="20">
                  <c:v>2.2821576763485511E-2</c:v>
                </c:pt>
              </c:numCache>
            </c:numRef>
          </c:val>
        </c:ser>
        <c:ser>
          <c:idx val="23"/>
          <c:order val="23"/>
          <c:tx>
            <c:strRef>
              <c:f>'cat-1(CB1111)_A5_0.02_5%'!$Y$104</c:f>
              <c:strCache>
                <c:ptCount val="1"/>
                <c:pt idx="0">
                  <c:v>cat-1(CB1111)_A5_25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Y$105:$Y$125</c:f>
              <c:numCache>
                <c:formatCode>General</c:formatCode>
                <c:ptCount val="21"/>
                <c:pt idx="1">
                  <c:v>8.0952380952381026E-2</c:v>
                </c:pt>
                <c:pt idx="2">
                  <c:v>6.4285714285714293E-2</c:v>
                </c:pt>
                <c:pt idx="3">
                  <c:v>5.2380952380952396E-2</c:v>
                </c:pt>
                <c:pt idx="4">
                  <c:v>5.7142857142857099E-2</c:v>
                </c:pt>
                <c:pt idx="5">
                  <c:v>5.7142857142857099E-2</c:v>
                </c:pt>
                <c:pt idx="6">
                  <c:v>3.3333333333333298E-2</c:v>
                </c:pt>
                <c:pt idx="7">
                  <c:v>1.9047619047619008E-2</c:v>
                </c:pt>
                <c:pt idx="8">
                  <c:v>3.0952380952380999E-2</c:v>
                </c:pt>
                <c:pt idx="9">
                  <c:v>0.05</c:v>
                </c:pt>
                <c:pt idx="10">
                  <c:v>3.8095238095238099E-2</c:v>
                </c:pt>
                <c:pt idx="11">
                  <c:v>4.7619047619047616E-2</c:v>
                </c:pt>
                <c:pt idx="12">
                  <c:v>3.8095238095238099E-2</c:v>
                </c:pt>
                <c:pt idx="13">
                  <c:v>4.2857142857142913E-2</c:v>
                </c:pt>
                <c:pt idx="14">
                  <c:v>4.5238095238095216E-2</c:v>
                </c:pt>
                <c:pt idx="15">
                  <c:v>5.7142857142857099E-2</c:v>
                </c:pt>
                <c:pt idx="16">
                  <c:v>3.5714285714285698E-2</c:v>
                </c:pt>
                <c:pt idx="17">
                  <c:v>3.3333333333333298E-2</c:v>
                </c:pt>
                <c:pt idx="18">
                  <c:v>3.0952380952380999E-2</c:v>
                </c:pt>
                <c:pt idx="19">
                  <c:v>2.8571428571428602E-2</c:v>
                </c:pt>
                <c:pt idx="20">
                  <c:v>1.9047619047619008E-2</c:v>
                </c:pt>
              </c:numCache>
            </c:numRef>
          </c:val>
        </c:ser>
        <c:ser>
          <c:idx val="24"/>
          <c:order val="24"/>
          <c:tx>
            <c:strRef>
              <c:f>'cat-1(CB1111)_A5_0.02_5%'!$Z$104</c:f>
              <c:strCache>
                <c:ptCount val="1"/>
                <c:pt idx="0">
                  <c:v>cat-1(CB1111)_A5_26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Z$105:$Z$125</c:f>
              <c:numCache>
                <c:formatCode>General</c:formatCode>
                <c:ptCount val="21"/>
                <c:pt idx="1">
                  <c:v>5.3264604810996638E-2</c:v>
                </c:pt>
                <c:pt idx="2">
                  <c:v>9.450171821305843E-2</c:v>
                </c:pt>
                <c:pt idx="3">
                  <c:v>9.1065292096219969E-2</c:v>
                </c:pt>
                <c:pt idx="4">
                  <c:v>0.10137457044673504</c:v>
                </c:pt>
                <c:pt idx="5">
                  <c:v>8.9347079037800703E-2</c:v>
                </c:pt>
                <c:pt idx="6">
                  <c:v>7.5601374570446703E-2</c:v>
                </c:pt>
                <c:pt idx="7">
                  <c:v>5.8419243986254296E-2</c:v>
                </c:pt>
                <c:pt idx="8">
                  <c:v>4.6391752577319589E-2</c:v>
                </c:pt>
                <c:pt idx="9">
                  <c:v>4.4673539518900303E-2</c:v>
                </c:pt>
                <c:pt idx="10">
                  <c:v>4.2955326460481086E-2</c:v>
                </c:pt>
                <c:pt idx="11">
                  <c:v>3.9518900343642603E-2</c:v>
                </c:pt>
                <c:pt idx="12">
                  <c:v>2.577319587628871E-2</c:v>
                </c:pt>
                <c:pt idx="13">
                  <c:v>3.09278350515464E-2</c:v>
                </c:pt>
                <c:pt idx="14">
                  <c:v>2.7491408934707907E-2</c:v>
                </c:pt>
                <c:pt idx="15">
                  <c:v>3.2646048109965617E-2</c:v>
                </c:pt>
                <c:pt idx="16">
                  <c:v>1.5463917525773198E-2</c:v>
                </c:pt>
                <c:pt idx="17">
                  <c:v>1.5463917525773198E-2</c:v>
                </c:pt>
                <c:pt idx="18">
                  <c:v>1.20274914089347E-2</c:v>
                </c:pt>
                <c:pt idx="19">
                  <c:v>1.0309278350515504E-2</c:v>
                </c:pt>
                <c:pt idx="20">
                  <c:v>8.5910652920962206E-3</c:v>
                </c:pt>
              </c:numCache>
            </c:numRef>
          </c:val>
        </c:ser>
        <c:ser>
          <c:idx val="25"/>
          <c:order val="25"/>
          <c:tx>
            <c:strRef>
              <c:f>'cat-1(CB1111)_A5_0.02_5%'!$AA$104</c:f>
              <c:strCache>
                <c:ptCount val="1"/>
                <c:pt idx="0">
                  <c:v>cat-1(CB1111)_A5_27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AA$105:$AA$125</c:f>
              <c:numCache>
                <c:formatCode>General</c:formatCode>
                <c:ptCount val="21"/>
                <c:pt idx="1">
                  <c:v>8.2386363636363605E-2</c:v>
                </c:pt>
                <c:pt idx="2">
                  <c:v>7.1022727272727321E-2</c:v>
                </c:pt>
                <c:pt idx="3">
                  <c:v>7.5284090909090912E-2</c:v>
                </c:pt>
                <c:pt idx="4">
                  <c:v>0.119318181818182</c:v>
                </c:pt>
                <c:pt idx="5">
                  <c:v>0.10937500000000003</c:v>
                </c:pt>
                <c:pt idx="6">
                  <c:v>5.1136363636363584E-2</c:v>
                </c:pt>
                <c:pt idx="7">
                  <c:v>4.6874999999999986E-2</c:v>
                </c:pt>
                <c:pt idx="8">
                  <c:v>4.4034090909090925E-2</c:v>
                </c:pt>
                <c:pt idx="9">
                  <c:v>4.2613636363636437E-2</c:v>
                </c:pt>
                <c:pt idx="10">
                  <c:v>2.8409090909090901E-2</c:v>
                </c:pt>
                <c:pt idx="11">
                  <c:v>2.6988636363636392E-2</c:v>
                </c:pt>
                <c:pt idx="12">
                  <c:v>3.5511363636363612E-2</c:v>
                </c:pt>
                <c:pt idx="13">
                  <c:v>1.9886363636363608E-2</c:v>
                </c:pt>
                <c:pt idx="14">
                  <c:v>1.9886363636363608E-2</c:v>
                </c:pt>
                <c:pt idx="15">
                  <c:v>1.9886363636363608E-2</c:v>
                </c:pt>
                <c:pt idx="16">
                  <c:v>1.7045454545454503E-2</c:v>
                </c:pt>
                <c:pt idx="17">
                  <c:v>1.7045454545454503E-2</c:v>
                </c:pt>
                <c:pt idx="18">
                  <c:v>1.4204545454545501E-2</c:v>
                </c:pt>
                <c:pt idx="19">
                  <c:v>2.2727272727272717E-2</c:v>
                </c:pt>
                <c:pt idx="20">
                  <c:v>1.2784090909090898E-2</c:v>
                </c:pt>
              </c:numCache>
            </c:numRef>
          </c:val>
        </c:ser>
        <c:ser>
          <c:idx val="26"/>
          <c:order val="26"/>
          <c:tx>
            <c:strRef>
              <c:f>'cat-1(CB1111)_A5_0.02_5%'!$AB$104</c:f>
              <c:strCache>
                <c:ptCount val="1"/>
                <c:pt idx="0">
                  <c:v>cat-1(CB1111)_A5_28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AB$105:$AB$125</c:f>
              <c:numCache>
                <c:formatCode>General</c:formatCode>
                <c:ptCount val="21"/>
                <c:pt idx="1">
                  <c:v>6.534954407294831E-2</c:v>
                </c:pt>
                <c:pt idx="2">
                  <c:v>7.9027355623100301E-2</c:v>
                </c:pt>
                <c:pt idx="3">
                  <c:v>7.4468085106383031E-2</c:v>
                </c:pt>
                <c:pt idx="4">
                  <c:v>0.10638297872340402</c:v>
                </c:pt>
                <c:pt idx="5">
                  <c:v>0.10790273556231003</c:v>
                </c:pt>
                <c:pt idx="6">
                  <c:v>4.7112462006079013E-2</c:v>
                </c:pt>
                <c:pt idx="7">
                  <c:v>5.6231003039513713E-2</c:v>
                </c:pt>
                <c:pt idx="8">
                  <c:v>5.6231003039513713E-2</c:v>
                </c:pt>
                <c:pt idx="9">
                  <c:v>3.3434650455927001E-2</c:v>
                </c:pt>
                <c:pt idx="10">
                  <c:v>3.4954407294832797E-2</c:v>
                </c:pt>
                <c:pt idx="11">
                  <c:v>2.2796352583586608E-2</c:v>
                </c:pt>
                <c:pt idx="12">
                  <c:v>1.6717325227963507E-2</c:v>
                </c:pt>
                <c:pt idx="13">
                  <c:v>1.3677811550152E-2</c:v>
                </c:pt>
                <c:pt idx="14">
                  <c:v>2.7355623100304E-2</c:v>
                </c:pt>
                <c:pt idx="15">
                  <c:v>1.6717325227963507E-2</c:v>
                </c:pt>
                <c:pt idx="16">
                  <c:v>2.7355623100304E-2</c:v>
                </c:pt>
                <c:pt idx="17">
                  <c:v>3.3434650455927001E-2</c:v>
                </c:pt>
                <c:pt idx="18">
                  <c:v>2.4316109422492398E-2</c:v>
                </c:pt>
                <c:pt idx="19">
                  <c:v>1.6717325227963507E-2</c:v>
                </c:pt>
                <c:pt idx="20">
                  <c:v>1.6717325227963507E-2</c:v>
                </c:pt>
              </c:numCache>
            </c:numRef>
          </c:val>
        </c:ser>
        <c:ser>
          <c:idx val="27"/>
          <c:order val="27"/>
          <c:tx>
            <c:strRef>
              <c:f>'cat-1(CB1111)_A5_0.02_5%'!$AC$104</c:f>
              <c:strCache>
                <c:ptCount val="1"/>
                <c:pt idx="0">
                  <c:v>cat-1(CB1111)_A5_29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AC$105:$AC$125</c:f>
              <c:numCache>
                <c:formatCode>General</c:formatCode>
                <c:ptCount val="21"/>
                <c:pt idx="1">
                  <c:v>6.9696969696969702E-2</c:v>
                </c:pt>
                <c:pt idx="2">
                  <c:v>3.9393939393939398E-2</c:v>
                </c:pt>
                <c:pt idx="3">
                  <c:v>5.1515151515151486E-2</c:v>
                </c:pt>
                <c:pt idx="4">
                  <c:v>7.5757575757575801E-2</c:v>
                </c:pt>
                <c:pt idx="5">
                  <c:v>6.9696969696969702E-2</c:v>
                </c:pt>
                <c:pt idx="6">
                  <c:v>3.03030303030303E-2</c:v>
                </c:pt>
                <c:pt idx="7">
                  <c:v>3.9393939393939398E-2</c:v>
                </c:pt>
                <c:pt idx="8">
                  <c:v>5.7575757575757579E-2</c:v>
                </c:pt>
                <c:pt idx="9">
                  <c:v>3.6363636363636397E-2</c:v>
                </c:pt>
                <c:pt idx="10">
                  <c:v>4.8484848484848485E-2</c:v>
                </c:pt>
                <c:pt idx="11">
                  <c:v>5.7575757575757579E-2</c:v>
                </c:pt>
                <c:pt idx="12">
                  <c:v>4.8484848484848485E-2</c:v>
                </c:pt>
                <c:pt idx="13">
                  <c:v>3.9393939393939398E-2</c:v>
                </c:pt>
                <c:pt idx="14">
                  <c:v>4.2424242424242399E-2</c:v>
                </c:pt>
                <c:pt idx="15">
                  <c:v>3.03030303030303E-2</c:v>
                </c:pt>
                <c:pt idx="16">
                  <c:v>1.5151515151515204E-2</c:v>
                </c:pt>
                <c:pt idx="17">
                  <c:v>2.7272727272727313E-2</c:v>
                </c:pt>
                <c:pt idx="18">
                  <c:v>3.9393939393939398E-2</c:v>
                </c:pt>
                <c:pt idx="19">
                  <c:v>2.12121212121212E-2</c:v>
                </c:pt>
                <c:pt idx="20">
                  <c:v>1.2121212121212099E-2</c:v>
                </c:pt>
              </c:numCache>
            </c:numRef>
          </c:val>
        </c:ser>
        <c:ser>
          <c:idx val="28"/>
          <c:order val="28"/>
          <c:tx>
            <c:strRef>
              <c:f>'cat-1(CB1111)_A5_0.02_5%'!$AD$104</c:f>
              <c:strCache>
                <c:ptCount val="1"/>
                <c:pt idx="0">
                  <c:v>cat-1(CB1111)_A5_30</c:v>
                </c:pt>
              </c:strCache>
            </c:strRef>
          </c:tx>
          <c:marker>
            <c:symbol val="none"/>
          </c:marker>
          <c:cat>
            <c:numRef>
              <c:f>'cat-1(CB1111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5_0.02_5%'!$AD$105:$AD$125</c:f>
              <c:numCache>
                <c:formatCode>General</c:formatCode>
                <c:ptCount val="21"/>
                <c:pt idx="1">
                  <c:v>0.14854111405835499</c:v>
                </c:pt>
                <c:pt idx="2">
                  <c:v>0.14854111405835499</c:v>
                </c:pt>
                <c:pt idx="3">
                  <c:v>9.2838196286472136E-2</c:v>
                </c:pt>
                <c:pt idx="4">
                  <c:v>6.1007957559681719E-2</c:v>
                </c:pt>
                <c:pt idx="5">
                  <c:v>6.3660477453580902E-2</c:v>
                </c:pt>
                <c:pt idx="6">
                  <c:v>3.9787798408488097E-2</c:v>
                </c:pt>
                <c:pt idx="7">
                  <c:v>2.6525198938991999E-2</c:v>
                </c:pt>
                <c:pt idx="8">
                  <c:v>3.4482758620689717E-2</c:v>
                </c:pt>
                <c:pt idx="9">
                  <c:v>1.3262599469496004E-2</c:v>
                </c:pt>
                <c:pt idx="10">
                  <c:v>2.6525198938991999E-2</c:v>
                </c:pt>
                <c:pt idx="11">
                  <c:v>1.3262599469496004E-2</c:v>
                </c:pt>
                <c:pt idx="12">
                  <c:v>1.0610079575596799E-2</c:v>
                </c:pt>
                <c:pt idx="13">
                  <c:v>1.8567639257294401E-2</c:v>
                </c:pt>
                <c:pt idx="14">
                  <c:v>1.8567639257294401E-2</c:v>
                </c:pt>
                <c:pt idx="15">
                  <c:v>2.1220159151193598E-2</c:v>
                </c:pt>
                <c:pt idx="16">
                  <c:v>7.9575596816976128E-3</c:v>
                </c:pt>
                <c:pt idx="17">
                  <c:v>5.3050397877984099E-3</c:v>
                </c:pt>
                <c:pt idx="18">
                  <c:v>5.3050397877984099E-3</c:v>
                </c:pt>
                <c:pt idx="19">
                  <c:v>2.6525198938991998E-3</c:v>
                </c:pt>
                <c:pt idx="20">
                  <c:v>0</c:v>
                </c:pt>
              </c:numCache>
            </c:numRef>
          </c:val>
        </c:ser>
        <c:marker val="1"/>
        <c:axId val="160877568"/>
        <c:axId val="160908032"/>
      </c:lineChart>
      <c:catAx>
        <c:axId val="160877568"/>
        <c:scaling>
          <c:orientation val="minMax"/>
        </c:scaling>
        <c:axPos val="b"/>
        <c:numFmt formatCode="0.0_ " sourceLinked="1"/>
        <c:tickLblPos val="nextTo"/>
        <c:crossAx val="160908032"/>
        <c:crosses val="autoZero"/>
        <c:auto val="1"/>
        <c:lblAlgn val="ctr"/>
        <c:lblOffset val="100"/>
        <c:tickLblSkip val="5"/>
        <c:tickMarkSkip val="5"/>
      </c:catAx>
      <c:valAx>
        <c:axId val="16090803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0877568"/>
        <c:crosses val="autoZero"/>
        <c:crossBetween val="between"/>
      </c:valAx>
    </c:plotArea>
    <c:plotVisOnly val="1"/>
  </c:chart>
  <c:externalData r:id="rId1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1(CB1111)_A3_0.02_5%'!$B$104</c:f>
              <c:strCache>
                <c:ptCount val="1"/>
                <c:pt idx="0">
                  <c:v>cat-1(CB1111)_A3_01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B$105:$B$125</c:f>
              <c:numCache>
                <c:formatCode>General</c:formatCode>
                <c:ptCount val="21"/>
                <c:pt idx="1">
                  <c:v>8.6084905660377395E-2</c:v>
                </c:pt>
                <c:pt idx="2">
                  <c:v>9.4339622641509427E-2</c:v>
                </c:pt>
                <c:pt idx="3">
                  <c:v>7.6650943396226398E-2</c:v>
                </c:pt>
                <c:pt idx="4">
                  <c:v>9.787735849056603E-2</c:v>
                </c:pt>
                <c:pt idx="5">
                  <c:v>0.11792452830188703</c:v>
                </c:pt>
                <c:pt idx="6">
                  <c:v>6.1320754716981098E-2</c:v>
                </c:pt>
                <c:pt idx="7">
                  <c:v>5.4245283018867899E-2</c:v>
                </c:pt>
                <c:pt idx="8">
                  <c:v>5.6603773584905696E-2</c:v>
                </c:pt>
                <c:pt idx="9">
                  <c:v>3.8915094339622598E-2</c:v>
                </c:pt>
                <c:pt idx="10">
                  <c:v>4.1273584905660396E-2</c:v>
                </c:pt>
                <c:pt idx="11">
                  <c:v>3.1839622641509413E-2</c:v>
                </c:pt>
                <c:pt idx="12">
                  <c:v>3.5377358490566016E-2</c:v>
                </c:pt>
                <c:pt idx="13">
                  <c:v>1.7688679245283008E-2</c:v>
                </c:pt>
                <c:pt idx="14">
                  <c:v>2.3584905660377402E-2</c:v>
                </c:pt>
                <c:pt idx="15">
                  <c:v>2.0047169811320809E-2</c:v>
                </c:pt>
                <c:pt idx="16">
                  <c:v>2.2405660377358499E-2</c:v>
                </c:pt>
                <c:pt idx="17">
                  <c:v>2.0047169811320809E-2</c:v>
                </c:pt>
                <c:pt idx="18">
                  <c:v>1.06132075471698E-2</c:v>
                </c:pt>
                <c:pt idx="19">
                  <c:v>4.7169811320754698E-3</c:v>
                </c:pt>
                <c:pt idx="20">
                  <c:v>3.5377358490566017E-3</c:v>
                </c:pt>
              </c:numCache>
            </c:numRef>
          </c:val>
        </c:ser>
        <c:ser>
          <c:idx val="1"/>
          <c:order val="1"/>
          <c:tx>
            <c:strRef>
              <c:f>'cat-1(CB1111)_A3_0.02_5%'!$C$104</c:f>
              <c:strCache>
                <c:ptCount val="1"/>
                <c:pt idx="0">
                  <c:v>cat-1(CB1111)_A3_02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C$105:$C$125</c:f>
              <c:numCache>
                <c:formatCode>General</c:formatCode>
                <c:ptCount val="21"/>
                <c:pt idx="1">
                  <c:v>7.5029308323563887E-2</c:v>
                </c:pt>
                <c:pt idx="2">
                  <c:v>0.110199296600234</c:v>
                </c:pt>
                <c:pt idx="3">
                  <c:v>0.11606096131301299</c:v>
                </c:pt>
                <c:pt idx="4">
                  <c:v>0.126611957796014</c:v>
                </c:pt>
                <c:pt idx="5">
                  <c:v>9.8475967174677673E-2</c:v>
                </c:pt>
                <c:pt idx="6">
                  <c:v>7.8546307151231023E-2</c:v>
                </c:pt>
                <c:pt idx="7">
                  <c:v>6.4478311840562727E-2</c:v>
                </c:pt>
                <c:pt idx="8">
                  <c:v>4.6893317702227412E-2</c:v>
                </c:pt>
                <c:pt idx="9">
                  <c:v>3.5169988276670602E-2</c:v>
                </c:pt>
                <c:pt idx="10">
                  <c:v>3.86869871043376E-2</c:v>
                </c:pt>
                <c:pt idx="11">
                  <c:v>2.5791324736225099E-2</c:v>
                </c:pt>
                <c:pt idx="12">
                  <c:v>2.2274325908558008E-2</c:v>
                </c:pt>
                <c:pt idx="13">
                  <c:v>1.2895662368112501E-2</c:v>
                </c:pt>
                <c:pt idx="14">
                  <c:v>1.7584994138335301E-2</c:v>
                </c:pt>
                <c:pt idx="15">
                  <c:v>2.1101992966002306E-2</c:v>
                </c:pt>
                <c:pt idx="16">
                  <c:v>9.3786635404454945E-3</c:v>
                </c:pt>
                <c:pt idx="17">
                  <c:v>1.1723329425556905E-3</c:v>
                </c:pt>
                <c:pt idx="18">
                  <c:v>3.5169988276670602E-3</c:v>
                </c:pt>
                <c:pt idx="19">
                  <c:v>1.1723329425556905E-3</c:v>
                </c:pt>
                <c:pt idx="20">
                  <c:v>4.6893317702227403E-3</c:v>
                </c:pt>
              </c:numCache>
            </c:numRef>
          </c:val>
        </c:ser>
        <c:ser>
          <c:idx val="2"/>
          <c:order val="2"/>
          <c:tx>
            <c:strRef>
              <c:f>'cat-1(CB1111)_A3_0.02_5%'!$D$104</c:f>
              <c:strCache>
                <c:ptCount val="1"/>
                <c:pt idx="0">
                  <c:v>cat-1(CB1111)_A3_03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D$105:$D$125</c:f>
              <c:numCache>
                <c:formatCode>General</c:formatCode>
                <c:ptCount val="21"/>
                <c:pt idx="1">
                  <c:v>0.10340775558166899</c:v>
                </c:pt>
                <c:pt idx="2">
                  <c:v>7.8730904817861352E-2</c:v>
                </c:pt>
                <c:pt idx="3">
                  <c:v>6.8155111633372498E-2</c:v>
                </c:pt>
                <c:pt idx="4">
                  <c:v>0.14688601645123406</c:v>
                </c:pt>
                <c:pt idx="5">
                  <c:v>0.10340775558166899</c:v>
                </c:pt>
                <c:pt idx="6">
                  <c:v>6.6980023501762603E-2</c:v>
                </c:pt>
                <c:pt idx="7">
                  <c:v>3.6427732079906017E-2</c:v>
                </c:pt>
                <c:pt idx="8">
                  <c:v>3.8777908343125715E-2</c:v>
                </c:pt>
                <c:pt idx="9">
                  <c:v>2.3501762632197398E-2</c:v>
                </c:pt>
                <c:pt idx="10">
                  <c:v>3.0552291421856601E-2</c:v>
                </c:pt>
                <c:pt idx="11">
                  <c:v>3.5252643948296102E-2</c:v>
                </c:pt>
                <c:pt idx="12">
                  <c:v>3.1727379553466516E-2</c:v>
                </c:pt>
                <c:pt idx="13">
                  <c:v>1.6451233842538205E-2</c:v>
                </c:pt>
                <c:pt idx="14">
                  <c:v>2.1151586368977692E-2</c:v>
                </c:pt>
                <c:pt idx="15">
                  <c:v>1.52761457109283E-2</c:v>
                </c:pt>
                <c:pt idx="16">
                  <c:v>1.0575793184488799E-2</c:v>
                </c:pt>
                <c:pt idx="17">
                  <c:v>1.4101057579318401E-2</c:v>
                </c:pt>
                <c:pt idx="18">
                  <c:v>1.52761457109283E-2</c:v>
                </c:pt>
                <c:pt idx="19">
                  <c:v>1.1750881316098707E-2</c:v>
                </c:pt>
                <c:pt idx="20">
                  <c:v>1.2925969447708604E-2</c:v>
                </c:pt>
              </c:numCache>
            </c:numRef>
          </c:val>
        </c:ser>
        <c:ser>
          <c:idx val="3"/>
          <c:order val="3"/>
          <c:tx>
            <c:strRef>
              <c:f>'cat-1(CB1111)_A3_0.02_5%'!$E$104</c:f>
              <c:strCache>
                <c:ptCount val="1"/>
                <c:pt idx="0">
                  <c:v>cat-1(CB1111)_A3_04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E$105:$E$125</c:f>
              <c:numCache>
                <c:formatCode>General</c:formatCode>
                <c:ptCount val="21"/>
                <c:pt idx="1">
                  <c:v>7.8224101479915389E-2</c:v>
                </c:pt>
                <c:pt idx="2">
                  <c:v>0.101479915433404</c:v>
                </c:pt>
                <c:pt idx="3">
                  <c:v>0.118393234672304</c:v>
                </c:pt>
                <c:pt idx="4">
                  <c:v>0.13424947145877406</c:v>
                </c:pt>
                <c:pt idx="5">
                  <c:v>0.127906976744186</c:v>
                </c:pt>
                <c:pt idx="6">
                  <c:v>7.5052854122621623E-2</c:v>
                </c:pt>
                <c:pt idx="7">
                  <c:v>3.9112050739957688E-2</c:v>
                </c:pt>
                <c:pt idx="8">
                  <c:v>4.96828752642706E-2</c:v>
                </c:pt>
                <c:pt idx="9">
                  <c:v>3.5940803382663811E-2</c:v>
                </c:pt>
                <c:pt idx="10">
                  <c:v>2.9598308668076112E-2</c:v>
                </c:pt>
                <c:pt idx="11">
                  <c:v>2.9598308668076112E-2</c:v>
                </c:pt>
                <c:pt idx="12">
                  <c:v>2.85412262156448E-2</c:v>
                </c:pt>
                <c:pt idx="13">
                  <c:v>1.3742071881606805E-2</c:v>
                </c:pt>
                <c:pt idx="14">
                  <c:v>2.2198731501057101E-2</c:v>
                </c:pt>
                <c:pt idx="15">
                  <c:v>1.1627906976744195E-2</c:v>
                </c:pt>
                <c:pt idx="16">
                  <c:v>8.4566596194503279E-3</c:v>
                </c:pt>
                <c:pt idx="17">
                  <c:v>7.3995771670190315E-3</c:v>
                </c:pt>
                <c:pt idx="18">
                  <c:v>9.5137420718816191E-3</c:v>
                </c:pt>
                <c:pt idx="19">
                  <c:v>3.1712473572938701E-3</c:v>
                </c:pt>
                <c:pt idx="20">
                  <c:v>5.2854122621564482E-3</c:v>
                </c:pt>
              </c:numCache>
            </c:numRef>
          </c:val>
        </c:ser>
        <c:ser>
          <c:idx val="4"/>
          <c:order val="4"/>
          <c:tx>
            <c:strRef>
              <c:f>'cat-1(CB1111)_A3_0.02_5%'!$F$104</c:f>
              <c:strCache>
                <c:ptCount val="1"/>
                <c:pt idx="0">
                  <c:v>cat-1(CB1111)_A3_05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F$105:$F$125</c:f>
              <c:numCache>
                <c:formatCode>General</c:formatCode>
                <c:ptCount val="21"/>
                <c:pt idx="1">
                  <c:v>8.0976863753213474E-2</c:v>
                </c:pt>
                <c:pt idx="2">
                  <c:v>0.10796915167095103</c:v>
                </c:pt>
                <c:pt idx="3">
                  <c:v>0.12339331619537297</c:v>
                </c:pt>
                <c:pt idx="4">
                  <c:v>0.12724935732647807</c:v>
                </c:pt>
                <c:pt idx="5">
                  <c:v>0.105398457583548</c:v>
                </c:pt>
                <c:pt idx="6">
                  <c:v>8.8688946015424208E-2</c:v>
                </c:pt>
                <c:pt idx="7">
                  <c:v>6.0411311053984611E-2</c:v>
                </c:pt>
                <c:pt idx="8">
                  <c:v>4.8843187660668384E-2</c:v>
                </c:pt>
                <c:pt idx="9">
                  <c:v>3.3419023136246798E-2</c:v>
                </c:pt>
                <c:pt idx="10">
                  <c:v>3.5989717223650415E-2</c:v>
                </c:pt>
                <c:pt idx="11">
                  <c:v>2.1850899742930599E-2</c:v>
                </c:pt>
                <c:pt idx="12">
                  <c:v>1.9280205655527006E-2</c:v>
                </c:pt>
                <c:pt idx="13">
                  <c:v>1.6709511568123406E-2</c:v>
                </c:pt>
                <c:pt idx="14">
                  <c:v>1.2853470437018007E-2</c:v>
                </c:pt>
                <c:pt idx="15">
                  <c:v>6.4267352185090002E-3</c:v>
                </c:pt>
                <c:pt idx="16">
                  <c:v>6.4267352185090002E-3</c:v>
                </c:pt>
                <c:pt idx="17">
                  <c:v>7.7120822622108003E-3</c:v>
                </c:pt>
                <c:pt idx="18">
                  <c:v>5.1413881748072019E-3</c:v>
                </c:pt>
                <c:pt idx="19">
                  <c:v>3.8560411311053997E-3</c:v>
                </c:pt>
                <c:pt idx="20">
                  <c:v>1.2853470437018009E-3</c:v>
                </c:pt>
              </c:numCache>
            </c:numRef>
          </c:val>
        </c:ser>
        <c:ser>
          <c:idx val="5"/>
          <c:order val="5"/>
          <c:tx>
            <c:strRef>
              <c:f>'cat-1(CB1111)_A3_0.02_5%'!$G$104</c:f>
              <c:strCache>
                <c:ptCount val="1"/>
                <c:pt idx="0">
                  <c:v>cat-1(CB1111)_A3_06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G$105:$G$125</c:f>
              <c:numCache>
                <c:formatCode>General</c:formatCode>
                <c:ptCount val="21"/>
                <c:pt idx="1">
                  <c:v>7.3298429319371722E-2</c:v>
                </c:pt>
                <c:pt idx="2">
                  <c:v>9.2931937172774884E-2</c:v>
                </c:pt>
                <c:pt idx="3">
                  <c:v>0.12434554973822005</c:v>
                </c:pt>
                <c:pt idx="4">
                  <c:v>0.12172774869109899</c:v>
                </c:pt>
                <c:pt idx="5">
                  <c:v>9.4240837696335081E-2</c:v>
                </c:pt>
                <c:pt idx="6">
                  <c:v>8.5078534031413605E-2</c:v>
                </c:pt>
                <c:pt idx="7">
                  <c:v>4.8429319371727779E-2</c:v>
                </c:pt>
                <c:pt idx="8">
                  <c:v>5.6282722513088995E-2</c:v>
                </c:pt>
                <c:pt idx="9">
                  <c:v>4.3193717277486915E-2</c:v>
                </c:pt>
                <c:pt idx="10">
                  <c:v>3.9267015706806317E-2</c:v>
                </c:pt>
                <c:pt idx="11">
                  <c:v>3.01047120418848E-2</c:v>
                </c:pt>
                <c:pt idx="12">
                  <c:v>2.6178010471204216E-2</c:v>
                </c:pt>
                <c:pt idx="13">
                  <c:v>1.7015706806282699E-2</c:v>
                </c:pt>
                <c:pt idx="14">
                  <c:v>1.5706806282722505E-2</c:v>
                </c:pt>
                <c:pt idx="15">
                  <c:v>9.1623036649214704E-3</c:v>
                </c:pt>
                <c:pt idx="16">
                  <c:v>5.235602094240845E-3</c:v>
                </c:pt>
                <c:pt idx="17">
                  <c:v>1.3089005235602108E-2</c:v>
                </c:pt>
                <c:pt idx="18">
                  <c:v>6.5445026178010497E-3</c:v>
                </c:pt>
                <c:pt idx="19">
                  <c:v>6.5445026178010497E-3</c:v>
                </c:pt>
                <c:pt idx="20">
                  <c:v>1.3089005235602108E-3</c:v>
                </c:pt>
              </c:numCache>
            </c:numRef>
          </c:val>
        </c:ser>
        <c:ser>
          <c:idx val="6"/>
          <c:order val="6"/>
          <c:tx>
            <c:strRef>
              <c:f>'cat-1(CB1111)_A3_0.02_5%'!$H$104</c:f>
              <c:strCache>
                <c:ptCount val="1"/>
                <c:pt idx="0">
                  <c:v>cat-1(CB1111)_A3_07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H$105:$H$125</c:f>
              <c:numCache>
                <c:formatCode>General</c:formatCode>
                <c:ptCount val="21"/>
                <c:pt idx="1">
                  <c:v>7.1593533487297897E-2</c:v>
                </c:pt>
                <c:pt idx="2">
                  <c:v>9.8152424942263353E-2</c:v>
                </c:pt>
                <c:pt idx="3">
                  <c:v>0.13394919168591207</c:v>
                </c:pt>
                <c:pt idx="4">
                  <c:v>0.14203233256351006</c:v>
                </c:pt>
                <c:pt idx="5">
                  <c:v>9.2378752886836002E-2</c:v>
                </c:pt>
                <c:pt idx="6">
                  <c:v>5.311778290993073E-2</c:v>
                </c:pt>
                <c:pt idx="7">
                  <c:v>5.311778290993073E-2</c:v>
                </c:pt>
                <c:pt idx="8">
                  <c:v>4.5034642032332622E-2</c:v>
                </c:pt>
                <c:pt idx="9">
                  <c:v>4.1570438799076202E-2</c:v>
                </c:pt>
                <c:pt idx="10">
                  <c:v>3.9260969976905299E-2</c:v>
                </c:pt>
                <c:pt idx="11">
                  <c:v>3.6951501154734404E-2</c:v>
                </c:pt>
                <c:pt idx="12">
                  <c:v>2.42494226327945E-2</c:v>
                </c:pt>
                <c:pt idx="13">
                  <c:v>1.7321016166281799E-2</c:v>
                </c:pt>
                <c:pt idx="14">
                  <c:v>9.2378752886835992E-3</c:v>
                </c:pt>
                <c:pt idx="15">
                  <c:v>1.15473441108545E-2</c:v>
                </c:pt>
                <c:pt idx="16">
                  <c:v>1.38568129330254E-2</c:v>
                </c:pt>
                <c:pt idx="17">
                  <c:v>5.7736720554272536E-3</c:v>
                </c:pt>
                <c:pt idx="18">
                  <c:v>9.2378752886835992E-3</c:v>
                </c:pt>
                <c:pt idx="19">
                  <c:v>4.6189376443417996E-3</c:v>
                </c:pt>
                <c:pt idx="20">
                  <c:v>1.1547344110854501E-3</c:v>
                </c:pt>
              </c:numCache>
            </c:numRef>
          </c:val>
        </c:ser>
        <c:ser>
          <c:idx val="7"/>
          <c:order val="7"/>
          <c:tx>
            <c:strRef>
              <c:f>'cat-1(CB1111)_A3_0.02_5%'!$I$104</c:f>
              <c:strCache>
                <c:ptCount val="1"/>
                <c:pt idx="0">
                  <c:v>cat-1(CB1111)_A3_08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I$105:$I$125</c:f>
              <c:numCache>
                <c:formatCode>General</c:formatCode>
                <c:ptCount val="21"/>
                <c:pt idx="1">
                  <c:v>9.2817679558011096E-2</c:v>
                </c:pt>
                <c:pt idx="2">
                  <c:v>0.10386740331491701</c:v>
                </c:pt>
                <c:pt idx="3">
                  <c:v>0.114917127071823</c:v>
                </c:pt>
                <c:pt idx="4">
                  <c:v>0.113812154696133</c:v>
                </c:pt>
                <c:pt idx="5">
                  <c:v>0.10718232044198908</c:v>
                </c:pt>
                <c:pt idx="6">
                  <c:v>6.740331491712713E-2</c:v>
                </c:pt>
                <c:pt idx="7">
                  <c:v>5.9668508287292796E-2</c:v>
                </c:pt>
                <c:pt idx="8">
                  <c:v>4.9723756906077318E-2</c:v>
                </c:pt>
                <c:pt idx="9">
                  <c:v>2.4309392265193408E-2</c:v>
                </c:pt>
                <c:pt idx="10">
                  <c:v>3.4254143646408802E-2</c:v>
                </c:pt>
                <c:pt idx="11">
                  <c:v>1.8784530386740307E-2</c:v>
                </c:pt>
                <c:pt idx="12">
                  <c:v>2.9834254143646398E-2</c:v>
                </c:pt>
                <c:pt idx="13">
                  <c:v>1.6574585635359108E-2</c:v>
                </c:pt>
                <c:pt idx="14">
                  <c:v>1.9889502762430906E-2</c:v>
                </c:pt>
                <c:pt idx="15">
                  <c:v>1.5469613259668504E-2</c:v>
                </c:pt>
                <c:pt idx="16">
                  <c:v>1.4364640883977899E-2</c:v>
                </c:pt>
                <c:pt idx="17">
                  <c:v>1.215469613259669E-2</c:v>
                </c:pt>
                <c:pt idx="18">
                  <c:v>6.6298342541436499E-3</c:v>
                </c:pt>
                <c:pt idx="19">
                  <c:v>1.32596685082873E-2</c:v>
                </c:pt>
                <c:pt idx="20">
                  <c:v>8.8397790055248643E-3</c:v>
                </c:pt>
              </c:numCache>
            </c:numRef>
          </c:val>
        </c:ser>
        <c:ser>
          <c:idx val="8"/>
          <c:order val="8"/>
          <c:tx>
            <c:strRef>
              <c:f>'cat-1(CB1111)_A3_0.02_5%'!$J$104</c:f>
              <c:strCache>
                <c:ptCount val="1"/>
                <c:pt idx="0">
                  <c:v>cat-1(CB1111)_A3_09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J$105:$J$125</c:f>
              <c:numCache>
                <c:formatCode>General</c:formatCode>
                <c:ptCount val="21"/>
                <c:pt idx="1">
                  <c:v>7.9128440366972488E-2</c:v>
                </c:pt>
                <c:pt idx="2">
                  <c:v>8.9449541284403702E-2</c:v>
                </c:pt>
                <c:pt idx="3">
                  <c:v>0.11697247706422002</c:v>
                </c:pt>
                <c:pt idx="4">
                  <c:v>0.12729357798165095</c:v>
                </c:pt>
                <c:pt idx="5">
                  <c:v>0.11697247706422002</c:v>
                </c:pt>
                <c:pt idx="6">
                  <c:v>6.4220183486238494E-2</c:v>
                </c:pt>
                <c:pt idx="7">
                  <c:v>7.4541284403669694E-2</c:v>
                </c:pt>
                <c:pt idx="8">
                  <c:v>5.5045871559633003E-2</c:v>
                </c:pt>
                <c:pt idx="9">
                  <c:v>3.0963302752293611E-2</c:v>
                </c:pt>
                <c:pt idx="10">
                  <c:v>3.4403669724770616E-2</c:v>
                </c:pt>
                <c:pt idx="11">
                  <c:v>2.9816513761467899E-2</c:v>
                </c:pt>
                <c:pt idx="12">
                  <c:v>2.4082568807339493E-2</c:v>
                </c:pt>
                <c:pt idx="13">
                  <c:v>1.8348623853211E-2</c:v>
                </c:pt>
                <c:pt idx="14">
                  <c:v>1.1467889908256904E-2</c:v>
                </c:pt>
                <c:pt idx="15">
                  <c:v>9.1743119266055103E-3</c:v>
                </c:pt>
                <c:pt idx="16">
                  <c:v>3.4403669724770618E-3</c:v>
                </c:pt>
                <c:pt idx="17">
                  <c:v>1.1467889908256904E-2</c:v>
                </c:pt>
                <c:pt idx="18">
                  <c:v>1.0321100917431204E-2</c:v>
                </c:pt>
                <c:pt idx="19">
                  <c:v>6.880733944954134E-3</c:v>
                </c:pt>
                <c:pt idx="20">
                  <c:v>2.2935779816513819E-3</c:v>
                </c:pt>
              </c:numCache>
            </c:numRef>
          </c:val>
        </c:ser>
        <c:ser>
          <c:idx val="9"/>
          <c:order val="9"/>
          <c:tx>
            <c:strRef>
              <c:f>'cat-1(CB1111)_A3_0.02_5%'!$K$104</c:f>
              <c:strCache>
                <c:ptCount val="1"/>
                <c:pt idx="0">
                  <c:v>cat-1(CB1111)_A3_10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K$105:$K$125</c:f>
              <c:numCache>
                <c:formatCode>General</c:formatCode>
                <c:ptCount val="21"/>
                <c:pt idx="1">
                  <c:v>8.251633986928103E-2</c:v>
                </c:pt>
                <c:pt idx="2">
                  <c:v>9.6405228758169939E-2</c:v>
                </c:pt>
                <c:pt idx="3">
                  <c:v>0.11683006535947697</c:v>
                </c:pt>
                <c:pt idx="4">
                  <c:v>0.12745098039215699</c:v>
                </c:pt>
                <c:pt idx="5">
                  <c:v>0.12908496732026101</c:v>
                </c:pt>
                <c:pt idx="6">
                  <c:v>7.1078431372549003E-2</c:v>
                </c:pt>
                <c:pt idx="7">
                  <c:v>4.5751633986928136E-2</c:v>
                </c:pt>
                <c:pt idx="8">
                  <c:v>5.555555555555558E-2</c:v>
                </c:pt>
                <c:pt idx="9">
                  <c:v>3.9215686274509803E-2</c:v>
                </c:pt>
                <c:pt idx="10">
                  <c:v>4.4934640522875803E-2</c:v>
                </c:pt>
                <c:pt idx="11">
                  <c:v>2.9411764705882398E-2</c:v>
                </c:pt>
                <c:pt idx="12">
                  <c:v>2.6143790849673214E-2</c:v>
                </c:pt>
                <c:pt idx="13">
                  <c:v>1.7156862745097999E-2</c:v>
                </c:pt>
                <c:pt idx="14">
                  <c:v>1.3888888888888907E-2</c:v>
                </c:pt>
                <c:pt idx="15">
                  <c:v>1.1437908496731999E-2</c:v>
                </c:pt>
                <c:pt idx="16">
                  <c:v>7.3529411764705899E-3</c:v>
                </c:pt>
                <c:pt idx="17">
                  <c:v>3.2679738562091526E-3</c:v>
                </c:pt>
                <c:pt idx="18">
                  <c:v>1.6339869281045804E-3</c:v>
                </c:pt>
                <c:pt idx="19">
                  <c:v>6.5359477124183035E-3</c:v>
                </c:pt>
                <c:pt idx="20">
                  <c:v>2.4509803921568601E-3</c:v>
                </c:pt>
              </c:numCache>
            </c:numRef>
          </c:val>
        </c:ser>
        <c:ser>
          <c:idx val="10"/>
          <c:order val="10"/>
          <c:tx>
            <c:strRef>
              <c:f>'cat-1(CB1111)_A3_0.02_5%'!$L$104</c:f>
              <c:strCache>
                <c:ptCount val="1"/>
                <c:pt idx="0">
                  <c:v>cat-1(CB1111)_A3_11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L$105:$L$125</c:f>
              <c:numCache>
                <c:formatCode>General</c:formatCode>
                <c:ptCount val="21"/>
                <c:pt idx="1">
                  <c:v>5.9829059829059804E-2</c:v>
                </c:pt>
                <c:pt idx="2">
                  <c:v>8.8319088319088329E-2</c:v>
                </c:pt>
                <c:pt idx="3">
                  <c:v>7.6923076923076913E-2</c:v>
                </c:pt>
                <c:pt idx="4">
                  <c:v>9.9715099715099773E-2</c:v>
                </c:pt>
                <c:pt idx="5">
                  <c:v>9.9715099715099773E-2</c:v>
                </c:pt>
                <c:pt idx="6">
                  <c:v>5.8404558404558396E-2</c:v>
                </c:pt>
                <c:pt idx="7">
                  <c:v>4.2735042735042701E-2</c:v>
                </c:pt>
                <c:pt idx="8">
                  <c:v>5.1282051282051301E-2</c:v>
                </c:pt>
                <c:pt idx="9">
                  <c:v>4.1310541310541321E-2</c:v>
                </c:pt>
                <c:pt idx="10">
                  <c:v>2.8490028490028501E-2</c:v>
                </c:pt>
                <c:pt idx="11">
                  <c:v>5.2706552706552702E-2</c:v>
                </c:pt>
                <c:pt idx="12">
                  <c:v>2.8490028490028501E-2</c:v>
                </c:pt>
                <c:pt idx="13">
                  <c:v>3.4188034188034198E-2</c:v>
                </c:pt>
                <c:pt idx="14">
                  <c:v>2.9914529914529892E-2</c:v>
                </c:pt>
                <c:pt idx="15">
                  <c:v>2.27920227920228E-2</c:v>
                </c:pt>
                <c:pt idx="16">
                  <c:v>1.9943019943019908E-2</c:v>
                </c:pt>
                <c:pt idx="17">
                  <c:v>1.5669515669515709E-2</c:v>
                </c:pt>
                <c:pt idx="18">
                  <c:v>1.4245014245014204E-2</c:v>
                </c:pt>
                <c:pt idx="19">
                  <c:v>1.1396011396011404E-2</c:v>
                </c:pt>
                <c:pt idx="20">
                  <c:v>1.1396011396011404E-2</c:v>
                </c:pt>
              </c:numCache>
            </c:numRef>
          </c:val>
        </c:ser>
        <c:ser>
          <c:idx val="11"/>
          <c:order val="11"/>
          <c:tx>
            <c:strRef>
              <c:f>'cat-1(CB1111)_A3_0.02_5%'!$M$104</c:f>
              <c:strCache>
                <c:ptCount val="1"/>
                <c:pt idx="0">
                  <c:v>cat-1(CB1111)_A3_12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M$105:$M$125</c:f>
              <c:numCache>
                <c:formatCode>General</c:formatCode>
                <c:ptCount val="21"/>
                <c:pt idx="1">
                  <c:v>7.7922077922077934E-2</c:v>
                </c:pt>
                <c:pt idx="2">
                  <c:v>7.6741440377803991E-2</c:v>
                </c:pt>
                <c:pt idx="3">
                  <c:v>7.5560802833530102E-2</c:v>
                </c:pt>
                <c:pt idx="4">
                  <c:v>0.11334120425029499</c:v>
                </c:pt>
                <c:pt idx="5">
                  <c:v>8.3825265643447569E-2</c:v>
                </c:pt>
                <c:pt idx="6">
                  <c:v>3.7780401416765114E-2</c:v>
                </c:pt>
                <c:pt idx="7">
                  <c:v>4.2502951593860715E-2</c:v>
                </c:pt>
                <c:pt idx="8">
                  <c:v>5.0767414403778036E-2</c:v>
                </c:pt>
                <c:pt idx="9">
                  <c:v>3.1877213695395527E-2</c:v>
                </c:pt>
                <c:pt idx="10">
                  <c:v>2.8335301062573814E-2</c:v>
                </c:pt>
                <c:pt idx="11">
                  <c:v>4.9586776859504127E-2</c:v>
                </c:pt>
                <c:pt idx="12">
                  <c:v>3.6599763872491115E-2</c:v>
                </c:pt>
                <c:pt idx="13">
                  <c:v>2.7154663518299905E-2</c:v>
                </c:pt>
                <c:pt idx="14">
                  <c:v>2.1251475796930298E-2</c:v>
                </c:pt>
                <c:pt idx="15">
                  <c:v>2.4793388429752112E-2</c:v>
                </c:pt>
                <c:pt idx="16">
                  <c:v>2.8335301062573814E-2</c:v>
                </c:pt>
                <c:pt idx="17">
                  <c:v>2.36127508854782E-2</c:v>
                </c:pt>
                <c:pt idx="18">
                  <c:v>1.5348288075560801E-2</c:v>
                </c:pt>
                <c:pt idx="19">
                  <c:v>8.2644628099173643E-3</c:v>
                </c:pt>
                <c:pt idx="20">
                  <c:v>9.4451003541912645E-3</c:v>
                </c:pt>
              </c:numCache>
            </c:numRef>
          </c:val>
        </c:ser>
        <c:ser>
          <c:idx val="12"/>
          <c:order val="12"/>
          <c:tx>
            <c:strRef>
              <c:f>'cat-1(CB1111)_A3_0.02_5%'!$N$104</c:f>
              <c:strCache>
                <c:ptCount val="1"/>
                <c:pt idx="0">
                  <c:v>cat-1(CB1111)_A3_13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N$105:$N$125</c:f>
              <c:numCache>
                <c:formatCode>General</c:formatCode>
                <c:ptCount val="21"/>
                <c:pt idx="1">
                  <c:v>5.9011164274322216E-2</c:v>
                </c:pt>
                <c:pt idx="2">
                  <c:v>0.10207336523126002</c:v>
                </c:pt>
                <c:pt idx="3">
                  <c:v>5.7416267942583754E-2</c:v>
                </c:pt>
                <c:pt idx="4">
                  <c:v>0.105263157894737</c:v>
                </c:pt>
                <c:pt idx="5">
                  <c:v>9.7288676236044661E-2</c:v>
                </c:pt>
                <c:pt idx="6">
                  <c:v>5.9011164274322216E-2</c:v>
                </c:pt>
                <c:pt idx="7">
                  <c:v>4.1467304625199403E-2</c:v>
                </c:pt>
                <c:pt idx="8">
                  <c:v>6.2200956937799014E-2</c:v>
                </c:pt>
                <c:pt idx="9">
                  <c:v>4.3062200956937836E-2</c:v>
                </c:pt>
                <c:pt idx="10">
                  <c:v>3.5087719298245605E-2</c:v>
                </c:pt>
                <c:pt idx="11">
                  <c:v>4.7846889952153117E-2</c:v>
                </c:pt>
                <c:pt idx="12">
                  <c:v>3.03030303030303E-2</c:v>
                </c:pt>
                <c:pt idx="13">
                  <c:v>2.5518341307814999E-2</c:v>
                </c:pt>
                <c:pt idx="14">
                  <c:v>2.0733652312599708E-2</c:v>
                </c:pt>
                <c:pt idx="15">
                  <c:v>3.189792663476871E-2</c:v>
                </c:pt>
                <c:pt idx="16">
                  <c:v>2.7113237639553416E-2</c:v>
                </c:pt>
                <c:pt idx="17">
                  <c:v>1.59489633173844E-2</c:v>
                </c:pt>
                <c:pt idx="18">
                  <c:v>9.5693779904306216E-3</c:v>
                </c:pt>
                <c:pt idx="19">
                  <c:v>1.5948963317384405E-3</c:v>
                </c:pt>
                <c:pt idx="20">
                  <c:v>1.1164274322169104E-2</c:v>
                </c:pt>
              </c:numCache>
            </c:numRef>
          </c:val>
        </c:ser>
        <c:ser>
          <c:idx val="13"/>
          <c:order val="13"/>
          <c:tx>
            <c:strRef>
              <c:f>'cat-1(CB1111)_A3_0.02_5%'!$O$104</c:f>
              <c:strCache>
                <c:ptCount val="1"/>
                <c:pt idx="0">
                  <c:v>cat-1(CB1111)_A3_14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O$105:$O$125</c:f>
              <c:numCache>
                <c:formatCode>General</c:formatCode>
                <c:ptCount val="21"/>
                <c:pt idx="1">
                  <c:v>6.8910256410256401E-2</c:v>
                </c:pt>
                <c:pt idx="2">
                  <c:v>9.7756410256410298E-2</c:v>
                </c:pt>
                <c:pt idx="3">
                  <c:v>9.2948717948717938E-2</c:v>
                </c:pt>
                <c:pt idx="4">
                  <c:v>7.3717948717948734E-2</c:v>
                </c:pt>
                <c:pt idx="5">
                  <c:v>9.615384615384627E-2</c:v>
                </c:pt>
                <c:pt idx="6">
                  <c:v>4.9679487179487197E-2</c:v>
                </c:pt>
                <c:pt idx="7">
                  <c:v>5.9294871794871813E-2</c:v>
                </c:pt>
                <c:pt idx="8">
                  <c:v>3.3653846153846201E-2</c:v>
                </c:pt>
                <c:pt idx="9">
                  <c:v>3.6858974358974415E-2</c:v>
                </c:pt>
                <c:pt idx="10">
                  <c:v>4.3269230769230796E-2</c:v>
                </c:pt>
                <c:pt idx="11">
                  <c:v>4.0064102564102588E-2</c:v>
                </c:pt>
                <c:pt idx="12">
                  <c:v>4.1666666666666699E-2</c:v>
                </c:pt>
                <c:pt idx="13">
                  <c:v>2.5641025641025609E-2</c:v>
                </c:pt>
                <c:pt idx="14">
                  <c:v>1.9230769230769208E-2</c:v>
                </c:pt>
                <c:pt idx="15">
                  <c:v>3.044871794871791E-2</c:v>
                </c:pt>
                <c:pt idx="16">
                  <c:v>1.1217948717948699E-2</c:v>
                </c:pt>
                <c:pt idx="17">
                  <c:v>1.6025641025641E-2</c:v>
                </c:pt>
                <c:pt idx="18">
                  <c:v>1.1217948717948699E-2</c:v>
                </c:pt>
                <c:pt idx="19">
                  <c:v>8.0128205128205138E-3</c:v>
                </c:pt>
                <c:pt idx="20">
                  <c:v>1.1217948717948699E-2</c:v>
                </c:pt>
              </c:numCache>
            </c:numRef>
          </c:val>
        </c:ser>
        <c:ser>
          <c:idx val="14"/>
          <c:order val="14"/>
          <c:tx>
            <c:strRef>
              <c:f>'cat-1(CB1111)_A3_0.02_5%'!$P$104</c:f>
              <c:strCache>
                <c:ptCount val="1"/>
                <c:pt idx="0">
                  <c:v>cat-1(CB1111)_A3_15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P$105:$P$125</c:f>
              <c:numCache>
                <c:formatCode>General</c:formatCode>
                <c:ptCount val="21"/>
                <c:pt idx="1">
                  <c:v>8.265424912689176E-2</c:v>
                </c:pt>
                <c:pt idx="2">
                  <c:v>8.3818393480791634E-2</c:v>
                </c:pt>
                <c:pt idx="3">
                  <c:v>6.9848661233993026E-2</c:v>
                </c:pt>
                <c:pt idx="4">
                  <c:v>9.0803259604190889E-2</c:v>
                </c:pt>
                <c:pt idx="5">
                  <c:v>0.10942956926658909</c:v>
                </c:pt>
                <c:pt idx="6">
                  <c:v>4.6565774155995318E-2</c:v>
                </c:pt>
                <c:pt idx="7">
                  <c:v>4.6565774155995318E-2</c:v>
                </c:pt>
                <c:pt idx="8">
                  <c:v>3.60884749708964E-2</c:v>
                </c:pt>
                <c:pt idx="9">
                  <c:v>3.60884749708964E-2</c:v>
                </c:pt>
                <c:pt idx="10">
                  <c:v>4.88940628637951E-2</c:v>
                </c:pt>
                <c:pt idx="11">
                  <c:v>4.0745052386495881E-2</c:v>
                </c:pt>
                <c:pt idx="12">
                  <c:v>5.5878928987194397E-2</c:v>
                </c:pt>
                <c:pt idx="13">
                  <c:v>4.1909196740395796E-2</c:v>
                </c:pt>
                <c:pt idx="14">
                  <c:v>2.0954598370197891E-2</c:v>
                </c:pt>
                <c:pt idx="15">
                  <c:v>1.8626309662398106E-2</c:v>
                </c:pt>
                <c:pt idx="16">
                  <c:v>2.2118742724097806E-2</c:v>
                </c:pt>
                <c:pt idx="17">
                  <c:v>1.62980209545984E-2</c:v>
                </c:pt>
                <c:pt idx="18">
                  <c:v>2.2118742724097806E-2</c:v>
                </c:pt>
                <c:pt idx="19">
                  <c:v>1.16414435389988E-2</c:v>
                </c:pt>
                <c:pt idx="20">
                  <c:v>6.9848661233993031E-3</c:v>
                </c:pt>
              </c:numCache>
            </c:numRef>
          </c:val>
        </c:ser>
        <c:ser>
          <c:idx val="15"/>
          <c:order val="15"/>
          <c:tx>
            <c:strRef>
              <c:f>'cat-1(CB1111)_A3_0.02_5%'!$Q$104</c:f>
              <c:strCache>
                <c:ptCount val="1"/>
                <c:pt idx="0">
                  <c:v>cat-1(CB1111)_A3_16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Q$105:$Q$125</c:f>
              <c:numCache>
                <c:formatCode>General</c:formatCode>
                <c:ptCount val="21"/>
                <c:pt idx="1">
                  <c:v>8.4507042253521153E-2</c:v>
                </c:pt>
                <c:pt idx="2">
                  <c:v>8.1488933601609664E-2</c:v>
                </c:pt>
                <c:pt idx="3">
                  <c:v>9.5573440643863236E-2</c:v>
                </c:pt>
                <c:pt idx="4">
                  <c:v>8.9537223340040259E-2</c:v>
                </c:pt>
                <c:pt idx="5">
                  <c:v>0.111670020120724</c:v>
                </c:pt>
                <c:pt idx="6">
                  <c:v>5.3319919517102597E-2</c:v>
                </c:pt>
                <c:pt idx="7">
                  <c:v>3.5211267605633818E-2</c:v>
                </c:pt>
                <c:pt idx="8">
                  <c:v>5.2313883299798823E-2</c:v>
                </c:pt>
                <c:pt idx="9">
                  <c:v>4.5271629778671982E-2</c:v>
                </c:pt>
                <c:pt idx="10">
                  <c:v>2.91750503018109E-2</c:v>
                </c:pt>
                <c:pt idx="11">
                  <c:v>3.420523138833001E-2</c:v>
                </c:pt>
                <c:pt idx="12">
                  <c:v>4.4265593561368201E-2</c:v>
                </c:pt>
                <c:pt idx="13">
                  <c:v>3.3199195171026201E-2</c:v>
                </c:pt>
                <c:pt idx="14">
                  <c:v>2.8169014084506998E-2</c:v>
                </c:pt>
                <c:pt idx="15">
                  <c:v>2.2132796780684111E-2</c:v>
                </c:pt>
                <c:pt idx="16">
                  <c:v>1.9114688128772601E-2</c:v>
                </c:pt>
                <c:pt idx="17">
                  <c:v>1.5090543259557304E-2</c:v>
                </c:pt>
                <c:pt idx="18">
                  <c:v>2.4144869215291694E-2</c:v>
                </c:pt>
                <c:pt idx="19">
                  <c:v>8.0482897384305772E-3</c:v>
                </c:pt>
                <c:pt idx="20">
                  <c:v>1.1066398390342104E-2</c:v>
                </c:pt>
              </c:numCache>
            </c:numRef>
          </c:val>
        </c:ser>
        <c:ser>
          <c:idx val="16"/>
          <c:order val="16"/>
          <c:tx>
            <c:strRef>
              <c:f>'cat-1(CB1111)_A3_0.02_5%'!$R$104</c:f>
              <c:strCache>
                <c:ptCount val="1"/>
                <c:pt idx="0">
                  <c:v>cat-1(CB1111)_A3_17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R$105:$R$125</c:f>
              <c:numCache>
                <c:formatCode>General</c:formatCode>
                <c:ptCount val="21"/>
                <c:pt idx="1">
                  <c:v>9.3447905477980708E-2</c:v>
                </c:pt>
                <c:pt idx="2">
                  <c:v>0.10096670247046204</c:v>
                </c:pt>
                <c:pt idx="3">
                  <c:v>9.8818474758324434E-2</c:v>
                </c:pt>
                <c:pt idx="4">
                  <c:v>0.11385606874328702</c:v>
                </c:pt>
                <c:pt idx="5">
                  <c:v>0.105263157894737</c:v>
                </c:pt>
                <c:pt idx="6">
                  <c:v>3.5445757250268516E-2</c:v>
                </c:pt>
                <c:pt idx="7">
                  <c:v>4.4038668098818519E-2</c:v>
                </c:pt>
                <c:pt idx="8">
                  <c:v>4.5112781954887243E-2</c:v>
                </c:pt>
                <c:pt idx="9">
                  <c:v>3.2223415682062322E-2</c:v>
                </c:pt>
                <c:pt idx="10">
                  <c:v>3.4371643394199805E-2</c:v>
                </c:pt>
                <c:pt idx="11">
                  <c:v>3.1149301825993615E-2</c:v>
                </c:pt>
                <c:pt idx="12">
                  <c:v>3.0075187969924817E-2</c:v>
                </c:pt>
                <c:pt idx="13">
                  <c:v>1.8259935553168599E-2</c:v>
                </c:pt>
                <c:pt idx="14">
                  <c:v>2.5778732545649809E-2</c:v>
                </c:pt>
                <c:pt idx="15">
                  <c:v>1.7185821697099906E-2</c:v>
                </c:pt>
                <c:pt idx="16">
                  <c:v>1.6111707841031202E-2</c:v>
                </c:pt>
                <c:pt idx="17">
                  <c:v>1.7185821697099906E-2</c:v>
                </c:pt>
                <c:pt idx="18">
                  <c:v>1.7185821697099906E-2</c:v>
                </c:pt>
                <c:pt idx="19">
                  <c:v>9.6670247046186895E-3</c:v>
                </c:pt>
                <c:pt idx="20">
                  <c:v>4.2964554242749722E-3</c:v>
                </c:pt>
              </c:numCache>
            </c:numRef>
          </c:val>
        </c:ser>
        <c:ser>
          <c:idx val="17"/>
          <c:order val="17"/>
          <c:tx>
            <c:strRef>
              <c:f>'cat-1(CB1111)_A3_0.02_5%'!$S$104</c:f>
              <c:strCache>
                <c:ptCount val="1"/>
                <c:pt idx="0">
                  <c:v>cat-1(CB1111)_A3_18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S$105:$S$125</c:f>
              <c:numCache>
                <c:formatCode>General</c:formatCode>
                <c:ptCount val="21"/>
                <c:pt idx="1">
                  <c:v>7.0886075949367133E-2</c:v>
                </c:pt>
                <c:pt idx="2">
                  <c:v>7.5949367088607597E-2</c:v>
                </c:pt>
                <c:pt idx="3">
                  <c:v>8.9873417721518981E-2</c:v>
                </c:pt>
                <c:pt idx="4">
                  <c:v>0.10253164556962004</c:v>
                </c:pt>
                <c:pt idx="5">
                  <c:v>7.8481012658227906E-2</c:v>
                </c:pt>
                <c:pt idx="6">
                  <c:v>4.5569620253164599E-2</c:v>
                </c:pt>
                <c:pt idx="7">
                  <c:v>4.3037974683544304E-2</c:v>
                </c:pt>
                <c:pt idx="8">
                  <c:v>4.1772151898734199E-2</c:v>
                </c:pt>
                <c:pt idx="9">
                  <c:v>4.8101265822784796E-2</c:v>
                </c:pt>
                <c:pt idx="10">
                  <c:v>4.3037974683544304E-2</c:v>
                </c:pt>
                <c:pt idx="11">
                  <c:v>4.5569620253164599E-2</c:v>
                </c:pt>
                <c:pt idx="12">
                  <c:v>4.05063291139241E-2</c:v>
                </c:pt>
                <c:pt idx="13">
                  <c:v>4.05063291139241E-2</c:v>
                </c:pt>
                <c:pt idx="14">
                  <c:v>2.4050632911392398E-2</c:v>
                </c:pt>
                <c:pt idx="15">
                  <c:v>1.8987341772151899E-2</c:v>
                </c:pt>
                <c:pt idx="16">
                  <c:v>2.0253164556962001E-2</c:v>
                </c:pt>
                <c:pt idx="17">
                  <c:v>1.7721518987341801E-2</c:v>
                </c:pt>
                <c:pt idx="18">
                  <c:v>2.1518987341772197E-2</c:v>
                </c:pt>
                <c:pt idx="19">
                  <c:v>5.0632911392405116E-3</c:v>
                </c:pt>
                <c:pt idx="20">
                  <c:v>7.5949367088607601E-3</c:v>
                </c:pt>
              </c:numCache>
            </c:numRef>
          </c:val>
        </c:ser>
        <c:ser>
          <c:idx val="18"/>
          <c:order val="18"/>
          <c:tx>
            <c:strRef>
              <c:f>'cat-1(CB1111)_A3_0.02_5%'!$T$104</c:f>
              <c:strCache>
                <c:ptCount val="1"/>
                <c:pt idx="0">
                  <c:v>cat-1(CB1111)_A3_19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T$105:$T$125</c:f>
              <c:numCache>
                <c:formatCode>General</c:formatCode>
                <c:ptCount val="21"/>
                <c:pt idx="1">
                  <c:v>7.0619006102877094E-2</c:v>
                </c:pt>
                <c:pt idx="2">
                  <c:v>0.10113339145597203</c:v>
                </c:pt>
                <c:pt idx="3">
                  <c:v>9.6774193548387122E-2</c:v>
                </c:pt>
                <c:pt idx="4">
                  <c:v>0.11508282476024402</c:v>
                </c:pt>
                <c:pt idx="5">
                  <c:v>0.11857018308631204</c:v>
                </c:pt>
                <c:pt idx="6">
                  <c:v>5.2310374891020035E-2</c:v>
                </c:pt>
                <c:pt idx="7">
                  <c:v>5.4054054054054113E-2</c:v>
                </c:pt>
                <c:pt idx="8">
                  <c:v>4.3591979075849996E-2</c:v>
                </c:pt>
                <c:pt idx="9">
                  <c:v>4.5335658238884004E-2</c:v>
                </c:pt>
                <c:pt idx="10">
                  <c:v>3.0514385353094999E-2</c:v>
                </c:pt>
                <c:pt idx="11">
                  <c:v>3.4001743679163018E-2</c:v>
                </c:pt>
                <c:pt idx="12">
                  <c:v>3.0514385353094999E-2</c:v>
                </c:pt>
                <c:pt idx="13">
                  <c:v>2.0052310374891007E-2</c:v>
                </c:pt>
                <c:pt idx="14">
                  <c:v>1.3949433304272004E-2</c:v>
                </c:pt>
                <c:pt idx="15">
                  <c:v>1.6564952048823006E-2</c:v>
                </c:pt>
                <c:pt idx="16">
                  <c:v>1.3949433304272004E-2</c:v>
                </c:pt>
                <c:pt idx="17">
                  <c:v>8.7183958151700099E-3</c:v>
                </c:pt>
                <c:pt idx="18">
                  <c:v>1.3949433304272004E-2</c:v>
                </c:pt>
                <c:pt idx="19">
                  <c:v>8.7183958151700099E-3</c:v>
                </c:pt>
                <c:pt idx="20">
                  <c:v>8.7183958151700099E-3</c:v>
                </c:pt>
              </c:numCache>
            </c:numRef>
          </c:val>
        </c:ser>
        <c:ser>
          <c:idx val="19"/>
          <c:order val="19"/>
          <c:tx>
            <c:strRef>
              <c:f>'cat-1(CB1111)_A3_0.02_5%'!$U$104</c:f>
              <c:strCache>
                <c:ptCount val="1"/>
                <c:pt idx="0">
                  <c:v>cat-1(CB1111)_A3_20</c:v>
                </c:pt>
              </c:strCache>
            </c:strRef>
          </c:tx>
          <c:marker>
            <c:symbol val="none"/>
          </c:marker>
          <c:cat>
            <c:numRef>
              <c:f>'cat-1(CB1111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3_0.02_5%'!$U$105:$U$125</c:f>
              <c:numCache>
                <c:formatCode>General</c:formatCode>
                <c:ptCount val="21"/>
                <c:pt idx="1">
                  <c:v>6.7024128686327095E-2</c:v>
                </c:pt>
                <c:pt idx="2">
                  <c:v>9.2940125111706906E-2</c:v>
                </c:pt>
                <c:pt idx="3">
                  <c:v>8.0428954423592505E-2</c:v>
                </c:pt>
                <c:pt idx="4">
                  <c:v>0.10098302055406598</c:v>
                </c:pt>
                <c:pt idx="5">
                  <c:v>0.14209115281501306</c:v>
                </c:pt>
                <c:pt idx="6">
                  <c:v>6.88114387846291E-2</c:v>
                </c:pt>
                <c:pt idx="7">
                  <c:v>4.6470062555853384E-2</c:v>
                </c:pt>
                <c:pt idx="8">
                  <c:v>5.3619302949061712E-2</c:v>
                </c:pt>
                <c:pt idx="9">
                  <c:v>4.2001787310098321E-2</c:v>
                </c:pt>
                <c:pt idx="10">
                  <c:v>4.5576407506702402E-2</c:v>
                </c:pt>
                <c:pt idx="11">
                  <c:v>3.4852546916890097E-2</c:v>
                </c:pt>
                <c:pt idx="12">
                  <c:v>2.6809651474530807E-2</c:v>
                </c:pt>
                <c:pt idx="13">
                  <c:v>3.2171581769436998E-2</c:v>
                </c:pt>
                <c:pt idx="14">
                  <c:v>2.1447721179624717E-2</c:v>
                </c:pt>
                <c:pt idx="15">
                  <c:v>2.05540661304736E-2</c:v>
                </c:pt>
                <c:pt idx="16">
                  <c:v>1.0723860589812305E-2</c:v>
                </c:pt>
                <c:pt idx="17">
                  <c:v>1.3404825737265411E-2</c:v>
                </c:pt>
                <c:pt idx="18">
                  <c:v>8.042895442359253E-3</c:v>
                </c:pt>
                <c:pt idx="19">
                  <c:v>9.8302055406613142E-3</c:v>
                </c:pt>
                <c:pt idx="20">
                  <c:v>3.5746201966041099E-3</c:v>
                </c:pt>
              </c:numCache>
            </c:numRef>
          </c:val>
        </c:ser>
        <c:marker val="1"/>
        <c:axId val="161046528"/>
        <c:axId val="161048064"/>
      </c:lineChart>
      <c:catAx>
        <c:axId val="161046528"/>
        <c:scaling>
          <c:orientation val="minMax"/>
        </c:scaling>
        <c:axPos val="b"/>
        <c:numFmt formatCode="0.0_ " sourceLinked="1"/>
        <c:tickLblPos val="nextTo"/>
        <c:crossAx val="161048064"/>
        <c:crosses val="autoZero"/>
        <c:auto val="1"/>
        <c:lblAlgn val="ctr"/>
        <c:lblOffset val="100"/>
        <c:tickLblSkip val="5"/>
        <c:tickMarkSkip val="5"/>
      </c:catAx>
      <c:valAx>
        <c:axId val="16104806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1046528"/>
        <c:crosses val="autoZero"/>
        <c:crossBetween val="between"/>
      </c:valAx>
    </c:plotArea>
    <c:plotVisOnly val="1"/>
  </c:chart>
  <c:externalData r:id="rId1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1</a:t>
            </a:r>
            <a:r>
              <a:rPr lang="en-US" altLang="ja-JP" sz="1400" b="0" baseline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1(CB1111)_A1_0.02_5%'!$B$104</c:f>
              <c:strCache>
                <c:ptCount val="1"/>
                <c:pt idx="0">
                  <c:v>cat-1(CB1111)_A1_01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B$105:$B$125</c:f>
              <c:numCache>
                <c:formatCode>General</c:formatCode>
                <c:ptCount val="21"/>
                <c:pt idx="1">
                  <c:v>8.4870848708487184E-2</c:v>
                </c:pt>
                <c:pt idx="2">
                  <c:v>7.7490774907749138E-2</c:v>
                </c:pt>
                <c:pt idx="3">
                  <c:v>0.11439114391143905</c:v>
                </c:pt>
                <c:pt idx="4">
                  <c:v>7.3800738007380101E-2</c:v>
                </c:pt>
                <c:pt idx="5">
                  <c:v>7.0110701107011134E-2</c:v>
                </c:pt>
                <c:pt idx="6">
                  <c:v>5.9040590405904099E-2</c:v>
                </c:pt>
                <c:pt idx="7">
                  <c:v>4.7970479704797099E-2</c:v>
                </c:pt>
                <c:pt idx="8">
                  <c:v>4.7970479704797099E-2</c:v>
                </c:pt>
                <c:pt idx="9">
                  <c:v>4.428044280442802E-2</c:v>
                </c:pt>
                <c:pt idx="10">
                  <c:v>2.5830258302582999E-2</c:v>
                </c:pt>
                <c:pt idx="11">
                  <c:v>5.1660516605166087E-2</c:v>
                </c:pt>
                <c:pt idx="12">
                  <c:v>2.9520295202951997E-2</c:v>
                </c:pt>
                <c:pt idx="13">
                  <c:v>2.5830258302582999E-2</c:v>
                </c:pt>
                <c:pt idx="14">
                  <c:v>2.5830258302582999E-2</c:v>
                </c:pt>
                <c:pt idx="15">
                  <c:v>3.690036900369001E-3</c:v>
                </c:pt>
                <c:pt idx="16">
                  <c:v>1.4760147601476E-2</c:v>
                </c:pt>
                <c:pt idx="17">
                  <c:v>1.4760147601476E-2</c:v>
                </c:pt>
                <c:pt idx="18">
                  <c:v>1.1070110701107005E-2</c:v>
                </c:pt>
                <c:pt idx="19">
                  <c:v>3.690036900369001E-3</c:v>
                </c:pt>
                <c:pt idx="20">
                  <c:v>1.1070110701107005E-2</c:v>
                </c:pt>
              </c:numCache>
            </c:numRef>
          </c:val>
        </c:ser>
        <c:ser>
          <c:idx val="1"/>
          <c:order val="1"/>
          <c:tx>
            <c:strRef>
              <c:f>'cat-1(CB1111)_A1_0.02_5%'!$C$104</c:f>
              <c:strCache>
                <c:ptCount val="1"/>
                <c:pt idx="0">
                  <c:v>cat-1(CB1111)_A1_02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C$105:$C$125</c:f>
              <c:numCache>
                <c:formatCode>General</c:formatCode>
                <c:ptCount val="21"/>
                <c:pt idx="1">
                  <c:v>7.5617283950617342E-2</c:v>
                </c:pt>
                <c:pt idx="2">
                  <c:v>8.6419753086419679E-2</c:v>
                </c:pt>
                <c:pt idx="3">
                  <c:v>0.12654320987654299</c:v>
                </c:pt>
                <c:pt idx="4">
                  <c:v>9.2592592592592671E-2</c:v>
                </c:pt>
                <c:pt idx="5">
                  <c:v>8.7962962962963034E-2</c:v>
                </c:pt>
                <c:pt idx="6">
                  <c:v>8.3333333333333329E-2</c:v>
                </c:pt>
                <c:pt idx="7">
                  <c:v>6.1728395061728399E-2</c:v>
                </c:pt>
                <c:pt idx="8">
                  <c:v>6.6358024691358E-2</c:v>
                </c:pt>
                <c:pt idx="9">
                  <c:v>4.1666666666666699E-2</c:v>
                </c:pt>
                <c:pt idx="10">
                  <c:v>4.0123456790123496E-2</c:v>
                </c:pt>
                <c:pt idx="11">
                  <c:v>1.8518518518518507E-2</c:v>
                </c:pt>
                <c:pt idx="12">
                  <c:v>3.086419753086421E-2</c:v>
                </c:pt>
                <c:pt idx="13">
                  <c:v>9.2592592592592692E-3</c:v>
                </c:pt>
                <c:pt idx="14">
                  <c:v>2.6234567901234608E-2</c:v>
                </c:pt>
                <c:pt idx="15">
                  <c:v>9.2592592592592692E-3</c:v>
                </c:pt>
                <c:pt idx="16">
                  <c:v>4.629629629629632E-3</c:v>
                </c:pt>
                <c:pt idx="17">
                  <c:v>3.0864197530864209E-3</c:v>
                </c:pt>
                <c:pt idx="18">
                  <c:v>1.5432098765432104E-3</c:v>
                </c:pt>
                <c:pt idx="19">
                  <c:v>4.629629629629632E-3</c:v>
                </c:pt>
                <c:pt idx="20">
                  <c:v>6.17283950617284E-3</c:v>
                </c:pt>
              </c:numCache>
            </c:numRef>
          </c:val>
        </c:ser>
        <c:ser>
          <c:idx val="2"/>
          <c:order val="2"/>
          <c:tx>
            <c:strRef>
              <c:f>'cat-1(CB1111)_A1_0.02_5%'!$D$104</c:f>
              <c:strCache>
                <c:ptCount val="1"/>
                <c:pt idx="0">
                  <c:v>cat-1(CB1111)_A1_03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D$105:$D$125</c:f>
              <c:numCache>
                <c:formatCode>General</c:formatCode>
                <c:ptCount val="21"/>
                <c:pt idx="1">
                  <c:v>0.10500000000000002</c:v>
                </c:pt>
                <c:pt idx="2">
                  <c:v>0.17</c:v>
                </c:pt>
                <c:pt idx="3">
                  <c:v>0.13</c:v>
                </c:pt>
                <c:pt idx="4">
                  <c:v>8.0000000000000029E-2</c:v>
                </c:pt>
                <c:pt idx="5">
                  <c:v>9.0000000000000024E-2</c:v>
                </c:pt>
                <c:pt idx="6">
                  <c:v>6.5000000000000002E-2</c:v>
                </c:pt>
                <c:pt idx="7">
                  <c:v>0.05</c:v>
                </c:pt>
                <c:pt idx="8">
                  <c:v>4.5000000000000012E-2</c:v>
                </c:pt>
                <c:pt idx="9">
                  <c:v>2.0000000000000007E-2</c:v>
                </c:pt>
                <c:pt idx="10">
                  <c:v>1.4999999999999998E-2</c:v>
                </c:pt>
                <c:pt idx="11">
                  <c:v>2.0000000000000007E-2</c:v>
                </c:pt>
                <c:pt idx="12">
                  <c:v>1.4999999999999998E-2</c:v>
                </c:pt>
                <c:pt idx="13">
                  <c:v>1.0000000000000004E-2</c:v>
                </c:pt>
                <c:pt idx="14">
                  <c:v>0</c:v>
                </c:pt>
                <c:pt idx="15">
                  <c:v>0</c:v>
                </c:pt>
                <c:pt idx="16">
                  <c:v>1.4999999999999998E-2</c:v>
                </c:pt>
                <c:pt idx="17">
                  <c:v>5.0000000000000018E-3</c:v>
                </c:pt>
                <c:pt idx="18">
                  <c:v>0</c:v>
                </c:pt>
                <c:pt idx="19">
                  <c:v>5.0000000000000018E-3</c:v>
                </c:pt>
                <c:pt idx="20">
                  <c:v>0</c:v>
                </c:pt>
              </c:numCache>
            </c:numRef>
          </c:val>
        </c:ser>
        <c:ser>
          <c:idx val="3"/>
          <c:order val="3"/>
          <c:tx>
            <c:strRef>
              <c:f>'cat-1(CB1111)_A1_0.02_5%'!$E$104</c:f>
              <c:strCache>
                <c:ptCount val="1"/>
                <c:pt idx="0">
                  <c:v>cat-1(CB1111)_A1_04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E$105:$E$125</c:f>
              <c:numCache>
                <c:formatCode>General</c:formatCode>
                <c:ptCount val="21"/>
                <c:pt idx="1">
                  <c:v>9.5846645367412164E-2</c:v>
                </c:pt>
                <c:pt idx="2">
                  <c:v>8.6261980830670895E-2</c:v>
                </c:pt>
                <c:pt idx="3">
                  <c:v>0.10223642172524006</c:v>
                </c:pt>
                <c:pt idx="4">
                  <c:v>0.11501597444089499</c:v>
                </c:pt>
                <c:pt idx="5">
                  <c:v>0.10223642172524006</c:v>
                </c:pt>
                <c:pt idx="6">
                  <c:v>7.9872204472843447E-2</c:v>
                </c:pt>
                <c:pt idx="7">
                  <c:v>5.7507987220447337E-2</c:v>
                </c:pt>
                <c:pt idx="8">
                  <c:v>4.7923322683706096E-2</c:v>
                </c:pt>
                <c:pt idx="9">
                  <c:v>5.1118210862619813E-2</c:v>
                </c:pt>
                <c:pt idx="10">
                  <c:v>3.8338658146964903E-2</c:v>
                </c:pt>
                <c:pt idx="11">
                  <c:v>3.19488817891374E-2</c:v>
                </c:pt>
                <c:pt idx="12">
                  <c:v>2.23642172523962E-2</c:v>
                </c:pt>
                <c:pt idx="13">
                  <c:v>1.9169329073482407E-2</c:v>
                </c:pt>
                <c:pt idx="14">
                  <c:v>2.23642172523962E-2</c:v>
                </c:pt>
                <c:pt idx="15">
                  <c:v>9.5846645367412206E-3</c:v>
                </c:pt>
                <c:pt idx="16">
                  <c:v>6.3897763578274801E-3</c:v>
                </c:pt>
                <c:pt idx="17">
                  <c:v>0</c:v>
                </c:pt>
                <c:pt idx="18">
                  <c:v>6.3897763578274801E-3</c:v>
                </c:pt>
                <c:pt idx="19">
                  <c:v>3.1948881789137401E-3</c:v>
                </c:pt>
                <c:pt idx="20">
                  <c:v>9.5846645367412206E-3</c:v>
                </c:pt>
              </c:numCache>
            </c:numRef>
          </c:val>
        </c:ser>
        <c:ser>
          <c:idx val="4"/>
          <c:order val="4"/>
          <c:tx>
            <c:strRef>
              <c:f>'cat-1(CB1111)_A1_0.02_5%'!$F$104</c:f>
              <c:strCache>
                <c:ptCount val="1"/>
                <c:pt idx="0">
                  <c:v>cat-1(CB1111)_A1_05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F$105:$F$125</c:f>
              <c:numCache>
                <c:formatCode>General</c:formatCode>
                <c:ptCount val="21"/>
                <c:pt idx="1">
                  <c:v>9.0140845070422554E-2</c:v>
                </c:pt>
                <c:pt idx="2">
                  <c:v>9.0140845070422554E-2</c:v>
                </c:pt>
                <c:pt idx="3">
                  <c:v>0.10704225352112705</c:v>
                </c:pt>
                <c:pt idx="4">
                  <c:v>0.13098591549295799</c:v>
                </c:pt>
                <c:pt idx="5">
                  <c:v>8.5915492957746559E-2</c:v>
                </c:pt>
                <c:pt idx="6">
                  <c:v>8.5915492957746559E-2</c:v>
                </c:pt>
                <c:pt idx="7">
                  <c:v>5.7746478873239422E-2</c:v>
                </c:pt>
                <c:pt idx="8">
                  <c:v>5.4929577464788701E-2</c:v>
                </c:pt>
                <c:pt idx="9">
                  <c:v>3.9436619718309911E-2</c:v>
                </c:pt>
                <c:pt idx="10">
                  <c:v>3.2394366197183097E-2</c:v>
                </c:pt>
                <c:pt idx="11">
                  <c:v>2.2535211267605614E-2</c:v>
                </c:pt>
                <c:pt idx="12">
                  <c:v>3.9436619718309911E-2</c:v>
                </c:pt>
                <c:pt idx="13">
                  <c:v>2.2535211267605614E-2</c:v>
                </c:pt>
                <c:pt idx="14">
                  <c:v>1.6901408450704206E-2</c:v>
                </c:pt>
                <c:pt idx="15">
                  <c:v>8.450704225352117E-3</c:v>
                </c:pt>
                <c:pt idx="16">
                  <c:v>8.450704225352117E-3</c:v>
                </c:pt>
                <c:pt idx="17">
                  <c:v>4.225352112676062E-3</c:v>
                </c:pt>
                <c:pt idx="18">
                  <c:v>4.225352112676062E-3</c:v>
                </c:pt>
                <c:pt idx="19">
                  <c:v>2.8169014084507E-3</c:v>
                </c:pt>
                <c:pt idx="20">
                  <c:v>2.8169014084507E-3</c:v>
                </c:pt>
              </c:numCache>
            </c:numRef>
          </c:val>
        </c:ser>
        <c:ser>
          <c:idx val="5"/>
          <c:order val="5"/>
          <c:tx>
            <c:strRef>
              <c:f>'cat-1(CB1111)_A1_0.02_5%'!$G$104</c:f>
              <c:strCache>
                <c:ptCount val="1"/>
                <c:pt idx="0">
                  <c:v>cat-1(CB1111)_A1_06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G$105:$G$125</c:f>
              <c:numCache>
                <c:formatCode>General</c:formatCode>
                <c:ptCount val="21"/>
                <c:pt idx="1">
                  <c:v>7.1253071253071329E-2</c:v>
                </c:pt>
                <c:pt idx="2">
                  <c:v>9.5004095004095068E-2</c:v>
                </c:pt>
                <c:pt idx="3">
                  <c:v>0.12530712530712501</c:v>
                </c:pt>
                <c:pt idx="4">
                  <c:v>0.13841113841113811</c:v>
                </c:pt>
                <c:pt idx="5">
                  <c:v>0.11957411957412002</c:v>
                </c:pt>
                <c:pt idx="6">
                  <c:v>7.8624078624078567E-2</c:v>
                </c:pt>
                <c:pt idx="7">
                  <c:v>5.5692055692055695E-2</c:v>
                </c:pt>
                <c:pt idx="8">
                  <c:v>6.6339066339066319E-2</c:v>
                </c:pt>
                <c:pt idx="9">
                  <c:v>4.0950040950040914E-2</c:v>
                </c:pt>
                <c:pt idx="10">
                  <c:v>3.521703521703521E-2</c:v>
                </c:pt>
                <c:pt idx="11">
                  <c:v>2.9484029484029513E-2</c:v>
                </c:pt>
                <c:pt idx="12">
                  <c:v>1.7199017199017202E-2</c:v>
                </c:pt>
                <c:pt idx="13">
                  <c:v>1.7199017199017202E-2</c:v>
                </c:pt>
                <c:pt idx="14">
                  <c:v>1.2285012285012303E-2</c:v>
                </c:pt>
                <c:pt idx="15">
                  <c:v>8.1900081900081901E-3</c:v>
                </c:pt>
                <c:pt idx="16">
                  <c:v>7.3710073710073721E-3</c:v>
                </c:pt>
                <c:pt idx="17">
                  <c:v>4.9140049140049104E-3</c:v>
                </c:pt>
                <c:pt idx="18">
                  <c:v>4.9140049140049104E-3</c:v>
                </c:pt>
                <c:pt idx="19">
                  <c:v>3.2760032760032801E-3</c:v>
                </c:pt>
                <c:pt idx="20">
                  <c:v>2.4570024570024608E-3</c:v>
                </c:pt>
              </c:numCache>
            </c:numRef>
          </c:val>
        </c:ser>
        <c:ser>
          <c:idx val="6"/>
          <c:order val="6"/>
          <c:tx>
            <c:strRef>
              <c:f>'cat-1(CB1111)_A1_0.02_5%'!$H$104</c:f>
              <c:strCache>
                <c:ptCount val="1"/>
                <c:pt idx="0">
                  <c:v>cat-1(CB1111)_A1_07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H$105:$H$125</c:f>
              <c:numCache>
                <c:formatCode>General</c:formatCode>
                <c:ptCount val="21"/>
                <c:pt idx="1">
                  <c:v>8.366533864541835E-2</c:v>
                </c:pt>
                <c:pt idx="2">
                  <c:v>0.10756972111553803</c:v>
                </c:pt>
                <c:pt idx="3">
                  <c:v>8.5657370517928322E-2</c:v>
                </c:pt>
                <c:pt idx="4">
                  <c:v>9.9601593625498031E-2</c:v>
                </c:pt>
                <c:pt idx="5">
                  <c:v>8.1673306772908405E-2</c:v>
                </c:pt>
                <c:pt idx="6">
                  <c:v>6.9721115537848599E-2</c:v>
                </c:pt>
                <c:pt idx="7">
                  <c:v>5.5776892430278904E-2</c:v>
                </c:pt>
                <c:pt idx="8">
                  <c:v>6.1752988047808821E-2</c:v>
                </c:pt>
                <c:pt idx="9">
                  <c:v>4.3824701195219098E-2</c:v>
                </c:pt>
                <c:pt idx="10">
                  <c:v>5.3784860557768897E-2</c:v>
                </c:pt>
                <c:pt idx="11">
                  <c:v>3.9840637450199216E-2</c:v>
                </c:pt>
                <c:pt idx="12">
                  <c:v>2.1912350597609601E-2</c:v>
                </c:pt>
                <c:pt idx="13">
                  <c:v>2.7888446215139407E-2</c:v>
                </c:pt>
                <c:pt idx="14">
                  <c:v>1.9920318725099601E-2</c:v>
                </c:pt>
                <c:pt idx="15">
                  <c:v>1.5936254980079698E-2</c:v>
                </c:pt>
                <c:pt idx="16">
                  <c:v>7.968127490039844E-3</c:v>
                </c:pt>
                <c:pt idx="17">
                  <c:v>9.9601593625498041E-3</c:v>
                </c:pt>
                <c:pt idx="18">
                  <c:v>7.968127490039844E-3</c:v>
                </c:pt>
                <c:pt idx="19">
                  <c:v>1.9920318725099601E-3</c:v>
                </c:pt>
                <c:pt idx="20">
                  <c:v>1.9920318725099601E-3</c:v>
                </c:pt>
              </c:numCache>
            </c:numRef>
          </c:val>
        </c:ser>
        <c:ser>
          <c:idx val="7"/>
          <c:order val="7"/>
          <c:tx>
            <c:strRef>
              <c:f>'cat-1(CB1111)_A1_0.02_5%'!$I$104</c:f>
              <c:strCache>
                <c:ptCount val="1"/>
                <c:pt idx="0">
                  <c:v>cat-1(CB1111)_A1_08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I$105:$I$125</c:f>
              <c:numCache>
                <c:formatCode>General</c:formatCode>
                <c:ptCount val="21"/>
                <c:pt idx="1">
                  <c:v>8.608058608058608E-2</c:v>
                </c:pt>
                <c:pt idx="2">
                  <c:v>8.7912087912087877E-2</c:v>
                </c:pt>
                <c:pt idx="3">
                  <c:v>0.12362637362637405</c:v>
                </c:pt>
                <c:pt idx="4">
                  <c:v>0.13736263736263701</c:v>
                </c:pt>
                <c:pt idx="5">
                  <c:v>0.115384615384615</c:v>
                </c:pt>
                <c:pt idx="6">
                  <c:v>8.7912087912087877E-2</c:v>
                </c:pt>
                <c:pt idx="7">
                  <c:v>5.8608058608058573E-2</c:v>
                </c:pt>
                <c:pt idx="8">
                  <c:v>6.0439560439560398E-2</c:v>
                </c:pt>
                <c:pt idx="9">
                  <c:v>4.2124542124542086E-2</c:v>
                </c:pt>
                <c:pt idx="10">
                  <c:v>3.4798534798534793E-2</c:v>
                </c:pt>
                <c:pt idx="11">
                  <c:v>2.7472527472527521E-2</c:v>
                </c:pt>
                <c:pt idx="12">
                  <c:v>1.6483516483516501E-2</c:v>
                </c:pt>
                <c:pt idx="13">
                  <c:v>1.4652014652014699E-2</c:v>
                </c:pt>
                <c:pt idx="14">
                  <c:v>1.1904761904761904E-2</c:v>
                </c:pt>
                <c:pt idx="15">
                  <c:v>3.6630036630036608E-3</c:v>
                </c:pt>
                <c:pt idx="16">
                  <c:v>2.7472527472527527E-3</c:v>
                </c:pt>
                <c:pt idx="17">
                  <c:v>5.4945054945054897E-3</c:v>
                </c:pt>
                <c:pt idx="18">
                  <c:v>3.6630036630036608E-3</c:v>
                </c:pt>
                <c:pt idx="19">
                  <c:v>3.6630036630036608E-3</c:v>
                </c:pt>
                <c:pt idx="20">
                  <c:v>2.7472527472527527E-3</c:v>
                </c:pt>
              </c:numCache>
            </c:numRef>
          </c:val>
        </c:ser>
        <c:ser>
          <c:idx val="8"/>
          <c:order val="8"/>
          <c:tx>
            <c:strRef>
              <c:f>'cat-1(CB1111)_A1_0.02_5%'!$J$104</c:f>
              <c:strCache>
                <c:ptCount val="1"/>
                <c:pt idx="0">
                  <c:v>cat-1(CB1111)_A1_09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J$105:$J$125</c:f>
              <c:numCache>
                <c:formatCode>General</c:formatCode>
                <c:ptCount val="21"/>
                <c:pt idx="1">
                  <c:v>8.5313174946004239E-2</c:v>
                </c:pt>
                <c:pt idx="2">
                  <c:v>9.6112311015118732E-2</c:v>
                </c:pt>
                <c:pt idx="3">
                  <c:v>0.12850971922246199</c:v>
                </c:pt>
                <c:pt idx="4">
                  <c:v>0.14254859611231108</c:v>
                </c:pt>
                <c:pt idx="5">
                  <c:v>9.2872570194384524E-2</c:v>
                </c:pt>
                <c:pt idx="6">
                  <c:v>6.8034557235421234E-2</c:v>
                </c:pt>
                <c:pt idx="7">
                  <c:v>5.6155507559395197E-2</c:v>
                </c:pt>
                <c:pt idx="8">
                  <c:v>4.7516198704103715E-2</c:v>
                </c:pt>
                <c:pt idx="9">
                  <c:v>6.0475161987040997E-2</c:v>
                </c:pt>
                <c:pt idx="10">
                  <c:v>3.2397408207343402E-2</c:v>
                </c:pt>
                <c:pt idx="11">
                  <c:v>3.2397408207343402E-2</c:v>
                </c:pt>
                <c:pt idx="12">
                  <c:v>1.4038876889848799E-2</c:v>
                </c:pt>
                <c:pt idx="13">
                  <c:v>1.5118790496760301E-2</c:v>
                </c:pt>
                <c:pt idx="14">
                  <c:v>7.5593952483801333E-3</c:v>
                </c:pt>
                <c:pt idx="15">
                  <c:v>6.4794816414686833E-3</c:v>
                </c:pt>
                <c:pt idx="16">
                  <c:v>8.6393088552915789E-3</c:v>
                </c:pt>
                <c:pt idx="17">
                  <c:v>7.5593952483801333E-3</c:v>
                </c:pt>
                <c:pt idx="18">
                  <c:v>5.399568034557242E-3</c:v>
                </c:pt>
                <c:pt idx="19">
                  <c:v>3.2397408207343408E-3</c:v>
                </c:pt>
                <c:pt idx="20">
                  <c:v>3.2397408207343408E-3</c:v>
                </c:pt>
              </c:numCache>
            </c:numRef>
          </c:val>
        </c:ser>
        <c:ser>
          <c:idx val="9"/>
          <c:order val="9"/>
          <c:tx>
            <c:strRef>
              <c:f>'cat-1(CB1111)_A1_0.02_5%'!$K$104</c:f>
              <c:strCache>
                <c:ptCount val="1"/>
                <c:pt idx="0">
                  <c:v>cat-1(CB1111)_A1_10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K$105:$K$125</c:f>
              <c:numCache>
                <c:formatCode>General</c:formatCode>
                <c:ptCount val="21"/>
                <c:pt idx="1">
                  <c:v>7.0588235294117604E-2</c:v>
                </c:pt>
                <c:pt idx="2">
                  <c:v>9.6078431372548997E-2</c:v>
                </c:pt>
                <c:pt idx="3">
                  <c:v>9.1176470588235331E-2</c:v>
                </c:pt>
                <c:pt idx="4">
                  <c:v>0.1</c:v>
                </c:pt>
                <c:pt idx="5">
                  <c:v>0.11764705882352898</c:v>
                </c:pt>
                <c:pt idx="6">
                  <c:v>8.0392156862745076E-2</c:v>
                </c:pt>
                <c:pt idx="7">
                  <c:v>4.3137254901960811E-2</c:v>
                </c:pt>
                <c:pt idx="8">
                  <c:v>5.0980392156862703E-2</c:v>
                </c:pt>
                <c:pt idx="9">
                  <c:v>4.0196078431372614E-2</c:v>
                </c:pt>
                <c:pt idx="10">
                  <c:v>4.5098039215686329E-2</c:v>
                </c:pt>
                <c:pt idx="11">
                  <c:v>3.823529411764711E-2</c:v>
                </c:pt>
                <c:pt idx="12">
                  <c:v>2.7450980392156901E-2</c:v>
                </c:pt>
                <c:pt idx="13">
                  <c:v>2.8431372549019621E-2</c:v>
                </c:pt>
                <c:pt idx="14">
                  <c:v>2.1568627450980399E-2</c:v>
                </c:pt>
                <c:pt idx="15">
                  <c:v>1.5686274509803901E-2</c:v>
                </c:pt>
                <c:pt idx="16">
                  <c:v>8.8235294117647144E-3</c:v>
                </c:pt>
                <c:pt idx="17">
                  <c:v>3.9215686274509812E-3</c:v>
                </c:pt>
                <c:pt idx="18">
                  <c:v>9.8039215686274508E-3</c:v>
                </c:pt>
                <c:pt idx="19">
                  <c:v>4.9019607843137358E-3</c:v>
                </c:pt>
                <c:pt idx="20">
                  <c:v>6.8627450980392199E-3</c:v>
                </c:pt>
              </c:numCache>
            </c:numRef>
          </c:val>
        </c:ser>
        <c:ser>
          <c:idx val="10"/>
          <c:order val="10"/>
          <c:tx>
            <c:strRef>
              <c:f>'cat-1(CB1111)_A1_0.02_5%'!$L$104</c:f>
              <c:strCache>
                <c:ptCount val="1"/>
                <c:pt idx="0">
                  <c:v>cat-1(CB1111)_A1_11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L$105:$L$125</c:f>
              <c:numCache>
                <c:formatCode>General</c:formatCode>
                <c:ptCount val="21"/>
              </c:numCache>
            </c:numRef>
          </c:val>
        </c:ser>
        <c:ser>
          <c:idx val="11"/>
          <c:order val="11"/>
          <c:tx>
            <c:strRef>
              <c:f>'cat-1(CB1111)_A1_0.02_5%'!$M$104</c:f>
              <c:strCache>
                <c:ptCount val="1"/>
                <c:pt idx="0">
                  <c:v>cat-1(CB1111)_A1_12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M$105:$M$125</c:f>
              <c:numCache>
                <c:formatCode>General</c:formatCode>
                <c:ptCount val="21"/>
                <c:pt idx="1">
                  <c:v>6.6129032258064505E-2</c:v>
                </c:pt>
                <c:pt idx="2">
                  <c:v>9.5161290322580597E-2</c:v>
                </c:pt>
                <c:pt idx="3">
                  <c:v>0.125</c:v>
                </c:pt>
                <c:pt idx="4">
                  <c:v>0.12822580645161297</c:v>
                </c:pt>
                <c:pt idx="5">
                  <c:v>0.12741935483871006</c:v>
                </c:pt>
                <c:pt idx="6">
                  <c:v>6.5322580645161332E-2</c:v>
                </c:pt>
                <c:pt idx="7">
                  <c:v>5.0806451612903238E-2</c:v>
                </c:pt>
                <c:pt idx="8">
                  <c:v>3.7096774193548399E-2</c:v>
                </c:pt>
                <c:pt idx="9">
                  <c:v>4.5161290322580622E-2</c:v>
                </c:pt>
                <c:pt idx="10">
                  <c:v>4.1129032258064482E-2</c:v>
                </c:pt>
                <c:pt idx="11">
                  <c:v>3.4677419354838701E-2</c:v>
                </c:pt>
                <c:pt idx="12">
                  <c:v>2.4193548387096801E-2</c:v>
                </c:pt>
                <c:pt idx="13">
                  <c:v>9.677419354838717E-3</c:v>
                </c:pt>
                <c:pt idx="14">
                  <c:v>2.0161290322580599E-2</c:v>
                </c:pt>
                <c:pt idx="15">
                  <c:v>1.3709677419354801E-2</c:v>
                </c:pt>
                <c:pt idx="16">
                  <c:v>1.4516129032258105E-2</c:v>
                </c:pt>
                <c:pt idx="17">
                  <c:v>7.2580645161290317E-3</c:v>
                </c:pt>
                <c:pt idx="18">
                  <c:v>6.4516129032258134E-3</c:v>
                </c:pt>
                <c:pt idx="19">
                  <c:v>6.4516129032258134E-3</c:v>
                </c:pt>
                <c:pt idx="20">
                  <c:v>6.4516129032258134E-3</c:v>
                </c:pt>
              </c:numCache>
            </c:numRef>
          </c:val>
        </c:ser>
        <c:ser>
          <c:idx val="12"/>
          <c:order val="12"/>
          <c:tx>
            <c:strRef>
              <c:f>'cat-1(CB1111)_A1_0.02_5%'!$N$104</c:f>
              <c:strCache>
                <c:ptCount val="1"/>
                <c:pt idx="0">
                  <c:v>cat-1(CB1111)_A1_13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N$105:$N$125</c:f>
              <c:numCache>
                <c:formatCode>General</c:formatCode>
                <c:ptCount val="21"/>
                <c:pt idx="1">
                  <c:v>6.9518716577540093E-2</c:v>
                </c:pt>
                <c:pt idx="2">
                  <c:v>0.11140819964349395</c:v>
                </c:pt>
                <c:pt idx="3">
                  <c:v>9.8930481283422536E-2</c:v>
                </c:pt>
                <c:pt idx="4">
                  <c:v>0.15775401069518699</c:v>
                </c:pt>
                <c:pt idx="5">
                  <c:v>0.13190730837789708</c:v>
                </c:pt>
                <c:pt idx="6">
                  <c:v>7.4866310160427829E-2</c:v>
                </c:pt>
                <c:pt idx="7">
                  <c:v>5.6149732620320879E-2</c:v>
                </c:pt>
                <c:pt idx="8">
                  <c:v>5.3475935828877004E-2</c:v>
                </c:pt>
                <c:pt idx="9">
                  <c:v>4.4563279857397532E-2</c:v>
                </c:pt>
                <c:pt idx="10">
                  <c:v>4.5454545454545497E-2</c:v>
                </c:pt>
                <c:pt idx="11">
                  <c:v>2.5846702317290606E-2</c:v>
                </c:pt>
                <c:pt idx="12">
                  <c:v>1.9607843137254902E-2</c:v>
                </c:pt>
                <c:pt idx="13">
                  <c:v>1.1586452762923404E-2</c:v>
                </c:pt>
                <c:pt idx="14">
                  <c:v>1.2477718360071298E-2</c:v>
                </c:pt>
                <c:pt idx="15">
                  <c:v>4.4563279857397532E-3</c:v>
                </c:pt>
                <c:pt idx="16">
                  <c:v>4.4563279857397532E-3</c:v>
                </c:pt>
                <c:pt idx="17">
                  <c:v>4.4563279857397532E-3</c:v>
                </c:pt>
                <c:pt idx="18">
                  <c:v>5.3475935828877002E-3</c:v>
                </c:pt>
                <c:pt idx="19">
                  <c:v>0</c:v>
                </c:pt>
                <c:pt idx="20">
                  <c:v>3.565062388591801E-3</c:v>
                </c:pt>
              </c:numCache>
            </c:numRef>
          </c:val>
        </c:ser>
        <c:ser>
          <c:idx val="13"/>
          <c:order val="13"/>
          <c:tx>
            <c:strRef>
              <c:f>'cat-1(CB1111)_A1_0.02_5%'!$O$104</c:f>
              <c:strCache>
                <c:ptCount val="1"/>
                <c:pt idx="0">
                  <c:v>cat-1(CB1111)_A1_14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O$105:$O$125</c:f>
              <c:numCache>
                <c:formatCode>General</c:formatCode>
                <c:ptCount val="21"/>
                <c:pt idx="1">
                  <c:v>7.6138147566718967E-2</c:v>
                </c:pt>
                <c:pt idx="2">
                  <c:v>9.5761381475667207E-2</c:v>
                </c:pt>
                <c:pt idx="3">
                  <c:v>0.10361067503924599</c:v>
                </c:pt>
                <c:pt idx="4">
                  <c:v>0.14756671899529006</c:v>
                </c:pt>
                <c:pt idx="5">
                  <c:v>0.12166405023547905</c:v>
                </c:pt>
                <c:pt idx="6">
                  <c:v>7.2998430141287332E-2</c:v>
                </c:pt>
                <c:pt idx="7">
                  <c:v>3.8461538461538498E-2</c:v>
                </c:pt>
                <c:pt idx="8">
                  <c:v>5.4160125588696997E-2</c:v>
                </c:pt>
                <c:pt idx="9">
                  <c:v>4.474097331240192E-2</c:v>
                </c:pt>
                <c:pt idx="10">
                  <c:v>4.0031397174254295E-2</c:v>
                </c:pt>
                <c:pt idx="11">
                  <c:v>2.5902668759811599E-2</c:v>
                </c:pt>
                <c:pt idx="12">
                  <c:v>2.2762951334379892E-2</c:v>
                </c:pt>
                <c:pt idx="13">
                  <c:v>1.9623233908948202E-2</c:v>
                </c:pt>
                <c:pt idx="14">
                  <c:v>1.6483516483516501E-2</c:v>
                </c:pt>
                <c:pt idx="15">
                  <c:v>1.4128728414442701E-2</c:v>
                </c:pt>
                <c:pt idx="16">
                  <c:v>1.0204081632653106E-2</c:v>
                </c:pt>
                <c:pt idx="17">
                  <c:v>7.0643642072213504E-3</c:v>
                </c:pt>
                <c:pt idx="18">
                  <c:v>6.2794348508634218E-3</c:v>
                </c:pt>
                <c:pt idx="19">
                  <c:v>6.2794348508634218E-3</c:v>
                </c:pt>
                <c:pt idx="20">
                  <c:v>4.7095761381475715E-3</c:v>
                </c:pt>
              </c:numCache>
            </c:numRef>
          </c:val>
        </c:ser>
        <c:ser>
          <c:idx val="14"/>
          <c:order val="14"/>
          <c:tx>
            <c:strRef>
              <c:f>'cat-1(CB1111)_A1_0.02_5%'!$P$104</c:f>
              <c:strCache>
                <c:ptCount val="1"/>
                <c:pt idx="0">
                  <c:v>cat-1(CB1111)_A1_15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P$105:$P$125</c:f>
              <c:numCache>
                <c:formatCode>General</c:formatCode>
                <c:ptCount val="21"/>
                <c:pt idx="1">
                  <c:v>8.9968152866242046E-2</c:v>
                </c:pt>
                <c:pt idx="2">
                  <c:v>0.11226114649681505</c:v>
                </c:pt>
                <c:pt idx="3">
                  <c:v>0.11863057324840805</c:v>
                </c:pt>
                <c:pt idx="4">
                  <c:v>0.14888535031847105</c:v>
                </c:pt>
                <c:pt idx="5">
                  <c:v>0.12022292993630604</c:v>
                </c:pt>
                <c:pt idx="6">
                  <c:v>5.5732484076433136E-2</c:v>
                </c:pt>
                <c:pt idx="7">
                  <c:v>4.0605095541401313E-2</c:v>
                </c:pt>
                <c:pt idx="8">
                  <c:v>4.6974522292993579E-2</c:v>
                </c:pt>
                <c:pt idx="9">
                  <c:v>4.0605095541401313E-2</c:v>
                </c:pt>
                <c:pt idx="10">
                  <c:v>4.1401273885350302E-2</c:v>
                </c:pt>
                <c:pt idx="11">
                  <c:v>3.4235668789808917E-2</c:v>
                </c:pt>
                <c:pt idx="12">
                  <c:v>2.07006369426752E-2</c:v>
                </c:pt>
                <c:pt idx="13">
                  <c:v>1.9108280254777107E-2</c:v>
                </c:pt>
                <c:pt idx="14">
                  <c:v>9.5541401273885294E-3</c:v>
                </c:pt>
                <c:pt idx="15">
                  <c:v>7.9617834394904528E-3</c:v>
                </c:pt>
                <c:pt idx="16">
                  <c:v>8.7579617834394868E-3</c:v>
                </c:pt>
                <c:pt idx="17">
                  <c:v>7.1656050955414023E-3</c:v>
                </c:pt>
                <c:pt idx="18">
                  <c:v>3.1847133757961815E-3</c:v>
                </c:pt>
                <c:pt idx="19">
                  <c:v>3.9808917197452212E-3</c:v>
                </c:pt>
                <c:pt idx="20">
                  <c:v>1.5923566878980901E-3</c:v>
                </c:pt>
              </c:numCache>
            </c:numRef>
          </c:val>
        </c:ser>
        <c:ser>
          <c:idx val="15"/>
          <c:order val="15"/>
          <c:tx>
            <c:strRef>
              <c:f>'cat-1(CB1111)_A1_0.02_5%'!$Q$104</c:f>
              <c:strCache>
                <c:ptCount val="1"/>
                <c:pt idx="0">
                  <c:v>cat-1(CB1111)_A1_16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Q$105:$Q$125</c:f>
              <c:numCache>
                <c:formatCode>General</c:formatCode>
                <c:ptCount val="21"/>
                <c:pt idx="1">
                  <c:v>6.11814345991561E-2</c:v>
                </c:pt>
                <c:pt idx="2">
                  <c:v>7.4542897327707511E-2</c:v>
                </c:pt>
                <c:pt idx="3">
                  <c:v>0.127988748241913</c:v>
                </c:pt>
                <c:pt idx="4">
                  <c:v>0.13994374120956399</c:v>
                </c:pt>
                <c:pt idx="5">
                  <c:v>0.14908579465541499</c:v>
                </c:pt>
                <c:pt idx="6">
                  <c:v>7.4542897327707511E-2</c:v>
                </c:pt>
                <c:pt idx="7">
                  <c:v>5.2039381153305218E-2</c:v>
                </c:pt>
                <c:pt idx="8">
                  <c:v>3.3052039381153302E-2</c:v>
                </c:pt>
                <c:pt idx="9">
                  <c:v>4.5710267229254621E-2</c:v>
                </c:pt>
                <c:pt idx="10">
                  <c:v>4.9929676511954985E-2</c:v>
                </c:pt>
                <c:pt idx="11">
                  <c:v>3.3052039381153302E-2</c:v>
                </c:pt>
                <c:pt idx="12">
                  <c:v>2.6722925457102701E-2</c:v>
                </c:pt>
                <c:pt idx="13">
                  <c:v>2.3909985935302393E-2</c:v>
                </c:pt>
                <c:pt idx="14">
                  <c:v>2.0393811533052E-2</c:v>
                </c:pt>
                <c:pt idx="15">
                  <c:v>9.1420534458509107E-3</c:v>
                </c:pt>
                <c:pt idx="16">
                  <c:v>9.8452883263009973E-3</c:v>
                </c:pt>
                <c:pt idx="17">
                  <c:v>4.92264416315049E-3</c:v>
                </c:pt>
                <c:pt idx="18">
                  <c:v>4.92264416315049E-3</c:v>
                </c:pt>
                <c:pt idx="19">
                  <c:v>6.3291139240506319E-3</c:v>
                </c:pt>
                <c:pt idx="20">
                  <c:v>3.5161744022503519E-3</c:v>
                </c:pt>
              </c:numCache>
            </c:numRef>
          </c:val>
        </c:ser>
        <c:ser>
          <c:idx val="16"/>
          <c:order val="16"/>
          <c:tx>
            <c:strRef>
              <c:f>'cat-1(CB1111)_A1_0.02_5%'!$R$104</c:f>
              <c:strCache>
                <c:ptCount val="1"/>
                <c:pt idx="0">
                  <c:v>cat-1(CB1111)_A1_17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R$105:$R$125</c:f>
              <c:numCache>
                <c:formatCode>General</c:formatCode>
                <c:ptCount val="21"/>
                <c:pt idx="1">
                  <c:v>7.0058381984987511E-2</c:v>
                </c:pt>
                <c:pt idx="2">
                  <c:v>8.5904920767306173E-2</c:v>
                </c:pt>
                <c:pt idx="3">
                  <c:v>0.12010008340283602</c:v>
                </c:pt>
                <c:pt idx="4">
                  <c:v>0.13427856547122599</c:v>
                </c:pt>
                <c:pt idx="5">
                  <c:v>0.14512093411176005</c:v>
                </c:pt>
                <c:pt idx="6">
                  <c:v>6.0050041701417797E-2</c:v>
                </c:pt>
                <c:pt idx="7">
                  <c:v>5.0875729774812299E-2</c:v>
                </c:pt>
                <c:pt idx="8">
                  <c:v>5.0875729774812299E-2</c:v>
                </c:pt>
                <c:pt idx="9">
                  <c:v>4.670558798999172E-2</c:v>
                </c:pt>
                <c:pt idx="10">
                  <c:v>3.6697247706422027E-2</c:v>
                </c:pt>
                <c:pt idx="11">
                  <c:v>3.0025020850708892E-2</c:v>
                </c:pt>
                <c:pt idx="12">
                  <c:v>2.25187656380317E-2</c:v>
                </c:pt>
                <c:pt idx="13">
                  <c:v>1.5846538782318606E-2</c:v>
                </c:pt>
                <c:pt idx="14">
                  <c:v>1.4178482068390298E-2</c:v>
                </c:pt>
                <c:pt idx="15">
                  <c:v>9.1743119266055103E-3</c:v>
                </c:pt>
                <c:pt idx="16">
                  <c:v>5.0041701417848222E-3</c:v>
                </c:pt>
                <c:pt idx="17">
                  <c:v>1.0008340283569599E-2</c:v>
                </c:pt>
                <c:pt idx="18">
                  <c:v>6.6722268557130923E-3</c:v>
                </c:pt>
                <c:pt idx="19">
                  <c:v>5.8381984987489624E-3</c:v>
                </c:pt>
                <c:pt idx="20">
                  <c:v>8.340283569641374E-4</c:v>
                </c:pt>
              </c:numCache>
            </c:numRef>
          </c:val>
        </c:ser>
        <c:ser>
          <c:idx val="17"/>
          <c:order val="17"/>
          <c:tx>
            <c:strRef>
              <c:f>'cat-1(CB1111)_A1_0.02_5%'!$S$104</c:f>
              <c:strCache>
                <c:ptCount val="1"/>
                <c:pt idx="0">
                  <c:v>cat-1(CB1111)_A1_18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S$105:$S$125</c:f>
              <c:numCache>
                <c:formatCode>General</c:formatCode>
                <c:ptCount val="21"/>
                <c:pt idx="1">
                  <c:v>8.0684596577017154E-2</c:v>
                </c:pt>
                <c:pt idx="2">
                  <c:v>0.10350448247758805</c:v>
                </c:pt>
                <c:pt idx="3">
                  <c:v>0.114099429502852</c:v>
                </c:pt>
                <c:pt idx="4">
                  <c:v>0.15321923390383008</c:v>
                </c:pt>
                <c:pt idx="5">
                  <c:v>0.12632436837815794</c:v>
                </c:pt>
                <c:pt idx="6">
                  <c:v>6.1939690301548521E-2</c:v>
                </c:pt>
                <c:pt idx="7">
                  <c:v>5.7864710676446635E-2</c:v>
                </c:pt>
                <c:pt idx="8">
                  <c:v>4.9714751426242931E-2</c:v>
                </c:pt>
                <c:pt idx="9">
                  <c:v>5.4604726976365113E-2</c:v>
                </c:pt>
                <c:pt idx="10">
                  <c:v>3.5859820700896515E-2</c:v>
                </c:pt>
                <c:pt idx="11">
                  <c:v>2.9339853300733507E-2</c:v>
                </c:pt>
                <c:pt idx="12">
                  <c:v>1.8744906275468601E-2</c:v>
                </c:pt>
                <c:pt idx="13">
                  <c:v>1.2224938875305598E-2</c:v>
                </c:pt>
                <c:pt idx="14">
                  <c:v>8.1499592502037536E-3</c:v>
                </c:pt>
                <c:pt idx="15">
                  <c:v>1.2224938875305598E-2</c:v>
                </c:pt>
                <c:pt idx="16">
                  <c:v>7.3349633251833741E-3</c:v>
                </c:pt>
                <c:pt idx="17">
                  <c:v>3.259983700081502E-3</c:v>
                </c:pt>
                <c:pt idx="18">
                  <c:v>4.0749796251018733E-3</c:v>
                </c:pt>
                <c:pt idx="19">
                  <c:v>4.0749796251018733E-3</c:v>
                </c:pt>
                <c:pt idx="20">
                  <c:v>1.6299918500407499E-3</c:v>
                </c:pt>
              </c:numCache>
            </c:numRef>
          </c:val>
        </c:ser>
        <c:ser>
          <c:idx val="18"/>
          <c:order val="18"/>
          <c:tx>
            <c:strRef>
              <c:f>'cat-1(CB1111)_A1_0.02_5%'!$T$104</c:f>
              <c:strCache>
                <c:ptCount val="1"/>
                <c:pt idx="0">
                  <c:v>cat-1(CB1111)_A1_19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T$105:$T$125</c:f>
              <c:numCache>
                <c:formatCode>General</c:formatCode>
                <c:ptCount val="21"/>
                <c:pt idx="1">
                  <c:v>6.7179846046186098E-2</c:v>
                </c:pt>
                <c:pt idx="2">
                  <c:v>0.11336599020293903</c:v>
                </c:pt>
                <c:pt idx="3">
                  <c:v>0.116864940517845</c:v>
                </c:pt>
                <c:pt idx="4">
                  <c:v>0.160251924422673</c:v>
                </c:pt>
                <c:pt idx="5">
                  <c:v>0.13365990202939099</c:v>
                </c:pt>
                <c:pt idx="6">
                  <c:v>6.5080475857242831E-2</c:v>
                </c:pt>
                <c:pt idx="7">
                  <c:v>4.6885934219734103E-2</c:v>
                </c:pt>
                <c:pt idx="8">
                  <c:v>5.2484254723582903E-2</c:v>
                </c:pt>
                <c:pt idx="9">
                  <c:v>4.4786564030790836E-2</c:v>
                </c:pt>
                <c:pt idx="10">
                  <c:v>3.7788663400979715E-2</c:v>
                </c:pt>
                <c:pt idx="11">
                  <c:v>2.3093072078376513E-2</c:v>
                </c:pt>
                <c:pt idx="12">
                  <c:v>1.67949615115465E-2</c:v>
                </c:pt>
                <c:pt idx="13">
                  <c:v>9.7970608817354761E-3</c:v>
                </c:pt>
                <c:pt idx="14">
                  <c:v>1.11966410076977E-2</c:v>
                </c:pt>
                <c:pt idx="15">
                  <c:v>9.7970608817354761E-3</c:v>
                </c:pt>
                <c:pt idx="16">
                  <c:v>5.5983205038488519E-3</c:v>
                </c:pt>
                <c:pt idx="17">
                  <c:v>7.6976906927921631E-3</c:v>
                </c:pt>
                <c:pt idx="18">
                  <c:v>4.8985304408677398E-3</c:v>
                </c:pt>
                <c:pt idx="19">
                  <c:v>4.1987403778866303E-3</c:v>
                </c:pt>
                <c:pt idx="20">
                  <c:v>2.7991602519244221E-3</c:v>
                </c:pt>
              </c:numCache>
            </c:numRef>
          </c:val>
        </c:ser>
        <c:ser>
          <c:idx val="19"/>
          <c:order val="19"/>
          <c:tx>
            <c:strRef>
              <c:f>'cat-1(CB1111)_A1_0.02_5%'!$U$104</c:f>
              <c:strCache>
                <c:ptCount val="1"/>
                <c:pt idx="0">
                  <c:v>cat-1(CB1111)_A1_20</c:v>
                </c:pt>
              </c:strCache>
            </c:strRef>
          </c:tx>
          <c:marker>
            <c:symbol val="none"/>
          </c:marker>
          <c:cat>
            <c:numRef>
              <c:f>'cat-1(CB1111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cat-1(CB1111)_A1_0.02_5%'!$U$105:$U$125</c:f>
              <c:numCache>
                <c:formatCode>General</c:formatCode>
                <c:ptCount val="21"/>
                <c:pt idx="1">
                  <c:v>7.9248366013071905E-2</c:v>
                </c:pt>
                <c:pt idx="2">
                  <c:v>9.7222222222222224E-2</c:v>
                </c:pt>
                <c:pt idx="3">
                  <c:v>0.13071895424836599</c:v>
                </c:pt>
                <c:pt idx="4">
                  <c:v>0.12254901960784295</c:v>
                </c:pt>
                <c:pt idx="5">
                  <c:v>0.15767973856209111</c:v>
                </c:pt>
                <c:pt idx="6">
                  <c:v>8.5784313725490238E-2</c:v>
                </c:pt>
                <c:pt idx="7">
                  <c:v>4.6568627450980421E-2</c:v>
                </c:pt>
                <c:pt idx="8">
                  <c:v>4.9019607843137344E-2</c:v>
                </c:pt>
                <c:pt idx="9">
                  <c:v>3.6764705882352901E-2</c:v>
                </c:pt>
                <c:pt idx="10">
                  <c:v>3.3496732026143811E-2</c:v>
                </c:pt>
                <c:pt idx="11">
                  <c:v>2.8594771241830082E-2</c:v>
                </c:pt>
                <c:pt idx="12">
                  <c:v>1.7156862745097999E-2</c:v>
                </c:pt>
                <c:pt idx="13">
                  <c:v>1.4705882352941199E-2</c:v>
                </c:pt>
                <c:pt idx="14">
                  <c:v>9.8039215686274508E-3</c:v>
                </c:pt>
                <c:pt idx="15">
                  <c:v>6.5359477124183035E-3</c:v>
                </c:pt>
                <c:pt idx="16">
                  <c:v>5.7189542483660075E-3</c:v>
                </c:pt>
                <c:pt idx="17">
                  <c:v>2.4509803921568601E-3</c:v>
                </c:pt>
                <c:pt idx="18">
                  <c:v>5.7189542483660075E-3</c:v>
                </c:pt>
                <c:pt idx="19">
                  <c:v>8.1699346405228798E-3</c:v>
                </c:pt>
                <c:pt idx="20">
                  <c:v>4.0849673202614399E-3</c:v>
                </c:pt>
              </c:numCache>
            </c:numRef>
          </c:val>
        </c:ser>
        <c:marker val="1"/>
        <c:axId val="161226752"/>
        <c:axId val="161228288"/>
      </c:lineChart>
      <c:catAx>
        <c:axId val="161226752"/>
        <c:scaling>
          <c:orientation val="minMax"/>
        </c:scaling>
        <c:axPos val="b"/>
        <c:numFmt formatCode="0.0_ " sourceLinked="1"/>
        <c:tickLblPos val="nextTo"/>
        <c:crossAx val="161228288"/>
        <c:crosses val="autoZero"/>
        <c:auto val="1"/>
        <c:lblAlgn val="ctr"/>
        <c:lblOffset val="100"/>
        <c:tickLblSkip val="5"/>
        <c:tickMarkSkip val="5"/>
      </c:catAx>
      <c:valAx>
        <c:axId val="16122828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1226752"/>
        <c:crosses val="autoZero"/>
        <c:crossBetween val="between"/>
      </c:valAx>
    </c:plotArea>
    <c:plotVisOnly val="1"/>
  </c:chart>
  <c:externalData r:id="rId1"/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tph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tph-1(mg280)_A5_0.02_5%'!$B$104</c:f>
              <c:strCache>
                <c:ptCount val="1"/>
                <c:pt idx="0">
                  <c:v>tph-1(mg280)_A5_01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B$105:$B$125</c:f>
              <c:numCache>
                <c:formatCode>General</c:formatCode>
                <c:ptCount val="21"/>
                <c:pt idx="1">
                  <c:v>0.13043478260869601</c:v>
                </c:pt>
                <c:pt idx="2">
                  <c:v>9.2391304347826136E-2</c:v>
                </c:pt>
                <c:pt idx="3">
                  <c:v>8.1521739130434798E-2</c:v>
                </c:pt>
                <c:pt idx="4">
                  <c:v>6.5217391304347824E-2</c:v>
                </c:pt>
                <c:pt idx="5">
                  <c:v>3.2608695652173912E-2</c:v>
                </c:pt>
                <c:pt idx="6">
                  <c:v>3.8043478260869602E-2</c:v>
                </c:pt>
                <c:pt idx="7">
                  <c:v>1.6304347826087001E-2</c:v>
                </c:pt>
                <c:pt idx="8">
                  <c:v>2.1739130434782601E-2</c:v>
                </c:pt>
                <c:pt idx="9">
                  <c:v>2.7173913043478312E-2</c:v>
                </c:pt>
                <c:pt idx="10">
                  <c:v>2.1739130434782601E-2</c:v>
                </c:pt>
                <c:pt idx="11">
                  <c:v>0</c:v>
                </c:pt>
                <c:pt idx="12">
                  <c:v>2.1739130434782601E-2</c:v>
                </c:pt>
                <c:pt idx="13">
                  <c:v>1.0869565217391306E-2</c:v>
                </c:pt>
                <c:pt idx="14">
                  <c:v>0</c:v>
                </c:pt>
                <c:pt idx="15">
                  <c:v>1.6304347826087001E-2</c:v>
                </c:pt>
                <c:pt idx="16">
                  <c:v>0</c:v>
                </c:pt>
                <c:pt idx="17">
                  <c:v>1.6304347826087001E-2</c:v>
                </c:pt>
                <c:pt idx="18">
                  <c:v>1.0869565217391306E-2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"/>
          <c:order val="1"/>
          <c:tx>
            <c:strRef>
              <c:f>'tph-1(mg280)_A5_0.02_5%'!$C$104</c:f>
              <c:strCache>
                <c:ptCount val="1"/>
                <c:pt idx="0">
                  <c:v>tph-1(mg280)_A5_02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C$105:$C$125</c:f>
              <c:numCache>
                <c:formatCode>General</c:formatCode>
                <c:ptCount val="21"/>
                <c:pt idx="1">
                  <c:v>0.12666666666666695</c:v>
                </c:pt>
                <c:pt idx="2">
                  <c:v>0.10666666666666705</c:v>
                </c:pt>
                <c:pt idx="3">
                  <c:v>8.0000000000000029E-2</c:v>
                </c:pt>
                <c:pt idx="4">
                  <c:v>6.0000000000000019E-2</c:v>
                </c:pt>
                <c:pt idx="5">
                  <c:v>3.3333333333333298E-2</c:v>
                </c:pt>
                <c:pt idx="6">
                  <c:v>2.0000000000000007E-2</c:v>
                </c:pt>
                <c:pt idx="7">
                  <c:v>6.6666666666666714E-3</c:v>
                </c:pt>
                <c:pt idx="8">
                  <c:v>1.3333333333333301E-2</c:v>
                </c:pt>
                <c:pt idx="9">
                  <c:v>6.6666666666666714E-3</c:v>
                </c:pt>
                <c:pt idx="10">
                  <c:v>2.0000000000000007E-2</c:v>
                </c:pt>
                <c:pt idx="11">
                  <c:v>6.6666666666666714E-3</c:v>
                </c:pt>
                <c:pt idx="12">
                  <c:v>1.3333333333333301E-2</c:v>
                </c:pt>
                <c:pt idx="13">
                  <c:v>6.6666666666666714E-3</c:v>
                </c:pt>
                <c:pt idx="14">
                  <c:v>6.6666666666666714E-3</c:v>
                </c:pt>
                <c:pt idx="15">
                  <c:v>1.3333333333333301E-2</c:v>
                </c:pt>
                <c:pt idx="16">
                  <c:v>0</c:v>
                </c:pt>
                <c:pt idx="17">
                  <c:v>2.0000000000000007E-2</c:v>
                </c:pt>
                <c:pt idx="18">
                  <c:v>6.6666666666666714E-3</c:v>
                </c:pt>
                <c:pt idx="19">
                  <c:v>0</c:v>
                </c:pt>
                <c:pt idx="20">
                  <c:v>1.3333333333333301E-2</c:v>
                </c:pt>
              </c:numCache>
            </c:numRef>
          </c:val>
        </c:ser>
        <c:ser>
          <c:idx val="2"/>
          <c:order val="2"/>
          <c:tx>
            <c:strRef>
              <c:f>'tph-1(mg280)_A5_0.02_5%'!$D$104</c:f>
              <c:strCache>
                <c:ptCount val="1"/>
                <c:pt idx="0">
                  <c:v>tph-1(mg280)_A5_03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D$105:$D$125</c:f>
              <c:numCache>
                <c:formatCode>General</c:formatCode>
                <c:ptCount val="21"/>
                <c:pt idx="1">
                  <c:v>0.18461538461538504</c:v>
                </c:pt>
                <c:pt idx="2">
                  <c:v>0.12307692307692306</c:v>
                </c:pt>
                <c:pt idx="3">
                  <c:v>6.1538461538461514E-2</c:v>
                </c:pt>
                <c:pt idx="4">
                  <c:v>3.0769230769230802E-2</c:v>
                </c:pt>
                <c:pt idx="5">
                  <c:v>3.0769230769230802E-2</c:v>
                </c:pt>
                <c:pt idx="6">
                  <c:v>1.5384615384615405E-2</c:v>
                </c:pt>
                <c:pt idx="7">
                  <c:v>3.0769230769230802E-2</c:v>
                </c:pt>
                <c:pt idx="8">
                  <c:v>0</c:v>
                </c:pt>
                <c:pt idx="9">
                  <c:v>3.0769230769230802E-2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.5384615384615405E-2</c:v>
                </c:pt>
                <c:pt idx="14">
                  <c:v>1.5384615384615405E-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3"/>
          <c:order val="3"/>
          <c:tx>
            <c:strRef>
              <c:f>'tph-1(mg280)_A5_0.02_5%'!$E$104</c:f>
              <c:strCache>
                <c:ptCount val="1"/>
                <c:pt idx="0">
                  <c:v>tph-1(mg280)_A5_04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E$105:$E$125</c:f>
              <c:numCache>
                <c:formatCode>General</c:formatCode>
                <c:ptCount val="21"/>
                <c:pt idx="1">
                  <c:v>6.5217391304347824E-2</c:v>
                </c:pt>
                <c:pt idx="2">
                  <c:v>0.17391304347826111</c:v>
                </c:pt>
                <c:pt idx="3">
                  <c:v>2.1739130434782601E-2</c:v>
                </c:pt>
                <c:pt idx="4">
                  <c:v>2.1739130434782601E-2</c:v>
                </c:pt>
                <c:pt idx="5">
                  <c:v>4.3478260869565202E-2</c:v>
                </c:pt>
                <c:pt idx="6">
                  <c:v>2.1739130434782601E-2</c:v>
                </c:pt>
                <c:pt idx="7">
                  <c:v>0</c:v>
                </c:pt>
                <c:pt idx="8">
                  <c:v>0</c:v>
                </c:pt>
                <c:pt idx="9">
                  <c:v>2.1739130434782601E-2</c:v>
                </c:pt>
                <c:pt idx="10">
                  <c:v>2.1739130434782601E-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4"/>
          <c:order val="4"/>
          <c:tx>
            <c:strRef>
              <c:f>'tph-1(mg280)_A5_0.02_5%'!$F$104</c:f>
              <c:strCache>
                <c:ptCount val="1"/>
                <c:pt idx="0">
                  <c:v>tph-1(mg280)_A5_05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F$105:$F$125</c:f>
              <c:numCache>
                <c:formatCode>General</c:formatCode>
                <c:ptCount val="21"/>
                <c:pt idx="1">
                  <c:v>0.15830115830115801</c:v>
                </c:pt>
                <c:pt idx="2">
                  <c:v>0.13513513513513506</c:v>
                </c:pt>
                <c:pt idx="3">
                  <c:v>0.10038610038610005</c:v>
                </c:pt>
                <c:pt idx="4">
                  <c:v>7.7220077220077218E-2</c:v>
                </c:pt>
                <c:pt idx="5">
                  <c:v>5.7915057915057903E-2</c:v>
                </c:pt>
                <c:pt idx="6">
                  <c:v>3.47490347490347E-2</c:v>
                </c:pt>
                <c:pt idx="7">
                  <c:v>2.7027027027027015E-2</c:v>
                </c:pt>
                <c:pt idx="8">
                  <c:v>1.9305019305019308E-2</c:v>
                </c:pt>
                <c:pt idx="9">
                  <c:v>3.0888030888030899E-2</c:v>
                </c:pt>
                <c:pt idx="10">
                  <c:v>1.9305019305019308E-2</c:v>
                </c:pt>
                <c:pt idx="11">
                  <c:v>1.1583011583011601E-2</c:v>
                </c:pt>
                <c:pt idx="12">
                  <c:v>1.1583011583011601E-2</c:v>
                </c:pt>
                <c:pt idx="13">
                  <c:v>1.1583011583011601E-2</c:v>
                </c:pt>
                <c:pt idx="14">
                  <c:v>3.8610038610038602E-3</c:v>
                </c:pt>
                <c:pt idx="15">
                  <c:v>1.1583011583011601E-2</c:v>
                </c:pt>
                <c:pt idx="16">
                  <c:v>0</c:v>
                </c:pt>
                <c:pt idx="17">
                  <c:v>1.1583011583011601E-2</c:v>
                </c:pt>
                <c:pt idx="18">
                  <c:v>1.5444015444015408E-2</c:v>
                </c:pt>
                <c:pt idx="19">
                  <c:v>7.7220077220077222E-3</c:v>
                </c:pt>
                <c:pt idx="20">
                  <c:v>7.7220077220077222E-3</c:v>
                </c:pt>
              </c:numCache>
            </c:numRef>
          </c:val>
        </c:ser>
        <c:ser>
          <c:idx val="5"/>
          <c:order val="5"/>
          <c:tx>
            <c:strRef>
              <c:f>'tph-1(mg280)_A5_0.02_5%'!$G$104</c:f>
              <c:strCache>
                <c:ptCount val="1"/>
                <c:pt idx="0">
                  <c:v>tph-1(mg280)_A5_06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G$105:$G$125</c:f>
              <c:numCache>
                <c:formatCode>General</c:formatCode>
                <c:ptCount val="21"/>
                <c:pt idx="1">
                  <c:v>9.9378881987577605E-2</c:v>
                </c:pt>
                <c:pt idx="2">
                  <c:v>7.1428571428571411E-2</c:v>
                </c:pt>
                <c:pt idx="3">
                  <c:v>0.10869565217391308</c:v>
                </c:pt>
                <c:pt idx="4">
                  <c:v>7.7639751552794997E-2</c:v>
                </c:pt>
                <c:pt idx="5">
                  <c:v>7.7639751552794997E-2</c:v>
                </c:pt>
                <c:pt idx="6">
                  <c:v>3.1055900621118016E-2</c:v>
                </c:pt>
                <c:pt idx="7">
                  <c:v>3.1055900621118016E-2</c:v>
                </c:pt>
                <c:pt idx="8">
                  <c:v>3.7267080745341602E-2</c:v>
                </c:pt>
                <c:pt idx="9">
                  <c:v>3.4161490683229802E-2</c:v>
                </c:pt>
                <c:pt idx="10">
                  <c:v>3.7267080745341602E-2</c:v>
                </c:pt>
                <c:pt idx="11">
                  <c:v>1.2422360248447206E-2</c:v>
                </c:pt>
                <c:pt idx="12">
                  <c:v>1.2422360248447206E-2</c:v>
                </c:pt>
                <c:pt idx="13">
                  <c:v>2.1739130434782601E-2</c:v>
                </c:pt>
                <c:pt idx="14">
                  <c:v>2.4844720496894401E-2</c:v>
                </c:pt>
                <c:pt idx="15">
                  <c:v>1.2422360248447206E-2</c:v>
                </c:pt>
                <c:pt idx="16">
                  <c:v>9.3167701863354005E-3</c:v>
                </c:pt>
                <c:pt idx="17">
                  <c:v>2.1739130434782601E-2</c:v>
                </c:pt>
                <c:pt idx="18">
                  <c:v>6.2111801242236038E-3</c:v>
                </c:pt>
                <c:pt idx="19">
                  <c:v>9.3167701863354005E-3</c:v>
                </c:pt>
                <c:pt idx="20">
                  <c:v>1.2422360248447206E-2</c:v>
                </c:pt>
              </c:numCache>
            </c:numRef>
          </c:val>
        </c:ser>
        <c:ser>
          <c:idx val="6"/>
          <c:order val="6"/>
          <c:tx>
            <c:strRef>
              <c:f>'tph-1(mg280)_A5_0.02_5%'!$H$104</c:f>
              <c:strCache>
                <c:ptCount val="1"/>
                <c:pt idx="0">
                  <c:v>tph-1(mg280)_A5_07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H$105:$H$125</c:f>
              <c:numCache>
                <c:formatCode>General</c:formatCode>
                <c:ptCount val="21"/>
                <c:pt idx="1">
                  <c:v>0.11555555555555599</c:v>
                </c:pt>
                <c:pt idx="2">
                  <c:v>0.15111111111111106</c:v>
                </c:pt>
                <c:pt idx="3">
                  <c:v>0.10666666666666705</c:v>
                </c:pt>
                <c:pt idx="4">
                  <c:v>7.555555555555557E-2</c:v>
                </c:pt>
                <c:pt idx="5">
                  <c:v>5.3333333333333337E-2</c:v>
                </c:pt>
                <c:pt idx="6">
                  <c:v>2.6666666666666707E-2</c:v>
                </c:pt>
                <c:pt idx="7">
                  <c:v>2.6666666666666707E-2</c:v>
                </c:pt>
                <c:pt idx="8">
                  <c:v>2.2222222222222202E-2</c:v>
                </c:pt>
                <c:pt idx="9">
                  <c:v>1.3333333333333301E-2</c:v>
                </c:pt>
                <c:pt idx="10">
                  <c:v>1.3333333333333301E-2</c:v>
                </c:pt>
                <c:pt idx="11">
                  <c:v>1.3333333333333301E-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4.4444444444444418E-3</c:v>
                </c:pt>
                <c:pt idx="16">
                  <c:v>8.8888888888888941E-3</c:v>
                </c:pt>
                <c:pt idx="17">
                  <c:v>8.8888888888888941E-3</c:v>
                </c:pt>
                <c:pt idx="18">
                  <c:v>0</c:v>
                </c:pt>
                <c:pt idx="19">
                  <c:v>4.4444444444444418E-3</c:v>
                </c:pt>
                <c:pt idx="20">
                  <c:v>4.4444444444444418E-3</c:v>
                </c:pt>
              </c:numCache>
            </c:numRef>
          </c:val>
        </c:ser>
        <c:ser>
          <c:idx val="7"/>
          <c:order val="7"/>
          <c:tx>
            <c:strRef>
              <c:f>'tph-1(mg280)_A5_0.02_5%'!$I$104</c:f>
              <c:strCache>
                <c:ptCount val="1"/>
                <c:pt idx="0">
                  <c:v>tph-1(mg280)_A5_08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I$105:$I$125</c:f>
              <c:numCache>
                <c:formatCode>General</c:formatCode>
                <c:ptCount val="21"/>
                <c:pt idx="1">
                  <c:v>8.9285714285714246E-2</c:v>
                </c:pt>
                <c:pt idx="2">
                  <c:v>5.3571428571428603E-2</c:v>
                </c:pt>
                <c:pt idx="3">
                  <c:v>3.5714285714285698E-2</c:v>
                </c:pt>
                <c:pt idx="4">
                  <c:v>7.1428571428571411E-2</c:v>
                </c:pt>
                <c:pt idx="5">
                  <c:v>1.7857142857142898E-2</c:v>
                </c:pt>
                <c:pt idx="6">
                  <c:v>8.9285714285714246E-2</c:v>
                </c:pt>
                <c:pt idx="7">
                  <c:v>0</c:v>
                </c:pt>
                <c:pt idx="8">
                  <c:v>3.5714285714285698E-2</c:v>
                </c:pt>
                <c:pt idx="9">
                  <c:v>1.7857142857142898E-2</c:v>
                </c:pt>
                <c:pt idx="10">
                  <c:v>1.7857142857142898E-2</c:v>
                </c:pt>
                <c:pt idx="11">
                  <c:v>1.7857142857142898E-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.7857142857142898E-2</c:v>
                </c:pt>
                <c:pt idx="16">
                  <c:v>3.5714285714285698E-2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1.7857142857142898E-2</c:v>
                </c:pt>
              </c:numCache>
            </c:numRef>
          </c:val>
        </c:ser>
        <c:ser>
          <c:idx val="8"/>
          <c:order val="8"/>
          <c:tx>
            <c:strRef>
              <c:f>'tph-1(mg280)_A5_0.02_5%'!$J$104</c:f>
              <c:strCache>
                <c:ptCount val="1"/>
                <c:pt idx="0">
                  <c:v>tph-1(mg280)_A5_10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J$105:$J$125</c:f>
              <c:numCache>
                <c:formatCode>General</c:formatCode>
                <c:ptCount val="21"/>
                <c:pt idx="1">
                  <c:v>0.10126582278481006</c:v>
                </c:pt>
                <c:pt idx="2">
                  <c:v>0.10126582278481006</c:v>
                </c:pt>
                <c:pt idx="3">
                  <c:v>0.116455696202532</c:v>
                </c:pt>
                <c:pt idx="4">
                  <c:v>8.6075949367088636E-2</c:v>
                </c:pt>
                <c:pt idx="5">
                  <c:v>8.6075949367088636E-2</c:v>
                </c:pt>
                <c:pt idx="6">
                  <c:v>4.5569620253164599E-2</c:v>
                </c:pt>
                <c:pt idx="7">
                  <c:v>5.5696202531645631E-2</c:v>
                </c:pt>
                <c:pt idx="8">
                  <c:v>4.05063291139241E-2</c:v>
                </c:pt>
                <c:pt idx="9">
                  <c:v>3.0379746835442999E-2</c:v>
                </c:pt>
                <c:pt idx="10">
                  <c:v>1.5189873417721501E-2</c:v>
                </c:pt>
                <c:pt idx="11">
                  <c:v>2.0253164556962001E-2</c:v>
                </c:pt>
                <c:pt idx="12">
                  <c:v>1.2658227848101299E-2</c:v>
                </c:pt>
                <c:pt idx="13">
                  <c:v>5.0632911392405116E-3</c:v>
                </c:pt>
                <c:pt idx="14">
                  <c:v>1.7721518987341801E-2</c:v>
                </c:pt>
                <c:pt idx="15">
                  <c:v>1.2658227848101299E-2</c:v>
                </c:pt>
                <c:pt idx="16">
                  <c:v>1.7721518987341801E-2</c:v>
                </c:pt>
                <c:pt idx="17">
                  <c:v>5.0632911392405116E-3</c:v>
                </c:pt>
                <c:pt idx="18">
                  <c:v>1.0126582278481001E-2</c:v>
                </c:pt>
                <c:pt idx="19">
                  <c:v>2.5316455696202493E-3</c:v>
                </c:pt>
                <c:pt idx="20">
                  <c:v>0</c:v>
                </c:pt>
              </c:numCache>
            </c:numRef>
          </c:val>
        </c:ser>
        <c:ser>
          <c:idx val="9"/>
          <c:order val="9"/>
          <c:tx>
            <c:strRef>
              <c:f>'tph-1(mg280)_A5_0.02_5%'!$K$104</c:f>
              <c:strCache>
                <c:ptCount val="1"/>
                <c:pt idx="0">
                  <c:v>tph-1(mg280)_A5_11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K$105:$K$125</c:f>
              <c:numCache>
                <c:formatCode>General</c:formatCode>
                <c:ptCount val="21"/>
                <c:pt idx="1">
                  <c:v>0.13544668587896311</c:v>
                </c:pt>
                <c:pt idx="2">
                  <c:v>0.16138328530259399</c:v>
                </c:pt>
                <c:pt idx="3">
                  <c:v>0.126801152737752</c:v>
                </c:pt>
                <c:pt idx="4">
                  <c:v>7.7809798270893404E-2</c:v>
                </c:pt>
                <c:pt idx="5">
                  <c:v>6.0518731988472636E-2</c:v>
                </c:pt>
                <c:pt idx="6">
                  <c:v>6.3400576368876096E-2</c:v>
                </c:pt>
                <c:pt idx="7">
                  <c:v>4.8991354466858796E-2</c:v>
                </c:pt>
                <c:pt idx="8">
                  <c:v>1.7291066282420799E-2</c:v>
                </c:pt>
                <c:pt idx="9">
                  <c:v>2.8818443804034598E-2</c:v>
                </c:pt>
                <c:pt idx="10">
                  <c:v>8.6455331412103806E-3</c:v>
                </c:pt>
                <c:pt idx="11">
                  <c:v>2.3054755043227692E-2</c:v>
                </c:pt>
                <c:pt idx="12">
                  <c:v>8.6455331412103806E-3</c:v>
                </c:pt>
                <c:pt idx="13">
                  <c:v>2.8818443804034598E-3</c:v>
                </c:pt>
                <c:pt idx="14">
                  <c:v>2.8818443804034598E-3</c:v>
                </c:pt>
                <c:pt idx="15">
                  <c:v>5.7636887608069204E-3</c:v>
                </c:pt>
                <c:pt idx="16">
                  <c:v>0</c:v>
                </c:pt>
                <c:pt idx="17">
                  <c:v>2.8818443804034598E-3</c:v>
                </c:pt>
                <c:pt idx="18">
                  <c:v>2.8818443804034598E-3</c:v>
                </c:pt>
                <c:pt idx="19">
                  <c:v>2.8818443804034598E-3</c:v>
                </c:pt>
                <c:pt idx="2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tph-1(mg280)_A5_0.02_5%'!$L$104</c:f>
              <c:strCache>
                <c:ptCount val="1"/>
                <c:pt idx="0">
                  <c:v>tph-1(mg280)_A5_12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L$105:$L$125</c:f>
              <c:numCache>
                <c:formatCode>General</c:formatCode>
                <c:ptCount val="21"/>
                <c:pt idx="1">
                  <c:v>0.14044943820224712</c:v>
                </c:pt>
                <c:pt idx="2">
                  <c:v>0.21348314606741611</c:v>
                </c:pt>
                <c:pt idx="3">
                  <c:v>0.12359550561797802</c:v>
                </c:pt>
                <c:pt idx="4">
                  <c:v>8.4269662921348298E-2</c:v>
                </c:pt>
                <c:pt idx="5">
                  <c:v>3.9325842696629212E-2</c:v>
                </c:pt>
                <c:pt idx="6">
                  <c:v>1.6853932584269701E-2</c:v>
                </c:pt>
                <c:pt idx="7">
                  <c:v>6.1797752808988818E-2</c:v>
                </c:pt>
                <c:pt idx="8">
                  <c:v>1.1235955056179799E-2</c:v>
                </c:pt>
                <c:pt idx="9">
                  <c:v>1.6853932584269701E-2</c:v>
                </c:pt>
                <c:pt idx="10">
                  <c:v>5.6179775280898884E-3</c:v>
                </c:pt>
                <c:pt idx="11">
                  <c:v>1.1235955056179799E-2</c:v>
                </c:pt>
                <c:pt idx="12">
                  <c:v>1.1235955056179799E-2</c:v>
                </c:pt>
                <c:pt idx="13">
                  <c:v>5.6179775280898884E-3</c:v>
                </c:pt>
                <c:pt idx="14">
                  <c:v>5.6179775280898884E-3</c:v>
                </c:pt>
                <c:pt idx="15">
                  <c:v>0</c:v>
                </c:pt>
                <c:pt idx="16">
                  <c:v>5.6179775280898884E-3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tph-1(mg280)_A5_0.02_5%'!$M$104</c:f>
              <c:strCache>
                <c:ptCount val="1"/>
                <c:pt idx="0">
                  <c:v>tph-1(mg280)_A5_13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M$105:$M$125</c:f>
              <c:numCache>
                <c:formatCode>General</c:formatCode>
                <c:ptCount val="21"/>
                <c:pt idx="1">
                  <c:v>9.1891891891891939E-2</c:v>
                </c:pt>
                <c:pt idx="2">
                  <c:v>0.13513513513513506</c:v>
                </c:pt>
                <c:pt idx="3">
                  <c:v>9.7297297297297303E-2</c:v>
                </c:pt>
                <c:pt idx="4">
                  <c:v>5.9459459459459497E-2</c:v>
                </c:pt>
                <c:pt idx="5">
                  <c:v>3.24324324324324E-2</c:v>
                </c:pt>
                <c:pt idx="6">
                  <c:v>3.24324324324324E-2</c:v>
                </c:pt>
                <c:pt idx="7">
                  <c:v>3.24324324324324E-2</c:v>
                </c:pt>
                <c:pt idx="8">
                  <c:v>1.62162162162162E-2</c:v>
                </c:pt>
                <c:pt idx="9">
                  <c:v>3.24324324324324E-2</c:v>
                </c:pt>
                <c:pt idx="10">
                  <c:v>2.1621621621621602E-2</c:v>
                </c:pt>
                <c:pt idx="11">
                  <c:v>2.1621621621621602E-2</c:v>
                </c:pt>
                <c:pt idx="12">
                  <c:v>1.0810810810810801E-2</c:v>
                </c:pt>
                <c:pt idx="13">
                  <c:v>5.4054054054054118E-3</c:v>
                </c:pt>
                <c:pt idx="14">
                  <c:v>5.4054054054054118E-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tph-1(mg280)_A5_0.02_5%'!$N$104</c:f>
              <c:strCache>
                <c:ptCount val="1"/>
                <c:pt idx="0">
                  <c:v>tph-1(mg280)_A5_14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N$105:$N$125</c:f>
              <c:numCache>
                <c:formatCode>General</c:formatCode>
                <c:ptCount val="21"/>
                <c:pt idx="1">
                  <c:v>0.11149825783972098</c:v>
                </c:pt>
                <c:pt idx="2">
                  <c:v>0.16376306620209105</c:v>
                </c:pt>
                <c:pt idx="3">
                  <c:v>0.12543554006968594</c:v>
                </c:pt>
                <c:pt idx="4">
                  <c:v>7.6655052264808385E-2</c:v>
                </c:pt>
                <c:pt idx="5">
                  <c:v>4.8780487804878127E-2</c:v>
                </c:pt>
                <c:pt idx="6">
                  <c:v>4.1811846689895481E-2</c:v>
                </c:pt>
                <c:pt idx="7">
                  <c:v>3.8327526132404185E-2</c:v>
                </c:pt>
                <c:pt idx="8">
                  <c:v>2.4390243902439001E-2</c:v>
                </c:pt>
                <c:pt idx="9">
                  <c:v>1.74216027874564E-2</c:v>
                </c:pt>
                <c:pt idx="10">
                  <c:v>1.3937282229965204E-2</c:v>
                </c:pt>
                <c:pt idx="11">
                  <c:v>1.74216027874564E-2</c:v>
                </c:pt>
                <c:pt idx="12">
                  <c:v>1.3937282229965204E-2</c:v>
                </c:pt>
                <c:pt idx="13">
                  <c:v>6.9686411149825853E-3</c:v>
                </c:pt>
                <c:pt idx="14">
                  <c:v>6.9686411149825853E-3</c:v>
                </c:pt>
                <c:pt idx="15">
                  <c:v>3.4843205574912927E-3</c:v>
                </c:pt>
                <c:pt idx="16">
                  <c:v>3.4843205574912927E-3</c:v>
                </c:pt>
                <c:pt idx="17">
                  <c:v>3.4843205574912927E-3</c:v>
                </c:pt>
                <c:pt idx="18">
                  <c:v>3.4843205574912927E-3</c:v>
                </c:pt>
                <c:pt idx="19">
                  <c:v>3.4843205574912927E-3</c:v>
                </c:pt>
                <c:pt idx="20">
                  <c:v>3.4843205574912927E-3</c:v>
                </c:pt>
              </c:numCache>
            </c:numRef>
          </c:val>
        </c:ser>
        <c:ser>
          <c:idx val="13"/>
          <c:order val="13"/>
          <c:tx>
            <c:strRef>
              <c:f>'tph-1(mg280)_A5_0.02_5%'!$O$104</c:f>
              <c:strCache>
                <c:ptCount val="1"/>
                <c:pt idx="0">
                  <c:v>tph-1(mg280)_A5_15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O$105:$O$125</c:f>
              <c:numCache>
                <c:formatCode>General</c:formatCode>
                <c:ptCount val="21"/>
                <c:pt idx="1">
                  <c:v>0.12429378531073405</c:v>
                </c:pt>
                <c:pt idx="2">
                  <c:v>8.7570621468926579E-2</c:v>
                </c:pt>
                <c:pt idx="3">
                  <c:v>9.6045197740112997E-2</c:v>
                </c:pt>
                <c:pt idx="4">
                  <c:v>8.7570621468926579E-2</c:v>
                </c:pt>
                <c:pt idx="5">
                  <c:v>9.8870056497175132E-2</c:v>
                </c:pt>
                <c:pt idx="6">
                  <c:v>5.3672316384180796E-2</c:v>
                </c:pt>
                <c:pt idx="7">
                  <c:v>2.824858757062151E-2</c:v>
                </c:pt>
                <c:pt idx="8">
                  <c:v>3.1073446327683614E-2</c:v>
                </c:pt>
                <c:pt idx="9">
                  <c:v>1.9774011299435009E-2</c:v>
                </c:pt>
                <c:pt idx="10">
                  <c:v>1.41242937853107E-2</c:v>
                </c:pt>
                <c:pt idx="11">
                  <c:v>2.824858757062151E-2</c:v>
                </c:pt>
                <c:pt idx="12">
                  <c:v>2.824858757062151E-2</c:v>
                </c:pt>
                <c:pt idx="13">
                  <c:v>1.41242937853107E-2</c:v>
                </c:pt>
                <c:pt idx="14">
                  <c:v>1.9774011299435009E-2</c:v>
                </c:pt>
                <c:pt idx="15">
                  <c:v>1.6949152542372906E-2</c:v>
                </c:pt>
                <c:pt idx="16">
                  <c:v>1.6949152542372906E-2</c:v>
                </c:pt>
                <c:pt idx="17">
                  <c:v>8.4745762711864476E-3</c:v>
                </c:pt>
                <c:pt idx="18">
                  <c:v>1.41242937853107E-2</c:v>
                </c:pt>
                <c:pt idx="19">
                  <c:v>8.4745762711864476E-3</c:v>
                </c:pt>
                <c:pt idx="20">
                  <c:v>1.9774011299435009E-2</c:v>
                </c:pt>
              </c:numCache>
            </c:numRef>
          </c:val>
        </c:ser>
        <c:ser>
          <c:idx val="14"/>
          <c:order val="14"/>
          <c:tx>
            <c:strRef>
              <c:f>'tph-1(mg280)_A5_0.02_5%'!$P$104</c:f>
              <c:strCache>
                <c:ptCount val="1"/>
                <c:pt idx="0">
                  <c:v>tph-1(mg280)_A5_16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P$105:$P$125</c:f>
              <c:numCache>
                <c:formatCode>General</c:formatCode>
                <c:ptCount val="21"/>
                <c:pt idx="1">
                  <c:v>9.5854922279792781E-2</c:v>
                </c:pt>
                <c:pt idx="2">
                  <c:v>0.116580310880829</c:v>
                </c:pt>
                <c:pt idx="3">
                  <c:v>8.8082901554404097E-2</c:v>
                </c:pt>
                <c:pt idx="4">
                  <c:v>8.8082901554404097E-2</c:v>
                </c:pt>
                <c:pt idx="5">
                  <c:v>6.4766839378238336E-2</c:v>
                </c:pt>
                <c:pt idx="6">
                  <c:v>4.6632124352331626E-2</c:v>
                </c:pt>
                <c:pt idx="7">
                  <c:v>5.6994818652849701E-2</c:v>
                </c:pt>
                <c:pt idx="8">
                  <c:v>4.9222797927461127E-2</c:v>
                </c:pt>
                <c:pt idx="9">
                  <c:v>5.4404145077720185E-2</c:v>
                </c:pt>
                <c:pt idx="10">
                  <c:v>2.5906735751295307E-2</c:v>
                </c:pt>
                <c:pt idx="11">
                  <c:v>3.8860103626943011E-2</c:v>
                </c:pt>
                <c:pt idx="12">
                  <c:v>2.5906735751295307E-2</c:v>
                </c:pt>
                <c:pt idx="13">
                  <c:v>3.1088082901554407E-2</c:v>
                </c:pt>
                <c:pt idx="14">
                  <c:v>1.81347150259067E-2</c:v>
                </c:pt>
                <c:pt idx="15">
                  <c:v>1.5544041450777204E-2</c:v>
                </c:pt>
                <c:pt idx="16">
                  <c:v>1.81347150259067E-2</c:v>
                </c:pt>
                <c:pt idx="17">
                  <c:v>2.5906735751295299E-3</c:v>
                </c:pt>
                <c:pt idx="18">
                  <c:v>1.5544041450777204E-2</c:v>
                </c:pt>
                <c:pt idx="19">
                  <c:v>7.7720207253886052E-3</c:v>
                </c:pt>
                <c:pt idx="20">
                  <c:v>1.0362694300518104E-2</c:v>
                </c:pt>
              </c:numCache>
            </c:numRef>
          </c:val>
        </c:ser>
        <c:ser>
          <c:idx val="15"/>
          <c:order val="15"/>
          <c:tx>
            <c:strRef>
              <c:f>'tph-1(mg280)_A5_0.02_5%'!$Q$104</c:f>
              <c:strCache>
                <c:ptCount val="1"/>
                <c:pt idx="0">
                  <c:v>tph-1(mg280)_A5_17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Q$105:$Q$125</c:f>
              <c:numCache>
                <c:formatCode>General</c:formatCode>
                <c:ptCount val="21"/>
                <c:pt idx="1">
                  <c:v>0.12235294117647103</c:v>
                </c:pt>
                <c:pt idx="2">
                  <c:v>0.15058823529411799</c:v>
                </c:pt>
                <c:pt idx="3">
                  <c:v>0.12235294117647103</c:v>
                </c:pt>
                <c:pt idx="4">
                  <c:v>0.10823529411764703</c:v>
                </c:pt>
                <c:pt idx="5">
                  <c:v>7.2941176470588204E-2</c:v>
                </c:pt>
                <c:pt idx="6">
                  <c:v>6.5882352941176531E-2</c:v>
                </c:pt>
                <c:pt idx="7">
                  <c:v>4.2352941176470621E-2</c:v>
                </c:pt>
                <c:pt idx="8">
                  <c:v>3.5294117647058802E-2</c:v>
                </c:pt>
                <c:pt idx="9">
                  <c:v>1.1764705882352905E-2</c:v>
                </c:pt>
                <c:pt idx="10">
                  <c:v>1.1764705882352905E-2</c:v>
                </c:pt>
                <c:pt idx="11">
                  <c:v>1.8823529411764711E-2</c:v>
                </c:pt>
                <c:pt idx="12">
                  <c:v>1.4117647058823493E-2</c:v>
                </c:pt>
                <c:pt idx="13">
                  <c:v>7.0588235294117719E-3</c:v>
                </c:pt>
                <c:pt idx="14">
                  <c:v>1.6470588235294101E-2</c:v>
                </c:pt>
                <c:pt idx="15">
                  <c:v>0</c:v>
                </c:pt>
                <c:pt idx="16">
                  <c:v>7.0588235294117719E-3</c:v>
                </c:pt>
                <c:pt idx="17">
                  <c:v>0</c:v>
                </c:pt>
                <c:pt idx="18">
                  <c:v>7.0588235294117719E-3</c:v>
                </c:pt>
                <c:pt idx="19">
                  <c:v>7.0588235294117719E-3</c:v>
                </c:pt>
                <c:pt idx="20">
                  <c:v>4.7058823529411821E-3</c:v>
                </c:pt>
              </c:numCache>
            </c:numRef>
          </c:val>
        </c:ser>
        <c:ser>
          <c:idx val="16"/>
          <c:order val="16"/>
          <c:tx>
            <c:strRef>
              <c:f>'tph-1(mg280)_A5_0.02_5%'!$R$104</c:f>
              <c:strCache>
                <c:ptCount val="1"/>
                <c:pt idx="0">
                  <c:v>tph-1(mg280)_A5_18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R$105:$R$125</c:f>
              <c:numCache>
                <c:formatCode>General</c:formatCode>
                <c:ptCount val="21"/>
                <c:pt idx="1">
                  <c:v>0.12857142857142906</c:v>
                </c:pt>
                <c:pt idx="2">
                  <c:v>0.13214285714285701</c:v>
                </c:pt>
                <c:pt idx="3">
                  <c:v>0.13571428571428606</c:v>
                </c:pt>
                <c:pt idx="4">
                  <c:v>6.4285714285714293E-2</c:v>
                </c:pt>
                <c:pt idx="5">
                  <c:v>6.4285714285714293E-2</c:v>
                </c:pt>
                <c:pt idx="6">
                  <c:v>3.5714285714285698E-2</c:v>
                </c:pt>
                <c:pt idx="7">
                  <c:v>2.8571428571428602E-2</c:v>
                </c:pt>
                <c:pt idx="8">
                  <c:v>1.7857142857142898E-2</c:v>
                </c:pt>
                <c:pt idx="9">
                  <c:v>3.2142857142857098E-2</c:v>
                </c:pt>
                <c:pt idx="10">
                  <c:v>1.4285714285714301E-2</c:v>
                </c:pt>
                <c:pt idx="11">
                  <c:v>1.7857142857142898E-2</c:v>
                </c:pt>
                <c:pt idx="12">
                  <c:v>2.5000000000000001E-2</c:v>
                </c:pt>
                <c:pt idx="13">
                  <c:v>7.1428571428571418E-3</c:v>
                </c:pt>
                <c:pt idx="14">
                  <c:v>1.0714285714285704E-2</c:v>
                </c:pt>
                <c:pt idx="15">
                  <c:v>0</c:v>
                </c:pt>
                <c:pt idx="16">
                  <c:v>7.1428571428571418E-3</c:v>
                </c:pt>
                <c:pt idx="17">
                  <c:v>7.1428571428571418E-3</c:v>
                </c:pt>
                <c:pt idx="18">
                  <c:v>3.5714285714285709E-3</c:v>
                </c:pt>
                <c:pt idx="19">
                  <c:v>7.1428571428571418E-3</c:v>
                </c:pt>
                <c:pt idx="20">
                  <c:v>7.1428571428571418E-3</c:v>
                </c:pt>
              </c:numCache>
            </c:numRef>
          </c:val>
        </c:ser>
        <c:ser>
          <c:idx val="17"/>
          <c:order val="17"/>
          <c:tx>
            <c:strRef>
              <c:f>'tph-1(mg280)_A5_0.02_5%'!$S$104</c:f>
              <c:strCache>
                <c:ptCount val="1"/>
                <c:pt idx="0">
                  <c:v>tph-1(mg280)_A5_19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S$105:$S$125</c:f>
              <c:numCache>
                <c:formatCode>General</c:formatCode>
                <c:ptCount val="21"/>
                <c:pt idx="1">
                  <c:v>6.9518716577540093E-2</c:v>
                </c:pt>
                <c:pt idx="2">
                  <c:v>0.12655971479500897</c:v>
                </c:pt>
                <c:pt idx="3">
                  <c:v>9.0909090909090939E-2</c:v>
                </c:pt>
                <c:pt idx="4">
                  <c:v>8.1996434937611398E-2</c:v>
                </c:pt>
                <c:pt idx="5">
                  <c:v>0.11586452762923399</c:v>
                </c:pt>
                <c:pt idx="6">
                  <c:v>6.595365418894833E-2</c:v>
                </c:pt>
                <c:pt idx="7">
                  <c:v>6.4171122994652399E-2</c:v>
                </c:pt>
                <c:pt idx="8">
                  <c:v>3.5650623885918005E-2</c:v>
                </c:pt>
                <c:pt idx="9">
                  <c:v>5.7040998217468802E-2</c:v>
                </c:pt>
                <c:pt idx="10">
                  <c:v>3.7433155080213928E-2</c:v>
                </c:pt>
                <c:pt idx="11">
                  <c:v>2.3172905525846714E-2</c:v>
                </c:pt>
                <c:pt idx="12">
                  <c:v>2.6737967914438505E-2</c:v>
                </c:pt>
                <c:pt idx="13">
                  <c:v>1.9607843137254902E-2</c:v>
                </c:pt>
                <c:pt idx="14">
                  <c:v>2.1390374331550797E-2</c:v>
                </c:pt>
                <c:pt idx="15">
                  <c:v>1.06951871657754E-2</c:v>
                </c:pt>
                <c:pt idx="16">
                  <c:v>1.7825311942959002E-2</c:v>
                </c:pt>
                <c:pt idx="17">
                  <c:v>7.130124777183602E-3</c:v>
                </c:pt>
                <c:pt idx="18">
                  <c:v>1.2477718360071298E-2</c:v>
                </c:pt>
                <c:pt idx="19">
                  <c:v>1.2477718360071298E-2</c:v>
                </c:pt>
                <c:pt idx="2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tph-1(mg280)_A5_0.02_5%'!$T$104</c:f>
              <c:strCache>
                <c:ptCount val="1"/>
                <c:pt idx="0">
                  <c:v>tph-1(mg280)_A5_20</c:v>
                </c:pt>
              </c:strCache>
            </c:strRef>
          </c:tx>
          <c:marker>
            <c:symbol val="none"/>
          </c:marker>
          <c:cat>
            <c:numRef>
              <c:f>'tph-1(mg280)_A5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5_0.02_5%'!$T$105:$T$125</c:f>
              <c:numCache>
                <c:formatCode>General</c:formatCode>
                <c:ptCount val="21"/>
                <c:pt idx="1">
                  <c:v>0.10489510489510502</c:v>
                </c:pt>
                <c:pt idx="2">
                  <c:v>0.10489510489510502</c:v>
                </c:pt>
                <c:pt idx="3">
                  <c:v>0.125874125874126</c:v>
                </c:pt>
                <c:pt idx="4">
                  <c:v>8.3916083916083961E-2</c:v>
                </c:pt>
                <c:pt idx="5">
                  <c:v>0.111888111888112</c:v>
                </c:pt>
                <c:pt idx="6">
                  <c:v>6.2937062937062901E-2</c:v>
                </c:pt>
                <c:pt idx="7">
                  <c:v>5.5944055944055895E-2</c:v>
                </c:pt>
                <c:pt idx="8">
                  <c:v>2.797202797202801E-2</c:v>
                </c:pt>
                <c:pt idx="9">
                  <c:v>2.797202797202801E-2</c:v>
                </c:pt>
                <c:pt idx="10">
                  <c:v>0</c:v>
                </c:pt>
                <c:pt idx="11">
                  <c:v>1.3986013986014E-2</c:v>
                </c:pt>
                <c:pt idx="12">
                  <c:v>2.0979020979021008E-2</c:v>
                </c:pt>
                <c:pt idx="13">
                  <c:v>6.9930069930069921E-3</c:v>
                </c:pt>
                <c:pt idx="14">
                  <c:v>0</c:v>
                </c:pt>
                <c:pt idx="15">
                  <c:v>0</c:v>
                </c:pt>
                <c:pt idx="16">
                  <c:v>6.9930069930069921E-3</c:v>
                </c:pt>
                <c:pt idx="17">
                  <c:v>1.3986013986014E-2</c:v>
                </c:pt>
                <c:pt idx="18">
                  <c:v>0</c:v>
                </c:pt>
                <c:pt idx="19">
                  <c:v>6.9930069930069921E-3</c:v>
                </c:pt>
                <c:pt idx="20">
                  <c:v>6.9930069930069921E-3</c:v>
                </c:pt>
              </c:numCache>
            </c:numRef>
          </c:val>
        </c:ser>
        <c:marker val="1"/>
        <c:axId val="161343744"/>
        <c:axId val="161386496"/>
      </c:lineChart>
      <c:catAx>
        <c:axId val="161343744"/>
        <c:scaling>
          <c:orientation val="minMax"/>
        </c:scaling>
        <c:axPos val="b"/>
        <c:numFmt formatCode="0.0_ " sourceLinked="1"/>
        <c:tickLblPos val="nextTo"/>
        <c:crossAx val="161386496"/>
        <c:crosses val="autoZero"/>
        <c:auto val="1"/>
        <c:lblAlgn val="ctr"/>
        <c:lblOffset val="100"/>
        <c:tickLblSkip val="5"/>
        <c:tickMarkSkip val="5"/>
      </c:catAx>
      <c:valAx>
        <c:axId val="16138649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1343744"/>
        <c:crosses val="autoZero"/>
        <c:crossBetween val="between"/>
      </c:valAx>
    </c:plotArea>
    <c:plotVisOnly val="1"/>
  </c:chart>
  <c:externalData r:id="rId1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tph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tph-1(mg280)_A3_0.02_5%'!$B$104</c:f>
              <c:strCache>
                <c:ptCount val="1"/>
                <c:pt idx="0">
                  <c:v>tph-1(mg280)_A3_01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B$105:$B$125</c:f>
              <c:numCache>
                <c:formatCode>General</c:formatCode>
                <c:ptCount val="21"/>
                <c:pt idx="1">
                  <c:v>6.6964285714285698E-2</c:v>
                </c:pt>
                <c:pt idx="2">
                  <c:v>8.035714285714296E-2</c:v>
                </c:pt>
                <c:pt idx="3">
                  <c:v>0.11607142857142905</c:v>
                </c:pt>
                <c:pt idx="4">
                  <c:v>9.8214285714285698E-2</c:v>
                </c:pt>
                <c:pt idx="5">
                  <c:v>9.8214285714285698E-2</c:v>
                </c:pt>
                <c:pt idx="6">
                  <c:v>5.8035714285714302E-2</c:v>
                </c:pt>
                <c:pt idx="7">
                  <c:v>6.25E-2</c:v>
                </c:pt>
                <c:pt idx="8">
                  <c:v>4.4642857142857095E-2</c:v>
                </c:pt>
                <c:pt idx="9">
                  <c:v>3.3482142857142898E-2</c:v>
                </c:pt>
                <c:pt idx="10">
                  <c:v>3.5714285714285698E-2</c:v>
                </c:pt>
                <c:pt idx="11">
                  <c:v>2.4553571428571407E-2</c:v>
                </c:pt>
                <c:pt idx="12">
                  <c:v>3.125E-2</c:v>
                </c:pt>
                <c:pt idx="13">
                  <c:v>1.5625E-2</c:v>
                </c:pt>
                <c:pt idx="14">
                  <c:v>8.9285714285714229E-3</c:v>
                </c:pt>
                <c:pt idx="15">
                  <c:v>2.2321428571428601E-3</c:v>
                </c:pt>
                <c:pt idx="16">
                  <c:v>2.4553571428571407E-2</c:v>
                </c:pt>
                <c:pt idx="17">
                  <c:v>1.3392857142857107E-2</c:v>
                </c:pt>
                <c:pt idx="18">
                  <c:v>1.1160714285714305E-2</c:v>
                </c:pt>
                <c:pt idx="19">
                  <c:v>2.23214285714286E-2</c:v>
                </c:pt>
                <c:pt idx="20">
                  <c:v>1.5625E-2</c:v>
                </c:pt>
              </c:numCache>
            </c:numRef>
          </c:val>
        </c:ser>
        <c:ser>
          <c:idx val="1"/>
          <c:order val="1"/>
          <c:tx>
            <c:strRef>
              <c:f>'tph-1(mg280)_A3_0.02_5%'!$C$104</c:f>
              <c:strCache>
                <c:ptCount val="1"/>
                <c:pt idx="0">
                  <c:v>tph-1(mg280)_A3_02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C$105:$C$125</c:f>
              <c:numCache>
                <c:formatCode>General</c:formatCode>
                <c:ptCount val="21"/>
                <c:pt idx="1">
                  <c:v>9.7500000000000031E-2</c:v>
                </c:pt>
                <c:pt idx="2">
                  <c:v>0.14000000000000001</c:v>
                </c:pt>
                <c:pt idx="3">
                  <c:v>8.2500000000000004E-2</c:v>
                </c:pt>
                <c:pt idx="4">
                  <c:v>0.12000000000000002</c:v>
                </c:pt>
                <c:pt idx="5">
                  <c:v>7.7500000000000013E-2</c:v>
                </c:pt>
                <c:pt idx="6">
                  <c:v>0.10750000000000003</c:v>
                </c:pt>
                <c:pt idx="7">
                  <c:v>6.5000000000000002E-2</c:v>
                </c:pt>
                <c:pt idx="8">
                  <c:v>3.0000000000000002E-2</c:v>
                </c:pt>
                <c:pt idx="9">
                  <c:v>4.0000000000000015E-2</c:v>
                </c:pt>
                <c:pt idx="10">
                  <c:v>2.5000000000000001E-2</c:v>
                </c:pt>
                <c:pt idx="11">
                  <c:v>2.0000000000000007E-2</c:v>
                </c:pt>
                <c:pt idx="12">
                  <c:v>2.0000000000000007E-2</c:v>
                </c:pt>
                <c:pt idx="13">
                  <c:v>1.0000000000000004E-2</c:v>
                </c:pt>
                <c:pt idx="14">
                  <c:v>1.0000000000000004E-2</c:v>
                </c:pt>
                <c:pt idx="15">
                  <c:v>1.2500000000000001E-2</c:v>
                </c:pt>
                <c:pt idx="16">
                  <c:v>7.5000000000000032E-3</c:v>
                </c:pt>
                <c:pt idx="17">
                  <c:v>7.5000000000000032E-3</c:v>
                </c:pt>
                <c:pt idx="18">
                  <c:v>0</c:v>
                </c:pt>
                <c:pt idx="19">
                  <c:v>2.5000000000000009E-3</c:v>
                </c:pt>
                <c:pt idx="20">
                  <c:v>7.5000000000000032E-3</c:v>
                </c:pt>
              </c:numCache>
            </c:numRef>
          </c:val>
        </c:ser>
        <c:ser>
          <c:idx val="2"/>
          <c:order val="2"/>
          <c:tx>
            <c:strRef>
              <c:f>'tph-1(mg280)_A3_0.02_5%'!$D$104</c:f>
              <c:strCache>
                <c:ptCount val="1"/>
                <c:pt idx="0">
                  <c:v>tph-1(mg280)_A3_03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D$105:$D$125</c:f>
              <c:numCache>
                <c:formatCode>General</c:formatCode>
                <c:ptCount val="21"/>
                <c:pt idx="1">
                  <c:v>8.9709762532981532E-2</c:v>
                </c:pt>
                <c:pt idx="2">
                  <c:v>6.332453825857523E-2</c:v>
                </c:pt>
                <c:pt idx="3">
                  <c:v>8.7071240105540904E-2</c:v>
                </c:pt>
                <c:pt idx="4">
                  <c:v>8.9709762532981532E-2</c:v>
                </c:pt>
                <c:pt idx="5">
                  <c:v>6.0686015831134629E-2</c:v>
                </c:pt>
                <c:pt idx="6">
                  <c:v>4.2216358839050103E-2</c:v>
                </c:pt>
                <c:pt idx="7">
                  <c:v>2.6385224274406299E-2</c:v>
                </c:pt>
                <c:pt idx="8">
                  <c:v>4.2216358839050103E-2</c:v>
                </c:pt>
                <c:pt idx="9">
                  <c:v>3.1662269129287601E-2</c:v>
                </c:pt>
                <c:pt idx="10">
                  <c:v>2.3746701846965694E-2</c:v>
                </c:pt>
                <c:pt idx="11">
                  <c:v>2.1108179419525117E-2</c:v>
                </c:pt>
                <c:pt idx="12">
                  <c:v>2.6385224274406299E-2</c:v>
                </c:pt>
                <c:pt idx="13">
                  <c:v>2.6385224274406299E-2</c:v>
                </c:pt>
                <c:pt idx="14">
                  <c:v>2.6385224274406299E-2</c:v>
                </c:pt>
                <c:pt idx="15">
                  <c:v>7.9155672823219038E-3</c:v>
                </c:pt>
                <c:pt idx="16">
                  <c:v>1.3192612137203198E-2</c:v>
                </c:pt>
                <c:pt idx="17">
                  <c:v>1.0554089709762505E-2</c:v>
                </c:pt>
                <c:pt idx="18">
                  <c:v>2.6385224274406299E-2</c:v>
                </c:pt>
                <c:pt idx="19">
                  <c:v>1.8469656992084402E-2</c:v>
                </c:pt>
                <c:pt idx="20">
                  <c:v>2.9023746701847E-2</c:v>
                </c:pt>
              </c:numCache>
            </c:numRef>
          </c:val>
        </c:ser>
        <c:ser>
          <c:idx val="3"/>
          <c:order val="3"/>
          <c:tx>
            <c:strRef>
              <c:f>'tph-1(mg280)_A3_0.02_5%'!$E$104</c:f>
              <c:strCache>
                <c:ptCount val="1"/>
                <c:pt idx="0">
                  <c:v>tph-1(mg280)_A3_04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E$105:$E$125</c:f>
              <c:numCache>
                <c:formatCode>General</c:formatCode>
                <c:ptCount val="21"/>
                <c:pt idx="1">
                  <c:v>8.4016393442622975E-2</c:v>
                </c:pt>
                <c:pt idx="2">
                  <c:v>0.10860655737704904</c:v>
                </c:pt>
                <c:pt idx="3">
                  <c:v>8.4016393442622975E-2</c:v>
                </c:pt>
                <c:pt idx="4">
                  <c:v>0.112704918032787</c:v>
                </c:pt>
                <c:pt idx="5">
                  <c:v>8.8114754098360698E-2</c:v>
                </c:pt>
                <c:pt idx="6">
                  <c:v>7.5819672131147528E-2</c:v>
                </c:pt>
                <c:pt idx="7">
                  <c:v>5.5327868852459001E-2</c:v>
                </c:pt>
                <c:pt idx="8">
                  <c:v>6.1475409836065614E-2</c:v>
                </c:pt>
                <c:pt idx="9">
                  <c:v>4.3032786885245929E-2</c:v>
                </c:pt>
                <c:pt idx="10">
                  <c:v>2.6639344262295118E-2</c:v>
                </c:pt>
                <c:pt idx="11">
                  <c:v>3.8934426229508198E-2</c:v>
                </c:pt>
                <c:pt idx="12">
                  <c:v>2.0491803278688499E-2</c:v>
                </c:pt>
                <c:pt idx="13">
                  <c:v>2.6639344262295118E-2</c:v>
                </c:pt>
                <c:pt idx="14">
                  <c:v>2.4590163934426198E-2</c:v>
                </c:pt>
                <c:pt idx="15">
                  <c:v>1.63934426229508E-2</c:v>
                </c:pt>
                <c:pt idx="16">
                  <c:v>8.1967213114754103E-3</c:v>
                </c:pt>
                <c:pt idx="17">
                  <c:v>1.63934426229508E-2</c:v>
                </c:pt>
                <c:pt idx="18">
                  <c:v>4.0983606557377103E-3</c:v>
                </c:pt>
                <c:pt idx="19">
                  <c:v>6.1475409836065599E-3</c:v>
                </c:pt>
                <c:pt idx="20">
                  <c:v>4.0983606557377103E-3</c:v>
                </c:pt>
              </c:numCache>
            </c:numRef>
          </c:val>
        </c:ser>
        <c:ser>
          <c:idx val="4"/>
          <c:order val="4"/>
          <c:tx>
            <c:strRef>
              <c:f>'tph-1(mg280)_A3_0.02_5%'!$F$104</c:f>
              <c:strCache>
                <c:ptCount val="1"/>
                <c:pt idx="0">
                  <c:v>tph-1(mg280)_A3_05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F$105:$F$125</c:f>
              <c:numCache>
                <c:formatCode>General</c:formatCode>
                <c:ptCount val="21"/>
                <c:pt idx="1">
                  <c:v>9.6989966555184007E-2</c:v>
                </c:pt>
                <c:pt idx="2">
                  <c:v>0.12374581939799301</c:v>
                </c:pt>
                <c:pt idx="3">
                  <c:v>0.11036789297658903</c:v>
                </c:pt>
                <c:pt idx="4">
                  <c:v>8.0267558528428096E-2</c:v>
                </c:pt>
                <c:pt idx="5">
                  <c:v>7.6923076923076913E-2</c:v>
                </c:pt>
                <c:pt idx="6">
                  <c:v>3.6789297658862921E-2</c:v>
                </c:pt>
                <c:pt idx="7">
                  <c:v>4.3478260869565202E-2</c:v>
                </c:pt>
                <c:pt idx="8">
                  <c:v>3.3444816053511697E-2</c:v>
                </c:pt>
                <c:pt idx="9">
                  <c:v>3.3444816053511697E-2</c:v>
                </c:pt>
                <c:pt idx="10">
                  <c:v>2.3411371237458199E-2</c:v>
                </c:pt>
                <c:pt idx="11">
                  <c:v>1.3377926421404698E-2</c:v>
                </c:pt>
                <c:pt idx="12">
                  <c:v>1.3377926421404698E-2</c:v>
                </c:pt>
                <c:pt idx="13">
                  <c:v>2.0066889632106989E-2</c:v>
                </c:pt>
                <c:pt idx="14">
                  <c:v>1.3377926421404698E-2</c:v>
                </c:pt>
                <c:pt idx="15">
                  <c:v>3.3444816053511709E-3</c:v>
                </c:pt>
                <c:pt idx="16">
                  <c:v>2.6755852842809402E-2</c:v>
                </c:pt>
                <c:pt idx="17">
                  <c:v>1.00334448160535E-2</c:v>
                </c:pt>
                <c:pt idx="18">
                  <c:v>6.6889632107023419E-3</c:v>
                </c:pt>
                <c:pt idx="19">
                  <c:v>3.3444816053511709E-3</c:v>
                </c:pt>
                <c:pt idx="20">
                  <c:v>3.3444816053511709E-3</c:v>
                </c:pt>
              </c:numCache>
            </c:numRef>
          </c:val>
        </c:ser>
        <c:ser>
          <c:idx val="5"/>
          <c:order val="5"/>
          <c:tx>
            <c:strRef>
              <c:f>'tph-1(mg280)_A3_0.02_5%'!$G$104</c:f>
              <c:strCache>
                <c:ptCount val="1"/>
                <c:pt idx="0">
                  <c:v>tph-1(mg280)_A3_06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G$105:$G$125</c:f>
              <c:numCache>
                <c:formatCode>General</c:formatCode>
                <c:ptCount val="21"/>
                <c:pt idx="1">
                  <c:v>5.8563535911602224E-2</c:v>
                </c:pt>
                <c:pt idx="2">
                  <c:v>7.18232044198895E-2</c:v>
                </c:pt>
                <c:pt idx="3">
                  <c:v>0.114917127071823</c:v>
                </c:pt>
                <c:pt idx="4">
                  <c:v>0.10386740331491701</c:v>
                </c:pt>
                <c:pt idx="5">
                  <c:v>0.10386740331491701</c:v>
                </c:pt>
                <c:pt idx="6">
                  <c:v>6.5193370165745904E-2</c:v>
                </c:pt>
                <c:pt idx="7">
                  <c:v>6.4088397790055193E-2</c:v>
                </c:pt>
                <c:pt idx="8">
                  <c:v>5.5248618784530384E-2</c:v>
                </c:pt>
                <c:pt idx="9">
                  <c:v>5.1933701657458621E-2</c:v>
                </c:pt>
                <c:pt idx="10">
                  <c:v>3.8674033149171311E-2</c:v>
                </c:pt>
                <c:pt idx="11">
                  <c:v>3.0939226519337008E-2</c:v>
                </c:pt>
                <c:pt idx="12">
                  <c:v>2.5414364640884E-2</c:v>
                </c:pt>
                <c:pt idx="13">
                  <c:v>2.2099447513812213E-2</c:v>
                </c:pt>
                <c:pt idx="14">
                  <c:v>1.8784530386740307E-2</c:v>
                </c:pt>
                <c:pt idx="15">
                  <c:v>1.9889502762430906E-2</c:v>
                </c:pt>
                <c:pt idx="16">
                  <c:v>1.7679558011049701E-2</c:v>
                </c:pt>
                <c:pt idx="17">
                  <c:v>1.215469613259669E-2</c:v>
                </c:pt>
                <c:pt idx="18">
                  <c:v>1.1049723756906101E-2</c:v>
                </c:pt>
                <c:pt idx="19">
                  <c:v>1.215469613259669E-2</c:v>
                </c:pt>
                <c:pt idx="20">
                  <c:v>7.7348066298342519E-3</c:v>
                </c:pt>
              </c:numCache>
            </c:numRef>
          </c:val>
        </c:ser>
        <c:ser>
          <c:idx val="6"/>
          <c:order val="6"/>
          <c:tx>
            <c:strRef>
              <c:f>'tph-1(mg280)_A3_0.02_5%'!$H$104</c:f>
              <c:strCache>
                <c:ptCount val="1"/>
                <c:pt idx="0">
                  <c:v>tph-1(mg280)_A3_07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H$105:$H$125</c:f>
              <c:numCache>
                <c:formatCode>General</c:formatCode>
                <c:ptCount val="21"/>
                <c:pt idx="1">
                  <c:v>7.3800738007380101E-2</c:v>
                </c:pt>
                <c:pt idx="2">
                  <c:v>6.2730627306273129E-2</c:v>
                </c:pt>
                <c:pt idx="3">
                  <c:v>7.3800738007380101E-2</c:v>
                </c:pt>
                <c:pt idx="4">
                  <c:v>8.1180811808118036E-2</c:v>
                </c:pt>
                <c:pt idx="5">
                  <c:v>4.428044280442802E-2</c:v>
                </c:pt>
                <c:pt idx="6">
                  <c:v>4.428044280442802E-2</c:v>
                </c:pt>
                <c:pt idx="7">
                  <c:v>3.3210332103321014E-2</c:v>
                </c:pt>
                <c:pt idx="8">
                  <c:v>4.0590405904059004E-2</c:v>
                </c:pt>
                <c:pt idx="9">
                  <c:v>1.8450184501845001E-2</c:v>
                </c:pt>
                <c:pt idx="10">
                  <c:v>2.5830258302582999E-2</c:v>
                </c:pt>
                <c:pt idx="11">
                  <c:v>3.6900369003690002E-2</c:v>
                </c:pt>
                <c:pt idx="12">
                  <c:v>1.8450184501845001E-2</c:v>
                </c:pt>
                <c:pt idx="13">
                  <c:v>1.4760147601476E-2</c:v>
                </c:pt>
                <c:pt idx="14">
                  <c:v>4.0590405904059004E-2</c:v>
                </c:pt>
                <c:pt idx="15">
                  <c:v>0</c:v>
                </c:pt>
                <c:pt idx="16">
                  <c:v>2.9520295202951997E-2</c:v>
                </c:pt>
                <c:pt idx="17">
                  <c:v>1.8450184501845001E-2</c:v>
                </c:pt>
                <c:pt idx="18">
                  <c:v>1.1070110701107005E-2</c:v>
                </c:pt>
                <c:pt idx="19">
                  <c:v>1.4760147601476E-2</c:v>
                </c:pt>
                <c:pt idx="20">
                  <c:v>2.214022140221401E-2</c:v>
                </c:pt>
              </c:numCache>
            </c:numRef>
          </c:val>
        </c:ser>
        <c:ser>
          <c:idx val="7"/>
          <c:order val="7"/>
          <c:tx>
            <c:strRef>
              <c:f>'tph-1(mg280)_A3_0.02_5%'!$I$104</c:f>
              <c:strCache>
                <c:ptCount val="1"/>
                <c:pt idx="0">
                  <c:v>tph-1(mg280)_A3_08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I$105:$I$125</c:f>
              <c:numCache>
                <c:formatCode>General</c:formatCode>
                <c:ptCount val="21"/>
                <c:pt idx="1">
                  <c:v>8.895705521472394E-2</c:v>
                </c:pt>
                <c:pt idx="2">
                  <c:v>9.8159509202454032E-2</c:v>
                </c:pt>
                <c:pt idx="3">
                  <c:v>7.9754601226993932E-2</c:v>
                </c:pt>
                <c:pt idx="4">
                  <c:v>7.3619631901840538E-2</c:v>
                </c:pt>
                <c:pt idx="5">
                  <c:v>5.5214723926380417E-2</c:v>
                </c:pt>
                <c:pt idx="6">
                  <c:v>3.680981595092022E-2</c:v>
                </c:pt>
                <c:pt idx="7">
                  <c:v>4.6012269938650319E-2</c:v>
                </c:pt>
                <c:pt idx="8">
                  <c:v>2.7607361963190209E-2</c:v>
                </c:pt>
                <c:pt idx="9">
                  <c:v>3.0674846625766916E-2</c:v>
                </c:pt>
                <c:pt idx="10">
                  <c:v>3.680981595092022E-2</c:v>
                </c:pt>
                <c:pt idx="11">
                  <c:v>2.4539877300613518E-2</c:v>
                </c:pt>
                <c:pt idx="12">
                  <c:v>1.5337423312883404E-2</c:v>
                </c:pt>
                <c:pt idx="13">
                  <c:v>1.2269938650306698E-2</c:v>
                </c:pt>
                <c:pt idx="14">
                  <c:v>1.5337423312883404E-2</c:v>
                </c:pt>
                <c:pt idx="15">
                  <c:v>2.1472392638036807E-2</c:v>
                </c:pt>
                <c:pt idx="16">
                  <c:v>2.1472392638036807E-2</c:v>
                </c:pt>
                <c:pt idx="17">
                  <c:v>1.5337423312883404E-2</c:v>
                </c:pt>
                <c:pt idx="18">
                  <c:v>1.2269938650306698E-2</c:v>
                </c:pt>
                <c:pt idx="19">
                  <c:v>2.1472392638036807E-2</c:v>
                </c:pt>
                <c:pt idx="20">
                  <c:v>3.0674846625766916E-2</c:v>
                </c:pt>
              </c:numCache>
            </c:numRef>
          </c:val>
        </c:ser>
        <c:ser>
          <c:idx val="8"/>
          <c:order val="8"/>
          <c:tx>
            <c:strRef>
              <c:f>'tph-1(mg280)_A3_0.02_5%'!$J$104</c:f>
              <c:strCache>
                <c:ptCount val="1"/>
                <c:pt idx="0">
                  <c:v>tph-1(mg280)_A3_09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J$105:$J$125</c:f>
              <c:numCache>
                <c:formatCode>General</c:formatCode>
                <c:ptCount val="21"/>
                <c:pt idx="1">
                  <c:v>9.3525179856115137E-2</c:v>
                </c:pt>
                <c:pt idx="2">
                  <c:v>8.9928057553956831E-2</c:v>
                </c:pt>
                <c:pt idx="3">
                  <c:v>7.5539568345323702E-2</c:v>
                </c:pt>
                <c:pt idx="4">
                  <c:v>7.5539568345323702E-2</c:v>
                </c:pt>
                <c:pt idx="5">
                  <c:v>5.7553956834532426E-2</c:v>
                </c:pt>
                <c:pt idx="6">
                  <c:v>7.1942446043165506E-2</c:v>
                </c:pt>
                <c:pt idx="7">
                  <c:v>3.2374100719424523E-2</c:v>
                </c:pt>
                <c:pt idx="8">
                  <c:v>4.6762589928057631E-2</c:v>
                </c:pt>
                <c:pt idx="9">
                  <c:v>4.3165467625899304E-2</c:v>
                </c:pt>
                <c:pt idx="10">
                  <c:v>3.2374100719424523E-2</c:v>
                </c:pt>
                <c:pt idx="11">
                  <c:v>2.5179856115107892E-2</c:v>
                </c:pt>
                <c:pt idx="12">
                  <c:v>2.5179856115107892E-2</c:v>
                </c:pt>
                <c:pt idx="13">
                  <c:v>1.7985611510791401E-2</c:v>
                </c:pt>
                <c:pt idx="14">
                  <c:v>1.7985611510791401E-2</c:v>
                </c:pt>
                <c:pt idx="15">
                  <c:v>7.1942446043165515E-3</c:v>
                </c:pt>
                <c:pt idx="16">
                  <c:v>7.1942446043165515E-3</c:v>
                </c:pt>
                <c:pt idx="17">
                  <c:v>7.1942446043165515E-3</c:v>
                </c:pt>
                <c:pt idx="18">
                  <c:v>2.1582733812949607E-2</c:v>
                </c:pt>
                <c:pt idx="19">
                  <c:v>1.4388489208633106E-2</c:v>
                </c:pt>
                <c:pt idx="20">
                  <c:v>1.0791366906474795E-2</c:v>
                </c:pt>
              </c:numCache>
            </c:numRef>
          </c:val>
        </c:ser>
        <c:ser>
          <c:idx val="9"/>
          <c:order val="9"/>
          <c:tx>
            <c:strRef>
              <c:f>'tph-1(mg280)_A3_0.02_5%'!$K$104</c:f>
              <c:strCache>
                <c:ptCount val="1"/>
                <c:pt idx="0">
                  <c:v>tph-1(mg280)_A3_10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K$105:$K$125</c:f>
              <c:numCache>
                <c:formatCode>General</c:formatCode>
                <c:ptCount val="21"/>
                <c:pt idx="1">
                  <c:v>0.10400000000000002</c:v>
                </c:pt>
                <c:pt idx="2">
                  <c:v>0.14400000000000004</c:v>
                </c:pt>
                <c:pt idx="3">
                  <c:v>9.6000000000000002E-2</c:v>
                </c:pt>
                <c:pt idx="4">
                  <c:v>8.0000000000000029E-2</c:v>
                </c:pt>
                <c:pt idx="5">
                  <c:v>8.8000000000000037E-2</c:v>
                </c:pt>
                <c:pt idx="6">
                  <c:v>4.8000000000000001E-2</c:v>
                </c:pt>
                <c:pt idx="7">
                  <c:v>2.4E-2</c:v>
                </c:pt>
                <c:pt idx="8">
                  <c:v>6.4000000000000029E-2</c:v>
                </c:pt>
                <c:pt idx="9">
                  <c:v>1.6000000000000007E-2</c:v>
                </c:pt>
                <c:pt idx="10">
                  <c:v>1.6000000000000007E-2</c:v>
                </c:pt>
                <c:pt idx="11">
                  <c:v>0</c:v>
                </c:pt>
                <c:pt idx="12">
                  <c:v>8.0000000000000054E-3</c:v>
                </c:pt>
                <c:pt idx="13">
                  <c:v>1.6000000000000007E-2</c:v>
                </c:pt>
                <c:pt idx="14">
                  <c:v>0</c:v>
                </c:pt>
                <c:pt idx="15">
                  <c:v>0</c:v>
                </c:pt>
                <c:pt idx="16">
                  <c:v>8.0000000000000054E-3</c:v>
                </c:pt>
                <c:pt idx="17">
                  <c:v>8.0000000000000054E-3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tph-1(mg280)_A3_0.02_5%'!$L$104</c:f>
              <c:strCache>
                <c:ptCount val="1"/>
                <c:pt idx="0">
                  <c:v>tph-1(mg280)_A3_11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L$105:$L$125</c:f>
              <c:numCache>
                <c:formatCode>General</c:formatCode>
                <c:ptCount val="21"/>
                <c:pt idx="1">
                  <c:v>0.14049586776859499</c:v>
                </c:pt>
                <c:pt idx="2">
                  <c:v>0.14049586776859499</c:v>
                </c:pt>
                <c:pt idx="3">
                  <c:v>6.6115702479338803E-2</c:v>
                </c:pt>
                <c:pt idx="4">
                  <c:v>6.6115702479338803E-2</c:v>
                </c:pt>
                <c:pt idx="5">
                  <c:v>5.7851239669421503E-2</c:v>
                </c:pt>
                <c:pt idx="6">
                  <c:v>8.2644628099173639E-2</c:v>
                </c:pt>
                <c:pt idx="7">
                  <c:v>4.132231404958682E-2</c:v>
                </c:pt>
                <c:pt idx="8">
                  <c:v>0</c:v>
                </c:pt>
                <c:pt idx="9">
                  <c:v>2.4793388429752112E-2</c:v>
                </c:pt>
                <c:pt idx="10">
                  <c:v>0</c:v>
                </c:pt>
                <c:pt idx="11">
                  <c:v>8.2644628099173643E-3</c:v>
                </c:pt>
                <c:pt idx="12">
                  <c:v>8.2644628099173643E-3</c:v>
                </c:pt>
                <c:pt idx="13">
                  <c:v>1.6528925619834708E-2</c:v>
                </c:pt>
                <c:pt idx="14">
                  <c:v>8.2644628099173643E-3</c:v>
                </c:pt>
                <c:pt idx="15">
                  <c:v>0</c:v>
                </c:pt>
                <c:pt idx="16">
                  <c:v>0</c:v>
                </c:pt>
                <c:pt idx="17">
                  <c:v>1.6528925619834708E-2</c:v>
                </c:pt>
                <c:pt idx="18">
                  <c:v>1.6528925619834708E-2</c:v>
                </c:pt>
                <c:pt idx="19">
                  <c:v>1.6528925619834708E-2</c:v>
                </c:pt>
                <c:pt idx="2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tph-1(mg280)_A3_0.02_5%'!$M$104</c:f>
              <c:strCache>
                <c:ptCount val="1"/>
                <c:pt idx="0">
                  <c:v>tph-1(mg280)_A3_12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M$105:$M$125</c:f>
              <c:numCache>
                <c:formatCode>General</c:formatCode>
                <c:ptCount val="21"/>
                <c:pt idx="1">
                  <c:v>9.0686274509803905E-2</c:v>
                </c:pt>
                <c:pt idx="2">
                  <c:v>9.0686274509803905E-2</c:v>
                </c:pt>
                <c:pt idx="3">
                  <c:v>0.13235294117647106</c:v>
                </c:pt>
                <c:pt idx="4">
                  <c:v>9.0686274509803905E-2</c:v>
                </c:pt>
                <c:pt idx="5">
                  <c:v>7.8431372549019607E-2</c:v>
                </c:pt>
                <c:pt idx="6">
                  <c:v>5.1470588235294081E-2</c:v>
                </c:pt>
                <c:pt idx="7">
                  <c:v>5.6372549019607802E-2</c:v>
                </c:pt>
                <c:pt idx="8">
                  <c:v>4.1666666666666699E-2</c:v>
                </c:pt>
                <c:pt idx="9">
                  <c:v>7.3529411764705899E-3</c:v>
                </c:pt>
                <c:pt idx="10">
                  <c:v>3.4313725490196102E-2</c:v>
                </c:pt>
                <c:pt idx="11">
                  <c:v>3.6764705882352901E-2</c:v>
                </c:pt>
                <c:pt idx="12">
                  <c:v>2.4509803921568599E-2</c:v>
                </c:pt>
                <c:pt idx="13">
                  <c:v>1.9607843137254902E-2</c:v>
                </c:pt>
                <c:pt idx="14">
                  <c:v>1.2254901960784298E-2</c:v>
                </c:pt>
                <c:pt idx="15">
                  <c:v>1.7156862745097999E-2</c:v>
                </c:pt>
                <c:pt idx="16">
                  <c:v>9.8039215686274508E-3</c:v>
                </c:pt>
                <c:pt idx="17">
                  <c:v>9.8039215686274508E-3</c:v>
                </c:pt>
                <c:pt idx="18">
                  <c:v>9.8039215686274508E-3</c:v>
                </c:pt>
                <c:pt idx="19">
                  <c:v>7.3529411764705899E-3</c:v>
                </c:pt>
                <c:pt idx="20">
                  <c:v>1.2254901960784298E-2</c:v>
                </c:pt>
              </c:numCache>
            </c:numRef>
          </c:val>
        </c:ser>
        <c:ser>
          <c:idx val="12"/>
          <c:order val="12"/>
          <c:tx>
            <c:strRef>
              <c:f>'tph-1(mg280)_A3_0.02_5%'!$N$104</c:f>
              <c:strCache>
                <c:ptCount val="1"/>
                <c:pt idx="0">
                  <c:v>tph-1(mg280)_A3_13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N$105:$N$125</c:f>
              <c:numCache>
                <c:formatCode>General</c:formatCode>
                <c:ptCount val="21"/>
                <c:pt idx="1">
                  <c:v>7.0996978851963821E-2</c:v>
                </c:pt>
                <c:pt idx="2">
                  <c:v>9.3655589123867178E-2</c:v>
                </c:pt>
                <c:pt idx="3">
                  <c:v>9.8187311178247708E-2</c:v>
                </c:pt>
                <c:pt idx="4">
                  <c:v>9.9697885196374667E-2</c:v>
                </c:pt>
                <c:pt idx="5">
                  <c:v>0.11480362537764402</c:v>
                </c:pt>
                <c:pt idx="6">
                  <c:v>8.0060422960725144E-2</c:v>
                </c:pt>
                <c:pt idx="7">
                  <c:v>4.9848942598187285E-2</c:v>
                </c:pt>
                <c:pt idx="8">
                  <c:v>4.8338368580060381E-2</c:v>
                </c:pt>
                <c:pt idx="9">
                  <c:v>3.6253776435045314E-2</c:v>
                </c:pt>
                <c:pt idx="10">
                  <c:v>4.0785498489426017E-2</c:v>
                </c:pt>
                <c:pt idx="11">
                  <c:v>2.7190332326284008E-2</c:v>
                </c:pt>
                <c:pt idx="12">
                  <c:v>3.1722054380664701E-2</c:v>
                </c:pt>
                <c:pt idx="13">
                  <c:v>2.5679758308157108E-2</c:v>
                </c:pt>
                <c:pt idx="14">
                  <c:v>1.0574018126888199E-2</c:v>
                </c:pt>
                <c:pt idx="15">
                  <c:v>1.6616314199395802E-2</c:v>
                </c:pt>
                <c:pt idx="16">
                  <c:v>1.3595166163142E-2</c:v>
                </c:pt>
                <c:pt idx="17">
                  <c:v>1.6616314199395802E-2</c:v>
                </c:pt>
                <c:pt idx="18">
                  <c:v>1.3595166163142E-2</c:v>
                </c:pt>
                <c:pt idx="19">
                  <c:v>7.5528700906344432E-3</c:v>
                </c:pt>
                <c:pt idx="20">
                  <c:v>7.5528700906344432E-3</c:v>
                </c:pt>
              </c:numCache>
            </c:numRef>
          </c:val>
        </c:ser>
        <c:ser>
          <c:idx val="13"/>
          <c:order val="13"/>
          <c:tx>
            <c:strRef>
              <c:f>'tph-1(mg280)_A3_0.02_5%'!$O$104</c:f>
              <c:strCache>
                <c:ptCount val="1"/>
                <c:pt idx="0">
                  <c:v>tph-1(mg280)_A3_14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O$105:$O$125</c:f>
              <c:numCache>
                <c:formatCode>General</c:formatCode>
                <c:ptCount val="21"/>
                <c:pt idx="1">
                  <c:v>8.8019559902200506E-2</c:v>
                </c:pt>
                <c:pt idx="2">
                  <c:v>0.11735941320293397</c:v>
                </c:pt>
                <c:pt idx="3">
                  <c:v>0.141809290953545</c:v>
                </c:pt>
                <c:pt idx="4">
                  <c:v>0.11858190709046497</c:v>
                </c:pt>
                <c:pt idx="5">
                  <c:v>0.116136919315403</c:v>
                </c:pt>
                <c:pt idx="6">
                  <c:v>5.7457212713936417E-2</c:v>
                </c:pt>
                <c:pt idx="7">
                  <c:v>5.5012224938875344E-2</c:v>
                </c:pt>
                <c:pt idx="8">
                  <c:v>4.5232273838630828E-2</c:v>
                </c:pt>
                <c:pt idx="9">
                  <c:v>2.4449877750611217E-2</c:v>
                </c:pt>
                <c:pt idx="10">
                  <c:v>3.1784841075794615E-2</c:v>
                </c:pt>
                <c:pt idx="11">
                  <c:v>1.5892420537897307E-2</c:v>
                </c:pt>
                <c:pt idx="12">
                  <c:v>1.8337408312958409E-2</c:v>
                </c:pt>
                <c:pt idx="13">
                  <c:v>2.4449877750611217E-2</c:v>
                </c:pt>
                <c:pt idx="14">
                  <c:v>1.1002444987775101E-2</c:v>
                </c:pt>
                <c:pt idx="15">
                  <c:v>1.2224938875305598E-2</c:v>
                </c:pt>
                <c:pt idx="16">
                  <c:v>1.46699266503667E-2</c:v>
                </c:pt>
                <c:pt idx="17">
                  <c:v>3.6674816625916927E-3</c:v>
                </c:pt>
                <c:pt idx="18">
                  <c:v>9.7799511002444987E-3</c:v>
                </c:pt>
                <c:pt idx="19">
                  <c:v>1.2224938875305598E-2</c:v>
                </c:pt>
                <c:pt idx="20">
                  <c:v>2.4449877750611216E-3</c:v>
                </c:pt>
              </c:numCache>
            </c:numRef>
          </c:val>
        </c:ser>
        <c:ser>
          <c:idx val="14"/>
          <c:order val="14"/>
          <c:tx>
            <c:strRef>
              <c:f>'tph-1(mg280)_A3_0.02_5%'!$P$104</c:f>
              <c:strCache>
                <c:ptCount val="1"/>
                <c:pt idx="0">
                  <c:v>tph-1(mg280)_A3_15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P$105:$P$125</c:f>
              <c:numCache>
                <c:formatCode>General</c:formatCode>
                <c:ptCount val="21"/>
                <c:pt idx="1">
                  <c:v>7.0496083550913843E-2</c:v>
                </c:pt>
                <c:pt idx="2">
                  <c:v>8.6161879895561427E-2</c:v>
                </c:pt>
                <c:pt idx="3">
                  <c:v>0.10182767624020905</c:v>
                </c:pt>
                <c:pt idx="4">
                  <c:v>9.9216710182767606E-2</c:v>
                </c:pt>
                <c:pt idx="5">
                  <c:v>8.6161879895561427E-2</c:v>
                </c:pt>
                <c:pt idx="6">
                  <c:v>6.7885117493472619E-2</c:v>
                </c:pt>
                <c:pt idx="7">
                  <c:v>5.2219321148825118E-2</c:v>
                </c:pt>
                <c:pt idx="8">
                  <c:v>2.8720626631853791E-2</c:v>
                </c:pt>
                <c:pt idx="9">
                  <c:v>4.1775456919060087E-2</c:v>
                </c:pt>
                <c:pt idx="10">
                  <c:v>2.3498694516971307E-2</c:v>
                </c:pt>
                <c:pt idx="11">
                  <c:v>2.6109660574412514E-2</c:v>
                </c:pt>
                <c:pt idx="12">
                  <c:v>1.3054830287206304E-2</c:v>
                </c:pt>
                <c:pt idx="13">
                  <c:v>1.8276762402088802E-2</c:v>
                </c:pt>
                <c:pt idx="14">
                  <c:v>1.3054830287206304E-2</c:v>
                </c:pt>
                <c:pt idx="15">
                  <c:v>1.0443864229765006E-2</c:v>
                </c:pt>
                <c:pt idx="16">
                  <c:v>1.0443864229765006E-2</c:v>
                </c:pt>
                <c:pt idx="17">
                  <c:v>1.3054830287206304E-2</c:v>
                </c:pt>
                <c:pt idx="18">
                  <c:v>1.3054830287206304E-2</c:v>
                </c:pt>
                <c:pt idx="19">
                  <c:v>5.2219321148825118E-3</c:v>
                </c:pt>
                <c:pt idx="20">
                  <c:v>7.8328981723237642E-3</c:v>
                </c:pt>
              </c:numCache>
            </c:numRef>
          </c:val>
        </c:ser>
        <c:ser>
          <c:idx val="15"/>
          <c:order val="15"/>
          <c:tx>
            <c:strRef>
              <c:f>'tph-1(mg280)_A3_0.02_5%'!$Q$104</c:f>
              <c:strCache>
                <c:ptCount val="1"/>
                <c:pt idx="0">
                  <c:v>tph-1(mg280)_A3_16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Q$105:$Q$125</c:f>
              <c:numCache>
                <c:formatCode>General</c:formatCode>
                <c:ptCount val="21"/>
                <c:pt idx="1">
                  <c:v>7.6923076923076913E-2</c:v>
                </c:pt>
                <c:pt idx="2">
                  <c:v>0.10931174089068803</c:v>
                </c:pt>
                <c:pt idx="3">
                  <c:v>0.135627530364372</c:v>
                </c:pt>
                <c:pt idx="4">
                  <c:v>0.13967611336032401</c:v>
                </c:pt>
                <c:pt idx="5">
                  <c:v>7.6923076923076913E-2</c:v>
                </c:pt>
                <c:pt idx="6">
                  <c:v>5.8704453441295504E-2</c:v>
                </c:pt>
                <c:pt idx="7">
                  <c:v>6.0728744939271335E-2</c:v>
                </c:pt>
                <c:pt idx="8">
                  <c:v>5.8704453441295504E-2</c:v>
                </c:pt>
                <c:pt idx="9">
                  <c:v>1.6194331983805699E-2</c:v>
                </c:pt>
                <c:pt idx="10">
                  <c:v>1.8218623481781399E-2</c:v>
                </c:pt>
                <c:pt idx="11">
                  <c:v>3.6437246963562812E-2</c:v>
                </c:pt>
                <c:pt idx="12">
                  <c:v>1.417004048583E-2</c:v>
                </c:pt>
                <c:pt idx="13">
                  <c:v>1.8218623481781399E-2</c:v>
                </c:pt>
                <c:pt idx="14">
                  <c:v>8.0971659919028306E-3</c:v>
                </c:pt>
                <c:pt idx="15">
                  <c:v>2.0242914979757111E-3</c:v>
                </c:pt>
                <c:pt idx="16">
                  <c:v>6.0728744939271334E-3</c:v>
                </c:pt>
                <c:pt idx="17">
                  <c:v>1.0121457489878501E-2</c:v>
                </c:pt>
                <c:pt idx="18">
                  <c:v>2.0242914979757111E-3</c:v>
                </c:pt>
                <c:pt idx="19">
                  <c:v>2.0242914979757111E-3</c:v>
                </c:pt>
                <c:pt idx="2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tph-1(mg280)_A3_0.02_5%'!$R$104</c:f>
              <c:strCache>
                <c:ptCount val="1"/>
                <c:pt idx="0">
                  <c:v>tph-1(mg280)_A3_17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R$105:$R$125</c:f>
              <c:numCache>
                <c:formatCode>General</c:formatCode>
                <c:ptCount val="21"/>
                <c:pt idx="1">
                  <c:v>5.518763796909492E-2</c:v>
                </c:pt>
                <c:pt idx="2">
                  <c:v>5.9602649006622516E-2</c:v>
                </c:pt>
                <c:pt idx="3">
                  <c:v>8.2781456953642432E-2</c:v>
                </c:pt>
                <c:pt idx="4">
                  <c:v>0.11479028697571705</c:v>
                </c:pt>
                <c:pt idx="5">
                  <c:v>0.12141280353200902</c:v>
                </c:pt>
                <c:pt idx="6">
                  <c:v>5.7395143487858701E-2</c:v>
                </c:pt>
                <c:pt idx="7">
                  <c:v>4.3046357615893996E-2</c:v>
                </c:pt>
                <c:pt idx="8">
                  <c:v>4.194260485651212E-2</c:v>
                </c:pt>
                <c:pt idx="9">
                  <c:v>7.0640176600441501E-2</c:v>
                </c:pt>
                <c:pt idx="10">
                  <c:v>4.6357615894039722E-2</c:v>
                </c:pt>
                <c:pt idx="11">
                  <c:v>3.0905077262693217E-2</c:v>
                </c:pt>
                <c:pt idx="12">
                  <c:v>3.3112582781456998E-2</c:v>
                </c:pt>
                <c:pt idx="13">
                  <c:v>2.5386313465783718E-2</c:v>
                </c:pt>
                <c:pt idx="14">
                  <c:v>2.8697571743929402E-2</c:v>
                </c:pt>
                <c:pt idx="15">
                  <c:v>1.87637969094923E-2</c:v>
                </c:pt>
                <c:pt idx="16">
                  <c:v>1.87637969094923E-2</c:v>
                </c:pt>
                <c:pt idx="17">
                  <c:v>1.6556291390728502E-2</c:v>
                </c:pt>
                <c:pt idx="18">
                  <c:v>1.76600441501104E-2</c:v>
                </c:pt>
                <c:pt idx="19">
                  <c:v>8.8300220750551894E-3</c:v>
                </c:pt>
                <c:pt idx="20">
                  <c:v>8.8300220750551894E-3</c:v>
                </c:pt>
              </c:numCache>
            </c:numRef>
          </c:val>
        </c:ser>
        <c:ser>
          <c:idx val="17"/>
          <c:order val="17"/>
          <c:tx>
            <c:strRef>
              <c:f>'tph-1(mg280)_A3_0.02_5%'!$S$104</c:f>
              <c:strCache>
                <c:ptCount val="1"/>
                <c:pt idx="0">
                  <c:v>tph-1(mg280)_A3_18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S$105:$S$125</c:f>
              <c:numCache>
                <c:formatCode>General</c:formatCode>
                <c:ptCount val="21"/>
                <c:pt idx="1">
                  <c:v>9.2592592592592671E-2</c:v>
                </c:pt>
                <c:pt idx="2">
                  <c:v>8.8888888888888934E-2</c:v>
                </c:pt>
                <c:pt idx="3">
                  <c:v>9.6296296296296338E-2</c:v>
                </c:pt>
                <c:pt idx="4">
                  <c:v>8.8888888888888934E-2</c:v>
                </c:pt>
                <c:pt idx="5">
                  <c:v>4.8148148148148086E-2</c:v>
                </c:pt>
                <c:pt idx="6">
                  <c:v>6.6666666666666693E-2</c:v>
                </c:pt>
                <c:pt idx="7">
                  <c:v>5.1851851851851899E-2</c:v>
                </c:pt>
                <c:pt idx="8">
                  <c:v>2.962962962962961E-2</c:v>
                </c:pt>
                <c:pt idx="9">
                  <c:v>1.1111111111111101E-2</c:v>
                </c:pt>
                <c:pt idx="10">
                  <c:v>2.2222222222222202E-2</c:v>
                </c:pt>
                <c:pt idx="11">
                  <c:v>7.4074074074074103E-3</c:v>
                </c:pt>
                <c:pt idx="12">
                  <c:v>2.962962962962961E-2</c:v>
                </c:pt>
                <c:pt idx="13">
                  <c:v>1.8518518518518507E-2</c:v>
                </c:pt>
                <c:pt idx="14">
                  <c:v>1.1111111111111101E-2</c:v>
                </c:pt>
                <c:pt idx="15">
                  <c:v>1.1111111111111101E-2</c:v>
                </c:pt>
                <c:pt idx="16">
                  <c:v>1.48148148148148E-2</c:v>
                </c:pt>
                <c:pt idx="17">
                  <c:v>1.1111111111111101E-2</c:v>
                </c:pt>
                <c:pt idx="18">
                  <c:v>3.7037037037037017E-3</c:v>
                </c:pt>
                <c:pt idx="19">
                  <c:v>7.4074074074074103E-3</c:v>
                </c:pt>
                <c:pt idx="20">
                  <c:v>1.48148148148148E-2</c:v>
                </c:pt>
              </c:numCache>
            </c:numRef>
          </c:val>
        </c:ser>
        <c:ser>
          <c:idx val="18"/>
          <c:order val="18"/>
          <c:tx>
            <c:strRef>
              <c:f>'tph-1(mg280)_A3_0.02_5%'!$T$104</c:f>
              <c:strCache>
                <c:ptCount val="1"/>
                <c:pt idx="0">
                  <c:v>tph-1(mg280)_A3_19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T$105:$T$125</c:f>
              <c:numCache>
                <c:formatCode>General</c:formatCode>
                <c:ptCount val="21"/>
                <c:pt idx="1">
                  <c:v>7.8048780487804906E-2</c:v>
                </c:pt>
                <c:pt idx="2">
                  <c:v>8.292682926829277E-2</c:v>
                </c:pt>
                <c:pt idx="3">
                  <c:v>0.11869918699187003</c:v>
                </c:pt>
                <c:pt idx="4">
                  <c:v>9.7560975609756156E-2</c:v>
                </c:pt>
                <c:pt idx="5">
                  <c:v>9.5934959349593549E-2</c:v>
                </c:pt>
                <c:pt idx="6">
                  <c:v>6.0162601626016353E-2</c:v>
                </c:pt>
                <c:pt idx="7">
                  <c:v>4.7154471544715519E-2</c:v>
                </c:pt>
                <c:pt idx="8">
                  <c:v>4.552845528455278E-2</c:v>
                </c:pt>
                <c:pt idx="9">
                  <c:v>4.552845528455278E-2</c:v>
                </c:pt>
                <c:pt idx="10">
                  <c:v>3.4146341463414616E-2</c:v>
                </c:pt>
                <c:pt idx="11">
                  <c:v>3.0894308943089407E-2</c:v>
                </c:pt>
                <c:pt idx="12">
                  <c:v>3.5772357723577217E-2</c:v>
                </c:pt>
                <c:pt idx="13">
                  <c:v>2.4390243902439001E-2</c:v>
                </c:pt>
                <c:pt idx="14">
                  <c:v>1.46341463414634E-2</c:v>
                </c:pt>
                <c:pt idx="15">
                  <c:v>2.4390243902439001E-2</c:v>
                </c:pt>
                <c:pt idx="16">
                  <c:v>1.3008130081300801E-2</c:v>
                </c:pt>
                <c:pt idx="17">
                  <c:v>2.113821138211381E-2</c:v>
                </c:pt>
                <c:pt idx="18">
                  <c:v>8.1300813008130107E-3</c:v>
                </c:pt>
                <c:pt idx="19">
                  <c:v>9.756097560975615E-3</c:v>
                </c:pt>
                <c:pt idx="20">
                  <c:v>1.7886178861788608E-2</c:v>
                </c:pt>
              </c:numCache>
            </c:numRef>
          </c:val>
        </c:ser>
        <c:ser>
          <c:idx val="19"/>
          <c:order val="19"/>
          <c:tx>
            <c:strRef>
              <c:f>'tph-1(mg280)_A3_0.02_5%'!$U$104</c:f>
              <c:strCache>
                <c:ptCount val="1"/>
                <c:pt idx="0">
                  <c:v>tph-1(mg280)_A3_20</c:v>
                </c:pt>
              </c:strCache>
            </c:strRef>
          </c:tx>
          <c:marker>
            <c:symbol val="none"/>
          </c:marker>
          <c:cat>
            <c:numRef>
              <c:f>'tph-1(mg280)_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3_0.02_5%'!$U$105:$U$125</c:f>
              <c:numCache>
                <c:formatCode>General</c:formatCode>
                <c:ptCount val="21"/>
                <c:pt idx="1">
                  <c:v>6.7985166872682301E-2</c:v>
                </c:pt>
                <c:pt idx="2">
                  <c:v>9.6415327564894945E-2</c:v>
                </c:pt>
                <c:pt idx="3">
                  <c:v>0.10630407911001202</c:v>
                </c:pt>
                <c:pt idx="4">
                  <c:v>0.12484548825710802</c:v>
                </c:pt>
                <c:pt idx="5">
                  <c:v>0.103831891223733</c:v>
                </c:pt>
                <c:pt idx="6">
                  <c:v>6.6749072929542602E-2</c:v>
                </c:pt>
                <c:pt idx="7">
                  <c:v>4.6971569839307795E-2</c:v>
                </c:pt>
                <c:pt idx="8">
                  <c:v>5.56242274412855E-2</c:v>
                </c:pt>
                <c:pt idx="9">
                  <c:v>4.5735475896168103E-2</c:v>
                </c:pt>
                <c:pt idx="10">
                  <c:v>4.2027194066749103E-2</c:v>
                </c:pt>
                <c:pt idx="11">
                  <c:v>2.4721878862793607E-2</c:v>
                </c:pt>
                <c:pt idx="12">
                  <c:v>1.8541409147095213E-2</c:v>
                </c:pt>
                <c:pt idx="13">
                  <c:v>2.8430160692212606E-2</c:v>
                </c:pt>
                <c:pt idx="14">
                  <c:v>2.3485784919653908E-2</c:v>
                </c:pt>
                <c:pt idx="15">
                  <c:v>2.2249690976514216E-2</c:v>
                </c:pt>
                <c:pt idx="16">
                  <c:v>1.6069221260815808E-2</c:v>
                </c:pt>
                <c:pt idx="17">
                  <c:v>7.4165636588380737E-3</c:v>
                </c:pt>
                <c:pt idx="18">
                  <c:v>4.9443757725587114E-3</c:v>
                </c:pt>
                <c:pt idx="19">
                  <c:v>4.9443757725587114E-3</c:v>
                </c:pt>
                <c:pt idx="20">
                  <c:v>6.1804697156983938E-3</c:v>
                </c:pt>
              </c:numCache>
            </c:numRef>
          </c:val>
        </c:ser>
        <c:marker val="1"/>
        <c:axId val="161475584"/>
        <c:axId val="161522432"/>
      </c:lineChart>
      <c:catAx>
        <c:axId val="161475584"/>
        <c:scaling>
          <c:orientation val="minMax"/>
        </c:scaling>
        <c:axPos val="b"/>
        <c:numFmt formatCode="0.0_ " sourceLinked="1"/>
        <c:tickLblPos val="nextTo"/>
        <c:crossAx val="161522432"/>
        <c:crosses val="autoZero"/>
        <c:auto val="1"/>
        <c:lblAlgn val="ctr"/>
        <c:lblOffset val="100"/>
        <c:tickLblSkip val="5"/>
        <c:tickMarkSkip val="5"/>
      </c:catAx>
      <c:valAx>
        <c:axId val="16152243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1475584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/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 A2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A2_0.02_5%'!$B$104</c:f>
              <c:strCache>
                <c:ptCount val="1"/>
                <c:pt idx="0">
                  <c:v>N2_A2_40_30_02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B$105:$B$125</c:f>
              <c:numCache>
                <c:formatCode>General</c:formatCode>
                <c:ptCount val="21"/>
                <c:pt idx="1">
                  <c:v>9.5066185318892993E-2</c:v>
                </c:pt>
                <c:pt idx="2">
                  <c:v>0.13838748495788208</c:v>
                </c:pt>
                <c:pt idx="3">
                  <c:v>0.12996389891696708</c:v>
                </c:pt>
                <c:pt idx="4">
                  <c:v>0.10830324909747302</c:v>
                </c:pt>
                <c:pt idx="5">
                  <c:v>0.110709987966306</c:v>
                </c:pt>
                <c:pt idx="6">
                  <c:v>7.4608904933814738E-2</c:v>
                </c:pt>
                <c:pt idx="7">
                  <c:v>4.2117930204572829E-2</c:v>
                </c:pt>
                <c:pt idx="8">
                  <c:v>3.6101083032491002E-2</c:v>
                </c:pt>
                <c:pt idx="9">
                  <c:v>3.8507821901323701E-2</c:v>
                </c:pt>
                <c:pt idx="10">
                  <c:v>3.6101083032491002E-2</c:v>
                </c:pt>
                <c:pt idx="11">
                  <c:v>2.4067388688327324E-2</c:v>
                </c:pt>
                <c:pt idx="12">
                  <c:v>1.4440433212996401E-2</c:v>
                </c:pt>
                <c:pt idx="13">
                  <c:v>9.6269554753309304E-3</c:v>
                </c:pt>
                <c:pt idx="14">
                  <c:v>1.20336943441637E-2</c:v>
                </c:pt>
                <c:pt idx="15">
                  <c:v>9.6269554753309304E-3</c:v>
                </c:pt>
                <c:pt idx="16">
                  <c:v>9.6269554753309304E-3</c:v>
                </c:pt>
                <c:pt idx="17">
                  <c:v>3.6101083032491002E-3</c:v>
                </c:pt>
                <c:pt idx="18">
                  <c:v>2.4067388688327326E-3</c:v>
                </c:pt>
                <c:pt idx="19">
                  <c:v>0</c:v>
                </c:pt>
                <c:pt idx="20">
                  <c:v>1.2033694344163706E-3</c:v>
                </c:pt>
              </c:numCache>
            </c:numRef>
          </c:val>
        </c:ser>
        <c:ser>
          <c:idx val="1"/>
          <c:order val="1"/>
          <c:tx>
            <c:strRef>
              <c:f>'N2 A2_0.02_5%'!$C$104</c:f>
              <c:strCache>
                <c:ptCount val="1"/>
                <c:pt idx="0">
                  <c:v>N2_A2_40_30_03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C$105:$C$125</c:f>
              <c:numCache>
                <c:formatCode>General</c:formatCode>
                <c:ptCount val="21"/>
                <c:pt idx="1">
                  <c:v>7.5826972010178129E-2</c:v>
                </c:pt>
                <c:pt idx="2">
                  <c:v>0.10890585241730302</c:v>
                </c:pt>
                <c:pt idx="3">
                  <c:v>0.12468193384223906</c:v>
                </c:pt>
                <c:pt idx="4">
                  <c:v>0.1302798982188299</c:v>
                </c:pt>
                <c:pt idx="5">
                  <c:v>0.10687022900763404</c:v>
                </c:pt>
                <c:pt idx="6">
                  <c:v>7.5318066157760835E-2</c:v>
                </c:pt>
                <c:pt idx="7">
                  <c:v>5.4961832061068701E-2</c:v>
                </c:pt>
                <c:pt idx="8">
                  <c:v>4.12213740458015E-2</c:v>
                </c:pt>
                <c:pt idx="9">
                  <c:v>3.7659033078880418E-2</c:v>
                </c:pt>
                <c:pt idx="10">
                  <c:v>3.7150127226463138E-2</c:v>
                </c:pt>
                <c:pt idx="11">
                  <c:v>3.0534351145038188E-2</c:v>
                </c:pt>
                <c:pt idx="12">
                  <c:v>2.1882951653944011E-2</c:v>
                </c:pt>
                <c:pt idx="13">
                  <c:v>1.9847328244274817E-2</c:v>
                </c:pt>
                <c:pt idx="14">
                  <c:v>1.4249363867684498E-2</c:v>
                </c:pt>
                <c:pt idx="15">
                  <c:v>1.8829516539440202E-2</c:v>
                </c:pt>
                <c:pt idx="16">
                  <c:v>8.1424936386768464E-3</c:v>
                </c:pt>
                <c:pt idx="17">
                  <c:v>8.6513994910941503E-3</c:v>
                </c:pt>
                <c:pt idx="18">
                  <c:v>4.5801526717557297E-3</c:v>
                </c:pt>
                <c:pt idx="19">
                  <c:v>3.0534351145038198E-3</c:v>
                </c:pt>
                <c:pt idx="20">
                  <c:v>2.0356234096692086E-3</c:v>
                </c:pt>
              </c:numCache>
            </c:numRef>
          </c:val>
        </c:ser>
        <c:ser>
          <c:idx val="2"/>
          <c:order val="2"/>
          <c:tx>
            <c:strRef>
              <c:f>'N2 A2_0.02_5%'!$D$104</c:f>
              <c:strCache>
                <c:ptCount val="1"/>
                <c:pt idx="0">
                  <c:v>N2_A2_40_30_04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D$105:$D$125</c:f>
              <c:numCache>
                <c:formatCode>General</c:formatCode>
                <c:ptCount val="21"/>
                <c:pt idx="1">
                  <c:v>0.112</c:v>
                </c:pt>
                <c:pt idx="2">
                  <c:v>0.10857142857142908</c:v>
                </c:pt>
                <c:pt idx="3">
                  <c:v>0.11542857142857108</c:v>
                </c:pt>
                <c:pt idx="4">
                  <c:v>9.3714285714285708E-2</c:v>
                </c:pt>
                <c:pt idx="5">
                  <c:v>7.6571428571428596E-2</c:v>
                </c:pt>
                <c:pt idx="6">
                  <c:v>6.7428571428571421E-2</c:v>
                </c:pt>
                <c:pt idx="7">
                  <c:v>4.3428571428571414E-2</c:v>
                </c:pt>
                <c:pt idx="8">
                  <c:v>3.2000000000000021E-2</c:v>
                </c:pt>
                <c:pt idx="9">
                  <c:v>3.4285714285714329E-2</c:v>
                </c:pt>
                <c:pt idx="10">
                  <c:v>2.8571428571428602E-2</c:v>
                </c:pt>
                <c:pt idx="11">
                  <c:v>2.2857142857142913E-2</c:v>
                </c:pt>
                <c:pt idx="12">
                  <c:v>2.8571428571428602E-2</c:v>
                </c:pt>
                <c:pt idx="13">
                  <c:v>1.6000000000000011E-2</c:v>
                </c:pt>
                <c:pt idx="14">
                  <c:v>1.6000000000000011E-2</c:v>
                </c:pt>
                <c:pt idx="15">
                  <c:v>8.0000000000000071E-3</c:v>
                </c:pt>
                <c:pt idx="16">
                  <c:v>8.0000000000000071E-3</c:v>
                </c:pt>
                <c:pt idx="17">
                  <c:v>8.0000000000000071E-3</c:v>
                </c:pt>
                <c:pt idx="18">
                  <c:v>3.4285714285714332E-3</c:v>
                </c:pt>
                <c:pt idx="19">
                  <c:v>4.5714285714285726E-3</c:v>
                </c:pt>
                <c:pt idx="20">
                  <c:v>2.285714285714292E-3</c:v>
                </c:pt>
              </c:numCache>
            </c:numRef>
          </c:val>
        </c:ser>
        <c:ser>
          <c:idx val="3"/>
          <c:order val="3"/>
          <c:tx>
            <c:strRef>
              <c:f>'N2 A2_0.02_5%'!$E$104</c:f>
              <c:strCache>
                <c:ptCount val="1"/>
                <c:pt idx="0">
                  <c:v>N2_REX_A2_01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E$105:$E$125</c:f>
              <c:numCache>
                <c:formatCode>General</c:formatCode>
                <c:ptCount val="21"/>
                <c:pt idx="1">
                  <c:v>8.6249717769248044E-2</c:v>
                </c:pt>
                <c:pt idx="2">
                  <c:v>0.11695642357191206</c:v>
                </c:pt>
                <c:pt idx="3">
                  <c:v>0.12824565364642113</c:v>
                </c:pt>
                <c:pt idx="4">
                  <c:v>0.11989162339128505</c:v>
                </c:pt>
                <c:pt idx="5">
                  <c:v>9.8667870851208012E-2</c:v>
                </c:pt>
                <c:pt idx="6">
                  <c:v>8.7152856175208807E-2</c:v>
                </c:pt>
                <c:pt idx="7">
                  <c:v>6.9315872657484803E-2</c:v>
                </c:pt>
                <c:pt idx="8">
                  <c:v>4.3802212689094601E-2</c:v>
                </c:pt>
                <c:pt idx="9">
                  <c:v>3.9286520659291002E-2</c:v>
                </c:pt>
                <c:pt idx="10">
                  <c:v>2.5513659968390189E-2</c:v>
                </c:pt>
                <c:pt idx="11">
                  <c:v>2.2352675547527699E-2</c:v>
                </c:pt>
                <c:pt idx="12">
                  <c:v>1.941747572815531E-2</c:v>
                </c:pt>
                <c:pt idx="13">
                  <c:v>1.5127568299842008E-2</c:v>
                </c:pt>
                <c:pt idx="14">
                  <c:v>1.24181530819598E-2</c:v>
                </c:pt>
                <c:pt idx="15">
                  <c:v>6.9993226461955342E-3</c:v>
                </c:pt>
                <c:pt idx="16">
                  <c:v>5.8703996387446467E-3</c:v>
                </c:pt>
                <c:pt idx="17">
                  <c:v>6.3219688417249925E-3</c:v>
                </c:pt>
                <c:pt idx="18">
                  <c:v>3.6125536238428486E-3</c:v>
                </c:pt>
                <c:pt idx="19">
                  <c:v>2.03206141341161E-3</c:v>
                </c:pt>
                <c:pt idx="20">
                  <c:v>2.7094152178821426E-3</c:v>
                </c:pt>
              </c:numCache>
            </c:numRef>
          </c:val>
        </c:ser>
        <c:ser>
          <c:idx val="4"/>
          <c:order val="4"/>
          <c:tx>
            <c:strRef>
              <c:f>'N2 A2_0.02_5%'!$F$104</c:f>
              <c:strCache>
                <c:ptCount val="1"/>
                <c:pt idx="0">
                  <c:v>N2_REX_A2_02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F$105:$F$125</c:f>
              <c:numCache>
                <c:formatCode>General</c:formatCode>
                <c:ptCount val="21"/>
                <c:pt idx="1">
                  <c:v>7.3981552651806309E-2</c:v>
                </c:pt>
                <c:pt idx="2">
                  <c:v>0.10491929285165302</c:v>
                </c:pt>
                <c:pt idx="3">
                  <c:v>0.124519600307456</c:v>
                </c:pt>
                <c:pt idx="4">
                  <c:v>0.14584934665641813</c:v>
                </c:pt>
                <c:pt idx="5">
                  <c:v>0.10991544965411204</c:v>
                </c:pt>
                <c:pt idx="6">
                  <c:v>7.4942352036894699E-2</c:v>
                </c:pt>
                <c:pt idx="7">
                  <c:v>7.1099154496541098E-2</c:v>
                </c:pt>
                <c:pt idx="8">
                  <c:v>5.1691006917755578E-2</c:v>
                </c:pt>
                <c:pt idx="9">
                  <c:v>3.1706379707917016E-2</c:v>
                </c:pt>
                <c:pt idx="10">
                  <c:v>3.0745580322828599E-2</c:v>
                </c:pt>
                <c:pt idx="11">
                  <c:v>2.2098385857033109E-2</c:v>
                </c:pt>
                <c:pt idx="12">
                  <c:v>1.633358954650271E-2</c:v>
                </c:pt>
                <c:pt idx="13">
                  <c:v>1.5180630284396601E-2</c:v>
                </c:pt>
                <c:pt idx="14">
                  <c:v>1.3835511145272907E-2</c:v>
                </c:pt>
                <c:pt idx="15">
                  <c:v>8.8393543428132246E-3</c:v>
                </c:pt>
                <c:pt idx="16">
                  <c:v>6.9177555726364299E-3</c:v>
                </c:pt>
                <c:pt idx="17">
                  <c:v>5.9569561875480433E-3</c:v>
                </c:pt>
                <c:pt idx="18">
                  <c:v>3.6510376633359016E-3</c:v>
                </c:pt>
                <c:pt idx="19">
                  <c:v>3.6510376633359016E-3</c:v>
                </c:pt>
                <c:pt idx="20">
                  <c:v>1.5372790161414301E-3</c:v>
                </c:pt>
              </c:numCache>
            </c:numRef>
          </c:val>
        </c:ser>
        <c:ser>
          <c:idx val="5"/>
          <c:order val="5"/>
          <c:tx>
            <c:strRef>
              <c:f>'N2 A2_0.02_5%'!$G$104</c:f>
              <c:strCache>
                <c:ptCount val="1"/>
                <c:pt idx="0">
                  <c:v>N2_REX_A2_03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G$105:$G$125</c:f>
              <c:numCache>
                <c:formatCode>General</c:formatCode>
                <c:ptCount val="21"/>
                <c:pt idx="1">
                  <c:v>8.2034830430797456E-2</c:v>
                </c:pt>
                <c:pt idx="2">
                  <c:v>0.110678276810266</c:v>
                </c:pt>
                <c:pt idx="3">
                  <c:v>0.13015582034830392</c:v>
                </c:pt>
                <c:pt idx="4">
                  <c:v>0.13588450962419793</c:v>
                </c:pt>
                <c:pt idx="5">
                  <c:v>0.112511457378552</c:v>
                </c:pt>
                <c:pt idx="6">
                  <c:v>8.1576535288725896E-2</c:v>
                </c:pt>
                <c:pt idx="7">
                  <c:v>6.8973418881759896E-2</c:v>
                </c:pt>
                <c:pt idx="8">
                  <c:v>4.4912923923006491E-2</c:v>
                </c:pt>
                <c:pt idx="9">
                  <c:v>3.4830430797433497E-2</c:v>
                </c:pt>
                <c:pt idx="10">
                  <c:v>2.7497708524289628E-2</c:v>
                </c:pt>
                <c:pt idx="11">
                  <c:v>2.1539871677360222E-2</c:v>
                </c:pt>
                <c:pt idx="12">
                  <c:v>1.6727772685609512E-2</c:v>
                </c:pt>
                <c:pt idx="13">
                  <c:v>1.6040329972502303E-2</c:v>
                </c:pt>
                <c:pt idx="14">
                  <c:v>1.2603116406966101E-2</c:v>
                </c:pt>
                <c:pt idx="15">
                  <c:v>9.8533455545371258E-3</c:v>
                </c:pt>
                <c:pt idx="16">
                  <c:v>4.8120989917506928E-3</c:v>
                </c:pt>
                <c:pt idx="17">
                  <c:v>3.2080659945004602E-3</c:v>
                </c:pt>
                <c:pt idx="18">
                  <c:v>2.06232813932172E-3</c:v>
                </c:pt>
                <c:pt idx="19">
                  <c:v>1.833180568285981E-3</c:v>
                </c:pt>
                <c:pt idx="20">
                  <c:v>6.8744271310724136E-4</c:v>
                </c:pt>
              </c:numCache>
            </c:numRef>
          </c:val>
        </c:ser>
        <c:ser>
          <c:idx val="6"/>
          <c:order val="6"/>
          <c:tx>
            <c:strRef>
              <c:f>'N2 A2_0.02_5%'!$H$104</c:f>
              <c:strCache>
                <c:ptCount val="1"/>
                <c:pt idx="0">
                  <c:v>N2_REX_A2_04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H$105:$H$125</c:f>
              <c:numCache>
                <c:formatCode>General</c:formatCode>
                <c:ptCount val="21"/>
                <c:pt idx="1">
                  <c:v>8.1481481481481446E-2</c:v>
                </c:pt>
                <c:pt idx="2">
                  <c:v>0.12037037037037</c:v>
                </c:pt>
                <c:pt idx="3">
                  <c:v>0.13634259259259307</c:v>
                </c:pt>
                <c:pt idx="4">
                  <c:v>0.12615740740740708</c:v>
                </c:pt>
                <c:pt idx="5">
                  <c:v>0.11273148148148109</c:v>
                </c:pt>
                <c:pt idx="6">
                  <c:v>8.9120370370370516E-2</c:v>
                </c:pt>
                <c:pt idx="7">
                  <c:v>5.3935185185185169E-2</c:v>
                </c:pt>
                <c:pt idx="8">
                  <c:v>4.004629629629633E-2</c:v>
                </c:pt>
                <c:pt idx="9">
                  <c:v>3.6805555555555612E-2</c:v>
                </c:pt>
                <c:pt idx="10">
                  <c:v>2.4768518518518488E-2</c:v>
                </c:pt>
                <c:pt idx="11">
                  <c:v>1.59722222222222E-2</c:v>
                </c:pt>
                <c:pt idx="12">
                  <c:v>1.7592592592592601E-2</c:v>
                </c:pt>
                <c:pt idx="13">
                  <c:v>1.1111111111111101E-2</c:v>
                </c:pt>
                <c:pt idx="14">
                  <c:v>8.1018518518518497E-3</c:v>
                </c:pt>
                <c:pt idx="15">
                  <c:v>6.9444444444444441E-3</c:v>
                </c:pt>
                <c:pt idx="16">
                  <c:v>6.0185185185185203E-3</c:v>
                </c:pt>
                <c:pt idx="17">
                  <c:v>4.3981481481481502E-3</c:v>
                </c:pt>
                <c:pt idx="18">
                  <c:v>4.1666666666666701E-3</c:v>
                </c:pt>
                <c:pt idx="19">
                  <c:v>2.0833333333333316E-3</c:v>
                </c:pt>
                <c:pt idx="20">
                  <c:v>6.9444444444444458E-4</c:v>
                </c:pt>
              </c:numCache>
            </c:numRef>
          </c:val>
        </c:ser>
        <c:ser>
          <c:idx val="7"/>
          <c:order val="7"/>
          <c:tx>
            <c:strRef>
              <c:f>'N2 A2_0.02_5%'!$I$104</c:f>
              <c:strCache>
                <c:ptCount val="1"/>
                <c:pt idx="0">
                  <c:v>N2_REX_A2_08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I$105:$I$125</c:f>
              <c:numCache>
                <c:formatCode>General</c:formatCode>
                <c:ptCount val="21"/>
                <c:pt idx="1">
                  <c:v>9.1282894736842146E-2</c:v>
                </c:pt>
                <c:pt idx="2">
                  <c:v>0.10978618421052606</c:v>
                </c:pt>
                <c:pt idx="3">
                  <c:v>0.10567434210526302</c:v>
                </c:pt>
                <c:pt idx="4">
                  <c:v>0.11184210526315802</c:v>
                </c:pt>
                <c:pt idx="5">
                  <c:v>8.4703947368421184E-2</c:v>
                </c:pt>
                <c:pt idx="6">
                  <c:v>6.4555921052631679E-2</c:v>
                </c:pt>
                <c:pt idx="7">
                  <c:v>5.3453947368421101E-2</c:v>
                </c:pt>
                <c:pt idx="8">
                  <c:v>4.5230263157894704E-2</c:v>
                </c:pt>
                <c:pt idx="9">
                  <c:v>4.975328947368423E-2</c:v>
                </c:pt>
                <c:pt idx="10">
                  <c:v>3.7417763157894718E-2</c:v>
                </c:pt>
                <c:pt idx="11">
                  <c:v>2.9194078947368397E-2</c:v>
                </c:pt>
                <c:pt idx="12">
                  <c:v>2.2615131578947414E-2</c:v>
                </c:pt>
                <c:pt idx="13">
                  <c:v>1.5625E-2</c:v>
                </c:pt>
                <c:pt idx="14">
                  <c:v>1.6447368421052603E-2</c:v>
                </c:pt>
                <c:pt idx="15">
                  <c:v>1.1513157894736807E-2</c:v>
                </c:pt>
                <c:pt idx="16">
                  <c:v>1.06907894736842E-2</c:v>
                </c:pt>
                <c:pt idx="17">
                  <c:v>4.1118421052631689E-3</c:v>
                </c:pt>
                <c:pt idx="18">
                  <c:v>4.9342105263157875E-3</c:v>
                </c:pt>
                <c:pt idx="19">
                  <c:v>3.2894736842105313E-3</c:v>
                </c:pt>
                <c:pt idx="20">
                  <c:v>2.0559210526315827E-3</c:v>
                </c:pt>
              </c:numCache>
            </c:numRef>
          </c:val>
        </c:ser>
        <c:ser>
          <c:idx val="8"/>
          <c:order val="8"/>
          <c:tx>
            <c:strRef>
              <c:f>'N2 A2_0.02_5%'!$J$104</c:f>
              <c:strCache>
                <c:ptCount val="1"/>
                <c:pt idx="0">
                  <c:v>N2_REX_A2_09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J$105:$J$125</c:f>
              <c:numCache>
                <c:formatCode>General</c:formatCode>
                <c:ptCount val="21"/>
                <c:pt idx="1">
                  <c:v>7.4346405228758239E-2</c:v>
                </c:pt>
                <c:pt idx="2">
                  <c:v>0.11540032679738596</c:v>
                </c:pt>
                <c:pt idx="3">
                  <c:v>0.13868464052287599</c:v>
                </c:pt>
                <c:pt idx="4">
                  <c:v>0.14522058823529399</c:v>
                </c:pt>
                <c:pt idx="5">
                  <c:v>0.11417483660130701</c:v>
                </c:pt>
                <c:pt idx="6">
                  <c:v>7.5776143790849695E-2</c:v>
                </c:pt>
                <c:pt idx="7">
                  <c:v>5.6781045751633986E-2</c:v>
                </c:pt>
                <c:pt idx="8">
                  <c:v>4.3096405228758218E-2</c:v>
                </c:pt>
                <c:pt idx="9">
                  <c:v>3.7785947712418333E-2</c:v>
                </c:pt>
                <c:pt idx="10">
                  <c:v>3.0841503267973924E-2</c:v>
                </c:pt>
                <c:pt idx="11">
                  <c:v>2.1854575163398698E-2</c:v>
                </c:pt>
                <c:pt idx="12">
                  <c:v>1.6339869281045801E-2</c:v>
                </c:pt>
                <c:pt idx="13">
                  <c:v>1.4297385620914999E-2</c:v>
                </c:pt>
                <c:pt idx="14">
                  <c:v>9.191176470588246E-3</c:v>
                </c:pt>
                <c:pt idx="15">
                  <c:v>9.191176470588246E-3</c:v>
                </c:pt>
                <c:pt idx="16">
                  <c:v>5.5147058823529424E-3</c:v>
                </c:pt>
                <c:pt idx="17">
                  <c:v>2.8594771241830085E-3</c:v>
                </c:pt>
                <c:pt idx="18">
                  <c:v>2.4509803921568601E-3</c:v>
                </c:pt>
                <c:pt idx="19">
                  <c:v>3.0637254901960814E-3</c:v>
                </c:pt>
                <c:pt idx="20">
                  <c:v>8.1699346405228858E-4</c:v>
                </c:pt>
              </c:numCache>
            </c:numRef>
          </c:val>
        </c:ser>
        <c:ser>
          <c:idx val="9"/>
          <c:order val="9"/>
          <c:tx>
            <c:strRef>
              <c:f>'N2 A2_0.02_5%'!$K$104</c:f>
              <c:strCache>
                <c:ptCount val="1"/>
                <c:pt idx="0">
                  <c:v>N2_REX_A2_10</c:v>
                </c:pt>
              </c:strCache>
            </c:strRef>
          </c:tx>
          <c:marker>
            <c:symbol val="none"/>
          </c:marker>
          <c:cat>
            <c:numRef>
              <c:f>'N2 A2_0.02_5%'!$A$105:$A$125</c:f>
              <c:numCache>
                <c:formatCode>General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26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8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7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6</c:v>
                </c:pt>
                <c:pt idx="16">
                  <c:v>0.32000000000000017</c:v>
                </c:pt>
                <c:pt idx="17">
                  <c:v>0.34</c:v>
                </c:pt>
                <c:pt idx="18">
                  <c:v>0.36000000000000015</c:v>
                </c:pt>
                <c:pt idx="19">
                  <c:v>0.38000000000000017</c:v>
                </c:pt>
                <c:pt idx="20">
                  <c:v>0.4</c:v>
                </c:pt>
              </c:numCache>
            </c:numRef>
          </c:cat>
          <c:val>
            <c:numRef>
              <c:f>'N2 A2_0.02_5%'!$K$105:$K$125</c:f>
              <c:numCache>
                <c:formatCode>General</c:formatCode>
                <c:ptCount val="21"/>
                <c:pt idx="1">
                  <c:v>6.9879518072289204E-2</c:v>
                </c:pt>
                <c:pt idx="2">
                  <c:v>0.11686746987951796</c:v>
                </c:pt>
                <c:pt idx="3">
                  <c:v>0.14036144578313309</c:v>
                </c:pt>
                <c:pt idx="4">
                  <c:v>0.12831325301204799</c:v>
                </c:pt>
                <c:pt idx="5">
                  <c:v>0.104819277108434</c:v>
                </c:pt>
                <c:pt idx="6">
                  <c:v>7.2289156626505965E-2</c:v>
                </c:pt>
                <c:pt idx="7">
                  <c:v>6.3855421686747002E-2</c:v>
                </c:pt>
                <c:pt idx="8">
                  <c:v>4.8795180722891629E-2</c:v>
                </c:pt>
                <c:pt idx="9">
                  <c:v>3.3734939759036103E-2</c:v>
                </c:pt>
                <c:pt idx="10">
                  <c:v>3.0722891566265099E-2</c:v>
                </c:pt>
                <c:pt idx="11">
                  <c:v>2.5301204819277112E-2</c:v>
                </c:pt>
                <c:pt idx="12">
                  <c:v>1.6867469879518111E-2</c:v>
                </c:pt>
                <c:pt idx="13">
                  <c:v>1.6867469879518111E-2</c:v>
                </c:pt>
                <c:pt idx="14">
                  <c:v>9.0361445783132561E-3</c:v>
                </c:pt>
                <c:pt idx="15">
                  <c:v>1.3855421686747011E-2</c:v>
                </c:pt>
                <c:pt idx="16">
                  <c:v>7.8313253012048285E-3</c:v>
                </c:pt>
                <c:pt idx="17">
                  <c:v>6.6265060240963897E-3</c:v>
                </c:pt>
                <c:pt idx="18">
                  <c:v>3.6144578313253013E-3</c:v>
                </c:pt>
                <c:pt idx="19">
                  <c:v>3.6144578313253013E-3</c:v>
                </c:pt>
                <c:pt idx="20">
                  <c:v>1.80722891566265E-3</c:v>
                </c:pt>
              </c:numCache>
            </c:numRef>
          </c:val>
        </c:ser>
        <c:marker val="1"/>
        <c:axId val="157132672"/>
        <c:axId val="157134208"/>
      </c:lineChart>
      <c:catAx>
        <c:axId val="157132672"/>
        <c:scaling>
          <c:orientation val="minMax"/>
        </c:scaling>
        <c:axPos val="b"/>
        <c:numFmt formatCode="#,##0.0_);\(#,##0.0\)" sourceLinked="0"/>
        <c:tickLblPos val="nextTo"/>
        <c:crossAx val="157134208"/>
        <c:crosses val="autoZero"/>
        <c:auto val="1"/>
        <c:lblAlgn val="ctr"/>
        <c:lblOffset val="100"/>
        <c:tickLblSkip val="5"/>
        <c:tickMarkSkip val="5"/>
      </c:catAx>
      <c:valAx>
        <c:axId val="15713420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7132672"/>
        <c:crosses val="autoZero"/>
        <c:crossBetween val="between"/>
      </c:valAx>
    </c:plotArea>
    <c:plotVisOnly val="1"/>
  </c:chart>
  <c:externalData r:id="rId1"/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 i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tph-1</a:t>
            </a:r>
            <a:r>
              <a:rPr lang="en-US" altLang="ja-JP" sz="1400" b="0" i="0" baseline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i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tph-1(mg280)_A1_0.02_5%'!$B$104</c:f>
              <c:strCache>
                <c:ptCount val="1"/>
                <c:pt idx="0">
                  <c:v>thp-1(mg280)_A1_01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B$105:$B$125</c:f>
              <c:numCache>
                <c:formatCode>General</c:formatCode>
                <c:ptCount val="21"/>
                <c:pt idx="1">
                  <c:v>6.8601583113456502E-2</c:v>
                </c:pt>
                <c:pt idx="2">
                  <c:v>9.4986807387862873E-2</c:v>
                </c:pt>
                <c:pt idx="3">
                  <c:v>0.10817941952506598</c:v>
                </c:pt>
                <c:pt idx="4">
                  <c:v>0.10290237467018502</c:v>
                </c:pt>
                <c:pt idx="5">
                  <c:v>9.762532981530346E-2</c:v>
                </c:pt>
                <c:pt idx="6">
                  <c:v>5.2770448548812701E-2</c:v>
                </c:pt>
                <c:pt idx="7">
                  <c:v>8.4432717678100233E-2</c:v>
                </c:pt>
                <c:pt idx="8">
                  <c:v>4.7493403693931437E-2</c:v>
                </c:pt>
                <c:pt idx="9">
                  <c:v>4.4854881266490801E-2</c:v>
                </c:pt>
                <c:pt idx="10">
                  <c:v>2.3746701846965694E-2</c:v>
                </c:pt>
                <c:pt idx="11">
                  <c:v>2.6385224274406299E-2</c:v>
                </c:pt>
                <c:pt idx="12">
                  <c:v>1.3192612137203198E-2</c:v>
                </c:pt>
                <c:pt idx="13">
                  <c:v>1.3192612137203198E-2</c:v>
                </c:pt>
                <c:pt idx="14">
                  <c:v>1.0554089709762505E-2</c:v>
                </c:pt>
                <c:pt idx="15">
                  <c:v>5.2770448548812715E-3</c:v>
                </c:pt>
                <c:pt idx="16">
                  <c:v>1.3192612137203198E-2</c:v>
                </c:pt>
                <c:pt idx="17">
                  <c:v>2.638522427440631E-3</c:v>
                </c:pt>
                <c:pt idx="18">
                  <c:v>5.2770448548812715E-3</c:v>
                </c:pt>
                <c:pt idx="19">
                  <c:v>0</c:v>
                </c:pt>
                <c:pt idx="20">
                  <c:v>2.638522427440631E-3</c:v>
                </c:pt>
              </c:numCache>
            </c:numRef>
          </c:val>
        </c:ser>
        <c:ser>
          <c:idx val="1"/>
          <c:order val="1"/>
          <c:tx>
            <c:strRef>
              <c:f>'tph-1(mg280)_A1_0.02_5%'!$C$104</c:f>
              <c:strCache>
                <c:ptCount val="1"/>
                <c:pt idx="0">
                  <c:v>thp-1(mg280)_A1_02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C$105:$C$125</c:f>
              <c:numCache>
                <c:formatCode>General</c:formatCode>
                <c:ptCount val="21"/>
                <c:pt idx="1">
                  <c:v>7.5329566854990634E-2</c:v>
                </c:pt>
                <c:pt idx="2">
                  <c:v>7.9096045197740134E-2</c:v>
                </c:pt>
                <c:pt idx="3">
                  <c:v>0.10169491525423703</c:v>
                </c:pt>
                <c:pt idx="4">
                  <c:v>0.105461393596987</c:v>
                </c:pt>
                <c:pt idx="5">
                  <c:v>9.9811676082862538E-2</c:v>
                </c:pt>
                <c:pt idx="6">
                  <c:v>9.9811676082862538E-2</c:v>
                </c:pt>
                <c:pt idx="7">
                  <c:v>6.5913370998116824E-2</c:v>
                </c:pt>
                <c:pt idx="8">
                  <c:v>4.70809792843691E-2</c:v>
                </c:pt>
                <c:pt idx="9">
                  <c:v>4.1431261770244796E-2</c:v>
                </c:pt>
                <c:pt idx="10">
                  <c:v>4.70809792843691E-2</c:v>
                </c:pt>
                <c:pt idx="11">
                  <c:v>3.2015065913371013E-2</c:v>
                </c:pt>
                <c:pt idx="12">
                  <c:v>2.4482109227871911E-2</c:v>
                </c:pt>
                <c:pt idx="13">
                  <c:v>2.2598870056497199E-2</c:v>
                </c:pt>
                <c:pt idx="14">
                  <c:v>9.4161958568738241E-3</c:v>
                </c:pt>
                <c:pt idx="15">
                  <c:v>1.3182674199623405E-2</c:v>
                </c:pt>
                <c:pt idx="16">
                  <c:v>1.8832391713747603E-2</c:v>
                </c:pt>
                <c:pt idx="17">
                  <c:v>5.6497175141242903E-3</c:v>
                </c:pt>
                <c:pt idx="18">
                  <c:v>9.4161958568738241E-3</c:v>
                </c:pt>
                <c:pt idx="19">
                  <c:v>5.6497175141242903E-3</c:v>
                </c:pt>
                <c:pt idx="20">
                  <c:v>5.6497175141242903E-3</c:v>
                </c:pt>
              </c:numCache>
            </c:numRef>
          </c:val>
        </c:ser>
        <c:ser>
          <c:idx val="2"/>
          <c:order val="2"/>
          <c:tx>
            <c:strRef>
              <c:f>'tph-1(mg280)_A1_0.02_5%'!$D$104</c:f>
              <c:strCache>
                <c:ptCount val="1"/>
                <c:pt idx="0">
                  <c:v>thp-1(mg280)_A1_03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D$105:$D$125</c:f>
              <c:numCache>
                <c:formatCode>General</c:formatCode>
                <c:ptCount val="21"/>
                <c:pt idx="1">
                  <c:v>0.10141987829614597</c:v>
                </c:pt>
                <c:pt idx="2">
                  <c:v>0.11967545638945203</c:v>
                </c:pt>
                <c:pt idx="3">
                  <c:v>9.3306288032454429E-2</c:v>
                </c:pt>
                <c:pt idx="4">
                  <c:v>0.133874239350913</c:v>
                </c:pt>
                <c:pt idx="5">
                  <c:v>0.10344827586206902</c:v>
                </c:pt>
                <c:pt idx="6">
                  <c:v>8.3164300202839853E-2</c:v>
                </c:pt>
                <c:pt idx="7">
                  <c:v>3.651115618661261E-2</c:v>
                </c:pt>
                <c:pt idx="8">
                  <c:v>5.476673427991894E-2</c:v>
                </c:pt>
                <c:pt idx="9">
                  <c:v>2.8397565922920899E-2</c:v>
                </c:pt>
                <c:pt idx="10">
                  <c:v>1.4198782961460396E-2</c:v>
                </c:pt>
                <c:pt idx="11">
                  <c:v>2.2312373225152105E-2</c:v>
                </c:pt>
                <c:pt idx="12">
                  <c:v>1.4198782961460396E-2</c:v>
                </c:pt>
                <c:pt idx="13">
                  <c:v>1.4198782961460396E-2</c:v>
                </c:pt>
                <c:pt idx="14">
                  <c:v>1.0141987829614599E-2</c:v>
                </c:pt>
                <c:pt idx="15">
                  <c:v>6.0851926977687626E-3</c:v>
                </c:pt>
                <c:pt idx="16">
                  <c:v>2.0283975659229226E-3</c:v>
                </c:pt>
                <c:pt idx="17">
                  <c:v>6.0851926977687626E-3</c:v>
                </c:pt>
                <c:pt idx="18">
                  <c:v>8.1135902636916835E-3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3"/>
          <c:order val="3"/>
          <c:tx>
            <c:strRef>
              <c:f>'tph-1(mg280)_A1_0.02_5%'!$E$104</c:f>
              <c:strCache>
                <c:ptCount val="1"/>
                <c:pt idx="0">
                  <c:v>thp-1(mg280)_A1_04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E$105:$E$125</c:f>
              <c:numCache>
                <c:formatCode>General</c:formatCode>
                <c:ptCount val="21"/>
                <c:pt idx="1">
                  <c:v>8.263069139966274E-2</c:v>
                </c:pt>
                <c:pt idx="2">
                  <c:v>8.6003372681281637E-2</c:v>
                </c:pt>
                <c:pt idx="3">
                  <c:v>8.6003372681281637E-2</c:v>
                </c:pt>
                <c:pt idx="4">
                  <c:v>0.10623946037099502</c:v>
                </c:pt>
                <c:pt idx="5">
                  <c:v>0.11298482293423302</c:v>
                </c:pt>
                <c:pt idx="6">
                  <c:v>9.4435075885328804E-2</c:v>
                </c:pt>
                <c:pt idx="7">
                  <c:v>5.9021922428330514E-2</c:v>
                </c:pt>
                <c:pt idx="8">
                  <c:v>5.5649241146711617E-2</c:v>
                </c:pt>
                <c:pt idx="9">
                  <c:v>5.7335581787521121E-2</c:v>
                </c:pt>
                <c:pt idx="10">
                  <c:v>4.721753794266443E-2</c:v>
                </c:pt>
                <c:pt idx="11">
                  <c:v>1.85497470489039E-2</c:v>
                </c:pt>
                <c:pt idx="12">
                  <c:v>1.85497470489039E-2</c:v>
                </c:pt>
                <c:pt idx="13">
                  <c:v>1.85497470489039E-2</c:v>
                </c:pt>
                <c:pt idx="14">
                  <c:v>1.6863406408094399E-2</c:v>
                </c:pt>
                <c:pt idx="15">
                  <c:v>1.5177065767284999E-2</c:v>
                </c:pt>
                <c:pt idx="16">
                  <c:v>5.059021922428332E-3</c:v>
                </c:pt>
                <c:pt idx="17">
                  <c:v>1.1804384485666107E-2</c:v>
                </c:pt>
                <c:pt idx="18">
                  <c:v>1.1804384485666107E-2</c:v>
                </c:pt>
                <c:pt idx="19">
                  <c:v>8.431703204047224E-3</c:v>
                </c:pt>
                <c:pt idx="20">
                  <c:v>1.6863406408094404E-3</c:v>
                </c:pt>
              </c:numCache>
            </c:numRef>
          </c:val>
        </c:ser>
        <c:ser>
          <c:idx val="4"/>
          <c:order val="4"/>
          <c:tx>
            <c:strRef>
              <c:f>'tph-1(mg280)_A1_0.02_5%'!$F$104</c:f>
              <c:strCache>
                <c:ptCount val="1"/>
                <c:pt idx="0">
                  <c:v>thp-1(mg280)_A1_05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F$105:$F$125</c:f>
              <c:numCache>
                <c:formatCode>General</c:formatCode>
                <c:ptCount val="21"/>
                <c:pt idx="1">
                  <c:v>9.1228070175438658E-2</c:v>
                </c:pt>
                <c:pt idx="2">
                  <c:v>9.9415204678362581E-2</c:v>
                </c:pt>
                <c:pt idx="3">
                  <c:v>8.5380116959064278E-2</c:v>
                </c:pt>
                <c:pt idx="4">
                  <c:v>9.4736842105263286E-2</c:v>
                </c:pt>
                <c:pt idx="5">
                  <c:v>0.105263157894737</c:v>
                </c:pt>
                <c:pt idx="6">
                  <c:v>8.7719298245614002E-2</c:v>
                </c:pt>
                <c:pt idx="7">
                  <c:v>6.4327485380117025E-2</c:v>
                </c:pt>
                <c:pt idx="8">
                  <c:v>7.2514619883040934E-2</c:v>
                </c:pt>
                <c:pt idx="9">
                  <c:v>5.4970760233918115E-2</c:v>
                </c:pt>
                <c:pt idx="10">
                  <c:v>3.5087719298245605E-2</c:v>
                </c:pt>
                <c:pt idx="11">
                  <c:v>2.3391812865497099E-2</c:v>
                </c:pt>
                <c:pt idx="12">
                  <c:v>1.1695906432748499E-2</c:v>
                </c:pt>
                <c:pt idx="13">
                  <c:v>2.3391812865497099E-2</c:v>
                </c:pt>
                <c:pt idx="14">
                  <c:v>1.05263157894737E-2</c:v>
                </c:pt>
                <c:pt idx="15">
                  <c:v>1.6374269005847999E-2</c:v>
                </c:pt>
                <c:pt idx="16">
                  <c:v>9.3567251461988306E-3</c:v>
                </c:pt>
                <c:pt idx="17">
                  <c:v>1.05263157894737E-2</c:v>
                </c:pt>
                <c:pt idx="18">
                  <c:v>2.3391812865497107E-3</c:v>
                </c:pt>
                <c:pt idx="19">
                  <c:v>1.1695906432748499E-3</c:v>
                </c:pt>
                <c:pt idx="20">
                  <c:v>8.1871345029239876E-3</c:v>
                </c:pt>
              </c:numCache>
            </c:numRef>
          </c:val>
        </c:ser>
        <c:ser>
          <c:idx val="5"/>
          <c:order val="5"/>
          <c:tx>
            <c:strRef>
              <c:f>'tph-1(mg280)_A1_0.02_5%'!$G$104</c:f>
              <c:strCache>
                <c:ptCount val="1"/>
                <c:pt idx="0">
                  <c:v>thp-1(mg280)_A1_06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G$105:$G$125</c:f>
              <c:numCache>
                <c:formatCode>General</c:formatCode>
                <c:ptCount val="21"/>
                <c:pt idx="1">
                  <c:v>9.9792099792099867E-2</c:v>
                </c:pt>
                <c:pt idx="2">
                  <c:v>9.1476091476091495E-2</c:v>
                </c:pt>
                <c:pt idx="3">
                  <c:v>7.6923076923076913E-2</c:v>
                </c:pt>
                <c:pt idx="4">
                  <c:v>8.9397089397089471E-2</c:v>
                </c:pt>
                <c:pt idx="5">
                  <c:v>0.10395010395010403</c:v>
                </c:pt>
                <c:pt idx="6">
                  <c:v>6.2370062370062387E-2</c:v>
                </c:pt>
                <c:pt idx="7">
                  <c:v>4.3659043659043696E-2</c:v>
                </c:pt>
                <c:pt idx="8">
                  <c:v>3.7422037422037417E-2</c:v>
                </c:pt>
                <c:pt idx="9">
                  <c:v>4.7817047817047834E-2</c:v>
                </c:pt>
                <c:pt idx="10">
                  <c:v>3.5343035343035303E-2</c:v>
                </c:pt>
                <c:pt idx="11">
                  <c:v>3.5343035343035303E-2</c:v>
                </c:pt>
                <c:pt idx="12">
                  <c:v>2.9106029106029101E-2</c:v>
                </c:pt>
                <c:pt idx="13">
                  <c:v>2.7027027027027015E-2</c:v>
                </c:pt>
                <c:pt idx="14">
                  <c:v>1.4553014553014595E-2</c:v>
                </c:pt>
                <c:pt idx="15">
                  <c:v>2.07900207900208E-3</c:v>
                </c:pt>
                <c:pt idx="16">
                  <c:v>6.23700623700624E-3</c:v>
                </c:pt>
                <c:pt idx="17">
                  <c:v>8.3160083160083286E-3</c:v>
                </c:pt>
                <c:pt idx="18">
                  <c:v>6.23700623700624E-3</c:v>
                </c:pt>
                <c:pt idx="19">
                  <c:v>4.1580041580041617E-3</c:v>
                </c:pt>
                <c:pt idx="20">
                  <c:v>6.23700623700624E-3</c:v>
                </c:pt>
              </c:numCache>
            </c:numRef>
          </c:val>
        </c:ser>
        <c:ser>
          <c:idx val="6"/>
          <c:order val="6"/>
          <c:tx>
            <c:strRef>
              <c:f>'tph-1(mg280)_A1_0.02_5%'!$H$104</c:f>
              <c:strCache>
                <c:ptCount val="1"/>
                <c:pt idx="0">
                  <c:v>thp-1(mg280)_A1_07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H$105:$H$125</c:f>
              <c:numCache>
                <c:formatCode>General</c:formatCode>
                <c:ptCount val="21"/>
                <c:pt idx="1">
                  <c:v>0.10602409638554203</c:v>
                </c:pt>
                <c:pt idx="2">
                  <c:v>0.11084337349397598</c:v>
                </c:pt>
                <c:pt idx="3">
                  <c:v>0.12289156626506002</c:v>
                </c:pt>
                <c:pt idx="4">
                  <c:v>7.4698795180722893E-2</c:v>
                </c:pt>
                <c:pt idx="5">
                  <c:v>6.5060240963855404E-2</c:v>
                </c:pt>
                <c:pt idx="6">
                  <c:v>5.78313253012048E-2</c:v>
                </c:pt>
                <c:pt idx="7">
                  <c:v>5.54216867469879E-2</c:v>
                </c:pt>
                <c:pt idx="8">
                  <c:v>4.3373493975903628E-2</c:v>
                </c:pt>
                <c:pt idx="9">
                  <c:v>2.6506024096385489E-2</c:v>
                </c:pt>
                <c:pt idx="10">
                  <c:v>2.6506024096385489E-2</c:v>
                </c:pt>
                <c:pt idx="11">
                  <c:v>2.89156626506024E-2</c:v>
                </c:pt>
                <c:pt idx="12">
                  <c:v>1.6867469879518107E-2</c:v>
                </c:pt>
                <c:pt idx="13">
                  <c:v>1.6867469879518107E-2</c:v>
                </c:pt>
                <c:pt idx="14">
                  <c:v>1.6867469879518107E-2</c:v>
                </c:pt>
                <c:pt idx="15">
                  <c:v>7.2289156626506E-3</c:v>
                </c:pt>
                <c:pt idx="16">
                  <c:v>2.4096385542168699E-3</c:v>
                </c:pt>
                <c:pt idx="17">
                  <c:v>4.8192771084337423E-3</c:v>
                </c:pt>
                <c:pt idx="18">
                  <c:v>2.4096385542168699E-3</c:v>
                </c:pt>
                <c:pt idx="19">
                  <c:v>4.8192771084337423E-3</c:v>
                </c:pt>
                <c:pt idx="20">
                  <c:v>0</c:v>
                </c:pt>
              </c:numCache>
            </c:numRef>
          </c:val>
        </c:ser>
        <c:ser>
          <c:idx val="7"/>
          <c:order val="7"/>
          <c:tx>
            <c:strRef>
              <c:f>'tph-1(mg280)_A1_0.02_5%'!$I$104</c:f>
              <c:strCache>
                <c:ptCount val="1"/>
                <c:pt idx="0">
                  <c:v>thp-1(mg280)_A1_08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I$105:$I$125</c:f>
              <c:numCache>
                <c:formatCode>General</c:formatCode>
                <c:ptCount val="21"/>
                <c:pt idx="1">
                  <c:v>9.1517857142857151E-2</c:v>
                </c:pt>
                <c:pt idx="2">
                  <c:v>9.1517857142857151E-2</c:v>
                </c:pt>
                <c:pt idx="3">
                  <c:v>8.816964285714296E-2</c:v>
                </c:pt>
                <c:pt idx="4">
                  <c:v>0.10267857142857104</c:v>
                </c:pt>
                <c:pt idx="5">
                  <c:v>0.11049107142857104</c:v>
                </c:pt>
                <c:pt idx="6">
                  <c:v>8.5937500000000028E-2</c:v>
                </c:pt>
                <c:pt idx="7">
                  <c:v>6.5848214285714302E-2</c:v>
                </c:pt>
                <c:pt idx="8">
                  <c:v>5.1339285714285698E-2</c:v>
                </c:pt>
                <c:pt idx="9">
                  <c:v>5.1339285714285698E-2</c:v>
                </c:pt>
                <c:pt idx="10">
                  <c:v>2.7901785714285705E-2</c:v>
                </c:pt>
                <c:pt idx="11">
                  <c:v>2.4553571428571407E-2</c:v>
                </c:pt>
                <c:pt idx="12">
                  <c:v>2.1205357142857106E-2</c:v>
                </c:pt>
                <c:pt idx="13">
                  <c:v>1.6741071428571407E-2</c:v>
                </c:pt>
                <c:pt idx="14">
                  <c:v>6.6964285714285702E-3</c:v>
                </c:pt>
                <c:pt idx="15">
                  <c:v>1.2276785714285704E-2</c:v>
                </c:pt>
                <c:pt idx="16">
                  <c:v>1.2276785714285704E-2</c:v>
                </c:pt>
                <c:pt idx="17">
                  <c:v>8.9285714285714229E-3</c:v>
                </c:pt>
                <c:pt idx="18">
                  <c:v>8.9285714285714229E-3</c:v>
                </c:pt>
                <c:pt idx="19">
                  <c:v>5.5803571428571421E-3</c:v>
                </c:pt>
                <c:pt idx="20">
                  <c:v>6.6964285714285702E-3</c:v>
                </c:pt>
              </c:numCache>
            </c:numRef>
          </c:val>
        </c:ser>
        <c:ser>
          <c:idx val="8"/>
          <c:order val="8"/>
          <c:tx>
            <c:strRef>
              <c:f>'tph-1(mg280)_A1_0.02_5%'!$J$104</c:f>
              <c:strCache>
                <c:ptCount val="1"/>
                <c:pt idx="0">
                  <c:v>thp-1(mg280)_A1_09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J$105:$J$125</c:f>
              <c:numCache>
                <c:formatCode>General</c:formatCode>
                <c:ptCount val="21"/>
                <c:pt idx="1">
                  <c:v>9.9264705882352922E-2</c:v>
                </c:pt>
                <c:pt idx="2">
                  <c:v>8.8235294117647162E-2</c:v>
                </c:pt>
                <c:pt idx="3">
                  <c:v>0.12132352941176502</c:v>
                </c:pt>
                <c:pt idx="4">
                  <c:v>6.9852941176470632E-2</c:v>
                </c:pt>
                <c:pt idx="5">
                  <c:v>9.3750000000000042E-2</c:v>
                </c:pt>
                <c:pt idx="6">
                  <c:v>6.6176470588235309E-2</c:v>
                </c:pt>
                <c:pt idx="7">
                  <c:v>5.8823529411764698E-2</c:v>
                </c:pt>
                <c:pt idx="8">
                  <c:v>5.5147058823529396E-2</c:v>
                </c:pt>
                <c:pt idx="9">
                  <c:v>5.5147058823529396E-2</c:v>
                </c:pt>
                <c:pt idx="10">
                  <c:v>5.1470588235294081E-2</c:v>
                </c:pt>
                <c:pt idx="11">
                  <c:v>3.3088235294117599E-2</c:v>
                </c:pt>
                <c:pt idx="12">
                  <c:v>1.8382352941176499E-2</c:v>
                </c:pt>
                <c:pt idx="13">
                  <c:v>1.8382352941176499E-2</c:v>
                </c:pt>
                <c:pt idx="14">
                  <c:v>1.1029411764705904E-2</c:v>
                </c:pt>
                <c:pt idx="15">
                  <c:v>9.1911764705882443E-3</c:v>
                </c:pt>
                <c:pt idx="16">
                  <c:v>3.676470588235291E-3</c:v>
                </c:pt>
                <c:pt idx="17">
                  <c:v>1.4705882352941199E-2</c:v>
                </c:pt>
                <c:pt idx="18">
                  <c:v>9.1911764705882443E-3</c:v>
                </c:pt>
                <c:pt idx="19">
                  <c:v>9.1911764705882443E-3</c:v>
                </c:pt>
                <c:pt idx="20">
                  <c:v>3.676470588235291E-3</c:v>
                </c:pt>
              </c:numCache>
            </c:numRef>
          </c:val>
        </c:ser>
        <c:ser>
          <c:idx val="9"/>
          <c:order val="9"/>
          <c:tx>
            <c:strRef>
              <c:f>'tph-1(mg280)_A1_0.02_5%'!$K$104</c:f>
              <c:strCache>
                <c:ptCount val="1"/>
                <c:pt idx="0">
                  <c:v>thp-1(mg280)_A1_10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K$105:$K$125</c:f>
              <c:numCache>
                <c:formatCode>General</c:formatCode>
                <c:ptCount val="21"/>
                <c:pt idx="1">
                  <c:v>9.4292803970223341E-2</c:v>
                </c:pt>
                <c:pt idx="2">
                  <c:v>8.1885856079404504E-2</c:v>
                </c:pt>
                <c:pt idx="3">
                  <c:v>8.9330024813895806E-2</c:v>
                </c:pt>
                <c:pt idx="4">
                  <c:v>8.1885856079404504E-2</c:v>
                </c:pt>
                <c:pt idx="5">
                  <c:v>6.9478908188585597E-2</c:v>
                </c:pt>
                <c:pt idx="6">
                  <c:v>7.196029776674942E-2</c:v>
                </c:pt>
                <c:pt idx="7">
                  <c:v>5.4590570719603021E-2</c:v>
                </c:pt>
                <c:pt idx="8">
                  <c:v>3.9702233250620299E-2</c:v>
                </c:pt>
                <c:pt idx="9">
                  <c:v>4.9627791563275403E-2</c:v>
                </c:pt>
                <c:pt idx="10">
                  <c:v>2.729528535980151E-2</c:v>
                </c:pt>
                <c:pt idx="11">
                  <c:v>2.4813895781637708E-2</c:v>
                </c:pt>
                <c:pt idx="12">
                  <c:v>2.4813895781637708E-2</c:v>
                </c:pt>
                <c:pt idx="13">
                  <c:v>1.4888337468982601E-2</c:v>
                </c:pt>
                <c:pt idx="14">
                  <c:v>1.9851116625310208E-2</c:v>
                </c:pt>
                <c:pt idx="15">
                  <c:v>2.4813895781637708E-2</c:v>
                </c:pt>
                <c:pt idx="16">
                  <c:v>7.4441687344913255E-3</c:v>
                </c:pt>
                <c:pt idx="17">
                  <c:v>1.4888337468982601E-2</c:v>
                </c:pt>
                <c:pt idx="18">
                  <c:v>1.2406947890818899E-2</c:v>
                </c:pt>
                <c:pt idx="19">
                  <c:v>7.4441687344913255E-3</c:v>
                </c:pt>
                <c:pt idx="20">
                  <c:v>7.4441687344913255E-3</c:v>
                </c:pt>
              </c:numCache>
            </c:numRef>
          </c:val>
        </c:ser>
        <c:ser>
          <c:idx val="10"/>
          <c:order val="10"/>
          <c:tx>
            <c:strRef>
              <c:f>'tph-1(mg280)_A1_0.02_5%'!$L$104</c:f>
              <c:strCache>
                <c:ptCount val="1"/>
                <c:pt idx="0">
                  <c:v>tph-1(mg280)_A1_11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L$105:$L$125</c:f>
              <c:numCache>
                <c:formatCode>General</c:formatCode>
                <c:ptCount val="21"/>
                <c:pt idx="1">
                  <c:v>9.4512195121951206E-2</c:v>
                </c:pt>
                <c:pt idx="2">
                  <c:v>0.100609756097561</c:v>
                </c:pt>
                <c:pt idx="3">
                  <c:v>0.10365853658536597</c:v>
                </c:pt>
                <c:pt idx="4">
                  <c:v>7.6219512195122005E-2</c:v>
                </c:pt>
                <c:pt idx="5">
                  <c:v>7.926829268292683E-2</c:v>
                </c:pt>
                <c:pt idx="6">
                  <c:v>5.4878048780487777E-2</c:v>
                </c:pt>
                <c:pt idx="7">
                  <c:v>6.7073170731707293E-2</c:v>
                </c:pt>
                <c:pt idx="8">
                  <c:v>4.8780487804878127E-2</c:v>
                </c:pt>
                <c:pt idx="9">
                  <c:v>1.5243902439024399E-2</c:v>
                </c:pt>
                <c:pt idx="10">
                  <c:v>1.5243902439024399E-2</c:v>
                </c:pt>
                <c:pt idx="11">
                  <c:v>1.8292682926829298E-2</c:v>
                </c:pt>
                <c:pt idx="12">
                  <c:v>1.8292682926829298E-2</c:v>
                </c:pt>
                <c:pt idx="13">
                  <c:v>9.1463414634146267E-3</c:v>
                </c:pt>
                <c:pt idx="14">
                  <c:v>1.5243902439024399E-2</c:v>
                </c:pt>
                <c:pt idx="15">
                  <c:v>1.5243902439024399E-2</c:v>
                </c:pt>
                <c:pt idx="16">
                  <c:v>2.7439024390243899E-2</c:v>
                </c:pt>
                <c:pt idx="17">
                  <c:v>1.21951219512195E-2</c:v>
                </c:pt>
                <c:pt idx="18">
                  <c:v>9.1463414634146267E-3</c:v>
                </c:pt>
                <c:pt idx="19">
                  <c:v>1.21951219512195E-2</c:v>
                </c:pt>
                <c:pt idx="20">
                  <c:v>1.21951219512195E-2</c:v>
                </c:pt>
              </c:numCache>
            </c:numRef>
          </c:val>
        </c:ser>
        <c:ser>
          <c:idx val="11"/>
          <c:order val="11"/>
          <c:tx>
            <c:strRef>
              <c:f>'tph-1(mg280)_A1_0.02_5%'!$M$104</c:f>
              <c:strCache>
                <c:ptCount val="1"/>
                <c:pt idx="0">
                  <c:v>tph-1(mg280)_A1_12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M$105:$M$125</c:f>
              <c:numCache>
                <c:formatCode>General</c:formatCode>
                <c:ptCount val="21"/>
                <c:pt idx="1">
                  <c:v>8.9285714285714246E-2</c:v>
                </c:pt>
                <c:pt idx="2">
                  <c:v>0.13265306122449</c:v>
                </c:pt>
                <c:pt idx="3">
                  <c:v>0.12755102040816294</c:v>
                </c:pt>
                <c:pt idx="4">
                  <c:v>0.102040816326531</c:v>
                </c:pt>
                <c:pt idx="5">
                  <c:v>7.9081632653061243E-2</c:v>
                </c:pt>
                <c:pt idx="6">
                  <c:v>5.8673469387755084E-2</c:v>
                </c:pt>
                <c:pt idx="7">
                  <c:v>5.8673469387755084E-2</c:v>
                </c:pt>
                <c:pt idx="8">
                  <c:v>3.31632653061225E-2</c:v>
                </c:pt>
                <c:pt idx="9">
                  <c:v>2.295918367346941E-2</c:v>
                </c:pt>
                <c:pt idx="10">
                  <c:v>4.3367346938775503E-2</c:v>
                </c:pt>
                <c:pt idx="11">
                  <c:v>2.5510204081632692E-2</c:v>
                </c:pt>
                <c:pt idx="12">
                  <c:v>1.7857142857142898E-2</c:v>
                </c:pt>
                <c:pt idx="13">
                  <c:v>1.7857142857142898E-2</c:v>
                </c:pt>
                <c:pt idx="14">
                  <c:v>1.2755102040816301E-2</c:v>
                </c:pt>
                <c:pt idx="15">
                  <c:v>3.8265306122449015E-2</c:v>
                </c:pt>
                <c:pt idx="16">
                  <c:v>5.1020408163265285E-3</c:v>
                </c:pt>
                <c:pt idx="17">
                  <c:v>1.2755102040816301E-2</c:v>
                </c:pt>
                <c:pt idx="18">
                  <c:v>2.5510204081632699E-3</c:v>
                </c:pt>
                <c:pt idx="19">
                  <c:v>1.0204081632653106E-2</c:v>
                </c:pt>
                <c:pt idx="20">
                  <c:v>2.5510204081632699E-3</c:v>
                </c:pt>
              </c:numCache>
            </c:numRef>
          </c:val>
        </c:ser>
        <c:ser>
          <c:idx val="12"/>
          <c:order val="12"/>
          <c:tx>
            <c:strRef>
              <c:f>'tph-1(mg280)_A1_0.02_5%'!$N$104</c:f>
              <c:strCache>
                <c:ptCount val="1"/>
                <c:pt idx="0">
                  <c:v>tph-1(mg280)_A1_13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N$105:$N$125</c:f>
              <c:numCache>
                <c:formatCode>General</c:formatCode>
                <c:ptCount val="21"/>
                <c:pt idx="1">
                  <c:v>9.2920353982300932E-2</c:v>
                </c:pt>
                <c:pt idx="2">
                  <c:v>8.6283185840707932E-2</c:v>
                </c:pt>
                <c:pt idx="3">
                  <c:v>9.7345132743362803E-2</c:v>
                </c:pt>
                <c:pt idx="4">
                  <c:v>0.11504424778761109</c:v>
                </c:pt>
                <c:pt idx="5">
                  <c:v>7.7433628318584094E-2</c:v>
                </c:pt>
                <c:pt idx="6">
                  <c:v>8.1858407079646034E-2</c:v>
                </c:pt>
                <c:pt idx="7">
                  <c:v>6.1946902654867297E-2</c:v>
                </c:pt>
                <c:pt idx="8">
                  <c:v>5.9734513274336334E-2</c:v>
                </c:pt>
                <c:pt idx="9">
                  <c:v>2.4336283185840701E-2</c:v>
                </c:pt>
                <c:pt idx="10">
                  <c:v>4.6460176991150397E-2</c:v>
                </c:pt>
                <c:pt idx="11">
                  <c:v>4.4247787610619496E-2</c:v>
                </c:pt>
                <c:pt idx="12">
                  <c:v>1.7699115044247801E-2</c:v>
                </c:pt>
                <c:pt idx="13">
                  <c:v>2.212389380530971E-2</c:v>
                </c:pt>
                <c:pt idx="14">
                  <c:v>3.5398230088495602E-2</c:v>
                </c:pt>
                <c:pt idx="15">
                  <c:v>1.5486725663716809E-2</c:v>
                </c:pt>
                <c:pt idx="16">
                  <c:v>1.5486725663716809E-2</c:v>
                </c:pt>
                <c:pt idx="17">
                  <c:v>2.2123893805309713E-3</c:v>
                </c:pt>
                <c:pt idx="18">
                  <c:v>8.8495575221238972E-3</c:v>
                </c:pt>
                <c:pt idx="19">
                  <c:v>4.4247787610619503E-3</c:v>
                </c:pt>
                <c:pt idx="20">
                  <c:v>2.2123893805309713E-3</c:v>
                </c:pt>
              </c:numCache>
            </c:numRef>
          </c:val>
        </c:ser>
        <c:ser>
          <c:idx val="13"/>
          <c:order val="13"/>
          <c:tx>
            <c:strRef>
              <c:f>'tph-1(mg280)_A1_0.02_5%'!$O$104</c:f>
              <c:strCache>
                <c:ptCount val="1"/>
                <c:pt idx="0">
                  <c:v>tph-1(mg280)_A1_14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O$105:$O$125</c:f>
              <c:numCache>
                <c:formatCode>General</c:formatCode>
                <c:ptCount val="21"/>
                <c:pt idx="1">
                  <c:v>6.4371257485029906E-2</c:v>
                </c:pt>
                <c:pt idx="2">
                  <c:v>8.8323353293413231E-2</c:v>
                </c:pt>
                <c:pt idx="3">
                  <c:v>0.10329341317365304</c:v>
                </c:pt>
                <c:pt idx="4">
                  <c:v>0.109281437125749</c:v>
                </c:pt>
                <c:pt idx="5">
                  <c:v>0.112275449101796</c:v>
                </c:pt>
                <c:pt idx="6">
                  <c:v>7.1856287425149726E-2</c:v>
                </c:pt>
                <c:pt idx="7">
                  <c:v>6.2874251497005998E-2</c:v>
                </c:pt>
                <c:pt idx="8">
                  <c:v>5.5389221556886227E-2</c:v>
                </c:pt>
                <c:pt idx="9">
                  <c:v>4.7904191616766512E-2</c:v>
                </c:pt>
                <c:pt idx="10">
                  <c:v>4.0419161676646713E-2</c:v>
                </c:pt>
                <c:pt idx="11">
                  <c:v>4.0419161676646713E-2</c:v>
                </c:pt>
                <c:pt idx="12">
                  <c:v>2.2455089820359306E-2</c:v>
                </c:pt>
                <c:pt idx="13">
                  <c:v>1.04790419161677E-2</c:v>
                </c:pt>
                <c:pt idx="14">
                  <c:v>8.9820359281437175E-3</c:v>
                </c:pt>
                <c:pt idx="15">
                  <c:v>1.7964071856287407E-2</c:v>
                </c:pt>
                <c:pt idx="16">
                  <c:v>7.4850299401197631E-3</c:v>
                </c:pt>
                <c:pt idx="17">
                  <c:v>1.1976047904191595E-2</c:v>
                </c:pt>
                <c:pt idx="18">
                  <c:v>1.04790419161677E-2</c:v>
                </c:pt>
                <c:pt idx="19">
                  <c:v>1.49700598802395E-2</c:v>
                </c:pt>
                <c:pt idx="20">
                  <c:v>5.9880239520958122E-3</c:v>
                </c:pt>
              </c:numCache>
            </c:numRef>
          </c:val>
        </c:ser>
        <c:ser>
          <c:idx val="14"/>
          <c:order val="14"/>
          <c:tx>
            <c:strRef>
              <c:f>'tph-1(mg280)_A1_0.02_5%'!$P$104</c:f>
              <c:strCache>
                <c:ptCount val="1"/>
                <c:pt idx="0">
                  <c:v>tph-1(mg280)_A1_15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P$105:$P$125</c:f>
              <c:numCache>
                <c:formatCode>General</c:formatCode>
                <c:ptCount val="21"/>
                <c:pt idx="1">
                  <c:v>0.11827956989247297</c:v>
                </c:pt>
                <c:pt idx="2">
                  <c:v>0.13364055299539199</c:v>
                </c:pt>
                <c:pt idx="3">
                  <c:v>0.121351766513057</c:v>
                </c:pt>
                <c:pt idx="4">
                  <c:v>0.10445468509984597</c:v>
                </c:pt>
                <c:pt idx="5">
                  <c:v>7.83410138248848E-2</c:v>
                </c:pt>
                <c:pt idx="6">
                  <c:v>7.9877112135176634E-2</c:v>
                </c:pt>
                <c:pt idx="7">
                  <c:v>6.2980030721966229E-2</c:v>
                </c:pt>
                <c:pt idx="8">
                  <c:v>2.9185867895545298E-2</c:v>
                </c:pt>
                <c:pt idx="9">
                  <c:v>3.2258064516129011E-2</c:v>
                </c:pt>
                <c:pt idx="10">
                  <c:v>2.1505376344085999E-2</c:v>
                </c:pt>
                <c:pt idx="11">
                  <c:v>1.5360983102918601E-2</c:v>
                </c:pt>
                <c:pt idx="12">
                  <c:v>1.2288786482334899E-2</c:v>
                </c:pt>
                <c:pt idx="13">
                  <c:v>6.1443932411674304E-3</c:v>
                </c:pt>
                <c:pt idx="14">
                  <c:v>1.2288786482334899E-2</c:v>
                </c:pt>
                <c:pt idx="15">
                  <c:v>3.07219662058372E-3</c:v>
                </c:pt>
                <c:pt idx="16">
                  <c:v>1.0752688172042998E-2</c:v>
                </c:pt>
                <c:pt idx="17">
                  <c:v>1.5360983102918604E-3</c:v>
                </c:pt>
                <c:pt idx="18">
                  <c:v>1.3824884792626705E-2</c:v>
                </c:pt>
                <c:pt idx="19">
                  <c:v>3.07219662058372E-3</c:v>
                </c:pt>
                <c:pt idx="20">
                  <c:v>4.6082949308755804E-3</c:v>
                </c:pt>
              </c:numCache>
            </c:numRef>
          </c:val>
        </c:ser>
        <c:ser>
          <c:idx val="15"/>
          <c:order val="15"/>
          <c:tx>
            <c:strRef>
              <c:f>'tph-1(mg280)_A1_0.02_5%'!$Q$104</c:f>
              <c:strCache>
                <c:ptCount val="1"/>
                <c:pt idx="0">
                  <c:v>tph-1(mg280)_A1_16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Q$105:$Q$125</c:f>
              <c:numCache>
                <c:formatCode>General</c:formatCode>
                <c:ptCount val="21"/>
                <c:pt idx="1">
                  <c:v>0.10733452593917703</c:v>
                </c:pt>
                <c:pt idx="2">
                  <c:v>0.10017889087656498</c:v>
                </c:pt>
                <c:pt idx="3">
                  <c:v>0.10375670840787103</c:v>
                </c:pt>
                <c:pt idx="4">
                  <c:v>8.7656529516994638E-2</c:v>
                </c:pt>
                <c:pt idx="5">
                  <c:v>8.7656529516994638E-2</c:v>
                </c:pt>
                <c:pt idx="6">
                  <c:v>7.1556350626118106E-2</c:v>
                </c:pt>
                <c:pt idx="7">
                  <c:v>5.0089445438282698E-2</c:v>
                </c:pt>
                <c:pt idx="8">
                  <c:v>2.1466905187835408E-2</c:v>
                </c:pt>
                <c:pt idx="9">
                  <c:v>3.3989266547406097E-2</c:v>
                </c:pt>
                <c:pt idx="10">
                  <c:v>2.8622540250447193E-2</c:v>
                </c:pt>
                <c:pt idx="11">
                  <c:v>1.96779964221825E-2</c:v>
                </c:pt>
                <c:pt idx="12">
                  <c:v>8.944543828264765E-3</c:v>
                </c:pt>
                <c:pt idx="13">
                  <c:v>1.96779964221825E-2</c:v>
                </c:pt>
                <c:pt idx="14">
                  <c:v>1.96779964221825E-2</c:v>
                </c:pt>
                <c:pt idx="15">
                  <c:v>1.4311270125223598E-2</c:v>
                </c:pt>
                <c:pt idx="16">
                  <c:v>8.944543828264765E-3</c:v>
                </c:pt>
                <c:pt idx="17">
                  <c:v>1.0733452593917704E-2</c:v>
                </c:pt>
                <c:pt idx="18">
                  <c:v>1.0733452593917704E-2</c:v>
                </c:pt>
                <c:pt idx="19">
                  <c:v>7.1556350626118103E-3</c:v>
                </c:pt>
                <c:pt idx="20">
                  <c:v>1.4311270125223598E-2</c:v>
                </c:pt>
              </c:numCache>
            </c:numRef>
          </c:val>
        </c:ser>
        <c:ser>
          <c:idx val="16"/>
          <c:order val="16"/>
          <c:tx>
            <c:strRef>
              <c:f>'tph-1(mg280)_A1_0.02_5%'!$R$104</c:f>
              <c:strCache>
                <c:ptCount val="1"/>
                <c:pt idx="0">
                  <c:v>tph-1(mg280)_A1_17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R$105:$R$125</c:f>
              <c:numCache>
                <c:formatCode>General</c:formatCode>
                <c:ptCount val="21"/>
                <c:pt idx="1">
                  <c:v>8.5778781038374663E-2</c:v>
                </c:pt>
                <c:pt idx="2">
                  <c:v>0.10383747178329603</c:v>
                </c:pt>
                <c:pt idx="3">
                  <c:v>5.8690744920993229E-2</c:v>
                </c:pt>
                <c:pt idx="4">
                  <c:v>9.0293453724604997E-2</c:v>
                </c:pt>
                <c:pt idx="5">
                  <c:v>6.0948081264108403E-2</c:v>
                </c:pt>
                <c:pt idx="6">
                  <c:v>4.0632054176072185E-2</c:v>
                </c:pt>
                <c:pt idx="7">
                  <c:v>6.3205417607223494E-2</c:v>
                </c:pt>
                <c:pt idx="8">
                  <c:v>5.8690744920993229E-2</c:v>
                </c:pt>
                <c:pt idx="9">
                  <c:v>6.5462753950338654E-2</c:v>
                </c:pt>
                <c:pt idx="10">
                  <c:v>2.7088036117381507E-2</c:v>
                </c:pt>
                <c:pt idx="11">
                  <c:v>3.1602708803611712E-2</c:v>
                </c:pt>
                <c:pt idx="12">
                  <c:v>2.0316027088036107E-2</c:v>
                </c:pt>
                <c:pt idx="13">
                  <c:v>3.1602708803611712E-2</c:v>
                </c:pt>
                <c:pt idx="14">
                  <c:v>1.5801354401805901E-2</c:v>
                </c:pt>
                <c:pt idx="15">
                  <c:v>1.8058690744920999E-2</c:v>
                </c:pt>
                <c:pt idx="16">
                  <c:v>2.0316027088036107E-2</c:v>
                </c:pt>
                <c:pt idx="17">
                  <c:v>1.8058690744920999E-2</c:v>
                </c:pt>
                <c:pt idx="18">
                  <c:v>2.0316027088036107E-2</c:v>
                </c:pt>
                <c:pt idx="19">
                  <c:v>1.35440180586907E-2</c:v>
                </c:pt>
                <c:pt idx="20">
                  <c:v>6.7720090293453732E-3</c:v>
                </c:pt>
              </c:numCache>
            </c:numRef>
          </c:val>
        </c:ser>
        <c:ser>
          <c:idx val="17"/>
          <c:order val="17"/>
          <c:tx>
            <c:strRef>
              <c:f>'tph-1(mg280)_A1_0.02_5%'!$S$104</c:f>
              <c:strCache>
                <c:ptCount val="1"/>
                <c:pt idx="0">
                  <c:v>tph-1(mg280)_A1_18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S$105:$S$125</c:f>
              <c:numCache>
                <c:formatCode>General</c:formatCode>
                <c:ptCount val="21"/>
                <c:pt idx="1">
                  <c:v>0.110181311018131</c:v>
                </c:pt>
                <c:pt idx="2">
                  <c:v>8.7866108786610941E-2</c:v>
                </c:pt>
                <c:pt idx="3">
                  <c:v>9.7629009762901023E-2</c:v>
                </c:pt>
                <c:pt idx="4">
                  <c:v>0.13389121338912099</c:v>
                </c:pt>
                <c:pt idx="5">
                  <c:v>0.10041841004184097</c:v>
                </c:pt>
                <c:pt idx="6">
                  <c:v>7.1129707112970703E-2</c:v>
                </c:pt>
                <c:pt idx="7">
                  <c:v>5.4393305439330519E-2</c:v>
                </c:pt>
                <c:pt idx="8">
                  <c:v>4.1841004184100396E-2</c:v>
                </c:pt>
                <c:pt idx="9">
                  <c:v>4.4630404463040417E-2</c:v>
                </c:pt>
                <c:pt idx="10">
                  <c:v>3.0683403068340314E-2</c:v>
                </c:pt>
                <c:pt idx="11">
                  <c:v>1.6736401673640201E-2</c:v>
                </c:pt>
                <c:pt idx="12">
                  <c:v>1.9525801952580208E-2</c:v>
                </c:pt>
                <c:pt idx="13">
                  <c:v>2.0920502092050198E-2</c:v>
                </c:pt>
                <c:pt idx="14">
                  <c:v>1.9525801952580208E-2</c:v>
                </c:pt>
                <c:pt idx="15">
                  <c:v>9.7629009762901005E-3</c:v>
                </c:pt>
                <c:pt idx="16">
                  <c:v>1.1157601115760104E-2</c:v>
                </c:pt>
                <c:pt idx="17">
                  <c:v>1.3947001394700108E-2</c:v>
                </c:pt>
                <c:pt idx="18">
                  <c:v>8.3682008368200847E-3</c:v>
                </c:pt>
                <c:pt idx="19">
                  <c:v>8.3682008368200847E-3</c:v>
                </c:pt>
                <c:pt idx="20">
                  <c:v>9.7629009762901005E-3</c:v>
                </c:pt>
              </c:numCache>
            </c:numRef>
          </c:val>
        </c:ser>
        <c:ser>
          <c:idx val="18"/>
          <c:order val="18"/>
          <c:tx>
            <c:strRef>
              <c:f>'tph-1(mg280)_A1_0.02_5%'!$T$104</c:f>
              <c:strCache>
                <c:ptCount val="1"/>
                <c:pt idx="0">
                  <c:v>tph-1(mg280)_A1_19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T$105:$T$125</c:f>
              <c:numCache>
                <c:formatCode>General</c:formatCode>
                <c:ptCount val="21"/>
                <c:pt idx="1">
                  <c:v>6.2737642585551312E-2</c:v>
                </c:pt>
                <c:pt idx="2">
                  <c:v>8.5551330798479208E-2</c:v>
                </c:pt>
                <c:pt idx="3">
                  <c:v>0.10266159695817505</c:v>
                </c:pt>
                <c:pt idx="4">
                  <c:v>0.10741444866920202</c:v>
                </c:pt>
                <c:pt idx="5">
                  <c:v>0.10646387832699603</c:v>
                </c:pt>
                <c:pt idx="6">
                  <c:v>7.224334600760457E-2</c:v>
                </c:pt>
                <c:pt idx="7">
                  <c:v>6.84410646387833E-2</c:v>
                </c:pt>
                <c:pt idx="8">
                  <c:v>4.0874524714828914E-2</c:v>
                </c:pt>
                <c:pt idx="9">
                  <c:v>5.6083650190114097E-2</c:v>
                </c:pt>
                <c:pt idx="10">
                  <c:v>4.6577946768060763E-2</c:v>
                </c:pt>
                <c:pt idx="11">
                  <c:v>3.6121673003802299E-2</c:v>
                </c:pt>
                <c:pt idx="12">
                  <c:v>2.75665399239544E-2</c:v>
                </c:pt>
                <c:pt idx="13">
                  <c:v>1.9011406844106505E-2</c:v>
                </c:pt>
                <c:pt idx="14">
                  <c:v>2.4714828897338385E-2</c:v>
                </c:pt>
                <c:pt idx="15">
                  <c:v>1.7110266159695794E-2</c:v>
                </c:pt>
                <c:pt idx="16">
                  <c:v>1.6159695817490501E-2</c:v>
                </c:pt>
                <c:pt idx="17">
                  <c:v>1.8060836501901101E-2</c:v>
                </c:pt>
                <c:pt idx="18">
                  <c:v>1.9011406844106505E-3</c:v>
                </c:pt>
                <c:pt idx="19">
                  <c:v>5.703422053231942E-3</c:v>
                </c:pt>
                <c:pt idx="20">
                  <c:v>6.653992395437262E-3</c:v>
                </c:pt>
              </c:numCache>
            </c:numRef>
          </c:val>
        </c:ser>
        <c:ser>
          <c:idx val="19"/>
          <c:order val="19"/>
          <c:tx>
            <c:strRef>
              <c:f>'tph-1(mg280)_A1_0.02_5%'!$U$104</c:f>
              <c:strCache>
                <c:ptCount val="1"/>
                <c:pt idx="0">
                  <c:v>tph-1(mg280)_A1_20</c:v>
                </c:pt>
              </c:strCache>
            </c:strRef>
          </c:tx>
          <c:marker>
            <c:symbol val="none"/>
          </c:marker>
          <c:cat>
            <c:numRef>
              <c:f>'tph-1(mg280)_A1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tph-1(mg280)_A1_0.02_5%'!$U$105:$U$125</c:f>
              <c:numCache>
                <c:formatCode>General</c:formatCode>
                <c:ptCount val="21"/>
                <c:pt idx="1">
                  <c:v>8.141592920353978E-2</c:v>
                </c:pt>
                <c:pt idx="2">
                  <c:v>0.10442477876106206</c:v>
                </c:pt>
                <c:pt idx="3">
                  <c:v>0.10265486725663703</c:v>
                </c:pt>
                <c:pt idx="4">
                  <c:v>9.0265486725663729E-2</c:v>
                </c:pt>
                <c:pt idx="5">
                  <c:v>8.6725663716814241E-2</c:v>
                </c:pt>
                <c:pt idx="6">
                  <c:v>7.787610619469032E-2</c:v>
                </c:pt>
                <c:pt idx="7">
                  <c:v>6.5486725663716813E-2</c:v>
                </c:pt>
                <c:pt idx="8">
                  <c:v>4.0707964601769897E-2</c:v>
                </c:pt>
                <c:pt idx="9">
                  <c:v>5.1327433628318618E-2</c:v>
                </c:pt>
                <c:pt idx="10">
                  <c:v>3.5398230088495602E-2</c:v>
                </c:pt>
                <c:pt idx="11">
                  <c:v>2.4778761061946892E-2</c:v>
                </c:pt>
                <c:pt idx="12">
                  <c:v>2.4778761061946892E-2</c:v>
                </c:pt>
                <c:pt idx="13">
                  <c:v>2.1238938053097314E-2</c:v>
                </c:pt>
                <c:pt idx="14">
                  <c:v>2.3008849557522099E-2</c:v>
                </c:pt>
                <c:pt idx="15">
                  <c:v>1.4159292035398192E-2</c:v>
                </c:pt>
                <c:pt idx="16">
                  <c:v>1.0619469026548698E-2</c:v>
                </c:pt>
                <c:pt idx="17">
                  <c:v>1.7699115044247805E-3</c:v>
                </c:pt>
                <c:pt idx="18">
                  <c:v>1.2389380530973498E-2</c:v>
                </c:pt>
                <c:pt idx="19">
                  <c:v>7.0796460176991141E-3</c:v>
                </c:pt>
                <c:pt idx="20">
                  <c:v>3.5398230088495609E-3</c:v>
                </c:pt>
              </c:numCache>
            </c:numRef>
          </c:val>
        </c:ser>
        <c:marker val="1"/>
        <c:axId val="161623040"/>
        <c:axId val="161657600"/>
      </c:lineChart>
      <c:catAx>
        <c:axId val="161623040"/>
        <c:scaling>
          <c:orientation val="minMax"/>
        </c:scaling>
        <c:axPos val="b"/>
        <c:numFmt formatCode="0.0_ " sourceLinked="1"/>
        <c:tickLblPos val="nextTo"/>
        <c:crossAx val="161657600"/>
        <c:crosses val="autoZero"/>
        <c:auto val="1"/>
        <c:lblAlgn val="ctr"/>
        <c:lblOffset val="100"/>
        <c:tickLblSkip val="5"/>
        <c:tickMarkSkip val="5"/>
      </c:catAx>
      <c:valAx>
        <c:axId val="16165760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1623040"/>
        <c:crosses val="autoZero"/>
        <c:crossBetween val="between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</a:t>
            </a:r>
            <a:r>
              <a:rPr lang="en-US" altLang="ja-JP" sz="1400" b="0" baseline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A5_0.02_5%'!$B$104</c:f>
              <c:strCache>
                <c:ptCount val="1"/>
                <c:pt idx="0">
                  <c:v>N2_A5_001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B$105:$B$125</c:f>
              <c:numCache>
                <c:formatCode>General</c:formatCode>
                <c:ptCount val="21"/>
                <c:pt idx="1">
                  <c:v>6.8437180796731403E-2</c:v>
                </c:pt>
                <c:pt idx="2">
                  <c:v>7.150153217568947E-2</c:v>
                </c:pt>
                <c:pt idx="3">
                  <c:v>5.3115423901940857E-2</c:v>
                </c:pt>
                <c:pt idx="4">
                  <c:v>5.5158324821246274E-2</c:v>
                </c:pt>
                <c:pt idx="5">
                  <c:v>3.8815117466802926E-2</c:v>
                </c:pt>
                <c:pt idx="6">
                  <c:v>4.0858018386108301E-2</c:v>
                </c:pt>
                <c:pt idx="7">
                  <c:v>3.2686414708886599E-2</c:v>
                </c:pt>
                <c:pt idx="8">
                  <c:v>3.2686414708886599E-2</c:v>
                </c:pt>
                <c:pt idx="9">
                  <c:v>3.0643513789581227E-2</c:v>
                </c:pt>
                <c:pt idx="10">
                  <c:v>4.49438202247191E-2</c:v>
                </c:pt>
                <c:pt idx="11">
                  <c:v>2.9622063329928498E-2</c:v>
                </c:pt>
                <c:pt idx="12">
                  <c:v>3.9836567926455631E-2</c:v>
                </c:pt>
                <c:pt idx="13">
                  <c:v>4.1879468845760985E-2</c:v>
                </c:pt>
                <c:pt idx="14">
                  <c:v>4.3922369765066395E-2</c:v>
                </c:pt>
                <c:pt idx="15">
                  <c:v>4.3922369765066395E-2</c:v>
                </c:pt>
                <c:pt idx="16">
                  <c:v>4.0858018386108301E-2</c:v>
                </c:pt>
                <c:pt idx="17">
                  <c:v>4.2900919305413739E-2</c:v>
                </c:pt>
                <c:pt idx="18">
                  <c:v>2.7579162410623165E-2</c:v>
                </c:pt>
                <c:pt idx="19">
                  <c:v>2.2471910112359654E-2</c:v>
                </c:pt>
                <c:pt idx="20">
                  <c:v>2.2471910112359654E-2</c:v>
                </c:pt>
              </c:numCache>
            </c:numRef>
          </c:val>
        </c:ser>
        <c:ser>
          <c:idx val="1"/>
          <c:order val="1"/>
          <c:tx>
            <c:strRef>
              <c:f>'N2 A5_0.02_5%'!$C$104</c:f>
              <c:strCache>
                <c:ptCount val="1"/>
                <c:pt idx="0">
                  <c:v>N2_A5_003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C$105:$C$125</c:f>
              <c:numCache>
                <c:formatCode>General</c:formatCode>
                <c:ptCount val="21"/>
                <c:pt idx="1">
                  <c:v>0.12886597938144301</c:v>
                </c:pt>
                <c:pt idx="2">
                  <c:v>0.10395189003436391</c:v>
                </c:pt>
                <c:pt idx="3">
                  <c:v>7.5601374570446703E-2</c:v>
                </c:pt>
                <c:pt idx="4">
                  <c:v>4.9828178694158065E-2</c:v>
                </c:pt>
                <c:pt idx="5">
                  <c:v>3.3505154639175298E-2</c:v>
                </c:pt>
                <c:pt idx="6">
                  <c:v>2.663230240549834E-2</c:v>
                </c:pt>
                <c:pt idx="7">
                  <c:v>3.09278350515464E-2</c:v>
                </c:pt>
                <c:pt idx="8">
                  <c:v>2.0618556701030875E-2</c:v>
                </c:pt>
                <c:pt idx="9">
                  <c:v>2.663230240549834E-2</c:v>
                </c:pt>
                <c:pt idx="10">
                  <c:v>1.6323024054982819E-2</c:v>
                </c:pt>
                <c:pt idx="11">
                  <c:v>1.8900343642611714E-2</c:v>
                </c:pt>
                <c:pt idx="12">
                  <c:v>1.28865979381443E-2</c:v>
                </c:pt>
                <c:pt idx="13">
                  <c:v>1.9759450171821302E-2</c:v>
                </c:pt>
                <c:pt idx="14">
                  <c:v>1.6323024054982819E-2</c:v>
                </c:pt>
                <c:pt idx="15">
                  <c:v>2.0618556701030875E-2</c:v>
                </c:pt>
                <c:pt idx="16">
                  <c:v>1.5463917525773198E-2</c:v>
                </c:pt>
                <c:pt idx="17">
                  <c:v>9.4501718213058396E-3</c:v>
                </c:pt>
                <c:pt idx="18">
                  <c:v>7.731958762886606E-3</c:v>
                </c:pt>
                <c:pt idx="19">
                  <c:v>4.2955326460481086E-3</c:v>
                </c:pt>
                <c:pt idx="20">
                  <c:v>8.5910652920962284E-4</c:v>
                </c:pt>
              </c:numCache>
            </c:numRef>
          </c:val>
        </c:ser>
        <c:ser>
          <c:idx val="2"/>
          <c:order val="2"/>
          <c:tx>
            <c:strRef>
              <c:f>'N2 A5_0.02_5%'!$D$104</c:f>
              <c:strCache>
                <c:ptCount val="1"/>
                <c:pt idx="0">
                  <c:v>N2_A5_004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D$105:$D$125</c:f>
              <c:numCache>
                <c:formatCode>General</c:formatCode>
                <c:ptCount val="21"/>
                <c:pt idx="1">
                  <c:v>9.2666666666666772E-2</c:v>
                </c:pt>
                <c:pt idx="2">
                  <c:v>7.6666666666666702E-2</c:v>
                </c:pt>
                <c:pt idx="3">
                  <c:v>8.6666666666666808E-2</c:v>
                </c:pt>
                <c:pt idx="4">
                  <c:v>8.0666666666666775E-2</c:v>
                </c:pt>
                <c:pt idx="5">
                  <c:v>6.6666666666666693E-2</c:v>
                </c:pt>
                <c:pt idx="6">
                  <c:v>5.9333333333333398E-2</c:v>
                </c:pt>
                <c:pt idx="7">
                  <c:v>4.3333333333333363E-2</c:v>
                </c:pt>
                <c:pt idx="8">
                  <c:v>4.5999999999999999E-2</c:v>
                </c:pt>
                <c:pt idx="9">
                  <c:v>3.8666666666666703E-2</c:v>
                </c:pt>
                <c:pt idx="10">
                  <c:v>3.2666666666666698E-2</c:v>
                </c:pt>
                <c:pt idx="11">
                  <c:v>4.0666666666666712E-2</c:v>
                </c:pt>
                <c:pt idx="12">
                  <c:v>3.2666666666666698E-2</c:v>
                </c:pt>
                <c:pt idx="13">
                  <c:v>2.6666666666666717E-2</c:v>
                </c:pt>
                <c:pt idx="14">
                  <c:v>3.2666666666666698E-2</c:v>
                </c:pt>
                <c:pt idx="15">
                  <c:v>3.4000000000000002E-2</c:v>
                </c:pt>
                <c:pt idx="16">
                  <c:v>1.7333333333333301E-2</c:v>
                </c:pt>
                <c:pt idx="17">
                  <c:v>1.4E-2</c:v>
                </c:pt>
                <c:pt idx="18">
                  <c:v>1.7333333333333301E-2</c:v>
                </c:pt>
                <c:pt idx="19">
                  <c:v>1.5333333333333301E-2</c:v>
                </c:pt>
                <c:pt idx="20">
                  <c:v>9.3333333333333376E-3</c:v>
                </c:pt>
              </c:numCache>
            </c:numRef>
          </c:val>
        </c:ser>
        <c:ser>
          <c:idx val="3"/>
          <c:order val="3"/>
          <c:tx>
            <c:strRef>
              <c:f>'N2 A5_0.02_5%'!$E$104</c:f>
              <c:strCache>
                <c:ptCount val="1"/>
                <c:pt idx="0">
                  <c:v>N2_A5_40_30_01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E$105:$E$125</c:f>
              <c:numCache>
                <c:formatCode>General</c:formatCode>
                <c:ptCount val="21"/>
                <c:pt idx="1">
                  <c:v>8.4507042253521222E-2</c:v>
                </c:pt>
                <c:pt idx="2">
                  <c:v>0.139280125195618</c:v>
                </c:pt>
                <c:pt idx="3">
                  <c:v>0.10798122065727705</c:v>
                </c:pt>
                <c:pt idx="4">
                  <c:v>0.12676056338028197</c:v>
                </c:pt>
                <c:pt idx="5">
                  <c:v>9.3896713615023525E-2</c:v>
                </c:pt>
                <c:pt idx="6">
                  <c:v>5.1643192488262837E-2</c:v>
                </c:pt>
                <c:pt idx="7">
                  <c:v>4.69483568075117E-2</c:v>
                </c:pt>
                <c:pt idx="8">
                  <c:v>4.3818466353677636E-2</c:v>
                </c:pt>
                <c:pt idx="9">
                  <c:v>4.2253521126760597E-2</c:v>
                </c:pt>
                <c:pt idx="10">
                  <c:v>2.8169014084506998E-2</c:v>
                </c:pt>
                <c:pt idx="11">
                  <c:v>2.8169014084506998E-2</c:v>
                </c:pt>
                <c:pt idx="12">
                  <c:v>2.5039123630672899E-2</c:v>
                </c:pt>
                <c:pt idx="13">
                  <c:v>2.03442879499218E-2</c:v>
                </c:pt>
                <c:pt idx="14">
                  <c:v>1.5649452269170614E-2</c:v>
                </c:pt>
                <c:pt idx="15">
                  <c:v>1.4084507042253508E-2</c:v>
                </c:pt>
                <c:pt idx="16">
                  <c:v>1.2519561815336503E-2</c:v>
                </c:pt>
                <c:pt idx="17">
                  <c:v>1.2519561815336503E-2</c:v>
                </c:pt>
                <c:pt idx="18">
                  <c:v>9.3896713615023528E-3</c:v>
                </c:pt>
                <c:pt idx="19">
                  <c:v>4.6948356807511703E-3</c:v>
                </c:pt>
                <c:pt idx="20">
                  <c:v>4.6948356807511703E-3</c:v>
                </c:pt>
              </c:numCache>
            </c:numRef>
          </c:val>
        </c:ser>
        <c:ser>
          <c:idx val="4"/>
          <c:order val="4"/>
          <c:tx>
            <c:strRef>
              <c:f>'N2 A5_0.02_5%'!$F$104</c:f>
              <c:strCache>
                <c:ptCount val="1"/>
                <c:pt idx="0">
                  <c:v>N2_A5_40_30_02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F$105:$F$125</c:f>
              <c:numCache>
                <c:formatCode>General</c:formatCode>
                <c:ptCount val="21"/>
                <c:pt idx="1">
                  <c:v>0.13021939136588812</c:v>
                </c:pt>
                <c:pt idx="2">
                  <c:v>0.11252653927813211</c:v>
                </c:pt>
                <c:pt idx="3">
                  <c:v>0.10898796886058</c:v>
                </c:pt>
                <c:pt idx="4">
                  <c:v>7.7848549186128796E-2</c:v>
                </c:pt>
                <c:pt idx="5">
                  <c:v>4.6709129511677286E-2</c:v>
                </c:pt>
                <c:pt idx="6">
                  <c:v>3.8216560509554097E-2</c:v>
                </c:pt>
                <c:pt idx="7">
                  <c:v>3.2554847841472015E-2</c:v>
                </c:pt>
                <c:pt idx="8">
                  <c:v>1.9108280254777114E-2</c:v>
                </c:pt>
                <c:pt idx="9">
                  <c:v>3.7508846426043949E-2</c:v>
                </c:pt>
                <c:pt idx="10">
                  <c:v>3.3970276008492603E-2</c:v>
                </c:pt>
                <c:pt idx="11">
                  <c:v>2.4062278839348882E-2</c:v>
                </c:pt>
                <c:pt idx="12">
                  <c:v>2.1231422505307924E-2</c:v>
                </c:pt>
                <c:pt idx="13">
                  <c:v>2.4769992922859217E-2</c:v>
                </c:pt>
                <c:pt idx="14">
                  <c:v>1.9815994338287315E-2</c:v>
                </c:pt>
                <c:pt idx="15">
                  <c:v>1.6277423920736001E-2</c:v>
                </c:pt>
                <c:pt idx="16">
                  <c:v>9.9079971691436747E-3</c:v>
                </c:pt>
                <c:pt idx="17">
                  <c:v>1.0615711252653899E-2</c:v>
                </c:pt>
                <c:pt idx="18">
                  <c:v>6.3694267515923639E-3</c:v>
                </c:pt>
                <c:pt idx="19">
                  <c:v>1.4154281670205201E-3</c:v>
                </c:pt>
                <c:pt idx="20">
                  <c:v>2.8308563340410479E-3</c:v>
                </c:pt>
              </c:numCache>
            </c:numRef>
          </c:val>
        </c:ser>
        <c:ser>
          <c:idx val="5"/>
          <c:order val="5"/>
          <c:tx>
            <c:strRef>
              <c:f>'N2 A5_0.02_5%'!$G$104</c:f>
              <c:strCache>
                <c:ptCount val="1"/>
                <c:pt idx="0">
                  <c:v>N2_A5_40_30_04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G$105:$G$125</c:f>
              <c:numCache>
                <c:formatCode>General</c:formatCode>
                <c:ptCount val="21"/>
                <c:pt idx="1">
                  <c:v>0.11212121212121209</c:v>
                </c:pt>
                <c:pt idx="2">
                  <c:v>0.12272727272727312</c:v>
                </c:pt>
                <c:pt idx="3">
                  <c:v>9.6969696969697067E-2</c:v>
                </c:pt>
                <c:pt idx="4">
                  <c:v>8.8636363636363735E-2</c:v>
                </c:pt>
                <c:pt idx="5">
                  <c:v>8.3333333333333343E-2</c:v>
                </c:pt>
                <c:pt idx="6">
                  <c:v>5.3030303030302997E-2</c:v>
                </c:pt>
                <c:pt idx="7">
                  <c:v>4.3939393939393903E-2</c:v>
                </c:pt>
                <c:pt idx="8">
                  <c:v>4.6969696969697002E-2</c:v>
                </c:pt>
                <c:pt idx="9">
                  <c:v>3.1060606060606111E-2</c:v>
                </c:pt>
                <c:pt idx="10">
                  <c:v>3.03030303030303E-2</c:v>
                </c:pt>
                <c:pt idx="11">
                  <c:v>2.4242424242424197E-2</c:v>
                </c:pt>
                <c:pt idx="12">
                  <c:v>1.8939393939393898E-2</c:v>
                </c:pt>
                <c:pt idx="13">
                  <c:v>2.5757575757575812E-2</c:v>
                </c:pt>
                <c:pt idx="14">
                  <c:v>1.8181818181818212E-2</c:v>
                </c:pt>
                <c:pt idx="15">
                  <c:v>1.0606060606060601E-2</c:v>
                </c:pt>
                <c:pt idx="16">
                  <c:v>7.5757575757575838E-3</c:v>
                </c:pt>
                <c:pt idx="17">
                  <c:v>8.3333333333333297E-3</c:v>
                </c:pt>
                <c:pt idx="18">
                  <c:v>6.8181818181818196E-3</c:v>
                </c:pt>
                <c:pt idx="19">
                  <c:v>3.0303030303030299E-3</c:v>
                </c:pt>
                <c:pt idx="20">
                  <c:v>1.5151515151515217E-3</c:v>
                </c:pt>
              </c:numCache>
            </c:numRef>
          </c:val>
        </c:ser>
        <c:ser>
          <c:idx val="6"/>
          <c:order val="6"/>
          <c:tx>
            <c:strRef>
              <c:f>'N2 A5_0.02_5%'!$H$104</c:f>
              <c:strCache>
                <c:ptCount val="1"/>
                <c:pt idx="0">
                  <c:v>N2_REX_A5_01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H$105:$H$125</c:f>
              <c:numCache>
                <c:formatCode>General</c:formatCode>
                <c:ptCount val="21"/>
                <c:pt idx="1">
                  <c:v>0.15724381625441711</c:v>
                </c:pt>
                <c:pt idx="2">
                  <c:v>0.11778563015312107</c:v>
                </c:pt>
                <c:pt idx="3">
                  <c:v>8.5983510011778494E-2</c:v>
                </c:pt>
                <c:pt idx="4">
                  <c:v>5.7126030624263822E-2</c:v>
                </c:pt>
                <c:pt idx="5">
                  <c:v>3.6513545347467605E-2</c:v>
                </c:pt>
                <c:pt idx="6">
                  <c:v>2.41460541813899E-2</c:v>
                </c:pt>
                <c:pt idx="7">
                  <c:v>3.415783274440521E-2</c:v>
                </c:pt>
                <c:pt idx="8">
                  <c:v>2.5323910482921142E-2</c:v>
                </c:pt>
                <c:pt idx="9">
                  <c:v>2.5323910482921142E-2</c:v>
                </c:pt>
                <c:pt idx="10">
                  <c:v>2.944640753828031E-2</c:v>
                </c:pt>
                <c:pt idx="11">
                  <c:v>1.3545347467609001E-2</c:v>
                </c:pt>
                <c:pt idx="12">
                  <c:v>1.1189634864546499E-2</c:v>
                </c:pt>
                <c:pt idx="13">
                  <c:v>1.5312131919905809E-2</c:v>
                </c:pt>
                <c:pt idx="14">
                  <c:v>1.2367491166077701E-2</c:v>
                </c:pt>
                <c:pt idx="15">
                  <c:v>8.2449941107184902E-3</c:v>
                </c:pt>
                <c:pt idx="16">
                  <c:v>6.4782096584216804E-3</c:v>
                </c:pt>
                <c:pt idx="17">
                  <c:v>1.177856301531212E-3</c:v>
                </c:pt>
                <c:pt idx="18">
                  <c:v>4.7114252061248524E-3</c:v>
                </c:pt>
                <c:pt idx="19">
                  <c:v>1.177856301531212E-3</c:v>
                </c:pt>
                <c:pt idx="20">
                  <c:v>2.3557126030624301E-3</c:v>
                </c:pt>
              </c:numCache>
            </c:numRef>
          </c:val>
        </c:ser>
        <c:ser>
          <c:idx val="7"/>
          <c:order val="7"/>
          <c:tx>
            <c:strRef>
              <c:f>'N2 A5_0.02_5%'!$I$104</c:f>
              <c:strCache>
                <c:ptCount val="1"/>
                <c:pt idx="0">
                  <c:v>N2_REX_A5_02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I$105:$I$125</c:f>
              <c:numCache>
                <c:formatCode>General</c:formatCode>
                <c:ptCount val="21"/>
                <c:pt idx="1">
                  <c:v>8.9724607639917187E-2</c:v>
                </c:pt>
                <c:pt idx="2">
                  <c:v>0.110453064850459</c:v>
                </c:pt>
                <c:pt idx="3">
                  <c:v>0.111045306485046</c:v>
                </c:pt>
                <c:pt idx="4">
                  <c:v>9.7127628072253572E-2</c:v>
                </c:pt>
                <c:pt idx="5">
                  <c:v>6.7811667160201455E-2</c:v>
                </c:pt>
                <c:pt idx="6">
                  <c:v>5.0044418122593998E-2</c:v>
                </c:pt>
                <c:pt idx="7">
                  <c:v>4.5306485045898778E-2</c:v>
                </c:pt>
                <c:pt idx="8">
                  <c:v>4.501036422860534E-2</c:v>
                </c:pt>
                <c:pt idx="9">
                  <c:v>4.2345276872964202E-2</c:v>
                </c:pt>
                <c:pt idx="10">
                  <c:v>3.3757773171454002E-2</c:v>
                </c:pt>
                <c:pt idx="11">
                  <c:v>3.7015102161682002E-2</c:v>
                </c:pt>
                <c:pt idx="12">
                  <c:v>3.9384068700029612E-2</c:v>
                </c:pt>
                <c:pt idx="13">
                  <c:v>2.6354752739117599E-2</c:v>
                </c:pt>
                <c:pt idx="14">
                  <c:v>2.2505182114302601E-2</c:v>
                </c:pt>
                <c:pt idx="15">
                  <c:v>2.3689665383476523E-2</c:v>
                </c:pt>
                <c:pt idx="16">
                  <c:v>1.3325436778205501E-2</c:v>
                </c:pt>
                <c:pt idx="17">
                  <c:v>8.5875037015102195E-3</c:v>
                </c:pt>
                <c:pt idx="18">
                  <c:v>7.9952620669233102E-3</c:v>
                </c:pt>
                <c:pt idx="19">
                  <c:v>3.5534498075214735E-3</c:v>
                </c:pt>
                <c:pt idx="20">
                  <c:v>1.4806040864672801E-3</c:v>
                </c:pt>
              </c:numCache>
            </c:numRef>
          </c:val>
        </c:ser>
        <c:ser>
          <c:idx val="8"/>
          <c:order val="8"/>
          <c:tx>
            <c:strRef>
              <c:f>'N2 A5_0.02_5%'!$J$104</c:f>
              <c:strCache>
                <c:ptCount val="1"/>
                <c:pt idx="0">
                  <c:v>N2_REX_A5_04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J$105:$J$125</c:f>
              <c:numCache>
                <c:formatCode>General</c:formatCode>
                <c:ptCount val="21"/>
                <c:pt idx="1">
                  <c:v>0.11867152693398111</c:v>
                </c:pt>
                <c:pt idx="2">
                  <c:v>0.14337788578371788</c:v>
                </c:pt>
                <c:pt idx="3">
                  <c:v>0.12515188335358382</c:v>
                </c:pt>
                <c:pt idx="4">
                  <c:v>0.100445524503848</c:v>
                </c:pt>
                <c:pt idx="5">
                  <c:v>7.2904009720534596E-2</c:v>
                </c:pt>
                <c:pt idx="6">
                  <c:v>4.2932361279870414E-2</c:v>
                </c:pt>
                <c:pt idx="7">
                  <c:v>3.8882138517618528E-2</c:v>
                </c:pt>
                <c:pt idx="8">
                  <c:v>4.0097205346294004E-2</c:v>
                </c:pt>
                <c:pt idx="9">
                  <c:v>2.8756581611988661E-2</c:v>
                </c:pt>
                <c:pt idx="10">
                  <c:v>2.8351559335763474E-2</c:v>
                </c:pt>
                <c:pt idx="11">
                  <c:v>2.0656136087484806E-2</c:v>
                </c:pt>
                <c:pt idx="12">
                  <c:v>2.1871202916160442E-2</c:v>
                </c:pt>
                <c:pt idx="13">
                  <c:v>1.3770757391656509E-2</c:v>
                </c:pt>
                <c:pt idx="14">
                  <c:v>1.1745646010530601E-2</c:v>
                </c:pt>
                <c:pt idx="15">
                  <c:v>9.7205346294046355E-3</c:v>
                </c:pt>
                <c:pt idx="16">
                  <c:v>8.1004455245038548E-3</c:v>
                </c:pt>
                <c:pt idx="17">
                  <c:v>3.240178209801544E-3</c:v>
                </c:pt>
                <c:pt idx="18">
                  <c:v>2.8351559335763484E-3</c:v>
                </c:pt>
                <c:pt idx="19">
                  <c:v>1.2150668286755801E-3</c:v>
                </c:pt>
                <c:pt idx="20">
                  <c:v>1.2150668286755801E-3</c:v>
                </c:pt>
              </c:numCache>
            </c:numRef>
          </c:val>
        </c:ser>
        <c:ser>
          <c:idx val="9"/>
          <c:order val="9"/>
          <c:tx>
            <c:strRef>
              <c:f>'N2 A5_0.02_5%'!$K$104</c:f>
              <c:strCache>
                <c:ptCount val="1"/>
                <c:pt idx="0">
                  <c:v>N2_REX_A5_05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K$105:$K$125</c:f>
              <c:numCache>
                <c:formatCode>General</c:formatCode>
                <c:ptCount val="21"/>
                <c:pt idx="1">
                  <c:v>0.105008077544426</c:v>
                </c:pt>
                <c:pt idx="2">
                  <c:v>0.13893376413570299</c:v>
                </c:pt>
                <c:pt idx="3">
                  <c:v>0.13570274636510499</c:v>
                </c:pt>
                <c:pt idx="4">
                  <c:v>0.11470113085622009</c:v>
                </c:pt>
                <c:pt idx="5">
                  <c:v>8.8852988691437929E-2</c:v>
                </c:pt>
                <c:pt idx="6">
                  <c:v>5.8158319870759277E-2</c:v>
                </c:pt>
                <c:pt idx="7">
                  <c:v>5.65428109854604E-2</c:v>
                </c:pt>
                <c:pt idx="8">
                  <c:v>3.2310177705977425E-2</c:v>
                </c:pt>
                <c:pt idx="9">
                  <c:v>2.9079159935379611E-2</c:v>
                </c:pt>
                <c:pt idx="10">
                  <c:v>2.4232633279482999E-2</c:v>
                </c:pt>
                <c:pt idx="11">
                  <c:v>3.2310177705977425E-2</c:v>
                </c:pt>
                <c:pt idx="12">
                  <c:v>2.4232633279482999E-2</c:v>
                </c:pt>
                <c:pt idx="13">
                  <c:v>2.4232633279482999E-2</c:v>
                </c:pt>
                <c:pt idx="14">
                  <c:v>1.4539579967689805E-2</c:v>
                </c:pt>
                <c:pt idx="15">
                  <c:v>8.0775444264943579E-3</c:v>
                </c:pt>
                <c:pt idx="16">
                  <c:v>1.6155088852988701E-3</c:v>
                </c:pt>
                <c:pt idx="17">
                  <c:v>4.8465266558966134E-3</c:v>
                </c:pt>
                <c:pt idx="18">
                  <c:v>0</c:v>
                </c:pt>
                <c:pt idx="19">
                  <c:v>0</c:v>
                </c:pt>
                <c:pt idx="20">
                  <c:v>1.6155088852988701E-3</c:v>
                </c:pt>
              </c:numCache>
            </c:numRef>
          </c:val>
        </c:ser>
        <c:ser>
          <c:idx val="10"/>
          <c:order val="10"/>
          <c:tx>
            <c:strRef>
              <c:f>'N2 A5_0.02_5%'!$L$104</c:f>
              <c:strCache>
                <c:ptCount val="1"/>
                <c:pt idx="0">
                  <c:v>N2_REX_A5_06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L$105:$L$125</c:f>
              <c:numCache>
                <c:formatCode>General</c:formatCode>
                <c:ptCount val="21"/>
                <c:pt idx="1">
                  <c:v>0.13356379635449411</c:v>
                </c:pt>
                <c:pt idx="2">
                  <c:v>0.15210559396605897</c:v>
                </c:pt>
                <c:pt idx="3">
                  <c:v>0.12822124450031411</c:v>
                </c:pt>
                <c:pt idx="4">
                  <c:v>8.3909490886235172E-2</c:v>
                </c:pt>
                <c:pt idx="5">
                  <c:v>6.8824638592080406E-2</c:v>
                </c:pt>
                <c:pt idx="6">
                  <c:v>5.279698302954134E-2</c:v>
                </c:pt>
                <c:pt idx="7">
                  <c:v>3.7083595223130129E-2</c:v>
                </c:pt>
                <c:pt idx="8">
                  <c:v>3.5197988686360829E-2</c:v>
                </c:pt>
                <c:pt idx="9">
                  <c:v>2.5455688246385888E-2</c:v>
                </c:pt>
                <c:pt idx="10">
                  <c:v>1.9798868636077917E-2</c:v>
                </c:pt>
                <c:pt idx="11">
                  <c:v>1.4770584538026401E-2</c:v>
                </c:pt>
                <c:pt idx="12">
                  <c:v>1.6027655562539305E-2</c:v>
                </c:pt>
                <c:pt idx="13">
                  <c:v>8.1709616593337517E-3</c:v>
                </c:pt>
                <c:pt idx="14">
                  <c:v>6.2853551225644372E-3</c:v>
                </c:pt>
                <c:pt idx="15">
                  <c:v>6.5996228786926537E-3</c:v>
                </c:pt>
                <c:pt idx="16">
                  <c:v>3.4569453174104299E-3</c:v>
                </c:pt>
                <c:pt idx="17">
                  <c:v>2.199874292897554E-3</c:v>
                </c:pt>
                <c:pt idx="18">
                  <c:v>1.8856065367693312E-3</c:v>
                </c:pt>
                <c:pt idx="19">
                  <c:v>1.2570710245128909E-3</c:v>
                </c:pt>
                <c:pt idx="2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N2 A5_0.02_5%'!$M$104</c:f>
              <c:strCache>
                <c:ptCount val="1"/>
                <c:pt idx="0">
                  <c:v>N2_REX_A5_08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M$105:$M$125</c:f>
              <c:numCache>
                <c:formatCode>General</c:formatCode>
                <c:ptCount val="21"/>
                <c:pt idx="1">
                  <c:v>0.128205128205128</c:v>
                </c:pt>
                <c:pt idx="2">
                  <c:v>0.14851814851814918</c:v>
                </c:pt>
                <c:pt idx="3">
                  <c:v>0.12987012987013</c:v>
                </c:pt>
                <c:pt idx="4">
                  <c:v>0.10256410256410307</c:v>
                </c:pt>
                <c:pt idx="5">
                  <c:v>7.6923076923076913E-2</c:v>
                </c:pt>
                <c:pt idx="6">
                  <c:v>4.8618048618048602E-2</c:v>
                </c:pt>
                <c:pt idx="7">
                  <c:v>4.0626040626040603E-2</c:v>
                </c:pt>
                <c:pt idx="8">
                  <c:v>3.03030303030303E-2</c:v>
                </c:pt>
                <c:pt idx="9">
                  <c:v>2.3643023643023616E-2</c:v>
                </c:pt>
                <c:pt idx="10">
                  <c:v>1.66500166500167E-2</c:v>
                </c:pt>
                <c:pt idx="11">
                  <c:v>1.4319014319014299E-2</c:v>
                </c:pt>
                <c:pt idx="12">
                  <c:v>1.0323010323010301E-2</c:v>
                </c:pt>
                <c:pt idx="13">
                  <c:v>6.66000666000666E-3</c:v>
                </c:pt>
                <c:pt idx="14">
                  <c:v>7.3260073260073303E-3</c:v>
                </c:pt>
                <c:pt idx="15">
                  <c:v>3.6630036630036617E-3</c:v>
                </c:pt>
                <c:pt idx="16">
                  <c:v>3.33000333000333E-3</c:v>
                </c:pt>
                <c:pt idx="17">
                  <c:v>2.3310023310023301E-3</c:v>
                </c:pt>
                <c:pt idx="18">
                  <c:v>1.3320013320013309E-3</c:v>
                </c:pt>
                <c:pt idx="19">
                  <c:v>0</c:v>
                </c:pt>
                <c:pt idx="20">
                  <c:v>6.6600066600066611E-4</c:v>
                </c:pt>
              </c:numCache>
            </c:numRef>
          </c:val>
        </c:ser>
        <c:ser>
          <c:idx val="12"/>
          <c:order val="12"/>
          <c:tx>
            <c:strRef>
              <c:f>'N2 A5_0.02_5%'!$N$104</c:f>
              <c:strCache>
                <c:ptCount val="1"/>
                <c:pt idx="0">
                  <c:v>N2_REX_A5_09</c:v>
                </c:pt>
              </c:strCache>
            </c:strRef>
          </c:tx>
          <c:marker>
            <c:symbol val="none"/>
          </c:marker>
          <c:cat>
            <c:numRef>
              <c:f>'N2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N2 A5_0.02_5%'!$N$105:$N$125</c:f>
              <c:numCache>
                <c:formatCode>General</c:formatCode>
                <c:ptCount val="21"/>
                <c:pt idx="1">
                  <c:v>0.10602910602910599</c:v>
                </c:pt>
                <c:pt idx="2">
                  <c:v>0.13305613305613312</c:v>
                </c:pt>
                <c:pt idx="3">
                  <c:v>0.16008316008316001</c:v>
                </c:pt>
                <c:pt idx="4">
                  <c:v>0.13513513513513511</c:v>
                </c:pt>
                <c:pt idx="5">
                  <c:v>0.10187110187110206</c:v>
                </c:pt>
                <c:pt idx="6">
                  <c:v>6.4449064449064494E-2</c:v>
                </c:pt>
                <c:pt idx="7">
                  <c:v>5.6133056133056101E-2</c:v>
                </c:pt>
                <c:pt idx="8">
                  <c:v>5.1975051975051985E-2</c:v>
                </c:pt>
                <c:pt idx="9">
                  <c:v>2.4948024948024887E-2</c:v>
                </c:pt>
                <c:pt idx="10">
                  <c:v>2.0790020790020798E-2</c:v>
                </c:pt>
                <c:pt idx="11">
                  <c:v>1.8711018711018716E-2</c:v>
                </c:pt>
                <c:pt idx="12">
                  <c:v>8.3160083160083356E-3</c:v>
                </c:pt>
                <c:pt idx="13">
                  <c:v>4.1580041580041634E-3</c:v>
                </c:pt>
                <c:pt idx="14">
                  <c:v>1.0395010395010401E-2</c:v>
                </c:pt>
                <c:pt idx="15">
                  <c:v>2.07900207900208E-3</c:v>
                </c:pt>
                <c:pt idx="16">
                  <c:v>0</c:v>
                </c:pt>
                <c:pt idx="17">
                  <c:v>4.1580041580041634E-3</c:v>
                </c:pt>
                <c:pt idx="18">
                  <c:v>2.07900207900208E-3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marker val="1"/>
        <c:axId val="157276800"/>
        <c:axId val="157630848"/>
      </c:lineChart>
      <c:catAx>
        <c:axId val="157276800"/>
        <c:scaling>
          <c:orientation val="minMax"/>
        </c:scaling>
        <c:axPos val="b"/>
        <c:numFmt formatCode="#,##0.0_);\(#,##0.0\)" sourceLinked="0"/>
        <c:tickLblPos val="nextTo"/>
        <c:crossAx val="157630848"/>
        <c:crosses val="autoZero"/>
        <c:auto val="1"/>
        <c:lblAlgn val="ctr"/>
        <c:lblOffset val="100"/>
        <c:tickLblSkip val="5"/>
        <c:tickMarkSkip val="5"/>
      </c:catAx>
      <c:valAx>
        <c:axId val="15763084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7276800"/>
        <c:crosses val="autoZero"/>
        <c:crossBetween val="between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A1_0.02_5%'!$B$104</c:f>
              <c:strCache>
                <c:ptCount val="1"/>
                <c:pt idx="0">
                  <c:v>control_unc-25_A1_001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B$105:$B$125</c:f>
              <c:numCache>
                <c:formatCode>General</c:formatCode>
                <c:ptCount val="21"/>
                <c:pt idx="1">
                  <c:v>8.9322685595977544E-2</c:v>
                </c:pt>
                <c:pt idx="2">
                  <c:v>0.11180124223602506</c:v>
                </c:pt>
                <c:pt idx="3">
                  <c:v>0.117420881396037</c:v>
                </c:pt>
                <c:pt idx="4">
                  <c:v>0.10854776693286</c:v>
                </c:pt>
                <c:pt idx="5">
                  <c:v>9.5533865720201241E-2</c:v>
                </c:pt>
                <c:pt idx="6">
                  <c:v>6.9801833776989106E-2</c:v>
                </c:pt>
                <c:pt idx="7">
                  <c:v>6.0928719313812496E-2</c:v>
                </c:pt>
                <c:pt idx="8">
                  <c:v>4.4661342797988765E-2</c:v>
                </c:pt>
                <c:pt idx="9">
                  <c:v>5.1464063886424112E-2</c:v>
                </c:pt>
                <c:pt idx="10">
                  <c:v>3.6675539781129848E-2</c:v>
                </c:pt>
                <c:pt idx="11">
                  <c:v>3.2238982549541627E-2</c:v>
                </c:pt>
                <c:pt idx="12">
                  <c:v>2.8098195800059202E-2</c:v>
                </c:pt>
                <c:pt idx="13">
                  <c:v>1.9520851818988529E-2</c:v>
                </c:pt>
                <c:pt idx="14">
                  <c:v>1.3013901212659001E-2</c:v>
                </c:pt>
                <c:pt idx="15">
                  <c:v>1.2422360248447213E-2</c:v>
                </c:pt>
                <c:pt idx="16">
                  <c:v>8.2815734989648004E-3</c:v>
                </c:pt>
                <c:pt idx="17">
                  <c:v>7.3942620526471544E-3</c:v>
                </c:pt>
                <c:pt idx="18">
                  <c:v>5.3238686779059395E-3</c:v>
                </c:pt>
                <c:pt idx="19">
                  <c:v>2.6619343389529758E-3</c:v>
                </c:pt>
                <c:pt idx="20">
                  <c:v>2.3661638568470925E-3</c:v>
                </c:pt>
              </c:numCache>
            </c:numRef>
          </c:val>
        </c:ser>
        <c:ser>
          <c:idx val="1"/>
          <c:order val="1"/>
          <c:tx>
            <c:strRef>
              <c:f>'unc-25 A1_0.02_5%'!$C$104</c:f>
              <c:strCache>
                <c:ptCount val="1"/>
                <c:pt idx="0">
                  <c:v>control_unc-25_A1_002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C$105:$C$125</c:f>
              <c:numCache>
                <c:formatCode>General</c:formatCode>
                <c:ptCount val="21"/>
                <c:pt idx="1">
                  <c:v>7.6098059244126756E-2</c:v>
                </c:pt>
                <c:pt idx="2">
                  <c:v>9.6782431052093998E-2</c:v>
                </c:pt>
                <c:pt idx="3">
                  <c:v>0.10852911133810007</c:v>
                </c:pt>
                <c:pt idx="4">
                  <c:v>0.11644535240040906</c:v>
                </c:pt>
                <c:pt idx="5">
                  <c:v>0.10776302349336107</c:v>
                </c:pt>
                <c:pt idx="6">
                  <c:v>7.3544433094994893E-2</c:v>
                </c:pt>
                <c:pt idx="7">
                  <c:v>6.38406537282942E-2</c:v>
                </c:pt>
                <c:pt idx="8">
                  <c:v>5.2860061287027665E-2</c:v>
                </c:pt>
                <c:pt idx="9">
                  <c:v>4.9029622063329899E-2</c:v>
                </c:pt>
                <c:pt idx="10">
                  <c:v>3.8559754851889678E-2</c:v>
                </c:pt>
                <c:pt idx="11">
                  <c:v>3.2686414708886599E-2</c:v>
                </c:pt>
                <c:pt idx="12">
                  <c:v>2.6557711950970401E-2</c:v>
                </c:pt>
                <c:pt idx="13">
                  <c:v>2.0684371807967318E-2</c:v>
                </c:pt>
                <c:pt idx="14">
                  <c:v>1.4811031664964209E-2</c:v>
                </c:pt>
                <c:pt idx="15">
                  <c:v>1.1235955056179799E-2</c:v>
                </c:pt>
                <c:pt idx="16">
                  <c:v>9.1930541368743669E-3</c:v>
                </c:pt>
                <c:pt idx="17">
                  <c:v>7.1501532175689475E-3</c:v>
                </c:pt>
                <c:pt idx="18">
                  <c:v>5.6179775280898875E-3</c:v>
                </c:pt>
                <c:pt idx="19">
                  <c:v>5.6179775280898875E-3</c:v>
                </c:pt>
                <c:pt idx="20">
                  <c:v>4.0858018386108301E-3</c:v>
                </c:pt>
              </c:numCache>
            </c:numRef>
          </c:val>
        </c:ser>
        <c:ser>
          <c:idx val="2"/>
          <c:order val="2"/>
          <c:tx>
            <c:strRef>
              <c:f>'unc-25 A1_0.02_5%'!$D$104</c:f>
              <c:strCache>
                <c:ptCount val="1"/>
                <c:pt idx="0">
                  <c:v>control_unc-25_A1_003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D$105:$D$125</c:f>
              <c:numCache>
                <c:formatCode>General</c:formatCode>
                <c:ptCount val="21"/>
                <c:pt idx="1">
                  <c:v>7.5077399380805002E-2</c:v>
                </c:pt>
                <c:pt idx="2">
                  <c:v>0.10371517027863815</c:v>
                </c:pt>
                <c:pt idx="3">
                  <c:v>0.1099071207430341</c:v>
                </c:pt>
                <c:pt idx="4">
                  <c:v>0.111455108359133</c:v>
                </c:pt>
                <c:pt idx="5">
                  <c:v>9.3266253869969007E-2</c:v>
                </c:pt>
                <c:pt idx="6">
                  <c:v>7.5464396284829732E-2</c:v>
                </c:pt>
                <c:pt idx="7">
                  <c:v>7.0433436532507776E-2</c:v>
                </c:pt>
                <c:pt idx="8">
                  <c:v>5.8823529411764698E-2</c:v>
                </c:pt>
                <c:pt idx="9">
                  <c:v>5.5727554179566624E-2</c:v>
                </c:pt>
                <c:pt idx="10">
                  <c:v>3.7925696594427204E-2</c:v>
                </c:pt>
                <c:pt idx="11">
                  <c:v>2.9798761609907101E-2</c:v>
                </c:pt>
                <c:pt idx="12">
                  <c:v>2.8637770897832801E-2</c:v>
                </c:pt>
                <c:pt idx="13">
                  <c:v>1.9736842105263205E-2</c:v>
                </c:pt>
                <c:pt idx="14">
                  <c:v>1.8575851393188923E-2</c:v>
                </c:pt>
                <c:pt idx="15">
                  <c:v>7.3529411764705899E-3</c:v>
                </c:pt>
                <c:pt idx="16">
                  <c:v>1.0448916408668699E-2</c:v>
                </c:pt>
                <c:pt idx="17">
                  <c:v>8.9009287925696668E-3</c:v>
                </c:pt>
                <c:pt idx="18">
                  <c:v>4.6439628482972065E-3</c:v>
                </c:pt>
                <c:pt idx="19">
                  <c:v>3.8699690402476819E-3</c:v>
                </c:pt>
                <c:pt idx="20">
                  <c:v>2.7089783281733721E-3</c:v>
                </c:pt>
              </c:numCache>
            </c:numRef>
          </c:val>
        </c:ser>
        <c:ser>
          <c:idx val="3"/>
          <c:order val="3"/>
          <c:tx>
            <c:strRef>
              <c:f>'unc-25 A1_0.02_5%'!$E$104</c:f>
              <c:strCache>
                <c:ptCount val="1"/>
                <c:pt idx="0">
                  <c:v>control_unc-25_A1_004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E$105:$E$125</c:f>
              <c:numCache>
                <c:formatCode>General</c:formatCode>
                <c:ptCount val="21"/>
                <c:pt idx="1">
                  <c:v>7.1095152603231598E-2</c:v>
                </c:pt>
                <c:pt idx="2">
                  <c:v>9.9820466786355616E-2</c:v>
                </c:pt>
                <c:pt idx="3">
                  <c:v>0.10520646319569102</c:v>
                </c:pt>
                <c:pt idx="4">
                  <c:v>0.11741472172351912</c:v>
                </c:pt>
                <c:pt idx="5">
                  <c:v>0.10053859964093401</c:v>
                </c:pt>
                <c:pt idx="6">
                  <c:v>7.0377019748653499E-2</c:v>
                </c:pt>
                <c:pt idx="7">
                  <c:v>5.2064631956912119E-2</c:v>
                </c:pt>
                <c:pt idx="8">
                  <c:v>5.2423698384201134E-2</c:v>
                </c:pt>
                <c:pt idx="9">
                  <c:v>4.1292639138240675E-2</c:v>
                </c:pt>
                <c:pt idx="10">
                  <c:v>3.6983842010772039E-2</c:v>
                </c:pt>
                <c:pt idx="11">
                  <c:v>3.5188509874326798E-2</c:v>
                </c:pt>
                <c:pt idx="12">
                  <c:v>3.3393177737881502E-2</c:v>
                </c:pt>
                <c:pt idx="13">
                  <c:v>2.3339317773788212E-2</c:v>
                </c:pt>
                <c:pt idx="14">
                  <c:v>2.2621184919210099E-2</c:v>
                </c:pt>
                <c:pt idx="15">
                  <c:v>2.2621184919210099E-2</c:v>
                </c:pt>
                <c:pt idx="16">
                  <c:v>1.4003590664272909E-2</c:v>
                </c:pt>
                <c:pt idx="17">
                  <c:v>9.6947935368043182E-3</c:v>
                </c:pt>
                <c:pt idx="18">
                  <c:v>7.5403949730700253E-3</c:v>
                </c:pt>
                <c:pt idx="19">
                  <c:v>5.3859964093357299E-3</c:v>
                </c:pt>
                <c:pt idx="20">
                  <c:v>4.3087971274685813E-3</c:v>
                </c:pt>
              </c:numCache>
            </c:numRef>
          </c:val>
        </c:ser>
        <c:ser>
          <c:idx val="4"/>
          <c:order val="4"/>
          <c:tx>
            <c:strRef>
              <c:f>'unc-25 A1_0.02_5%'!$F$104</c:f>
              <c:strCache>
                <c:ptCount val="1"/>
                <c:pt idx="0">
                  <c:v>control_unc-25_A1_005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F$105:$F$125</c:f>
              <c:numCache>
                <c:formatCode>General</c:formatCode>
                <c:ptCount val="21"/>
                <c:pt idx="1">
                  <c:v>6.9591527987897153E-2</c:v>
                </c:pt>
                <c:pt idx="2">
                  <c:v>9.1780131114473001E-2</c:v>
                </c:pt>
                <c:pt idx="3">
                  <c:v>0.10993444276349011</c:v>
                </c:pt>
                <c:pt idx="4">
                  <c:v>0.11396873424104906</c:v>
                </c:pt>
                <c:pt idx="5">
                  <c:v>0.1122037317196171</c:v>
                </c:pt>
                <c:pt idx="6">
                  <c:v>8.4215834594049521E-2</c:v>
                </c:pt>
                <c:pt idx="7">
                  <c:v>6.2279374684820962E-2</c:v>
                </c:pt>
                <c:pt idx="8">
                  <c:v>6.1018658598083704E-2</c:v>
                </c:pt>
                <c:pt idx="9">
                  <c:v>5.1941502773575329E-2</c:v>
                </c:pt>
                <c:pt idx="10">
                  <c:v>4.03429147755925E-2</c:v>
                </c:pt>
                <c:pt idx="11">
                  <c:v>3.3282904689863828E-2</c:v>
                </c:pt>
                <c:pt idx="12">
                  <c:v>2.37014624306606E-2</c:v>
                </c:pt>
                <c:pt idx="13">
                  <c:v>1.8406454866364119E-2</c:v>
                </c:pt>
                <c:pt idx="14">
                  <c:v>1.9667170953101401E-2</c:v>
                </c:pt>
                <c:pt idx="15">
                  <c:v>1.4372163388804799E-2</c:v>
                </c:pt>
                <c:pt idx="16">
                  <c:v>1.1598587997982909E-2</c:v>
                </c:pt>
                <c:pt idx="17">
                  <c:v>5.2950075642965236E-3</c:v>
                </c:pt>
                <c:pt idx="18">
                  <c:v>6.8078668683812385E-3</c:v>
                </c:pt>
                <c:pt idx="19">
                  <c:v>3.5300050428643541E-3</c:v>
                </c:pt>
                <c:pt idx="20">
                  <c:v>3.0257186081694429E-3</c:v>
                </c:pt>
              </c:numCache>
            </c:numRef>
          </c:val>
        </c:ser>
        <c:ser>
          <c:idx val="5"/>
          <c:order val="5"/>
          <c:tx>
            <c:strRef>
              <c:f>'unc-25 A1_0.02_5%'!$G$104</c:f>
              <c:strCache>
                <c:ptCount val="1"/>
                <c:pt idx="0">
                  <c:v>control_unc-25_A1_006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G$105:$G$125</c:f>
              <c:numCache>
                <c:formatCode>General</c:formatCode>
                <c:ptCount val="21"/>
                <c:pt idx="1">
                  <c:v>6.3614013521819293E-2</c:v>
                </c:pt>
                <c:pt idx="2">
                  <c:v>8.7277197295636127E-2</c:v>
                </c:pt>
                <c:pt idx="3">
                  <c:v>0.11186232329440694</c:v>
                </c:pt>
                <c:pt idx="4">
                  <c:v>0.12476951444376205</c:v>
                </c:pt>
                <c:pt idx="5">
                  <c:v>0.11862323294406911</c:v>
                </c:pt>
                <c:pt idx="6">
                  <c:v>7.5906576521204694E-2</c:v>
                </c:pt>
                <c:pt idx="7">
                  <c:v>6.1155500921942198E-2</c:v>
                </c:pt>
                <c:pt idx="8">
                  <c:v>5.4394591272280371E-2</c:v>
                </c:pt>
                <c:pt idx="9">
                  <c:v>4.978488014751084E-2</c:v>
                </c:pt>
                <c:pt idx="10">
                  <c:v>3.6877688998156098E-2</c:v>
                </c:pt>
                <c:pt idx="11">
                  <c:v>4.3331284572833424E-2</c:v>
                </c:pt>
                <c:pt idx="12">
                  <c:v>3.042409342347881E-2</c:v>
                </c:pt>
                <c:pt idx="13">
                  <c:v>2.427781192378612E-2</c:v>
                </c:pt>
                <c:pt idx="14">
                  <c:v>2.02827289489859E-2</c:v>
                </c:pt>
                <c:pt idx="15">
                  <c:v>1.3521819299323921E-2</c:v>
                </c:pt>
                <c:pt idx="16">
                  <c:v>8.6047940995697732E-3</c:v>
                </c:pt>
                <c:pt idx="17">
                  <c:v>4.917025199754157E-3</c:v>
                </c:pt>
                <c:pt idx="18">
                  <c:v>4.3023970497848814E-3</c:v>
                </c:pt>
                <c:pt idx="19">
                  <c:v>2.765826674861712E-3</c:v>
                </c:pt>
                <c:pt idx="20">
                  <c:v>3.0731407498463441E-3</c:v>
                </c:pt>
              </c:numCache>
            </c:numRef>
          </c:val>
        </c:ser>
        <c:ser>
          <c:idx val="6"/>
          <c:order val="6"/>
          <c:tx>
            <c:strRef>
              <c:f>'unc-25 A1_0.02_5%'!$H$104</c:f>
              <c:strCache>
                <c:ptCount val="1"/>
                <c:pt idx="0">
                  <c:v>control_unc-25_A1_007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H$105:$H$125</c:f>
              <c:numCache>
                <c:formatCode>General</c:formatCode>
                <c:ptCount val="21"/>
                <c:pt idx="1">
                  <c:v>7.2240259740259688E-2</c:v>
                </c:pt>
                <c:pt idx="2">
                  <c:v>9.4155844155844368E-2</c:v>
                </c:pt>
                <c:pt idx="3">
                  <c:v>9.7402597402597296E-2</c:v>
                </c:pt>
                <c:pt idx="4">
                  <c:v>9.9431818181818246E-2</c:v>
                </c:pt>
                <c:pt idx="5">
                  <c:v>8.3603896103896277E-2</c:v>
                </c:pt>
                <c:pt idx="6">
                  <c:v>6.4123376623376596E-2</c:v>
                </c:pt>
                <c:pt idx="7">
                  <c:v>5.3165584415584395E-2</c:v>
                </c:pt>
                <c:pt idx="8">
                  <c:v>4.9918831168831279E-2</c:v>
                </c:pt>
                <c:pt idx="9">
                  <c:v>4.8701298701298704E-2</c:v>
                </c:pt>
                <c:pt idx="10">
                  <c:v>4.1396103896103924E-2</c:v>
                </c:pt>
                <c:pt idx="11">
                  <c:v>3.9366883116883099E-2</c:v>
                </c:pt>
                <c:pt idx="12">
                  <c:v>4.0178571428571404E-2</c:v>
                </c:pt>
                <c:pt idx="13">
                  <c:v>2.5162337662337698E-2</c:v>
                </c:pt>
                <c:pt idx="14">
                  <c:v>2.0698051948051872E-2</c:v>
                </c:pt>
                <c:pt idx="15">
                  <c:v>2.3133116883116926E-2</c:v>
                </c:pt>
                <c:pt idx="16">
                  <c:v>2.5974025974026017E-2</c:v>
                </c:pt>
                <c:pt idx="17">
                  <c:v>1.379870129870131E-2</c:v>
                </c:pt>
                <c:pt idx="18">
                  <c:v>9.74025974025974E-3</c:v>
                </c:pt>
                <c:pt idx="19">
                  <c:v>6.8993506493506534E-3</c:v>
                </c:pt>
                <c:pt idx="20">
                  <c:v>7.3051948051948137E-3</c:v>
                </c:pt>
              </c:numCache>
            </c:numRef>
          </c:val>
        </c:ser>
        <c:ser>
          <c:idx val="7"/>
          <c:order val="7"/>
          <c:tx>
            <c:strRef>
              <c:f>'unc-25 A1_0.02_5%'!$I$104</c:f>
              <c:strCache>
                <c:ptCount val="1"/>
                <c:pt idx="0">
                  <c:v>control_unc-25_A1_008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I$105:$I$125</c:f>
              <c:numCache>
                <c:formatCode>General</c:formatCode>
                <c:ptCount val="21"/>
                <c:pt idx="1">
                  <c:v>7.1238545669524034E-2</c:v>
                </c:pt>
                <c:pt idx="2">
                  <c:v>8.9565474430978481E-2</c:v>
                </c:pt>
                <c:pt idx="3">
                  <c:v>9.3112621933195402E-2</c:v>
                </c:pt>
                <c:pt idx="4">
                  <c:v>0.10966597694354112</c:v>
                </c:pt>
                <c:pt idx="5">
                  <c:v>0.107301211942063</c:v>
                </c:pt>
                <c:pt idx="6">
                  <c:v>7.064735441915454E-2</c:v>
                </c:pt>
                <c:pt idx="7">
                  <c:v>5.3207212533254465E-2</c:v>
                </c:pt>
                <c:pt idx="8">
                  <c:v>4.7590895654744336E-2</c:v>
                </c:pt>
                <c:pt idx="9">
                  <c:v>4.7590895654744336E-2</c:v>
                </c:pt>
                <c:pt idx="10">
                  <c:v>4.1678983151049398E-2</c:v>
                </c:pt>
                <c:pt idx="11">
                  <c:v>2.7785988767366224E-2</c:v>
                </c:pt>
                <c:pt idx="12">
                  <c:v>2.8968371268105197E-2</c:v>
                </c:pt>
                <c:pt idx="13">
                  <c:v>2.1874076263671331E-2</c:v>
                </c:pt>
                <c:pt idx="14">
                  <c:v>2.5716819391072988E-2</c:v>
                </c:pt>
                <c:pt idx="15">
                  <c:v>1.5075376884422099E-2</c:v>
                </c:pt>
                <c:pt idx="16">
                  <c:v>1.7440141885900103E-2</c:v>
                </c:pt>
                <c:pt idx="17">
                  <c:v>1.4779781259237412E-2</c:v>
                </c:pt>
                <c:pt idx="18">
                  <c:v>1.0937038131835601E-2</c:v>
                </c:pt>
                <c:pt idx="19">
                  <c:v>7.3898906296186858E-3</c:v>
                </c:pt>
                <c:pt idx="20">
                  <c:v>4.1383387525864603E-3</c:v>
                </c:pt>
              </c:numCache>
            </c:numRef>
          </c:val>
        </c:ser>
        <c:ser>
          <c:idx val="8"/>
          <c:order val="8"/>
          <c:tx>
            <c:strRef>
              <c:f>'unc-25 A1_0.02_5%'!$J$104</c:f>
              <c:strCache>
                <c:ptCount val="1"/>
                <c:pt idx="0">
                  <c:v>unc-25_A1_M101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J$105:$J$125</c:f>
              <c:numCache>
                <c:formatCode>General</c:formatCode>
                <c:ptCount val="21"/>
                <c:pt idx="1">
                  <c:v>6.0644749441429863E-2</c:v>
                </c:pt>
                <c:pt idx="2">
                  <c:v>9.3839770188317975E-2</c:v>
                </c:pt>
                <c:pt idx="3">
                  <c:v>0.115863389722311</c:v>
                </c:pt>
                <c:pt idx="4">
                  <c:v>0.11841685285668706</c:v>
                </c:pt>
                <c:pt idx="5">
                  <c:v>0.10437280561761902</c:v>
                </c:pt>
                <c:pt idx="6">
                  <c:v>9.0647941270347948E-2</c:v>
                </c:pt>
                <c:pt idx="7">
                  <c:v>7.0858601978933955E-2</c:v>
                </c:pt>
                <c:pt idx="8">
                  <c:v>5.2026811362910999E-2</c:v>
                </c:pt>
                <c:pt idx="9">
                  <c:v>5.4580274497286932E-2</c:v>
                </c:pt>
                <c:pt idx="10">
                  <c:v>3.4152569422278997E-2</c:v>
                </c:pt>
                <c:pt idx="11">
                  <c:v>3.3833386530481999E-2</c:v>
                </c:pt>
                <c:pt idx="12">
                  <c:v>3.2237472071497027E-2</c:v>
                </c:pt>
                <c:pt idx="13">
                  <c:v>1.9150973507820003E-2</c:v>
                </c:pt>
                <c:pt idx="14">
                  <c:v>2.2981168209384017E-2</c:v>
                </c:pt>
                <c:pt idx="15">
                  <c:v>1.0213852537503999E-2</c:v>
                </c:pt>
                <c:pt idx="16">
                  <c:v>1.1809766996489E-2</c:v>
                </c:pt>
                <c:pt idx="17">
                  <c:v>7.9795722949250001E-3</c:v>
                </c:pt>
                <c:pt idx="18">
                  <c:v>5.7452920523459938E-3</c:v>
                </c:pt>
                <c:pt idx="19">
                  <c:v>3.8301947015640038E-3</c:v>
                </c:pt>
                <c:pt idx="20">
                  <c:v>2.5534631343760001E-3</c:v>
                </c:pt>
              </c:numCache>
            </c:numRef>
          </c:val>
        </c:ser>
        <c:ser>
          <c:idx val="9"/>
          <c:order val="9"/>
          <c:tx>
            <c:strRef>
              <c:f>'unc-25 A1_0.02_5%'!$K$104</c:f>
              <c:strCache>
                <c:ptCount val="1"/>
                <c:pt idx="0">
                  <c:v>unc-25_A1_M102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K$105:$K$125</c:f>
              <c:numCache>
                <c:formatCode>General</c:formatCode>
                <c:ptCount val="21"/>
                <c:pt idx="1">
                  <c:v>6.4668094218415476E-2</c:v>
                </c:pt>
                <c:pt idx="2">
                  <c:v>9.5931477516060071E-2</c:v>
                </c:pt>
                <c:pt idx="3">
                  <c:v>0.10963597430406906</c:v>
                </c:pt>
                <c:pt idx="4">
                  <c:v>0.113490364025696</c:v>
                </c:pt>
                <c:pt idx="5">
                  <c:v>9.1220556745182049E-2</c:v>
                </c:pt>
                <c:pt idx="6">
                  <c:v>6.3383297644539677E-2</c:v>
                </c:pt>
                <c:pt idx="7">
                  <c:v>5.6959314775160551E-2</c:v>
                </c:pt>
                <c:pt idx="8">
                  <c:v>4.6680942184154132E-2</c:v>
                </c:pt>
                <c:pt idx="9">
                  <c:v>4.5396145610278403E-2</c:v>
                </c:pt>
                <c:pt idx="10">
                  <c:v>3.940042826552461E-2</c:v>
                </c:pt>
                <c:pt idx="11">
                  <c:v>3.1263383297644498E-2</c:v>
                </c:pt>
                <c:pt idx="12">
                  <c:v>3.1691648822269838E-2</c:v>
                </c:pt>
                <c:pt idx="13">
                  <c:v>2.141327623126342E-2</c:v>
                </c:pt>
                <c:pt idx="14">
                  <c:v>2.3554603854389684E-2</c:v>
                </c:pt>
                <c:pt idx="15">
                  <c:v>1.8843683083511805E-2</c:v>
                </c:pt>
                <c:pt idx="16">
                  <c:v>1.8415417558886499E-2</c:v>
                </c:pt>
                <c:pt idx="17">
                  <c:v>1.4132762312633799E-2</c:v>
                </c:pt>
                <c:pt idx="18">
                  <c:v>1.07066381156317E-2</c:v>
                </c:pt>
                <c:pt idx="19">
                  <c:v>9.8501070663811682E-3</c:v>
                </c:pt>
                <c:pt idx="20">
                  <c:v>6.4239828693790097E-3</c:v>
                </c:pt>
              </c:numCache>
            </c:numRef>
          </c:val>
        </c:ser>
        <c:ser>
          <c:idx val="10"/>
          <c:order val="10"/>
          <c:tx>
            <c:strRef>
              <c:f>'unc-25 A1_0.02_5%'!$L$104</c:f>
              <c:strCache>
                <c:ptCount val="1"/>
                <c:pt idx="0">
                  <c:v>unc-25_A1_M104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L$105:$L$125</c:f>
              <c:numCache>
                <c:formatCode>General</c:formatCode>
                <c:ptCount val="21"/>
                <c:pt idx="1">
                  <c:v>8.5467128027681707E-2</c:v>
                </c:pt>
                <c:pt idx="2">
                  <c:v>0.112456747404844</c:v>
                </c:pt>
                <c:pt idx="3">
                  <c:v>0.11972318339100307</c:v>
                </c:pt>
                <c:pt idx="4">
                  <c:v>0.11972318339100307</c:v>
                </c:pt>
                <c:pt idx="5">
                  <c:v>9.6193771626297581E-2</c:v>
                </c:pt>
                <c:pt idx="6">
                  <c:v>7.6124567474048402E-2</c:v>
                </c:pt>
                <c:pt idx="7">
                  <c:v>6.7820069204152206E-2</c:v>
                </c:pt>
                <c:pt idx="8">
                  <c:v>5.7093425605536395E-2</c:v>
                </c:pt>
                <c:pt idx="9">
                  <c:v>4.4636678200692004E-2</c:v>
                </c:pt>
                <c:pt idx="10">
                  <c:v>3.9100346020761206E-2</c:v>
                </c:pt>
                <c:pt idx="11">
                  <c:v>3.1487889273356405E-2</c:v>
                </c:pt>
                <c:pt idx="12">
                  <c:v>2.179930795847753E-2</c:v>
                </c:pt>
                <c:pt idx="13">
                  <c:v>1.5916955017301001E-2</c:v>
                </c:pt>
                <c:pt idx="14">
                  <c:v>1.8339100346020803E-2</c:v>
                </c:pt>
                <c:pt idx="15">
                  <c:v>1.10726643598616E-2</c:v>
                </c:pt>
                <c:pt idx="16">
                  <c:v>7.2664359861591733E-3</c:v>
                </c:pt>
                <c:pt idx="17">
                  <c:v>5.1903114186851234E-3</c:v>
                </c:pt>
                <c:pt idx="18">
                  <c:v>3.8062283737024202E-3</c:v>
                </c:pt>
                <c:pt idx="19">
                  <c:v>3.1141868512110757E-3</c:v>
                </c:pt>
                <c:pt idx="20">
                  <c:v>2.42214532871972E-3</c:v>
                </c:pt>
              </c:numCache>
            </c:numRef>
          </c:val>
        </c:ser>
        <c:ser>
          <c:idx val="11"/>
          <c:order val="11"/>
          <c:tx>
            <c:strRef>
              <c:f>'unc-25 A1_0.02_5%'!$M$104</c:f>
              <c:strCache>
                <c:ptCount val="1"/>
                <c:pt idx="0">
                  <c:v>unc-25_A1_M106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M$105:$M$125</c:f>
              <c:numCache>
                <c:formatCode>General</c:formatCode>
                <c:ptCount val="21"/>
                <c:pt idx="1">
                  <c:v>6.7929188966652856E-2</c:v>
                </c:pt>
                <c:pt idx="2">
                  <c:v>8.645533141210375E-2</c:v>
                </c:pt>
                <c:pt idx="3">
                  <c:v>9.2219020172910698E-2</c:v>
                </c:pt>
                <c:pt idx="4">
                  <c:v>9.0572251955537281E-2</c:v>
                </c:pt>
                <c:pt idx="5">
                  <c:v>9.5924248662000902E-2</c:v>
                </c:pt>
                <c:pt idx="6">
                  <c:v>7.5339645944833403E-2</c:v>
                </c:pt>
                <c:pt idx="7">
                  <c:v>6.1342116097159297E-2</c:v>
                </c:pt>
                <c:pt idx="8">
                  <c:v>4.9403046521202101E-2</c:v>
                </c:pt>
                <c:pt idx="9">
                  <c:v>4.3227665706051875E-2</c:v>
                </c:pt>
                <c:pt idx="10">
                  <c:v>3.2111980238781403E-2</c:v>
                </c:pt>
                <c:pt idx="11">
                  <c:v>3.4170440510498098E-2</c:v>
                </c:pt>
                <c:pt idx="12">
                  <c:v>2.8406751749691189E-2</c:v>
                </c:pt>
                <c:pt idx="13">
                  <c:v>3.0876904075751329E-2</c:v>
                </c:pt>
                <c:pt idx="14">
                  <c:v>2.3054755043227682E-2</c:v>
                </c:pt>
                <c:pt idx="15">
                  <c:v>2.5113215314944412E-2</c:v>
                </c:pt>
                <c:pt idx="16">
                  <c:v>1.9349526554137512E-2</c:v>
                </c:pt>
                <c:pt idx="17">
                  <c:v>1.6467682173734E-2</c:v>
                </c:pt>
                <c:pt idx="18">
                  <c:v>1.19390695759572E-2</c:v>
                </c:pt>
                <c:pt idx="19">
                  <c:v>1.2350761630300501E-2</c:v>
                </c:pt>
                <c:pt idx="20">
                  <c:v>6.587072869493624E-3</c:v>
                </c:pt>
              </c:numCache>
            </c:numRef>
          </c:val>
        </c:ser>
        <c:ser>
          <c:idx val="12"/>
          <c:order val="12"/>
          <c:tx>
            <c:strRef>
              <c:f>'unc-25 A1_0.02_5%'!$N$104</c:f>
              <c:strCache>
                <c:ptCount val="1"/>
                <c:pt idx="0">
                  <c:v>unc-25_REX_A1_01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N$105:$N$125</c:f>
              <c:numCache>
                <c:formatCode>General</c:formatCode>
                <c:ptCount val="21"/>
                <c:pt idx="1">
                  <c:v>7.4897750511247474E-2</c:v>
                </c:pt>
                <c:pt idx="2">
                  <c:v>8.2822085889570504E-2</c:v>
                </c:pt>
                <c:pt idx="3">
                  <c:v>9.8159509202454087E-2</c:v>
                </c:pt>
                <c:pt idx="4">
                  <c:v>0.10761758691206498</c:v>
                </c:pt>
                <c:pt idx="5">
                  <c:v>8.4611451942740307E-2</c:v>
                </c:pt>
                <c:pt idx="6">
                  <c:v>6.6462167689161619E-2</c:v>
                </c:pt>
                <c:pt idx="7">
                  <c:v>6.0582822085889602E-2</c:v>
                </c:pt>
                <c:pt idx="8">
                  <c:v>4.8057259713701402E-2</c:v>
                </c:pt>
                <c:pt idx="9">
                  <c:v>4.9591002044989813E-2</c:v>
                </c:pt>
                <c:pt idx="10">
                  <c:v>3.6298568507157528E-2</c:v>
                </c:pt>
                <c:pt idx="11">
                  <c:v>3.1186094069529713E-2</c:v>
                </c:pt>
                <c:pt idx="12">
                  <c:v>2.7096114519427419E-2</c:v>
                </c:pt>
                <c:pt idx="13">
                  <c:v>2.6329243353783206E-2</c:v>
                </c:pt>
                <c:pt idx="14">
                  <c:v>2.6840490797546E-2</c:v>
                </c:pt>
                <c:pt idx="15">
                  <c:v>2.1216768916155402E-2</c:v>
                </c:pt>
                <c:pt idx="16">
                  <c:v>1.7638036809815998E-2</c:v>
                </c:pt>
                <c:pt idx="17">
                  <c:v>1.6615541922290398E-2</c:v>
                </c:pt>
                <c:pt idx="18">
                  <c:v>1.4826175869120712E-2</c:v>
                </c:pt>
                <c:pt idx="19">
                  <c:v>1.1758691206544001E-2</c:v>
                </c:pt>
                <c:pt idx="20">
                  <c:v>5.6237218813905924E-3</c:v>
                </c:pt>
              </c:numCache>
            </c:numRef>
          </c:val>
        </c:ser>
        <c:ser>
          <c:idx val="13"/>
          <c:order val="13"/>
          <c:tx>
            <c:strRef>
              <c:f>'unc-25 A1_0.02_5%'!$O$104</c:f>
              <c:strCache>
                <c:ptCount val="1"/>
                <c:pt idx="0">
                  <c:v>unc-25_REX_A1_02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O$105:$O$125</c:f>
              <c:numCache>
                <c:formatCode>General</c:formatCode>
                <c:ptCount val="21"/>
                <c:pt idx="1">
                  <c:v>8.1042382588774345E-2</c:v>
                </c:pt>
                <c:pt idx="2">
                  <c:v>0.105670103092784</c:v>
                </c:pt>
                <c:pt idx="3">
                  <c:v>0.11712485681557799</c:v>
                </c:pt>
                <c:pt idx="4">
                  <c:v>0.10681557846506302</c:v>
                </c:pt>
                <c:pt idx="5">
                  <c:v>9.5933562428407795E-2</c:v>
                </c:pt>
                <c:pt idx="6">
                  <c:v>6.3860252004581911E-2</c:v>
                </c:pt>
                <c:pt idx="7">
                  <c:v>6.0423825887743435E-2</c:v>
                </c:pt>
                <c:pt idx="8">
                  <c:v>3.8659793814432998E-2</c:v>
                </c:pt>
                <c:pt idx="9">
                  <c:v>4.0378006872852201E-2</c:v>
                </c:pt>
                <c:pt idx="10">
                  <c:v>3.2646048109965638E-2</c:v>
                </c:pt>
                <c:pt idx="11">
                  <c:v>3.0068728522336798E-2</c:v>
                </c:pt>
                <c:pt idx="12">
                  <c:v>2.2050400916380289E-2</c:v>
                </c:pt>
                <c:pt idx="13">
                  <c:v>2.2050400916380289E-2</c:v>
                </c:pt>
                <c:pt idx="14">
                  <c:v>2.0332187857961117E-2</c:v>
                </c:pt>
                <c:pt idx="15">
                  <c:v>1.9759450171821302E-2</c:v>
                </c:pt>
                <c:pt idx="16">
                  <c:v>1.4891179839633414E-2</c:v>
                </c:pt>
                <c:pt idx="17">
                  <c:v>1.2313860252004599E-2</c:v>
                </c:pt>
                <c:pt idx="18">
                  <c:v>6.8728522336769802E-3</c:v>
                </c:pt>
                <c:pt idx="19">
                  <c:v>6.013745704467356E-3</c:v>
                </c:pt>
                <c:pt idx="20">
                  <c:v>4.8682703321878597E-3</c:v>
                </c:pt>
              </c:numCache>
            </c:numRef>
          </c:val>
        </c:ser>
        <c:ser>
          <c:idx val="14"/>
          <c:order val="14"/>
          <c:tx>
            <c:strRef>
              <c:f>'unc-25 A1_0.02_5%'!$P$104</c:f>
              <c:strCache>
                <c:ptCount val="1"/>
                <c:pt idx="0">
                  <c:v>unc-25_REX_A1_04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P$105:$P$125</c:f>
              <c:numCache>
                <c:formatCode>General</c:formatCode>
                <c:ptCount val="21"/>
                <c:pt idx="1">
                  <c:v>8.4415584415584347E-2</c:v>
                </c:pt>
                <c:pt idx="2">
                  <c:v>9.2803030303030304E-2</c:v>
                </c:pt>
                <c:pt idx="3">
                  <c:v>0.1087662337662342</c:v>
                </c:pt>
                <c:pt idx="4">
                  <c:v>0.102813852813853</c:v>
                </c:pt>
                <c:pt idx="5">
                  <c:v>8.3603896103896277E-2</c:v>
                </c:pt>
                <c:pt idx="6">
                  <c:v>5.9253246753246835E-2</c:v>
                </c:pt>
                <c:pt idx="7">
                  <c:v>5.2218614718614734E-2</c:v>
                </c:pt>
                <c:pt idx="8">
                  <c:v>4.1666666666666699E-2</c:v>
                </c:pt>
                <c:pt idx="9">
                  <c:v>3.6525974025974038E-2</c:v>
                </c:pt>
                <c:pt idx="10">
                  <c:v>3.2738095238095198E-2</c:v>
                </c:pt>
                <c:pt idx="11">
                  <c:v>3.3008658008657994E-2</c:v>
                </c:pt>
                <c:pt idx="12">
                  <c:v>2.4350649350649397E-2</c:v>
                </c:pt>
                <c:pt idx="13">
                  <c:v>2.4621212121212134E-2</c:v>
                </c:pt>
                <c:pt idx="14">
                  <c:v>2.1915584415584399E-2</c:v>
                </c:pt>
                <c:pt idx="15">
                  <c:v>2.0562770562770602E-2</c:v>
                </c:pt>
                <c:pt idx="16">
                  <c:v>2.2997835497835527E-2</c:v>
                </c:pt>
                <c:pt idx="17">
                  <c:v>1.4069264069264099E-2</c:v>
                </c:pt>
                <c:pt idx="18">
                  <c:v>1.3528138528138505E-2</c:v>
                </c:pt>
                <c:pt idx="19">
                  <c:v>1.1093073593073601E-2</c:v>
                </c:pt>
                <c:pt idx="20">
                  <c:v>7.3051948051948137E-3</c:v>
                </c:pt>
              </c:numCache>
            </c:numRef>
          </c:val>
        </c:ser>
        <c:ser>
          <c:idx val="15"/>
          <c:order val="15"/>
          <c:tx>
            <c:strRef>
              <c:f>'unc-25 A1_0.02_5%'!$Q$104</c:f>
              <c:strCache>
                <c:ptCount val="1"/>
                <c:pt idx="0">
                  <c:v>unc-25_REX_A1_06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Q$105:$Q$125</c:f>
              <c:numCache>
                <c:formatCode>General</c:formatCode>
                <c:ptCount val="21"/>
                <c:pt idx="1">
                  <c:v>9.0353697749196146E-2</c:v>
                </c:pt>
                <c:pt idx="2">
                  <c:v>0.11414790996784598</c:v>
                </c:pt>
                <c:pt idx="3">
                  <c:v>0.109967845659164</c:v>
                </c:pt>
                <c:pt idx="4">
                  <c:v>9.7749196141479214E-2</c:v>
                </c:pt>
                <c:pt idx="5">
                  <c:v>7.3633440514469406E-2</c:v>
                </c:pt>
                <c:pt idx="6">
                  <c:v>5.1125401929260413E-2</c:v>
                </c:pt>
                <c:pt idx="7">
                  <c:v>3.8263665594855299E-2</c:v>
                </c:pt>
                <c:pt idx="8">
                  <c:v>3.5369774919614128E-2</c:v>
                </c:pt>
                <c:pt idx="9">
                  <c:v>3.6655948553054755E-2</c:v>
                </c:pt>
                <c:pt idx="10">
                  <c:v>3.1511254019292598E-2</c:v>
                </c:pt>
                <c:pt idx="11">
                  <c:v>2.733118971061092E-2</c:v>
                </c:pt>
                <c:pt idx="12">
                  <c:v>2.8617363344051398E-2</c:v>
                </c:pt>
                <c:pt idx="13">
                  <c:v>2.4758842443729934E-2</c:v>
                </c:pt>
                <c:pt idx="14">
                  <c:v>2.9903536977491998E-2</c:v>
                </c:pt>
                <c:pt idx="15">
                  <c:v>2.28295819935691E-2</c:v>
                </c:pt>
                <c:pt idx="16">
                  <c:v>1.8971061093247601E-2</c:v>
                </c:pt>
                <c:pt idx="17">
                  <c:v>1.2540192926044993E-2</c:v>
                </c:pt>
                <c:pt idx="18">
                  <c:v>1.3504823151125401E-2</c:v>
                </c:pt>
                <c:pt idx="19">
                  <c:v>6.7524115755627024E-3</c:v>
                </c:pt>
                <c:pt idx="20">
                  <c:v>6.7524115755627024E-3</c:v>
                </c:pt>
              </c:numCache>
            </c:numRef>
          </c:val>
        </c:ser>
        <c:ser>
          <c:idx val="16"/>
          <c:order val="16"/>
          <c:tx>
            <c:strRef>
              <c:f>'unc-25 A1_0.02_5%'!$R$104</c:f>
              <c:strCache>
                <c:ptCount val="1"/>
                <c:pt idx="0">
                  <c:v>unc-25_REX_A1_07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R$105:$R$125</c:f>
              <c:numCache>
                <c:formatCode>General</c:formatCode>
                <c:ptCount val="21"/>
                <c:pt idx="1">
                  <c:v>7.6952822892498093E-2</c:v>
                </c:pt>
                <c:pt idx="2">
                  <c:v>9.2807424593967527E-2</c:v>
                </c:pt>
                <c:pt idx="3">
                  <c:v>0.11562258313998502</c:v>
                </c:pt>
                <c:pt idx="4">
                  <c:v>9.5901005413766449E-2</c:v>
                </c:pt>
                <c:pt idx="5">
                  <c:v>9.2420726991492702E-2</c:v>
                </c:pt>
                <c:pt idx="6">
                  <c:v>5.9938128383603996E-2</c:v>
                </c:pt>
                <c:pt idx="7">
                  <c:v>5.1430781129157013E-2</c:v>
                </c:pt>
                <c:pt idx="8">
                  <c:v>4.4470224284609422E-2</c:v>
                </c:pt>
                <c:pt idx="9">
                  <c:v>3.4416086620262999E-2</c:v>
                </c:pt>
                <c:pt idx="10">
                  <c:v>3.9443155452436228E-2</c:v>
                </c:pt>
                <c:pt idx="11">
                  <c:v>3.4802784222737797E-2</c:v>
                </c:pt>
                <c:pt idx="12">
                  <c:v>2.900232018561482E-2</c:v>
                </c:pt>
                <c:pt idx="13">
                  <c:v>2.3975251353441588E-2</c:v>
                </c:pt>
                <c:pt idx="14">
                  <c:v>2.2428460943542183E-2</c:v>
                </c:pt>
                <c:pt idx="15">
                  <c:v>1.7401392111368902E-2</c:v>
                </c:pt>
                <c:pt idx="16">
                  <c:v>1.27610208816705E-2</c:v>
                </c:pt>
                <c:pt idx="17">
                  <c:v>1.1214230471771091E-2</c:v>
                </c:pt>
                <c:pt idx="18">
                  <c:v>1.198762567672081E-2</c:v>
                </c:pt>
                <c:pt idx="19">
                  <c:v>8.5073472544470279E-3</c:v>
                </c:pt>
                <c:pt idx="20">
                  <c:v>7.7339520494972913E-3</c:v>
                </c:pt>
              </c:numCache>
            </c:numRef>
          </c:val>
        </c:ser>
        <c:ser>
          <c:idx val="17"/>
          <c:order val="17"/>
          <c:tx>
            <c:strRef>
              <c:f>'unc-25 A1_0.02_5%'!$S$104</c:f>
              <c:strCache>
                <c:ptCount val="1"/>
                <c:pt idx="0">
                  <c:v>unc-25_REX_A1_09</c:v>
                </c:pt>
              </c:strCache>
            </c:strRef>
          </c:tx>
          <c:marker>
            <c:symbol val="none"/>
          </c:marker>
          <c:cat>
            <c:numRef>
              <c:f>'unc-25 A1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1_0.02_5%'!$S$105:$S$125</c:f>
              <c:numCache>
                <c:formatCode>General</c:formatCode>
                <c:ptCount val="21"/>
                <c:pt idx="1">
                  <c:v>6.6880684858213094E-2</c:v>
                </c:pt>
                <c:pt idx="2">
                  <c:v>8.2932049224184082E-2</c:v>
                </c:pt>
                <c:pt idx="3">
                  <c:v>0.10299625468164811</c:v>
                </c:pt>
                <c:pt idx="4">
                  <c:v>9.2027822364901077E-2</c:v>
                </c:pt>
                <c:pt idx="5">
                  <c:v>8.9085072231139706E-2</c:v>
                </c:pt>
                <c:pt idx="6">
                  <c:v>6.0727661851257463E-2</c:v>
                </c:pt>
                <c:pt idx="7">
                  <c:v>5.3772070626003241E-2</c:v>
                </c:pt>
                <c:pt idx="8">
                  <c:v>4.7084002140181914E-2</c:v>
                </c:pt>
                <c:pt idx="9">
                  <c:v>4.4408774745853433E-2</c:v>
                </c:pt>
                <c:pt idx="10">
                  <c:v>3.1300160513643725E-2</c:v>
                </c:pt>
                <c:pt idx="11">
                  <c:v>3.1300160513643725E-2</c:v>
                </c:pt>
                <c:pt idx="12">
                  <c:v>3.2102728731942198E-2</c:v>
                </c:pt>
                <c:pt idx="13">
                  <c:v>2.9695024077046599E-2</c:v>
                </c:pt>
                <c:pt idx="14">
                  <c:v>2.67522739432852E-2</c:v>
                </c:pt>
                <c:pt idx="15">
                  <c:v>2.4879614767255219E-2</c:v>
                </c:pt>
                <c:pt idx="16">
                  <c:v>1.6318887105403999E-2</c:v>
                </c:pt>
                <c:pt idx="17">
                  <c:v>1.5516318887105399E-2</c:v>
                </c:pt>
                <c:pt idx="18">
                  <c:v>1.2573568753343999E-2</c:v>
                </c:pt>
                <c:pt idx="19">
                  <c:v>1.20385232744783E-2</c:v>
                </c:pt>
                <c:pt idx="20">
                  <c:v>9.8983413590155202E-3</c:v>
                </c:pt>
              </c:numCache>
            </c:numRef>
          </c:val>
        </c:ser>
        <c:marker val="1"/>
        <c:axId val="157734016"/>
        <c:axId val="157735552"/>
      </c:lineChart>
      <c:catAx>
        <c:axId val="157734016"/>
        <c:scaling>
          <c:orientation val="minMax"/>
        </c:scaling>
        <c:axPos val="b"/>
        <c:numFmt formatCode="#,##0.0_);\(#,##0.0\)" sourceLinked="0"/>
        <c:tickLblPos val="nextTo"/>
        <c:crossAx val="157735552"/>
        <c:crosses val="autoZero"/>
        <c:auto val="1"/>
        <c:lblAlgn val="ctr"/>
        <c:lblOffset val="100"/>
        <c:tickLblSkip val="5"/>
        <c:tickMarkSkip val="5"/>
      </c:catAx>
      <c:valAx>
        <c:axId val="15773555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7734016"/>
        <c:crosses val="autoZero"/>
        <c:crossBetween val="between"/>
      </c:valAx>
    </c:plotArea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A3_0.02_5%'!$B$104</c:f>
              <c:strCache>
                <c:ptCount val="1"/>
                <c:pt idx="0">
                  <c:v>unc-25_A3_40_30_01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B$105:$B$125</c:f>
              <c:numCache>
                <c:formatCode>General</c:formatCode>
                <c:ptCount val="21"/>
                <c:pt idx="1">
                  <c:v>8.7771203155818503E-2</c:v>
                </c:pt>
                <c:pt idx="2">
                  <c:v>9.4181459566074974E-2</c:v>
                </c:pt>
                <c:pt idx="3">
                  <c:v>0.12771203155818511</c:v>
                </c:pt>
                <c:pt idx="4">
                  <c:v>9.9605522682445921E-2</c:v>
                </c:pt>
                <c:pt idx="5">
                  <c:v>9.0236686390532506E-2</c:v>
                </c:pt>
                <c:pt idx="6">
                  <c:v>6.6074950690335296E-2</c:v>
                </c:pt>
                <c:pt idx="7">
                  <c:v>7.4457593688362897E-2</c:v>
                </c:pt>
                <c:pt idx="8">
                  <c:v>4.4871794871794914E-2</c:v>
                </c:pt>
                <c:pt idx="9">
                  <c:v>4.2406311637080904E-2</c:v>
                </c:pt>
                <c:pt idx="10">
                  <c:v>3.7475345167652947E-2</c:v>
                </c:pt>
                <c:pt idx="11">
                  <c:v>3.0078895463510835E-2</c:v>
                </c:pt>
                <c:pt idx="12">
                  <c:v>2.5147928994082788E-2</c:v>
                </c:pt>
                <c:pt idx="13">
                  <c:v>2.0710059171597583E-2</c:v>
                </c:pt>
                <c:pt idx="14">
                  <c:v>1.9230769230769221E-2</c:v>
                </c:pt>
                <c:pt idx="15">
                  <c:v>1.3806706114398401E-2</c:v>
                </c:pt>
                <c:pt idx="16">
                  <c:v>9.3688362919132281E-3</c:v>
                </c:pt>
                <c:pt idx="17">
                  <c:v>7.3964497041420193E-3</c:v>
                </c:pt>
                <c:pt idx="18">
                  <c:v>4.9309664694280114E-3</c:v>
                </c:pt>
                <c:pt idx="19">
                  <c:v>2.9585798816568012E-3</c:v>
                </c:pt>
                <c:pt idx="20">
                  <c:v>3.4516765285996119E-3</c:v>
                </c:pt>
              </c:numCache>
            </c:numRef>
          </c:val>
        </c:ser>
        <c:ser>
          <c:idx val="1"/>
          <c:order val="1"/>
          <c:tx>
            <c:strRef>
              <c:f>'unc-25 A3_0.02_5%'!$C$104</c:f>
              <c:strCache>
                <c:ptCount val="1"/>
                <c:pt idx="0">
                  <c:v>unc-25_A3_40_30_03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C$105:$C$125</c:f>
              <c:numCache>
                <c:formatCode>General</c:formatCode>
                <c:ptCount val="21"/>
                <c:pt idx="1">
                  <c:v>7.6543209876543214E-2</c:v>
                </c:pt>
                <c:pt idx="2">
                  <c:v>0.10222222222222214</c:v>
                </c:pt>
                <c:pt idx="3">
                  <c:v>9.9753086419753098E-2</c:v>
                </c:pt>
                <c:pt idx="4">
                  <c:v>9.6790123456790098E-2</c:v>
                </c:pt>
                <c:pt idx="5">
                  <c:v>8.2962962962963072E-2</c:v>
                </c:pt>
                <c:pt idx="6">
                  <c:v>7.4074074074074098E-2</c:v>
                </c:pt>
                <c:pt idx="7">
                  <c:v>6.2222222222222241E-2</c:v>
                </c:pt>
                <c:pt idx="8">
                  <c:v>5.6296296296296337E-2</c:v>
                </c:pt>
                <c:pt idx="9">
                  <c:v>4.8395061728395104E-2</c:v>
                </c:pt>
                <c:pt idx="10">
                  <c:v>4.5925925925925912E-2</c:v>
                </c:pt>
                <c:pt idx="11">
                  <c:v>3.4567901234567884E-2</c:v>
                </c:pt>
                <c:pt idx="12">
                  <c:v>3.0617283950617299E-2</c:v>
                </c:pt>
                <c:pt idx="13">
                  <c:v>1.6790123456790103E-2</c:v>
                </c:pt>
                <c:pt idx="14">
                  <c:v>1.4320987654320999E-2</c:v>
                </c:pt>
                <c:pt idx="15">
                  <c:v>1.7777777777777802E-2</c:v>
                </c:pt>
                <c:pt idx="16">
                  <c:v>1.2839506172839498E-2</c:v>
                </c:pt>
                <c:pt idx="17">
                  <c:v>5.92592592592593E-3</c:v>
                </c:pt>
                <c:pt idx="18">
                  <c:v>6.419753086419757E-3</c:v>
                </c:pt>
                <c:pt idx="19">
                  <c:v>2.4691358024691418E-3</c:v>
                </c:pt>
                <c:pt idx="20">
                  <c:v>2.9629629629629619E-3</c:v>
                </c:pt>
              </c:numCache>
            </c:numRef>
          </c:val>
        </c:ser>
        <c:ser>
          <c:idx val="2"/>
          <c:order val="2"/>
          <c:tx>
            <c:strRef>
              <c:f>'unc-25 A3_0.02_5%'!$D$104</c:f>
              <c:strCache>
                <c:ptCount val="1"/>
                <c:pt idx="0">
                  <c:v>unc-25_A3_40_30_2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D$105:$D$125</c:f>
              <c:numCache>
                <c:formatCode>General</c:formatCode>
                <c:ptCount val="21"/>
                <c:pt idx="1">
                  <c:v>9.2942345924453398E-2</c:v>
                </c:pt>
                <c:pt idx="2">
                  <c:v>0.11232604373757506</c:v>
                </c:pt>
                <c:pt idx="3">
                  <c:v>0.10337972166998002</c:v>
                </c:pt>
                <c:pt idx="4">
                  <c:v>9.8409542743538844E-2</c:v>
                </c:pt>
                <c:pt idx="5">
                  <c:v>6.6600397614314105E-2</c:v>
                </c:pt>
                <c:pt idx="6">
                  <c:v>5.7157057654075499E-2</c:v>
                </c:pt>
                <c:pt idx="7">
                  <c:v>4.5725646123260397E-2</c:v>
                </c:pt>
                <c:pt idx="8">
                  <c:v>4.7216699801192863E-2</c:v>
                </c:pt>
                <c:pt idx="9">
                  <c:v>3.7276341948310129E-2</c:v>
                </c:pt>
                <c:pt idx="10">
                  <c:v>3.08151093439364E-2</c:v>
                </c:pt>
                <c:pt idx="11">
                  <c:v>2.9324055666004E-2</c:v>
                </c:pt>
                <c:pt idx="12">
                  <c:v>2.2862823061630198E-2</c:v>
                </c:pt>
                <c:pt idx="13">
                  <c:v>2.0377733598409525E-2</c:v>
                </c:pt>
                <c:pt idx="14">
                  <c:v>1.9383697813121301E-2</c:v>
                </c:pt>
                <c:pt idx="15">
                  <c:v>1.2922465208747515E-2</c:v>
                </c:pt>
                <c:pt idx="16">
                  <c:v>9.9403578528827075E-3</c:v>
                </c:pt>
                <c:pt idx="17">
                  <c:v>5.9642147117296238E-3</c:v>
                </c:pt>
                <c:pt idx="18">
                  <c:v>6.9582504970178939E-3</c:v>
                </c:pt>
                <c:pt idx="19">
                  <c:v>1.4910536779324101E-3</c:v>
                </c:pt>
                <c:pt idx="20">
                  <c:v>5.4671968190854849E-3</c:v>
                </c:pt>
              </c:numCache>
            </c:numRef>
          </c:val>
        </c:ser>
        <c:ser>
          <c:idx val="3"/>
          <c:order val="3"/>
          <c:tx>
            <c:strRef>
              <c:f>'unc-25 A3_0.02_5%'!$E$104</c:f>
              <c:strCache>
                <c:ptCount val="1"/>
                <c:pt idx="0">
                  <c:v>unc-25_A3_40_30_4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E$105:$E$125</c:f>
              <c:numCache>
                <c:formatCode>General</c:formatCode>
                <c:ptCount val="21"/>
                <c:pt idx="1">
                  <c:v>6.9489185457892302E-2</c:v>
                </c:pt>
                <c:pt idx="2">
                  <c:v>8.973768982972849E-2</c:v>
                </c:pt>
                <c:pt idx="3">
                  <c:v>0.11596870685688006</c:v>
                </c:pt>
                <c:pt idx="4">
                  <c:v>0.10952600092038711</c:v>
                </c:pt>
                <c:pt idx="5">
                  <c:v>9.2498849516797169E-2</c:v>
                </c:pt>
                <c:pt idx="6">
                  <c:v>7.5011504832029549E-2</c:v>
                </c:pt>
                <c:pt idx="7">
                  <c:v>5.2922227335480937E-2</c:v>
                </c:pt>
                <c:pt idx="8">
                  <c:v>5.0621260929590413E-2</c:v>
                </c:pt>
                <c:pt idx="9">
                  <c:v>4.4638748274275157E-2</c:v>
                </c:pt>
                <c:pt idx="10">
                  <c:v>4.2797975149562836E-2</c:v>
                </c:pt>
                <c:pt idx="11">
                  <c:v>3.1753336401288502E-2</c:v>
                </c:pt>
                <c:pt idx="12">
                  <c:v>2.8071790151863819E-2</c:v>
                </c:pt>
                <c:pt idx="13">
                  <c:v>2.2089277496548626E-2</c:v>
                </c:pt>
                <c:pt idx="14">
                  <c:v>2.300966405890471E-2</c:v>
                </c:pt>
                <c:pt idx="15">
                  <c:v>1.2425218591808599E-2</c:v>
                </c:pt>
                <c:pt idx="16">
                  <c:v>1.8407731247123818E-2</c:v>
                </c:pt>
                <c:pt idx="17">
                  <c:v>9.6640589047399979E-3</c:v>
                </c:pt>
                <c:pt idx="18">
                  <c:v>5.9825126553152324E-3</c:v>
                </c:pt>
                <c:pt idx="19">
                  <c:v>7.3630924988495293E-3</c:v>
                </c:pt>
                <c:pt idx="20">
                  <c:v>3.2213529682466619E-3</c:v>
                </c:pt>
              </c:numCache>
            </c:numRef>
          </c:val>
        </c:ser>
        <c:ser>
          <c:idx val="4"/>
          <c:order val="4"/>
          <c:tx>
            <c:strRef>
              <c:f>'unc-25 A3_0.02_5%'!$F$104</c:f>
              <c:strCache>
                <c:ptCount val="1"/>
                <c:pt idx="0">
                  <c:v>unc-25_REX_A3_01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F$105:$F$125</c:f>
              <c:numCache>
                <c:formatCode>General</c:formatCode>
                <c:ptCount val="21"/>
                <c:pt idx="1">
                  <c:v>9.6701437834790002E-2</c:v>
                </c:pt>
                <c:pt idx="2">
                  <c:v>0.11559063997744599</c:v>
                </c:pt>
                <c:pt idx="3">
                  <c:v>0.10487736115026793</c:v>
                </c:pt>
                <c:pt idx="4">
                  <c:v>9.5855652664223426E-2</c:v>
                </c:pt>
                <c:pt idx="5">
                  <c:v>7.8094164082323114E-2</c:v>
                </c:pt>
                <c:pt idx="6">
                  <c:v>6.1460389061178497E-2</c:v>
                </c:pt>
                <c:pt idx="7">
                  <c:v>4.1725401747955998E-2</c:v>
                </c:pt>
                <c:pt idx="8">
                  <c:v>3.7778404285311498E-2</c:v>
                </c:pt>
                <c:pt idx="9">
                  <c:v>4.6236255990978303E-2</c:v>
                </c:pt>
                <c:pt idx="10">
                  <c:v>3.35494784324782E-2</c:v>
                </c:pt>
                <c:pt idx="11">
                  <c:v>3.101212292077812E-2</c:v>
                </c:pt>
                <c:pt idx="12">
                  <c:v>2.7065125458133624E-2</c:v>
                </c:pt>
                <c:pt idx="13">
                  <c:v>2.81928390188892E-2</c:v>
                </c:pt>
                <c:pt idx="14">
                  <c:v>1.9453058923033603E-2</c:v>
                </c:pt>
                <c:pt idx="15">
                  <c:v>1.5787989850578003E-2</c:v>
                </c:pt>
                <c:pt idx="16">
                  <c:v>1.3814491119255709E-2</c:v>
                </c:pt>
                <c:pt idx="17">
                  <c:v>7.8939949252889805E-3</c:v>
                </c:pt>
                <c:pt idx="18">
                  <c:v>5.9204961939667358E-3</c:v>
                </c:pt>
                <c:pt idx="19">
                  <c:v>4.7927826332111638E-3</c:v>
                </c:pt>
                <c:pt idx="20">
                  <c:v>3.6650690724556022E-3</c:v>
                </c:pt>
              </c:numCache>
            </c:numRef>
          </c:val>
        </c:ser>
        <c:ser>
          <c:idx val="5"/>
          <c:order val="5"/>
          <c:tx>
            <c:strRef>
              <c:f>'unc-25 A3_0.02_5%'!$G$104</c:f>
              <c:strCache>
                <c:ptCount val="1"/>
                <c:pt idx="0">
                  <c:v>unc-25_REX_A3_03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G$105:$G$125</c:f>
              <c:numCache>
                <c:formatCode>General</c:formatCode>
                <c:ptCount val="21"/>
                <c:pt idx="1">
                  <c:v>8.5830666278731524E-2</c:v>
                </c:pt>
                <c:pt idx="2">
                  <c:v>0.101251091067792</c:v>
                </c:pt>
                <c:pt idx="3">
                  <c:v>0.11114343904567905</c:v>
                </c:pt>
                <c:pt idx="4">
                  <c:v>0.10066918824556299</c:v>
                </c:pt>
                <c:pt idx="5">
                  <c:v>8.2048297934244993E-2</c:v>
                </c:pt>
                <c:pt idx="6">
                  <c:v>7.622926971195805E-2</c:v>
                </c:pt>
                <c:pt idx="7">
                  <c:v>5.5280768111725304E-2</c:v>
                </c:pt>
                <c:pt idx="8">
                  <c:v>5.0334594122781552E-2</c:v>
                </c:pt>
                <c:pt idx="9">
                  <c:v>4.18970032004655E-2</c:v>
                </c:pt>
                <c:pt idx="10">
                  <c:v>3.6659877800407352E-2</c:v>
                </c:pt>
                <c:pt idx="11">
                  <c:v>2.6476578411405337E-2</c:v>
                </c:pt>
                <c:pt idx="12">
                  <c:v>2.7931335466977052E-2</c:v>
                </c:pt>
                <c:pt idx="13">
                  <c:v>2.2985161478033235E-2</c:v>
                </c:pt>
                <c:pt idx="14">
                  <c:v>1.83299389002037E-2</c:v>
                </c:pt>
                <c:pt idx="15">
                  <c:v>1.3674716322374198E-2</c:v>
                </c:pt>
                <c:pt idx="16">
                  <c:v>1.16380564445738E-2</c:v>
                </c:pt>
                <c:pt idx="17">
                  <c:v>1.0183299389002009E-2</c:v>
                </c:pt>
                <c:pt idx="18">
                  <c:v>9.0194937445446689E-3</c:v>
                </c:pt>
                <c:pt idx="19">
                  <c:v>5.8190282222868837E-3</c:v>
                </c:pt>
                <c:pt idx="20">
                  <c:v>2.9095141111434419E-3</c:v>
                </c:pt>
              </c:numCache>
            </c:numRef>
          </c:val>
        </c:ser>
        <c:ser>
          <c:idx val="6"/>
          <c:order val="6"/>
          <c:tx>
            <c:strRef>
              <c:f>'unc-25 A3_0.02_5%'!$H$104</c:f>
              <c:strCache>
                <c:ptCount val="1"/>
                <c:pt idx="0">
                  <c:v>unc-25_REX_A3_04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H$105:$H$125</c:f>
              <c:numCache>
                <c:formatCode>General</c:formatCode>
                <c:ptCount val="21"/>
                <c:pt idx="1">
                  <c:v>0.10416666666666707</c:v>
                </c:pt>
                <c:pt idx="2">
                  <c:v>0.11666666666666706</c:v>
                </c:pt>
                <c:pt idx="3">
                  <c:v>0.119345238095238</c:v>
                </c:pt>
                <c:pt idx="4">
                  <c:v>0.10327380952381007</c:v>
                </c:pt>
                <c:pt idx="5">
                  <c:v>9.3154761904762004E-2</c:v>
                </c:pt>
                <c:pt idx="6">
                  <c:v>5.8928571428571414E-2</c:v>
                </c:pt>
                <c:pt idx="7">
                  <c:v>4.1964285714285697E-2</c:v>
                </c:pt>
                <c:pt idx="8">
                  <c:v>4.4940476190476197E-2</c:v>
                </c:pt>
                <c:pt idx="9">
                  <c:v>3.5714285714285698E-2</c:v>
                </c:pt>
                <c:pt idx="10">
                  <c:v>3.3333333333333298E-2</c:v>
                </c:pt>
                <c:pt idx="11">
                  <c:v>3.0952380952380999E-2</c:v>
                </c:pt>
                <c:pt idx="12">
                  <c:v>2.2619047619047629E-2</c:v>
                </c:pt>
                <c:pt idx="13">
                  <c:v>1.8749999999999999E-2</c:v>
                </c:pt>
                <c:pt idx="14">
                  <c:v>1.2797619047619007E-2</c:v>
                </c:pt>
                <c:pt idx="15">
                  <c:v>1.01190476190476E-2</c:v>
                </c:pt>
                <c:pt idx="16">
                  <c:v>7.440476190476197E-3</c:v>
                </c:pt>
                <c:pt idx="17">
                  <c:v>6.5476190476190504E-3</c:v>
                </c:pt>
                <c:pt idx="18">
                  <c:v>6.2500000000000038E-3</c:v>
                </c:pt>
                <c:pt idx="19">
                  <c:v>3.86904761904762E-3</c:v>
                </c:pt>
                <c:pt idx="20">
                  <c:v>1.4880952380952408E-3</c:v>
                </c:pt>
              </c:numCache>
            </c:numRef>
          </c:val>
        </c:ser>
        <c:ser>
          <c:idx val="7"/>
          <c:order val="7"/>
          <c:tx>
            <c:strRef>
              <c:f>'unc-25 A3_0.02_5%'!$I$104</c:f>
              <c:strCache>
                <c:ptCount val="1"/>
                <c:pt idx="0">
                  <c:v>unc-25_REX_A3_05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I$105:$I$125</c:f>
              <c:numCache>
                <c:formatCode>General</c:formatCode>
                <c:ptCount val="21"/>
                <c:pt idx="1">
                  <c:v>0.10218767990788702</c:v>
                </c:pt>
                <c:pt idx="2">
                  <c:v>0.11370178468624108</c:v>
                </c:pt>
                <c:pt idx="3">
                  <c:v>0.11283822682786394</c:v>
                </c:pt>
                <c:pt idx="4">
                  <c:v>9.2688543465745496E-2</c:v>
                </c:pt>
                <c:pt idx="5">
                  <c:v>7.6856649395509499E-2</c:v>
                </c:pt>
                <c:pt idx="6">
                  <c:v>6.3615428900403004E-2</c:v>
                </c:pt>
                <c:pt idx="7">
                  <c:v>5.3252734599884895E-2</c:v>
                </c:pt>
                <c:pt idx="8">
                  <c:v>4.6344271732872797E-2</c:v>
                </c:pt>
                <c:pt idx="9">
                  <c:v>3.6845135290731128E-2</c:v>
                </c:pt>
                <c:pt idx="10">
                  <c:v>3.7996545768566536E-2</c:v>
                </c:pt>
                <c:pt idx="11">
                  <c:v>3.25273459988486E-2</c:v>
                </c:pt>
                <c:pt idx="12">
                  <c:v>2.3891767415083542E-2</c:v>
                </c:pt>
                <c:pt idx="13">
                  <c:v>2.3603914795624618E-2</c:v>
                </c:pt>
                <c:pt idx="14">
                  <c:v>1.2665515256188812E-2</c:v>
                </c:pt>
                <c:pt idx="15">
                  <c:v>1.09383995394358E-2</c:v>
                </c:pt>
                <c:pt idx="16">
                  <c:v>6.6206102475532495E-3</c:v>
                </c:pt>
                <c:pt idx="17">
                  <c:v>5.7570523891767424E-3</c:v>
                </c:pt>
                <c:pt idx="18">
                  <c:v>4.6056419113413936E-3</c:v>
                </c:pt>
                <c:pt idx="19">
                  <c:v>3.1663788140472099E-3</c:v>
                </c:pt>
                <c:pt idx="20">
                  <c:v>1.4392630972941882E-3</c:v>
                </c:pt>
              </c:numCache>
            </c:numRef>
          </c:val>
        </c:ser>
        <c:ser>
          <c:idx val="8"/>
          <c:order val="8"/>
          <c:tx>
            <c:strRef>
              <c:f>'unc-25 A3_0.02_5%'!$J$104</c:f>
              <c:strCache>
                <c:ptCount val="1"/>
                <c:pt idx="0">
                  <c:v>unc-25_REX_A3_06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J$105:$J$125</c:f>
              <c:numCache>
                <c:formatCode>General</c:formatCode>
                <c:ptCount val="21"/>
                <c:pt idx="1">
                  <c:v>0.112340131351538</c:v>
                </c:pt>
                <c:pt idx="2">
                  <c:v>0.11406844106463908</c:v>
                </c:pt>
                <c:pt idx="3">
                  <c:v>0.11406844106463908</c:v>
                </c:pt>
                <c:pt idx="4">
                  <c:v>8.9526443138610606E-2</c:v>
                </c:pt>
                <c:pt idx="5">
                  <c:v>7.1206360179744202E-2</c:v>
                </c:pt>
                <c:pt idx="6">
                  <c:v>4.3207742827514696E-2</c:v>
                </c:pt>
                <c:pt idx="7">
                  <c:v>4.0096785343933683E-2</c:v>
                </c:pt>
                <c:pt idx="8">
                  <c:v>3.6640165917732531E-2</c:v>
                </c:pt>
                <c:pt idx="9">
                  <c:v>3.6640165917732531E-2</c:v>
                </c:pt>
                <c:pt idx="10">
                  <c:v>3.3183546491531303E-2</c:v>
                </c:pt>
                <c:pt idx="11">
                  <c:v>2.7307293466989336E-2</c:v>
                </c:pt>
                <c:pt idx="12">
                  <c:v>2.6615969581749034E-2</c:v>
                </c:pt>
                <c:pt idx="13">
                  <c:v>1.7974421016246113E-2</c:v>
                </c:pt>
                <c:pt idx="14">
                  <c:v>1.1752506049084012E-2</c:v>
                </c:pt>
                <c:pt idx="15">
                  <c:v>9.3328724507431727E-3</c:v>
                </c:pt>
                <c:pt idx="16">
                  <c:v>8.9872105081230721E-3</c:v>
                </c:pt>
                <c:pt idx="17">
                  <c:v>3.8022813688212941E-3</c:v>
                </c:pt>
                <c:pt idx="18">
                  <c:v>3.1109574835810612E-3</c:v>
                </c:pt>
                <c:pt idx="19">
                  <c:v>1.382647770480471E-3</c:v>
                </c:pt>
                <c:pt idx="20">
                  <c:v>3.4566194262011801E-4</c:v>
                </c:pt>
              </c:numCache>
            </c:numRef>
          </c:val>
        </c:ser>
        <c:ser>
          <c:idx val="9"/>
          <c:order val="9"/>
          <c:tx>
            <c:strRef>
              <c:f>'unc-25 A3_0.02_5%'!$K$104</c:f>
              <c:strCache>
                <c:ptCount val="1"/>
                <c:pt idx="0">
                  <c:v>unc-25_REX_A3_08</c:v>
                </c:pt>
              </c:strCache>
            </c:strRef>
          </c:tx>
          <c:marker>
            <c:symbol val="none"/>
          </c:marker>
          <c:cat>
            <c:numRef>
              <c:f>'unc-25 A3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3_0.02_5%'!$K$105:$K$125</c:f>
              <c:numCache>
                <c:formatCode>General</c:formatCode>
                <c:ptCount val="21"/>
                <c:pt idx="1">
                  <c:v>9.0178058587019078E-2</c:v>
                </c:pt>
                <c:pt idx="2">
                  <c:v>0.11229178632969605</c:v>
                </c:pt>
                <c:pt idx="3">
                  <c:v>0.10941987363584101</c:v>
                </c:pt>
                <c:pt idx="4">
                  <c:v>0.10022975301550806</c:v>
                </c:pt>
                <c:pt idx="5">
                  <c:v>7.8403216542217102E-2</c:v>
                </c:pt>
                <c:pt idx="6">
                  <c:v>5.7438253877082103E-2</c:v>
                </c:pt>
                <c:pt idx="7">
                  <c:v>5.0832854681217704E-2</c:v>
                </c:pt>
                <c:pt idx="8">
                  <c:v>4.9684089603675985E-2</c:v>
                </c:pt>
                <c:pt idx="9">
                  <c:v>4.5089029293509497E-2</c:v>
                </c:pt>
                <c:pt idx="10">
                  <c:v>3.8483630097645001E-2</c:v>
                </c:pt>
                <c:pt idx="11">
                  <c:v>3.3888569787478499E-2</c:v>
                </c:pt>
                <c:pt idx="12">
                  <c:v>2.8431935669155743E-2</c:v>
                </c:pt>
                <c:pt idx="13">
                  <c:v>2.1539345203905828E-2</c:v>
                </c:pt>
                <c:pt idx="14">
                  <c:v>1.8954623779437112E-2</c:v>
                </c:pt>
                <c:pt idx="15">
                  <c:v>1.5221137277426801E-2</c:v>
                </c:pt>
                <c:pt idx="16">
                  <c:v>1.1487650775416403E-2</c:v>
                </c:pt>
                <c:pt idx="17">
                  <c:v>1.03388856978748E-2</c:v>
                </c:pt>
                <c:pt idx="18">
                  <c:v>7.4669730040206892E-3</c:v>
                </c:pt>
                <c:pt idx="19">
                  <c:v>3.4462952326249335E-3</c:v>
                </c:pt>
                <c:pt idx="20">
                  <c:v>2.0103388856978718E-3</c:v>
                </c:pt>
              </c:numCache>
            </c:numRef>
          </c:val>
        </c:ser>
        <c:marker val="1"/>
        <c:axId val="157788800"/>
        <c:axId val="157806976"/>
      </c:lineChart>
      <c:catAx>
        <c:axId val="157788800"/>
        <c:scaling>
          <c:orientation val="minMax"/>
        </c:scaling>
        <c:axPos val="b"/>
        <c:numFmt formatCode="#,##0.0_);\(#,##0.0\)" sourceLinked="0"/>
        <c:tickLblPos val="nextTo"/>
        <c:crossAx val="157806976"/>
        <c:crosses val="autoZero"/>
        <c:auto val="1"/>
        <c:lblAlgn val="ctr"/>
        <c:lblOffset val="100"/>
        <c:tickLblSkip val="5"/>
        <c:tickMarkSkip val="5"/>
      </c:catAx>
      <c:valAx>
        <c:axId val="15780697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7788800"/>
        <c:crosses val="autoZero"/>
        <c:crossBetween val="between"/>
      </c:valAx>
    </c:plotArea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A5_0.02_5%'!$B$104</c:f>
              <c:strCache>
                <c:ptCount val="1"/>
                <c:pt idx="0">
                  <c:v>unc-25_A5_001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B$105:$B$125</c:f>
              <c:numCache>
                <c:formatCode>General</c:formatCode>
                <c:ptCount val="21"/>
                <c:pt idx="1">
                  <c:v>9.3645484949832922E-2</c:v>
                </c:pt>
                <c:pt idx="2">
                  <c:v>0.11304347826087002</c:v>
                </c:pt>
                <c:pt idx="3">
                  <c:v>9.8996655518394788E-2</c:v>
                </c:pt>
                <c:pt idx="4">
                  <c:v>7.1571906354515005E-2</c:v>
                </c:pt>
                <c:pt idx="5">
                  <c:v>7.2909698996655503E-2</c:v>
                </c:pt>
                <c:pt idx="6">
                  <c:v>6.8227424749163906E-2</c:v>
                </c:pt>
                <c:pt idx="7">
                  <c:v>5.6187290969899703E-2</c:v>
                </c:pt>
                <c:pt idx="8">
                  <c:v>5.1505016722407974E-2</c:v>
                </c:pt>
                <c:pt idx="9">
                  <c:v>3.3444816053511697E-2</c:v>
                </c:pt>
                <c:pt idx="10">
                  <c:v>4.0133779264213999E-2</c:v>
                </c:pt>
                <c:pt idx="11">
                  <c:v>3.2107023411371227E-2</c:v>
                </c:pt>
                <c:pt idx="12">
                  <c:v>2.5418060200668901E-2</c:v>
                </c:pt>
                <c:pt idx="13">
                  <c:v>2.0735785953177311E-2</c:v>
                </c:pt>
                <c:pt idx="14">
                  <c:v>1.9397993311036799E-2</c:v>
                </c:pt>
                <c:pt idx="15">
                  <c:v>1.6722408026755915E-2</c:v>
                </c:pt>
                <c:pt idx="16">
                  <c:v>1.07023411371237E-2</c:v>
                </c:pt>
                <c:pt idx="17">
                  <c:v>1.1371237458193998E-2</c:v>
                </c:pt>
                <c:pt idx="18">
                  <c:v>7.3578595317725804E-3</c:v>
                </c:pt>
                <c:pt idx="19">
                  <c:v>5.35117056856187E-3</c:v>
                </c:pt>
                <c:pt idx="20">
                  <c:v>2.6755852842809428E-3</c:v>
                </c:pt>
              </c:numCache>
            </c:numRef>
          </c:val>
        </c:ser>
        <c:ser>
          <c:idx val="1"/>
          <c:order val="1"/>
          <c:tx>
            <c:strRef>
              <c:f>'unc-25 A5_0.02_5%'!$C$104</c:f>
              <c:strCache>
                <c:ptCount val="1"/>
                <c:pt idx="0">
                  <c:v>unc-25_A5_002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C$105:$C$125</c:f>
              <c:numCache>
                <c:formatCode>General</c:formatCode>
                <c:ptCount val="21"/>
                <c:pt idx="1">
                  <c:v>8.9425587467362927E-2</c:v>
                </c:pt>
                <c:pt idx="2">
                  <c:v>9.9869451697127895E-2</c:v>
                </c:pt>
                <c:pt idx="3">
                  <c:v>9.5953002610966176E-2</c:v>
                </c:pt>
                <c:pt idx="4">
                  <c:v>8.4856396866840822E-2</c:v>
                </c:pt>
                <c:pt idx="5">
                  <c:v>7.8981723237597903E-2</c:v>
                </c:pt>
                <c:pt idx="6">
                  <c:v>5.9399477806788586E-2</c:v>
                </c:pt>
                <c:pt idx="7">
                  <c:v>4.89556135770235E-2</c:v>
                </c:pt>
                <c:pt idx="8">
                  <c:v>4.4386422976501402E-2</c:v>
                </c:pt>
                <c:pt idx="9">
                  <c:v>4.6997389033942641E-2</c:v>
                </c:pt>
                <c:pt idx="10">
                  <c:v>3.6553524804177499E-2</c:v>
                </c:pt>
                <c:pt idx="11">
                  <c:v>3.5900783289817204E-2</c:v>
                </c:pt>
                <c:pt idx="12">
                  <c:v>3.0678851174934699E-2</c:v>
                </c:pt>
                <c:pt idx="13">
                  <c:v>2.9373368146214135E-2</c:v>
                </c:pt>
                <c:pt idx="14">
                  <c:v>1.5665796344647501E-2</c:v>
                </c:pt>
                <c:pt idx="15">
                  <c:v>1.1096605744125309E-2</c:v>
                </c:pt>
                <c:pt idx="16">
                  <c:v>1.3707571801566617E-2</c:v>
                </c:pt>
                <c:pt idx="17">
                  <c:v>1.1749347258485601E-2</c:v>
                </c:pt>
                <c:pt idx="18">
                  <c:v>4.5691906005221935E-3</c:v>
                </c:pt>
                <c:pt idx="19">
                  <c:v>3.2637075718015755E-3</c:v>
                </c:pt>
                <c:pt idx="20">
                  <c:v>7.8328981723237677E-3</c:v>
                </c:pt>
              </c:numCache>
            </c:numRef>
          </c:val>
        </c:ser>
        <c:ser>
          <c:idx val="2"/>
          <c:order val="2"/>
          <c:tx>
            <c:strRef>
              <c:f>'unc-25 A5_0.02_5%'!$D$104</c:f>
              <c:strCache>
                <c:ptCount val="1"/>
                <c:pt idx="0">
                  <c:v>unc-25_A5_003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D$105:$D$125</c:f>
              <c:numCache>
                <c:formatCode>General</c:formatCode>
                <c:ptCount val="21"/>
                <c:pt idx="1">
                  <c:v>9.5882990249187394E-2</c:v>
                </c:pt>
                <c:pt idx="2">
                  <c:v>0.10130010834236194</c:v>
                </c:pt>
                <c:pt idx="3">
                  <c:v>9.4257854821235096E-2</c:v>
                </c:pt>
                <c:pt idx="4">
                  <c:v>9.5882990249187394E-2</c:v>
                </c:pt>
                <c:pt idx="5">
                  <c:v>9.3716143011917705E-2</c:v>
                </c:pt>
                <c:pt idx="6">
                  <c:v>7.8006500541711862E-2</c:v>
                </c:pt>
                <c:pt idx="7">
                  <c:v>7.0964247020585111E-2</c:v>
                </c:pt>
                <c:pt idx="8">
                  <c:v>6.0671722643553562E-2</c:v>
                </c:pt>
                <c:pt idx="9">
                  <c:v>4.8754062838569902E-2</c:v>
                </c:pt>
                <c:pt idx="10">
                  <c:v>3.9003250270855931E-2</c:v>
                </c:pt>
                <c:pt idx="11">
                  <c:v>3.9544962080173433E-2</c:v>
                </c:pt>
                <c:pt idx="12">
                  <c:v>1.84182015167931E-2</c:v>
                </c:pt>
                <c:pt idx="13">
                  <c:v>2.2751895991332597E-2</c:v>
                </c:pt>
                <c:pt idx="14">
                  <c:v>1.3542795232936116E-2</c:v>
                </c:pt>
                <c:pt idx="15">
                  <c:v>7.0422535211267659E-3</c:v>
                </c:pt>
                <c:pt idx="16">
                  <c:v>8.6673889490790895E-3</c:v>
                </c:pt>
                <c:pt idx="17">
                  <c:v>1.083423618634889E-2</c:v>
                </c:pt>
                <c:pt idx="18">
                  <c:v>5.4171180931744363E-4</c:v>
                </c:pt>
                <c:pt idx="19">
                  <c:v>2.7085590465872229E-3</c:v>
                </c:pt>
                <c:pt idx="20">
                  <c:v>1.6251354279523309E-3</c:v>
                </c:pt>
              </c:numCache>
            </c:numRef>
          </c:val>
        </c:ser>
        <c:ser>
          <c:idx val="3"/>
          <c:order val="3"/>
          <c:tx>
            <c:strRef>
              <c:f>'unc-25 A5_0.02_5%'!$E$104</c:f>
              <c:strCache>
                <c:ptCount val="1"/>
                <c:pt idx="0">
                  <c:v>unc-25_A5_004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E$105:$E$125</c:f>
              <c:numCache>
                <c:formatCode>General</c:formatCode>
                <c:ptCount val="21"/>
                <c:pt idx="1">
                  <c:v>9.1633466135458308E-2</c:v>
                </c:pt>
                <c:pt idx="2">
                  <c:v>0.111553784860558</c:v>
                </c:pt>
                <c:pt idx="3">
                  <c:v>0.105577689243028</c:v>
                </c:pt>
                <c:pt idx="4">
                  <c:v>6.4741035856573773E-2</c:v>
                </c:pt>
                <c:pt idx="5">
                  <c:v>6.872509960159362E-2</c:v>
                </c:pt>
                <c:pt idx="6">
                  <c:v>5.2788844621513904E-2</c:v>
                </c:pt>
                <c:pt idx="7">
                  <c:v>4.6812749003984098E-2</c:v>
                </c:pt>
                <c:pt idx="8">
                  <c:v>4.1832669322709237E-2</c:v>
                </c:pt>
                <c:pt idx="9">
                  <c:v>3.38645418326693E-2</c:v>
                </c:pt>
                <c:pt idx="10">
                  <c:v>3.8844621513944202E-2</c:v>
                </c:pt>
                <c:pt idx="11">
                  <c:v>2.7888446215139411E-2</c:v>
                </c:pt>
                <c:pt idx="12">
                  <c:v>3.0876494023904411E-2</c:v>
                </c:pt>
                <c:pt idx="13">
                  <c:v>1.3944223107569705E-2</c:v>
                </c:pt>
                <c:pt idx="14">
                  <c:v>2.6892430278884511E-2</c:v>
                </c:pt>
                <c:pt idx="15">
                  <c:v>2.3904382470119535E-2</c:v>
                </c:pt>
                <c:pt idx="16">
                  <c:v>1.2948207171314698E-2</c:v>
                </c:pt>
                <c:pt idx="17">
                  <c:v>9.9601593625498076E-3</c:v>
                </c:pt>
                <c:pt idx="18">
                  <c:v>1.2948207171314698E-2</c:v>
                </c:pt>
                <c:pt idx="19">
                  <c:v>3.9840637450199237E-3</c:v>
                </c:pt>
                <c:pt idx="20">
                  <c:v>2.9880478087649419E-3</c:v>
                </c:pt>
              </c:numCache>
            </c:numRef>
          </c:val>
        </c:ser>
        <c:ser>
          <c:idx val="4"/>
          <c:order val="4"/>
          <c:tx>
            <c:strRef>
              <c:f>'unc-25 A5_0.02_5%'!$F$104</c:f>
              <c:strCache>
                <c:ptCount val="1"/>
                <c:pt idx="0">
                  <c:v>unc-25_A5_006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F$105:$F$125</c:f>
              <c:numCache>
                <c:formatCode>General</c:formatCode>
                <c:ptCount val="21"/>
                <c:pt idx="1">
                  <c:v>0.10871302957633912</c:v>
                </c:pt>
                <c:pt idx="2">
                  <c:v>0.11350919264588298</c:v>
                </c:pt>
                <c:pt idx="3">
                  <c:v>0.11031175059951999</c:v>
                </c:pt>
                <c:pt idx="4">
                  <c:v>7.9936051159072749E-2</c:v>
                </c:pt>
                <c:pt idx="5">
                  <c:v>6.314948041566748E-2</c:v>
                </c:pt>
                <c:pt idx="6">
                  <c:v>5.1159072741806602E-2</c:v>
                </c:pt>
                <c:pt idx="7">
                  <c:v>4.6362909672262177E-2</c:v>
                </c:pt>
                <c:pt idx="8">
                  <c:v>3.9968025579536402E-2</c:v>
                </c:pt>
                <c:pt idx="9">
                  <c:v>3.4372501998401278E-2</c:v>
                </c:pt>
                <c:pt idx="10">
                  <c:v>3.8369304556354906E-2</c:v>
                </c:pt>
                <c:pt idx="11">
                  <c:v>3.0375699440447601E-2</c:v>
                </c:pt>
                <c:pt idx="12">
                  <c:v>2.0783373301358911E-2</c:v>
                </c:pt>
                <c:pt idx="13">
                  <c:v>2.3181454836131061E-2</c:v>
                </c:pt>
                <c:pt idx="14">
                  <c:v>2.3980815347721802E-2</c:v>
                </c:pt>
                <c:pt idx="15">
                  <c:v>1.59872102318145E-2</c:v>
                </c:pt>
                <c:pt idx="16">
                  <c:v>1.4388489208633115E-2</c:v>
                </c:pt>
                <c:pt idx="17">
                  <c:v>7.1942446043165523E-3</c:v>
                </c:pt>
                <c:pt idx="18">
                  <c:v>3.1974420463629135E-3</c:v>
                </c:pt>
                <c:pt idx="19">
                  <c:v>4.7961630695443694E-3</c:v>
                </c:pt>
                <c:pt idx="20">
                  <c:v>2.3980815347721812E-3</c:v>
                </c:pt>
              </c:numCache>
            </c:numRef>
          </c:val>
        </c:ser>
        <c:ser>
          <c:idx val="5"/>
          <c:order val="5"/>
          <c:tx>
            <c:strRef>
              <c:f>'unc-25 A5_0.02_5%'!$G$104</c:f>
              <c:strCache>
                <c:ptCount val="1"/>
                <c:pt idx="0">
                  <c:v>unc-25_A5_40_30_01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G$105:$G$125</c:f>
              <c:numCache>
                <c:formatCode>General</c:formatCode>
                <c:ptCount val="21"/>
                <c:pt idx="1">
                  <c:v>0.10303587856485702</c:v>
                </c:pt>
                <c:pt idx="2">
                  <c:v>0.11959521619135199</c:v>
                </c:pt>
                <c:pt idx="3">
                  <c:v>0.11591536338546495</c:v>
                </c:pt>
                <c:pt idx="4">
                  <c:v>6.7157313707451718E-2</c:v>
                </c:pt>
                <c:pt idx="5">
                  <c:v>8.0036798528058978E-2</c:v>
                </c:pt>
                <c:pt idx="6">
                  <c:v>5.3357865685372555E-2</c:v>
                </c:pt>
                <c:pt idx="7">
                  <c:v>3.1278748850046015E-2</c:v>
                </c:pt>
                <c:pt idx="8">
                  <c:v>3.31186752529899E-2</c:v>
                </c:pt>
                <c:pt idx="9">
                  <c:v>2.9438822447102116E-2</c:v>
                </c:pt>
                <c:pt idx="10">
                  <c:v>2.4839006439742402E-2</c:v>
                </c:pt>
                <c:pt idx="11">
                  <c:v>2.3919043238270501E-2</c:v>
                </c:pt>
                <c:pt idx="12">
                  <c:v>1.6559337626494898E-2</c:v>
                </c:pt>
                <c:pt idx="13">
                  <c:v>1.4719411223551099E-2</c:v>
                </c:pt>
                <c:pt idx="14">
                  <c:v>1.1039558417663315E-2</c:v>
                </c:pt>
                <c:pt idx="15">
                  <c:v>5.5197792088316558E-3</c:v>
                </c:pt>
                <c:pt idx="16">
                  <c:v>7.3597056117755324E-3</c:v>
                </c:pt>
                <c:pt idx="17">
                  <c:v>5.5197792088316558E-3</c:v>
                </c:pt>
                <c:pt idx="18">
                  <c:v>2.7598896044158201E-3</c:v>
                </c:pt>
                <c:pt idx="19">
                  <c:v>9.1996320147194274E-4</c:v>
                </c:pt>
                <c:pt idx="20">
                  <c:v>1.8399264029438801E-3</c:v>
                </c:pt>
              </c:numCache>
            </c:numRef>
          </c:val>
        </c:ser>
        <c:ser>
          <c:idx val="6"/>
          <c:order val="6"/>
          <c:tx>
            <c:strRef>
              <c:f>'unc-25 A5_0.02_5%'!$H$104</c:f>
              <c:strCache>
                <c:ptCount val="1"/>
                <c:pt idx="0">
                  <c:v>unc-25_A5_40_30_03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H$105:$H$125</c:f>
              <c:numCache>
                <c:formatCode>General</c:formatCode>
                <c:ptCount val="21"/>
                <c:pt idx="1">
                  <c:v>0.11111111111111099</c:v>
                </c:pt>
                <c:pt idx="2">
                  <c:v>0.11187739463601494</c:v>
                </c:pt>
                <c:pt idx="3">
                  <c:v>9.118773946360148E-2</c:v>
                </c:pt>
                <c:pt idx="4">
                  <c:v>8.6590038314176276E-2</c:v>
                </c:pt>
                <c:pt idx="5">
                  <c:v>7.5862068965517254E-2</c:v>
                </c:pt>
                <c:pt idx="6">
                  <c:v>6.5134099616858204E-2</c:v>
                </c:pt>
                <c:pt idx="7">
                  <c:v>5.3639846743294937E-2</c:v>
                </c:pt>
                <c:pt idx="8">
                  <c:v>5.2107279693486636E-2</c:v>
                </c:pt>
                <c:pt idx="9">
                  <c:v>3.6781609195402298E-2</c:v>
                </c:pt>
                <c:pt idx="10">
                  <c:v>3.6781609195402298E-2</c:v>
                </c:pt>
                <c:pt idx="11">
                  <c:v>3.8314176245210697E-2</c:v>
                </c:pt>
                <c:pt idx="12">
                  <c:v>2.0689655172413828E-2</c:v>
                </c:pt>
                <c:pt idx="13">
                  <c:v>1.6858237547892702E-2</c:v>
                </c:pt>
                <c:pt idx="14">
                  <c:v>1.3793103448275909E-2</c:v>
                </c:pt>
                <c:pt idx="15">
                  <c:v>9.9616858237548019E-3</c:v>
                </c:pt>
                <c:pt idx="16">
                  <c:v>3.8314176245210717E-3</c:v>
                </c:pt>
                <c:pt idx="17">
                  <c:v>4.5977011494252899E-3</c:v>
                </c:pt>
                <c:pt idx="18">
                  <c:v>3.8314176245210717E-3</c:v>
                </c:pt>
                <c:pt idx="19">
                  <c:v>1.5325670498084309E-3</c:v>
                </c:pt>
                <c:pt idx="20">
                  <c:v>7.6628352490421502E-4</c:v>
                </c:pt>
              </c:numCache>
            </c:numRef>
          </c:val>
        </c:ser>
        <c:ser>
          <c:idx val="7"/>
          <c:order val="7"/>
          <c:tx>
            <c:strRef>
              <c:f>'unc-25 A5_0.02_5%'!$I$104</c:f>
              <c:strCache>
                <c:ptCount val="1"/>
                <c:pt idx="0">
                  <c:v>unc-25_A5_40_30_04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I$105:$I$125</c:f>
              <c:numCache>
                <c:formatCode>General</c:formatCode>
                <c:ptCount val="21"/>
                <c:pt idx="1">
                  <c:v>0.106111484217596</c:v>
                </c:pt>
                <c:pt idx="2">
                  <c:v>0.11349899261249193</c:v>
                </c:pt>
                <c:pt idx="3">
                  <c:v>0.12357286769644098</c:v>
                </c:pt>
                <c:pt idx="4">
                  <c:v>0.10073875083949002</c:v>
                </c:pt>
                <c:pt idx="5">
                  <c:v>7.3875083948959003E-2</c:v>
                </c:pt>
                <c:pt idx="6">
                  <c:v>5.8428475486903997E-2</c:v>
                </c:pt>
                <c:pt idx="7">
                  <c:v>5.1040967092008102E-2</c:v>
                </c:pt>
                <c:pt idx="8">
                  <c:v>4.0295500335795799E-2</c:v>
                </c:pt>
                <c:pt idx="9">
                  <c:v>3.2236400268636702E-2</c:v>
                </c:pt>
                <c:pt idx="10">
                  <c:v>3.0221625251846893E-2</c:v>
                </c:pt>
                <c:pt idx="11">
                  <c:v>2.3505708529214228E-2</c:v>
                </c:pt>
                <c:pt idx="12">
                  <c:v>1.6118200134318302E-2</c:v>
                </c:pt>
                <c:pt idx="13">
                  <c:v>1.0745466756212208E-2</c:v>
                </c:pt>
                <c:pt idx="14">
                  <c:v>7.3875083948959034E-3</c:v>
                </c:pt>
                <c:pt idx="15">
                  <c:v>5.37273337810611E-3</c:v>
                </c:pt>
                <c:pt idx="16">
                  <c:v>2.6863666890530598E-3</c:v>
                </c:pt>
                <c:pt idx="17">
                  <c:v>2.6863666890530598E-3</c:v>
                </c:pt>
                <c:pt idx="18">
                  <c:v>2.0147750167897882E-3</c:v>
                </c:pt>
                <c:pt idx="19">
                  <c:v>6.7159167226326462E-4</c:v>
                </c:pt>
                <c:pt idx="20">
                  <c:v>6.7159167226326462E-4</c:v>
                </c:pt>
              </c:numCache>
            </c:numRef>
          </c:val>
        </c:ser>
        <c:ser>
          <c:idx val="8"/>
          <c:order val="8"/>
          <c:tx>
            <c:strRef>
              <c:f>'unc-25 A5_0.02_5%'!$J$104</c:f>
              <c:strCache>
                <c:ptCount val="1"/>
                <c:pt idx="0">
                  <c:v>unc-25_A5_M102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J$105:$J$125</c:f>
              <c:numCache>
                <c:formatCode>General</c:formatCode>
                <c:ptCount val="21"/>
                <c:pt idx="1">
                  <c:v>9.5995288574794016E-2</c:v>
                </c:pt>
                <c:pt idx="2">
                  <c:v>0.11896348645465306</c:v>
                </c:pt>
                <c:pt idx="3">
                  <c:v>9.4817432273262808E-2</c:v>
                </c:pt>
                <c:pt idx="4">
                  <c:v>7.4204946996466403E-2</c:v>
                </c:pt>
                <c:pt idx="5">
                  <c:v>6.9493521790341711E-2</c:v>
                </c:pt>
                <c:pt idx="6">
                  <c:v>7.1260306242638419E-2</c:v>
                </c:pt>
                <c:pt idx="7">
                  <c:v>5.5948174322732601E-2</c:v>
                </c:pt>
                <c:pt idx="8">
                  <c:v>4.0047114252061235E-2</c:v>
                </c:pt>
                <c:pt idx="9">
                  <c:v>4.1224970553592477E-2</c:v>
                </c:pt>
                <c:pt idx="10">
                  <c:v>4.6525323910482877E-2</c:v>
                </c:pt>
                <c:pt idx="11">
                  <c:v>3.8280329799764402E-2</c:v>
                </c:pt>
                <c:pt idx="12">
                  <c:v>3.06242638398115E-2</c:v>
                </c:pt>
                <c:pt idx="13">
                  <c:v>2.8268551236749064E-2</c:v>
                </c:pt>
                <c:pt idx="14">
                  <c:v>2.0612485276796197E-2</c:v>
                </c:pt>
                <c:pt idx="15">
                  <c:v>1.5901060070671401E-2</c:v>
                </c:pt>
                <c:pt idx="16">
                  <c:v>1.1189634864546499E-2</c:v>
                </c:pt>
                <c:pt idx="17">
                  <c:v>7.0671378091872765E-3</c:v>
                </c:pt>
                <c:pt idx="18">
                  <c:v>3.53356890459364E-3</c:v>
                </c:pt>
                <c:pt idx="19">
                  <c:v>2.3557126030624301E-3</c:v>
                </c:pt>
                <c:pt idx="20">
                  <c:v>2.3557126030624301E-3</c:v>
                </c:pt>
              </c:numCache>
            </c:numRef>
          </c:val>
        </c:ser>
        <c:ser>
          <c:idx val="9"/>
          <c:order val="9"/>
          <c:tx>
            <c:strRef>
              <c:f>'unc-25 A5_0.02_5%'!$K$104</c:f>
              <c:strCache>
                <c:ptCount val="1"/>
                <c:pt idx="0">
                  <c:v>unc-25_A5_M103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K$105:$K$125</c:f>
              <c:numCache>
                <c:formatCode>General</c:formatCode>
                <c:ptCount val="21"/>
                <c:pt idx="1">
                  <c:v>0.10721982758620706</c:v>
                </c:pt>
                <c:pt idx="2">
                  <c:v>0.125</c:v>
                </c:pt>
                <c:pt idx="3">
                  <c:v>0.11206896551724101</c:v>
                </c:pt>
                <c:pt idx="4">
                  <c:v>9.8060344827586271E-2</c:v>
                </c:pt>
                <c:pt idx="5">
                  <c:v>6.1422413793103404E-2</c:v>
                </c:pt>
                <c:pt idx="6">
                  <c:v>6.1422413793103404E-2</c:v>
                </c:pt>
                <c:pt idx="7">
                  <c:v>4.9030172413793101E-2</c:v>
                </c:pt>
                <c:pt idx="8">
                  <c:v>4.0948275862068964E-2</c:v>
                </c:pt>
                <c:pt idx="9">
                  <c:v>3.9870689655172403E-2</c:v>
                </c:pt>
                <c:pt idx="10">
                  <c:v>3.8254310344827604E-2</c:v>
                </c:pt>
                <c:pt idx="11">
                  <c:v>2.909482758620693E-2</c:v>
                </c:pt>
                <c:pt idx="12">
                  <c:v>2.1012931034482797E-2</c:v>
                </c:pt>
                <c:pt idx="13">
                  <c:v>2.0474137931034499E-2</c:v>
                </c:pt>
                <c:pt idx="14">
                  <c:v>1.29310344827586E-2</c:v>
                </c:pt>
                <c:pt idx="15">
                  <c:v>1.13146551724138E-2</c:v>
                </c:pt>
                <c:pt idx="16">
                  <c:v>8.6206896551724189E-3</c:v>
                </c:pt>
                <c:pt idx="17">
                  <c:v>3.7715517241379347E-3</c:v>
                </c:pt>
                <c:pt idx="18">
                  <c:v>3.7715517241379347E-3</c:v>
                </c:pt>
                <c:pt idx="19">
                  <c:v>2.1551724137930982E-3</c:v>
                </c:pt>
                <c:pt idx="20">
                  <c:v>1.6163793103448308E-3</c:v>
                </c:pt>
              </c:numCache>
            </c:numRef>
          </c:val>
        </c:ser>
        <c:ser>
          <c:idx val="10"/>
          <c:order val="10"/>
          <c:tx>
            <c:strRef>
              <c:f>'unc-25 A5_0.02_5%'!$L$104</c:f>
              <c:strCache>
                <c:ptCount val="1"/>
                <c:pt idx="0">
                  <c:v>unc-25_A5_M105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L$105:$L$125</c:f>
              <c:numCache>
                <c:formatCode>General</c:formatCode>
                <c:ptCount val="21"/>
                <c:pt idx="1">
                  <c:v>0.1045056320400501</c:v>
                </c:pt>
                <c:pt idx="2">
                  <c:v>0.11639549436796</c:v>
                </c:pt>
                <c:pt idx="3">
                  <c:v>0.10763454317897411</c:v>
                </c:pt>
                <c:pt idx="4">
                  <c:v>9.011264080100119E-2</c:v>
                </c:pt>
                <c:pt idx="5">
                  <c:v>8.1977471839799781E-2</c:v>
                </c:pt>
                <c:pt idx="6">
                  <c:v>5.2565707133917436E-2</c:v>
                </c:pt>
                <c:pt idx="7">
                  <c:v>4.5056320400500637E-2</c:v>
                </c:pt>
                <c:pt idx="8">
                  <c:v>4.31789737171464E-2</c:v>
                </c:pt>
                <c:pt idx="9">
                  <c:v>3.692115143929911E-2</c:v>
                </c:pt>
                <c:pt idx="10">
                  <c:v>3.8798498122653298E-2</c:v>
                </c:pt>
                <c:pt idx="11">
                  <c:v>2.9411764705882398E-2</c:v>
                </c:pt>
                <c:pt idx="12">
                  <c:v>2.5657071339174001E-2</c:v>
                </c:pt>
                <c:pt idx="13">
                  <c:v>1.5018773466833503E-2</c:v>
                </c:pt>
                <c:pt idx="14">
                  <c:v>1.6896120150187714E-2</c:v>
                </c:pt>
                <c:pt idx="15">
                  <c:v>8.1351689612014985E-3</c:v>
                </c:pt>
                <c:pt idx="16">
                  <c:v>5.6320400500625804E-3</c:v>
                </c:pt>
                <c:pt idx="17">
                  <c:v>5.0062578222778535E-3</c:v>
                </c:pt>
                <c:pt idx="18">
                  <c:v>0</c:v>
                </c:pt>
                <c:pt idx="19">
                  <c:v>1.8773466833541899E-3</c:v>
                </c:pt>
                <c:pt idx="20">
                  <c:v>3.1289111389236541E-3</c:v>
                </c:pt>
              </c:numCache>
            </c:numRef>
          </c:val>
        </c:ser>
        <c:ser>
          <c:idx val="11"/>
          <c:order val="11"/>
          <c:tx>
            <c:strRef>
              <c:f>'unc-25 A5_0.02_5%'!$M$104</c:f>
              <c:strCache>
                <c:ptCount val="1"/>
                <c:pt idx="0">
                  <c:v>unc-25_A5_M108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M$105:$M$125</c:f>
              <c:numCache>
                <c:formatCode>General</c:formatCode>
                <c:ptCount val="21"/>
                <c:pt idx="1">
                  <c:v>9.4968107725017722E-2</c:v>
                </c:pt>
                <c:pt idx="2">
                  <c:v>0.10347271438696005</c:v>
                </c:pt>
                <c:pt idx="3">
                  <c:v>0.1282778171509569</c:v>
                </c:pt>
                <c:pt idx="4">
                  <c:v>0.10347271438696005</c:v>
                </c:pt>
                <c:pt idx="5">
                  <c:v>6.9454287739192114E-2</c:v>
                </c:pt>
                <c:pt idx="6">
                  <c:v>5.8114812189936214E-2</c:v>
                </c:pt>
                <c:pt idx="7">
                  <c:v>4.5357902197023424E-2</c:v>
                </c:pt>
                <c:pt idx="8">
                  <c:v>3.6853295535081529E-2</c:v>
                </c:pt>
                <c:pt idx="9">
                  <c:v>3.4727143869596001E-2</c:v>
                </c:pt>
                <c:pt idx="10">
                  <c:v>4.9610205527994312E-2</c:v>
                </c:pt>
                <c:pt idx="11">
                  <c:v>3.4727143869596001E-2</c:v>
                </c:pt>
                <c:pt idx="12">
                  <c:v>3.3309709425938999E-2</c:v>
                </c:pt>
                <c:pt idx="13">
                  <c:v>1.6300496102055303E-2</c:v>
                </c:pt>
                <c:pt idx="14">
                  <c:v>9.2133238837703735E-3</c:v>
                </c:pt>
                <c:pt idx="15">
                  <c:v>1.0630758327427403E-2</c:v>
                </c:pt>
                <c:pt idx="16">
                  <c:v>1.0630758327427403E-2</c:v>
                </c:pt>
                <c:pt idx="17">
                  <c:v>3.5435861091424547E-3</c:v>
                </c:pt>
                <c:pt idx="18">
                  <c:v>7.0871722182849013E-4</c:v>
                </c:pt>
                <c:pt idx="19">
                  <c:v>1.4174344436569798E-3</c:v>
                </c:pt>
                <c:pt idx="20">
                  <c:v>2.126151665485472E-3</c:v>
                </c:pt>
              </c:numCache>
            </c:numRef>
          </c:val>
        </c:ser>
        <c:ser>
          <c:idx val="12"/>
          <c:order val="12"/>
          <c:tx>
            <c:strRef>
              <c:f>'unc-25 A5_0.02_5%'!$N$104</c:f>
              <c:strCache>
                <c:ptCount val="1"/>
                <c:pt idx="0">
                  <c:v>unc-25_A5_M109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N$105:$N$125</c:f>
              <c:numCache>
                <c:formatCode>General</c:formatCode>
                <c:ptCount val="21"/>
                <c:pt idx="1">
                  <c:v>0.10475161987041005</c:v>
                </c:pt>
                <c:pt idx="2">
                  <c:v>0.13606911447084211</c:v>
                </c:pt>
                <c:pt idx="3">
                  <c:v>0.140388768898488</c:v>
                </c:pt>
                <c:pt idx="4">
                  <c:v>9.827213822894168E-2</c:v>
                </c:pt>
                <c:pt idx="5">
                  <c:v>7.7753779697624259E-2</c:v>
                </c:pt>
                <c:pt idx="6">
                  <c:v>5.0755939524838041E-2</c:v>
                </c:pt>
                <c:pt idx="7">
                  <c:v>4.2116630669546483E-2</c:v>
                </c:pt>
                <c:pt idx="8">
                  <c:v>5.8315334773218104E-2</c:v>
                </c:pt>
                <c:pt idx="9">
                  <c:v>3.0237580993520499E-2</c:v>
                </c:pt>
                <c:pt idx="10">
                  <c:v>2.4838012958963342E-2</c:v>
                </c:pt>
                <c:pt idx="11">
                  <c:v>1.72786177105832E-2</c:v>
                </c:pt>
                <c:pt idx="12">
                  <c:v>1.6198704103671697E-2</c:v>
                </c:pt>
                <c:pt idx="13">
                  <c:v>7.5593952483801359E-3</c:v>
                </c:pt>
                <c:pt idx="14">
                  <c:v>5.3995680345572438E-3</c:v>
                </c:pt>
                <c:pt idx="15">
                  <c:v>1.07991360691145E-3</c:v>
                </c:pt>
                <c:pt idx="16">
                  <c:v>1.07991360691145E-3</c:v>
                </c:pt>
                <c:pt idx="17">
                  <c:v>0</c:v>
                </c:pt>
                <c:pt idx="18">
                  <c:v>1.07991360691145E-3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unc-25 A5_0.02_5%'!$O$104</c:f>
              <c:strCache>
                <c:ptCount val="1"/>
                <c:pt idx="0">
                  <c:v>unc-25_A5_M110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O$105:$O$125</c:f>
              <c:numCache>
                <c:formatCode>General</c:formatCode>
                <c:ptCount val="21"/>
                <c:pt idx="1">
                  <c:v>9.5572733661278997E-2</c:v>
                </c:pt>
                <c:pt idx="2">
                  <c:v>9.908643710470838E-2</c:v>
                </c:pt>
                <c:pt idx="3">
                  <c:v>9.3464511595221483E-2</c:v>
                </c:pt>
                <c:pt idx="4">
                  <c:v>7.9409697821503991E-2</c:v>
                </c:pt>
                <c:pt idx="5">
                  <c:v>8.713984539704861E-2</c:v>
                </c:pt>
                <c:pt idx="6">
                  <c:v>6.0435699226985246E-2</c:v>
                </c:pt>
                <c:pt idx="7">
                  <c:v>5.6219255094869948E-2</c:v>
                </c:pt>
                <c:pt idx="8">
                  <c:v>3.513703443429373E-2</c:v>
                </c:pt>
                <c:pt idx="9">
                  <c:v>4.9191848208011202E-2</c:v>
                </c:pt>
                <c:pt idx="10">
                  <c:v>4.0056219255094914E-2</c:v>
                </c:pt>
                <c:pt idx="11">
                  <c:v>3.1623330990864416E-2</c:v>
                </c:pt>
                <c:pt idx="12">
                  <c:v>3.0217849613492602E-2</c:v>
                </c:pt>
                <c:pt idx="13">
                  <c:v>2.9515108924806712E-2</c:v>
                </c:pt>
                <c:pt idx="14">
                  <c:v>2.4595924104005597E-2</c:v>
                </c:pt>
                <c:pt idx="15">
                  <c:v>1.4757554462403401E-2</c:v>
                </c:pt>
                <c:pt idx="16">
                  <c:v>1.4757554462403401E-2</c:v>
                </c:pt>
                <c:pt idx="17">
                  <c:v>7.7301475755446316E-3</c:v>
                </c:pt>
                <c:pt idx="18">
                  <c:v>7.7301475755446316E-3</c:v>
                </c:pt>
                <c:pt idx="19">
                  <c:v>3.5137034434293735E-3</c:v>
                </c:pt>
                <c:pt idx="20">
                  <c:v>3.5137034434293735E-3</c:v>
                </c:pt>
              </c:numCache>
            </c:numRef>
          </c:val>
        </c:ser>
        <c:ser>
          <c:idx val="14"/>
          <c:order val="14"/>
          <c:tx>
            <c:strRef>
              <c:f>'unc-25 A5_0.02_5%'!$P$104</c:f>
              <c:strCache>
                <c:ptCount val="1"/>
                <c:pt idx="0">
                  <c:v>unc-25_A5_M111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P$105:$P$125</c:f>
              <c:numCache>
                <c:formatCode>General</c:formatCode>
                <c:ptCount val="21"/>
                <c:pt idx="1">
                  <c:v>8.9005235602094224E-2</c:v>
                </c:pt>
                <c:pt idx="2">
                  <c:v>0.1017202692595361</c:v>
                </c:pt>
                <c:pt idx="3">
                  <c:v>0.10321615557217707</c:v>
                </c:pt>
                <c:pt idx="4">
                  <c:v>9.05011219147345E-2</c:v>
                </c:pt>
                <c:pt idx="5">
                  <c:v>7.4046372475691818E-2</c:v>
                </c:pt>
                <c:pt idx="6">
                  <c:v>6.3575168287210146E-2</c:v>
                </c:pt>
                <c:pt idx="7">
                  <c:v>5.5347793567688902E-2</c:v>
                </c:pt>
                <c:pt idx="8">
                  <c:v>4.4128646222887098E-2</c:v>
                </c:pt>
                <c:pt idx="9">
                  <c:v>4.7120418848167513E-2</c:v>
                </c:pt>
                <c:pt idx="10">
                  <c:v>3.8145100972326131E-2</c:v>
                </c:pt>
                <c:pt idx="11">
                  <c:v>2.4682124158564002E-2</c:v>
                </c:pt>
                <c:pt idx="12">
                  <c:v>1.8698578908003013E-2</c:v>
                </c:pt>
                <c:pt idx="13">
                  <c:v>9.7232610321615603E-3</c:v>
                </c:pt>
                <c:pt idx="14">
                  <c:v>8.2273747195213201E-3</c:v>
                </c:pt>
                <c:pt idx="15">
                  <c:v>7.479431563201207E-3</c:v>
                </c:pt>
                <c:pt idx="16">
                  <c:v>5.235602094240851E-3</c:v>
                </c:pt>
                <c:pt idx="17">
                  <c:v>8.2273747195213201E-3</c:v>
                </c:pt>
                <c:pt idx="18">
                  <c:v>5.235602094240851E-3</c:v>
                </c:pt>
                <c:pt idx="19">
                  <c:v>1.49588631264024E-3</c:v>
                </c:pt>
                <c:pt idx="20">
                  <c:v>1.49588631264024E-3</c:v>
                </c:pt>
              </c:numCache>
            </c:numRef>
          </c:val>
        </c:ser>
        <c:ser>
          <c:idx val="15"/>
          <c:order val="15"/>
          <c:tx>
            <c:strRef>
              <c:f>'unc-25 A5_0.02_5%'!$Q$104</c:f>
              <c:strCache>
                <c:ptCount val="1"/>
                <c:pt idx="0">
                  <c:v>unc-25_REX_A5_01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Q$105:$Q$125</c:f>
              <c:numCache>
                <c:formatCode>General</c:formatCode>
                <c:ptCount val="21"/>
                <c:pt idx="1">
                  <c:v>0.120383036935705</c:v>
                </c:pt>
                <c:pt idx="2">
                  <c:v>0.111263109895121</c:v>
                </c:pt>
                <c:pt idx="3">
                  <c:v>8.8919288645690805E-2</c:v>
                </c:pt>
                <c:pt idx="4">
                  <c:v>7.159142726858192E-2</c:v>
                </c:pt>
                <c:pt idx="5">
                  <c:v>6.0647514819881433E-2</c:v>
                </c:pt>
                <c:pt idx="6">
                  <c:v>4.4687642498859967E-2</c:v>
                </c:pt>
                <c:pt idx="7">
                  <c:v>3.7391700866393152E-2</c:v>
                </c:pt>
                <c:pt idx="8">
                  <c:v>2.9639762881896931E-2</c:v>
                </c:pt>
                <c:pt idx="9">
                  <c:v>2.9183766529867802E-2</c:v>
                </c:pt>
                <c:pt idx="10">
                  <c:v>3.0551755585955329E-2</c:v>
                </c:pt>
                <c:pt idx="11">
                  <c:v>2.8271773825809438E-2</c:v>
                </c:pt>
                <c:pt idx="12">
                  <c:v>2.5535795713634325E-2</c:v>
                </c:pt>
                <c:pt idx="13">
                  <c:v>2.1431828545371626E-2</c:v>
                </c:pt>
                <c:pt idx="14">
                  <c:v>9.1199270405836804E-3</c:v>
                </c:pt>
                <c:pt idx="15">
                  <c:v>6.3839489284085735E-3</c:v>
                </c:pt>
                <c:pt idx="16">
                  <c:v>7.2959416324669402E-3</c:v>
                </c:pt>
                <c:pt idx="17">
                  <c:v>6.3839489284085735E-3</c:v>
                </c:pt>
                <c:pt idx="18">
                  <c:v>1.8239854081167418E-3</c:v>
                </c:pt>
                <c:pt idx="19">
                  <c:v>2.279981760145924E-3</c:v>
                </c:pt>
                <c:pt idx="20">
                  <c:v>1.8239854081167418E-3</c:v>
                </c:pt>
              </c:numCache>
            </c:numRef>
          </c:val>
        </c:ser>
        <c:ser>
          <c:idx val="16"/>
          <c:order val="16"/>
          <c:tx>
            <c:strRef>
              <c:f>'unc-25 A5_0.02_5%'!$R$104</c:f>
              <c:strCache>
                <c:ptCount val="1"/>
                <c:pt idx="0">
                  <c:v>unc-25_REX_A5_02</c:v>
                </c:pt>
              </c:strCache>
            </c:strRef>
          </c:tx>
          <c:marker>
            <c:symbol val="none"/>
          </c:marker>
          <c:cat>
            <c:numRef>
              <c:f>'unc-25 A5_0.02_5%'!$A$105:$A$125</c:f>
              <c:numCache>
                <c:formatCode>0.00_ </c:formatCode>
                <c:ptCount val="21"/>
                <c:pt idx="0">
                  <c:v>0</c:v>
                </c:pt>
                <c:pt idx="1">
                  <c:v>2.0000000000000011E-2</c:v>
                </c:pt>
                <c:pt idx="2">
                  <c:v>4.0000000000000022E-2</c:v>
                </c:pt>
                <c:pt idx="3">
                  <c:v>6.0000000000000032E-2</c:v>
                </c:pt>
                <c:pt idx="4">
                  <c:v>8.0000000000000043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1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1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21</c:v>
                </c:pt>
                <c:pt idx="16">
                  <c:v>0.32000000000000023</c:v>
                </c:pt>
                <c:pt idx="17">
                  <c:v>0.34</c:v>
                </c:pt>
                <c:pt idx="18">
                  <c:v>0.36000000000000021</c:v>
                </c:pt>
                <c:pt idx="19">
                  <c:v>0.38000000000000023</c:v>
                </c:pt>
                <c:pt idx="20">
                  <c:v>0.4</c:v>
                </c:pt>
              </c:numCache>
            </c:numRef>
          </c:cat>
          <c:val>
            <c:numRef>
              <c:f>'unc-25 A5_0.02_5%'!$R$105:$R$125</c:f>
              <c:numCache>
                <c:formatCode>General</c:formatCode>
                <c:ptCount val="21"/>
                <c:pt idx="1">
                  <c:v>0.11056910569105698</c:v>
                </c:pt>
                <c:pt idx="2">
                  <c:v>0.11910569105691111</c:v>
                </c:pt>
                <c:pt idx="3">
                  <c:v>0.12520325203252011</c:v>
                </c:pt>
                <c:pt idx="4">
                  <c:v>0.107317073170732</c:v>
                </c:pt>
                <c:pt idx="5">
                  <c:v>7.0731707317073261E-2</c:v>
                </c:pt>
                <c:pt idx="6">
                  <c:v>4.796747967479674E-2</c:v>
                </c:pt>
                <c:pt idx="7">
                  <c:v>4.3495934959349704E-2</c:v>
                </c:pt>
                <c:pt idx="8">
                  <c:v>3.3739837398374016E-2</c:v>
                </c:pt>
                <c:pt idx="9">
                  <c:v>2.6422764227642281E-2</c:v>
                </c:pt>
                <c:pt idx="10">
                  <c:v>1.5447154471544699E-2</c:v>
                </c:pt>
                <c:pt idx="11">
                  <c:v>2.0731707317073241E-2</c:v>
                </c:pt>
                <c:pt idx="12">
                  <c:v>1.3008130081300801E-2</c:v>
                </c:pt>
                <c:pt idx="13">
                  <c:v>9.3495934959349682E-3</c:v>
                </c:pt>
                <c:pt idx="14">
                  <c:v>6.50406504065041E-3</c:v>
                </c:pt>
                <c:pt idx="15">
                  <c:v>6.9105691056910714E-3</c:v>
                </c:pt>
                <c:pt idx="16">
                  <c:v>2.8455284552845518E-3</c:v>
                </c:pt>
                <c:pt idx="17">
                  <c:v>2.0325203252032501E-3</c:v>
                </c:pt>
                <c:pt idx="18">
                  <c:v>4.0650406504065002E-3</c:v>
                </c:pt>
                <c:pt idx="19">
                  <c:v>1.6260162601626012E-3</c:v>
                </c:pt>
                <c:pt idx="20">
                  <c:v>8.1300813008130103E-4</c:v>
                </c:pt>
              </c:numCache>
            </c:numRef>
          </c:val>
        </c:ser>
        <c:marker val="1"/>
        <c:axId val="157910912"/>
        <c:axId val="157912448"/>
      </c:lineChart>
      <c:catAx>
        <c:axId val="157910912"/>
        <c:scaling>
          <c:orientation val="minMax"/>
        </c:scaling>
        <c:axPos val="b"/>
        <c:numFmt formatCode="#,##0.0_);\(#,##0.0\)" sourceLinked="0"/>
        <c:tickLblPos val="nextTo"/>
        <c:crossAx val="157912448"/>
        <c:crosses val="autoZero"/>
        <c:auto val="1"/>
        <c:lblAlgn val="ctr"/>
        <c:lblOffset val="100"/>
        <c:tickLblSkip val="5"/>
        <c:tickMarkSkip val="5"/>
      </c:catAx>
      <c:valAx>
        <c:axId val="15791244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7910912"/>
        <c:crosses val="autoZero"/>
        <c:crossBetween val="between"/>
      </c:valAx>
    </c:plotArea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/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</a:t>
            </a:r>
            <a:r>
              <a:rPr lang="en-US" altLang="ja-JP" sz="1400" b="0" baseline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A3_0.02_5%'!$B$104</c:f>
              <c:strCache>
                <c:ptCount val="1"/>
                <c:pt idx="0">
                  <c:v>N2_A3_40_30_03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B$105:$B$125</c:f>
              <c:numCache>
                <c:formatCode>General</c:formatCode>
                <c:ptCount val="21"/>
                <c:pt idx="1">
                  <c:v>7.3863636363636437E-2</c:v>
                </c:pt>
                <c:pt idx="2">
                  <c:v>0.12448347107438003</c:v>
                </c:pt>
                <c:pt idx="3">
                  <c:v>0.12448347107438003</c:v>
                </c:pt>
                <c:pt idx="4">
                  <c:v>9.9173553719008281E-2</c:v>
                </c:pt>
                <c:pt idx="5">
                  <c:v>8.8842975206611594E-2</c:v>
                </c:pt>
                <c:pt idx="6">
                  <c:v>6.8181818181818205E-2</c:v>
                </c:pt>
                <c:pt idx="7">
                  <c:v>5.7334710743801733E-2</c:v>
                </c:pt>
                <c:pt idx="8">
                  <c:v>4.4421487603305818E-2</c:v>
                </c:pt>
                <c:pt idx="9">
                  <c:v>3.9256198347107397E-2</c:v>
                </c:pt>
                <c:pt idx="10">
                  <c:v>3.3574380165289297E-2</c:v>
                </c:pt>
                <c:pt idx="11">
                  <c:v>3.0475206611570219E-2</c:v>
                </c:pt>
                <c:pt idx="12">
                  <c:v>2.1694214876033114E-2</c:v>
                </c:pt>
                <c:pt idx="13">
                  <c:v>1.9111570247933914E-2</c:v>
                </c:pt>
                <c:pt idx="14">
                  <c:v>1.6528925619834708E-2</c:v>
                </c:pt>
                <c:pt idx="15">
                  <c:v>1.0330578512396701E-2</c:v>
                </c:pt>
                <c:pt idx="16">
                  <c:v>1.2913223140495899E-2</c:v>
                </c:pt>
                <c:pt idx="17">
                  <c:v>5.6818181818181837E-3</c:v>
                </c:pt>
                <c:pt idx="18">
                  <c:v>5.1652892561983481E-3</c:v>
                </c:pt>
                <c:pt idx="19">
                  <c:v>4.1322314049586821E-3</c:v>
                </c:pt>
                <c:pt idx="20">
                  <c:v>1.5495867768595005E-3</c:v>
                </c:pt>
              </c:numCache>
            </c:numRef>
          </c:val>
        </c:ser>
        <c:ser>
          <c:idx val="1"/>
          <c:order val="1"/>
          <c:tx>
            <c:strRef>
              <c:f>'N2 A3_0.02_5%'!$C$104</c:f>
              <c:strCache>
                <c:ptCount val="1"/>
                <c:pt idx="0">
                  <c:v>N2_A3_40_30_2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C$105:$C$125</c:f>
              <c:numCache>
                <c:formatCode>General</c:formatCode>
                <c:ptCount val="21"/>
                <c:pt idx="1">
                  <c:v>9.3624609897458855E-2</c:v>
                </c:pt>
                <c:pt idx="2">
                  <c:v>0.12706197057512306</c:v>
                </c:pt>
                <c:pt idx="3">
                  <c:v>0.144003566651806</c:v>
                </c:pt>
                <c:pt idx="4">
                  <c:v>0.11591618368256798</c:v>
                </c:pt>
                <c:pt idx="5">
                  <c:v>0.10075791350869398</c:v>
                </c:pt>
                <c:pt idx="6">
                  <c:v>7.8466339723584494E-2</c:v>
                </c:pt>
                <c:pt idx="7">
                  <c:v>5.4391440035666525E-2</c:v>
                </c:pt>
                <c:pt idx="8">
                  <c:v>5.0378956754346914E-2</c:v>
                </c:pt>
                <c:pt idx="9">
                  <c:v>3.9679001337494399E-2</c:v>
                </c:pt>
                <c:pt idx="10">
                  <c:v>3.6558181007579099E-2</c:v>
                </c:pt>
                <c:pt idx="11">
                  <c:v>1.8279090503789602E-2</c:v>
                </c:pt>
                <c:pt idx="12">
                  <c:v>1.2929112795363401E-2</c:v>
                </c:pt>
                <c:pt idx="13">
                  <c:v>1.1591618368256803E-2</c:v>
                </c:pt>
                <c:pt idx="14">
                  <c:v>8.9166295140437005E-3</c:v>
                </c:pt>
                <c:pt idx="15">
                  <c:v>5.3499777084262097E-3</c:v>
                </c:pt>
                <c:pt idx="16">
                  <c:v>8.4707980383415156E-3</c:v>
                </c:pt>
                <c:pt idx="17">
                  <c:v>4.0124832813196619E-3</c:v>
                </c:pt>
                <c:pt idx="18">
                  <c:v>6.6874721355327732E-3</c:v>
                </c:pt>
                <c:pt idx="19">
                  <c:v>5.7958091841284034E-3</c:v>
                </c:pt>
                <c:pt idx="20">
                  <c:v>5.3499777084262097E-3</c:v>
                </c:pt>
              </c:numCache>
            </c:numRef>
          </c:val>
        </c:ser>
        <c:ser>
          <c:idx val="2"/>
          <c:order val="2"/>
          <c:tx>
            <c:strRef>
              <c:f>'N2 A3_0.02_5%'!$D$104</c:f>
              <c:strCache>
                <c:ptCount val="1"/>
                <c:pt idx="0">
                  <c:v>N2_REX_A3_01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D$105:$D$125</c:f>
              <c:numCache>
                <c:formatCode>General</c:formatCode>
                <c:ptCount val="21"/>
                <c:pt idx="1">
                  <c:v>8.0235988200590025E-2</c:v>
                </c:pt>
                <c:pt idx="2">
                  <c:v>0.11622418879056003</c:v>
                </c:pt>
                <c:pt idx="3">
                  <c:v>0.14159292035398197</c:v>
                </c:pt>
                <c:pt idx="4">
                  <c:v>0.14572271386430699</c:v>
                </c:pt>
                <c:pt idx="5">
                  <c:v>9.8525073746312794E-2</c:v>
                </c:pt>
                <c:pt idx="6">
                  <c:v>8.0825958702064951E-2</c:v>
                </c:pt>
                <c:pt idx="7">
                  <c:v>6.2536873156342224E-2</c:v>
                </c:pt>
                <c:pt idx="8">
                  <c:v>4.3067846607669581E-2</c:v>
                </c:pt>
                <c:pt idx="9">
                  <c:v>2.8908554572271393E-2</c:v>
                </c:pt>
                <c:pt idx="10">
                  <c:v>2.6548672566371709E-2</c:v>
                </c:pt>
                <c:pt idx="11">
                  <c:v>1.7109144542772899E-2</c:v>
                </c:pt>
                <c:pt idx="12">
                  <c:v>1.9469026548672608E-2</c:v>
                </c:pt>
                <c:pt idx="13">
                  <c:v>1.8879056047197605E-2</c:v>
                </c:pt>
                <c:pt idx="14">
                  <c:v>7.0796460176991141E-3</c:v>
                </c:pt>
                <c:pt idx="15">
                  <c:v>1.0619469026548698E-2</c:v>
                </c:pt>
                <c:pt idx="16">
                  <c:v>5.8997050147492625E-3</c:v>
                </c:pt>
                <c:pt idx="17">
                  <c:v>4.7197640117994117E-3</c:v>
                </c:pt>
                <c:pt idx="18">
                  <c:v>4.7197640117994117E-3</c:v>
                </c:pt>
                <c:pt idx="19">
                  <c:v>1.7699115044247805E-3</c:v>
                </c:pt>
                <c:pt idx="20">
                  <c:v>2.9498525073746299E-3</c:v>
                </c:pt>
              </c:numCache>
            </c:numRef>
          </c:val>
        </c:ser>
        <c:ser>
          <c:idx val="3"/>
          <c:order val="3"/>
          <c:tx>
            <c:strRef>
              <c:f>'N2 A3_0.02_5%'!$E$104</c:f>
              <c:strCache>
                <c:ptCount val="1"/>
                <c:pt idx="0">
                  <c:v>N2_REX_A3_02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E$105:$E$125</c:f>
              <c:numCache>
                <c:formatCode>General</c:formatCode>
                <c:ptCount val="21"/>
                <c:pt idx="1">
                  <c:v>0.115884115884116</c:v>
                </c:pt>
                <c:pt idx="2">
                  <c:v>0.14085914085914106</c:v>
                </c:pt>
                <c:pt idx="3">
                  <c:v>0.13236763236763199</c:v>
                </c:pt>
                <c:pt idx="4">
                  <c:v>9.9400599400599421E-2</c:v>
                </c:pt>
                <c:pt idx="5">
                  <c:v>6.6933066933066901E-2</c:v>
                </c:pt>
                <c:pt idx="6">
                  <c:v>5.1948051948052E-2</c:v>
                </c:pt>
                <c:pt idx="7">
                  <c:v>4.6453546453546504E-2</c:v>
                </c:pt>
                <c:pt idx="8">
                  <c:v>3.1468531468531499E-2</c:v>
                </c:pt>
                <c:pt idx="9">
                  <c:v>3.2467532467532499E-2</c:v>
                </c:pt>
                <c:pt idx="10">
                  <c:v>3.5964035964035995E-2</c:v>
                </c:pt>
                <c:pt idx="11">
                  <c:v>2.2977022977023018E-2</c:v>
                </c:pt>
                <c:pt idx="12">
                  <c:v>1.7982017982018001E-2</c:v>
                </c:pt>
                <c:pt idx="13">
                  <c:v>1.3486513486513505E-2</c:v>
                </c:pt>
                <c:pt idx="14">
                  <c:v>1.1488511488511505E-2</c:v>
                </c:pt>
                <c:pt idx="15">
                  <c:v>6.9930069930069921E-3</c:v>
                </c:pt>
                <c:pt idx="16">
                  <c:v>9.9900099900100004E-3</c:v>
                </c:pt>
                <c:pt idx="17">
                  <c:v>3.9960039960040003E-3</c:v>
                </c:pt>
                <c:pt idx="18">
                  <c:v>2.497502497502501E-3</c:v>
                </c:pt>
                <c:pt idx="19">
                  <c:v>1.998001998002001E-3</c:v>
                </c:pt>
                <c:pt idx="20">
                  <c:v>9.9900099900099987E-4</c:v>
                </c:pt>
              </c:numCache>
            </c:numRef>
          </c:val>
        </c:ser>
        <c:ser>
          <c:idx val="4"/>
          <c:order val="4"/>
          <c:tx>
            <c:strRef>
              <c:f>'N2 A3_0.02_5%'!$F$104</c:f>
              <c:strCache>
                <c:ptCount val="1"/>
                <c:pt idx="0">
                  <c:v>N2_REX_A3_03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F$105:$F$125</c:f>
              <c:numCache>
                <c:formatCode>General</c:formatCode>
                <c:ptCount val="21"/>
                <c:pt idx="1">
                  <c:v>0.11074144486692003</c:v>
                </c:pt>
                <c:pt idx="2">
                  <c:v>0.13925855513308</c:v>
                </c:pt>
                <c:pt idx="3">
                  <c:v>0.12119771863117899</c:v>
                </c:pt>
                <c:pt idx="4">
                  <c:v>0.111692015209125</c:v>
                </c:pt>
                <c:pt idx="5">
                  <c:v>7.6045627376425895E-2</c:v>
                </c:pt>
                <c:pt idx="6">
                  <c:v>5.6083650190114097E-2</c:v>
                </c:pt>
                <c:pt idx="7">
                  <c:v>4.13498098859316E-2</c:v>
                </c:pt>
                <c:pt idx="8">
                  <c:v>4.0399239543726234E-2</c:v>
                </c:pt>
                <c:pt idx="9">
                  <c:v>2.6615969581749013E-2</c:v>
                </c:pt>
                <c:pt idx="10">
                  <c:v>3.1844106463878315E-2</c:v>
                </c:pt>
                <c:pt idx="11">
                  <c:v>2.3764258555133092E-2</c:v>
                </c:pt>
                <c:pt idx="12">
                  <c:v>1.4733840304182504E-2</c:v>
                </c:pt>
                <c:pt idx="13">
                  <c:v>1.8060836501901101E-2</c:v>
                </c:pt>
                <c:pt idx="14">
                  <c:v>1.28326996197719E-2</c:v>
                </c:pt>
                <c:pt idx="15">
                  <c:v>1.0456273764258599E-2</c:v>
                </c:pt>
                <c:pt idx="16">
                  <c:v>6.653992395437262E-3</c:v>
                </c:pt>
                <c:pt idx="17">
                  <c:v>6.1787072243346024E-3</c:v>
                </c:pt>
                <c:pt idx="18">
                  <c:v>6.653992395437262E-3</c:v>
                </c:pt>
                <c:pt idx="19">
                  <c:v>3.8022813688212919E-3</c:v>
                </c:pt>
                <c:pt idx="20">
                  <c:v>0</c:v>
                </c:pt>
              </c:numCache>
            </c:numRef>
          </c:val>
        </c:ser>
        <c:ser>
          <c:idx val="5"/>
          <c:order val="5"/>
          <c:tx>
            <c:strRef>
              <c:f>'N2 A3_0.02_5%'!$G$104</c:f>
              <c:strCache>
                <c:ptCount val="1"/>
                <c:pt idx="0">
                  <c:v>N2_REX_A3_04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G$105:$G$125</c:f>
              <c:numCache>
                <c:formatCode>General</c:formatCode>
                <c:ptCount val="21"/>
                <c:pt idx="1">
                  <c:v>0.14408361328853994</c:v>
                </c:pt>
                <c:pt idx="2">
                  <c:v>0.161254199328108</c:v>
                </c:pt>
                <c:pt idx="3">
                  <c:v>0.15528182157521506</c:v>
                </c:pt>
                <c:pt idx="4">
                  <c:v>0.102650242627846</c:v>
                </c:pt>
                <c:pt idx="5">
                  <c:v>7.4281448301605102E-2</c:v>
                </c:pt>
                <c:pt idx="6">
                  <c:v>5.1511758118700984E-2</c:v>
                </c:pt>
                <c:pt idx="7">
                  <c:v>3.2848077640910814E-2</c:v>
                </c:pt>
                <c:pt idx="8">
                  <c:v>3.2474804031355005E-2</c:v>
                </c:pt>
                <c:pt idx="9">
                  <c:v>2.46360582306831E-2</c:v>
                </c:pt>
                <c:pt idx="10">
                  <c:v>1.3064576334453206E-2</c:v>
                </c:pt>
                <c:pt idx="11">
                  <c:v>1.7543859649122813E-2</c:v>
                </c:pt>
                <c:pt idx="12">
                  <c:v>1.0451661067562505E-2</c:v>
                </c:pt>
                <c:pt idx="13">
                  <c:v>7.8387458006718928E-3</c:v>
                </c:pt>
                <c:pt idx="14">
                  <c:v>5.2258305337812604E-3</c:v>
                </c:pt>
                <c:pt idx="15">
                  <c:v>3.7327360955580402E-3</c:v>
                </c:pt>
                <c:pt idx="16">
                  <c:v>1.49309443822322E-3</c:v>
                </c:pt>
                <c:pt idx="17">
                  <c:v>1.49309443822322E-3</c:v>
                </c:pt>
                <c:pt idx="18">
                  <c:v>1.8663680477790201E-3</c:v>
                </c:pt>
                <c:pt idx="19">
                  <c:v>3.7327360955580414E-4</c:v>
                </c:pt>
                <c:pt idx="20">
                  <c:v>7.4654721911160925E-4</c:v>
                </c:pt>
              </c:numCache>
            </c:numRef>
          </c:val>
        </c:ser>
        <c:ser>
          <c:idx val="6"/>
          <c:order val="6"/>
          <c:tx>
            <c:strRef>
              <c:f>'N2 A3_0.02_5%'!$H$104</c:f>
              <c:strCache>
                <c:ptCount val="1"/>
                <c:pt idx="0">
                  <c:v>N2_REX_A3_05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H$105:$H$125</c:f>
              <c:numCache>
                <c:formatCode>General</c:formatCode>
                <c:ptCount val="21"/>
                <c:pt idx="1">
                  <c:v>0.13799621928166406</c:v>
                </c:pt>
                <c:pt idx="2">
                  <c:v>0.14366729678638906</c:v>
                </c:pt>
                <c:pt idx="3">
                  <c:v>0.12161310649023305</c:v>
                </c:pt>
                <c:pt idx="4">
                  <c:v>8.443604284814113E-2</c:v>
                </c:pt>
                <c:pt idx="5">
                  <c:v>6.4902331442974234E-2</c:v>
                </c:pt>
                <c:pt idx="6">
                  <c:v>4.7889098928796517E-2</c:v>
                </c:pt>
                <c:pt idx="7">
                  <c:v>3.2136105860113416E-2</c:v>
                </c:pt>
                <c:pt idx="8">
                  <c:v>3.1505986137366097E-2</c:v>
                </c:pt>
                <c:pt idx="9">
                  <c:v>2.2054190296156299E-2</c:v>
                </c:pt>
                <c:pt idx="10">
                  <c:v>2.7725267800882202E-2</c:v>
                </c:pt>
                <c:pt idx="11">
                  <c:v>1.9533711405167006E-2</c:v>
                </c:pt>
                <c:pt idx="12">
                  <c:v>1.3232514177693798E-2</c:v>
                </c:pt>
                <c:pt idx="13">
                  <c:v>2.0163831127914308E-2</c:v>
                </c:pt>
                <c:pt idx="14">
                  <c:v>1.5752993068683E-2</c:v>
                </c:pt>
                <c:pt idx="15">
                  <c:v>6.3011972274732223E-3</c:v>
                </c:pt>
                <c:pt idx="16">
                  <c:v>5.0409577819785821E-3</c:v>
                </c:pt>
                <c:pt idx="17">
                  <c:v>1.8903591682419712E-3</c:v>
                </c:pt>
                <c:pt idx="18">
                  <c:v>3.1505986137366111E-3</c:v>
                </c:pt>
                <c:pt idx="19">
                  <c:v>6.3011972274732223E-4</c:v>
                </c:pt>
                <c:pt idx="20">
                  <c:v>1.2602394454946399E-3</c:v>
                </c:pt>
              </c:numCache>
            </c:numRef>
          </c:val>
        </c:ser>
        <c:ser>
          <c:idx val="7"/>
          <c:order val="7"/>
          <c:tx>
            <c:strRef>
              <c:f>'N2 A3_0.02_5%'!$I$104</c:f>
              <c:strCache>
                <c:ptCount val="1"/>
                <c:pt idx="0">
                  <c:v>N2_REX_A3_07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I$105:$I$125</c:f>
              <c:numCache>
                <c:formatCode>General</c:formatCode>
                <c:ptCount val="21"/>
                <c:pt idx="1">
                  <c:v>0.10706638115631703</c:v>
                </c:pt>
                <c:pt idx="2">
                  <c:v>0.12419700214132802</c:v>
                </c:pt>
                <c:pt idx="3">
                  <c:v>0.13888039155705106</c:v>
                </c:pt>
                <c:pt idx="4">
                  <c:v>0.10676047721015604</c:v>
                </c:pt>
                <c:pt idx="5">
                  <c:v>8.9935760171306237E-2</c:v>
                </c:pt>
                <c:pt idx="6">
                  <c:v>6.4851636586112024E-2</c:v>
                </c:pt>
                <c:pt idx="7">
                  <c:v>5.2615478739675703E-2</c:v>
                </c:pt>
                <c:pt idx="8">
                  <c:v>4.03793208932395E-2</c:v>
                </c:pt>
                <c:pt idx="9">
                  <c:v>3.5484857754665013E-2</c:v>
                </c:pt>
                <c:pt idx="10">
                  <c:v>2.6001835423677021E-2</c:v>
                </c:pt>
                <c:pt idx="11">
                  <c:v>1.9271948608137007E-2</c:v>
                </c:pt>
                <c:pt idx="12">
                  <c:v>1.5601101254206209E-2</c:v>
                </c:pt>
                <c:pt idx="13">
                  <c:v>1.3459773631079801E-2</c:v>
                </c:pt>
                <c:pt idx="14">
                  <c:v>7.0357907617008336E-3</c:v>
                </c:pt>
                <c:pt idx="15">
                  <c:v>7.9535026001835429E-3</c:v>
                </c:pt>
                <c:pt idx="16">
                  <c:v>7.9535026001835429E-3</c:v>
                </c:pt>
                <c:pt idx="17">
                  <c:v>4.5885591924135841E-3</c:v>
                </c:pt>
                <c:pt idx="18">
                  <c:v>3.0590394616090508E-3</c:v>
                </c:pt>
                <c:pt idx="19">
                  <c:v>3.3649434077699602E-3</c:v>
                </c:pt>
                <c:pt idx="20">
                  <c:v>1.83542367696543E-3</c:v>
                </c:pt>
              </c:numCache>
            </c:numRef>
          </c:val>
        </c:ser>
        <c:ser>
          <c:idx val="8"/>
          <c:order val="8"/>
          <c:tx>
            <c:strRef>
              <c:f>'N2 A3_0.02_5%'!$J$104</c:f>
              <c:strCache>
                <c:ptCount val="1"/>
                <c:pt idx="0">
                  <c:v>N2_REX_A3_08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J$105:$J$125</c:f>
              <c:numCache>
                <c:formatCode>General</c:formatCode>
                <c:ptCount val="21"/>
                <c:pt idx="1">
                  <c:v>0.101966496722505</c:v>
                </c:pt>
                <c:pt idx="2">
                  <c:v>0.13401310997815</c:v>
                </c:pt>
                <c:pt idx="3">
                  <c:v>0.11798980335032797</c:v>
                </c:pt>
                <c:pt idx="4">
                  <c:v>9.1041514930808379E-2</c:v>
                </c:pt>
                <c:pt idx="5">
                  <c:v>7.3197378004369998E-2</c:v>
                </c:pt>
                <c:pt idx="6">
                  <c:v>5.6445739257101217E-2</c:v>
                </c:pt>
                <c:pt idx="7">
                  <c:v>4.1150764748725401E-2</c:v>
                </c:pt>
                <c:pt idx="8">
                  <c:v>3.8601602330662801E-2</c:v>
                </c:pt>
                <c:pt idx="9">
                  <c:v>2.9861616897305206E-2</c:v>
                </c:pt>
                <c:pt idx="10">
                  <c:v>2.9133284777858707E-2</c:v>
                </c:pt>
                <c:pt idx="11">
                  <c:v>2.2942461762563707E-2</c:v>
                </c:pt>
                <c:pt idx="12">
                  <c:v>2.1485797523670819E-2</c:v>
                </c:pt>
                <c:pt idx="13">
                  <c:v>2.1485797523670819E-2</c:v>
                </c:pt>
                <c:pt idx="14">
                  <c:v>1.82083029861617E-2</c:v>
                </c:pt>
                <c:pt idx="15">
                  <c:v>1.2381646030589898E-2</c:v>
                </c:pt>
                <c:pt idx="16">
                  <c:v>1.4930808448652605E-2</c:v>
                </c:pt>
                <c:pt idx="17">
                  <c:v>1.0924981791697005E-2</c:v>
                </c:pt>
                <c:pt idx="18">
                  <c:v>4.0058266569555695E-3</c:v>
                </c:pt>
                <c:pt idx="19">
                  <c:v>5.0983248361252684E-3</c:v>
                </c:pt>
                <c:pt idx="20">
                  <c:v>1.0924981791697005E-3</c:v>
                </c:pt>
              </c:numCache>
            </c:numRef>
          </c:val>
        </c:ser>
        <c:ser>
          <c:idx val="9"/>
          <c:order val="9"/>
          <c:tx>
            <c:strRef>
              <c:f>'N2 A3_0.02_5%'!$K$104</c:f>
              <c:strCache>
                <c:ptCount val="1"/>
                <c:pt idx="0">
                  <c:v>N2_REX_A3_09</c:v>
                </c:pt>
              </c:strCache>
            </c:strRef>
          </c:tx>
          <c:marker>
            <c:symbol val="none"/>
          </c:marker>
          <c:cat>
            <c:numRef>
              <c:f>'N2 A3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N2 A3_0.02_5%'!$K$105:$K$125</c:f>
              <c:numCache>
                <c:formatCode>General</c:formatCode>
                <c:ptCount val="21"/>
                <c:pt idx="1">
                  <c:v>0.104684788895315</c:v>
                </c:pt>
                <c:pt idx="2">
                  <c:v>0.12724117987275901</c:v>
                </c:pt>
                <c:pt idx="3">
                  <c:v>0.12521688837478301</c:v>
                </c:pt>
                <c:pt idx="4">
                  <c:v>0.10121457489878502</c:v>
                </c:pt>
                <c:pt idx="5">
                  <c:v>9.8611914401388084E-2</c:v>
                </c:pt>
                <c:pt idx="6">
                  <c:v>6.824754193175249E-2</c:v>
                </c:pt>
                <c:pt idx="7">
                  <c:v>5.6390977443609019E-2</c:v>
                </c:pt>
                <c:pt idx="8">
                  <c:v>3.7015615962984416E-2</c:v>
                </c:pt>
                <c:pt idx="9">
                  <c:v>3.4412955465587002E-2</c:v>
                </c:pt>
                <c:pt idx="10">
                  <c:v>2.8050896471949114E-2</c:v>
                </c:pt>
                <c:pt idx="11">
                  <c:v>2.3134759976865198E-2</c:v>
                </c:pt>
                <c:pt idx="12">
                  <c:v>1.7929438982070601E-2</c:v>
                </c:pt>
                <c:pt idx="13">
                  <c:v>1.33024869866975E-2</c:v>
                </c:pt>
                <c:pt idx="14">
                  <c:v>1.417004048583E-2</c:v>
                </c:pt>
                <c:pt idx="15">
                  <c:v>1.0121457489878501E-2</c:v>
                </c:pt>
                <c:pt idx="16">
                  <c:v>8.3863504916136533E-3</c:v>
                </c:pt>
                <c:pt idx="17">
                  <c:v>8.0971659919028306E-3</c:v>
                </c:pt>
                <c:pt idx="18">
                  <c:v>4.0485829959514223E-3</c:v>
                </c:pt>
                <c:pt idx="19">
                  <c:v>2.0242914979757111E-3</c:v>
                </c:pt>
                <c:pt idx="20">
                  <c:v>2.6026604973973409E-3</c:v>
                </c:pt>
              </c:numCache>
            </c:numRef>
          </c:val>
        </c:ser>
        <c:marker val="1"/>
        <c:axId val="157970816"/>
        <c:axId val="157972352"/>
      </c:lineChart>
      <c:catAx>
        <c:axId val="157970816"/>
        <c:scaling>
          <c:orientation val="minMax"/>
        </c:scaling>
        <c:axPos val="b"/>
        <c:numFmt formatCode="#,##0.0_);\(#,##0.0\)" sourceLinked="0"/>
        <c:tickLblPos val="nextTo"/>
        <c:crossAx val="157972352"/>
        <c:crosses val="autoZero"/>
        <c:auto val="1"/>
        <c:lblAlgn val="ctr"/>
        <c:lblOffset val="100"/>
        <c:tickLblSkip val="5"/>
        <c:tickMarkSkip val="5"/>
      </c:catAx>
      <c:valAx>
        <c:axId val="15797235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7970816"/>
        <c:crosses val="autoZero"/>
        <c:crossBetween val="between"/>
      </c:valAx>
    </c:plotArea>
    <c:plotVisOnly val="1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L4</a:t>
            </a: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L4_0.02_5%'!$B$104</c:f>
              <c:strCache>
                <c:ptCount val="1"/>
                <c:pt idx="0">
                  <c:v>unc-25_L4_06001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B$105:$B$125</c:f>
              <c:numCache>
                <c:formatCode>General</c:formatCode>
                <c:ptCount val="21"/>
                <c:pt idx="1">
                  <c:v>6.4904552129221721E-2</c:v>
                </c:pt>
                <c:pt idx="2">
                  <c:v>0.10014684287812003</c:v>
                </c:pt>
                <c:pt idx="3">
                  <c:v>0.10543318649045499</c:v>
                </c:pt>
                <c:pt idx="4">
                  <c:v>0.13186490455212904</c:v>
                </c:pt>
                <c:pt idx="5">
                  <c:v>0.11541850220264301</c:v>
                </c:pt>
                <c:pt idx="6">
                  <c:v>7.4008810572687198E-2</c:v>
                </c:pt>
                <c:pt idx="7">
                  <c:v>5.7268722466960395E-2</c:v>
                </c:pt>
                <c:pt idx="8">
                  <c:v>5.198237885462563E-2</c:v>
                </c:pt>
                <c:pt idx="9">
                  <c:v>4.7283406754772404E-2</c:v>
                </c:pt>
                <c:pt idx="10">
                  <c:v>4.2290748898678399E-2</c:v>
                </c:pt>
                <c:pt idx="11">
                  <c:v>2.9074889867841399E-2</c:v>
                </c:pt>
                <c:pt idx="12">
                  <c:v>2.6431718061674027E-2</c:v>
                </c:pt>
                <c:pt idx="13">
                  <c:v>1.7327459618208512E-2</c:v>
                </c:pt>
                <c:pt idx="14">
                  <c:v>1.8208516886931002E-2</c:v>
                </c:pt>
                <c:pt idx="15">
                  <c:v>1.3215859030837008E-2</c:v>
                </c:pt>
                <c:pt idx="16">
                  <c:v>9.3979441997063175E-3</c:v>
                </c:pt>
                <c:pt idx="17">
                  <c:v>6.4610866372980897E-3</c:v>
                </c:pt>
                <c:pt idx="18">
                  <c:v>4.9926578560939797E-3</c:v>
                </c:pt>
                <c:pt idx="19">
                  <c:v>4.9926578560939797E-3</c:v>
                </c:pt>
                <c:pt idx="20">
                  <c:v>4.1116005873715116E-3</c:v>
                </c:pt>
              </c:numCache>
            </c:numRef>
          </c:val>
        </c:ser>
        <c:ser>
          <c:idx val="1"/>
          <c:order val="1"/>
          <c:tx>
            <c:strRef>
              <c:f>'unc-25 L4_0.02_5%'!$C$104</c:f>
              <c:strCache>
                <c:ptCount val="1"/>
                <c:pt idx="0">
                  <c:v>unc-25_L4_06002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C$105:$C$125</c:f>
              <c:numCache>
                <c:formatCode>General</c:formatCode>
                <c:ptCount val="21"/>
                <c:pt idx="1">
                  <c:v>7.8361531611754229E-2</c:v>
                </c:pt>
                <c:pt idx="2">
                  <c:v>0.10477886613238301</c:v>
                </c:pt>
                <c:pt idx="3">
                  <c:v>0.12318195310181103</c:v>
                </c:pt>
                <c:pt idx="4">
                  <c:v>0.11932324131789802</c:v>
                </c:pt>
                <c:pt idx="5">
                  <c:v>0.11279311368358604</c:v>
                </c:pt>
                <c:pt idx="6">
                  <c:v>7.3018699910952833E-2</c:v>
                </c:pt>
                <c:pt idx="7">
                  <c:v>6.4113980409617133E-2</c:v>
                </c:pt>
                <c:pt idx="8">
                  <c:v>5.9364796675571423E-2</c:v>
                </c:pt>
                <c:pt idx="9">
                  <c:v>4.9272781240724227E-2</c:v>
                </c:pt>
                <c:pt idx="10">
                  <c:v>3.4431582071831404E-2</c:v>
                </c:pt>
                <c:pt idx="11">
                  <c:v>3.3837934105075712E-2</c:v>
                </c:pt>
                <c:pt idx="12">
                  <c:v>2.2558622736717101E-2</c:v>
                </c:pt>
                <c:pt idx="13">
                  <c:v>1.9887206886316403E-2</c:v>
                </c:pt>
                <c:pt idx="14">
                  <c:v>1.2169783318492101E-2</c:v>
                </c:pt>
                <c:pt idx="15">
                  <c:v>8.3110715345799946E-3</c:v>
                </c:pt>
                <c:pt idx="16">
                  <c:v>6.5301276343128533E-3</c:v>
                </c:pt>
                <c:pt idx="17">
                  <c:v>2.6714158504007098E-3</c:v>
                </c:pt>
                <c:pt idx="18">
                  <c:v>3.8587117839121417E-3</c:v>
                </c:pt>
                <c:pt idx="19">
                  <c:v>2.0777678836450008E-3</c:v>
                </c:pt>
                <c:pt idx="20">
                  <c:v>1.7809439002671405E-3</c:v>
                </c:pt>
              </c:numCache>
            </c:numRef>
          </c:val>
        </c:ser>
        <c:ser>
          <c:idx val="2"/>
          <c:order val="2"/>
          <c:tx>
            <c:strRef>
              <c:f>'unc-25 L4_0.02_5%'!$D$104</c:f>
              <c:strCache>
                <c:ptCount val="1"/>
                <c:pt idx="0">
                  <c:v>unc-25_L4_06003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D$105:$D$125</c:f>
              <c:numCache>
                <c:formatCode>General</c:formatCode>
                <c:ptCount val="21"/>
                <c:pt idx="1">
                  <c:v>7.9724409448818936E-2</c:v>
                </c:pt>
                <c:pt idx="2">
                  <c:v>9.1043307086614192E-2</c:v>
                </c:pt>
                <c:pt idx="3">
                  <c:v>0.11466535433070903</c:v>
                </c:pt>
                <c:pt idx="4">
                  <c:v>9.9901574803149581E-2</c:v>
                </c:pt>
                <c:pt idx="5">
                  <c:v>9.5472440944881928E-2</c:v>
                </c:pt>
                <c:pt idx="6">
                  <c:v>6.3976377952755903E-2</c:v>
                </c:pt>
                <c:pt idx="7">
                  <c:v>6.6437007874015824E-2</c:v>
                </c:pt>
                <c:pt idx="8">
                  <c:v>4.9212598425196923E-2</c:v>
                </c:pt>
                <c:pt idx="9">
                  <c:v>3.6417322834645716E-2</c:v>
                </c:pt>
                <c:pt idx="10">
                  <c:v>3.3956692913385794E-2</c:v>
                </c:pt>
                <c:pt idx="11">
                  <c:v>3.3464566929133903E-2</c:v>
                </c:pt>
                <c:pt idx="12">
                  <c:v>2.6574803149606308E-2</c:v>
                </c:pt>
                <c:pt idx="13">
                  <c:v>2.7559055118110208E-2</c:v>
                </c:pt>
                <c:pt idx="14">
                  <c:v>2.1161417322834601E-2</c:v>
                </c:pt>
                <c:pt idx="15">
                  <c:v>1.4271653543307101E-2</c:v>
                </c:pt>
                <c:pt idx="16">
                  <c:v>1.27952755905512E-2</c:v>
                </c:pt>
                <c:pt idx="17">
                  <c:v>6.8897637795275642E-3</c:v>
                </c:pt>
                <c:pt idx="18">
                  <c:v>5.41338582677165E-3</c:v>
                </c:pt>
                <c:pt idx="19">
                  <c:v>4.9212598425196919E-3</c:v>
                </c:pt>
                <c:pt idx="20">
                  <c:v>3.9370078740157497E-3</c:v>
                </c:pt>
              </c:numCache>
            </c:numRef>
          </c:val>
        </c:ser>
        <c:ser>
          <c:idx val="3"/>
          <c:order val="3"/>
          <c:tx>
            <c:strRef>
              <c:f>'unc-25 L4_0.02_5%'!$E$104</c:f>
              <c:strCache>
                <c:ptCount val="1"/>
                <c:pt idx="0">
                  <c:v>unc-25_L4_06004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E$105:$E$125</c:f>
              <c:numCache>
                <c:formatCode>General</c:formatCode>
                <c:ptCount val="21"/>
                <c:pt idx="1">
                  <c:v>8.3241252302025781E-2</c:v>
                </c:pt>
                <c:pt idx="2">
                  <c:v>0.10349907918968702</c:v>
                </c:pt>
                <c:pt idx="3">
                  <c:v>0.113812154696133</c:v>
                </c:pt>
                <c:pt idx="4">
                  <c:v>0.119705340699816</c:v>
                </c:pt>
                <c:pt idx="5">
                  <c:v>9.9079189686924488E-2</c:v>
                </c:pt>
                <c:pt idx="6">
                  <c:v>5.8563535911602224E-2</c:v>
                </c:pt>
                <c:pt idx="7">
                  <c:v>5.1933701657458621E-2</c:v>
                </c:pt>
                <c:pt idx="8">
                  <c:v>4.4935543278084696E-2</c:v>
                </c:pt>
                <c:pt idx="9">
                  <c:v>4.0883977900552516E-2</c:v>
                </c:pt>
                <c:pt idx="10">
                  <c:v>3.3149171270718203E-2</c:v>
                </c:pt>
                <c:pt idx="11">
                  <c:v>3.8674033149171311E-2</c:v>
                </c:pt>
                <c:pt idx="12">
                  <c:v>2.5046040515653813E-2</c:v>
                </c:pt>
                <c:pt idx="13">
                  <c:v>2.3941068139963207E-2</c:v>
                </c:pt>
                <c:pt idx="14">
                  <c:v>2.1731123388582001E-2</c:v>
                </c:pt>
                <c:pt idx="15">
                  <c:v>1.9521178637200712E-2</c:v>
                </c:pt>
                <c:pt idx="16">
                  <c:v>1.3627992633517504E-2</c:v>
                </c:pt>
                <c:pt idx="17">
                  <c:v>1.215469613259669E-2</c:v>
                </c:pt>
                <c:pt idx="18">
                  <c:v>6.9981583793738518E-3</c:v>
                </c:pt>
                <c:pt idx="19">
                  <c:v>4.4198895027624321E-3</c:v>
                </c:pt>
                <c:pt idx="20">
                  <c:v>3.3149171270718202E-3</c:v>
                </c:pt>
              </c:numCache>
            </c:numRef>
          </c:val>
        </c:ser>
        <c:ser>
          <c:idx val="4"/>
          <c:order val="4"/>
          <c:tx>
            <c:strRef>
              <c:f>'unc-25 L4_0.02_5%'!$F$104</c:f>
              <c:strCache>
                <c:ptCount val="1"/>
                <c:pt idx="0">
                  <c:v>unc-25_L4_06005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F$105:$F$125</c:f>
              <c:numCache>
                <c:formatCode>General</c:formatCode>
                <c:ptCount val="21"/>
              </c:numCache>
            </c:numRef>
          </c:val>
        </c:ser>
        <c:ser>
          <c:idx val="5"/>
          <c:order val="5"/>
          <c:tx>
            <c:strRef>
              <c:f>'unc-25 L4_0.02_5%'!$G$104</c:f>
              <c:strCache>
                <c:ptCount val="1"/>
                <c:pt idx="0">
                  <c:v>unc-25_L4_06006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G$105:$G$125</c:f>
              <c:numCache>
                <c:formatCode>General</c:formatCode>
                <c:ptCount val="21"/>
                <c:pt idx="1">
                  <c:v>0.10400000000000002</c:v>
                </c:pt>
                <c:pt idx="2">
                  <c:v>0.12000000000000002</c:v>
                </c:pt>
                <c:pt idx="3">
                  <c:v>7.1999999999999995E-2</c:v>
                </c:pt>
                <c:pt idx="4">
                  <c:v>6.4000000000000029E-2</c:v>
                </c:pt>
                <c:pt idx="5">
                  <c:v>6.4000000000000029E-2</c:v>
                </c:pt>
                <c:pt idx="6">
                  <c:v>5.6000000000000001E-2</c:v>
                </c:pt>
                <c:pt idx="7">
                  <c:v>1.6000000000000007E-2</c:v>
                </c:pt>
                <c:pt idx="8">
                  <c:v>1.6000000000000007E-2</c:v>
                </c:pt>
                <c:pt idx="9">
                  <c:v>2.4E-2</c:v>
                </c:pt>
                <c:pt idx="10">
                  <c:v>4.8000000000000001E-2</c:v>
                </c:pt>
                <c:pt idx="11">
                  <c:v>1.6000000000000007E-2</c:v>
                </c:pt>
                <c:pt idx="12">
                  <c:v>2.4E-2</c:v>
                </c:pt>
                <c:pt idx="13">
                  <c:v>0</c:v>
                </c:pt>
                <c:pt idx="14">
                  <c:v>8.0000000000000054E-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8.0000000000000054E-3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6"/>
          <c:order val="6"/>
          <c:tx>
            <c:strRef>
              <c:f>'unc-25 L4_0.02_5%'!$H$104</c:f>
              <c:strCache>
                <c:ptCount val="1"/>
                <c:pt idx="0">
                  <c:v>unc-25_L4_06007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H$105:$H$125</c:f>
              <c:numCache>
                <c:formatCode>General</c:formatCode>
                <c:ptCount val="21"/>
                <c:pt idx="1">
                  <c:v>7.7050264550264494E-2</c:v>
                </c:pt>
                <c:pt idx="2">
                  <c:v>0.10152116402116403</c:v>
                </c:pt>
                <c:pt idx="3">
                  <c:v>0.12301587301587302</c:v>
                </c:pt>
                <c:pt idx="4">
                  <c:v>0.12599206349206307</c:v>
                </c:pt>
                <c:pt idx="5">
                  <c:v>0.11640211640211599</c:v>
                </c:pt>
                <c:pt idx="6">
                  <c:v>6.2169312169312201E-2</c:v>
                </c:pt>
                <c:pt idx="7">
                  <c:v>5.555555555555558E-2</c:v>
                </c:pt>
                <c:pt idx="8">
                  <c:v>4.5634920634920619E-2</c:v>
                </c:pt>
                <c:pt idx="9">
                  <c:v>4.7288359788359761E-2</c:v>
                </c:pt>
                <c:pt idx="10">
                  <c:v>3.6706349206349215E-2</c:v>
                </c:pt>
                <c:pt idx="11">
                  <c:v>3.2407407407407413E-2</c:v>
                </c:pt>
                <c:pt idx="12">
                  <c:v>1.9841269841269809E-2</c:v>
                </c:pt>
                <c:pt idx="13">
                  <c:v>1.6534391534391499E-2</c:v>
                </c:pt>
                <c:pt idx="14">
                  <c:v>1.6865079365079413E-2</c:v>
                </c:pt>
                <c:pt idx="15">
                  <c:v>1.1574074074074099E-2</c:v>
                </c:pt>
                <c:pt idx="16">
                  <c:v>1.09126984126984E-2</c:v>
                </c:pt>
                <c:pt idx="17">
                  <c:v>7.6058201058201132E-3</c:v>
                </c:pt>
                <c:pt idx="18">
                  <c:v>9.9206349206349236E-3</c:v>
                </c:pt>
                <c:pt idx="19">
                  <c:v>2.6455026455026519E-3</c:v>
                </c:pt>
                <c:pt idx="20">
                  <c:v>9.9206349206349244E-4</c:v>
                </c:pt>
              </c:numCache>
            </c:numRef>
          </c:val>
        </c:ser>
        <c:ser>
          <c:idx val="7"/>
          <c:order val="7"/>
          <c:tx>
            <c:strRef>
              <c:f>'unc-25 L4_0.02_5%'!$I$104</c:f>
              <c:strCache>
                <c:ptCount val="1"/>
                <c:pt idx="0">
                  <c:v>unc-25_L4_06008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I$105:$I$125</c:f>
              <c:numCache>
                <c:formatCode>General</c:formatCode>
                <c:ptCount val="21"/>
                <c:pt idx="1">
                  <c:v>9.9826388888888951E-2</c:v>
                </c:pt>
                <c:pt idx="2">
                  <c:v>0.10590277777777803</c:v>
                </c:pt>
                <c:pt idx="3">
                  <c:v>0.12065972222222203</c:v>
                </c:pt>
                <c:pt idx="4">
                  <c:v>0.11024305555555602</c:v>
                </c:pt>
                <c:pt idx="5">
                  <c:v>7.8125E-2</c:v>
                </c:pt>
                <c:pt idx="6">
                  <c:v>6.5104166666666699E-2</c:v>
                </c:pt>
                <c:pt idx="7">
                  <c:v>4.6006944444444413E-2</c:v>
                </c:pt>
                <c:pt idx="8">
                  <c:v>3.6458333333333301E-2</c:v>
                </c:pt>
                <c:pt idx="9">
                  <c:v>3.2118055555555601E-2</c:v>
                </c:pt>
                <c:pt idx="10">
                  <c:v>2.3437500000000007E-2</c:v>
                </c:pt>
                <c:pt idx="11">
                  <c:v>2.9513888888888892E-2</c:v>
                </c:pt>
                <c:pt idx="12">
                  <c:v>2.4305555555555601E-2</c:v>
                </c:pt>
                <c:pt idx="13">
                  <c:v>3.5590277777777811E-2</c:v>
                </c:pt>
                <c:pt idx="14">
                  <c:v>2.6041666666666713E-2</c:v>
                </c:pt>
                <c:pt idx="15">
                  <c:v>1.6493055555555601E-2</c:v>
                </c:pt>
                <c:pt idx="16">
                  <c:v>8.6805555555555646E-3</c:v>
                </c:pt>
                <c:pt idx="17">
                  <c:v>8.6805555555555646E-3</c:v>
                </c:pt>
                <c:pt idx="18">
                  <c:v>1.0416666666666699E-2</c:v>
                </c:pt>
                <c:pt idx="19">
                  <c:v>1.7361111111111108E-3</c:v>
                </c:pt>
                <c:pt idx="20">
                  <c:v>1.7361111111111108E-3</c:v>
                </c:pt>
              </c:numCache>
            </c:numRef>
          </c:val>
        </c:ser>
        <c:ser>
          <c:idx val="8"/>
          <c:order val="8"/>
          <c:tx>
            <c:strRef>
              <c:f>'unc-25 L4_0.02_5%'!$J$104</c:f>
              <c:strCache>
                <c:ptCount val="1"/>
                <c:pt idx="0">
                  <c:v>unc-25_L4_06009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J$105:$J$125</c:f>
              <c:numCache>
                <c:formatCode>General</c:formatCode>
                <c:ptCount val="21"/>
                <c:pt idx="1">
                  <c:v>0.12109375000000006</c:v>
                </c:pt>
                <c:pt idx="2">
                  <c:v>0.12109375000000006</c:v>
                </c:pt>
                <c:pt idx="3">
                  <c:v>0.11328125000000003</c:v>
                </c:pt>
                <c:pt idx="4">
                  <c:v>7.0312500000000028E-2</c:v>
                </c:pt>
                <c:pt idx="5">
                  <c:v>7.4218750000000014E-2</c:v>
                </c:pt>
                <c:pt idx="6">
                  <c:v>7.0312500000000028E-2</c:v>
                </c:pt>
                <c:pt idx="7">
                  <c:v>4.2968750000000014E-2</c:v>
                </c:pt>
                <c:pt idx="8">
                  <c:v>5.4687500000000014E-2</c:v>
                </c:pt>
                <c:pt idx="9">
                  <c:v>3.515625E-2</c:v>
                </c:pt>
                <c:pt idx="10">
                  <c:v>2.7343750000000007E-2</c:v>
                </c:pt>
                <c:pt idx="11">
                  <c:v>3.125E-2</c:v>
                </c:pt>
                <c:pt idx="12">
                  <c:v>1.9531250000000003E-2</c:v>
                </c:pt>
                <c:pt idx="13">
                  <c:v>1.5625E-2</c:v>
                </c:pt>
                <c:pt idx="14">
                  <c:v>0</c:v>
                </c:pt>
                <c:pt idx="15">
                  <c:v>3.90625E-3</c:v>
                </c:pt>
                <c:pt idx="16">
                  <c:v>1.5625E-2</c:v>
                </c:pt>
                <c:pt idx="17">
                  <c:v>7.8125E-3</c:v>
                </c:pt>
                <c:pt idx="18">
                  <c:v>3.90625E-3</c:v>
                </c:pt>
                <c:pt idx="19">
                  <c:v>0</c:v>
                </c:pt>
                <c:pt idx="20">
                  <c:v>3.90625E-3</c:v>
                </c:pt>
              </c:numCache>
            </c:numRef>
          </c:val>
        </c:ser>
        <c:ser>
          <c:idx val="9"/>
          <c:order val="9"/>
          <c:tx>
            <c:strRef>
              <c:f>'unc-25 L4_0.02_5%'!$K$104</c:f>
              <c:strCache>
                <c:ptCount val="1"/>
                <c:pt idx="0">
                  <c:v>unc-25_L4_06011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K$105:$K$125</c:f>
              <c:numCache>
                <c:formatCode>General</c:formatCode>
                <c:ptCount val="21"/>
                <c:pt idx="1">
                  <c:v>7.5655682582380604E-2</c:v>
                </c:pt>
                <c:pt idx="2">
                  <c:v>9.9529253530598508E-2</c:v>
                </c:pt>
                <c:pt idx="3">
                  <c:v>0.11264290517821103</c:v>
                </c:pt>
                <c:pt idx="4">
                  <c:v>0.13315400134499</c:v>
                </c:pt>
                <c:pt idx="5">
                  <c:v>9.9529253530598508E-2</c:v>
                </c:pt>
                <c:pt idx="6">
                  <c:v>7.1620712844653697E-2</c:v>
                </c:pt>
                <c:pt idx="7">
                  <c:v>6.6913248150638913E-2</c:v>
                </c:pt>
                <c:pt idx="8">
                  <c:v>6.0860793544048435E-2</c:v>
                </c:pt>
                <c:pt idx="9">
                  <c:v>4.64021519838601E-2</c:v>
                </c:pt>
                <c:pt idx="10">
                  <c:v>4.1358439811701432E-2</c:v>
                </c:pt>
                <c:pt idx="11">
                  <c:v>2.6563550773369207E-2</c:v>
                </c:pt>
                <c:pt idx="12">
                  <c:v>2.7908540685944918E-2</c:v>
                </c:pt>
                <c:pt idx="13">
                  <c:v>1.5803631472764E-2</c:v>
                </c:pt>
                <c:pt idx="14">
                  <c:v>1.546738399462E-2</c:v>
                </c:pt>
                <c:pt idx="15">
                  <c:v>1.07599193006052E-2</c:v>
                </c:pt>
                <c:pt idx="16">
                  <c:v>9.7511768661734995E-3</c:v>
                </c:pt>
                <c:pt idx="17">
                  <c:v>8.4061869535978564E-3</c:v>
                </c:pt>
                <c:pt idx="18">
                  <c:v>3.6987222595830519E-3</c:v>
                </c:pt>
                <c:pt idx="19">
                  <c:v>1.6812373907195701E-3</c:v>
                </c:pt>
                <c:pt idx="20">
                  <c:v>3.3624747814391402E-3</c:v>
                </c:pt>
              </c:numCache>
            </c:numRef>
          </c:val>
        </c:ser>
        <c:ser>
          <c:idx val="10"/>
          <c:order val="10"/>
          <c:tx>
            <c:strRef>
              <c:f>'unc-25 L4_0.02_5%'!$L$104</c:f>
              <c:strCache>
                <c:ptCount val="1"/>
                <c:pt idx="0">
                  <c:v>unc-25_L4_06012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L$105:$L$125</c:f>
              <c:numCache>
                <c:formatCode>General</c:formatCode>
                <c:ptCount val="21"/>
                <c:pt idx="1">
                  <c:v>5.923043666234333E-2</c:v>
                </c:pt>
                <c:pt idx="2">
                  <c:v>9.1223519239083395E-2</c:v>
                </c:pt>
                <c:pt idx="3">
                  <c:v>0.12019022913964503</c:v>
                </c:pt>
                <c:pt idx="4">
                  <c:v>0.11197578901859102</c:v>
                </c:pt>
                <c:pt idx="5">
                  <c:v>0.10073497622135805</c:v>
                </c:pt>
                <c:pt idx="6">
                  <c:v>7.8685689580631199E-2</c:v>
                </c:pt>
                <c:pt idx="7">
                  <c:v>6.9606571552096846E-2</c:v>
                </c:pt>
                <c:pt idx="8">
                  <c:v>5.1015996541288418E-2</c:v>
                </c:pt>
                <c:pt idx="9">
                  <c:v>4.3666234327712918E-2</c:v>
                </c:pt>
                <c:pt idx="10">
                  <c:v>4.2369217466493719E-2</c:v>
                </c:pt>
                <c:pt idx="11">
                  <c:v>2.9831387808041513E-2</c:v>
                </c:pt>
                <c:pt idx="12">
                  <c:v>2.6372676178123614E-2</c:v>
                </c:pt>
                <c:pt idx="13">
                  <c:v>1.8590575010808508E-2</c:v>
                </c:pt>
                <c:pt idx="14">
                  <c:v>2.1184608733246894E-2</c:v>
                </c:pt>
                <c:pt idx="15">
                  <c:v>1.9022913964548201E-2</c:v>
                </c:pt>
                <c:pt idx="16">
                  <c:v>6.0527453523562501E-3</c:v>
                </c:pt>
                <c:pt idx="17">
                  <c:v>9.9437959360138307E-3</c:v>
                </c:pt>
                <c:pt idx="18">
                  <c:v>6.91742325983571E-3</c:v>
                </c:pt>
                <c:pt idx="19">
                  <c:v>4.7557284911370519E-3</c:v>
                </c:pt>
                <c:pt idx="20">
                  <c:v>3.0263726761781207E-3</c:v>
                </c:pt>
              </c:numCache>
            </c:numRef>
          </c:val>
        </c:ser>
        <c:ser>
          <c:idx val="11"/>
          <c:order val="11"/>
          <c:tx>
            <c:strRef>
              <c:f>'unc-25 L4_0.02_5%'!$M$104</c:f>
              <c:strCache>
                <c:ptCount val="1"/>
                <c:pt idx="0">
                  <c:v>unc-25_L4_06013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M$105:$M$125</c:f>
              <c:numCache>
                <c:formatCode>General</c:formatCode>
                <c:ptCount val="21"/>
                <c:pt idx="1">
                  <c:v>7.7850877192982504E-2</c:v>
                </c:pt>
                <c:pt idx="2">
                  <c:v>9.5394736842105227E-2</c:v>
                </c:pt>
                <c:pt idx="3">
                  <c:v>0.10964912280701802</c:v>
                </c:pt>
                <c:pt idx="4">
                  <c:v>0.12225877192982502</c:v>
                </c:pt>
                <c:pt idx="5">
                  <c:v>9.3750000000000042E-2</c:v>
                </c:pt>
                <c:pt idx="6">
                  <c:v>7.839912280701751E-2</c:v>
                </c:pt>
                <c:pt idx="7">
                  <c:v>6.140350877192978E-2</c:v>
                </c:pt>
                <c:pt idx="8">
                  <c:v>5.5921052631578885E-2</c:v>
                </c:pt>
                <c:pt idx="9">
                  <c:v>4.8245614035087703E-2</c:v>
                </c:pt>
                <c:pt idx="10">
                  <c:v>4.0570175438596486E-2</c:v>
                </c:pt>
                <c:pt idx="11">
                  <c:v>3.125E-2</c:v>
                </c:pt>
                <c:pt idx="12">
                  <c:v>2.4671052631578899E-2</c:v>
                </c:pt>
                <c:pt idx="13">
                  <c:v>2.1929824561403508E-2</c:v>
                </c:pt>
                <c:pt idx="14">
                  <c:v>2.1381578947368401E-2</c:v>
                </c:pt>
                <c:pt idx="15">
                  <c:v>1.4254385964912301E-2</c:v>
                </c:pt>
                <c:pt idx="16">
                  <c:v>8.2236842105263275E-3</c:v>
                </c:pt>
                <c:pt idx="17">
                  <c:v>1.0964912280701799E-2</c:v>
                </c:pt>
                <c:pt idx="18">
                  <c:v>8.2236842105263275E-3</c:v>
                </c:pt>
                <c:pt idx="19">
                  <c:v>3.2894736842105309E-3</c:v>
                </c:pt>
                <c:pt idx="20">
                  <c:v>2.1929824561403499E-3</c:v>
                </c:pt>
              </c:numCache>
            </c:numRef>
          </c:val>
        </c:ser>
        <c:ser>
          <c:idx val="12"/>
          <c:order val="12"/>
          <c:tx>
            <c:strRef>
              <c:f>'unc-25 L4_0.02_5%'!$N$104</c:f>
              <c:strCache>
                <c:ptCount val="1"/>
                <c:pt idx="0">
                  <c:v>unc-25_L4_06014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N$105:$N$125</c:f>
              <c:numCache>
                <c:formatCode>General</c:formatCode>
                <c:ptCount val="21"/>
                <c:pt idx="1">
                  <c:v>6.6476054324517503E-2</c:v>
                </c:pt>
                <c:pt idx="2">
                  <c:v>9.7212294496068538E-2</c:v>
                </c:pt>
                <c:pt idx="3">
                  <c:v>0.11686919228020003</c:v>
                </c:pt>
                <c:pt idx="4">
                  <c:v>0.12294496068620403</c:v>
                </c:pt>
                <c:pt idx="5">
                  <c:v>0.10686204431736999</c:v>
                </c:pt>
                <c:pt idx="6">
                  <c:v>7.576840600428883E-2</c:v>
                </c:pt>
                <c:pt idx="7">
                  <c:v>7.1479628305932796E-2</c:v>
                </c:pt>
                <c:pt idx="8">
                  <c:v>5.8255897069335184E-2</c:v>
                </c:pt>
                <c:pt idx="9">
                  <c:v>5.432451751250892E-2</c:v>
                </c:pt>
                <c:pt idx="10">
                  <c:v>3.3952823445318102E-2</c:v>
                </c:pt>
                <c:pt idx="11">
                  <c:v>3.2523230879199415E-2</c:v>
                </c:pt>
                <c:pt idx="12">
                  <c:v>2.0729092208720507E-2</c:v>
                </c:pt>
                <c:pt idx="13">
                  <c:v>1.75125089349535E-2</c:v>
                </c:pt>
                <c:pt idx="14">
                  <c:v>1.4295925661186601E-2</c:v>
                </c:pt>
                <c:pt idx="15">
                  <c:v>1.0721944245889901E-2</c:v>
                </c:pt>
                <c:pt idx="16">
                  <c:v>1.0721944245889901E-2</c:v>
                </c:pt>
                <c:pt idx="17">
                  <c:v>6.4331665475339519E-3</c:v>
                </c:pt>
                <c:pt idx="18">
                  <c:v>5.0035739814153022E-3</c:v>
                </c:pt>
                <c:pt idx="19">
                  <c:v>2.8591851322373111E-3</c:v>
                </c:pt>
                <c:pt idx="20">
                  <c:v>2.1443888491779819E-3</c:v>
                </c:pt>
              </c:numCache>
            </c:numRef>
          </c:val>
        </c:ser>
        <c:ser>
          <c:idx val="13"/>
          <c:order val="13"/>
          <c:tx>
            <c:strRef>
              <c:f>'unc-25 L4_0.02_5%'!$O$104</c:f>
              <c:strCache>
                <c:ptCount val="1"/>
                <c:pt idx="0">
                  <c:v>unc-25_L4_06015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O$105:$O$125</c:f>
              <c:numCache>
                <c:formatCode>General</c:formatCode>
                <c:ptCount val="21"/>
                <c:pt idx="1">
                  <c:v>8.2191780821917734E-2</c:v>
                </c:pt>
                <c:pt idx="2">
                  <c:v>0.12328767123287702</c:v>
                </c:pt>
                <c:pt idx="3">
                  <c:v>6.8493150684931503E-2</c:v>
                </c:pt>
                <c:pt idx="4">
                  <c:v>4.1095890410958895E-2</c:v>
                </c:pt>
                <c:pt idx="5">
                  <c:v>2.7397260273972608E-2</c:v>
                </c:pt>
                <c:pt idx="6">
                  <c:v>5.4794520547945244E-2</c:v>
                </c:pt>
                <c:pt idx="7">
                  <c:v>2.7397260273972608E-2</c:v>
                </c:pt>
                <c:pt idx="8">
                  <c:v>0</c:v>
                </c:pt>
                <c:pt idx="9">
                  <c:v>8.2191780821917734E-2</c:v>
                </c:pt>
                <c:pt idx="10">
                  <c:v>1.3698630136986301E-2</c:v>
                </c:pt>
                <c:pt idx="11">
                  <c:v>1.3698630136986301E-2</c:v>
                </c:pt>
                <c:pt idx="12">
                  <c:v>1.3698630136986301E-2</c:v>
                </c:pt>
                <c:pt idx="13">
                  <c:v>0</c:v>
                </c:pt>
                <c:pt idx="14">
                  <c:v>1.3698630136986301E-2</c:v>
                </c:pt>
                <c:pt idx="15">
                  <c:v>0</c:v>
                </c:pt>
                <c:pt idx="16">
                  <c:v>1.3698630136986301E-2</c:v>
                </c:pt>
                <c:pt idx="17">
                  <c:v>0</c:v>
                </c:pt>
                <c:pt idx="18">
                  <c:v>2.7397260273972608E-2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unc-25 L4_0.02_5%'!$P$104</c:f>
              <c:strCache>
                <c:ptCount val="1"/>
                <c:pt idx="0">
                  <c:v>unc-25_L4_06016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P$105:$P$125</c:f>
              <c:numCache>
                <c:formatCode>General</c:formatCode>
                <c:ptCount val="21"/>
                <c:pt idx="1">
                  <c:v>8.0666666666666748E-2</c:v>
                </c:pt>
                <c:pt idx="2">
                  <c:v>0.105333333333333</c:v>
                </c:pt>
                <c:pt idx="3">
                  <c:v>0.14200000000000004</c:v>
                </c:pt>
                <c:pt idx="4">
                  <c:v>0.10400000000000002</c:v>
                </c:pt>
                <c:pt idx="5">
                  <c:v>9.73333333333333E-2</c:v>
                </c:pt>
                <c:pt idx="6">
                  <c:v>7.3999999999999996E-2</c:v>
                </c:pt>
                <c:pt idx="7">
                  <c:v>5.4666666666666718E-2</c:v>
                </c:pt>
                <c:pt idx="8">
                  <c:v>4.8000000000000001E-2</c:v>
                </c:pt>
                <c:pt idx="9">
                  <c:v>3.4000000000000002E-2</c:v>
                </c:pt>
                <c:pt idx="10">
                  <c:v>3.2000000000000015E-2</c:v>
                </c:pt>
                <c:pt idx="11">
                  <c:v>3.0666666666666707E-2</c:v>
                </c:pt>
                <c:pt idx="12">
                  <c:v>2.6666666666666707E-2</c:v>
                </c:pt>
                <c:pt idx="13">
                  <c:v>1.2E-2</c:v>
                </c:pt>
                <c:pt idx="14">
                  <c:v>1.4666666666666701E-2</c:v>
                </c:pt>
                <c:pt idx="15">
                  <c:v>1.2666666666666701E-2</c:v>
                </c:pt>
                <c:pt idx="16">
                  <c:v>1.0000000000000004E-2</c:v>
                </c:pt>
                <c:pt idx="17">
                  <c:v>1.0666666666666701E-2</c:v>
                </c:pt>
                <c:pt idx="18">
                  <c:v>2.6666666666666709E-3</c:v>
                </c:pt>
                <c:pt idx="19">
                  <c:v>3.3333333333333309E-3</c:v>
                </c:pt>
                <c:pt idx="20">
                  <c:v>2.6666666666666709E-3</c:v>
                </c:pt>
              </c:numCache>
            </c:numRef>
          </c:val>
        </c:ser>
        <c:ser>
          <c:idx val="15"/>
          <c:order val="15"/>
          <c:tx>
            <c:strRef>
              <c:f>'unc-25 L4_0.02_5%'!$Q$104</c:f>
              <c:strCache>
                <c:ptCount val="1"/>
                <c:pt idx="0">
                  <c:v>unc-25_L4_06017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Q$105:$Q$125</c:f>
              <c:numCache>
                <c:formatCode>General</c:formatCode>
                <c:ptCount val="21"/>
                <c:pt idx="1">
                  <c:v>8.0875041431886022E-2</c:v>
                </c:pt>
                <c:pt idx="2">
                  <c:v>0.104076897580378</c:v>
                </c:pt>
                <c:pt idx="3">
                  <c:v>0.12495856811402095</c:v>
                </c:pt>
                <c:pt idx="4">
                  <c:v>0.12727875372886993</c:v>
                </c:pt>
                <c:pt idx="5">
                  <c:v>0.11037454424925403</c:v>
                </c:pt>
                <c:pt idx="6">
                  <c:v>5.7673185283394081E-2</c:v>
                </c:pt>
                <c:pt idx="7">
                  <c:v>5.601590984421613E-2</c:v>
                </c:pt>
                <c:pt idx="8">
                  <c:v>3.9111700364600599E-2</c:v>
                </c:pt>
                <c:pt idx="9">
                  <c:v>4.0437520715943011E-2</c:v>
                </c:pt>
                <c:pt idx="10">
                  <c:v>3.3145508783559811E-2</c:v>
                </c:pt>
                <c:pt idx="11">
                  <c:v>2.91680477295326E-2</c:v>
                </c:pt>
                <c:pt idx="12">
                  <c:v>2.4859131587669916E-2</c:v>
                </c:pt>
                <c:pt idx="13">
                  <c:v>2.3201856148491892E-2</c:v>
                </c:pt>
                <c:pt idx="14">
                  <c:v>2.1213125621478309E-2</c:v>
                </c:pt>
                <c:pt idx="15">
                  <c:v>1.55783891282731E-2</c:v>
                </c:pt>
                <c:pt idx="16">
                  <c:v>1.2263838249917114E-2</c:v>
                </c:pt>
                <c:pt idx="17">
                  <c:v>8.9492873715611553E-3</c:v>
                </c:pt>
                <c:pt idx="18">
                  <c:v>8.6178322837255593E-3</c:v>
                </c:pt>
                <c:pt idx="19">
                  <c:v>4.3089161418627796E-3</c:v>
                </c:pt>
                <c:pt idx="20">
                  <c:v>3.9774610540271819E-3</c:v>
                </c:pt>
              </c:numCache>
            </c:numRef>
          </c:val>
        </c:ser>
        <c:ser>
          <c:idx val="16"/>
          <c:order val="16"/>
          <c:tx>
            <c:strRef>
              <c:f>'unc-25 L4_0.02_5%'!$R$104</c:f>
              <c:strCache>
                <c:ptCount val="1"/>
                <c:pt idx="0">
                  <c:v>unc-25_L4_06018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R$105:$R$125</c:f>
              <c:numCache>
                <c:formatCode>General</c:formatCode>
                <c:ptCount val="21"/>
                <c:pt idx="1">
                  <c:v>0.1276595744680849</c:v>
                </c:pt>
                <c:pt idx="2">
                  <c:v>0.12056737588652502</c:v>
                </c:pt>
                <c:pt idx="3">
                  <c:v>7.8014184397163094E-2</c:v>
                </c:pt>
                <c:pt idx="4">
                  <c:v>7.09219858156028E-2</c:v>
                </c:pt>
                <c:pt idx="5">
                  <c:v>7.09219858156028E-2</c:v>
                </c:pt>
                <c:pt idx="6">
                  <c:v>4.9645390070921995E-2</c:v>
                </c:pt>
                <c:pt idx="7">
                  <c:v>4.2553191489361715E-2</c:v>
                </c:pt>
                <c:pt idx="8">
                  <c:v>4.9645390070921995E-2</c:v>
                </c:pt>
                <c:pt idx="9">
                  <c:v>2.8368794326241082E-2</c:v>
                </c:pt>
                <c:pt idx="10">
                  <c:v>0</c:v>
                </c:pt>
                <c:pt idx="11">
                  <c:v>2.1276595744680899E-2</c:v>
                </c:pt>
                <c:pt idx="12">
                  <c:v>7.0921985815602818E-3</c:v>
                </c:pt>
                <c:pt idx="13">
                  <c:v>7.0921985815602818E-3</c:v>
                </c:pt>
                <c:pt idx="14">
                  <c:v>2.8368794326241082E-2</c:v>
                </c:pt>
                <c:pt idx="15">
                  <c:v>1.4184397163120598E-2</c:v>
                </c:pt>
                <c:pt idx="16">
                  <c:v>0</c:v>
                </c:pt>
                <c:pt idx="17">
                  <c:v>7.0921985815602818E-3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unc-25 L4_0.02_5%'!$S$104</c:f>
              <c:strCache>
                <c:ptCount val="1"/>
                <c:pt idx="0">
                  <c:v>unc-25_L4_06019</c:v>
                </c:pt>
              </c:strCache>
            </c:strRef>
          </c:tx>
          <c:marker>
            <c:symbol val="none"/>
          </c:marker>
          <c:cat>
            <c:numRef>
              <c:f>'unc-25 L4_0.02_5%'!$A$105:$A$125</c:f>
              <c:numCache>
                <c:formatCode>0.0_ </c:formatCode>
                <c:ptCount val="2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</c:numCache>
            </c:numRef>
          </c:cat>
          <c:val>
            <c:numRef>
              <c:f>'unc-25 L4_0.02_5%'!$S$105:$S$125</c:f>
              <c:numCache>
                <c:formatCode>General</c:formatCode>
                <c:ptCount val="21"/>
                <c:pt idx="1">
                  <c:v>6.5656565656565705E-2</c:v>
                </c:pt>
                <c:pt idx="2">
                  <c:v>8.9225589225589208E-2</c:v>
                </c:pt>
                <c:pt idx="3">
                  <c:v>0.11560044893378203</c:v>
                </c:pt>
                <c:pt idx="4">
                  <c:v>0.10325476992143705</c:v>
                </c:pt>
                <c:pt idx="5">
                  <c:v>0.10662177328844008</c:v>
                </c:pt>
                <c:pt idx="6">
                  <c:v>6.5656565656565705E-2</c:v>
                </c:pt>
                <c:pt idx="7">
                  <c:v>4.5454545454545497E-2</c:v>
                </c:pt>
                <c:pt idx="8">
                  <c:v>4.2648709315375989E-2</c:v>
                </c:pt>
                <c:pt idx="9">
                  <c:v>4.2087542087542097E-2</c:v>
                </c:pt>
                <c:pt idx="10">
                  <c:v>3.7598204264870899E-2</c:v>
                </c:pt>
                <c:pt idx="11">
                  <c:v>3.2547699214365899E-2</c:v>
                </c:pt>
                <c:pt idx="12">
                  <c:v>3.03030303030303E-2</c:v>
                </c:pt>
                <c:pt idx="13">
                  <c:v>2.1324354657687991E-2</c:v>
                </c:pt>
                <c:pt idx="14">
                  <c:v>1.7396184062850702E-2</c:v>
                </c:pt>
                <c:pt idx="15">
                  <c:v>1.68350168350168E-2</c:v>
                </c:pt>
                <c:pt idx="16">
                  <c:v>1.0662177328844001E-2</c:v>
                </c:pt>
                <c:pt idx="17">
                  <c:v>8.9786756453423093E-3</c:v>
                </c:pt>
                <c:pt idx="18">
                  <c:v>1.0662177328844001E-2</c:v>
                </c:pt>
                <c:pt idx="19">
                  <c:v>5.6116722783389403E-3</c:v>
                </c:pt>
                <c:pt idx="20">
                  <c:v>8.9786756453423093E-3</c:v>
                </c:pt>
              </c:numCache>
            </c:numRef>
          </c:val>
        </c:ser>
        <c:marker val="1"/>
        <c:axId val="158241920"/>
        <c:axId val="158243456"/>
      </c:lineChart>
      <c:catAx>
        <c:axId val="158241920"/>
        <c:scaling>
          <c:orientation val="minMax"/>
        </c:scaling>
        <c:axPos val="b"/>
        <c:numFmt formatCode="0.0_ " sourceLinked="1"/>
        <c:tickLblPos val="nextTo"/>
        <c:crossAx val="158243456"/>
        <c:crosses val="autoZero"/>
        <c:auto val="1"/>
        <c:lblAlgn val="ctr"/>
        <c:lblOffset val="100"/>
        <c:tickLblSkip val="5"/>
        <c:tickMarkSkip val="5"/>
      </c:catAx>
      <c:valAx>
        <c:axId val="15824345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58241920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CBBF2-A2DA-48DA-BDB5-4DADD9A6167B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529CEA-BC98-4E26-9E74-6D918A6BF2A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7.xml"/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12" Type="http://schemas.openxmlformats.org/officeDocument/2006/relationships/chart" Target="../charts/chart21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5.xml"/><Relationship Id="rId11" Type="http://schemas.openxmlformats.org/officeDocument/2006/relationships/chart" Target="../charts/chart20.xml"/><Relationship Id="rId5" Type="http://schemas.openxmlformats.org/officeDocument/2006/relationships/chart" Target="../charts/chart14.xml"/><Relationship Id="rId10" Type="http://schemas.openxmlformats.org/officeDocument/2006/relationships/chart" Target="../charts/chart19.xml"/><Relationship Id="rId4" Type="http://schemas.openxmlformats.org/officeDocument/2006/relationships/chart" Target="../charts/chart13.xml"/><Relationship Id="rId9" Type="http://schemas.openxmlformats.org/officeDocument/2006/relationships/chart" Target="../charts/chart18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8.xml"/><Relationship Id="rId3" Type="http://schemas.openxmlformats.org/officeDocument/2006/relationships/chart" Target="../charts/chart23.xml"/><Relationship Id="rId7" Type="http://schemas.openxmlformats.org/officeDocument/2006/relationships/chart" Target="../charts/chart27.xml"/><Relationship Id="rId2" Type="http://schemas.openxmlformats.org/officeDocument/2006/relationships/chart" Target="../charts/chart2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6.xml"/><Relationship Id="rId5" Type="http://schemas.openxmlformats.org/officeDocument/2006/relationships/chart" Target="../charts/chart25.xml"/><Relationship Id="rId10" Type="http://schemas.openxmlformats.org/officeDocument/2006/relationships/chart" Target="../charts/chart30.xml"/><Relationship Id="rId4" Type="http://schemas.openxmlformats.org/officeDocument/2006/relationships/chart" Target="../charts/chart24.xml"/><Relationship Id="rId9" Type="http://schemas.openxmlformats.org/officeDocument/2006/relationships/chart" Target="../charts/chart2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グラフ 21"/>
          <p:cNvGraphicFramePr>
            <a:graphicFrameLocks noGrp="1"/>
          </p:cNvGraphicFramePr>
          <p:nvPr/>
        </p:nvGraphicFramePr>
        <p:xfrm>
          <a:off x="2420888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グラフ 12"/>
          <p:cNvGraphicFramePr>
            <a:graphicFrameLocks noGrp="1"/>
          </p:cNvGraphicFramePr>
          <p:nvPr/>
        </p:nvGraphicFramePr>
        <p:xfrm>
          <a:off x="260350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グラフ 11"/>
          <p:cNvGraphicFramePr>
            <a:graphicFrameLocks noGrp="1"/>
          </p:cNvGraphicFramePr>
          <p:nvPr/>
        </p:nvGraphicFramePr>
        <p:xfrm>
          <a:off x="4581128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グラフ 15"/>
          <p:cNvGraphicFramePr>
            <a:graphicFrameLocks noGrp="1"/>
          </p:cNvGraphicFramePr>
          <p:nvPr/>
        </p:nvGraphicFramePr>
        <p:xfrm>
          <a:off x="2420888" y="2504728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グラフ 17"/>
          <p:cNvGraphicFramePr>
            <a:graphicFrameLocks noGrp="1"/>
          </p:cNvGraphicFramePr>
          <p:nvPr/>
        </p:nvGraphicFramePr>
        <p:xfrm>
          <a:off x="2420888" y="4736976"/>
          <a:ext cx="2016522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9" name="グラフ 18"/>
          <p:cNvGraphicFramePr>
            <a:graphicFrameLocks noGrp="1"/>
          </p:cNvGraphicFramePr>
          <p:nvPr/>
        </p:nvGraphicFramePr>
        <p:xfrm>
          <a:off x="260350" y="6969224"/>
          <a:ext cx="2016522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0" name="グラフ 19"/>
          <p:cNvGraphicFramePr>
            <a:graphicFrameLocks noGrp="1"/>
          </p:cNvGraphicFramePr>
          <p:nvPr/>
        </p:nvGraphicFramePr>
        <p:xfrm>
          <a:off x="2420888" y="6969224"/>
          <a:ext cx="2016522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7" name="グラフ 16"/>
          <p:cNvGraphicFramePr/>
          <p:nvPr/>
        </p:nvGraphicFramePr>
        <p:xfrm>
          <a:off x="260350" y="2504728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5" name="グラフ 24"/>
          <p:cNvGraphicFramePr/>
          <p:nvPr/>
        </p:nvGraphicFramePr>
        <p:xfrm>
          <a:off x="260350" y="4736976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7" name="グラフ 26"/>
          <p:cNvGraphicFramePr/>
          <p:nvPr/>
        </p:nvGraphicFramePr>
        <p:xfrm>
          <a:off x="4581128" y="4736976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" name="グラフ 31"/>
          <p:cNvGraphicFramePr/>
          <p:nvPr/>
        </p:nvGraphicFramePr>
        <p:xfrm>
          <a:off x="260350" y="6969224"/>
          <a:ext cx="2016522" cy="21601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6" name="グラフ 25"/>
          <p:cNvGraphicFramePr/>
          <p:nvPr/>
        </p:nvGraphicFramePr>
        <p:xfrm>
          <a:off x="260350" y="4736976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グラフ 20"/>
          <p:cNvGraphicFramePr/>
          <p:nvPr/>
        </p:nvGraphicFramePr>
        <p:xfrm>
          <a:off x="260350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" name="グラフ 21"/>
          <p:cNvGraphicFramePr/>
          <p:nvPr/>
        </p:nvGraphicFramePr>
        <p:xfrm>
          <a:off x="2420888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" name="グラフ 22"/>
          <p:cNvGraphicFramePr/>
          <p:nvPr/>
        </p:nvGraphicFramePr>
        <p:xfrm>
          <a:off x="4581128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4" name="グラフ 23"/>
          <p:cNvGraphicFramePr/>
          <p:nvPr/>
        </p:nvGraphicFramePr>
        <p:xfrm>
          <a:off x="260350" y="2504728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5" name="グラフ 24"/>
          <p:cNvGraphicFramePr/>
          <p:nvPr/>
        </p:nvGraphicFramePr>
        <p:xfrm>
          <a:off x="2420888" y="2504728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7" name="グラフ 26"/>
          <p:cNvGraphicFramePr/>
          <p:nvPr/>
        </p:nvGraphicFramePr>
        <p:xfrm>
          <a:off x="2420888" y="4736976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9" name="グラフ 28"/>
          <p:cNvGraphicFramePr/>
          <p:nvPr/>
        </p:nvGraphicFramePr>
        <p:xfrm>
          <a:off x="4581128" y="4737100"/>
          <a:ext cx="2016522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7" name="グラフ 36"/>
          <p:cNvGraphicFramePr/>
          <p:nvPr/>
        </p:nvGraphicFramePr>
        <p:xfrm>
          <a:off x="2420888" y="6969224"/>
          <a:ext cx="2016522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8" name="グラフ 37"/>
          <p:cNvGraphicFramePr/>
          <p:nvPr/>
        </p:nvGraphicFramePr>
        <p:xfrm>
          <a:off x="4581128" y="6969224"/>
          <a:ext cx="2016522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グラフ 26"/>
          <p:cNvGraphicFramePr/>
          <p:nvPr/>
        </p:nvGraphicFramePr>
        <p:xfrm>
          <a:off x="4581128" y="4736976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6" name="グラフ 25"/>
          <p:cNvGraphicFramePr/>
          <p:nvPr/>
        </p:nvGraphicFramePr>
        <p:xfrm>
          <a:off x="2420888" y="4736976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グラフ 24"/>
          <p:cNvGraphicFramePr/>
          <p:nvPr/>
        </p:nvGraphicFramePr>
        <p:xfrm>
          <a:off x="260350" y="4736976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/>
          <p:cNvGraphicFramePr/>
          <p:nvPr/>
        </p:nvGraphicFramePr>
        <p:xfrm>
          <a:off x="4581128" y="2504728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" name="グラフ 22"/>
          <p:cNvGraphicFramePr/>
          <p:nvPr/>
        </p:nvGraphicFramePr>
        <p:xfrm>
          <a:off x="2420888" y="2504728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" name="グラフ 21"/>
          <p:cNvGraphicFramePr/>
          <p:nvPr/>
        </p:nvGraphicFramePr>
        <p:xfrm>
          <a:off x="260350" y="2504728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0" name="グラフ 19"/>
          <p:cNvGraphicFramePr/>
          <p:nvPr/>
        </p:nvGraphicFramePr>
        <p:xfrm>
          <a:off x="4581128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9" name="グラフ 18"/>
          <p:cNvGraphicFramePr/>
          <p:nvPr/>
        </p:nvGraphicFramePr>
        <p:xfrm>
          <a:off x="2420888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8" name="グラフ 17"/>
          <p:cNvGraphicFramePr/>
          <p:nvPr/>
        </p:nvGraphicFramePr>
        <p:xfrm>
          <a:off x="260350" y="273050"/>
          <a:ext cx="2016522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E8C78F21B45EF479F5CA629480F6AA8" ma:contentTypeVersion="7" ma:contentTypeDescription="Create a new document." ma:contentTypeScope="" ma:versionID="f671af6365ac414c1b586ce32e882c71">
  <xsd:schema xmlns:xsd="http://www.w3.org/2001/XMLSchema" xmlns:p="http://schemas.microsoft.com/office/2006/metadata/properties" xmlns:ns2="e0c5cd90-fa0d-4391-bd91-b400daf014db" targetNamespace="http://schemas.microsoft.com/office/2006/metadata/properties" ma:root="true" ma:fieldsID="9d3cfad310efeeb70853a035efe4057c" ns2:_="">
    <xsd:import namespace="e0c5cd90-fa0d-4391-bd91-b400daf014d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0c5cd90-fa0d-4391-bd91-b400daf014d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e0c5cd90-fa0d-4391-bd91-b400daf014db">PPTX</FileFormat>
    <DocumentId xmlns="e0c5cd90-fa0d-4391-bd91-b400daf014db">Presentation 2.PPTX</DocumentId>
    <IsDeleted xmlns="e0c5cd90-fa0d-4391-bd91-b400daf014db">false</IsDeleted>
    <DocumentType xmlns="e0c5cd90-fa0d-4391-bd91-b400daf014db">Presentation</DocumentType>
    <Checked_x0020_Out_x0020_To xmlns="e0c5cd90-fa0d-4391-bd91-b400daf014db">
      <UserInfo>
        <DisplayName/>
        <AccountId xsi:nil="true"/>
        <AccountType/>
      </UserInfo>
    </Checked_x0020_Out_x0020_To>
    <TitleName xmlns="e0c5cd90-fa0d-4391-bd91-b400daf014db">Presentation 2.PPTX</TitleName>
    <StageName xmlns="e0c5cd90-fa0d-4391-bd91-b400daf014db" xsi:nil="true"/>
  </documentManagement>
</p:properties>
</file>

<file path=customXml/itemProps1.xml><?xml version="1.0" encoding="utf-8"?>
<ds:datastoreItem xmlns:ds="http://schemas.openxmlformats.org/officeDocument/2006/customXml" ds:itemID="{BCA5E1C0-640F-46FC-9B10-CF97F9AE4979}"/>
</file>

<file path=customXml/itemProps2.xml><?xml version="1.0" encoding="utf-8"?>
<ds:datastoreItem xmlns:ds="http://schemas.openxmlformats.org/officeDocument/2006/customXml" ds:itemID="{B984C25B-6E64-4D32-AE3F-03F1C76B9918}"/>
</file>

<file path=customXml/itemProps3.xml><?xml version="1.0" encoding="utf-8"?>
<ds:datastoreItem xmlns:ds="http://schemas.openxmlformats.org/officeDocument/2006/customXml" ds:itemID="{84505A5F-B5AF-4606-876F-862E2AE7A9C9}"/>
</file>

<file path=docProps/app.xml><?xml version="1.0" encoding="utf-8"?>
<Properties xmlns="http://schemas.openxmlformats.org/officeDocument/2006/extended-properties" xmlns:vt="http://schemas.openxmlformats.org/officeDocument/2006/docPropsVTypes">
  <TotalTime>4091</TotalTime>
  <Words>65</Words>
  <Application>Microsoft Office PowerPoint</Application>
  <PresentationFormat>A4 210 x 297 mm</PresentationFormat>
  <Paragraphs>30</Paragraphs>
  <Slides>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Office テーマ</vt:lpstr>
      <vt:lpstr>スライド 1</vt:lpstr>
      <vt:lpstr>スライド 2</vt:lpstr>
      <vt:lpstr>スライド 3</vt:lpstr>
    </vt:vector>
  </TitlesOfParts>
  <Company>UNITCOM P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furu</dc:creator>
  <cp:lastModifiedBy>Shingai</cp:lastModifiedBy>
  <cp:revision>38</cp:revision>
  <dcterms:created xsi:type="dcterms:W3CDTF">2013-01-17T23:55:34Z</dcterms:created>
  <dcterms:modified xsi:type="dcterms:W3CDTF">2013-02-07T11:16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E8C78F21B45EF479F5CA629480F6AA8</vt:lpwstr>
  </property>
</Properties>
</file>